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tags/tag2.xml" ContentType="application/vnd.openxmlformats-officedocument.presentationml.tags+xml"/>
  <Override PartName="/ppt/notesSlides/notesSlide2.xml" ContentType="application/vnd.openxmlformats-officedocument.presentationml.notesSlide+xml"/>
  <Override PartName="/ppt/tags/tag3.xml" ContentType="application/vnd.openxmlformats-officedocument.presentationml.tags+xml"/>
  <Override PartName="/ppt/notesSlides/notesSlide3.xml" ContentType="application/vnd.openxmlformats-officedocument.presentationml.notesSlide+xml"/>
  <Override PartName="/ppt/tags/tag4.xml" ContentType="application/vnd.openxmlformats-officedocument.presentationml.tags+xml"/>
  <Override PartName="/ppt/notesSlides/notesSlide4.xml" ContentType="application/vnd.openxmlformats-officedocument.presentationml.notesSlide+xml"/>
  <Override PartName="/ppt/tags/tag5.xml" ContentType="application/vnd.openxmlformats-officedocument.presentationml.tags+xml"/>
  <Override PartName="/ppt/notesSlides/notesSlide5.xml" ContentType="application/vnd.openxmlformats-officedocument.presentationml.notesSlide+xml"/>
  <Override PartName="/ppt/tags/tag6.xml" ContentType="application/vnd.openxmlformats-officedocument.presentationml.tags+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tags/tag7.xml" ContentType="application/vnd.openxmlformats-officedocument.presentationml.tags+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1.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2.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3.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4.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5.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16.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17.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18.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19.xml" ContentType="application/vnd.openxmlformats-officedocument.presentationml.notesSlide+xml"/>
  <Override PartName="/ppt/diagrams/data11.xml" ContentType="application/vnd.openxmlformats-officedocument.drawingml.diagramData+xml"/>
  <Override PartName="/ppt/diagrams/layout11.xml" ContentType="application/vnd.openxmlformats-officedocument.drawingml.diagramLayout+xml"/>
  <Override PartName="/ppt/diagrams/quickStyle11.xml" ContentType="application/vnd.openxmlformats-officedocument.drawingml.diagramStyle+xml"/>
  <Override PartName="/ppt/diagrams/colors11.xml" ContentType="application/vnd.openxmlformats-officedocument.drawingml.diagramColors+xml"/>
  <Override PartName="/ppt/diagrams/drawing11.xml" ContentType="application/vnd.ms-office.drawingml.diagramDrawing+xml"/>
  <Override PartName="/ppt/notesSlides/notesSlide20.xml" ContentType="application/vnd.openxmlformats-officedocument.presentationml.notesSlide+xml"/>
  <Override PartName="/ppt/diagrams/data12.xml" ContentType="application/vnd.openxmlformats-officedocument.drawingml.diagramData+xml"/>
  <Override PartName="/ppt/diagrams/layout12.xml" ContentType="application/vnd.openxmlformats-officedocument.drawingml.diagramLayout+xml"/>
  <Override PartName="/ppt/diagrams/quickStyle12.xml" ContentType="application/vnd.openxmlformats-officedocument.drawingml.diagramStyle+xml"/>
  <Override PartName="/ppt/diagrams/colors12.xml" ContentType="application/vnd.openxmlformats-officedocument.drawingml.diagramColors+xml"/>
  <Override PartName="/ppt/diagrams/drawing12.xml" ContentType="application/vnd.ms-office.drawingml.diagramDrawing+xml"/>
  <Override PartName="/ppt/tags/tag8.xml" ContentType="application/vnd.openxmlformats-officedocument.presentationml.tags+xml"/>
  <Override PartName="/ppt/notesSlides/notesSlide21.xml" ContentType="application/vnd.openxmlformats-officedocument.presentationml.notesSlide+xml"/>
  <Override PartName="/ppt/tags/tag9.xml" ContentType="application/vnd.openxmlformats-officedocument.presentationml.tags+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tags/tag10.xml" ContentType="application/vnd.openxmlformats-officedocument.presentationml.tags+xml"/>
  <Override PartName="/ppt/notesSlides/notesSlide24.xml" ContentType="application/vnd.openxmlformats-officedocument.presentationml.notesSlide+xml"/>
  <Override PartName="/ppt/tags/tag11.xml" ContentType="application/vnd.openxmlformats-officedocument.presentationml.tags+xml"/>
  <Override PartName="/ppt/notesSlides/notesSlide25.xml" ContentType="application/vnd.openxmlformats-officedocument.presentationml.notesSlide+xml"/>
  <Override PartName="/ppt/tags/tag12.xml" ContentType="application/vnd.openxmlformats-officedocument.presentationml.tags+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tags/tag13.xml" ContentType="application/vnd.openxmlformats-officedocument.presentationml.tags+xml"/>
  <Override PartName="/ppt/notesSlides/notesSlide29.xml" ContentType="application/vnd.openxmlformats-officedocument.presentationml.notesSlide+xml"/>
  <Override PartName="/ppt/tags/tag14.xml" ContentType="application/vnd.openxmlformats-officedocument.presentationml.tags+xml"/>
  <Override PartName="/ppt/notesSlides/notesSlide30.xml" ContentType="application/vnd.openxmlformats-officedocument.presentationml.notesSlide+xml"/>
  <Override PartName="/ppt/tags/tag15.xml" ContentType="application/vnd.openxmlformats-officedocument.presentationml.tags+xml"/>
  <Override PartName="/ppt/notesSlides/notesSlide31.xml" ContentType="application/vnd.openxmlformats-officedocument.presentationml.notesSlide+xml"/>
  <Override PartName="/ppt/tags/tag16.xml" ContentType="application/vnd.openxmlformats-officedocument.presentationml.tags+xml"/>
  <Override PartName="/ppt/notesSlides/notesSlide32.xml" ContentType="application/vnd.openxmlformats-officedocument.presentationml.notesSlide+xml"/>
  <Override PartName="/ppt/tags/tag17.xml" ContentType="application/vnd.openxmlformats-officedocument.presentationml.tags+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tags/tag18.xml" ContentType="application/vnd.openxmlformats-officedocument.presentationml.tags+xml"/>
  <Override PartName="/ppt/notesSlides/notesSlide35.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37"/>
  </p:notesMasterIdLst>
  <p:sldIdLst>
    <p:sldId id="256" r:id="rId2"/>
    <p:sldId id="257" r:id="rId3"/>
    <p:sldId id="258" r:id="rId4"/>
    <p:sldId id="259" r:id="rId5"/>
    <p:sldId id="260" r:id="rId6"/>
    <p:sldId id="261" r:id="rId7"/>
    <p:sldId id="444" r:id="rId8"/>
    <p:sldId id="445" r:id="rId9"/>
    <p:sldId id="264" r:id="rId10"/>
    <p:sldId id="415" r:id="rId11"/>
    <p:sldId id="414" r:id="rId12"/>
    <p:sldId id="453" r:id="rId13"/>
    <p:sldId id="454" r:id="rId14"/>
    <p:sldId id="420" r:id="rId15"/>
    <p:sldId id="421" r:id="rId16"/>
    <p:sldId id="422" r:id="rId17"/>
    <p:sldId id="423" r:id="rId18"/>
    <p:sldId id="424" r:id="rId19"/>
    <p:sldId id="425" r:id="rId20"/>
    <p:sldId id="426" r:id="rId21"/>
    <p:sldId id="266" r:id="rId22"/>
    <p:sldId id="267" r:id="rId23"/>
    <p:sldId id="343" r:id="rId24"/>
    <p:sldId id="268" r:id="rId25"/>
    <p:sldId id="273" r:id="rId26"/>
    <p:sldId id="450" r:id="rId27"/>
    <p:sldId id="451" r:id="rId28"/>
    <p:sldId id="443" r:id="rId29"/>
    <p:sldId id="452" r:id="rId30"/>
    <p:sldId id="277" r:id="rId31"/>
    <p:sldId id="279" r:id="rId32"/>
    <p:sldId id="448" r:id="rId33"/>
    <p:sldId id="449" r:id="rId34"/>
    <p:sldId id="283" r:id="rId35"/>
    <p:sldId id="284" r:id="rId36"/>
  </p:sldIdLst>
  <p:sldSz cx="12192000" cy="6858000"/>
  <p:notesSz cx="6858000" cy="9144000"/>
  <p:embeddedFontLst>
    <p:embeddedFont>
      <p:font typeface="Source Sans Pro" panose="020B0503030403020204" pitchFamily="34" charset="0"/>
      <p:regular r:id="rId38"/>
      <p:bold r:id="rId39"/>
      <p:italic r:id="rId40"/>
      <p:boldItalic r:id="rId41"/>
    </p:embeddedFont>
    <p:embeddedFont>
      <p:font typeface="Verdana" panose="020B0604030504040204" pitchFamily="34" charset="0"/>
      <p:regular r:id="rId42"/>
      <p:bold r:id="rId43"/>
      <p:italic r:id="rId44"/>
      <p:boldItalic r:id="rId45"/>
    </p:embeddedFont>
  </p:embeddedFontLst>
  <p:custDataLst>
    <p:tags r:id="rId46"/>
  </p:custData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64" roundtripDataSignature="AMtx7mg/DY4xIRmtg+pDeq9pFtGuykZU5w=="/>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75DD1278-FC1E-A544-1405-FD12E347695E}" name="Burnett-Bowie, Sherri-Ann M.,MD, MPH" initials="SB" userId="S::sburnett-bowie@mgh.harvard.edu::814cbf33-9580-4012-8f22-e2efc8832414" providerId="AD"/>
  <p188:author id="{1D602791-DA7C-748E-5CE6-0C0016DFFACD}" name="Bromberg, Gabrielle K.,MD" initials="BGK" userId="S::gbromberg@mgh.harvard.edu::609b76b4-4634-43eb-b10c-798fc2193272" providerId="AD"/>
  <p188:author id="{26B5EEEC-9AB9-9D81-2E5C-51CF054458AC}" name="Bromberg, Gabrielle K.,MD" initials="GB" userId="S::GBROMBERG@mgh.harvard.edu::609b76b4-4634-43eb-b10c-798fc2193272"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E5D6501E-3FD5-426A-94D2-988B3E3310CF}">
  <a:tblStyle styleId="{E5D6501E-3FD5-426A-94D2-988B3E3310CF}" styleName="Table_0">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7836"/>
    <p:restoredTop sz="49524"/>
  </p:normalViewPr>
  <p:slideViewPr>
    <p:cSldViewPr snapToGrid="0" snapToObjects="1">
      <p:cViewPr varScale="1">
        <p:scale>
          <a:sx n="60" d="100"/>
          <a:sy n="60" d="100"/>
        </p:scale>
        <p:origin x="1536" y="168"/>
      </p:cViewPr>
      <p:guideLst/>
    </p:cSldViewPr>
  </p:slideViewPr>
  <p:outlineViewPr>
    <p:cViewPr>
      <p:scale>
        <a:sx n="33" d="100"/>
        <a:sy n="33" d="100"/>
      </p:scale>
      <p:origin x="0" y="-4360"/>
    </p:cViewPr>
  </p:outlineViewPr>
  <p:notesTextViewPr>
    <p:cViewPr>
      <p:scale>
        <a:sx n="155" d="100"/>
        <a:sy n="155" d="100"/>
      </p:scale>
      <p:origin x="0" y="0"/>
    </p:cViewPr>
  </p:notesTextViewPr>
  <p:sorterViewPr>
    <p:cViewPr>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2.fntdata"/><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font" Target="fonts/font5.fntdata"/><Relationship Id="rId68"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font" Target="fonts/font3.fntdata"/><Relationship Id="rId45" Type="http://schemas.openxmlformats.org/officeDocument/2006/relationships/font" Target="fonts/font8.fntdata"/><Relationship Id="rId66"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font" Target="fonts/font7.fntdata"/><Relationship Id="rId65"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font" Target="fonts/font6.fntdata"/><Relationship Id="rId64" Type="http://customschemas.google.com/relationships/presentationmetadata" Target="metadata"/><Relationship Id="rId69" Type="http://schemas.microsoft.com/office/2018/10/relationships/authors" Target="author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font" Target="fonts/font1.fntdata"/><Relationship Id="rId46" Type="http://schemas.openxmlformats.org/officeDocument/2006/relationships/tags" Target="tags/tag1.xml"/><Relationship Id="rId67" Type="http://schemas.openxmlformats.org/officeDocument/2006/relationships/theme" Target="theme/theme1.xml"/><Relationship Id="rId20" Type="http://schemas.openxmlformats.org/officeDocument/2006/relationships/slide" Target="slides/slide19.xml"/><Relationship Id="rId41" Type="http://schemas.openxmlformats.org/officeDocument/2006/relationships/font" Target="fonts/font4.fntdata"/><Relationship Id="rId1" Type="http://schemas.openxmlformats.org/officeDocument/2006/relationships/slideMaster" Target="slideMasters/slideMaster1.xml"/><Relationship Id="rId6" Type="http://schemas.openxmlformats.org/officeDocument/2006/relationships/slide" Target="slides/slide5.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CE7EC2B3-709C-7049-AC98-40D647A08CD5}" type="doc">
      <dgm:prSet loTypeId="urn:microsoft.com/office/officeart/2005/8/layout/vList5" loCatId="" qsTypeId="urn:microsoft.com/office/officeart/2005/8/quickstyle/simple1" qsCatId="simple" csTypeId="urn:microsoft.com/office/officeart/2005/8/colors/accent1_2" csCatId="accent1" phldr="1"/>
      <dgm:spPr/>
      <dgm:t>
        <a:bodyPr/>
        <a:lstStyle/>
        <a:p>
          <a:endParaRPr lang="en-US"/>
        </a:p>
      </dgm:t>
    </dgm:pt>
    <dgm:pt modelId="{54EB0C78-47D0-4144-BBA1-ED83F2276A80}">
      <dgm:prSet phldrT="[Text]"/>
      <dgm:spPr/>
      <dgm:t>
        <a:bodyPr/>
        <a:lstStyle/>
        <a:p>
          <a:r>
            <a:rPr lang="en-US" dirty="0"/>
            <a:t>1</a:t>
          </a:r>
        </a:p>
      </dgm:t>
    </dgm:pt>
    <dgm:pt modelId="{46A28A5B-8A7C-BF49-A5DC-996D874F74B0}" type="parTrans" cxnId="{54AEA8B7-F89B-724F-98A1-0AEC5D7FC3A2}">
      <dgm:prSet/>
      <dgm:spPr/>
      <dgm:t>
        <a:bodyPr/>
        <a:lstStyle/>
        <a:p>
          <a:endParaRPr lang="en-US"/>
        </a:p>
      </dgm:t>
    </dgm:pt>
    <dgm:pt modelId="{E8376F97-8FAC-AA43-868D-BB3E335B92F2}" type="sibTrans" cxnId="{54AEA8B7-F89B-724F-98A1-0AEC5D7FC3A2}">
      <dgm:prSet/>
      <dgm:spPr/>
      <dgm:t>
        <a:bodyPr/>
        <a:lstStyle/>
        <a:p>
          <a:endParaRPr lang="en-US"/>
        </a:p>
      </dgm:t>
    </dgm:pt>
    <dgm:pt modelId="{D57A6E2B-1DF9-5046-BC1D-709A01F64D7F}">
      <dgm:prSet phldrT="[Text]"/>
      <dgm:spPr/>
      <dgm:t>
        <a:bodyPr/>
        <a:lstStyle/>
        <a:p>
          <a:r>
            <a:rPr lang="en-US"/>
            <a:t>Patient stability</a:t>
          </a:r>
          <a:endParaRPr lang="en-US" dirty="0"/>
        </a:p>
      </dgm:t>
    </dgm:pt>
    <dgm:pt modelId="{C76AEE8B-D94A-7D44-B03A-3FE0785274DD}" type="parTrans" cxnId="{B2C59790-5949-8740-B37D-5567793C306C}">
      <dgm:prSet/>
      <dgm:spPr/>
      <dgm:t>
        <a:bodyPr/>
        <a:lstStyle/>
        <a:p>
          <a:endParaRPr lang="en-US"/>
        </a:p>
      </dgm:t>
    </dgm:pt>
    <dgm:pt modelId="{55132C62-F393-2540-A3F5-1E79E69F36CF}" type="sibTrans" cxnId="{B2C59790-5949-8740-B37D-5567793C306C}">
      <dgm:prSet/>
      <dgm:spPr/>
      <dgm:t>
        <a:bodyPr/>
        <a:lstStyle/>
        <a:p>
          <a:endParaRPr lang="en-US"/>
        </a:p>
      </dgm:t>
    </dgm:pt>
    <dgm:pt modelId="{D03F059F-5021-1F40-A19F-9647158C52AD}">
      <dgm:prSet phldrT="[Text]"/>
      <dgm:spPr/>
      <dgm:t>
        <a:bodyPr/>
        <a:lstStyle/>
        <a:p>
          <a:r>
            <a:rPr lang="en-US" dirty="0"/>
            <a:t>2</a:t>
          </a:r>
        </a:p>
      </dgm:t>
    </dgm:pt>
    <dgm:pt modelId="{CF000D09-B476-0444-AE02-AACE5A32ABB9}" type="parTrans" cxnId="{65CEA44F-9E16-EA4E-A309-EC3B3016297A}">
      <dgm:prSet/>
      <dgm:spPr/>
      <dgm:t>
        <a:bodyPr/>
        <a:lstStyle/>
        <a:p>
          <a:endParaRPr lang="en-US"/>
        </a:p>
      </dgm:t>
    </dgm:pt>
    <dgm:pt modelId="{294C2440-29C3-A948-ADDD-2D4D34880BDD}" type="sibTrans" cxnId="{65CEA44F-9E16-EA4E-A309-EC3B3016297A}">
      <dgm:prSet/>
      <dgm:spPr/>
      <dgm:t>
        <a:bodyPr/>
        <a:lstStyle/>
        <a:p>
          <a:endParaRPr lang="en-US"/>
        </a:p>
      </dgm:t>
    </dgm:pt>
    <dgm:pt modelId="{8E966A69-49F1-5E4B-B606-FCAEDAA984ED}">
      <dgm:prSet phldrT="[Text]"/>
      <dgm:spPr/>
      <dgm:t>
        <a:bodyPr/>
        <a:lstStyle/>
        <a:p>
          <a:r>
            <a:rPr lang="en-US" dirty="0"/>
            <a:t>Emotional check</a:t>
          </a:r>
        </a:p>
      </dgm:t>
    </dgm:pt>
    <dgm:pt modelId="{DBAD8E5C-BD8A-8D4C-B4F0-8493200D7696}" type="parTrans" cxnId="{FBB45EE4-904A-AF48-A0C9-CB655E66EF52}">
      <dgm:prSet/>
      <dgm:spPr/>
      <dgm:t>
        <a:bodyPr/>
        <a:lstStyle/>
        <a:p>
          <a:endParaRPr lang="en-US"/>
        </a:p>
      </dgm:t>
    </dgm:pt>
    <dgm:pt modelId="{6E022D76-54D3-5040-BFB1-6E3CF648085C}" type="sibTrans" cxnId="{FBB45EE4-904A-AF48-A0C9-CB655E66EF52}">
      <dgm:prSet/>
      <dgm:spPr/>
      <dgm:t>
        <a:bodyPr/>
        <a:lstStyle/>
        <a:p>
          <a:endParaRPr lang="en-US"/>
        </a:p>
      </dgm:t>
    </dgm:pt>
    <dgm:pt modelId="{73A345CE-36FD-894D-BBC6-F1148569A643}">
      <dgm:prSet phldrT="[Text]"/>
      <dgm:spPr/>
      <dgm:t>
        <a:bodyPr/>
        <a:lstStyle/>
        <a:p>
          <a:r>
            <a:rPr lang="en-US" dirty="0"/>
            <a:t>3</a:t>
          </a:r>
        </a:p>
      </dgm:t>
    </dgm:pt>
    <dgm:pt modelId="{E3B27BD6-FBE2-5640-8D4A-26A5222CC3EA}" type="parTrans" cxnId="{408ED183-BF58-1C4B-97FD-732582625FEF}">
      <dgm:prSet/>
      <dgm:spPr/>
      <dgm:t>
        <a:bodyPr/>
        <a:lstStyle/>
        <a:p>
          <a:endParaRPr lang="en-US"/>
        </a:p>
      </dgm:t>
    </dgm:pt>
    <dgm:pt modelId="{7A99C83F-BC00-3743-81E8-552BD253CEC3}" type="sibTrans" cxnId="{408ED183-BF58-1C4B-97FD-732582625FEF}">
      <dgm:prSet/>
      <dgm:spPr/>
      <dgm:t>
        <a:bodyPr/>
        <a:lstStyle/>
        <a:p>
          <a:endParaRPr lang="en-US"/>
        </a:p>
      </dgm:t>
    </dgm:pt>
    <dgm:pt modelId="{E900B89A-C42B-5249-B68C-A3D7ECDC2722}">
      <dgm:prSet phldrT="[Text]"/>
      <dgm:spPr/>
      <dgm:t>
        <a:bodyPr/>
        <a:lstStyle/>
        <a:p>
          <a:r>
            <a:rPr lang="en-US" dirty="0"/>
            <a:t>Address bias</a:t>
          </a:r>
        </a:p>
      </dgm:t>
    </dgm:pt>
    <dgm:pt modelId="{8E839505-C7B5-E846-B572-409C6E14F87D}" type="parTrans" cxnId="{8EA459AB-225B-8C4D-9825-5D1C6BF10277}">
      <dgm:prSet/>
      <dgm:spPr/>
      <dgm:t>
        <a:bodyPr/>
        <a:lstStyle/>
        <a:p>
          <a:endParaRPr lang="en-US"/>
        </a:p>
      </dgm:t>
    </dgm:pt>
    <dgm:pt modelId="{1CCB8A03-5593-CE44-86BA-AACEAE0CCB98}" type="sibTrans" cxnId="{8EA459AB-225B-8C4D-9825-5D1C6BF10277}">
      <dgm:prSet/>
      <dgm:spPr/>
      <dgm:t>
        <a:bodyPr/>
        <a:lstStyle/>
        <a:p>
          <a:endParaRPr lang="en-US"/>
        </a:p>
      </dgm:t>
    </dgm:pt>
    <dgm:pt modelId="{418E94F4-4F87-154C-8C2C-4FA1854F2962}">
      <dgm:prSet/>
      <dgm:spPr/>
      <dgm:t>
        <a:bodyPr/>
        <a:lstStyle/>
        <a:p>
          <a:r>
            <a:rPr lang="en-US" dirty="0"/>
            <a:t>4</a:t>
          </a:r>
        </a:p>
      </dgm:t>
    </dgm:pt>
    <dgm:pt modelId="{67B29BF1-08A2-E04F-9D69-0598739CF13B}" type="parTrans" cxnId="{2BBF3C50-1ED6-9847-B76B-936F9EDE5606}">
      <dgm:prSet/>
      <dgm:spPr/>
      <dgm:t>
        <a:bodyPr/>
        <a:lstStyle/>
        <a:p>
          <a:endParaRPr lang="en-US"/>
        </a:p>
      </dgm:t>
    </dgm:pt>
    <dgm:pt modelId="{A5C1BCA8-59E6-2D47-BF9C-24A0A56844F7}" type="sibTrans" cxnId="{2BBF3C50-1ED6-9847-B76B-936F9EDE5606}">
      <dgm:prSet/>
      <dgm:spPr/>
      <dgm:t>
        <a:bodyPr/>
        <a:lstStyle/>
        <a:p>
          <a:endParaRPr lang="en-US"/>
        </a:p>
      </dgm:t>
    </dgm:pt>
    <dgm:pt modelId="{827957E1-E296-1C4F-A5F6-1C5FE324A00C}">
      <dgm:prSet/>
      <dgm:spPr/>
      <dgm:t>
        <a:bodyPr/>
        <a:lstStyle/>
        <a:p>
          <a:r>
            <a:rPr lang="en-US" dirty="0"/>
            <a:t>5</a:t>
          </a:r>
        </a:p>
      </dgm:t>
    </dgm:pt>
    <dgm:pt modelId="{AC89EDA2-97A0-704F-A224-66777968DC79}" type="parTrans" cxnId="{C5A31E1B-1939-A943-9EA9-0D1F931C9095}">
      <dgm:prSet/>
      <dgm:spPr/>
      <dgm:t>
        <a:bodyPr/>
        <a:lstStyle/>
        <a:p>
          <a:endParaRPr lang="en-US"/>
        </a:p>
      </dgm:t>
    </dgm:pt>
    <dgm:pt modelId="{9F52F0F0-B16C-AB44-86AF-35AA79D5B0BB}" type="sibTrans" cxnId="{C5A31E1B-1939-A943-9EA9-0D1F931C9095}">
      <dgm:prSet/>
      <dgm:spPr/>
      <dgm:t>
        <a:bodyPr/>
        <a:lstStyle/>
        <a:p>
          <a:endParaRPr lang="en-US"/>
        </a:p>
      </dgm:t>
    </dgm:pt>
    <dgm:pt modelId="{9F6E5C8F-12F1-3545-94A6-291C5042E69E}">
      <dgm:prSet/>
      <dgm:spPr/>
      <dgm:t>
        <a:bodyPr/>
        <a:lstStyle/>
        <a:p>
          <a:r>
            <a:rPr lang="en-US" dirty="0"/>
            <a:t>6</a:t>
          </a:r>
        </a:p>
      </dgm:t>
    </dgm:pt>
    <dgm:pt modelId="{F878F1E0-BA83-0B4F-8407-D69A3E0606E8}" type="parTrans" cxnId="{545F95DE-9A10-3948-9807-36C195D34A35}">
      <dgm:prSet/>
      <dgm:spPr/>
      <dgm:t>
        <a:bodyPr/>
        <a:lstStyle/>
        <a:p>
          <a:endParaRPr lang="en-US"/>
        </a:p>
      </dgm:t>
    </dgm:pt>
    <dgm:pt modelId="{F501E3C1-886B-5244-A7B1-7A80D72A4D8C}" type="sibTrans" cxnId="{545F95DE-9A10-3948-9807-36C195D34A35}">
      <dgm:prSet/>
      <dgm:spPr/>
      <dgm:t>
        <a:bodyPr/>
        <a:lstStyle/>
        <a:p>
          <a:endParaRPr lang="en-US"/>
        </a:p>
      </dgm:t>
    </dgm:pt>
    <dgm:pt modelId="{02BDF100-8338-E043-96F5-EE898B9D5AB2}">
      <dgm:prSet/>
      <dgm:spPr/>
      <dgm:t>
        <a:bodyPr/>
        <a:lstStyle/>
        <a:p>
          <a:r>
            <a:rPr lang="en-US" dirty="0"/>
            <a:t>7</a:t>
          </a:r>
        </a:p>
      </dgm:t>
    </dgm:pt>
    <dgm:pt modelId="{1B53CCA0-CFF2-384B-856E-1EBDFA4D02AD}" type="parTrans" cxnId="{F6183E77-6BBF-FA47-854D-F0D53AE21A8A}">
      <dgm:prSet/>
      <dgm:spPr/>
      <dgm:t>
        <a:bodyPr/>
        <a:lstStyle/>
        <a:p>
          <a:endParaRPr lang="en-US"/>
        </a:p>
      </dgm:t>
    </dgm:pt>
    <dgm:pt modelId="{BCE247F3-63ED-824C-BC43-9D645F88694B}" type="sibTrans" cxnId="{F6183E77-6BBF-FA47-854D-F0D53AE21A8A}">
      <dgm:prSet/>
      <dgm:spPr/>
      <dgm:t>
        <a:bodyPr/>
        <a:lstStyle/>
        <a:p>
          <a:endParaRPr lang="en-US"/>
        </a:p>
      </dgm:t>
    </dgm:pt>
    <dgm:pt modelId="{7CF6944D-D814-F446-BDE2-B55C1C344687}">
      <dgm:prSet/>
      <dgm:spPr/>
      <dgm:t>
        <a:bodyPr/>
        <a:lstStyle/>
        <a:p>
          <a:r>
            <a:rPr lang="en-US" dirty="0"/>
            <a:t>8</a:t>
          </a:r>
        </a:p>
      </dgm:t>
    </dgm:pt>
    <dgm:pt modelId="{18766106-4E88-954F-80B4-8435CD7E3607}" type="parTrans" cxnId="{B4BAA057-82A7-8F4F-B3AE-D2474B9F0D61}">
      <dgm:prSet/>
      <dgm:spPr/>
      <dgm:t>
        <a:bodyPr/>
        <a:lstStyle/>
        <a:p>
          <a:endParaRPr lang="en-US"/>
        </a:p>
      </dgm:t>
    </dgm:pt>
    <dgm:pt modelId="{41CA9CD1-BD05-D240-8585-F6D044F469D5}" type="sibTrans" cxnId="{B4BAA057-82A7-8F4F-B3AE-D2474B9F0D61}">
      <dgm:prSet/>
      <dgm:spPr/>
      <dgm:t>
        <a:bodyPr/>
        <a:lstStyle/>
        <a:p>
          <a:endParaRPr lang="en-US"/>
        </a:p>
      </dgm:t>
    </dgm:pt>
    <dgm:pt modelId="{77E26394-E137-5E44-9434-AC75CD3E8E1C}">
      <dgm:prSet/>
      <dgm:spPr/>
      <dgm:t>
        <a:bodyPr/>
        <a:lstStyle/>
        <a:p>
          <a:r>
            <a:rPr lang="en-US" dirty="0"/>
            <a:t>Align with team</a:t>
          </a:r>
        </a:p>
      </dgm:t>
    </dgm:pt>
    <dgm:pt modelId="{0106416C-C608-3E4B-95A9-3A27F212EF0D}" type="parTrans" cxnId="{3055A850-65BD-2C48-A538-0AAEB9138E85}">
      <dgm:prSet/>
      <dgm:spPr/>
      <dgm:t>
        <a:bodyPr/>
        <a:lstStyle/>
        <a:p>
          <a:endParaRPr lang="en-US"/>
        </a:p>
      </dgm:t>
    </dgm:pt>
    <dgm:pt modelId="{4162CFAB-B676-8E4E-8FEB-32BD16B62DEC}" type="sibTrans" cxnId="{3055A850-65BD-2C48-A538-0AAEB9138E85}">
      <dgm:prSet/>
      <dgm:spPr/>
      <dgm:t>
        <a:bodyPr/>
        <a:lstStyle/>
        <a:p>
          <a:endParaRPr lang="en-US"/>
        </a:p>
      </dgm:t>
    </dgm:pt>
    <dgm:pt modelId="{D6BB4A41-00B2-5448-BB3F-80605AC75A4E}">
      <dgm:prSet/>
      <dgm:spPr/>
      <dgm:t>
        <a:bodyPr/>
        <a:lstStyle/>
        <a:p>
          <a:r>
            <a:rPr lang="en-US" dirty="0"/>
            <a:t>Recenter on care</a:t>
          </a:r>
        </a:p>
      </dgm:t>
    </dgm:pt>
    <dgm:pt modelId="{4E04882C-8060-1D42-8502-5D210AA0DCD3}" type="parTrans" cxnId="{DF1A41C0-D8B8-6D4F-A8A5-91EC68AFBCAD}">
      <dgm:prSet/>
      <dgm:spPr/>
      <dgm:t>
        <a:bodyPr/>
        <a:lstStyle/>
        <a:p>
          <a:endParaRPr lang="en-US"/>
        </a:p>
      </dgm:t>
    </dgm:pt>
    <dgm:pt modelId="{A3F6C628-648D-0249-B65F-551AF9ECEEA6}" type="sibTrans" cxnId="{DF1A41C0-D8B8-6D4F-A8A5-91EC68AFBCAD}">
      <dgm:prSet/>
      <dgm:spPr/>
      <dgm:t>
        <a:bodyPr/>
        <a:lstStyle/>
        <a:p>
          <a:endParaRPr lang="en-US"/>
        </a:p>
      </dgm:t>
    </dgm:pt>
    <dgm:pt modelId="{0545D5E0-C6B3-A447-B001-E955BFE39730}">
      <dgm:prSet/>
      <dgm:spPr/>
      <dgm:t>
        <a:bodyPr/>
        <a:lstStyle/>
        <a:p>
          <a:r>
            <a:rPr lang="en-US" dirty="0"/>
            <a:t>Give space</a:t>
          </a:r>
        </a:p>
      </dgm:t>
    </dgm:pt>
    <dgm:pt modelId="{74548467-254B-2943-9A99-08C07F3E448D}" type="parTrans" cxnId="{E2BB9BC9-6DB1-9443-8E35-6250A99E4AD7}">
      <dgm:prSet/>
      <dgm:spPr/>
      <dgm:t>
        <a:bodyPr/>
        <a:lstStyle/>
        <a:p>
          <a:endParaRPr lang="en-US"/>
        </a:p>
      </dgm:t>
    </dgm:pt>
    <dgm:pt modelId="{43A03E68-4CAE-A344-B58C-38B13B6EE776}" type="sibTrans" cxnId="{E2BB9BC9-6DB1-9443-8E35-6250A99E4AD7}">
      <dgm:prSet/>
      <dgm:spPr/>
      <dgm:t>
        <a:bodyPr/>
        <a:lstStyle/>
        <a:p>
          <a:endParaRPr lang="en-US"/>
        </a:p>
      </dgm:t>
    </dgm:pt>
    <dgm:pt modelId="{4042EA18-93B7-8447-AC0A-58BAED6135AA}">
      <dgm:prSet/>
      <dgm:spPr/>
      <dgm:t>
        <a:bodyPr/>
        <a:lstStyle/>
        <a:p>
          <a:r>
            <a:rPr lang="en-US" dirty="0"/>
            <a:t>Seek support</a:t>
          </a:r>
        </a:p>
      </dgm:t>
    </dgm:pt>
    <dgm:pt modelId="{2F5CB061-56DE-EB4D-BFD4-36B00E6055CB}" type="parTrans" cxnId="{BBBA16DC-BC73-8048-A725-FE1EF1BF6593}">
      <dgm:prSet/>
      <dgm:spPr/>
      <dgm:t>
        <a:bodyPr/>
        <a:lstStyle/>
        <a:p>
          <a:endParaRPr lang="en-US"/>
        </a:p>
      </dgm:t>
    </dgm:pt>
    <dgm:pt modelId="{A608511D-1BB9-EB4E-9E74-CCD7B0DB861D}" type="sibTrans" cxnId="{BBBA16DC-BC73-8048-A725-FE1EF1BF6593}">
      <dgm:prSet/>
      <dgm:spPr/>
      <dgm:t>
        <a:bodyPr/>
        <a:lstStyle/>
        <a:p>
          <a:endParaRPr lang="en-US"/>
        </a:p>
      </dgm:t>
    </dgm:pt>
    <dgm:pt modelId="{B3ABDBBC-28C2-CC44-9EA0-940A074F9BF0}">
      <dgm:prSet/>
      <dgm:spPr/>
      <dgm:t>
        <a:bodyPr/>
        <a:lstStyle/>
        <a:p>
          <a:r>
            <a:rPr lang="en-US" dirty="0"/>
            <a:t>Set boundaries</a:t>
          </a:r>
        </a:p>
      </dgm:t>
    </dgm:pt>
    <dgm:pt modelId="{B1A1C092-087B-F241-9B26-AD1D13C72D4D}" type="sibTrans" cxnId="{D85391B8-F585-FD43-82E0-8ACB9B810BF4}">
      <dgm:prSet/>
      <dgm:spPr/>
      <dgm:t>
        <a:bodyPr/>
        <a:lstStyle/>
        <a:p>
          <a:endParaRPr lang="en-US"/>
        </a:p>
      </dgm:t>
    </dgm:pt>
    <dgm:pt modelId="{D1297B60-D255-DA44-8D75-399213932CFB}" type="parTrans" cxnId="{D85391B8-F585-FD43-82E0-8ACB9B810BF4}">
      <dgm:prSet/>
      <dgm:spPr/>
      <dgm:t>
        <a:bodyPr/>
        <a:lstStyle/>
        <a:p>
          <a:endParaRPr lang="en-US"/>
        </a:p>
      </dgm:t>
    </dgm:pt>
    <dgm:pt modelId="{C651D352-06FA-1B42-81FF-A95099FE5645}" type="pres">
      <dgm:prSet presAssocID="{CE7EC2B3-709C-7049-AC98-40D647A08CD5}" presName="Name0" presStyleCnt="0">
        <dgm:presLayoutVars>
          <dgm:dir/>
          <dgm:animLvl val="lvl"/>
          <dgm:resizeHandles val="exact"/>
        </dgm:presLayoutVars>
      </dgm:prSet>
      <dgm:spPr/>
    </dgm:pt>
    <dgm:pt modelId="{2E2FEDEA-0CB5-FD4B-8718-95B9D6A14304}" type="pres">
      <dgm:prSet presAssocID="{54EB0C78-47D0-4144-BBA1-ED83F2276A80}" presName="linNode" presStyleCnt="0"/>
      <dgm:spPr/>
    </dgm:pt>
    <dgm:pt modelId="{2F0271A3-745A-A943-B67B-E4069A93AE61}" type="pres">
      <dgm:prSet presAssocID="{54EB0C78-47D0-4144-BBA1-ED83F2276A80}" presName="parentText" presStyleLbl="node1" presStyleIdx="0" presStyleCnt="8" custScaleX="67001">
        <dgm:presLayoutVars>
          <dgm:chMax val="1"/>
          <dgm:bulletEnabled val="1"/>
        </dgm:presLayoutVars>
      </dgm:prSet>
      <dgm:spPr/>
    </dgm:pt>
    <dgm:pt modelId="{21D64796-42C1-6A47-B16B-F23C35A117FF}" type="pres">
      <dgm:prSet presAssocID="{54EB0C78-47D0-4144-BBA1-ED83F2276A80}" presName="descendantText" presStyleLbl="alignAccFollowNode1" presStyleIdx="0" presStyleCnt="8">
        <dgm:presLayoutVars>
          <dgm:bulletEnabled val="1"/>
        </dgm:presLayoutVars>
      </dgm:prSet>
      <dgm:spPr/>
    </dgm:pt>
    <dgm:pt modelId="{B2C4C361-6A0B-BC45-90FD-318B0EB08F6D}" type="pres">
      <dgm:prSet presAssocID="{E8376F97-8FAC-AA43-868D-BB3E335B92F2}" presName="sp" presStyleCnt="0"/>
      <dgm:spPr/>
    </dgm:pt>
    <dgm:pt modelId="{277D1FDC-6CD3-BB41-8E20-960C658417CF}" type="pres">
      <dgm:prSet presAssocID="{D03F059F-5021-1F40-A19F-9647158C52AD}" presName="linNode" presStyleCnt="0"/>
      <dgm:spPr/>
    </dgm:pt>
    <dgm:pt modelId="{6CEBA26E-9501-3E41-ACBB-39C96B19A924}" type="pres">
      <dgm:prSet presAssocID="{D03F059F-5021-1F40-A19F-9647158C52AD}" presName="parentText" presStyleLbl="node1" presStyleIdx="1" presStyleCnt="8" custScaleX="67001">
        <dgm:presLayoutVars>
          <dgm:chMax val="1"/>
          <dgm:bulletEnabled val="1"/>
        </dgm:presLayoutVars>
      </dgm:prSet>
      <dgm:spPr/>
    </dgm:pt>
    <dgm:pt modelId="{2EB4DD27-0645-2048-89E9-55CE50FE52DA}" type="pres">
      <dgm:prSet presAssocID="{D03F059F-5021-1F40-A19F-9647158C52AD}" presName="descendantText" presStyleLbl="alignAccFollowNode1" presStyleIdx="1" presStyleCnt="8">
        <dgm:presLayoutVars>
          <dgm:bulletEnabled val="1"/>
        </dgm:presLayoutVars>
      </dgm:prSet>
      <dgm:spPr/>
    </dgm:pt>
    <dgm:pt modelId="{33CCAA17-6648-4F4C-9AC2-5ECE7EDB6E70}" type="pres">
      <dgm:prSet presAssocID="{294C2440-29C3-A948-ADDD-2D4D34880BDD}" presName="sp" presStyleCnt="0"/>
      <dgm:spPr/>
    </dgm:pt>
    <dgm:pt modelId="{B97FC210-8EA1-614A-91AB-916C1AEFBDEE}" type="pres">
      <dgm:prSet presAssocID="{73A345CE-36FD-894D-BBC6-F1148569A643}" presName="linNode" presStyleCnt="0"/>
      <dgm:spPr/>
    </dgm:pt>
    <dgm:pt modelId="{A3A63788-1227-B240-AFF4-87DA3887717D}" type="pres">
      <dgm:prSet presAssocID="{73A345CE-36FD-894D-BBC6-F1148569A643}" presName="parentText" presStyleLbl="node1" presStyleIdx="2" presStyleCnt="8" custScaleX="67001">
        <dgm:presLayoutVars>
          <dgm:chMax val="1"/>
          <dgm:bulletEnabled val="1"/>
        </dgm:presLayoutVars>
      </dgm:prSet>
      <dgm:spPr/>
    </dgm:pt>
    <dgm:pt modelId="{5432570E-A980-7C49-B78B-FBD7E95247D6}" type="pres">
      <dgm:prSet presAssocID="{73A345CE-36FD-894D-BBC6-F1148569A643}" presName="descendantText" presStyleLbl="alignAccFollowNode1" presStyleIdx="2" presStyleCnt="8">
        <dgm:presLayoutVars>
          <dgm:bulletEnabled val="1"/>
        </dgm:presLayoutVars>
      </dgm:prSet>
      <dgm:spPr/>
    </dgm:pt>
    <dgm:pt modelId="{3E055F9F-21A2-424C-8A4E-65EE89C8A916}" type="pres">
      <dgm:prSet presAssocID="{7A99C83F-BC00-3743-81E8-552BD253CEC3}" presName="sp" presStyleCnt="0"/>
      <dgm:spPr/>
    </dgm:pt>
    <dgm:pt modelId="{3D7F3715-4665-FB42-B9D8-1FF06FE7ED04}" type="pres">
      <dgm:prSet presAssocID="{418E94F4-4F87-154C-8C2C-4FA1854F2962}" presName="linNode" presStyleCnt="0"/>
      <dgm:spPr/>
    </dgm:pt>
    <dgm:pt modelId="{F459C834-8503-9C47-9E88-19B5B264D39A}" type="pres">
      <dgm:prSet presAssocID="{418E94F4-4F87-154C-8C2C-4FA1854F2962}" presName="parentText" presStyleLbl="node1" presStyleIdx="3" presStyleCnt="8" custScaleX="67001">
        <dgm:presLayoutVars>
          <dgm:chMax val="1"/>
          <dgm:bulletEnabled val="1"/>
        </dgm:presLayoutVars>
      </dgm:prSet>
      <dgm:spPr/>
    </dgm:pt>
    <dgm:pt modelId="{B11406A9-5BCB-7247-9C38-2B1D2505F2B8}" type="pres">
      <dgm:prSet presAssocID="{418E94F4-4F87-154C-8C2C-4FA1854F2962}" presName="descendantText" presStyleLbl="alignAccFollowNode1" presStyleIdx="3" presStyleCnt="8">
        <dgm:presLayoutVars>
          <dgm:bulletEnabled val="1"/>
        </dgm:presLayoutVars>
      </dgm:prSet>
      <dgm:spPr/>
    </dgm:pt>
    <dgm:pt modelId="{E355AC6F-4099-CB47-B889-4B740E437363}" type="pres">
      <dgm:prSet presAssocID="{A5C1BCA8-59E6-2D47-BF9C-24A0A56844F7}" presName="sp" presStyleCnt="0"/>
      <dgm:spPr/>
    </dgm:pt>
    <dgm:pt modelId="{A60CA7D8-39CB-954A-95BD-9B247DA4C063}" type="pres">
      <dgm:prSet presAssocID="{827957E1-E296-1C4F-A5F6-1C5FE324A00C}" presName="linNode" presStyleCnt="0"/>
      <dgm:spPr/>
    </dgm:pt>
    <dgm:pt modelId="{4D3677DD-203E-6A46-986E-4A5C658C9303}" type="pres">
      <dgm:prSet presAssocID="{827957E1-E296-1C4F-A5F6-1C5FE324A00C}" presName="parentText" presStyleLbl="node1" presStyleIdx="4" presStyleCnt="8" custScaleX="67001">
        <dgm:presLayoutVars>
          <dgm:chMax val="1"/>
          <dgm:bulletEnabled val="1"/>
        </dgm:presLayoutVars>
      </dgm:prSet>
      <dgm:spPr/>
    </dgm:pt>
    <dgm:pt modelId="{DF481026-182D-AB4B-A938-B9E12915351D}" type="pres">
      <dgm:prSet presAssocID="{827957E1-E296-1C4F-A5F6-1C5FE324A00C}" presName="descendantText" presStyleLbl="alignAccFollowNode1" presStyleIdx="4" presStyleCnt="8">
        <dgm:presLayoutVars>
          <dgm:bulletEnabled val="1"/>
        </dgm:presLayoutVars>
      </dgm:prSet>
      <dgm:spPr/>
    </dgm:pt>
    <dgm:pt modelId="{0E9316E9-2C30-AB47-AE90-7E8E046E1AFD}" type="pres">
      <dgm:prSet presAssocID="{9F52F0F0-B16C-AB44-86AF-35AA79D5B0BB}" presName="sp" presStyleCnt="0"/>
      <dgm:spPr/>
    </dgm:pt>
    <dgm:pt modelId="{037794A2-D322-8E40-B011-CE07ECE52AD6}" type="pres">
      <dgm:prSet presAssocID="{9F6E5C8F-12F1-3545-94A6-291C5042E69E}" presName="linNode" presStyleCnt="0"/>
      <dgm:spPr/>
    </dgm:pt>
    <dgm:pt modelId="{B6C279C8-1B63-3845-ADAB-B82AEFA3D8E4}" type="pres">
      <dgm:prSet presAssocID="{9F6E5C8F-12F1-3545-94A6-291C5042E69E}" presName="parentText" presStyleLbl="node1" presStyleIdx="5" presStyleCnt="8" custScaleX="67001">
        <dgm:presLayoutVars>
          <dgm:chMax val="1"/>
          <dgm:bulletEnabled val="1"/>
        </dgm:presLayoutVars>
      </dgm:prSet>
      <dgm:spPr/>
    </dgm:pt>
    <dgm:pt modelId="{95DA0D8B-BC89-0948-909A-C298332DBD75}" type="pres">
      <dgm:prSet presAssocID="{9F6E5C8F-12F1-3545-94A6-291C5042E69E}" presName="descendantText" presStyleLbl="alignAccFollowNode1" presStyleIdx="5" presStyleCnt="8">
        <dgm:presLayoutVars>
          <dgm:bulletEnabled val="1"/>
        </dgm:presLayoutVars>
      </dgm:prSet>
      <dgm:spPr/>
    </dgm:pt>
    <dgm:pt modelId="{05C8E7F6-EE84-404A-A830-A5238A04D5A3}" type="pres">
      <dgm:prSet presAssocID="{F501E3C1-886B-5244-A7B1-7A80D72A4D8C}" presName="sp" presStyleCnt="0"/>
      <dgm:spPr/>
    </dgm:pt>
    <dgm:pt modelId="{450D1F74-F684-8F4C-A8B3-6F8B553AB682}" type="pres">
      <dgm:prSet presAssocID="{02BDF100-8338-E043-96F5-EE898B9D5AB2}" presName="linNode" presStyleCnt="0"/>
      <dgm:spPr/>
    </dgm:pt>
    <dgm:pt modelId="{B67BA8B7-08DC-C244-8300-FCD547033DBD}" type="pres">
      <dgm:prSet presAssocID="{02BDF100-8338-E043-96F5-EE898B9D5AB2}" presName="parentText" presStyleLbl="node1" presStyleIdx="6" presStyleCnt="8" custScaleX="67001">
        <dgm:presLayoutVars>
          <dgm:chMax val="1"/>
          <dgm:bulletEnabled val="1"/>
        </dgm:presLayoutVars>
      </dgm:prSet>
      <dgm:spPr/>
    </dgm:pt>
    <dgm:pt modelId="{9D2B4FF6-13FB-EF49-977A-31DF5EE58099}" type="pres">
      <dgm:prSet presAssocID="{02BDF100-8338-E043-96F5-EE898B9D5AB2}" presName="descendantText" presStyleLbl="alignAccFollowNode1" presStyleIdx="6" presStyleCnt="8">
        <dgm:presLayoutVars>
          <dgm:bulletEnabled val="1"/>
        </dgm:presLayoutVars>
      </dgm:prSet>
      <dgm:spPr/>
    </dgm:pt>
    <dgm:pt modelId="{580F7313-AC0F-FA49-A45E-0C9486F52D6E}" type="pres">
      <dgm:prSet presAssocID="{BCE247F3-63ED-824C-BC43-9D645F88694B}" presName="sp" presStyleCnt="0"/>
      <dgm:spPr/>
    </dgm:pt>
    <dgm:pt modelId="{E737A561-EB87-EC46-B404-0D8CDB0DE287}" type="pres">
      <dgm:prSet presAssocID="{7CF6944D-D814-F446-BDE2-B55C1C344687}" presName="linNode" presStyleCnt="0"/>
      <dgm:spPr/>
    </dgm:pt>
    <dgm:pt modelId="{D5D04DA4-D0C2-DE47-8C8C-0B8EFFA304FE}" type="pres">
      <dgm:prSet presAssocID="{7CF6944D-D814-F446-BDE2-B55C1C344687}" presName="parentText" presStyleLbl="node1" presStyleIdx="7" presStyleCnt="8" custScaleX="67001">
        <dgm:presLayoutVars>
          <dgm:chMax val="1"/>
          <dgm:bulletEnabled val="1"/>
        </dgm:presLayoutVars>
      </dgm:prSet>
      <dgm:spPr/>
    </dgm:pt>
    <dgm:pt modelId="{8CF3EAF4-8574-9841-9B3E-4FBF8CB57172}" type="pres">
      <dgm:prSet presAssocID="{7CF6944D-D814-F446-BDE2-B55C1C344687}" presName="descendantText" presStyleLbl="alignAccFollowNode1" presStyleIdx="7" presStyleCnt="8">
        <dgm:presLayoutVars>
          <dgm:bulletEnabled val="1"/>
        </dgm:presLayoutVars>
      </dgm:prSet>
      <dgm:spPr/>
    </dgm:pt>
  </dgm:ptLst>
  <dgm:cxnLst>
    <dgm:cxn modelId="{E4273A05-E6BD-7B48-BAB7-FF2C885BDD30}" type="presOf" srcId="{02BDF100-8338-E043-96F5-EE898B9D5AB2}" destId="{B67BA8B7-08DC-C244-8300-FCD547033DBD}" srcOrd="0" destOrd="0" presId="urn:microsoft.com/office/officeart/2005/8/layout/vList5"/>
    <dgm:cxn modelId="{E9D1E10C-1628-524C-9321-D84C071FF74D}" type="presOf" srcId="{CE7EC2B3-709C-7049-AC98-40D647A08CD5}" destId="{C651D352-06FA-1B42-81FF-A95099FE5645}" srcOrd="0" destOrd="0" presId="urn:microsoft.com/office/officeart/2005/8/layout/vList5"/>
    <dgm:cxn modelId="{C4160712-DF53-0F4F-9BBA-78BD9BBF4B88}" type="presOf" srcId="{77E26394-E137-5E44-9434-AC75CD3E8E1C}" destId="{B11406A9-5BCB-7247-9C38-2B1D2505F2B8}" srcOrd="0" destOrd="0" presId="urn:microsoft.com/office/officeart/2005/8/layout/vList5"/>
    <dgm:cxn modelId="{C5A31E1B-1939-A943-9EA9-0D1F931C9095}" srcId="{CE7EC2B3-709C-7049-AC98-40D647A08CD5}" destId="{827957E1-E296-1C4F-A5F6-1C5FE324A00C}" srcOrd="4" destOrd="0" parTransId="{AC89EDA2-97A0-704F-A224-66777968DC79}" sibTransId="{9F52F0F0-B16C-AB44-86AF-35AA79D5B0BB}"/>
    <dgm:cxn modelId="{086EAA1D-3224-4E41-87B1-9FA27037DE47}" type="presOf" srcId="{9F6E5C8F-12F1-3545-94A6-291C5042E69E}" destId="{B6C279C8-1B63-3845-ADAB-B82AEFA3D8E4}" srcOrd="0" destOrd="0" presId="urn:microsoft.com/office/officeart/2005/8/layout/vList5"/>
    <dgm:cxn modelId="{71BBC71D-E55C-424F-B6C9-6E507D91D4E5}" type="presOf" srcId="{D6BB4A41-00B2-5448-BB3F-80605AC75A4E}" destId="{95DA0D8B-BC89-0948-909A-C298332DBD75}" srcOrd="0" destOrd="0" presId="urn:microsoft.com/office/officeart/2005/8/layout/vList5"/>
    <dgm:cxn modelId="{7A4CD21E-5C30-9844-B8CC-04D4CC71350C}" type="presOf" srcId="{4042EA18-93B7-8447-AC0A-58BAED6135AA}" destId="{8CF3EAF4-8574-9841-9B3E-4FBF8CB57172}" srcOrd="0" destOrd="0" presId="urn:microsoft.com/office/officeart/2005/8/layout/vList5"/>
    <dgm:cxn modelId="{EA0CCB2E-33A7-7842-AF42-FDB163C3A0DB}" type="presOf" srcId="{8E966A69-49F1-5E4B-B606-FCAEDAA984ED}" destId="{2EB4DD27-0645-2048-89E9-55CE50FE52DA}" srcOrd="0" destOrd="0" presId="urn:microsoft.com/office/officeart/2005/8/layout/vList5"/>
    <dgm:cxn modelId="{65CEA44F-9E16-EA4E-A309-EC3B3016297A}" srcId="{CE7EC2B3-709C-7049-AC98-40D647A08CD5}" destId="{D03F059F-5021-1F40-A19F-9647158C52AD}" srcOrd="1" destOrd="0" parTransId="{CF000D09-B476-0444-AE02-AACE5A32ABB9}" sibTransId="{294C2440-29C3-A948-ADDD-2D4D34880BDD}"/>
    <dgm:cxn modelId="{2BBF3C50-1ED6-9847-B76B-936F9EDE5606}" srcId="{CE7EC2B3-709C-7049-AC98-40D647A08CD5}" destId="{418E94F4-4F87-154C-8C2C-4FA1854F2962}" srcOrd="3" destOrd="0" parTransId="{67B29BF1-08A2-E04F-9D69-0598739CF13B}" sibTransId="{A5C1BCA8-59E6-2D47-BF9C-24A0A56844F7}"/>
    <dgm:cxn modelId="{3055A850-65BD-2C48-A538-0AAEB9138E85}" srcId="{418E94F4-4F87-154C-8C2C-4FA1854F2962}" destId="{77E26394-E137-5E44-9434-AC75CD3E8E1C}" srcOrd="0" destOrd="0" parTransId="{0106416C-C608-3E4B-95A9-3A27F212EF0D}" sibTransId="{4162CFAB-B676-8E4E-8FEB-32BD16B62DEC}"/>
    <dgm:cxn modelId="{B3273152-AF0F-EE4B-8C28-8B1E95E5CD89}" type="presOf" srcId="{E900B89A-C42B-5249-B68C-A3D7ECDC2722}" destId="{5432570E-A980-7C49-B78B-FBD7E95247D6}" srcOrd="0" destOrd="0" presId="urn:microsoft.com/office/officeart/2005/8/layout/vList5"/>
    <dgm:cxn modelId="{90712D57-061F-8444-BA8A-D8DA5E4630C5}" type="presOf" srcId="{73A345CE-36FD-894D-BBC6-F1148569A643}" destId="{A3A63788-1227-B240-AFF4-87DA3887717D}" srcOrd="0" destOrd="0" presId="urn:microsoft.com/office/officeart/2005/8/layout/vList5"/>
    <dgm:cxn modelId="{B4BAA057-82A7-8F4F-B3AE-D2474B9F0D61}" srcId="{CE7EC2B3-709C-7049-AC98-40D647A08CD5}" destId="{7CF6944D-D814-F446-BDE2-B55C1C344687}" srcOrd="7" destOrd="0" parTransId="{18766106-4E88-954F-80B4-8435CD7E3607}" sibTransId="{41CA9CD1-BD05-D240-8585-F6D044F469D5}"/>
    <dgm:cxn modelId="{BAD62360-A798-6A47-A994-B5126C6DDBBA}" type="presOf" srcId="{D57A6E2B-1DF9-5046-BC1D-709A01F64D7F}" destId="{21D64796-42C1-6A47-B16B-F23C35A117FF}" srcOrd="0" destOrd="0" presId="urn:microsoft.com/office/officeart/2005/8/layout/vList5"/>
    <dgm:cxn modelId="{F6183E77-6BBF-FA47-854D-F0D53AE21A8A}" srcId="{CE7EC2B3-709C-7049-AC98-40D647A08CD5}" destId="{02BDF100-8338-E043-96F5-EE898B9D5AB2}" srcOrd="6" destOrd="0" parTransId="{1B53CCA0-CFF2-384B-856E-1EBDFA4D02AD}" sibTransId="{BCE247F3-63ED-824C-BC43-9D645F88694B}"/>
    <dgm:cxn modelId="{89198578-5DCB-6140-878F-E9FD8D67271F}" type="presOf" srcId="{7CF6944D-D814-F446-BDE2-B55C1C344687}" destId="{D5D04DA4-D0C2-DE47-8C8C-0B8EFFA304FE}" srcOrd="0" destOrd="0" presId="urn:microsoft.com/office/officeart/2005/8/layout/vList5"/>
    <dgm:cxn modelId="{408ED183-BF58-1C4B-97FD-732582625FEF}" srcId="{CE7EC2B3-709C-7049-AC98-40D647A08CD5}" destId="{73A345CE-36FD-894D-BBC6-F1148569A643}" srcOrd="2" destOrd="0" parTransId="{E3B27BD6-FBE2-5640-8D4A-26A5222CC3EA}" sibTransId="{7A99C83F-BC00-3743-81E8-552BD253CEC3}"/>
    <dgm:cxn modelId="{B2C59790-5949-8740-B37D-5567793C306C}" srcId="{54EB0C78-47D0-4144-BBA1-ED83F2276A80}" destId="{D57A6E2B-1DF9-5046-BC1D-709A01F64D7F}" srcOrd="0" destOrd="0" parTransId="{C76AEE8B-D94A-7D44-B03A-3FE0785274DD}" sibTransId="{55132C62-F393-2540-A3F5-1E79E69F36CF}"/>
    <dgm:cxn modelId="{2D83CF9B-C8D2-5645-B148-7557D123AE42}" type="presOf" srcId="{827957E1-E296-1C4F-A5F6-1C5FE324A00C}" destId="{4D3677DD-203E-6A46-986E-4A5C658C9303}" srcOrd="0" destOrd="0" presId="urn:microsoft.com/office/officeart/2005/8/layout/vList5"/>
    <dgm:cxn modelId="{D734F3A8-F28E-EC4B-833E-A76A8DF839E2}" type="presOf" srcId="{D03F059F-5021-1F40-A19F-9647158C52AD}" destId="{6CEBA26E-9501-3E41-ACBB-39C96B19A924}" srcOrd="0" destOrd="0" presId="urn:microsoft.com/office/officeart/2005/8/layout/vList5"/>
    <dgm:cxn modelId="{8EA459AB-225B-8C4D-9825-5D1C6BF10277}" srcId="{73A345CE-36FD-894D-BBC6-F1148569A643}" destId="{E900B89A-C42B-5249-B68C-A3D7ECDC2722}" srcOrd="0" destOrd="0" parTransId="{8E839505-C7B5-E846-B572-409C6E14F87D}" sibTransId="{1CCB8A03-5593-CE44-86BA-AACEAE0CCB98}"/>
    <dgm:cxn modelId="{54AEA8B7-F89B-724F-98A1-0AEC5D7FC3A2}" srcId="{CE7EC2B3-709C-7049-AC98-40D647A08CD5}" destId="{54EB0C78-47D0-4144-BBA1-ED83F2276A80}" srcOrd="0" destOrd="0" parTransId="{46A28A5B-8A7C-BF49-A5DC-996D874F74B0}" sibTransId="{E8376F97-8FAC-AA43-868D-BB3E335B92F2}"/>
    <dgm:cxn modelId="{D85391B8-F585-FD43-82E0-8ACB9B810BF4}" srcId="{827957E1-E296-1C4F-A5F6-1C5FE324A00C}" destId="{B3ABDBBC-28C2-CC44-9EA0-940A074F9BF0}" srcOrd="0" destOrd="0" parTransId="{D1297B60-D255-DA44-8D75-399213932CFB}" sibTransId="{B1A1C092-087B-F241-9B26-AD1D13C72D4D}"/>
    <dgm:cxn modelId="{DF1A41C0-D8B8-6D4F-A8A5-91EC68AFBCAD}" srcId="{9F6E5C8F-12F1-3545-94A6-291C5042E69E}" destId="{D6BB4A41-00B2-5448-BB3F-80605AC75A4E}" srcOrd="0" destOrd="0" parTransId="{4E04882C-8060-1D42-8502-5D210AA0DCD3}" sibTransId="{A3F6C628-648D-0249-B65F-551AF9ECEEA6}"/>
    <dgm:cxn modelId="{F2E046C8-391B-6946-ACE6-697EC224AB98}" type="presOf" srcId="{B3ABDBBC-28C2-CC44-9EA0-940A074F9BF0}" destId="{DF481026-182D-AB4B-A938-B9E12915351D}" srcOrd="0" destOrd="0" presId="urn:microsoft.com/office/officeart/2005/8/layout/vList5"/>
    <dgm:cxn modelId="{E2BB9BC9-6DB1-9443-8E35-6250A99E4AD7}" srcId="{02BDF100-8338-E043-96F5-EE898B9D5AB2}" destId="{0545D5E0-C6B3-A447-B001-E955BFE39730}" srcOrd="0" destOrd="0" parTransId="{74548467-254B-2943-9A99-08C07F3E448D}" sibTransId="{43A03E68-4CAE-A344-B58C-38B13B6EE776}"/>
    <dgm:cxn modelId="{A16837DB-2A15-1C45-807B-67AB4EF8E75E}" type="presOf" srcId="{0545D5E0-C6B3-A447-B001-E955BFE39730}" destId="{9D2B4FF6-13FB-EF49-977A-31DF5EE58099}" srcOrd="0" destOrd="0" presId="urn:microsoft.com/office/officeart/2005/8/layout/vList5"/>
    <dgm:cxn modelId="{BBBA16DC-BC73-8048-A725-FE1EF1BF6593}" srcId="{7CF6944D-D814-F446-BDE2-B55C1C344687}" destId="{4042EA18-93B7-8447-AC0A-58BAED6135AA}" srcOrd="0" destOrd="0" parTransId="{2F5CB061-56DE-EB4D-BFD4-36B00E6055CB}" sibTransId="{A608511D-1BB9-EB4E-9E74-CCD7B0DB861D}"/>
    <dgm:cxn modelId="{545F95DE-9A10-3948-9807-36C195D34A35}" srcId="{CE7EC2B3-709C-7049-AC98-40D647A08CD5}" destId="{9F6E5C8F-12F1-3545-94A6-291C5042E69E}" srcOrd="5" destOrd="0" parTransId="{F878F1E0-BA83-0B4F-8407-D69A3E0606E8}" sibTransId="{F501E3C1-886B-5244-A7B1-7A80D72A4D8C}"/>
    <dgm:cxn modelId="{1AC639E1-2DD4-8C49-9596-C5731579DC3A}" type="presOf" srcId="{54EB0C78-47D0-4144-BBA1-ED83F2276A80}" destId="{2F0271A3-745A-A943-B67B-E4069A93AE61}" srcOrd="0" destOrd="0" presId="urn:microsoft.com/office/officeart/2005/8/layout/vList5"/>
    <dgm:cxn modelId="{FBB45EE4-904A-AF48-A0C9-CB655E66EF52}" srcId="{D03F059F-5021-1F40-A19F-9647158C52AD}" destId="{8E966A69-49F1-5E4B-B606-FCAEDAA984ED}" srcOrd="0" destOrd="0" parTransId="{DBAD8E5C-BD8A-8D4C-B4F0-8493200D7696}" sibTransId="{6E022D76-54D3-5040-BFB1-6E3CF648085C}"/>
    <dgm:cxn modelId="{CE4D51EC-1171-9740-9774-3550157EF9C1}" type="presOf" srcId="{418E94F4-4F87-154C-8C2C-4FA1854F2962}" destId="{F459C834-8503-9C47-9E88-19B5B264D39A}" srcOrd="0" destOrd="0" presId="urn:microsoft.com/office/officeart/2005/8/layout/vList5"/>
    <dgm:cxn modelId="{BF236B13-02D1-B64C-986F-0CAF7E0612E5}" type="presParOf" srcId="{C651D352-06FA-1B42-81FF-A95099FE5645}" destId="{2E2FEDEA-0CB5-FD4B-8718-95B9D6A14304}" srcOrd="0" destOrd="0" presId="urn:microsoft.com/office/officeart/2005/8/layout/vList5"/>
    <dgm:cxn modelId="{9578A504-AB23-5044-A923-D3DEFAE4D5E7}" type="presParOf" srcId="{2E2FEDEA-0CB5-FD4B-8718-95B9D6A14304}" destId="{2F0271A3-745A-A943-B67B-E4069A93AE61}" srcOrd="0" destOrd="0" presId="urn:microsoft.com/office/officeart/2005/8/layout/vList5"/>
    <dgm:cxn modelId="{253C94D8-1885-B543-AF3D-F6A1DD424873}" type="presParOf" srcId="{2E2FEDEA-0CB5-FD4B-8718-95B9D6A14304}" destId="{21D64796-42C1-6A47-B16B-F23C35A117FF}" srcOrd="1" destOrd="0" presId="urn:microsoft.com/office/officeart/2005/8/layout/vList5"/>
    <dgm:cxn modelId="{C06B9A2B-4F20-7C45-806D-5E7956B4F171}" type="presParOf" srcId="{C651D352-06FA-1B42-81FF-A95099FE5645}" destId="{B2C4C361-6A0B-BC45-90FD-318B0EB08F6D}" srcOrd="1" destOrd="0" presId="urn:microsoft.com/office/officeart/2005/8/layout/vList5"/>
    <dgm:cxn modelId="{7BF712B5-32BC-7844-BF86-9BFE0BE03182}" type="presParOf" srcId="{C651D352-06FA-1B42-81FF-A95099FE5645}" destId="{277D1FDC-6CD3-BB41-8E20-960C658417CF}" srcOrd="2" destOrd="0" presId="urn:microsoft.com/office/officeart/2005/8/layout/vList5"/>
    <dgm:cxn modelId="{8EE30A21-17AC-A34E-A945-33D32D0CD928}" type="presParOf" srcId="{277D1FDC-6CD3-BB41-8E20-960C658417CF}" destId="{6CEBA26E-9501-3E41-ACBB-39C96B19A924}" srcOrd="0" destOrd="0" presId="urn:microsoft.com/office/officeart/2005/8/layout/vList5"/>
    <dgm:cxn modelId="{3CCA96C7-C68E-DA49-A8B4-DD728A5A5A21}" type="presParOf" srcId="{277D1FDC-6CD3-BB41-8E20-960C658417CF}" destId="{2EB4DD27-0645-2048-89E9-55CE50FE52DA}" srcOrd="1" destOrd="0" presId="urn:microsoft.com/office/officeart/2005/8/layout/vList5"/>
    <dgm:cxn modelId="{4AF2BADF-B9C1-834B-AC41-60901F7D6D95}" type="presParOf" srcId="{C651D352-06FA-1B42-81FF-A95099FE5645}" destId="{33CCAA17-6648-4F4C-9AC2-5ECE7EDB6E70}" srcOrd="3" destOrd="0" presId="urn:microsoft.com/office/officeart/2005/8/layout/vList5"/>
    <dgm:cxn modelId="{2A4E440E-B7D6-6B49-8318-F6B71A21E6CF}" type="presParOf" srcId="{C651D352-06FA-1B42-81FF-A95099FE5645}" destId="{B97FC210-8EA1-614A-91AB-916C1AEFBDEE}" srcOrd="4" destOrd="0" presId="urn:microsoft.com/office/officeart/2005/8/layout/vList5"/>
    <dgm:cxn modelId="{2BDD0334-A1D2-DC42-B9D1-68F24D23B5D5}" type="presParOf" srcId="{B97FC210-8EA1-614A-91AB-916C1AEFBDEE}" destId="{A3A63788-1227-B240-AFF4-87DA3887717D}" srcOrd="0" destOrd="0" presId="urn:microsoft.com/office/officeart/2005/8/layout/vList5"/>
    <dgm:cxn modelId="{C69877D5-79C1-9F4C-B7F4-8AD7D15754EE}" type="presParOf" srcId="{B97FC210-8EA1-614A-91AB-916C1AEFBDEE}" destId="{5432570E-A980-7C49-B78B-FBD7E95247D6}" srcOrd="1" destOrd="0" presId="urn:microsoft.com/office/officeart/2005/8/layout/vList5"/>
    <dgm:cxn modelId="{33ACEA31-C6CD-5547-BED3-2458723FCA4A}" type="presParOf" srcId="{C651D352-06FA-1B42-81FF-A95099FE5645}" destId="{3E055F9F-21A2-424C-8A4E-65EE89C8A916}" srcOrd="5" destOrd="0" presId="urn:microsoft.com/office/officeart/2005/8/layout/vList5"/>
    <dgm:cxn modelId="{A37DA9BE-A47E-BB4D-9CC1-632CE186629D}" type="presParOf" srcId="{C651D352-06FA-1B42-81FF-A95099FE5645}" destId="{3D7F3715-4665-FB42-B9D8-1FF06FE7ED04}" srcOrd="6" destOrd="0" presId="urn:microsoft.com/office/officeart/2005/8/layout/vList5"/>
    <dgm:cxn modelId="{C891109C-0686-B74F-8141-60300585C701}" type="presParOf" srcId="{3D7F3715-4665-FB42-B9D8-1FF06FE7ED04}" destId="{F459C834-8503-9C47-9E88-19B5B264D39A}" srcOrd="0" destOrd="0" presId="urn:microsoft.com/office/officeart/2005/8/layout/vList5"/>
    <dgm:cxn modelId="{2F31821D-0811-794B-B121-3DE9146709AD}" type="presParOf" srcId="{3D7F3715-4665-FB42-B9D8-1FF06FE7ED04}" destId="{B11406A9-5BCB-7247-9C38-2B1D2505F2B8}" srcOrd="1" destOrd="0" presId="urn:microsoft.com/office/officeart/2005/8/layout/vList5"/>
    <dgm:cxn modelId="{0F8FFFCC-28B5-A844-A0C0-4277188A3AC8}" type="presParOf" srcId="{C651D352-06FA-1B42-81FF-A95099FE5645}" destId="{E355AC6F-4099-CB47-B889-4B740E437363}" srcOrd="7" destOrd="0" presId="urn:microsoft.com/office/officeart/2005/8/layout/vList5"/>
    <dgm:cxn modelId="{53EF242F-1951-6046-AB59-C18248626329}" type="presParOf" srcId="{C651D352-06FA-1B42-81FF-A95099FE5645}" destId="{A60CA7D8-39CB-954A-95BD-9B247DA4C063}" srcOrd="8" destOrd="0" presId="urn:microsoft.com/office/officeart/2005/8/layout/vList5"/>
    <dgm:cxn modelId="{ED3BF37E-4F96-D544-B638-C0AB83F1A9B4}" type="presParOf" srcId="{A60CA7D8-39CB-954A-95BD-9B247DA4C063}" destId="{4D3677DD-203E-6A46-986E-4A5C658C9303}" srcOrd="0" destOrd="0" presId="urn:microsoft.com/office/officeart/2005/8/layout/vList5"/>
    <dgm:cxn modelId="{5F05AF10-2999-E74B-852A-D64954D94FF8}" type="presParOf" srcId="{A60CA7D8-39CB-954A-95BD-9B247DA4C063}" destId="{DF481026-182D-AB4B-A938-B9E12915351D}" srcOrd="1" destOrd="0" presId="urn:microsoft.com/office/officeart/2005/8/layout/vList5"/>
    <dgm:cxn modelId="{ACD94F81-0016-934D-9BD5-68D8F780E3B7}" type="presParOf" srcId="{C651D352-06FA-1B42-81FF-A95099FE5645}" destId="{0E9316E9-2C30-AB47-AE90-7E8E046E1AFD}" srcOrd="9" destOrd="0" presId="urn:microsoft.com/office/officeart/2005/8/layout/vList5"/>
    <dgm:cxn modelId="{F8E487A0-A252-584F-8A38-3822D4AF8219}" type="presParOf" srcId="{C651D352-06FA-1B42-81FF-A95099FE5645}" destId="{037794A2-D322-8E40-B011-CE07ECE52AD6}" srcOrd="10" destOrd="0" presId="urn:microsoft.com/office/officeart/2005/8/layout/vList5"/>
    <dgm:cxn modelId="{67548826-ED42-6242-AA6A-DBBB72691D13}" type="presParOf" srcId="{037794A2-D322-8E40-B011-CE07ECE52AD6}" destId="{B6C279C8-1B63-3845-ADAB-B82AEFA3D8E4}" srcOrd="0" destOrd="0" presId="urn:microsoft.com/office/officeart/2005/8/layout/vList5"/>
    <dgm:cxn modelId="{B87CE2C3-5909-4C4E-A75A-B68815D3150A}" type="presParOf" srcId="{037794A2-D322-8E40-B011-CE07ECE52AD6}" destId="{95DA0D8B-BC89-0948-909A-C298332DBD75}" srcOrd="1" destOrd="0" presId="urn:microsoft.com/office/officeart/2005/8/layout/vList5"/>
    <dgm:cxn modelId="{B702A7F2-2B11-8D48-B9AE-A25D0DE633A1}" type="presParOf" srcId="{C651D352-06FA-1B42-81FF-A95099FE5645}" destId="{05C8E7F6-EE84-404A-A830-A5238A04D5A3}" srcOrd="11" destOrd="0" presId="urn:microsoft.com/office/officeart/2005/8/layout/vList5"/>
    <dgm:cxn modelId="{5D36C750-8050-AB49-B923-84B64CB9D59C}" type="presParOf" srcId="{C651D352-06FA-1B42-81FF-A95099FE5645}" destId="{450D1F74-F684-8F4C-A8B3-6F8B553AB682}" srcOrd="12" destOrd="0" presId="urn:microsoft.com/office/officeart/2005/8/layout/vList5"/>
    <dgm:cxn modelId="{69DDD68C-0D88-6141-B93A-2DFC27495FCF}" type="presParOf" srcId="{450D1F74-F684-8F4C-A8B3-6F8B553AB682}" destId="{B67BA8B7-08DC-C244-8300-FCD547033DBD}" srcOrd="0" destOrd="0" presId="urn:microsoft.com/office/officeart/2005/8/layout/vList5"/>
    <dgm:cxn modelId="{772109BC-D0C5-5C47-B68B-C1F238D6D77F}" type="presParOf" srcId="{450D1F74-F684-8F4C-A8B3-6F8B553AB682}" destId="{9D2B4FF6-13FB-EF49-977A-31DF5EE58099}" srcOrd="1" destOrd="0" presId="urn:microsoft.com/office/officeart/2005/8/layout/vList5"/>
    <dgm:cxn modelId="{5EBAD0AC-A244-A44E-ADFB-53F20C58044C}" type="presParOf" srcId="{C651D352-06FA-1B42-81FF-A95099FE5645}" destId="{580F7313-AC0F-FA49-A45E-0C9486F52D6E}" srcOrd="13" destOrd="0" presId="urn:microsoft.com/office/officeart/2005/8/layout/vList5"/>
    <dgm:cxn modelId="{6E9922E5-478F-AF4D-9DCA-7A72508F4F6D}" type="presParOf" srcId="{C651D352-06FA-1B42-81FF-A95099FE5645}" destId="{E737A561-EB87-EC46-B404-0D8CDB0DE287}" srcOrd="14" destOrd="0" presId="urn:microsoft.com/office/officeart/2005/8/layout/vList5"/>
    <dgm:cxn modelId="{8E470ECC-4731-EF49-B2A8-AD4470B8AD53}" type="presParOf" srcId="{E737A561-EB87-EC46-B404-0D8CDB0DE287}" destId="{D5D04DA4-D0C2-DE47-8C8C-0B8EFFA304FE}" srcOrd="0" destOrd="0" presId="urn:microsoft.com/office/officeart/2005/8/layout/vList5"/>
    <dgm:cxn modelId="{B9608D4F-B546-F142-90CB-D6437FE05ACF}" type="presParOf" srcId="{E737A561-EB87-EC46-B404-0D8CDB0DE287}" destId="{8CF3EAF4-8574-9841-9B3E-4FBF8CB57172}"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CE7EC2B3-709C-7049-AC98-40D647A08CD5}" type="doc">
      <dgm:prSet loTypeId="urn:microsoft.com/office/officeart/2005/8/layout/vList5" loCatId="" qsTypeId="urn:microsoft.com/office/officeart/2005/8/quickstyle/simple1" qsCatId="simple" csTypeId="urn:microsoft.com/office/officeart/2005/8/colors/accent1_2" csCatId="accent1" phldr="1"/>
      <dgm:spPr/>
      <dgm:t>
        <a:bodyPr/>
        <a:lstStyle/>
        <a:p>
          <a:endParaRPr lang="en-US"/>
        </a:p>
      </dgm:t>
    </dgm:pt>
    <dgm:pt modelId="{54EB0C78-47D0-4144-BBA1-ED83F2276A80}">
      <dgm:prSet phldrT="[Text]"/>
      <dgm:spPr/>
      <dgm:t>
        <a:bodyPr/>
        <a:lstStyle/>
        <a:p>
          <a:r>
            <a:rPr lang="en-US" dirty="0"/>
            <a:t>1</a:t>
          </a:r>
        </a:p>
      </dgm:t>
    </dgm:pt>
    <dgm:pt modelId="{46A28A5B-8A7C-BF49-A5DC-996D874F74B0}" type="parTrans" cxnId="{54AEA8B7-F89B-724F-98A1-0AEC5D7FC3A2}">
      <dgm:prSet/>
      <dgm:spPr/>
      <dgm:t>
        <a:bodyPr/>
        <a:lstStyle/>
        <a:p>
          <a:endParaRPr lang="en-US"/>
        </a:p>
      </dgm:t>
    </dgm:pt>
    <dgm:pt modelId="{E8376F97-8FAC-AA43-868D-BB3E335B92F2}" type="sibTrans" cxnId="{54AEA8B7-F89B-724F-98A1-0AEC5D7FC3A2}">
      <dgm:prSet/>
      <dgm:spPr/>
      <dgm:t>
        <a:bodyPr/>
        <a:lstStyle/>
        <a:p>
          <a:endParaRPr lang="en-US"/>
        </a:p>
      </dgm:t>
    </dgm:pt>
    <dgm:pt modelId="{D57A6E2B-1DF9-5046-BC1D-709A01F64D7F}">
      <dgm:prSet phldrT="[Text]"/>
      <dgm:spPr/>
      <dgm:t>
        <a:bodyPr/>
        <a:lstStyle/>
        <a:p>
          <a:r>
            <a:rPr lang="en-US"/>
            <a:t>Patient stability</a:t>
          </a:r>
          <a:endParaRPr lang="en-US" dirty="0"/>
        </a:p>
      </dgm:t>
    </dgm:pt>
    <dgm:pt modelId="{C76AEE8B-D94A-7D44-B03A-3FE0785274DD}" type="parTrans" cxnId="{B2C59790-5949-8740-B37D-5567793C306C}">
      <dgm:prSet/>
      <dgm:spPr/>
      <dgm:t>
        <a:bodyPr/>
        <a:lstStyle/>
        <a:p>
          <a:endParaRPr lang="en-US"/>
        </a:p>
      </dgm:t>
    </dgm:pt>
    <dgm:pt modelId="{55132C62-F393-2540-A3F5-1E79E69F36CF}" type="sibTrans" cxnId="{B2C59790-5949-8740-B37D-5567793C306C}">
      <dgm:prSet/>
      <dgm:spPr/>
      <dgm:t>
        <a:bodyPr/>
        <a:lstStyle/>
        <a:p>
          <a:endParaRPr lang="en-US"/>
        </a:p>
      </dgm:t>
    </dgm:pt>
    <dgm:pt modelId="{D03F059F-5021-1F40-A19F-9647158C52AD}">
      <dgm:prSet phldrT="[Text]"/>
      <dgm:spPr/>
      <dgm:t>
        <a:bodyPr/>
        <a:lstStyle/>
        <a:p>
          <a:r>
            <a:rPr lang="en-US" dirty="0"/>
            <a:t>2</a:t>
          </a:r>
        </a:p>
      </dgm:t>
    </dgm:pt>
    <dgm:pt modelId="{CF000D09-B476-0444-AE02-AACE5A32ABB9}" type="parTrans" cxnId="{65CEA44F-9E16-EA4E-A309-EC3B3016297A}">
      <dgm:prSet/>
      <dgm:spPr/>
      <dgm:t>
        <a:bodyPr/>
        <a:lstStyle/>
        <a:p>
          <a:endParaRPr lang="en-US"/>
        </a:p>
      </dgm:t>
    </dgm:pt>
    <dgm:pt modelId="{294C2440-29C3-A948-ADDD-2D4D34880BDD}" type="sibTrans" cxnId="{65CEA44F-9E16-EA4E-A309-EC3B3016297A}">
      <dgm:prSet/>
      <dgm:spPr/>
      <dgm:t>
        <a:bodyPr/>
        <a:lstStyle/>
        <a:p>
          <a:endParaRPr lang="en-US"/>
        </a:p>
      </dgm:t>
    </dgm:pt>
    <dgm:pt modelId="{8E966A69-49F1-5E4B-B606-FCAEDAA984ED}">
      <dgm:prSet phldrT="[Text]"/>
      <dgm:spPr/>
      <dgm:t>
        <a:bodyPr/>
        <a:lstStyle/>
        <a:p>
          <a:r>
            <a:rPr lang="en-US" dirty="0"/>
            <a:t>Emotional check</a:t>
          </a:r>
        </a:p>
      </dgm:t>
    </dgm:pt>
    <dgm:pt modelId="{DBAD8E5C-BD8A-8D4C-B4F0-8493200D7696}" type="parTrans" cxnId="{FBB45EE4-904A-AF48-A0C9-CB655E66EF52}">
      <dgm:prSet/>
      <dgm:spPr/>
      <dgm:t>
        <a:bodyPr/>
        <a:lstStyle/>
        <a:p>
          <a:endParaRPr lang="en-US"/>
        </a:p>
      </dgm:t>
    </dgm:pt>
    <dgm:pt modelId="{6E022D76-54D3-5040-BFB1-6E3CF648085C}" type="sibTrans" cxnId="{FBB45EE4-904A-AF48-A0C9-CB655E66EF52}">
      <dgm:prSet/>
      <dgm:spPr/>
      <dgm:t>
        <a:bodyPr/>
        <a:lstStyle/>
        <a:p>
          <a:endParaRPr lang="en-US"/>
        </a:p>
      </dgm:t>
    </dgm:pt>
    <dgm:pt modelId="{73A345CE-36FD-894D-BBC6-F1148569A643}">
      <dgm:prSet phldrT="[Text]"/>
      <dgm:spPr/>
      <dgm:t>
        <a:bodyPr/>
        <a:lstStyle/>
        <a:p>
          <a:r>
            <a:rPr lang="en-US" dirty="0"/>
            <a:t>3</a:t>
          </a:r>
        </a:p>
      </dgm:t>
    </dgm:pt>
    <dgm:pt modelId="{E3B27BD6-FBE2-5640-8D4A-26A5222CC3EA}" type="parTrans" cxnId="{408ED183-BF58-1C4B-97FD-732582625FEF}">
      <dgm:prSet/>
      <dgm:spPr/>
      <dgm:t>
        <a:bodyPr/>
        <a:lstStyle/>
        <a:p>
          <a:endParaRPr lang="en-US"/>
        </a:p>
      </dgm:t>
    </dgm:pt>
    <dgm:pt modelId="{7A99C83F-BC00-3743-81E8-552BD253CEC3}" type="sibTrans" cxnId="{408ED183-BF58-1C4B-97FD-732582625FEF}">
      <dgm:prSet/>
      <dgm:spPr/>
      <dgm:t>
        <a:bodyPr/>
        <a:lstStyle/>
        <a:p>
          <a:endParaRPr lang="en-US"/>
        </a:p>
      </dgm:t>
    </dgm:pt>
    <dgm:pt modelId="{E900B89A-C42B-5249-B68C-A3D7ECDC2722}">
      <dgm:prSet phldrT="[Text]"/>
      <dgm:spPr/>
      <dgm:t>
        <a:bodyPr/>
        <a:lstStyle/>
        <a:p>
          <a:r>
            <a:rPr lang="en-US" dirty="0"/>
            <a:t>Address bias</a:t>
          </a:r>
        </a:p>
      </dgm:t>
    </dgm:pt>
    <dgm:pt modelId="{8E839505-C7B5-E846-B572-409C6E14F87D}" type="parTrans" cxnId="{8EA459AB-225B-8C4D-9825-5D1C6BF10277}">
      <dgm:prSet/>
      <dgm:spPr/>
      <dgm:t>
        <a:bodyPr/>
        <a:lstStyle/>
        <a:p>
          <a:endParaRPr lang="en-US"/>
        </a:p>
      </dgm:t>
    </dgm:pt>
    <dgm:pt modelId="{1CCB8A03-5593-CE44-86BA-AACEAE0CCB98}" type="sibTrans" cxnId="{8EA459AB-225B-8C4D-9825-5D1C6BF10277}">
      <dgm:prSet/>
      <dgm:spPr/>
      <dgm:t>
        <a:bodyPr/>
        <a:lstStyle/>
        <a:p>
          <a:endParaRPr lang="en-US"/>
        </a:p>
      </dgm:t>
    </dgm:pt>
    <dgm:pt modelId="{418E94F4-4F87-154C-8C2C-4FA1854F2962}">
      <dgm:prSet/>
      <dgm:spPr/>
      <dgm:t>
        <a:bodyPr/>
        <a:lstStyle/>
        <a:p>
          <a:r>
            <a:rPr lang="en-US" dirty="0"/>
            <a:t>4</a:t>
          </a:r>
        </a:p>
      </dgm:t>
    </dgm:pt>
    <dgm:pt modelId="{67B29BF1-08A2-E04F-9D69-0598739CF13B}" type="parTrans" cxnId="{2BBF3C50-1ED6-9847-B76B-936F9EDE5606}">
      <dgm:prSet/>
      <dgm:spPr/>
      <dgm:t>
        <a:bodyPr/>
        <a:lstStyle/>
        <a:p>
          <a:endParaRPr lang="en-US"/>
        </a:p>
      </dgm:t>
    </dgm:pt>
    <dgm:pt modelId="{A5C1BCA8-59E6-2D47-BF9C-24A0A56844F7}" type="sibTrans" cxnId="{2BBF3C50-1ED6-9847-B76B-936F9EDE5606}">
      <dgm:prSet/>
      <dgm:spPr/>
      <dgm:t>
        <a:bodyPr/>
        <a:lstStyle/>
        <a:p>
          <a:endParaRPr lang="en-US"/>
        </a:p>
      </dgm:t>
    </dgm:pt>
    <dgm:pt modelId="{827957E1-E296-1C4F-A5F6-1C5FE324A00C}">
      <dgm:prSet/>
      <dgm:spPr/>
      <dgm:t>
        <a:bodyPr/>
        <a:lstStyle/>
        <a:p>
          <a:r>
            <a:rPr lang="en-US" dirty="0"/>
            <a:t>5</a:t>
          </a:r>
        </a:p>
      </dgm:t>
    </dgm:pt>
    <dgm:pt modelId="{AC89EDA2-97A0-704F-A224-66777968DC79}" type="parTrans" cxnId="{C5A31E1B-1939-A943-9EA9-0D1F931C9095}">
      <dgm:prSet/>
      <dgm:spPr/>
      <dgm:t>
        <a:bodyPr/>
        <a:lstStyle/>
        <a:p>
          <a:endParaRPr lang="en-US"/>
        </a:p>
      </dgm:t>
    </dgm:pt>
    <dgm:pt modelId="{9F52F0F0-B16C-AB44-86AF-35AA79D5B0BB}" type="sibTrans" cxnId="{C5A31E1B-1939-A943-9EA9-0D1F931C9095}">
      <dgm:prSet/>
      <dgm:spPr/>
      <dgm:t>
        <a:bodyPr/>
        <a:lstStyle/>
        <a:p>
          <a:endParaRPr lang="en-US"/>
        </a:p>
      </dgm:t>
    </dgm:pt>
    <dgm:pt modelId="{9F6E5C8F-12F1-3545-94A6-291C5042E69E}">
      <dgm:prSet/>
      <dgm:spPr/>
      <dgm:t>
        <a:bodyPr/>
        <a:lstStyle/>
        <a:p>
          <a:r>
            <a:rPr lang="en-US" dirty="0"/>
            <a:t>6</a:t>
          </a:r>
        </a:p>
      </dgm:t>
    </dgm:pt>
    <dgm:pt modelId="{F878F1E0-BA83-0B4F-8407-D69A3E0606E8}" type="parTrans" cxnId="{545F95DE-9A10-3948-9807-36C195D34A35}">
      <dgm:prSet/>
      <dgm:spPr/>
      <dgm:t>
        <a:bodyPr/>
        <a:lstStyle/>
        <a:p>
          <a:endParaRPr lang="en-US"/>
        </a:p>
      </dgm:t>
    </dgm:pt>
    <dgm:pt modelId="{F501E3C1-886B-5244-A7B1-7A80D72A4D8C}" type="sibTrans" cxnId="{545F95DE-9A10-3948-9807-36C195D34A35}">
      <dgm:prSet/>
      <dgm:spPr/>
      <dgm:t>
        <a:bodyPr/>
        <a:lstStyle/>
        <a:p>
          <a:endParaRPr lang="en-US"/>
        </a:p>
      </dgm:t>
    </dgm:pt>
    <dgm:pt modelId="{02BDF100-8338-E043-96F5-EE898B9D5AB2}">
      <dgm:prSet/>
      <dgm:spPr/>
      <dgm:t>
        <a:bodyPr/>
        <a:lstStyle/>
        <a:p>
          <a:r>
            <a:rPr lang="en-US" dirty="0"/>
            <a:t>7</a:t>
          </a:r>
        </a:p>
      </dgm:t>
    </dgm:pt>
    <dgm:pt modelId="{1B53CCA0-CFF2-384B-856E-1EBDFA4D02AD}" type="parTrans" cxnId="{F6183E77-6BBF-FA47-854D-F0D53AE21A8A}">
      <dgm:prSet/>
      <dgm:spPr/>
      <dgm:t>
        <a:bodyPr/>
        <a:lstStyle/>
        <a:p>
          <a:endParaRPr lang="en-US"/>
        </a:p>
      </dgm:t>
    </dgm:pt>
    <dgm:pt modelId="{BCE247F3-63ED-824C-BC43-9D645F88694B}" type="sibTrans" cxnId="{F6183E77-6BBF-FA47-854D-F0D53AE21A8A}">
      <dgm:prSet/>
      <dgm:spPr/>
      <dgm:t>
        <a:bodyPr/>
        <a:lstStyle/>
        <a:p>
          <a:endParaRPr lang="en-US"/>
        </a:p>
      </dgm:t>
    </dgm:pt>
    <dgm:pt modelId="{7CF6944D-D814-F446-BDE2-B55C1C344687}">
      <dgm:prSet/>
      <dgm:spPr/>
      <dgm:t>
        <a:bodyPr/>
        <a:lstStyle/>
        <a:p>
          <a:r>
            <a:rPr lang="en-US" dirty="0"/>
            <a:t>8</a:t>
          </a:r>
        </a:p>
      </dgm:t>
    </dgm:pt>
    <dgm:pt modelId="{18766106-4E88-954F-80B4-8435CD7E3607}" type="parTrans" cxnId="{B4BAA057-82A7-8F4F-B3AE-D2474B9F0D61}">
      <dgm:prSet/>
      <dgm:spPr/>
      <dgm:t>
        <a:bodyPr/>
        <a:lstStyle/>
        <a:p>
          <a:endParaRPr lang="en-US"/>
        </a:p>
      </dgm:t>
    </dgm:pt>
    <dgm:pt modelId="{41CA9CD1-BD05-D240-8585-F6D044F469D5}" type="sibTrans" cxnId="{B4BAA057-82A7-8F4F-B3AE-D2474B9F0D61}">
      <dgm:prSet/>
      <dgm:spPr/>
      <dgm:t>
        <a:bodyPr/>
        <a:lstStyle/>
        <a:p>
          <a:endParaRPr lang="en-US"/>
        </a:p>
      </dgm:t>
    </dgm:pt>
    <dgm:pt modelId="{77E26394-E137-5E44-9434-AC75CD3E8E1C}">
      <dgm:prSet/>
      <dgm:spPr/>
      <dgm:t>
        <a:bodyPr/>
        <a:lstStyle/>
        <a:p>
          <a:r>
            <a:rPr lang="en-US" dirty="0"/>
            <a:t>Align with team</a:t>
          </a:r>
        </a:p>
      </dgm:t>
    </dgm:pt>
    <dgm:pt modelId="{0106416C-C608-3E4B-95A9-3A27F212EF0D}" type="parTrans" cxnId="{3055A850-65BD-2C48-A538-0AAEB9138E85}">
      <dgm:prSet/>
      <dgm:spPr/>
      <dgm:t>
        <a:bodyPr/>
        <a:lstStyle/>
        <a:p>
          <a:endParaRPr lang="en-US"/>
        </a:p>
      </dgm:t>
    </dgm:pt>
    <dgm:pt modelId="{4162CFAB-B676-8E4E-8FEB-32BD16B62DEC}" type="sibTrans" cxnId="{3055A850-65BD-2C48-A538-0AAEB9138E85}">
      <dgm:prSet/>
      <dgm:spPr/>
      <dgm:t>
        <a:bodyPr/>
        <a:lstStyle/>
        <a:p>
          <a:endParaRPr lang="en-US"/>
        </a:p>
      </dgm:t>
    </dgm:pt>
    <dgm:pt modelId="{D6BB4A41-00B2-5448-BB3F-80605AC75A4E}">
      <dgm:prSet/>
      <dgm:spPr/>
      <dgm:t>
        <a:bodyPr/>
        <a:lstStyle/>
        <a:p>
          <a:r>
            <a:rPr lang="en-US" dirty="0"/>
            <a:t>Recenter on care</a:t>
          </a:r>
        </a:p>
      </dgm:t>
    </dgm:pt>
    <dgm:pt modelId="{4E04882C-8060-1D42-8502-5D210AA0DCD3}" type="parTrans" cxnId="{DF1A41C0-D8B8-6D4F-A8A5-91EC68AFBCAD}">
      <dgm:prSet/>
      <dgm:spPr/>
      <dgm:t>
        <a:bodyPr/>
        <a:lstStyle/>
        <a:p>
          <a:endParaRPr lang="en-US"/>
        </a:p>
      </dgm:t>
    </dgm:pt>
    <dgm:pt modelId="{A3F6C628-648D-0249-B65F-551AF9ECEEA6}" type="sibTrans" cxnId="{DF1A41C0-D8B8-6D4F-A8A5-91EC68AFBCAD}">
      <dgm:prSet/>
      <dgm:spPr/>
      <dgm:t>
        <a:bodyPr/>
        <a:lstStyle/>
        <a:p>
          <a:endParaRPr lang="en-US"/>
        </a:p>
      </dgm:t>
    </dgm:pt>
    <dgm:pt modelId="{0545D5E0-C6B3-A447-B001-E955BFE39730}">
      <dgm:prSet/>
      <dgm:spPr/>
      <dgm:t>
        <a:bodyPr/>
        <a:lstStyle/>
        <a:p>
          <a:r>
            <a:rPr lang="en-US" dirty="0"/>
            <a:t>Give space</a:t>
          </a:r>
        </a:p>
      </dgm:t>
    </dgm:pt>
    <dgm:pt modelId="{74548467-254B-2943-9A99-08C07F3E448D}" type="parTrans" cxnId="{E2BB9BC9-6DB1-9443-8E35-6250A99E4AD7}">
      <dgm:prSet/>
      <dgm:spPr/>
      <dgm:t>
        <a:bodyPr/>
        <a:lstStyle/>
        <a:p>
          <a:endParaRPr lang="en-US"/>
        </a:p>
      </dgm:t>
    </dgm:pt>
    <dgm:pt modelId="{43A03E68-4CAE-A344-B58C-38B13B6EE776}" type="sibTrans" cxnId="{E2BB9BC9-6DB1-9443-8E35-6250A99E4AD7}">
      <dgm:prSet/>
      <dgm:spPr/>
      <dgm:t>
        <a:bodyPr/>
        <a:lstStyle/>
        <a:p>
          <a:endParaRPr lang="en-US"/>
        </a:p>
      </dgm:t>
    </dgm:pt>
    <dgm:pt modelId="{4042EA18-93B7-8447-AC0A-58BAED6135AA}">
      <dgm:prSet/>
      <dgm:spPr/>
      <dgm:t>
        <a:bodyPr/>
        <a:lstStyle/>
        <a:p>
          <a:r>
            <a:rPr lang="en-US" dirty="0"/>
            <a:t>Seek support</a:t>
          </a:r>
        </a:p>
      </dgm:t>
    </dgm:pt>
    <dgm:pt modelId="{2F5CB061-56DE-EB4D-BFD4-36B00E6055CB}" type="parTrans" cxnId="{BBBA16DC-BC73-8048-A725-FE1EF1BF6593}">
      <dgm:prSet/>
      <dgm:spPr/>
      <dgm:t>
        <a:bodyPr/>
        <a:lstStyle/>
        <a:p>
          <a:endParaRPr lang="en-US"/>
        </a:p>
      </dgm:t>
    </dgm:pt>
    <dgm:pt modelId="{A608511D-1BB9-EB4E-9E74-CCD7B0DB861D}" type="sibTrans" cxnId="{BBBA16DC-BC73-8048-A725-FE1EF1BF6593}">
      <dgm:prSet/>
      <dgm:spPr/>
      <dgm:t>
        <a:bodyPr/>
        <a:lstStyle/>
        <a:p>
          <a:endParaRPr lang="en-US"/>
        </a:p>
      </dgm:t>
    </dgm:pt>
    <dgm:pt modelId="{B3ABDBBC-28C2-CC44-9EA0-940A074F9BF0}">
      <dgm:prSet/>
      <dgm:spPr/>
      <dgm:t>
        <a:bodyPr/>
        <a:lstStyle/>
        <a:p>
          <a:r>
            <a:rPr lang="en-US" dirty="0"/>
            <a:t>Set boundaries</a:t>
          </a:r>
        </a:p>
      </dgm:t>
    </dgm:pt>
    <dgm:pt modelId="{B1A1C092-087B-F241-9B26-AD1D13C72D4D}" type="sibTrans" cxnId="{D85391B8-F585-FD43-82E0-8ACB9B810BF4}">
      <dgm:prSet/>
      <dgm:spPr/>
      <dgm:t>
        <a:bodyPr/>
        <a:lstStyle/>
        <a:p>
          <a:endParaRPr lang="en-US"/>
        </a:p>
      </dgm:t>
    </dgm:pt>
    <dgm:pt modelId="{D1297B60-D255-DA44-8D75-399213932CFB}" type="parTrans" cxnId="{D85391B8-F585-FD43-82E0-8ACB9B810BF4}">
      <dgm:prSet/>
      <dgm:spPr/>
      <dgm:t>
        <a:bodyPr/>
        <a:lstStyle/>
        <a:p>
          <a:endParaRPr lang="en-US"/>
        </a:p>
      </dgm:t>
    </dgm:pt>
    <dgm:pt modelId="{C651D352-06FA-1B42-81FF-A95099FE5645}" type="pres">
      <dgm:prSet presAssocID="{CE7EC2B3-709C-7049-AC98-40D647A08CD5}" presName="Name0" presStyleCnt="0">
        <dgm:presLayoutVars>
          <dgm:dir/>
          <dgm:animLvl val="lvl"/>
          <dgm:resizeHandles val="exact"/>
        </dgm:presLayoutVars>
      </dgm:prSet>
      <dgm:spPr/>
    </dgm:pt>
    <dgm:pt modelId="{2E2FEDEA-0CB5-FD4B-8718-95B9D6A14304}" type="pres">
      <dgm:prSet presAssocID="{54EB0C78-47D0-4144-BBA1-ED83F2276A80}" presName="linNode" presStyleCnt="0"/>
      <dgm:spPr/>
    </dgm:pt>
    <dgm:pt modelId="{2F0271A3-745A-A943-B67B-E4069A93AE61}" type="pres">
      <dgm:prSet presAssocID="{54EB0C78-47D0-4144-BBA1-ED83F2276A80}" presName="parentText" presStyleLbl="node1" presStyleIdx="0" presStyleCnt="8" custScaleX="67001">
        <dgm:presLayoutVars>
          <dgm:chMax val="1"/>
          <dgm:bulletEnabled val="1"/>
        </dgm:presLayoutVars>
      </dgm:prSet>
      <dgm:spPr/>
    </dgm:pt>
    <dgm:pt modelId="{21D64796-42C1-6A47-B16B-F23C35A117FF}" type="pres">
      <dgm:prSet presAssocID="{54EB0C78-47D0-4144-BBA1-ED83F2276A80}" presName="descendantText" presStyleLbl="alignAccFollowNode1" presStyleIdx="0" presStyleCnt="8">
        <dgm:presLayoutVars>
          <dgm:bulletEnabled val="1"/>
        </dgm:presLayoutVars>
      </dgm:prSet>
      <dgm:spPr/>
    </dgm:pt>
    <dgm:pt modelId="{B2C4C361-6A0B-BC45-90FD-318B0EB08F6D}" type="pres">
      <dgm:prSet presAssocID="{E8376F97-8FAC-AA43-868D-BB3E335B92F2}" presName="sp" presStyleCnt="0"/>
      <dgm:spPr/>
    </dgm:pt>
    <dgm:pt modelId="{277D1FDC-6CD3-BB41-8E20-960C658417CF}" type="pres">
      <dgm:prSet presAssocID="{D03F059F-5021-1F40-A19F-9647158C52AD}" presName="linNode" presStyleCnt="0"/>
      <dgm:spPr/>
    </dgm:pt>
    <dgm:pt modelId="{6CEBA26E-9501-3E41-ACBB-39C96B19A924}" type="pres">
      <dgm:prSet presAssocID="{D03F059F-5021-1F40-A19F-9647158C52AD}" presName="parentText" presStyleLbl="node1" presStyleIdx="1" presStyleCnt="8" custScaleX="67001">
        <dgm:presLayoutVars>
          <dgm:chMax val="1"/>
          <dgm:bulletEnabled val="1"/>
        </dgm:presLayoutVars>
      </dgm:prSet>
      <dgm:spPr/>
    </dgm:pt>
    <dgm:pt modelId="{2EB4DD27-0645-2048-89E9-55CE50FE52DA}" type="pres">
      <dgm:prSet presAssocID="{D03F059F-5021-1F40-A19F-9647158C52AD}" presName="descendantText" presStyleLbl="alignAccFollowNode1" presStyleIdx="1" presStyleCnt="8">
        <dgm:presLayoutVars>
          <dgm:bulletEnabled val="1"/>
        </dgm:presLayoutVars>
      </dgm:prSet>
      <dgm:spPr/>
    </dgm:pt>
    <dgm:pt modelId="{33CCAA17-6648-4F4C-9AC2-5ECE7EDB6E70}" type="pres">
      <dgm:prSet presAssocID="{294C2440-29C3-A948-ADDD-2D4D34880BDD}" presName="sp" presStyleCnt="0"/>
      <dgm:spPr/>
    </dgm:pt>
    <dgm:pt modelId="{B97FC210-8EA1-614A-91AB-916C1AEFBDEE}" type="pres">
      <dgm:prSet presAssocID="{73A345CE-36FD-894D-BBC6-F1148569A643}" presName="linNode" presStyleCnt="0"/>
      <dgm:spPr/>
    </dgm:pt>
    <dgm:pt modelId="{A3A63788-1227-B240-AFF4-87DA3887717D}" type="pres">
      <dgm:prSet presAssocID="{73A345CE-36FD-894D-BBC6-F1148569A643}" presName="parentText" presStyleLbl="node1" presStyleIdx="2" presStyleCnt="8" custScaleX="67001">
        <dgm:presLayoutVars>
          <dgm:chMax val="1"/>
          <dgm:bulletEnabled val="1"/>
        </dgm:presLayoutVars>
      </dgm:prSet>
      <dgm:spPr/>
    </dgm:pt>
    <dgm:pt modelId="{5432570E-A980-7C49-B78B-FBD7E95247D6}" type="pres">
      <dgm:prSet presAssocID="{73A345CE-36FD-894D-BBC6-F1148569A643}" presName="descendantText" presStyleLbl="alignAccFollowNode1" presStyleIdx="2" presStyleCnt="8">
        <dgm:presLayoutVars>
          <dgm:bulletEnabled val="1"/>
        </dgm:presLayoutVars>
      </dgm:prSet>
      <dgm:spPr/>
    </dgm:pt>
    <dgm:pt modelId="{3E055F9F-21A2-424C-8A4E-65EE89C8A916}" type="pres">
      <dgm:prSet presAssocID="{7A99C83F-BC00-3743-81E8-552BD253CEC3}" presName="sp" presStyleCnt="0"/>
      <dgm:spPr/>
    </dgm:pt>
    <dgm:pt modelId="{3D7F3715-4665-FB42-B9D8-1FF06FE7ED04}" type="pres">
      <dgm:prSet presAssocID="{418E94F4-4F87-154C-8C2C-4FA1854F2962}" presName="linNode" presStyleCnt="0"/>
      <dgm:spPr/>
    </dgm:pt>
    <dgm:pt modelId="{F459C834-8503-9C47-9E88-19B5B264D39A}" type="pres">
      <dgm:prSet presAssocID="{418E94F4-4F87-154C-8C2C-4FA1854F2962}" presName="parentText" presStyleLbl="node1" presStyleIdx="3" presStyleCnt="8" custScaleX="67001">
        <dgm:presLayoutVars>
          <dgm:chMax val="1"/>
          <dgm:bulletEnabled val="1"/>
        </dgm:presLayoutVars>
      </dgm:prSet>
      <dgm:spPr/>
    </dgm:pt>
    <dgm:pt modelId="{B11406A9-5BCB-7247-9C38-2B1D2505F2B8}" type="pres">
      <dgm:prSet presAssocID="{418E94F4-4F87-154C-8C2C-4FA1854F2962}" presName="descendantText" presStyleLbl="alignAccFollowNode1" presStyleIdx="3" presStyleCnt="8">
        <dgm:presLayoutVars>
          <dgm:bulletEnabled val="1"/>
        </dgm:presLayoutVars>
      </dgm:prSet>
      <dgm:spPr/>
    </dgm:pt>
    <dgm:pt modelId="{E355AC6F-4099-CB47-B889-4B740E437363}" type="pres">
      <dgm:prSet presAssocID="{A5C1BCA8-59E6-2D47-BF9C-24A0A56844F7}" presName="sp" presStyleCnt="0"/>
      <dgm:spPr/>
    </dgm:pt>
    <dgm:pt modelId="{A60CA7D8-39CB-954A-95BD-9B247DA4C063}" type="pres">
      <dgm:prSet presAssocID="{827957E1-E296-1C4F-A5F6-1C5FE324A00C}" presName="linNode" presStyleCnt="0"/>
      <dgm:spPr/>
    </dgm:pt>
    <dgm:pt modelId="{4D3677DD-203E-6A46-986E-4A5C658C9303}" type="pres">
      <dgm:prSet presAssocID="{827957E1-E296-1C4F-A5F6-1C5FE324A00C}" presName="parentText" presStyleLbl="node1" presStyleIdx="4" presStyleCnt="8" custScaleX="67001">
        <dgm:presLayoutVars>
          <dgm:chMax val="1"/>
          <dgm:bulletEnabled val="1"/>
        </dgm:presLayoutVars>
      </dgm:prSet>
      <dgm:spPr/>
    </dgm:pt>
    <dgm:pt modelId="{DF481026-182D-AB4B-A938-B9E12915351D}" type="pres">
      <dgm:prSet presAssocID="{827957E1-E296-1C4F-A5F6-1C5FE324A00C}" presName="descendantText" presStyleLbl="alignAccFollowNode1" presStyleIdx="4" presStyleCnt="8">
        <dgm:presLayoutVars>
          <dgm:bulletEnabled val="1"/>
        </dgm:presLayoutVars>
      </dgm:prSet>
      <dgm:spPr/>
    </dgm:pt>
    <dgm:pt modelId="{0E9316E9-2C30-AB47-AE90-7E8E046E1AFD}" type="pres">
      <dgm:prSet presAssocID="{9F52F0F0-B16C-AB44-86AF-35AA79D5B0BB}" presName="sp" presStyleCnt="0"/>
      <dgm:spPr/>
    </dgm:pt>
    <dgm:pt modelId="{037794A2-D322-8E40-B011-CE07ECE52AD6}" type="pres">
      <dgm:prSet presAssocID="{9F6E5C8F-12F1-3545-94A6-291C5042E69E}" presName="linNode" presStyleCnt="0"/>
      <dgm:spPr/>
    </dgm:pt>
    <dgm:pt modelId="{B6C279C8-1B63-3845-ADAB-B82AEFA3D8E4}" type="pres">
      <dgm:prSet presAssocID="{9F6E5C8F-12F1-3545-94A6-291C5042E69E}" presName="parentText" presStyleLbl="node1" presStyleIdx="5" presStyleCnt="8" custScaleX="67001">
        <dgm:presLayoutVars>
          <dgm:chMax val="1"/>
          <dgm:bulletEnabled val="1"/>
        </dgm:presLayoutVars>
      </dgm:prSet>
      <dgm:spPr/>
    </dgm:pt>
    <dgm:pt modelId="{95DA0D8B-BC89-0948-909A-C298332DBD75}" type="pres">
      <dgm:prSet presAssocID="{9F6E5C8F-12F1-3545-94A6-291C5042E69E}" presName="descendantText" presStyleLbl="alignAccFollowNode1" presStyleIdx="5" presStyleCnt="8">
        <dgm:presLayoutVars>
          <dgm:bulletEnabled val="1"/>
        </dgm:presLayoutVars>
      </dgm:prSet>
      <dgm:spPr/>
    </dgm:pt>
    <dgm:pt modelId="{05C8E7F6-EE84-404A-A830-A5238A04D5A3}" type="pres">
      <dgm:prSet presAssocID="{F501E3C1-886B-5244-A7B1-7A80D72A4D8C}" presName="sp" presStyleCnt="0"/>
      <dgm:spPr/>
    </dgm:pt>
    <dgm:pt modelId="{450D1F74-F684-8F4C-A8B3-6F8B553AB682}" type="pres">
      <dgm:prSet presAssocID="{02BDF100-8338-E043-96F5-EE898B9D5AB2}" presName="linNode" presStyleCnt="0"/>
      <dgm:spPr/>
    </dgm:pt>
    <dgm:pt modelId="{B67BA8B7-08DC-C244-8300-FCD547033DBD}" type="pres">
      <dgm:prSet presAssocID="{02BDF100-8338-E043-96F5-EE898B9D5AB2}" presName="parentText" presStyleLbl="node1" presStyleIdx="6" presStyleCnt="8" custScaleX="67001">
        <dgm:presLayoutVars>
          <dgm:chMax val="1"/>
          <dgm:bulletEnabled val="1"/>
        </dgm:presLayoutVars>
      </dgm:prSet>
      <dgm:spPr/>
    </dgm:pt>
    <dgm:pt modelId="{9D2B4FF6-13FB-EF49-977A-31DF5EE58099}" type="pres">
      <dgm:prSet presAssocID="{02BDF100-8338-E043-96F5-EE898B9D5AB2}" presName="descendantText" presStyleLbl="alignAccFollowNode1" presStyleIdx="6" presStyleCnt="8">
        <dgm:presLayoutVars>
          <dgm:bulletEnabled val="1"/>
        </dgm:presLayoutVars>
      </dgm:prSet>
      <dgm:spPr/>
    </dgm:pt>
    <dgm:pt modelId="{580F7313-AC0F-FA49-A45E-0C9486F52D6E}" type="pres">
      <dgm:prSet presAssocID="{BCE247F3-63ED-824C-BC43-9D645F88694B}" presName="sp" presStyleCnt="0"/>
      <dgm:spPr/>
    </dgm:pt>
    <dgm:pt modelId="{E737A561-EB87-EC46-B404-0D8CDB0DE287}" type="pres">
      <dgm:prSet presAssocID="{7CF6944D-D814-F446-BDE2-B55C1C344687}" presName="linNode" presStyleCnt="0"/>
      <dgm:spPr/>
    </dgm:pt>
    <dgm:pt modelId="{D5D04DA4-D0C2-DE47-8C8C-0B8EFFA304FE}" type="pres">
      <dgm:prSet presAssocID="{7CF6944D-D814-F446-BDE2-B55C1C344687}" presName="parentText" presStyleLbl="node1" presStyleIdx="7" presStyleCnt="8" custScaleX="67001">
        <dgm:presLayoutVars>
          <dgm:chMax val="1"/>
          <dgm:bulletEnabled val="1"/>
        </dgm:presLayoutVars>
      </dgm:prSet>
      <dgm:spPr/>
    </dgm:pt>
    <dgm:pt modelId="{8CF3EAF4-8574-9841-9B3E-4FBF8CB57172}" type="pres">
      <dgm:prSet presAssocID="{7CF6944D-D814-F446-BDE2-B55C1C344687}" presName="descendantText" presStyleLbl="alignAccFollowNode1" presStyleIdx="7" presStyleCnt="8">
        <dgm:presLayoutVars>
          <dgm:bulletEnabled val="1"/>
        </dgm:presLayoutVars>
      </dgm:prSet>
      <dgm:spPr/>
    </dgm:pt>
  </dgm:ptLst>
  <dgm:cxnLst>
    <dgm:cxn modelId="{E4273A05-E6BD-7B48-BAB7-FF2C885BDD30}" type="presOf" srcId="{02BDF100-8338-E043-96F5-EE898B9D5AB2}" destId="{B67BA8B7-08DC-C244-8300-FCD547033DBD}" srcOrd="0" destOrd="0" presId="urn:microsoft.com/office/officeart/2005/8/layout/vList5"/>
    <dgm:cxn modelId="{E9D1E10C-1628-524C-9321-D84C071FF74D}" type="presOf" srcId="{CE7EC2B3-709C-7049-AC98-40D647A08CD5}" destId="{C651D352-06FA-1B42-81FF-A95099FE5645}" srcOrd="0" destOrd="0" presId="urn:microsoft.com/office/officeart/2005/8/layout/vList5"/>
    <dgm:cxn modelId="{C4160712-DF53-0F4F-9BBA-78BD9BBF4B88}" type="presOf" srcId="{77E26394-E137-5E44-9434-AC75CD3E8E1C}" destId="{B11406A9-5BCB-7247-9C38-2B1D2505F2B8}" srcOrd="0" destOrd="0" presId="urn:microsoft.com/office/officeart/2005/8/layout/vList5"/>
    <dgm:cxn modelId="{C5A31E1B-1939-A943-9EA9-0D1F931C9095}" srcId="{CE7EC2B3-709C-7049-AC98-40D647A08CD5}" destId="{827957E1-E296-1C4F-A5F6-1C5FE324A00C}" srcOrd="4" destOrd="0" parTransId="{AC89EDA2-97A0-704F-A224-66777968DC79}" sibTransId="{9F52F0F0-B16C-AB44-86AF-35AA79D5B0BB}"/>
    <dgm:cxn modelId="{086EAA1D-3224-4E41-87B1-9FA27037DE47}" type="presOf" srcId="{9F6E5C8F-12F1-3545-94A6-291C5042E69E}" destId="{B6C279C8-1B63-3845-ADAB-B82AEFA3D8E4}" srcOrd="0" destOrd="0" presId="urn:microsoft.com/office/officeart/2005/8/layout/vList5"/>
    <dgm:cxn modelId="{71BBC71D-E55C-424F-B6C9-6E507D91D4E5}" type="presOf" srcId="{D6BB4A41-00B2-5448-BB3F-80605AC75A4E}" destId="{95DA0D8B-BC89-0948-909A-C298332DBD75}" srcOrd="0" destOrd="0" presId="urn:microsoft.com/office/officeart/2005/8/layout/vList5"/>
    <dgm:cxn modelId="{7A4CD21E-5C30-9844-B8CC-04D4CC71350C}" type="presOf" srcId="{4042EA18-93B7-8447-AC0A-58BAED6135AA}" destId="{8CF3EAF4-8574-9841-9B3E-4FBF8CB57172}" srcOrd="0" destOrd="0" presId="urn:microsoft.com/office/officeart/2005/8/layout/vList5"/>
    <dgm:cxn modelId="{EA0CCB2E-33A7-7842-AF42-FDB163C3A0DB}" type="presOf" srcId="{8E966A69-49F1-5E4B-B606-FCAEDAA984ED}" destId="{2EB4DD27-0645-2048-89E9-55CE50FE52DA}" srcOrd="0" destOrd="0" presId="urn:microsoft.com/office/officeart/2005/8/layout/vList5"/>
    <dgm:cxn modelId="{65CEA44F-9E16-EA4E-A309-EC3B3016297A}" srcId="{CE7EC2B3-709C-7049-AC98-40D647A08CD5}" destId="{D03F059F-5021-1F40-A19F-9647158C52AD}" srcOrd="1" destOrd="0" parTransId="{CF000D09-B476-0444-AE02-AACE5A32ABB9}" sibTransId="{294C2440-29C3-A948-ADDD-2D4D34880BDD}"/>
    <dgm:cxn modelId="{2BBF3C50-1ED6-9847-B76B-936F9EDE5606}" srcId="{CE7EC2B3-709C-7049-AC98-40D647A08CD5}" destId="{418E94F4-4F87-154C-8C2C-4FA1854F2962}" srcOrd="3" destOrd="0" parTransId="{67B29BF1-08A2-E04F-9D69-0598739CF13B}" sibTransId="{A5C1BCA8-59E6-2D47-BF9C-24A0A56844F7}"/>
    <dgm:cxn modelId="{3055A850-65BD-2C48-A538-0AAEB9138E85}" srcId="{418E94F4-4F87-154C-8C2C-4FA1854F2962}" destId="{77E26394-E137-5E44-9434-AC75CD3E8E1C}" srcOrd="0" destOrd="0" parTransId="{0106416C-C608-3E4B-95A9-3A27F212EF0D}" sibTransId="{4162CFAB-B676-8E4E-8FEB-32BD16B62DEC}"/>
    <dgm:cxn modelId="{B3273152-AF0F-EE4B-8C28-8B1E95E5CD89}" type="presOf" srcId="{E900B89A-C42B-5249-B68C-A3D7ECDC2722}" destId="{5432570E-A980-7C49-B78B-FBD7E95247D6}" srcOrd="0" destOrd="0" presId="urn:microsoft.com/office/officeart/2005/8/layout/vList5"/>
    <dgm:cxn modelId="{90712D57-061F-8444-BA8A-D8DA5E4630C5}" type="presOf" srcId="{73A345CE-36FD-894D-BBC6-F1148569A643}" destId="{A3A63788-1227-B240-AFF4-87DA3887717D}" srcOrd="0" destOrd="0" presId="urn:microsoft.com/office/officeart/2005/8/layout/vList5"/>
    <dgm:cxn modelId="{B4BAA057-82A7-8F4F-B3AE-D2474B9F0D61}" srcId="{CE7EC2B3-709C-7049-AC98-40D647A08CD5}" destId="{7CF6944D-D814-F446-BDE2-B55C1C344687}" srcOrd="7" destOrd="0" parTransId="{18766106-4E88-954F-80B4-8435CD7E3607}" sibTransId="{41CA9CD1-BD05-D240-8585-F6D044F469D5}"/>
    <dgm:cxn modelId="{BAD62360-A798-6A47-A994-B5126C6DDBBA}" type="presOf" srcId="{D57A6E2B-1DF9-5046-BC1D-709A01F64D7F}" destId="{21D64796-42C1-6A47-B16B-F23C35A117FF}" srcOrd="0" destOrd="0" presId="urn:microsoft.com/office/officeart/2005/8/layout/vList5"/>
    <dgm:cxn modelId="{F6183E77-6BBF-FA47-854D-F0D53AE21A8A}" srcId="{CE7EC2B3-709C-7049-AC98-40D647A08CD5}" destId="{02BDF100-8338-E043-96F5-EE898B9D5AB2}" srcOrd="6" destOrd="0" parTransId="{1B53CCA0-CFF2-384B-856E-1EBDFA4D02AD}" sibTransId="{BCE247F3-63ED-824C-BC43-9D645F88694B}"/>
    <dgm:cxn modelId="{89198578-5DCB-6140-878F-E9FD8D67271F}" type="presOf" srcId="{7CF6944D-D814-F446-BDE2-B55C1C344687}" destId="{D5D04DA4-D0C2-DE47-8C8C-0B8EFFA304FE}" srcOrd="0" destOrd="0" presId="urn:microsoft.com/office/officeart/2005/8/layout/vList5"/>
    <dgm:cxn modelId="{408ED183-BF58-1C4B-97FD-732582625FEF}" srcId="{CE7EC2B3-709C-7049-AC98-40D647A08CD5}" destId="{73A345CE-36FD-894D-BBC6-F1148569A643}" srcOrd="2" destOrd="0" parTransId="{E3B27BD6-FBE2-5640-8D4A-26A5222CC3EA}" sibTransId="{7A99C83F-BC00-3743-81E8-552BD253CEC3}"/>
    <dgm:cxn modelId="{B2C59790-5949-8740-B37D-5567793C306C}" srcId="{54EB0C78-47D0-4144-BBA1-ED83F2276A80}" destId="{D57A6E2B-1DF9-5046-BC1D-709A01F64D7F}" srcOrd="0" destOrd="0" parTransId="{C76AEE8B-D94A-7D44-B03A-3FE0785274DD}" sibTransId="{55132C62-F393-2540-A3F5-1E79E69F36CF}"/>
    <dgm:cxn modelId="{2D83CF9B-C8D2-5645-B148-7557D123AE42}" type="presOf" srcId="{827957E1-E296-1C4F-A5F6-1C5FE324A00C}" destId="{4D3677DD-203E-6A46-986E-4A5C658C9303}" srcOrd="0" destOrd="0" presId="urn:microsoft.com/office/officeart/2005/8/layout/vList5"/>
    <dgm:cxn modelId="{D734F3A8-F28E-EC4B-833E-A76A8DF839E2}" type="presOf" srcId="{D03F059F-5021-1F40-A19F-9647158C52AD}" destId="{6CEBA26E-9501-3E41-ACBB-39C96B19A924}" srcOrd="0" destOrd="0" presId="urn:microsoft.com/office/officeart/2005/8/layout/vList5"/>
    <dgm:cxn modelId="{8EA459AB-225B-8C4D-9825-5D1C6BF10277}" srcId="{73A345CE-36FD-894D-BBC6-F1148569A643}" destId="{E900B89A-C42B-5249-B68C-A3D7ECDC2722}" srcOrd="0" destOrd="0" parTransId="{8E839505-C7B5-E846-B572-409C6E14F87D}" sibTransId="{1CCB8A03-5593-CE44-86BA-AACEAE0CCB98}"/>
    <dgm:cxn modelId="{54AEA8B7-F89B-724F-98A1-0AEC5D7FC3A2}" srcId="{CE7EC2B3-709C-7049-AC98-40D647A08CD5}" destId="{54EB0C78-47D0-4144-BBA1-ED83F2276A80}" srcOrd="0" destOrd="0" parTransId="{46A28A5B-8A7C-BF49-A5DC-996D874F74B0}" sibTransId="{E8376F97-8FAC-AA43-868D-BB3E335B92F2}"/>
    <dgm:cxn modelId="{D85391B8-F585-FD43-82E0-8ACB9B810BF4}" srcId="{827957E1-E296-1C4F-A5F6-1C5FE324A00C}" destId="{B3ABDBBC-28C2-CC44-9EA0-940A074F9BF0}" srcOrd="0" destOrd="0" parTransId="{D1297B60-D255-DA44-8D75-399213932CFB}" sibTransId="{B1A1C092-087B-F241-9B26-AD1D13C72D4D}"/>
    <dgm:cxn modelId="{DF1A41C0-D8B8-6D4F-A8A5-91EC68AFBCAD}" srcId="{9F6E5C8F-12F1-3545-94A6-291C5042E69E}" destId="{D6BB4A41-00B2-5448-BB3F-80605AC75A4E}" srcOrd="0" destOrd="0" parTransId="{4E04882C-8060-1D42-8502-5D210AA0DCD3}" sibTransId="{A3F6C628-648D-0249-B65F-551AF9ECEEA6}"/>
    <dgm:cxn modelId="{F2E046C8-391B-6946-ACE6-697EC224AB98}" type="presOf" srcId="{B3ABDBBC-28C2-CC44-9EA0-940A074F9BF0}" destId="{DF481026-182D-AB4B-A938-B9E12915351D}" srcOrd="0" destOrd="0" presId="urn:microsoft.com/office/officeart/2005/8/layout/vList5"/>
    <dgm:cxn modelId="{E2BB9BC9-6DB1-9443-8E35-6250A99E4AD7}" srcId="{02BDF100-8338-E043-96F5-EE898B9D5AB2}" destId="{0545D5E0-C6B3-A447-B001-E955BFE39730}" srcOrd="0" destOrd="0" parTransId="{74548467-254B-2943-9A99-08C07F3E448D}" sibTransId="{43A03E68-4CAE-A344-B58C-38B13B6EE776}"/>
    <dgm:cxn modelId="{A16837DB-2A15-1C45-807B-67AB4EF8E75E}" type="presOf" srcId="{0545D5E0-C6B3-A447-B001-E955BFE39730}" destId="{9D2B4FF6-13FB-EF49-977A-31DF5EE58099}" srcOrd="0" destOrd="0" presId="urn:microsoft.com/office/officeart/2005/8/layout/vList5"/>
    <dgm:cxn modelId="{BBBA16DC-BC73-8048-A725-FE1EF1BF6593}" srcId="{7CF6944D-D814-F446-BDE2-B55C1C344687}" destId="{4042EA18-93B7-8447-AC0A-58BAED6135AA}" srcOrd="0" destOrd="0" parTransId="{2F5CB061-56DE-EB4D-BFD4-36B00E6055CB}" sibTransId="{A608511D-1BB9-EB4E-9E74-CCD7B0DB861D}"/>
    <dgm:cxn modelId="{545F95DE-9A10-3948-9807-36C195D34A35}" srcId="{CE7EC2B3-709C-7049-AC98-40D647A08CD5}" destId="{9F6E5C8F-12F1-3545-94A6-291C5042E69E}" srcOrd="5" destOrd="0" parTransId="{F878F1E0-BA83-0B4F-8407-D69A3E0606E8}" sibTransId="{F501E3C1-886B-5244-A7B1-7A80D72A4D8C}"/>
    <dgm:cxn modelId="{1AC639E1-2DD4-8C49-9596-C5731579DC3A}" type="presOf" srcId="{54EB0C78-47D0-4144-BBA1-ED83F2276A80}" destId="{2F0271A3-745A-A943-B67B-E4069A93AE61}" srcOrd="0" destOrd="0" presId="urn:microsoft.com/office/officeart/2005/8/layout/vList5"/>
    <dgm:cxn modelId="{FBB45EE4-904A-AF48-A0C9-CB655E66EF52}" srcId="{D03F059F-5021-1F40-A19F-9647158C52AD}" destId="{8E966A69-49F1-5E4B-B606-FCAEDAA984ED}" srcOrd="0" destOrd="0" parTransId="{DBAD8E5C-BD8A-8D4C-B4F0-8493200D7696}" sibTransId="{6E022D76-54D3-5040-BFB1-6E3CF648085C}"/>
    <dgm:cxn modelId="{CE4D51EC-1171-9740-9774-3550157EF9C1}" type="presOf" srcId="{418E94F4-4F87-154C-8C2C-4FA1854F2962}" destId="{F459C834-8503-9C47-9E88-19B5B264D39A}" srcOrd="0" destOrd="0" presId="urn:microsoft.com/office/officeart/2005/8/layout/vList5"/>
    <dgm:cxn modelId="{BF236B13-02D1-B64C-986F-0CAF7E0612E5}" type="presParOf" srcId="{C651D352-06FA-1B42-81FF-A95099FE5645}" destId="{2E2FEDEA-0CB5-FD4B-8718-95B9D6A14304}" srcOrd="0" destOrd="0" presId="urn:microsoft.com/office/officeart/2005/8/layout/vList5"/>
    <dgm:cxn modelId="{9578A504-AB23-5044-A923-D3DEFAE4D5E7}" type="presParOf" srcId="{2E2FEDEA-0CB5-FD4B-8718-95B9D6A14304}" destId="{2F0271A3-745A-A943-B67B-E4069A93AE61}" srcOrd="0" destOrd="0" presId="urn:microsoft.com/office/officeart/2005/8/layout/vList5"/>
    <dgm:cxn modelId="{253C94D8-1885-B543-AF3D-F6A1DD424873}" type="presParOf" srcId="{2E2FEDEA-0CB5-FD4B-8718-95B9D6A14304}" destId="{21D64796-42C1-6A47-B16B-F23C35A117FF}" srcOrd="1" destOrd="0" presId="urn:microsoft.com/office/officeart/2005/8/layout/vList5"/>
    <dgm:cxn modelId="{C06B9A2B-4F20-7C45-806D-5E7956B4F171}" type="presParOf" srcId="{C651D352-06FA-1B42-81FF-A95099FE5645}" destId="{B2C4C361-6A0B-BC45-90FD-318B0EB08F6D}" srcOrd="1" destOrd="0" presId="urn:microsoft.com/office/officeart/2005/8/layout/vList5"/>
    <dgm:cxn modelId="{7BF712B5-32BC-7844-BF86-9BFE0BE03182}" type="presParOf" srcId="{C651D352-06FA-1B42-81FF-A95099FE5645}" destId="{277D1FDC-6CD3-BB41-8E20-960C658417CF}" srcOrd="2" destOrd="0" presId="urn:microsoft.com/office/officeart/2005/8/layout/vList5"/>
    <dgm:cxn modelId="{8EE30A21-17AC-A34E-A945-33D32D0CD928}" type="presParOf" srcId="{277D1FDC-6CD3-BB41-8E20-960C658417CF}" destId="{6CEBA26E-9501-3E41-ACBB-39C96B19A924}" srcOrd="0" destOrd="0" presId="urn:microsoft.com/office/officeart/2005/8/layout/vList5"/>
    <dgm:cxn modelId="{3CCA96C7-C68E-DA49-A8B4-DD728A5A5A21}" type="presParOf" srcId="{277D1FDC-6CD3-BB41-8E20-960C658417CF}" destId="{2EB4DD27-0645-2048-89E9-55CE50FE52DA}" srcOrd="1" destOrd="0" presId="urn:microsoft.com/office/officeart/2005/8/layout/vList5"/>
    <dgm:cxn modelId="{4AF2BADF-B9C1-834B-AC41-60901F7D6D95}" type="presParOf" srcId="{C651D352-06FA-1B42-81FF-A95099FE5645}" destId="{33CCAA17-6648-4F4C-9AC2-5ECE7EDB6E70}" srcOrd="3" destOrd="0" presId="urn:microsoft.com/office/officeart/2005/8/layout/vList5"/>
    <dgm:cxn modelId="{2A4E440E-B7D6-6B49-8318-F6B71A21E6CF}" type="presParOf" srcId="{C651D352-06FA-1B42-81FF-A95099FE5645}" destId="{B97FC210-8EA1-614A-91AB-916C1AEFBDEE}" srcOrd="4" destOrd="0" presId="urn:microsoft.com/office/officeart/2005/8/layout/vList5"/>
    <dgm:cxn modelId="{2BDD0334-A1D2-DC42-B9D1-68F24D23B5D5}" type="presParOf" srcId="{B97FC210-8EA1-614A-91AB-916C1AEFBDEE}" destId="{A3A63788-1227-B240-AFF4-87DA3887717D}" srcOrd="0" destOrd="0" presId="urn:microsoft.com/office/officeart/2005/8/layout/vList5"/>
    <dgm:cxn modelId="{C69877D5-79C1-9F4C-B7F4-8AD7D15754EE}" type="presParOf" srcId="{B97FC210-8EA1-614A-91AB-916C1AEFBDEE}" destId="{5432570E-A980-7C49-B78B-FBD7E95247D6}" srcOrd="1" destOrd="0" presId="urn:microsoft.com/office/officeart/2005/8/layout/vList5"/>
    <dgm:cxn modelId="{33ACEA31-C6CD-5547-BED3-2458723FCA4A}" type="presParOf" srcId="{C651D352-06FA-1B42-81FF-A95099FE5645}" destId="{3E055F9F-21A2-424C-8A4E-65EE89C8A916}" srcOrd="5" destOrd="0" presId="urn:microsoft.com/office/officeart/2005/8/layout/vList5"/>
    <dgm:cxn modelId="{A37DA9BE-A47E-BB4D-9CC1-632CE186629D}" type="presParOf" srcId="{C651D352-06FA-1B42-81FF-A95099FE5645}" destId="{3D7F3715-4665-FB42-B9D8-1FF06FE7ED04}" srcOrd="6" destOrd="0" presId="urn:microsoft.com/office/officeart/2005/8/layout/vList5"/>
    <dgm:cxn modelId="{C891109C-0686-B74F-8141-60300585C701}" type="presParOf" srcId="{3D7F3715-4665-FB42-B9D8-1FF06FE7ED04}" destId="{F459C834-8503-9C47-9E88-19B5B264D39A}" srcOrd="0" destOrd="0" presId="urn:microsoft.com/office/officeart/2005/8/layout/vList5"/>
    <dgm:cxn modelId="{2F31821D-0811-794B-B121-3DE9146709AD}" type="presParOf" srcId="{3D7F3715-4665-FB42-B9D8-1FF06FE7ED04}" destId="{B11406A9-5BCB-7247-9C38-2B1D2505F2B8}" srcOrd="1" destOrd="0" presId="urn:microsoft.com/office/officeart/2005/8/layout/vList5"/>
    <dgm:cxn modelId="{0F8FFFCC-28B5-A844-A0C0-4277188A3AC8}" type="presParOf" srcId="{C651D352-06FA-1B42-81FF-A95099FE5645}" destId="{E355AC6F-4099-CB47-B889-4B740E437363}" srcOrd="7" destOrd="0" presId="urn:microsoft.com/office/officeart/2005/8/layout/vList5"/>
    <dgm:cxn modelId="{53EF242F-1951-6046-AB59-C18248626329}" type="presParOf" srcId="{C651D352-06FA-1B42-81FF-A95099FE5645}" destId="{A60CA7D8-39CB-954A-95BD-9B247DA4C063}" srcOrd="8" destOrd="0" presId="urn:microsoft.com/office/officeart/2005/8/layout/vList5"/>
    <dgm:cxn modelId="{ED3BF37E-4F96-D544-B638-C0AB83F1A9B4}" type="presParOf" srcId="{A60CA7D8-39CB-954A-95BD-9B247DA4C063}" destId="{4D3677DD-203E-6A46-986E-4A5C658C9303}" srcOrd="0" destOrd="0" presId="urn:microsoft.com/office/officeart/2005/8/layout/vList5"/>
    <dgm:cxn modelId="{5F05AF10-2999-E74B-852A-D64954D94FF8}" type="presParOf" srcId="{A60CA7D8-39CB-954A-95BD-9B247DA4C063}" destId="{DF481026-182D-AB4B-A938-B9E12915351D}" srcOrd="1" destOrd="0" presId="urn:microsoft.com/office/officeart/2005/8/layout/vList5"/>
    <dgm:cxn modelId="{ACD94F81-0016-934D-9BD5-68D8F780E3B7}" type="presParOf" srcId="{C651D352-06FA-1B42-81FF-A95099FE5645}" destId="{0E9316E9-2C30-AB47-AE90-7E8E046E1AFD}" srcOrd="9" destOrd="0" presId="urn:microsoft.com/office/officeart/2005/8/layout/vList5"/>
    <dgm:cxn modelId="{F8E487A0-A252-584F-8A38-3822D4AF8219}" type="presParOf" srcId="{C651D352-06FA-1B42-81FF-A95099FE5645}" destId="{037794A2-D322-8E40-B011-CE07ECE52AD6}" srcOrd="10" destOrd="0" presId="urn:microsoft.com/office/officeart/2005/8/layout/vList5"/>
    <dgm:cxn modelId="{67548826-ED42-6242-AA6A-DBBB72691D13}" type="presParOf" srcId="{037794A2-D322-8E40-B011-CE07ECE52AD6}" destId="{B6C279C8-1B63-3845-ADAB-B82AEFA3D8E4}" srcOrd="0" destOrd="0" presId="urn:microsoft.com/office/officeart/2005/8/layout/vList5"/>
    <dgm:cxn modelId="{B87CE2C3-5909-4C4E-A75A-B68815D3150A}" type="presParOf" srcId="{037794A2-D322-8E40-B011-CE07ECE52AD6}" destId="{95DA0D8B-BC89-0948-909A-C298332DBD75}" srcOrd="1" destOrd="0" presId="urn:microsoft.com/office/officeart/2005/8/layout/vList5"/>
    <dgm:cxn modelId="{B702A7F2-2B11-8D48-B9AE-A25D0DE633A1}" type="presParOf" srcId="{C651D352-06FA-1B42-81FF-A95099FE5645}" destId="{05C8E7F6-EE84-404A-A830-A5238A04D5A3}" srcOrd="11" destOrd="0" presId="urn:microsoft.com/office/officeart/2005/8/layout/vList5"/>
    <dgm:cxn modelId="{5D36C750-8050-AB49-B923-84B64CB9D59C}" type="presParOf" srcId="{C651D352-06FA-1B42-81FF-A95099FE5645}" destId="{450D1F74-F684-8F4C-A8B3-6F8B553AB682}" srcOrd="12" destOrd="0" presId="urn:microsoft.com/office/officeart/2005/8/layout/vList5"/>
    <dgm:cxn modelId="{69DDD68C-0D88-6141-B93A-2DFC27495FCF}" type="presParOf" srcId="{450D1F74-F684-8F4C-A8B3-6F8B553AB682}" destId="{B67BA8B7-08DC-C244-8300-FCD547033DBD}" srcOrd="0" destOrd="0" presId="urn:microsoft.com/office/officeart/2005/8/layout/vList5"/>
    <dgm:cxn modelId="{772109BC-D0C5-5C47-B68B-C1F238D6D77F}" type="presParOf" srcId="{450D1F74-F684-8F4C-A8B3-6F8B553AB682}" destId="{9D2B4FF6-13FB-EF49-977A-31DF5EE58099}" srcOrd="1" destOrd="0" presId="urn:microsoft.com/office/officeart/2005/8/layout/vList5"/>
    <dgm:cxn modelId="{5EBAD0AC-A244-A44E-ADFB-53F20C58044C}" type="presParOf" srcId="{C651D352-06FA-1B42-81FF-A95099FE5645}" destId="{580F7313-AC0F-FA49-A45E-0C9486F52D6E}" srcOrd="13" destOrd="0" presId="urn:microsoft.com/office/officeart/2005/8/layout/vList5"/>
    <dgm:cxn modelId="{6E9922E5-478F-AF4D-9DCA-7A72508F4F6D}" type="presParOf" srcId="{C651D352-06FA-1B42-81FF-A95099FE5645}" destId="{E737A561-EB87-EC46-B404-0D8CDB0DE287}" srcOrd="14" destOrd="0" presId="urn:microsoft.com/office/officeart/2005/8/layout/vList5"/>
    <dgm:cxn modelId="{8E470ECC-4731-EF49-B2A8-AD4470B8AD53}" type="presParOf" srcId="{E737A561-EB87-EC46-B404-0D8CDB0DE287}" destId="{D5D04DA4-D0C2-DE47-8C8C-0B8EFFA304FE}" srcOrd="0" destOrd="0" presId="urn:microsoft.com/office/officeart/2005/8/layout/vList5"/>
    <dgm:cxn modelId="{B9608D4F-B546-F142-90CB-D6437FE05ACF}" type="presParOf" srcId="{E737A561-EB87-EC46-B404-0D8CDB0DE287}" destId="{8CF3EAF4-8574-9841-9B3E-4FBF8CB57172}"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1.xml><?xml version="1.0" encoding="utf-8"?>
<dgm:dataModel xmlns:dgm="http://schemas.openxmlformats.org/drawingml/2006/diagram" xmlns:a="http://schemas.openxmlformats.org/drawingml/2006/main">
  <dgm:ptLst>
    <dgm:pt modelId="{CE7EC2B3-709C-7049-AC98-40D647A08CD5}" type="doc">
      <dgm:prSet loTypeId="urn:microsoft.com/office/officeart/2005/8/layout/vList5" loCatId="" qsTypeId="urn:microsoft.com/office/officeart/2005/8/quickstyle/simple1" qsCatId="simple" csTypeId="urn:microsoft.com/office/officeart/2005/8/colors/accent1_2" csCatId="accent1" phldr="1"/>
      <dgm:spPr/>
      <dgm:t>
        <a:bodyPr/>
        <a:lstStyle/>
        <a:p>
          <a:endParaRPr lang="en-US"/>
        </a:p>
      </dgm:t>
    </dgm:pt>
    <dgm:pt modelId="{54EB0C78-47D0-4144-BBA1-ED83F2276A80}">
      <dgm:prSet phldrT="[Text]"/>
      <dgm:spPr/>
      <dgm:t>
        <a:bodyPr/>
        <a:lstStyle/>
        <a:p>
          <a:r>
            <a:rPr lang="en-US" dirty="0"/>
            <a:t>1</a:t>
          </a:r>
        </a:p>
      </dgm:t>
    </dgm:pt>
    <dgm:pt modelId="{46A28A5B-8A7C-BF49-A5DC-996D874F74B0}" type="parTrans" cxnId="{54AEA8B7-F89B-724F-98A1-0AEC5D7FC3A2}">
      <dgm:prSet/>
      <dgm:spPr/>
      <dgm:t>
        <a:bodyPr/>
        <a:lstStyle/>
        <a:p>
          <a:endParaRPr lang="en-US"/>
        </a:p>
      </dgm:t>
    </dgm:pt>
    <dgm:pt modelId="{E8376F97-8FAC-AA43-868D-BB3E335B92F2}" type="sibTrans" cxnId="{54AEA8B7-F89B-724F-98A1-0AEC5D7FC3A2}">
      <dgm:prSet/>
      <dgm:spPr/>
      <dgm:t>
        <a:bodyPr/>
        <a:lstStyle/>
        <a:p>
          <a:endParaRPr lang="en-US"/>
        </a:p>
      </dgm:t>
    </dgm:pt>
    <dgm:pt modelId="{D57A6E2B-1DF9-5046-BC1D-709A01F64D7F}">
      <dgm:prSet phldrT="[Text]"/>
      <dgm:spPr/>
      <dgm:t>
        <a:bodyPr/>
        <a:lstStyle/>
        <a:p>
          <a:r>
            <a:rPr lang="en-US"/>
            <a:t>Patient stability</a:t>
          </a:r>
          <a:endParaRPr lang="en-US" dirty="0"/>
        </a:p>
      </dgm:t>
    </dgm:pt>
    <dgm:pt modelId="{C76AEE8B-D94A-7D44-B03A-3FE0785274DD}" type="parTrans" cxnId="{B2C59790-5949-8740-B37D-5567793C306C}">
      <dgm:prSet/>
      <dgm:spPr/>
      <dgm:t>
        <a:bodyPr/>
        <a:lstStyle/>
        <a:p>
          <a:endParaRPr lang="en-US"/>
        </a:p>
      </dgm:t>
    </dgm:pt>
    <dgm:pt modelId="{55132C62-F393-2540-A3F5-1E79E69F36CF}" type="sibTrans" cxnId="{B2C59790-5949-8740-B37D-5567793C306C}">
      <dgm:prSet/>
      <dgm:spPr/>
      <dgm:t>
        <a:bodyPr/>
        <a:lstStyle/>
        <a:p>
          <a:endParaRPr lang="en-US"/>
        </a:p>
      </dgm:t>
    </dgm:pt>
    <dgm:pt modelId="{D03F059F-5021-1F40-A19F-9647158C52AD}">
      <dgm:prSet phldrT="[Text]"/>
      <dgm:spPr/>
      <dgm:t>
        <a:bodyPr/>
        <a:lstStyle/>
        <a:p>
          <a:r>
            <a:rPr lang="en-US" dirty="0"/>
            <a:t>2</a:t>
          </a:r>
        </a:p>
      </dgm:t>
    </dgm:pt>
    <dgm:pt modelId="{CF000D09-B476-0444-AE02-AACE5A32ABB9}" type="parTrans" cxnId="{65CEA44F-9E16-EA4E-A309-EC3B3016297A}">
      <dgm:prSet/>
      <dgm:spPr/>
      <dgm:t>
        <a:bodyPr/>
        <a:lstStyle/>
        <a:p>
          <a:endParaRPr lang="en-US"/>
        </a:p>
      </dgm:t>
    </dgm:pt>
    <dgm:pt modelId="{294C2440-29C3-A948-ADDD-2D4D34880BDD}" type="sibTrans" cxnId="{65CEA44F-9E16-EA4E-A309-EC3B3016297A}">
      <dgm:prSet/>
      <dgm:spPr/>
      <dgm:t>
        <a:bodyPr/>
        <a:lstStyle/>
        <a:p>
          <a:endParaRPr lang="en-US"/>
        </a:p>
      </dgm:t>
    </dgm:pt>
    <dgm:pt modelId="{8E966A69-49F1-5E4B-B606-FCAEDAA984ED}">
      <dgm:prSet phldrT="[Text]"/>
      <dgm:spPr/>
      <dgm:t>
        <a:bodyPr/>
        <a:lstStyle/>
        <a:p>
          <a:r>
            <a:rPr lang="en-US" dirty="0"/>
            <a:t>Emotional check</a:t>
          </a:r>
        </a:p>
      </dgm:t>
    </dgm:pt>
    <dgm:pt modelId="{DBAD8E5C-BD8A-8D4C-B4F0-8493200D7696}" type="parTrans" cxnId="{FBB45EE4-904A-AF48-A0C9-CB655E66EF52}">
      <dgm:prSet/>
      <dgm:spPr/>
      <dgm:t>
        <a:bodyPr/>
        <a:lstStyle/>
        <a:p>
          <a:endParaRPr lang="en-US"/>
        </a:p>
      </dgm:t>
    </dgm:pt>
    <dgm:pt modelId="{6E022D76-54D3-5040-BFB1-6E3CF648085C}" type="sibTrans" cxnId="{FBB45EE4-904A-AF48-A0C9-CB655E66EF52}">
      <dgm:prSet/>
      <dgm:spPr/>
      <dgm:t>
        <a:bodyPr/>
        <a:lstStyle/>
        <a:p>
          <a:endParaRPr lang="en-US"/>
        </a:p>
      </dgm:t>
    </dgm:pt>
    <dgm:pt modelId="{73A345CE-36FD-894D-BBC6-F1148569A643}">
      <dgm:prSet phldrT="[Text]"/>
      <dgm:spPr/>
      <dgm:t>
        <a:bodyPr/>
        <a:lstStyle/>
        <a:p>
          <a:r>
            <a:rPr lang="en-US" dirty="0"/>
            <a:t>3</a:t>
          </a:r>
        </a:p>
      </dgm:t>
    </dgm:pt>
    <dgm:pt modelId="{E3B27BD6-FBE2-5640-8D4A-26A5222CC3EA}" type="parTrans" cxnId="{408ED183-BF58-1C4B-97FD-732582625FEF}">
      <dgm:prSet/>
      <dgm:spPr/>
      <dgm:t>
        <a:bodyPr/>
        <a:lstStyle/>
        <a:p>
          <a:endParaRPr lang="en-US"/>
        </a:p>
      </dgm:t>
    </dgm:pt>
    <dgm:pt modelId="{7A99C83F-BC00-3743-81E8-552BD253CEC3}" type="sibTrans" cxnId="{408ED183-BF58-1C4B-97FD-732582625FEF}">
      <dgm:prSet/>
      <dgm:spPr/>
      <dgm:t>
        <a:bodyPr/>
        <a:lstStyle/>
        <a:p>
          <a:endParaRPr lang="en-US"/>
        </a:p>
      </dgm:t>
    </dgm:pt>
    <dgm:pt modelId="{E900B89A-C42B-5249-B68C-A3D7ECDC2722}">
      <dgm:prSet phldrT="[Text]"/>
      <dgm:spPr/>
      <dgm:t>
        <a:bodyPr/>
        <a:lstStyle/>
        <a:p>
          <a:r>
            <a:rPr lang="en-US" dirty="0"/>
            <a:t>Address bias</a:t>
          </a:r>
        </a:p>
      </dgm:t>
    </dgm:pt>
    <dgm:pt modelId="{8E839505-C7B5-E846-B572-409C6E14F87D}" type="parTrans" cxnId="{8EA459AB-225B-8C4D-9825-5D1C6BF10277}">
      <dgm:prSet/>
      <dgm:spPr/>
      <dgm:t>
        <a:bodyPr/>
        <a:lstStyle/>
        <a:p>
          <a:endParaRPr lang="en-US"/>
        </a:p>
      </dgm:t>
    </dgm:pt>
    <dgm:pt modelId="{1CCB8A03-5593-CE44-86BA-AACEAE0CCB98}" type="sibTrans" cxnId="{8EA459AB-225B-8C4D-9825-5D1C6BF10277}">
      <dgm:prSet/>
      <dgm:spPr/>
      <dgm:t>
        <a:bodyPr/>
        <a:lstStyle/>
        <a:p>
          <a:endParaRPr lang="en-US"/>
        </a:p>
      </dgm:t>
    </dgm:pt>
    <dgm:pt modelId="{418E94F4-4F87-154C-8C2C-4FA1854F2962}">
      <dgm:prSet/>
      <dgm:spPr/>
      <dgm:t>
        <a:bodyPr/>
        <a:lstStyle/>
        <a:p>
          <a:r>
            <a:rPr lang="en-US" dirty="0"/>
            <a:t>4</a:t>
          </a:r>
        </a:p>
      </dgm:t>
    </dgm:pt>
    <dgm:pt modelId="{67B29BF1-08A2-E04F-9D69-0598739CF13B}" type="parTrans" cxnId="{2BBF3C50-1ED6-9847-B76B-936F9EDE5606}">
      <dgm:prSet/>
      <dgm:spPr/>
      <dgm:t>
        <a:bodyPr/>
        <a:lstStyle/>
        <a:p>
          <a:endParaRPr lang="en-US"/>
        </a:p>
      </dgm:t>
    </dgm:pt>
    <dgm:pt modelId="{A5C1BCA8-59E6-2D47-BF9C-24A0A56844F7}" type="sibTrans" cxnId="{2BBF3C50-1ED6-9847-B76B-936F9EDE5606}">
      <dgm:prSet/>
      <dgm:spPr/>
      <dgm:t>
        <a:bodyPr/>
        <a:lstStyle/>
        <a:p>
          <a:endParaRPr lang="en-US"/>
        </a:p>
      </dgm:t>
    </dgm:pt>
    <dgm:pt modelId="{827957E1-E296-1C4F-A5F6-1C5FE324A00C}">
      <dgm:prSet/>
      <dgm:spPr/>
      <dgm:t>
        <a:bodyPr/>
        <a:lstStyle/>
        <a:p>
          <a:r>
            <a:rPr lang="en-US" dirty="0"/>
            <a:t>5</a:t>
          </a:r>
        </a:p>
      </dgm:t>
    </dgm:pt>
    <dgm:pt modelId="{AC89EDA2-97A0-704F-A224-66777968DC79}" type="parTrans" cxnId="{C5A31E1B-1939-A943-9EA9-0D1F931C9095}">
      <dgm:prSet/>
      <dgm:spPr/>
      <dgm:t>
        <a:bodyPr/>
        <a:lstStyle/>
        <a:p>
          <a:endParaRPr lang="en-US"/>
        </a:p>
      </dgm:t>
    </dgm:pt>
    <dgm:pt modelId="{9F52F0F0-B16C-AB44-86AF-35AA79D5B0BB}" type="sibTrans" cxnId="{C5A31E1B-1939-A943-9EA9-0D1F931C9095}">
      <dgm:prSet/>
      <dgm:spPr/>
      <dgm:t>
        <a:bodyPr/>
        <a:lstStyle/>
        <a:p>
          <a:endParaRPr lang="en-US"/>
        </a:p>
      </dgm:t>
    </dgm:pt>
    <dgm:pt modelId="{9F6E5C8F-12F1-3545-94A6-291C5042E69E}">
      <dgm:prSet/>
      <dgm:spPr/>
      <dgm:t>
        <a:bodyPr/>
        <a:lstStyle/>
        <a:p>
          <a:r>
            <a:rPr lang="en-US" dirty="0"/>
            <a:t>6</a:t>
          </a:r>
        </a:p>
      </dgm:t>
    </dgm:pt>
    <dgm:pt modelId="{F878F1E0-BA83-0B4F-8407-D69A3E0606E8}" type="parTrans" cxnId="{545F95DE-9A10-3948-9807-36C195D34A35}">
      <dgm:prSet/>
      <dgm:spPr/>
      <dgm:t>
        <a:bodyPr/>
        <a:lstStyle/>
        <a:p>
          <a:endParaRPr lang="en-US"/>
        </a:p>
      </dgm:t>
    </dgm:pt>
    <dgm:pt modelId="{F501E3C1-886B-5244-A7B1-7A80D72A4D8C}" type="sibTrans" cxnId="{545F95DE-9A10-3948-9807-36C195D34A35}">
      <dgm:prSet/>
      <dgm:spPr/>
      <dgm:t>
        <a:bodyPr/>
        <a:lstStyle/>
        <a:p>
          <a:endParaRPr lang="en-US"/>
        </a:p>
      </dgm:t>
    </dgm:pt>
    <dgm:pt modelId="{02BDF100-8338-E043-96F5-EE898B9D5AB2}">
      <dgm:prSet/>
      <dgm:spPr/>
      <dgm:t>
        <a:bodyPr/>
        <a:lstStyle/>
        <a:p>
          <a:r>
            <a:rPr lang="en-US" dirty="0"/>
            <a:t>7</a:t>
          </a:r>
        </a:p>
      </dgm:t>
    </dgm:pt>
    <dgm:pt modelId="{1B53CCA0-CFF2-384B-856E-1EBDFA4D02AD}" type="parTrans" cxnId="{F6183E77-6BBF-FA47-854D-F0D53AE21A8A}">
      <dgm:prSet/>
      <dgm:spPr/>
      <dgm:t>
        <a:bodyPr/>
        <a:lstStyle/>
        <a:p>
          <a:endParaRPr lang="en-US"/>
        </a:p>
      </dgm:t>
    </dgm:pt>
    <dgm:pt modelId="{BCE247F3-63ED-824C-BC43-9D645F88694B}" type="sibTrans" cxnId="{F6183E77-6BBF-FA47-854D-F0D53AE21A8A}">
      <dgm:prSet/>
      <dgm:spPr/>
      <dgm:t>
        <a:bodyPr/>
        <a:lstStyle/>
        <a:p>
          <a:endParaRPr lang="en-US"/>
        </a:p>
      </dgm:t>
    </dgm:pt>
    <dgm:pt modelId="{7CF6944D-D814-F446-BDE2-B55C1C344687}">
      <dgm:prSet/>
      <dgm:spPr/>
      <dgm:t>
        <a:bodyPr/>
        <a:lstStyle/>
        <a:p>
          <a:r>
            <a:rPr lang="en-US" dirty="0"/>
            <a:t>8</a:t>
          </a:r>
        </a:p>
      </dgm:t>
    </dgm:pt>
    <dgm:pt modelId="{18766106-4E88-954F-80B4-8435CD7E3607}" type="parTrans" cxnId="{B4BAA057-82A7-8F4F-B3AE-D2474B9F0D61}">
      <dgm:prSet/>
      <dgm:spPr/>
      <dgm:t>
        <a:bodyPr/>
        <a:lstStyle/>
        <a:p>
          <a:endParaRPr lang="en-US"/>
        </a:p>
      </dgm:t>
    </dgm:pt>
    <dgm:pt modelId="{41CA9CD1-BD05-D240-8585-F6D044F469D5}" type="sibTrans" cxnId="{B4BAA057-82A7-8F4F-B3AE-D2474B9F0D61}">
      <dgm:prSet/>
      <dgm:spPr/>
      <dgm:t>
        <a:bodyPr/>
        <a:lstStyle/>
        <a:p>
          <a:endParaRPr lang="en-US"/>
        </a:p>
      </dgm:t>
    </dgm:pt>
    <dgm:pt modelId="{77E26394-E137-5E44-9434-AC75CD3E8E1C}">
      <dgm:prSet/>
      <dgm:spPr/>
      <dgm:t>
        <a:bodyPr/>
        <a:lstStyle/>
        <a:p>
          <a:r>
            <a:rPr lang="en-US" dirty="0"/>
            <a:t>Align with team</a:t>
          </a:r>
        </a:p>
      </dgm:t>
    </dgm:pt>
    <dgm:pt modelId="{0106416C-C608-3E4B-95A9-3A27F212EF0D}" type="parTrans" cxnId="{3055A850-65BD-2C48-A538-0AAEB9138E85}">
      <dgm:prSet/>
      <dgm:spPr/>
      <dgm:t>
        <a:bodyPr/>
        <a:lstStyle/>
        <a:p>
          <a:endParaRPr lang="en-US"/>
        </a:p>
      </dgm:t>
    </dgm:pt>
    <dgm:pt modelId="{4162CFAB-B676-8E4E-8FEB-32BD16B62DEC}" type="sibTrans" cxnId="{3055A850-65BD-2C48-A538-0AAEB9138E85}">
      <dgm:prSet/>
      <dgm:spPr/>
      <dgm:t>
        <a:bodyPr/>
        <a:lstStyle/>
        <a:p>
          <a:endParaRPr lang="en-US"/>
        </a:p>
      </dgm:t>
    </dgm:pt>
    <dgm:pt modelId="{D6BB4A41-00B2-5448-BB3F-80605AC75A4E}">
      <dgm:prSet/>
      <dgm:spPr/>
      <dgm:t>
        <a:bodyPr/>
        <a:lstStyle/>
        <a:p>
          <a:r>
            <a:rPr lang="en-US" dirty="0"/>
            <a:t>Recenter on care</a:t>
          </a:r>
        </a:p>
      </dgm:t>
    </dgm:pt>
    <dgm:pt modelId="{4E04882C-8060-1D42-8502-5D210AA0DCD3}" type="parTrans" cxnId="{DF1A41C0-D8B8-6D4F-A8A5-91EC68AFBCAD}">
      <dgm:prSet/>
      <dgm:spPr/>
      <dgm:t>
        <a:bodyPr/>
        <a:lstStyle/>
        <a:p>
          <a:endParaRPr lang="en-US"/>
        </a:p>
      </dgm:t>
    </dgm:pt>
    <dgm:pt modelId="{A3F6C628-648D-0249-B65F-551AF9ECEEA6}" type="sibTrans" cxnId="{DF1A41C0-D8B8-6D4F-A8A5-91EC68AFBCAD}">
      <dgm:prSet/>
      <dgm:spPr/>
      <dgm:t>
        <a:bodyPr/>
        <a:lstStyle/>
        <a:p>
          <a:endParaRPr lang="en-US"/>
        </a:p>
      </dgm:t>
    </dgm:pt>
    <dgm:pt modelId="{0545D5E0-C6B3-A447-B001-E955BFE39730}">
      <dgm:prSet/>
      <dgm:spPr/>
      <dgm:t>
        <a:bodyPr/>
        <a:lstStyle/>
        <a:p>
          <a:r>
            <a:rPr lang="en-US" dirty="0"/>
            <a:t>Give space</a:t>
          </a:r>
        </a:p>
      </dgm:t>
    </dgm:pt>
    <dgm:pt modelId="{74548467-254B-2943-9A99-08C07F3E448D}" type="parTrans" cxnId="{E2BB9BC9-6DB1-9443-8E35-6250A99E4AD7}">
      <dgm:prSet/>
      <dgm:spPr/>
      <dgm:t>
        <a:bodyPr/>
        <a:lstStyle/>
        <a:p>
          <a:endParaRPr lang="en-US"/>
        </a:p>
      </dgm:t>
    </dgm:pt>
    <dgm:pt modelId="{43A03E68-4CAE-A344-B58C-38B13B6EE776}" type="sibTrans" cxnId="{E2BB9BC9-6DB1-9443-8E35-6250A99E4AD7}">
      <dgm:prSet/>
      <dgm:spPr/>
      <dgm:t>
        <a:bodyPr/>
        <a:lstStyle/>
        <a:p>
          <a:endParaRPr lang="en-US"/>
        </a:p>
      </dgm:t>
    </dgm:pt>
    <dgm:pt modelId="{4042EA18-93B7-8447-AC0A-58BAED6135AA}">
      <dgm:prSet/>
      <dgm:spPr/>
      <dgm:t>
        <a:bodyPr/>
        <a:lstStyle/>
        <a:p>
          <a:r>
            <a:rPr lang="en-US" dirty="0"/>
            <a:t>Seek support</a:t>
          </a:r>
        </a:p>
      </dgm:t>
    </dgm:pt>
    <dgm:pt modelId="{2F5CB061-56DE-EB4D-BFD4-36B00E6055CB}" type="parTrans" cxnId="{BBBA16DC-BC73-8048-A725-FE1EF1BF6593}">
      <dgm:prSet/>
      <dgm:spPr/>
      <dgm:t>
        <a:bodyPr/>
        <a:lstStyle/>
        <a:p>
          <a:endParaRPr lang="en-US"/>
        </a:p>
      </dgm:t>
    </dgm:pt>
    <dgm:pt modelId="{A608511D-1BB9-EB4E-9E74-CCD7B0DB861D}" type="sibTrans" cxnId="{BBBA16DC-BC73-8048-A725-FE1EF1BF6593}">
      <dgm:prSet/>
      <dgm:spPr/>
      <dgm:t>
        <a:bodyPr/>
        <a:lstStyle/>
        <a:p>
          <a:endParaRPr lang="en-US"/>
        </a:p>
      </dgm:t>
    </dgm:pt>
    <dgm:pt modelId="{B3ABDBBC-28C2-CC44-9EA0-940A074F9BF0}">
      <dgm:prSet/>
      <dgm:spPr/>
      <dgm:t>
        <a:bodyPr/>
        <a:lstStyle/>
        <a:p>
          <a:r>
            <a:rPr lang="en-US" dirty="0"/>
            <a:t>Set boundaries</a:t>
          </a:r>
        </a:p>
      </dgm:t>
    </dgm:pt>
    <dgm:pt modelId="{B1A1C092-087B-F241-9B26-AD1D13C72D4D}" type="sibTrans" cxnId="{D85391B8-F585-FD43-82E0-8ACB9B810BF4}">
      <dgm:prSet/>
      <dgm:spPr/>
      <dgm:t>
        <a:bodyPr/>
        <a:lstStyle/>
        <a:p>
          <a:endParaRPr lang="en-US"/>
        </a:p>
      </dgm:t>
    </dgm:pt>
    <dgm:pt modelId="{D1297B60-D255-DA44-8D75-399213932CFB}" type="parTrans" cxnId="{D85391B8-F585-FD43-82E0-8ACB9B810BF4}">
      <dgm:prSet/>
      <dgm:spPr/>
      <dgm:t>
        <a:bodyPr/>
        <a:lstStyle/>
        <a:p>
          <a:endParaRPr lang="en-US"/>
        </a:p>
      </dgm:t>
    </dgm:pt>
    <dgm:pt modelId="{C651D352-06FA-1B42-81FF-A95099FE5645}" type="pres">
      <dgm:prSet presAssocID="{CE7EC2B3-709C-7049-AC98-40D647A08CD5}" presName="Name0" presStyleCnt="0">
        <dgm:presLayoutVars>
          <dgm:dir/>
          <dgm:animLvl val="lvl"/>
          <dgm:resizeHandles val="exact"/>
        </dgm:presLayoutVars>
      </dgm:prSet>
      <dgm:spPr/>
    </dgm:pt>
    <dgm:pt modelId="{2E2FEDEA-0CB5-FD4B-8718-95B9D6A14304}" type="pres">
      <dgm:prSet presAssocID="{54EB0C78-47D0-4144-BBA1-ED83F2276A80}" presName="linNode" presStyleCnt="0"/>
      <dgm:spPr/>
    </dgm:pt>
    <dgm:pt modelId="{2F0271A3-745A-A943-B67B-E4069A93AE61}" type="pres">
      <dgm:prSet presAssocID="{54EB0C78-47D0-4144-BBA1-ED83F2276A80}" presName="parentText" presStyleLbl="node1" presStyleIdx="0" presStyleCnt="8" custScaleX="67001">
        <dgm:presLayoutVars>
          <dgm:chMax val="1"/>
          <dgm:bulletEnabled val="1"/>
        </dgm:presLayoutVars>
      </dgm:prSet>
      <dgm:spPr/>
    </dgm:pt>
    <dgm:pt modelId="{21D64796-42C1-6A47-B16B-F23C35A117FF}" type="pres">
      <dgm:prSet presAssocID="{54EB0C78-47D0-4144-BBA1-ED83F2276A80}" presName="descendantText" presStyleLbl="alignAccFollowNode1" presStyleIdx="0" presStyleCnt="8">
        <dgm:presLayoutVars>
          <dgm:bulletEnabled val="1"/>
        </dgm:presLayoutVars>
      </dgm:prSet>
      <dgm:spPr/>
    </dgm:pt>
    <dgm:pt modelId="{B2C4C361-6A0B-BC45-90FD-318B0EB08F6D}" type="pres">
      <dgm:prSet presAssocID="{E8376F97-8FAC-AA43-868D-BB3E335B92F2}" presName="sp" presStyleCnt="0"/>
      <dgm:spPr/>
    </dgm:pt>
    <dgm:pt modelId="{277D1FDC-6CD3-BB41-8E20-960C658417CF}" type="pres">
      <dgm:prSet presAssocID="{D03F059F-5021-1F40-A19F-9647158C52AD}" presName="linNode" presStyleCnt="0"/>
      <dgm:spPr/>
    </dgm:pt>
    <dgm:pt modelId="{6CEBA26E-9501-3E41-ACBB-39C96B19A924}" type="pres">
      <dgm:prSet presAssocID="{D03F059F-5021-1F40-A19F-9647158C52AD}" presName="parentText" presStyleLbl="node1" presStyleIdx="1" presStyleCnt="8" custScaleX="67001">
        <dgm:presLayoutVars>
          <dgm:chMax val="1"/>
          <dgm:bulletEnabled val="1"/>
        </dgm:presLayoutVars>
      </dgm:prSet>
      <dgm:spPr/>
    </dgm:pt>
    <dgm:pt modelId="{2EB4DD27-0645-2048-89E9-55CE50FE52DA}" type="pres">
      <dgm:prSet presAssocID="{D03F059F-5021-1F40-A19F-9647158C52AD}" presName="descendantText" presStyleLbl="alignAccFollowNode1" presStyleIdx="1" presStyleCnt="8">
        <dgm:presLayoutVars>
          <dgm:bulletEnabled val="1"/>
        </dgm:presLayoutVars>
      </dgm:prSet>
      <dgm:spPr/>
    </dgm:pt>
    <dgm:pt modelId="{33CCAA17-6648-4F4C-9AC2-5ECE7EDB6E70}" type="pres">
      <dgm:prSet presAssocID="{294C2440-29C3-A948-ADDD-2D4D34880BDD}" presName="sp" presStyleCnt="0"/>
      <dgm:spPr/>
    </dgm:pt>
    <dgm:pt modelId="{B97FC210-8EA1-614A-91AB-916C1AEFBDEE}" type="pres">
      <dgm:prSet presAssocID="{73A345CE-36FD-894D-BBC6-F1148569A643}" presName="linNode" presStyleCnt="0"/>
      <dgm:spPr/>
    </dgm:pt>
    <dgm:pt modelId="{A3A63788-1227-B240-AFF4-87DA3887717D}" type="pres">
      <dgm:prSet presAssocID="{73A345CE-36FD-894D-BBC6-F1148569A643}" presName="parentText" presStyleLbl="node1" presStyleIdx="2" presStyleCnt="8" custScaleX="67001">
        <dgm:presLayoutVars>
          <dgm:chMax val="1"/>
          <dgm:bulletEnabled val="1"/>
        </dgm:presLayoutVars>
      </dgm:prSet>
      <dgm:spPr/>
    </dgm:pt>
    <dgm:pt modelId="{5432570E-A980-7C49-B78B-FBD7E95247D6}" type="pres">
      <dgm:prSet presAssocID="{73A345CE-36FD-894D-BBC6-F1148569A643}" presName="descendantText" presStyleLbl="alignAccFollowNode1" presStyleIdx="2" presStyleCnt="8">
        <dgm:presLayoutVars>
          <dgm:bulletEnabled val="1"/>
        </dgm:presLayoutVars>
      </dgm:prSet>
      <dgm:spPr/>
    </dgm:pt>
    <dgm:pt modelId="{3E055F9F-21A2-424C-8A4E-65EE89C8A916}" type="pres">
      <dgm:prSet presAssocID="{7A99C83F-BC00-3743-81E8-552BD253CEC3}" presName="sp" presStyleCnt="0"/>
      <dgm:spPr/>
    </dgm:pt>
    <dgm:pt modelId="{3D7F3715-4665-FB42-B9D8-1FF06FE7ED04}" type="pres">
      <dgm:prSet presAssocID="{418E94F4-4F87-154C-8C2C-4FA1854F2962}" presName="linNode" presStyleCnt="0"/>
      <dgm:spPr/>
    </dgm:pt>
    <dgm:pt modelId="{F459C834-8503-9C47-9E88-19B5B264D39A}" type="pres">
      <dgm:prSet presAssocID="{418E94F4-4F87-154C-8C2C-4FA1854F2962}" presName="parentText" presStyleLbl="node1" presStyleIdx="3" presStyleCnt="8" custScaleX="67001">
        <dgm:presLayoutVars>
          <dgm:chMax val="1"/>
          <dgm:bulletEnabled val="1"/>
        </dgm:presLayoutVars>
      </dgm:prSet>
      <dgm:spPr/>
    </dgm:pt>
    <dgm:pt modelId="{B11406A9-5BCB-7247-9C38-2B1D2505F2B8}" type="pres">
      <dgm:prSet presAssocID="{418E94F4-4F87-154C-8C2C-4FA1854F2962}" presName="descendantText" presStyleLbl="alignAccFollowNode1" presStyleIdx="3" presStyleCnt="8">
        <dgm:presLayoutVars>
          <dgm:bulletEnabled val="1"/>
        </dgm:presLayoutVars>
      </dgm:prSet>
      <dgm:spPr/>
    </dgm:pt>
    <dgm:pt modelId="{E355AC6F-4099-CB47-B889-4B740E437363}" type="pres">
      <dgm:prSet presAssocID="{A5C1BCA8-59E6-2D47-BF9C-24A0A56844F7}" presName="sp" presStyleCnt="0"/>
      <dgm:spPr/>
    </dgm:pt>
    <dgm:pt modelId="{A60CA7D8-39CB-954A-95BD-9B247DA4C063}" type="pres">
      <dgm:prSet presAssocID="{827957E1-E296-1C4F-A5F6-1C5FE324A00C}" presName="linNode" presStyleCnt="0"/>
      <dgm:spPr/>
    </dgm:pt>
    <dgm:pt modelId="{4D3677DD-203E-6A46-986E-4A5C658C9303}" type="pres">
      <dgm:prSet presAssocID="{827957E1-E296-1C4F-A5F6-1C5FE324A00C}" presName="parentText" presStyleLbl="node1" presStyleIdx="4" presStyleCnt="8" custScaleX="67001">
        <dgm:presLayoutVars>
          <dgm:chMax val="1"/>
          <dgm:bulletEnabled val="1"/>
        </dgm:presLayoutVars>
      </dgm:prSet>
      <dgm:spPr/>
    </dgm:pt>
    <dgm:pt modelId="{DF481026-182D-AB4B-A938-B9E12915351D}" type="pres">
      <dgm:prSet presAssocID="{827957E1-E296-1C4F-A5F6-1C5FE324A00C}" presName="descendantText" presStyleLbl="alignAccFollowNode1" presStyleIdx="4" presStyleCnt="8">
        <dgm:presLayoutVars>
          <dgm:bulletEnabled val="1"/>
        </dgm:presLayoutVars>
      </dgm:prSet>
      <dgm:spPr/>
    </dgm:pt>
    <dgm:pt modelId="{0E9316E9-2C30-AB47-AE90-7E8E046E1AFD}" type="pres">
      <dgm:prSet presAssocID="{9F52F0F0-B16C-AB44-86AF-35AA79D5B0BB}" presName="sp" presStyleCnt="0"/>
      <dgm:spPr/>
    </dgm:pt>
    <dgm:pt modelId="{037794A2-D322-8E40-B011-CE07ECE52AD6}" type="pres">
      <dgm:prSet presAssocID="{9F6E5C8F-12F1-3545-94A6-291C5042E69E}" presName="linNode" presStyleCnt="0"/>
      <dgm:spPr/>
    </dgm:pt>
    <dgm:pt modelId="{B6C279C8-1B63-3845-ADAB-B82AEFA3D8E4}" type="pres">
      <dgm:prSet presAssocID="{9F6E5C8F-12F1-3545-94A6-291C5042E69E}" presName="parentText" presStyleLbl="node1" presStyleIdx="5" presStyleCnt="8" custScaleX="67001">
        <dgm:presLayoutVars>
          <dgm:chMax val="1"/>
          <dgm:bulletEnabled val="1"/>
        </dgm:presLayoutVars>
      </dgm:prSet>
      <dgm:spPr/>
    </dgm:pt>
    <dgm:pt modelId="{95DA0D8B-BC89-0948-909A-C298332DBD75}" type="pres">
      <dgm:prSet presAssocID="{9F6E5C8F-12F1-3545-94A6-291C5042E69E}" presName="descendantText" presStyleLbl="alignAccFollowNode1" presStyleIdx="5" presStyleCnt="8">
        <dgm:presLayoutVars>
          <dgm:bulletEnabled val="1"/>
        </dgm:presLayoutVars>
      </dgm:prSet>
      <dgm:spPr/>
    </dgm:pt>
    <dgm:pt modelId="{05C8E7F6-EE84-404A-A830-A5238A04D5A3}" type="pres">
      <dgm:prSet presAssocID="{F501E3C1-886B-5244-A7B1-7A80D72A4D8C}" presName="sp" presStyleCnt="0"/>
      <dgm:spPr/>
    </dgm:pt>
    <dgm:pt modelId="{450D1F74-F684-8F4C-A8B3-6F8B553AB682}" type="pres">
      <dgm:prSet presAssocID="{02BDF100-8338-E043-96F5-EE898B9D5AB2}" presName="linNode" presStyleCnt="0"/>
      <dgm:spPr/>
    </dgm:pt>
    <dgm:pt modelId="{B67BA8B7-08DC-C244-8300-FCD547033DBD}" type="pres">
      <dgm:prSet presAssocID="{02BDF100-8338-E043-96F5-EE898B9D5AB2}" presName="parentText" presStyleLbl="node1" presStyleIdx="6" presStyleCnt="8" custScaleX="67001">
        <dgm:presLayoutVars>
          <dgm:chMax val="1"/>
          <dgm:bulletEnabled val="1"/>
        </dgm:presLayoutVars>
      </dgm:prSet>
      <dgm:spPr/>
    </dgm:pt>
    <dgm:pt modelId="{9D2B4FF6-13FB-EF49-977A-31DF5EE58099}" type="pres">
      <dgm:prSet presAssocID="{02BDF100-8338-E043-96F5-EE898B9D5AB2}" presName="descendantText" presStyleLbl="alignAccFollowNode1" presStyleIdx="6" presStyleCnt="8">
        <dgm:presLayoutVars>
          <dgm:bulletEnabled val="1"/>
        </dgm:presLayoutVars>
      </dgm:prSet>
      <dgm:spPr/>
    </dgm:pt>
    <dgm:pt modelId="{580F7313-AC0F-FA49-A45E-0C9486F52D6E}" type="pres">
      <dgm:prSet presAssocID="{BCE247F3-63ED-824C-BC43-9D645F88694B}" presName="sp" presStyleCnt="0"/>
      <dgm:spPr/>
    </dgm:pt>
    <dgm:pt modelId="{E737A561-EB87-EC46-B404-0D8CDB0DE287}" type="pres">
      <dgm:prSet presAssocID="{7CF6944D-D814-F446-BDE2-B55C1C344687}" presName="linNode" presStyleCnt="0"/>
      <dgm:spPr/>
    </dgm:pt>
    <dgm:pt modelId="{D5D04DA4-D0C2-DE47-8C8C-0B8EFFA304FE}" type="pres">
      <dgm:prSet presAssocID="{7CF6944D-D814-F446-BDE2-B55C1C344687}" presName="parentText" presStyleLbl="node1" presStyleIdx="7" presStyleCnt="8" custScaleX="67001">
        <dgm:presLayoutVars>
          <dgm:chMax val="1"/>
          <dgm:bulletEnabled val="1"/>
        </dgm:presLayoutVars>
      </dgm:prSet>
      <dgm:spPr/>
    </dgm:pt>
    <dgm:pt modelId="{8CF3EAF4-8574-9841-9B3E-4FBF8CB57172}" type="pres">
      <dgm:prSet presAssocID="{7CF6944D-D814-F446-BDE2-B55C1C344687}" presName="descendantText" presStyleLbl="alignAccFollowNode1" presStyleIdx="7" presStyleCnt="8">
        <dgm:presLayoutVars>
          <dgm:bulletEnabled val="1"/>
        </dgm:presLayoutVars>
      </dgm:prSet>
      <dgm:spPr/>
    </dgm:pt>
  </dgm:ptLst>
  <dgm:cxnLst>
    <dgm:cxn modelId="{E4273A05-E6BD-7B48-BAB7-FF2C885BDD30}" type="presOf" srcId="{02BDF100-8338-E043-96F5-EE898B9D5AB2}" destId="{B67BA8B7-08DC-C244-8300-FCD547033DBD}" srcOrd="0" destOrd="0" presId="urn:microsoft.com/office/officeart/2005/8/layout/vList5"/>
    <dgm:cxn modelId="{E9D1E10C-1628-524C-9321-D84C071FF74D}" type="presOf" srcId="{CE7EC2B3-709C-7049-AC98-40D647A08CD5}" destId="{C651D352-06FA-1B42-81FF-A95099FE5645}" srcOrd="0" destOrd="0" presId="urn:microsoft.com/office/officeart/2005/8/layout/vList5"/>
    <dgm:cxn modelId="{C4160712-DF53-0F4F-9BBA-78BD9BBF4B88}" type="presOf" srcId="{77E26394-E137-5E44-9434-AC75CD3E8E1C}" destId="{B11406A9-5BCB-7247-9C38-2B1D2505F2B8}" srcOrd="0" destOrd="0" presId="urn:microsoft.com/office/officeart/2005/8/layout/vList5"/>
    <dgm:cxn modelId="{C5A31E1B-1939-A943-9EA9-0D1F931C9095}" srcId="{CE7EC2B3-709C-7049-AC98-40D647A08CD5}" destId="{827957E1-E296-1C4F-A5F6-1C5FE324A00C}" srcOrd="4" destOrd="0" parTransId="{AC89EDA2-97A0-704F-A224-66777968DC79}" sibTransId="{9F52F0F0-B16C-AB44-86AF-35AA79D5B0BB}"/>
    <dgm:cxn modelId="{086EAA1D-3224-4E41-87B1-9FA27037DE47}" type="presOf" srcId="{9F6E5C8F-12F1-3545-94A6-291C5042E69E}" destId="{B6C279C8-1B63-3845-ADAB-B82AEFA3D8E4}" srcOrd="0" destOrd="0" presId="urn:microsoft.com/office/officeart/2005/8/layout/vList5"/>
    <dgm:cxn modelId="{71BBC71D-E55C-424F-B6C9-6E507D91D4E5}" type="presOf" srcId="{D6BB4A41-00B2-5448-BB3F-80605AC75A4E}" destId="{95DA0D8B-BC89-0948-909A-C298332DBD75}" srcOrd="0" destOrd="0" presId="urn:microsoft.com/office/officeart/2005/8/layout/vList5"/>
    <dgm:cxn modelId="{7A4CD21E-5C30-9844-B8CC-04D4CC71350C}" type="presOf" srcId="{4042EA18-93B7-8447-AC0A-58BAED6135AA}" destId="{8CF3EAF4-8574-9841-9B3E-4FBF8CB57172}" srcOrd="0" destOrd="0" presId="urn:microsoft.com/office/officeart/2005/8/layout/vList5"/>
    <dgm:cxn modelId="{EA0CCB2E-33A7-7842-AF42-FDB163C3A0DB}" type="presOf" srcId="{8E966A69-49F1-5E4B-B606-FCAEDAA984ED}" destId="{2EB4DD27-0645-2048-89E9-55CE50FE52DA}" srcOrd="0" destOrd="0" presId="urn:microsoft.com/office/officeart/2005/8/layout/vList5"/>
    <dgm:cxn modelId="{65CEA44F-9E16-EA4E-A309-EC3B3016297A}" srcId="{CE7EC2B3-709C-7049-AC98-40D647A08CD5}" destId="{D03F059F-5021-1F40-A19F-9647158C52AD}" srcOrd="1" destOrd="0" parTransId="{CF000D09-B476-0444-AE02-AACE5A32ABB9}" sibTransId="{294C2440-29C3-A948-ADDD-2D4D34880BDD}"/>
    <dgm:cxn modelId="{2BBF3C50-1ED6-9847-B76B-936F9EDE5606}" srcId="{CE7EC2B3-709C-7049-AC98-40D647A08CD5}" destId="{418E94F4-4F87-154C-8C2C-4FA1854F2962}" srcOrd="3" destOrd="0" parTransId="{67B29BF1-08A2-E04F-9D69-0598739CF13B}" sibTransId="{A5C1BCA8-59E6-2D47-BF9C-24A0A56844F7}"/>
    <dgm:cxn modelId="{3055A850-65BD-2C48-A538-0AAEB9138E85}" srcId="{418E94F4-4F87-154C-8C2C-4FA1854F2962}" destId="{77E26394-E137-5E44-9434-AC75CD3E8E1C}" srcOrd="0" destOrd="0" parTransId="{0106416C-C608-3E4B-95A9-3A27F212EF0D}" sibTransId="{4162CFAB-B676-8E4E-8FEB-32BD16B62DEC}"/>
    <dgm:cxn modelId="{B3273152-AF0F-EE4B-8C28-8B1E95E5CD89}" type="presOf" srcId="{E900B89A-C42B-5249-B68C-A3D7ECDC2722}" destId="{5432570E-A980-7C49-B78B-FBD7E95247D6}" srcOrd="0" destOrd="0" presId="urn:microsoft.com/office/officeart/2005/8/layout/vList5"/>
    <dgm:cxn modelId="{90712D57-061F-8444-BA8A-D8DA5E4630C5}" type="presOf" srcId="{73A345CE-36FD-894D-BBC6-F1148569A643}" destId="{A3A63788-1227-B240-AFF4-87DA3887717D}" srcOrd="0" destOrd="0" presId="urn:microsoft.com/office/officeart/2005/8/layout/vList5"/>
    <dgm:cxn modelId="{B4BAA057-82A7-8F4F-B3AE-D2474B9F0D61}" srcId="{CE7EC2B3-709C-7049-AC98-40D647A08CD5}" destId="{7CF6944D-D814-F446-BDE2-B55C1C344687}" srcOrd="7" destOrd="0" parTransId="{18766106-4E88-954F-80B4-8435CD7E3607}" sibTransId="{41CA9CD1-BD05-D240-8585-F6D044F469D5}"/>
    <dgm:cxn modelId="{BAD62360-A798-6A47-A994-B5126C6DDBBA}" type="presOf" srcId="{D57A6E2B-1DF9-5046-BC1D-709A01F64D7F}" destId="{21D64796-42C1-6A47-B16B-F23C35A117FF}" srcOrd="0" destOrd="0" presId="urn:microsoft.com/office/officeart/2005/8/layout/vList5"/>
    <dgm:cxn modelId="{F6183E77-6BBF-FA47-854D-F0D53AE21A8A}" srcId="{CE7EC2B3-709C-7049-AC98-40D647A08CD5}" destId="{02BDF100-8338-E043-96F5-EE898B9D5AB2}" srcOrd="6" destOrd="0" parTransId="{1B53CCA0-CFF2-384B-856E-1EBDFA4D02AD}" sibTransId="{BCE247F3-63ED-824C-BC43-9D645F88694B}"/>
    <dgm:cxn modelId="{89198578-5DCB-6140-878F-E9FD8D67271F}" type="presOf" srcId="{7CF6944D-D814-F446-BDE2-B55C1C344687}" destId="{D5D04DA4-D0C2-DE47-8C8C-0B8EFFA304FE}" srcOrd="0" destOrd="0" presId="urn:microsoft.com/office/officeart/2005/8/layout/vList5"/>
    <dgm:cxn modelId="{408ED183-BF58-1C4B-97FD-732582625FEF}" srcId="{CE7EC2B3-709C-7049-AC98-40D647A08CD5}" destId="{73A345CE-36FD-894D-BBC6-F1148569A643}" srcOrd="2" destOrd="0" parTransId="{E3B27BD6-FBE2-5640-8D4A-26A5222CC3EA}" sibTransId="{7A99C83F-BC00-3743-81E8-552BD253CEC3}"/>
    <dgm:cxn modelId="{B2C59790-5949-8740-B37D-5567793C306C}" srcId="{54EB0C78-47D0-4144-BBA1-ED83F2276A80}" destId="{D57A6E2B-1DF9-5046-BC1D-709A01F64D7F}" srcOrd="0" destOrd="0" parTransId="{C76AEE8B-D94A-7D44-B03A-3FE0785274DD}" sibTransId="{55132C62-F393-2540-A3F5-1E79E69F36CF}"/>
    <dgm:cxn modelId="{2D83CF9B-C8D2-5645-B148-7557D123AE42}" type="presOf" srcId="{827957E1-E296-1C4F-A5F6-1C5FE324A00C}" destId="{4D3677DD-203E-6A46-986E-4A5C658C9303}" srcOrd="0" destOrd="0" presId="urn:microsoft.com/office/officeart/2005/8/layout/vList5"/>
    <dgm:cxn modelId="{D734F3A8-F28E-EC4B-833E-A76A8DF839E2}" type="presOf" srcId="{D03F059F-5021-1F40-A19F-9647158C52AD}" destId="{6CEBA26E-9501-3E41-ACBB-39C96B19A924}" srcOrd="0" destOrd="0" presId="urn:microsoft.com/office/officeart/2005/8/layout/vList5"/>
    <dgm:cxn modelId="{8EA459AB-225B-8C4D-9825-5D1C6BF10277}" srcId="{73A345CE-36FD-894D-BBC6-F1148569A643}" destId="{E900B89A-C42B-5249-B68C-A3D7ECDC2722}" srcOrd="0" destOrd="0" parTransId="{8E839505-C7B5-E846-B572-409C6E14F87D}" sibTransId="{1CCB8A03-5593-CE44-86BA-AACEAE0CCB98}"/>
    <dgm:cxn modelId="{54AEA8B7-F89B-724F-98A1-0AEC5D7FC3A2}" srcId="{CE7EC2B3-709C-7049-AC98-40D647A08CD5}" destId="{54EB0C78-47D0-4144-BBA1-ED83F2276A80}" srcOrd="0" destOrd="0" parTransId="{46A28A5B-8A7C-BF49-A5DC-996D874F74B0}" sibTransId="{E8376F97-8FAC-AA43-868D-BB3E335B92F2}"/>
    <dgm:cxn modelId="{D85391B8-F585-FD43-82E0-8ACB9B810BF4}" srcId="{827957E1-E296-1C4F-A5F6-1C5FE324A00C}" destId="{B3ABDBBC-28C2-CC44-9EA0-940A074F9BF0}" srcOrd="0" destOrd="0" parTransId="{D1297B60-D255-DA44-8D75-399213932CFB}" sibTransId="{B1A1C092-087B-F241-9B26-AD1D13C72D4D}"/>
    <dgm:cxn modelId="{DF1A41C0-D8B8-6D4F-A8A5-91EC68AFBCAD}" srcId="{9F6E5C8F-12F1-3545-94A6-291C5042E69E}" destId="{D6BB4A41-00B2-5448-BB3F-80605AC75A4E}" srcOrd="0" destOrd="0" parTransId="{4E04882C-8060-1D42-8502-5D210AA0DCD3}" sibTransId="{A3F6C628-648D-0249-B65F-551AF9ECEEA6}"/>
    <dgm:cxn modelId="{F2E046C8-391B-6946-ACE6-697EC224AB98}" type="presOf" srcId="{B3ABDBBC-28C2-CC44-9EA0-940A074F9BF0}" destId="{DF481026-182D-AB4B-A938-B9E12915351D}" srcOrd="0" destOrd="0" presId="urn:microsoft.com/office/officeart/2005/8/layout/vList5"/>
    <dgm:cxn modelId="{E2BB9BC9-6DB1-9443-8E35-6250A99E4AD7}" srcId="{02BDF100-8338-E043-96F5-EE898B9D5AB2}" destId="{0545D5E0-C6B3-A447-B001-E955BFE39730}" srcOrd="0" destOrd="0" parTransId="{74548467-254B-2943-9A99-08C07F3E448D}" sibTransId="{43A03E68-4CAE-A344-B58C-38B13B6EE776}"/>
    <dgm:cxn modelId="{A16837DB-2A15-1C45-807B-67AB4EF8E75E}" type="presOf" srcId="{0545D5E0-C6B3-A447-B001-E955BFE39730}" destId="{9D2B4FF6-13FB-EF49-977A-31DF5EE58099}" srcOrd="0" destOrd="0" presId="urn:microsoft.com/office/officeart/2005/8/layout/vList5"/>
    <dgm:cxn modelId="{BBBA16DC-BC73-8048-A725-FE1EF1BF6593}" srcId="{7CF6944D-D814-F446-BDE2-B55C1C344687}" destId="{4042EA18-93B7-8447-AC0A-58BAED6135AA}" srcOrd="0" destOrd="0" parTransId="{2F5CB061-56DE-EB4D-BFD4-36B00E6055CB}" sibTransId="{A608511D-1BB9-EB4E-9E74-CCD7B0DB861D}"/>
    <dgm:cxn modelId="{545F95DE-9A10-3948-9807-36C195D34A35}" srcId="{CE7EC2B3-709C-7049-AC98-40D647A08CD5}" destId="{9F6E5C8F-12F1-3545-94A6-291C5042E69E}" srcOrd="5" destOrd="0" parTransId="{F878F1E0-BA83-0B4F-8407-D69A3E0606E8}" sibTransId="{F501E3C1-886B-5244-A7B1-7A80D72A4D8C}"/>
    <dgm:cxn modelId="{1AC639E1-2DD4-8C49-9596-C5731579DC3A}" type="presOf" srcId="{54EB0C78-47D0-4144-BBA1-ED83F2276A80}" destId="{2F0271A3-745A-A943-B67B-E4069A93AE61}" srcOrd="0" destOrd="0" presId="urn:microsoft.com/office/officeart/2005/8/layout/vList5"/>
    <dgm:cxn modelId="{FBB45EE4-904A-AF48-A0C9-CB655E66EF52}" srcId="{D03F059F-5021-1F40-A19F-9647158C52AD}" destId="{8E966A69-49F1-5E4B-B606-FCAEDAA984ED}" srcOrd="0" destOrd="0" parTransId="{DBAD8E5C-BD8A-8D4C-B4F0-8493200D7696}" sibTransId="{6E022D76-54D3-5040-BFB1-6E3CF648085C}"/>
    <dgm:cxn modelId="{CE4D51EC-1171-9740-9774-3550157EF9C1}" type="presOf" srcId="{418E94F4-4F87-154C-8C2C-4FA1854F2962}" destId="{F459C834-8503-9C47-9E88-19B5B264D39A}" srcOrd="0" destOrd="0" presId="urn:microsoft.com/office/officeart/2005/8/layout/vList5"/>
    <dgm:cxn modelId="{BF236B13-02D1-B64C-986F-0CAF7E0612E5}" type="presParOf" srcId="{C651D352-06FA-1B42-81FF-A95099FE5645}" destId="{2E2FEDEA-0CB5-FD4B-8718-95B9D6A14304}" srcOrd="0" destOrd="0" presId="urn:microsoft.com/office/officeart/2005/8/layout/vList5"/>
    <dgm:cxn modelId="{9578A504-AB23-5044-A923-D3DEFAE4D5E7}" type="presParOf" srcId="{2E2FEDEA-0CB5-FD4B-8718-95B9D6A14304}" destId="{2F0271A3-745A-A943-B67B-E4069A93AE61}" srcOrd="0" destOrd="0" presId="urn:microsoft.com/office/officeart/2005/8/layout/vList5"/>
    <dgm:cxn modelId="{253C94D8-1885-B543-AF3D-F6A1DD424873}" type="presParOf" srcId="{2E2FEDEA-0CB5-FD4B-8718-95B9D6A14304}" destId="{21D64796-42C1-6A47-B16B-F23C35A117FF}" srcOrd="1" destOrd="0" presId="urn:microsoft.com/office/officeart/2005/8/layout/vList5"/>
    <dgm:cxn modelId="{C06B9A2B-4F20-7C45-806D-5E7956B4F171}" type="presParOf" srcId="{C651D352-06FA-1B42-81FF-A95099FE5645}" destId="{B2C4C361-6A0B-BC45-90FD-318B0EB08F6D}" srcOrd="1" destOrd="0" presId="urn:microsoft.com/office/officeart/2005/8/layout/vList5"/>
    <dgm:cxn modelId="{7BF712B5-32BC-7844-BF86-9BFE0BE03182}" type="presParOf" srcId="{C651D352-06FA-1B42-81FF-A95099FE5645}" destId="{277D1FDC-6CD3-BB41-8E20-960C658417CF}" srcOrd="2" destOrd="0" presId="urn:microsoft.com/office/officeart/2005/8/layout/vList5"/>
    <dgm:cxn modelId="{8EE30A21-17AC-A34E-A945-33D32D0CD928}" type="presParOf" srcId="{277D1FDC-6CD3-BB41-8E20-960C658417CF}" destId="{6CEBA26E-9501-3E41-ACBB-39C96B19A924}" srcOrd="0" destOrd="0" presId="urn:microsoft.com/office/officeart/2005/8/layout/vList5"/>
    <dgm:cxn modelId="{3CCA96C7-C68E-DA49-A8B4-DD728A5A5A21}" type="presParOf" srcId="{277D1FDC-6CD3-BB41-8E20-960C658417CF}" destId="{2EB4DD27-0645-2048-89E9-55CE50FE52DA}" srcOrd="1" destOrd="0" presId="urn:microsoft.com/office/officeart/2005/8/layout/vList5"/>
    <dgm:cxn modelId="{4AF2BADF-B9C1-834B-AC41-60901F7D6D95}" type="presParOf" srcId="{C651D352-06FA-1B42-81FF-A95099FE5645}" destId="{33CCAA17-6648-4F4C-9AC2-5ECE7EDB6E70}" srcOrd="3" destOrd="0" presId="urn:microsoft.com/office/officeart/2005/8/layout/vList5"/>
    <dgm:cxn modelId="{2A4E440E-B7D6-6B49-8318-F6B71A21E6CF}" type="presParOf" srcId="{C651D352-06FA-1B42-81FF-A95099FE5645}" destId="{B97FC210-8EA1-614A-91AB-916C1AEFBDEE}" srcOrd="4" destOrd="0" presId="urn:microsoft.com/office/officeart/2005/8/layout/vList5"/>
    <dgm:cxn modelId="{2BDD0334-A1D2-DC42-B9D1-68F24D23B5D5}" type="presParOf" srcId="{B97FC210-8EA1-614A-91AB-916C1AEFBDEE}" destId="{A3A63788-1227-B240-AFF4-87DA3887717D}" srcOrd="0" destOrd="0" presId="urn:microsoft.com/office/officeart/2005/8/layout/vList5"/>
    <dgm:cxn modelId="{C69877D5-79C1-9F4C-B7F4-8AD7D15754EE}" type="presParOf" srcId="{B97FC210-8EA1-614A-91AB-916C1AEFBDEE}" destId="{5432570E-A980-7C49-B78B-FBD7E95247D6}" srcOrd="1" destOrd="0" presId="urn:microsoft.com/office/officeart/2005/8/layout/vList5"/>
    <dgm:cxn modelId="{33ACEA31-C6CD-5547-BED3-2458723FCA4A}" type="presParOf" srcId="{C651D352-06FA-1B42-81FF-A95099FE5645}" destId="{3E055F9F-21A2-424C-8A4E-65EE89C8A916}" srcOrd="5" destOrd="0" presId="urn:microsoft.com/office/officeart/2005/8/layout/vList5"/>
    <dgm:cxn modelId="{A37DA9BE-A47E-BB4D-9CC1-632CE186629D}" type="presParOf" srcId="{C651D352-06FA-1B42-81FF-A95099FE5645}" destId="{3D7F3715-4665-FB42-B9D8-1FF06FE7ED04}" srcOrd="6" destOrd="0" presId="urn:microsoft.com/office/officeart/2005/8/layout/vList5"/>
    <dgm:cxn modelId="{C891109C-0686-B74F-8141-60300585C701}" type="presParOf" srcId="{3D7F3715-4665-FB42-B9D8-1FF06FE7ED04}" destId="{F459C834-8503-9C47-9E88-19B5B264D39A}" srcOrd="0" destOrd="0" presId="urn:microsoft.com/office/officeart/2005/8/layout/vList5"/>
    <dgm:cxn modelId="{2F31821D-0811-794B-B121-3DE9146709AD}" type="presParOf" srcId="{3D7F3715-4665-FB42-B9D8-1FF06FE7ED04}" destId="{B11406A9-5BCB-7247-9C38-2B1D2505F2B8}" srcOrd="1" destOrd="0" presId="urn:microsoft.com/office/officeart/2005/8/layout/vList5"/>
    <dgm:cxn modelId="{0F8FFFCC-28B5-A844-A0C0-4277188A3AC8}" type="presParOf" srcId="{C651D352-06FA-1B42-81FF-A95099FE5645}" destId="{E355AC6F-4099-CB47-B889-4B740E437363}" srcOrd="7" destOrd="0" presId="urn:microsoft.com/office/officeart/2005/8/layout/vList5"/>
    <dgm:cxn modelId="{53EF242F-1951-6046-AB59-C18248626329}" type="presParOf" srcId="{C651D352-06FA-1B42-81FF-A95099FE5645}" destId="{A60CA7D8-39CB-954A-95BD-9B247DA4C063}" srcOrd="8" destOrd="0" presId="urn:microsoft.com/office/officeart/2005/8/layout/vList5"/>
    <dgm:cxn modelId="{ED3BF37E-4F96-D544-B638-C0AB83F1A9B4}" type="presParOf" srcId="{A60CA7D8-39CB-954A-95BD-9B247DA4C063}" destId="{4D3677DD-203E-6A46-986E-4A5C658C9303}" srcOrd="0" destOrd="0" presId="urn:microsoft.com/office/officeart/2005/8/layout/vList5"/>
    <dgm:cxn modelId="{5F05AF10-2999-E74B-852A-D64954D94FF8}" type="presParOf" srcId="{A60CA7D8-39CB-954A-95BD-9B247DA4C063}" destId="{DF481026-182D-AB4B-A938-B9E12915351D}" srcOrd="1" destOrd="0" presId="urn:microsoft.com/office/officeart/2005/8/layout/vList5"/>
    <dgm:cxn modelId="{ACD94F81-0016-934D-9BD5-68D8F780E3B7}" type="presParOf" srcId="{C651D352-06FA-1B42-81FF-A95099FE5645}" destId="{0E9316E9-2C30-AB47-AE90-7E8E046E1AFD}" srcOrd="9" destOrd="0" presId="urn:microsoft.com/office/officeart/2005/8/layout/vList5"/>
    <dgm:cxn modelId="{F8E487A0-A252-584F-8A38-3822D4AF8219}" type="presParOf" srcId="{C651D352-06FA-1B42-81FF-A95099FE5645}" destId="{037794A2-D322-8E40-B011-CE07ECE52AD6}" srcOrd="10" destOrd="0" presId="urn:microsoft.com/office/officeart/2005/8/layout/vList5"/>
    <dgm:cxn modelId="{67548826-ED42-6242-AA6A-DBBB72691D13}" type="presParOf" srcId="{037794A2-D322-8E40-B011-CE07ECE52AD6}" destId="{B6C279C8-1B63-3845-ADAB-B82AEFA3D8E4}" srcOrd="0" destOrd="0" presId="urn:microsoft.com/office/officeart/2005/8/layout/vList5"/>
    <dgm:cxn modelId="{B87CE2C3-5909-4C4E-A75A-B68815D3150A}" type="presParOf" srcId="{037794A2-D322-8E40-B011-CE07ECE52AD6}" destId="{95DA0D8B-BC89-0948-909A-C298332DBD75}" srcOrd="1" destOrd="0" presId="urn:microsoft.com/office/officeart/2005/8/layout/vList5"/>
    <dgm:cxn modelId="{B702A7F2-2B11-8D48-B9AE-A25D0DE633A1}" type="presParOf" srcId="{C651D352-06FA-1B42-81FF-A95099FE5645}" destId="{05C8E7F6-EE84-404A-A830-A5238A04D5A3}" srcOrd="11" destOrd="0" presId="urn:microsoft.com/office/officeart/2005/8/layout/vList5"/>
    <dgm:cxn modelId="{5D36C750-8050-AB49-B923-84B64CB9D59C}" type="presParOf" srcId="{C651D352-06FA-1B42-81FF-A95099FE5645}" destId="{450D1F74-F684-8F4C-A8B3-6F8B553AB682}" srcOrd="12" destOrd="0" presId="urn:microsoft.com/office/officeart/2005/8/layout/vList5"/>
    <dgm:cxn modelId="{69DDD68C-0D88-6141-B93A-2DFC27495FCF}" type="presParOf" srcId="{450D1F74-F684-8F4C-A8B3-6F8B553AB682}" destId="{B67BA8B7-08DC-C244-8300-FCD547033DBD}" srcOrd="0" destOrd="0" presId="urn:microsoft.com/office/officeart/2005/8/layout/vList5"/>
    <dgm:cxn modelId="{772109BC-D0C5-5C47-B68B-C1F238D6D77F}" type="presParOf" srcId="{450D1F74-F684-8F4C-A8B3-6F8B553AB682}" destId="{9D2B4FF6-13FB-EF49-977A-31DF5EE58099}" srcOrd="1" destOrd="0" presId="urn:microsoft.com/office/officeart/2005/8/layout/vList5"/>
    <dgm:cxn modelId="{5EBAD0AC-A244-A44E-ADFB-53F20C58044C}" type="presParOf" srcId="{C651D352-06FA-1B42-81FF-A95099FE5645}" destId="{580F7313-AC0F-FA49-A45E-0C9486F52D6E}" srcOrd="13" destOrd="0" presId="urn:microsoft.com/office/officeart/2005/8/layout/vList5"/>
    <dgm:cxn modelId="{6E9922E5-478F-AF4D-9DCA-7A72508F4F6D}" type="presParOf" srcId="{C651D352-06FA-1B42-81FF-A95099FE5645}" destId="{E737A561-EB87-EC46-B404-0D8CDB0DE287}" srcOrd="14" destOrd="0" presId="urn:microsoft.com/office/officeart/2005/8/layout/vList5"/>
    <dgm:cxn modelId="{8E470ECC-4731-EF49-B2A8-AD4470B8AD53}" type="presParOf" srcId="{E737A561-EB87-EC46-B404-0D8CDB0DE287}" destId="{D5D04DA4-D0C2-DE47-8C8C-0B8EFFA304FE}" srcOrd="0" destOrd="0" presId="urn:microsoft.com/office/officeart/2005/8/layout/vList5"/>
    <dgm:cxn modelId="{B9608D4F-B546-F142-90CB-D6437FE05ACF}" type="presParOf" srcId="{E737A561-EB87-EC46-B404-0D8CDB0DE287}" destId="{8CF3EAF4-8574-9841-9B3E-4FBF8CB57172}"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2.xml><?xml version="1.0" encoding="utf-8"?>
<dgm:dataModel xmlns:dgm="http://schemas.openxmlformats.org/drawingml/2006/diagram" xmlns:a="http://schemas.openxmlformats.org/drawingml/2006/main">
  <dgm:ptLst>
    <dgm:pt modelId="{CE7EC2B3-709C-7049-AC98-40D647A08CD5}" type="doc">
      <dgm:prSet loTypeId="urn:microsoft.com/office/officeart/2005/8/layout/vList5" loCatId="" qsTypeId="urn:microsoft.com/office/officeart/2005/8/quickstyle/simple1" qsCatId="simple" csTypeId="urn:microsoft.com/office/officeart/2005/8/colors/accent1_2" csCatId="accent1" phldr="1"/>
      <dgm:spPr/>
      <dgm:t>
        <a:bodyPr/>
        <a:lstStyle/>
        <a:p>
          <a:endParaRPr lang="en-US"/>
        </a:p>
      </dgm:t>
    </dgm:pt>
    <dgm:pt modelId="{54EB0C78-47D0-4144-BBA1-ED83F2276A80}">
      <dgm:prSet phldrT="[Text]"/>
      <dgm:spPr/>
      <dgm:t>
        <a:bodyPr/>
        <a:lstStyle/>
        <a:p>
          <a:r>
            <a:rPr lang="en-US" dirty="0"/>
            <a:t>1</a:t>
          </a:r>
        </a:p>
      </dgm:t>
    </dgm:pt>
    <dgm:pt modelId="{46A28A5B-8A7C-BF49-A5DC-996D874F74B0}" type="parTrans" cxnId="{54AEA8B7-F89B-724F-98A1-0AEC5D7FC3A2}">
      <dgm:prSet/>
      <dgm:spPr/>
      <dgm:t>
        <a:bodyPr/>
        <a:lstStyle/>
        <a:p>
          <a:endParaRPr lang="en-US"/>
        </a:p>
      </dgm:t>
    </dgm:pt>
    <dgm:pt modelId="{E8376F97-8FAC-AA43-868D-BB3E335B92F2}" type="sibTrans" cxnId="{54AEA8B7-F89B-724F-98A1-0AEC5D7FC3A2}">
      <dgm:prSet/>
      <dgm:spPr/>
      <dgm:t>
        <a:bodyPr/>
        <a:lstStyle/>
        <a:p>
          <a:endParaRPr lang="en-US"/>
        </a:p>
      </dgm:t>
    </dgm:pt>
    <dgm:pt modelId="{D57A6E2B-1DF9-5046-BC1D-709A01F64D7F}">
      <dgm:prSet phldrT="[Text]"/>
      <dgm:spPr/>
      <dgm:t>
        <a:bodyPr/>
        <a:lstStyle/>
        <a:p>
          <a:r>
            <a:rPr lang="en-US"/>
            <a:t>Patient stability</a:t>
          </a:r>
          <a:endParaRPr lang="en-US" dirty="0"/>
        </a:p>
      </dgm:t>
    </dgm:pt>
    <dgm:pt modelId="{C76AEE8B-D94A-7D44-B03A-3FE0785274DD}" type="parTrans" cxnId="{B2C59790-5949-8740-B37D-5567793C306C}">
      <dgm:prSet/>
      <dgm:spPr/>
      <dgm:t>
        <a:bodyPr/>
        <a:lstStyle/>
        <a:p>
          <a:endParaRPr lang="en-US"/>
        </a:p>
      </dgm:t>
    </dgm:pt>
    <dgm:pt modelId="{55132C62-F393-2540-A3F5-1E79E69F36CF}" type="sibTrans" cxnId="{B2C59790-5949-8740-B37D-5567793C306C}">
      <dgm:prSet/>
      <dgm:spPr/>
      <dgm:t>
        <a:bodyPr/>
        <a:lstStyle/>
        <a:p>
          <a:endParaRPr lang="en-US"/>
        </a:p>
      </dgm:t>
    </dgm:pt>
    <dgm:pt modelId="{D03F059F-5021-1F40-A19F-9647158C52AD}">
      <dgm:prSet phldrT="[Text]"/>
      <dgm:spPr/>
      <dgm:t>
        <a:bodyPr/>
        <a:lstStyle/>
        <a:p>
          <a:r>
            <a:rPr lang="en-US" dirty="0"/>
            <a:t>2</a:t>
          </a:r>
        </a:p>
      </dgm:t>
    </dgm:pt>
    <dgm:pt modelId="{CF000D09-B476-0444-AE02-AACE5A32ABB9}" type="parTrans" cxnId="{65CEA44F-9E16-EA4E-A309-EC3B3016297A}">
      <dgm:prSet/>
      <dgm:spPr/>
      <dgm:t>
        <a:bodyPr/>
        <a:lstStyle/>
        <a:p>
          <a:endParaRPr lang="en-US"/>
        </a:p>
      </dgm:t>
    </dgm:pt>
    <dgm:pt modelId="{294C2440-29C3-A948-ADDD-2D4D34880BDD}" type="sibTrans" cxnId="{65CEA44F-9E16-EA4E-A309-EC3B3016297A}">
      <dgm:prSet/>
      <dgm:spPr/>
      <dgm:t>
        <a:bodyPr/>
        <a:lstStyle/>
        <a:p>
          <a:endParaRPr lang="en-US"/>
        </a:p>
      </dgm:t>
    </dgm:pt>
    <dgm:pt modelId="{8E966A69-49F1-5E4B-B606-FCAEDAA984ED}">
      <dgm:prSet phldrT="[Text]"/>
      <dgm:spPr/>
      <dgm:t>
        <a:bodyPr/>
        <a:lstStyle/>
        <a:p>
          <a:r>
            <a:rPr lang="en-US" dirty="0"/>
            <a:t>Emotional check</a:t>
          </a:r>
        </a:p>
      </dgm:t>
    </dgm:pt>
    <dgm:pt modelId="{DBAD8E5C-BD8A-8D4C-B4F0-8493200D7696}" type="parTrans" cxnId="{FBB45EE4-904A-AF48-A0C9-CB655E66EF52}">
      <dgm:prSet/>
      <dgm:spPr/>
      <dgm:t>
        <a:bodyPr/>
        <a:lstStyle/>
        <a:p>
          <a:endParaRPr lang="en-US"/>
        </a:p>
      </dgm:t>
    </dgm:pt>
    <dgm:pt modelId="{6E022D76-54D3-5040-BFB1-6E3CF648085C}" type="sibTrans" cxnId="{FBB45EE4-904A-AF48-A0C9-CB655E66EF52}">
      <dgm:prSet/>
      <dgm:spPr/>
      <dgm:t>
        <a:bodyPr/>
        <a:lstStyle/>
        <a:p>
          <a:endParaRPr lang="en-US"/>
        </a:p>
      </dgm:t>
    </dgm:pt>
    <dgm:pt modelId="{73A345CE-36FD-894D-BBC6-F1148569A643}">
      <dgm:prSet phldrT="[Text]"/>
      <dgm:spPr/>
      <dgm:t>
        <a:bodyPr/>
        <a:lstStyle/>
        <a:p>
          <a:r>
            <a:rPr lang="en-US" dirty="0"/>
            <a:t>3</a:t>
          </a:r>
        </a:p>
      </dgm:t>
    </dgm:pt>
    <dgm:pt modelId="{E3B27BD6-FBE2-5640-8D4A-26A5222CC3EA}" type="parTrans" cxnId="{408ED183-BF58-1C4B-97FD-732582625FEF}">
      <dgm:prSet/>
      <dgm:spPr/>
      <dgm:t>
        <a:bodyPr/>
        <a:lstStyle/>
        <a:p>
          <a:endParaRPr lang="en-US"/>
        </a:p>
      </dgm:t>
    </dgm:pt>
    <dgm:pt modelId="{7A99C83F-BC00-3743-81E8-552BD253CEC3}" type="sibTrans" cxnId="{408ED183-BF58-1C4B-97FD-732582625FEF}">
      <dgm:prSet/>
      <dgm:spPr/>
      <dgm:t>
        <a:bodyPr/>
        <a:lstStyle/>
        <a:p>
          <a:endParaRPr lang="en-US"/>
        </a:p>
      </dgm:t>
    </dgm:pt>
    <dgm:pt modelId="{E900B89A-C42B-5249-B68C-A3D7ECDC2722}">
      <dgm:prSet phldrT="[Text]"/>
      <dgm:spPr/>
      <dgm:t>
        <a:bodyPr/>
        <a:lstStyle/>
        <a:p>
          <a:r>
            <a:rPr lang="en-US" dirty="0"/>
            <a:t>Address bias</a:t>
          </a:r>
        </a:p>
      </dgm:t>
    </dgm:pt>
    <dgm:pt modelId="{8E839505-C7B5-E846-B572-409C6E14F87D}" type="parTrans" cxnId="{8EA459AB-225B-8C4D-9825-5D1C6BF10277}">
      <dgm:prSet/>
      <dgm:spPr/>
      <dgm:t>
        <a:bodyPr/>
        <a:lstStyle/>
        <a:p>
          <a:endParaRPr lang="en-US"/>
        </a:p>
      </dgm:t>
    </dgm:pt>
    <dgm:pt modelId="{1CCB8A03-5593-CE44-86BA-AACEAE0CCB98}" type="sibTrans" cxnId="{8EA459AB-225B-8C4D-9825-5D1C6BF10277}">
      <dgm:prSet/>
      <dgm:spPr/>
      <dgm:t>
        <a:bodyPr/>
        <a:lstStyle/>
        <a:p>
          <a:endParaRPr lang="en-US"/>
        </a:p>
      </dgm:t>
    </dgm:pt>
    <dgm:pt modelId="{418E94F4-4F87-154C-8C2C-4FA1854F2962}">
      <dgm:prSet/>
      <dgm:spPr/>
      <dgm:t>
        <a:bodyPr/>
        <a:lstStyle/>
        <a:p>
          <a:r>
            <a:rPr lang="en-US" dirty="0"/>
            <a:t>4</a:t>
          </a:r>
        </a:p>
      </dgm:t>
    </dgm:pt>
    <dgm:pt modelId="{67B29BF1-08A2-E04F-9D69-0598739CF13B}" type="parTrans" cxnId="{2BBF3C50-1ED6-9847-B76B-936F9EDE5606}">
      <dgm:prSet/>
      <dgm:spPr/>
      <dgm:t>
        <a:bodyPr/>
        <a:lstStyle/>
        <a:p>
          <a:endParaRPr lang="en-US"/>
        </a:p>
      </dgm:t>
    </dgm:pt>
    <dgm:pt modelId="{A5C1BCA8-59E6-2D47-BF9C-24A0A56844F7}" type="sibTrans" cxnId="{2BBF3C50-1ED6-9847-B76B-936F9EDE5606}">
      <dgm:prSet/>
      <dgm:spPr/>
      <dgm:t>
        <a:bodyPr/>
        <a:lstStyle/>
        <a:p>
          <a:endParaRPr lang="en-US"/>
        </a:p>
      </dgm:t>
    </dgm:pt>
    <dgm:pt modelId="{827957E1-E296-1C4F-A5F6-1C5FE324A00C}">
      <dgm:prSet/>
      <dgm:spPr/>
      <dgm:t>
        <a:bodyPr/>
        <a:lstStyle/>
        <a:p>
          <a:r>
            <a:rPr lang="en-US" dirty="0"/>
            <a:t>5</a:t>
          </a:r>
        </a:p>
      </dgm:t>
    </dgm:pt>
    <dgm:pt modelId="{AC89EDA2-97A0-704F-A224-66777968DC79}" type="parTrans" cxnId="{C5A31E1B-1939-A943-9EA9-0D1F931C9095}">
      <dgm:prSet/>
      <dgm:spPr/>
      <dgm:t>
        <a:bodyPr/>
        <a:lstStyle/>
        <a:p>
          <a:endParaRPr lang="en-US"/>
        </a:p>
      </dgm:t>
    </dgm:pt>
    <dgm:pt modelId="{9F52F0F0-B16C-AB44-86AF-35AA79D5B0BB}" type="sibTrans" cxnId="{C5A31E1B-1939-A943-9EA9-0D1F931C9095}">
      <dgm:prSet/>
      <dgm:spPr/>
      <dgm:t>
        <a:bodyPr/>
        <a:lstStyle/>
        <a:p>
          <a:endParaRPr lang="en-US"/>
        </a:p>
      </dgm:t>
    </dgm:pt>
    <dgm:pt modelId="{9F6E5C8F-12F1-3545-94A6-291C5042E69E}">
      <dgm:prSet/>
      <dgm:spPr/>
      <dgm:t>
        <a:bodyPr/>
        <a:lstStyle/>
        <a:p>
          <a:r>
            <a:rPr lang="en-US" dirty="0"/>
            <a:t>6</a:t>
          </a:r>
        </a:p>
      </dgm:t>
    </dgm:pt>
    <dgm:pt modelId="{F878F1E0-BA83-0B4F-8407-D69A3E0606E8}" type="parTrans" cxnId="{545F95DE-9A10-3948-9807-36C195D34A35}">
      <dgm:prSet/>
      <dgm:spPr/>
      <dgm:t>
        <a:bodyPr/>
        <a:lstStyle/>
        <a:p>
          <a:endParaRPr lang="en-US"/>
        </a:p>
      </dgm:t>
    </dgm:pt>
    <dgm:pt modelId="{F501E3C1-886B-5244-A7B1-7A80D72A4D8C}" type="sibTrans" cxnId="{545F95DE-9A10-3948-9807-36C195D34A35}">
      <dgm:prSet/>
      <dgm:spPr/>
      <dgm:t>
        <a:bodyPr/>
        <a:lstStyle/>
        <a:p>
          <a:endParaRPr lang="en-US"/>
        </a:p>
      </dgm:t>
    </dgm:pt>
    <dgm:pt modelId="{02BDF100-8338-E043-96F5-EE898B9D5AB2}">
      <dgm:prSet/>
      <dgm:spPr/>
      <dgm:t>
        <a:bodyPr/>
        <a:lstStyle/>
        <a:p>
          <a:r>
            <a:rPr lang="en-US" dirty="0"/>
            <a:t>7</a:t>
          </a:r>
        </a:p>
      </dgm:t>
    </dgm:pt>
    <dgm:pt modelId="{1B53CCA0-CFF2-384B-856E-1EBDFA4D02AD}" type="parTrans" cxnId="{F6183E77-6BBF-FA47-854D-F0D53AE21A8A}">
      <dgm:prSet/>
      <dgm:spPr/>
      <dgm:t>
        <a:bodyPr/>
        <a:lstStyle/>
        <a:p>
          <a:endParaRPr lang="en-US"/>
        </a:p>
      </dgm:t>
    </dgm:pt>
    <dgm:pt modelId="{BCE247F3-63ED-824C-BC43-9D645F88694B}" type="sibTrans" cxnId="{F6183E77-6BBF-FA47-854D-F0D53AE21A8A}">
      <dgm:prSet/>
      <dgm:spPr/>
      <dgm:t>
        <a:bodyPr/>
        <a:lstStyle/>
        <a:p>
          <a:endParaRPr lang="en-US"/>
        </a:p>
      </dgm:t>
    </dgm:pt>
    <dgm:pt modelId="{7CF6944D-D814-F446-BDE2-B55C1C344687}">
      <dgm:prSet/>
      <dgm:spPr/>
      <dgm:t>
        <a:bodyPr/>
        <a:lstStyle/>
        <a:p>
          <a:r>
            <a:rPr lang="en-US" dirty="0"/>
            <a:t>8</a:t>
          </a:r>
        </a:p>
      </dgm:t>
    </dgm:pt>
    <dgm:pt modelId="{18766106-4E88-954F-80B4-8435CD7E3607}" type="parTrans" cxnId="{B4BAA057-82A7-8F4F-B3AE-D2474B9F0D61}">
      <dgm:prSet/>
      <dgm:spPr/>
      <dgm:t>
        <a:bodyPr/>
        <a:lstStyle/>
        <a:p>
          <a:endParaRPr lang="en-US"/>
        </a:p>
      </dgm:t>
    </dgm:pt>
    <dgm:pt modelId="{41CA9CD1-BD05-D240-8585-F6D044F469D5}" type="sibTrans" cxnId="{B4BAA057-82A7-8F4F-B3AE-D2474B9F0D61}">
      <dgm:prSet/>
      <dgm:spPr/>
      <dgm:t>
        <a:bodyPr/>
        <a:lstStyle/>
        <a:p>
          <a:endParaRPr lang="en-US"/>
        </a:p>
      </dgm:t>
    </dgm:pt>
    <dgm:pt modelId="{77E26394-E137-5E44-9434-AC75CD3E8E1C}">
      <dgm:prSet/>
      <dgm:spPr/>
      <dgm:t>
        <a:bodyPr/>
        <a:lstStyle/>
        <a:p>
          <a:r>
            <a:rPr lang="en-US" dirty="0"/>
            <a:t>Align with team</a:t>
          </a:r>
        </a:p>
      </dgm:t>
    </dgm:pt>
    <dgm:pt modelId="{0106416C-C608-3E4B-95A9-3A27F212EF0D}" type="parTrans" cxnId="{3055A850-65BD-2C48-A538-0AAEB9138E85}">
      <dgm:prSet/>
      <dgm:spPr/>
      <dgm:t>
        <a:bodyPr/>
        <a:lstStyle/>
        <a:p>
          <a:endParaRPr lang="en-US"/>
        </a:p>
      </dgm:t>
    </dgm:pt>
    <dgm:pt modelId="{4162CFAB-B676-8E4E-8FEB-32BD16B62DEC}" type="sibTrans" cxnId="{3055A850-65BD-2C48-A538-0AAEB9138E85}">
      <dgm:prSet/>
      <dgm:spPr/>
      <dgm:t>
        <a:bodyPr/>
        <a:lstStyle/>
        <a:p>
          <a:endParaRPr lang="en-US"/>
        </a:p>
      </dgm:t>
    </dgm:pt>
    <dgm:pt modelId="{D6BB4A41-00B2-5448-BB3F-80605AC75A4E}">
      <dgm:prSet/>
      <dgm:spPr/>
      <dgm:t>
        <a:bodyPr/>
        <a:lstStyle/>
        <a:p>
          <a:r>
            <a:rPr lang="en-US" dirty="0"/>
            <a:t>Recenter on care</a:t>
          </a:r>
        </a:p>
      </dgm:t>
    </dgm:pt>
    <dgm:pt modelId="{4E04882C-8060-1D42-8502-5D210AA0DCD3}" type="parTrans" cxnId="{DF1A41C0-D8B8-6D4F-A8A5-91EC68AFBCAD}">
      <dgm:prSet/>
      <dgm:spPr/>
      <dgm:t>
        <a:bodyPr/>
        <a:lstStyle/>
        <a:p>
          <a:endParaRPr lang="en-US"/>
        </a:p>
      </dgm:t>
    </dgm:pt>
    <dgm:pt modelId="{A3F6C628-648D-0249-B65F-551AF9ECEEA6}" type="sibTrans" cxnId="{DF1A41C0-D8B8-6D4F-A8A5-91EC68AFBCAD}">
      <dgm:prSet/>
      <dgm:spPr/>
      <dgm:t>
        <a:bodyPr/>
        <a:lstStyle/>
        <a:p>
          <a:endParaRPr lang="en-US"/>
        </a:p>
      </dgm:t>
    </dgm:pt>
    <dgm:pt modelId="{0545D5E0-C6B3-A447-B001-E955BFE39730}">
      <dgm:prSet/>
      <dgm:spPr/>
      <dgm:t>
        <a:bodyPr/>
        <a:lstStyle/>
        <a:p>
          <a:r>
            <a:rPr lang="en-US" dirty="0"/>
            <a:t>Give space</a:t>
          </a:r>
        </a:p>
      </dgm:t>
    </dgm:pt>
    <dgm:pt modelId="{74548467-254B-2943-9A99-08C07F3E448D}" type="parTrans" cxnId="{E2BB9BC9-6DB1-9443-8E35-6250A99E4AD7}">
      <dgm:prSet/>
      <dgm:spPr/>
      <dgm:t>
        <a:bodyPr/>
        <a:lstStyle/>
        <a:p>
          <a:endParaRPr lang="en-US"/>
        </a:p>
      </dgm:t>
    </dgm:pt>
    <dgm:pt modelId="{43A03E68-4CAE-A344-B58C-38B13B6EE776}" type="sibTrans" cxnId="{E2BB9BC9-6DB1-9443-8E35-6250A99E4AD7}">
      <dgm:prSet/>
      <dgm:spPr/>
      <dgm:t>
        <a:bodyPr/>
        <a:lstStyle/>
        <a:p>
          <a:endParaRPr lang="en-US"/>
        </a:p>
      </dgm:t>
    </dgm:pt>
    <dgm:pt modelId="{4042EA18-93B7-8447-AC0A-58BAED6135AA}">
      <dgm:prSet/>
      <dgm:spPr/>
      <dgm:t>
        <a:bodyPr/>
        <a:lstStyle/>
        <a:p>
          <a:r>
            <a:rPr lang="en-US" dirty="0"/>
            <a:t>Seek support</a:t>
          </a:r>
        </a:p>
      </dgm:t>
    </dgm:pt>
    <dgm:pt modelId="{2F5CB061-56DE-EB4D-BFD4-36B00E6055CB}" type="parTrans" cxnId="{BBBA16DC-BC73-8048-A725-FE1EF1BF6593}">
      <dgm:prSet/>
      <dgm:spPr/>
      <dgm:t>
        <a:bodyPr/>
        <a:lstStyle/>
        <a:p>
          <a:endParaRPr lang="en-US"/>
        </a:p>
      </dgm:t>
    </dgm:pt>
    <dgm:pt modelId="{A608511D-1BB9-EB4E-9E74-CCD7B0DB861D}" type="sibTrans" cxnId="{BBBA16DC-BC73-8048-A725-FE1EF1BF6593}">
      <dgm:prSet/>
      <dgm:spPr/>
      <dgm:t>
        <a:bodyPr/>
        <a:lstStyle/>
        <a:p>
          <a:endParaRPr lang="en-US"/>
        </a:p>
      </dgm:t>
    </dgm:pt>
    <dgm:pt modelId="{B3ABDBBC-28C2-CC44-9EA0-940A074F9BF0}">
      <dgm:prSet/>
      <dgm:spPr/>
      <dgm:t>
        <a:bodyPr/>
        <a:lstStyle/>
        <a:p>
          <a:r>
            <a:rPr lang="en-US" dirty="0"/>
            <a:t>Set boundaries</a:t>
          </a:r>
        </a:p>
      </dgm:t>
    </dgm:pt>
    <dgm:pt modelId="{B1A1C092-087B-F241-9B26-AD1D13C72D4D}" type="sibTrans" cxnId="{D85391B8-F585-FD43-82E0-8ACB9B810BF4}">
      <dgm:prSet/>
      <dgm:spPr/>
      <dgm:t>
        <a:bodyPr/>
        <a:lstStyle/>
        <a:p>
          <a:endParaRPr lang="en-US"/>
        </a:p>
      </dgm:t>
    </dgm:pt>
    <dgm:pt modelId="{D1297B60-D255-DA44-8D75-399213932CFB}" type="parTrans" cxnId="{D85391B8-F585-FD43-82E0-8ACB9B810BF4}">
      <dgm:prSet/>
      <dgm:spPr/>
      <dgm:t>
        <a:bodyPr/>
        <a:lstStyle/>
        <a:p>
          <a:endParaRPr lang="en-US"/>
        </a:p>
      </dgm:t>
    </dgm:pt>
    <dgm:pt modelId="{C651D352-06FA-1B42-81FF-A95099FE5645}" type="pres">
      <dgm:prSet presAssocID="{CE7EC2B3-709C-7049-AC98-40D647A08CD5}" presName="Name0" presStyleCnt="0">
        <dgm:presLayoutVars>
          <dgm:dir/>
          <dgm:animLvl val="lvl"/>
          <dgm:resizeHandles val="exact"/>
        </dgm:presLayoutVars>
      </dgm:prSet>
      <dgm:spPr/>
    </dgm:pt>
    <dgm:pt modelId="{2E2FEDEA-0CB5-FD4B-8718-95B9D6A14304}" type="pres">
      <dgm:prSet presAssocID="{54EB0C78-47D0-4144-BBA1-ED83F2276A80}" presName="linNode" presStyleCnt="0"/>
      <dgm:spPr/>
    </dgm:pt>
    <dgm:pt modelId="{2F0271A3-745A-A943-B67B-E4069A93AE61}" type="pres">
      <dgm:prSet presAssocID="{54EB0C78-47D0-4144-BBA1-ED83F2276A80}" presName="parentText" presStyleLbl="node1" presStyleIdx="0" presStyleCnt="8" custScaleX="67001">
        <dgm:presLayoutVars>
          <dgm:chMax val="1"/>
          <dgm:bulletEnabled val="1"/>
        </dgm:presLayoutVars>
      </dgm:prSet>
      <dgm:spPr/>
    </dgm:pt>
    <dgm:pt modelId="{21D64796-42C1-6A47-B16B-F23C35A117FF}" type="pres">
      <dgm:prSet presAssocID="{54EB0C78-47D0-4144-BBA1-ED83F2276A80}" presName="descendantText" presStyleLbl="alignAccFollowNode1" presStyleIdx="0" presStyleCnt="8">
        <dgm:presLayoutVars>
          <dgm:bulletEnabled val="1"/>
        </dgm:presLayoutVars>
      </dgm:prSet>
      <dgm:spPr/>
    </dgm:pt>
    <dgm:pt modelId="{B2C4C361-6A0B-BC45-90FD-318B0EB08F6D}" type="pres">
      <dgm:prSet presAssocID="{E8376F97-8FAC-AA43-868D-BB3E335B92F2}" presName="sp" presStyleCnt="0"/>
      <dgm:spPr/>
    </dgm:pt>
    <dgm:pt modelId="{277D1FDC-6CD3-BB41-8E20-960C658417CF}" type="pres">
      <dgm:prSet presAssocID="{D03F059F-5021-1F40-A19F-9647158C52AD}" presName="linNode" presStyleCnt="0"/>
      <dgm:spPr/>
    </dgm:pt>
    <dgm:pt modelId="{6CEBA26E-9501-3E41-ACBB-39C96B19A924}" type="pres">
      <dgm:prSet presAssocID="{D03F059F-5021-1F40-A19F-9647158C52AD}" presName="parentText" presStyleLbl="node1" presStyleIdx="1" presStyleCnt="8" custScaleX="67001">
        <dgm:presLayoutVars>
          <dgm:chMax val="1"/>
          <dgm:bulletEnabled val="1"/>
        </dgm:presLayoutVars>
      </dgm:prSet>
      <dgm:spPr/>
    </dgm:pt>
    <dgm:pt modelId="{2EB4DD27-0645-2048-89E9-55CE50FE52DA}" type="pres">
      <dgm:prSet presAssocID="{D03F059F-5021-1F40-A19F-9647158C52AD}" presName="descendantText" presStyleLbl="alignAccFollowNode1" presStyleIdx="1" presStyleCnt="8">
        <dgm:presLayoutVars>
          <dgm:bulletEnabled val="1"/>
        </dgm:presLayoutVars>
      </dgm:prSet>
      <dgm:spPr/>
    </dgm:pt>
    <dgm:pt modelId="{33CCAA17-6648-4F4C-9AC2-5ECE7EDB6E70}" type="pres">
      <dgm:prSet presAssocID="{294C2440-29C3-A948-ADDD-2D4D34880BDD}" presName="sp" presStyleCnt="0"/>
      <dgm:spPr/>
    </dgm:pt>
    <dgm:pt modelId="{B97FC210-8EA1-614A-91AB-916C1AEFBDEE}" type="pres">
      <dgm:prSet presAssocID="{73A345CE-36FD-894D-BBC6-F1148569A643}" presName="linNode" presStyleCnt="0"/>
      <dgm:spPr/>
    </dgm:pt>
    <dgm:pt modelId="{A3A63788-1227-B240-AFF4-87DA3887717D}" type="pres">
      <dgm:prSet presAssocID="{73A345CE-36FD-894D-BBC6-F1148569A643}" presName="parentText" presStyleLbl="node1" presStyleIdx="2" presStyleCnt="8" custScaleX="67001">
        <dgm:presLayoutVars>
          <dgm:chMax val="1"/>
          <dgm:bulletEnabled val="1"/>
        </dgm:presLayoutVars>
      </dgm:prSet>
      <dgm:spPr/>
    </dgm:pt>
    <dgm:pt modelId="{5432570E-A980-7C49-B78B-FBD7E95247D6}" type="pres">
      <dgm:prSet presAssocID="{73A345CE-36FD-894D-BBC6-F1148569A643}" presName="descendantText" presStyleLbl="alignAccFollowNode1" presStyleIdx="2" presStyleCnt="8">
        <dgm:presLayoutVars>
          <dgm:bulletEnabled val="1"/>
        </dgm:presLayoutVars>
      </dgm:prSet>
      <dgm:spPr/>
    </dgm:pt>
    <dgm:pt modelId="{3E055F9F-21A2-424C-8A4E-65EE89C8A916}" type="pres">
      <dgm:prSet presAssocID="{7A99C83F-BC00-3743-81E8-552BD253CEC3}" presName="sp" presStyleCnt="0"/>
      <dgm:spPr/>
    </dgm:pt>
    <dgm:pt modelId="{3D7F3715-4665-FB42-B9D8-1FF06FE7ED04}" type="pres">
      <dgm:prSet presAssocID="{418E94F4-4F87-154C-8C2C-4FA1854F2962}" presName="linNode" presStyleCnt="0"/>
      <dgm:spPr/>
    </dgm:pt>
    <dgm:pt modelId="{F459C834-8503-9C47-9E88-19B5B264D39A}" type="pres">
      <dgm:prSet presAssocID="{418E94F4-4F87-154C-8C2C-4FA1854F2962}" presName="parentText" presStyleLbl="node1" presStyleIdx="3" presStyleCnt="8" custScaleX="67001">
        <dgm:presLayoutVars>
          <dgm:chMax val="1"/>
          <dgm:bulletEnabled val="1"/>
        </dgm:presLayoutVars>
      </dgm:prSet>
      <dgm:spPr/>
    </dgm:pt>
    <dgm:pt modelId="{B11406A9-5BCB-7247-9C38-2B1D2505F2B8}" type="pres">
      <dgm:prSet presAssocID="{418E94F4-4F87-154C-8C2C-4FA1854F2962}" presName="descendantText" presStyleLbl="alignAccFollowNode1" presStyleIdx="3" presStyleCnt="8">
        <dgm:presLayoutVars>
          <dgm:bulletEnabled val="1"/>
        </dgm:presLayoutVars>
      </dgm:prSet>
      <dgm:spPr/>
    </dgm:pt>
    <dgm:pt modelId="{E355AC6F-4099-CB47-B889-4B740E437363}" type="pres">
      <dgm:prSet presAssocID="{A5C1BCA8-59E6-2D47-BF9C-24A0A56844F7}" presName="sp" presStyleCnt="0"/>
      <dgm:spPr/>
    </dgm:pt>
    <dgm:pt modelId="{A60CA7D8-39CB-954A-95BD-9B247DA4C063}" type="pres">
      <dgm:prSet presAssocID="{827957E1-E296-1C4F-A5F6-1C5FE324A00C}" presName="linNode" presStyleCnt="0"/>
      <dgm:spPr/>
    </dgm:pt>
    <dgm:pt modelId="{4D3677DD-203E-6A46-986E-4A5C658C9303}" type="pres">
      <dgm:prSet presAssocID="{827957E1-E296-1C4F-A5F6-1C5FE324A00C}" presName="parentText" presStyleLbl="node1" presStyleIdx="4" presStyleCnt="8" custScaleX="67001">
        <dgm:presLayoutVars>
          <dgm:chMax val="1"/>
          <dgm:bulletEnabled val="1"/>
        </dgm:presLayoutVars>
      </dgm:prSet>
      <dgm:spPr/>
    </dgm:pt>
    <dgm:pt modelId="{DF481026-182D-AB4B-A938-B9E12915351D}" type="pres">
      <dgm:prSet presAssocID="{827957E1-E296-1C4F-A5F6-1C5FE324A00C}" presName="descendantText" presStyleLbl="alignAccFollowNode1" presStyleIdx="4" presStyleCnt="8">
        <dgm:presLayoutVars>
          <dgm:bulletEnabled val="1"/>
        </dgm:presLayoutVars>
      </dgm:prSet>
      <dgm:spPr/>
    </dgm:pt>
    <dgm:pt modelId="{0E9316E9-2C30-AB47-AE90-7E8E046E1AFD}" type="pres">
      <dgm:prSet presAssocID="{9F52F0F0-B16C-AB44-86AF-35AA79D5B0BB}" presName="sp" presStyleCnt="0"/>
      <dgm:spPr/>
    </dgm:pt>
    <dgm:pt modelId="{037794A2-D322-8E40-B011-CE07ECE52AD6}" type="pres">
      <dgm:prSet presAssocID="{9F6E5C8F-12F1-3545-94A6-291C5042E69E}" presName="linNode" presStyleCnt="0"/>
      <dgm:spPr/>
    </dgm:pt>
    <dgm:pt modelId="{B6C279C8-1B63-3845-ADAB-B82AEFA3D8E4}" type="pres">
      <dgm:prSet presAssocID="{9F6E5C8F-12F1-3545-94A6-291C5042E69E}" presName="parentText" presStyleLbl="node1" presStyleIdx="5" presStyleCnt="8" custScaleX="67001">
        <dgm:presLayoutVars>
          <dgm:chMax val="1"/>
          <dgm:bulletEnabled val="1"/>
        </dgm:presLayoutVars>
      </dgm:prSet>
      <dgm:spPr/>
    </dgm:pt>
    <dgm:pt modelId="{95DA0D8B-BC89-0948-909A-C298332DBD75}" type="pres">
      <dgm:prSet presAssocID="{9F6E5C8F-12F1-3545-94A6-291C5042E69E}" presName="descendantText" presStyleLbl="alignAccFollowNode1" presStyleIdx="5" presStyleCnt="8">
        <dgm:presLayoutVars>
          <dgm:bulletEnabled val="1"/>
        </dgm:presLayoutVars>
      </dgm:prSet>
      <dgm:spPr/>
    </dgm:pt>
    <dgm:pt modelId="{05C8E7F6-EE84-404A-A830-A5238A04D5A3}" type="pres">
      <dgm:prSet presAssocID="{F501E3C1-886B-5244-A7B1-7A80D72A4D8C}" presName="sp" presStyleCnt="0"/>
      <dgm:spPr/>
    </dgm:pt>
    <dgm:pt modelId="{450D1F74-F684-8F4C-A8B3-6F8B553AB682}" type="pres">
      <dgm:prSet presAssocID="{02BDF100-8338-E043-96F5-EE898B9D5AB2}" presName="linNode" presStyleCnt="0"/>
      <dgm:spPr/>
    </dgm:pt>
    <dgm:pt modelId="{B67BA8B7-08DC-C244-8300-FCD547033DBD}" type="pres">
      <dgm:prSet presAssocID="{02BDF100-8338-E043-96F5-EE898B9D5AB2}" presName="parentText" presStyleLbl="node1" presStyleIdx="6" presStyleCnt="8" custScaleX="67001">
        <dgm:presLayoutVars>
          <dgm:chMax val="1"/>
          <dgm:bulletEnabled val="1"/>
        </dgm:presLayoutVars>
      </dgm:prSet>
      <dgm:spPr/>
    </dgm:pt>
    <dgm:pt modelId="{9D2B4FF6-13FB-EF49-977A-31DF5EE58099}" type="pres">
      <dgm:prSet presAssocID="{02BDF100-8338-E043-96F5-EE898B9D5AB2}" presName="descendantText" presStyleLbl="alignAccFollowNode1" presStyleIdx="6" presStyleCnt="8">
        <dgm:presLayoutVars>
          <dgm:bulletEnabled val="1"/>
        </dgm:presLayoutVars>
      </dgm:prSet>
      <dgm:spPr/>
    </dgm:pt>
    <dgm:pt modelId="{580F7313-AC0F-FA49-A45E-0C9486F52D6E}" type="pres">
      <dgm:prSet presAssocID="{BCE247F3-63ED-824C-BC43-9D645F88694B}" presName="sp" presStyleCnt="0"/>
      <dgm:spPr/>
    </dgm:pt>
    <dgm:pt modelId="{E737A561-EB87-EC46-B404-0D8CDB0DE287}" type="pres">
      <dgm:prSet presAssocID="{7CF6944D-D814-F446-BDE2-B55C1C344687}" presName="linNode" presStyleCnt="0"/>
      <dgm:spPr/>
    </dgm:pt>
    <dgm:pt modelId="{D5D04DA4-D0C2-DE47-8C8C-0B8EFFA304FE}" type="pres">
      <dgm:prSet presAssocID="{7CF6944D-D814-F446-BDE2-B55C1C344687}" presName="parentText" presStyleLbl="node1" presStyleIdx="7" presStyleCnt="8" custScaleX="67001">
        <dgm:presLayoutVars>
          <dgm:chMax val="1"/>
          <dgm:bulletEnabled val="1"/>
        </dgm:presLayoutVars>
      </dgm:prSet>
      <dgm:spPr/>
    </dgm:pt>
    <dgm:pt modelId="{8CF3EAF4-8574-9841-9B3E-4FBF8CB57172}" type="pres">
      <dgm:prSet presAssocID="{7CF6944D-D814-F446-BDE2-B55C1C344687}" presName="descendantText" presStyleLbl="alignAccFollowNode1" presStyleIdx="7" presStyleCnt="8">
        <dgm:presLayoutVars>
          <dgm:bulletEnabled val="1"/>
        </dgm:presLayoutVars>
      </dgm:prSet>
      <dgm:spPr/>
    </dgm:pt>
  </dgm:ptLst>
  <dgm:cxnLst>
    <dgm:cxn modelId="{E4273A05-E6BD-7B48-BAB7-FF2C885BDD30}" type="presOf" srcId="{02BDF100-8338-E043-96F5-EE898B9D5AB2}" destId="{B67BA8B7-08DC-C244-8300-FCD547033DBD}" srcOrd="0" destOrd="0" presId="urn:microsoft.com/office/officeart/2005/8/layout/vList5"/>
    <dgm:cxn modelId="{E9D1E10C-1628-524C-9321-D84C071FF74D}" type="presOf" srcId="{CE7EC2B3-709C-7049-AC98-40D647A08CD5}" destId="{C651D352-06FA-1B42-81FF-A95099FE5645}" srcOrd="0" destOrd="0" presId="urn:microsoft.com/office/officeart/2005/8/layout/vList5"/>
    <dgm:cxn modelId="{C4160712-DF53-0F4F-9BBA-78BD9BBF4B88}" type="presOf" srcId="{77E26394-E137-5E44-9434-AC75CD3E8E1C}" destId="{B11406A9-5BCB-7247-9C38-2B1D2505F2B8}" srcOrd="0" destOrd="0" presId="urn:microsoft.com/office/officeart/2005/8/layout/vList5"/>
    <dgm:cxn modelId="{C5A31E1B-1939-A943-9EA9-0D1F931C9095}" srcId="{CE7EC2B3-709C-7049-AC98-40D647A08CD5}" destId="{827957E1-E296-1C4F-A5F6-1C5FE324A00C}" srcOrd="4" destOrd="0" parTransId="{AC89EDA2-97A0-704F-A224-66777968DC79}" sibTransId="{9F52F0F0-B16C-AB44-86AF-35AA79D5B0BB}"/>
    <dgm:cxn modelId="{086EAA1D-3224-4E41-87B1-9FA27037DE47}" type="presOf" srcId="{9F6E5C8F-12F1-3545-94A6-291C5042E69E}" destId="{B6C279C8-1B63-3845-ADAB-B82AEFA3D8E4}" srcOrd="0" destOrd="0" presId="urn:microsoft.com/office/officeart/2005/8/layout/vList5"/>
    <dgm:cxn modelId="{71BBC71D-E55C-424F-B6C9-6E507D91D4E5}" type="presOf" srcId="{D6BB4A41-00B2-5448-BB3F-80605AC75A4E}" destId="{95DA0D8B-BC89-0948-909A-C298332DBD75}" srcOrd="0" destOrd="0" presId="urn:microsoft.com/office/officeart/2005/8/layout/vList5"/>
    <dgm:cxn modelId="{7A4CD21E-5C30-9844-B8CC-04D4CC71350C}" type="presOf" srcId="{4042EA18-93B7-8447-AC0A-58BAED6135AA}" destId="{8CF3EAF4-8574-9841-9B3E-4FBF8CB57172}" srcOrd="0" destOrd="0" presId="urn:microsoft.com/office/officeart/2005/8/layout/vList5"/>
    <dgm:cxn modelId="{EA0CCB2E-33A7-7842-AF42-FDB163C3A0DB}" type="presOf" srcId="{8E966A69-49F1-5E4B-B606-FCAEDAA984ED}" destId="{2EB4DD27-0645-2048-89E9-55CE50FE52DA}" srcOrd="0" destOrd="0" presId="urn:microsoft.com/office/officeart/2005/8/layout/vList5"/>
    <dgm:cxn modelId="{65CEA44F-9E16-EA4E-A309-EC3B3016297A}" srcId="{CE7EC2B3-709C-7049-AC98-40D647A08CD5}" destId="{D03F059F-5021-1F40-A19F-9647158C52AD}" srcOrd="1" destOrd="0" parTransId="{CF000D09-B476-0444-AE02-AACE5A32ABB9}" sibTransId="{294C2440-29C3-A948-ADDD-2D4D34880BDD}"/>
    <dgm:cxn modelId="{2BBF3C50-1ED6-9847-B76B-936F9EDE5606}" srcId="{CE7EC2B3-709C-7049-AC98-40D647A08CD5}" destId="{418E94F4-4F87-154C-8C2C-4FA1854F2962}" srcOrd="3" destOrd="0" parTransId="{67B29BF1-08A2-E04F-9D69-0598739CF13B}" sibTransId="{A5C1BCA8-59E6-2D47-BF9C-24A0A56844F7}"/>
    <dgm:cxn modelId="{3055A850-65BD-2C48-A538-0AAEB9138E85}" srcId="{418E94F4-4F87-154C-8C2C-4FA1854F2962}" destId="{77E26394-E137-5E44-9434-AC75CD3E8E1C}" srcOrd="0" destOrd="0" parTransId="{0106416C-C608-3E4B-95A9-3A27F212EF0D}" sibTransId="{4162CFAB-B676-8E4E-8FEB-32BD16B62DEC}"/>
    <dgm:cxn modelId="{B3273152-AF0F-EE4B-8C28-8B1E95E5CD89}" type="presOf" srcId="{E900B89A-C42B-5249-B68C-A3D7ECDC2722}" destId="{5432570E-A980-7C49-B78B-FBD7E95247D6}" srcOrd="0" destOrd="0" presId="urn:microsoft.com/office/officeart/2005/8/layout/vList5"/>
    <dgm:cxn modelId="{90712D57-061F-8444-BA8A-D8DA5E4630C5}" type="presOf" srcId="{73A345CE-36FD-894D-BBC6-F1148569A643}" destId="{A3A63788-1227-B240-AFF4-87DA3887717D}" srcOrd="0" destOrd="0" presId="urn:microsoft.com/office/officeart/2005/8/layout/vList5"/>
    <dgm:cxn modelId="{B4BAA057-82A7-8F4F-B3AE-D2474B9F0D61}" srcId="{CE7EC2B3-709C-7049-AC98-40D647A08CD5}" destId="{7CF6944D-D814-F446-BDE2-B55C1C344687}" srcOrd="7" destOrd="0" parTransId="{18766106-4E88-954F-80B4-8435CD7E3607}" sibTransId="{41CA9CD1-BD05-D240-8585-F6D044F469D5}"/>
    <dgm:cxn modelId="{BAD62360-A798-6A47-A994-B5126C6DDBBA}" type="presOf" srcId="{D57A6E2B-1DF9-5046-BC1D-709A01F64D7F}" destId="{21D64796-42C1-6A47-B16B-F23C35A117FF}" srcOrd="0" destOrd="0" presId="urn:microsoft.com/office/officeart/2005/8/layout/vList5"/>
    <dgm:cxn modelId="{F6183E77-6BBF-FA47-854D-F0D53AE21A8A}" srcId="{CE7EC2B3-709C-7049-AC98-40D647A08CD5}" destId="{02BDF100-8338-E043-96F5-EE898B9D5AB2}" srcOrd="6" destOrd="0" parTransId="{1B53CCA0-CFF2-384B-856E-1EBDFA4D02AD}" sibTransId="{BCE247F3-63ED-824C-BC43-9D645F88694B}"/>
    <dgm:cxn modelId="{89198578-5DCB-6140-878F-E9FD8D67271F}" type="presOf" srcId="{7CF6944D-D814-F446-BDE2-B55C1C344687}" destId="{D5D04DA4-D0C2-DE47-8C8C-0B8EFFA304FE}" srcOrd="0" destOrd="0" presId="urn:microsoft.com/office/officeart/2005/8/layout/vList5"/>
    <dgm:cxn modelId="{408ED183-BF58-1C4B-97FD-732582625FEF}" srcId="{CE7EC2B3-709C-7049-AC98-40D647A08CD5}" destId="{73A345CE-36FD-894D-BBC6-F1148569A643}" srcOrd="2" destOrd="0" parTransId="{E3B27BD6-FBE2-5640-8D4A-26A5222CC3EA}" sibTransId="{7A99C83F-BC00-3743-81E8-552BD253CEC3}"/>
    <dgm:cxn modelId="{B2C59790-5949-8740-B37D-5567793C306C}" srcId="{54EB0C78-47D0-4144-BBA1-ED83F2276A80}" destId="{D57A6E2B-1DF9-5046-BC1D-709A01F64D7F}" srcOrd="0" destOrd="0" parTransId="{C76AEE8B-D94A-7D44-B03A-3FE0785274DD}" sibTransId="{55132C62-F393-2540-A3F5-1E79E69F36CF}"/>
    <dgm:cxn modelId="{2D83CF9B-C8D2-5645-B148-7557D123AE42}" type="presOf" srcId="{827957E1-E296-1C4F-A5F6-1C5FE324A00C}" destId="{4D3677DD-203E-6A46-986E-4A5C658C9303}" srcOrd="0" destOrd="0" presId="urn:microsoft.com/office/officeart/2005/8/layout/vList5"/>
    <dgm:cxn modelId="{D734F3A8-F28E-EC4B-833E-A76A8DF839E2}" type="presOf" srcId="{D03F059F-5021-1F40-A19F-9647158C52AD}" destId="{6CEBA26E-9501-3E41-ACBB-39C96B19A924}" srcOrd="0" destOrd="0" presId="urn:microsoft.com/office/officeart/2005/8/layout/vList5"/>
    <dgm:cxn modelId="{8EA459AB-225B-8C4D-9825-5D1C6BF10277}" srcId="{73A345CE-36FD-894D-BBC6-F1148569A643}" destId="{E900B89A-C42B-5249-B68C-A3D7ECDC2722}" srcOrd="0" destOrd="0" parTransId="{8E839505-C7B5-E846-B572-409C6E14F87D}" sibTransId="{1CCB8A03-5593-CE44-86BA-AACEAE0CCB98}"/>
    <dgm:cxn modelId="{54AEA8B7-F89B-724F-98A1-0AEC5D7FC3A2}" srcId="{CE7EC2B3-709C-7049-AC98-40D647A08CD5}" destId="{54EB0C78-47D0-4144-BBA1-ED83F2276A80}" srcOrd="0" destOrd="0" parTransId="{46A28A5B-8A7C-BF49-A5DC-996D874F74B0}" sibTransId="{E8376F97-8FAC-AA43-868D-BB3E335B92F2}"/>
    <dgm:cxn modelId="{D85391B8-F585-FD43-82E0-8ACB9B810BF4}" srcId="{827957E1-E296-1C4F-A5F6-1C5FE324A00C}" destId="{B3ABDBBC-28C2-CC44-9EA0-940A074F9BF0}" srcOrd="0" destOrd="0" parTransId="{D1297B60-D255-DA44-8D75-399213932CFB}" sibTransId="{B1A1C092-087B-F241-9B26-AD1D13C72D4D}"/>
    <dgm:cxn modelId="{DF1A41C0-D8B8-6D4F-A8A5-91EC68AFBCAD}" srcId="{9F6E5C8F-12F1-3545-94A6-291C5042E69E}" destId="{D6BB4A41-00B2-5448-BB3F-80605AC75A4E}" srcOrd="0" destOrd="0" parTransId="{4E04882C-8060-1D42-8502-5D210AA0DCD3}" sibTransId="{A3F6C628-648D-0249-B65F-551AF9ECEEA6}"/>
    <dgm:cxn modelId="{F2E046C8-391B-6946-ACE6-697EC224AB98}" type="presOf" srcId="{B3ABDBBC-28C2-CC44-9EA0-940A074F9BF0}" destId="{DF481026-182D-AB4B-A938-B9E12915351D}" srcOrd="0" destOrd="0" presId="urn:microsoft.com/office/officeart/2005/8/layout/vList5"/>
    <dgm:cxn modelId="{E2BB9BC9-6DB1-9443-8E35-6250A99E4AD7}" srcId="{02BDF100-8338-E043-96F5-EE898B9D5AB2}" destId="{0545D5E0-C6B3-A447-B001-E955BFE39730}" srcOrd="0" destOrd="0" parTransId="{74548467-254B-2943-9A99-08C07F3E448D}" sibTransId="{43A03E68-4CAE-A344-B58C-38B13B6EE776}"/>
    <dgm:cxn modelId="{A16837DB-2A15-1C45-807B-67AB4EF8E75E}" type="presOf" srcId="{0545D5E0-C6B3-A447-B001-E955BFE39730}" destId="{9D2B4FF6-13FB-EF49-977A-31DF5EE58099}" srcOrd="0" destOrd="0" presId="urn:microsoft.com/office/officeart/2005/8/layout/vList5"/>
    <dgm:cxn modelId="{BBBA16DC-BC73-8048-A725-FE1EF1BF6593}" srcId="{7CF6944D-D814-F446-BDE2-B55C1C344687}" destId="{4042EA18-93B7-8447-AC0A-58BAED6135AA}" srcOrd="0" destOrd="0" parTransId="{2F5CB061-56DE-EB4D-BFD4-36B00E6055CB}" sibTransId="{A608511D-1BB9-EB4E-9E74-CCD7B0DB861D}"/>
    <dgm:cxn modelId="{545F95DE-9A10-3948-9807-36C195D34A35}" srcId="{CE7EC2B3-709C-7049-AC98-40D647A08CD5}" destId="{9F6E5C8F-12F1-3545-94A6-291C5042E69E}" srcOrd="5" destOrd="0" parTransId="{F878F1E0-BA83-0B4F-8407-D69A3E0606E8}" sibTransId="{F501E3C1-886B-5244-A7B1-7A80D72A4D8C}"/>
    <dgm:cxn modelId="{1AC639E1-2DD4-8C49-9596-C5731579DC3A}" type="presOf" srcId="{54EB0C78-47D0-4144-BBA1-ED83F2276A80}" destId="{2F0271A3-745A-A943-B67B-E4069A93AE61}" srcOrd="0" destOrd="0" presId="urn:microsoft.com/office/officeart/2005/8/layout/vList5"/>
    <dgm:cxn modelId="{FBB45EE4-904A-AF48-A0C9-CB655E66EF52}" srcId="{D03F059F-5021-1F40-A19F-9647158C52AD}" destId="{8E966A69-49F1-5E4B-B606-FCAEDAA984ED}" srcOrd="0" destOrd="0" parTransId="{DBAD8E5C-BD8A-8D4C-B4F0-8493200D7696}" sibTransId="{6E022D76-54D3-5040-BFB1-6E3CF648085C}"/>
    <dgm:cxn modelId="{CE4D51EC-1171-9740-9774-3550157EF9C1}" type="presOf" srcId="{418E94F4-4F87-154C-8C2C-4FA1854F2962}" destId="{F459C834-8503-9C47-9E88-19B5B264D39A}" srcOrd="0" destOrd="0" presId="urn:microsoft.com/office/officeart/2005/8/layout/vList5"/>
    <dgm:cxn modelId="{BF236B13-02D1-B64C-986F-0CAF7E0612E5}" type="presParOf" srcId="{C651D352-06FA-1B42-81FF-A95099FE5645}" destId="{2E2FEDEA-0CB5-FD4B-8718-95B9D6A14304}" srcOrd="0" destOrd="0" presId="urn:microsoft.com/office/officeart/2005/8/layout/vList5"/>
    <dgm:cxn modelId="{9578A504-AB23-5044-A923-D3DEFAE4D5E7}" type="presParOf" srcId="{2E2FEDEA-0CB5-FD4B-8718-95B9D6A14304}" destId="{2F0271A3-745A-A943-B67B-E4069A93AE61}" srcOrd="0" destOrd="0" presId="urn:microsoft.com/office/officeart/2005/8/layout/vList5"/>
    <dgm:cxn modelId="{253C94D8-1885-B543-AF3D-F6A1DD424873}" type="presParOf" srcId="{2E2FEDEA-0CB5-FD4B-8718-95B9D6A14304}" destId="{21D64796-42C1-6A47-B16B-F23C35A117FF}" srcOrd="1" destOrd="0" presId="urn:microsoft.com/office/officeart/2005/8/layout/vList5"/>
    <dgm:cxn modelId="{C06B9A2B-4F20-7C45-806D-5E7956B4F171}" type="presParOf" srcId="{C651D352-06FA-1B42-81FF-A95099FE5645}" destId="{B2C4C361-6A0B-BC45-90FD-318B0EB08F6D}" srcOrd="1" destOrd="0" presId="urn:microsoft.com/office/officeart/2005/8/layout/vList5"/>
    <dgm:cxn modelId="{7BF712B5-32BC-7844-BF86-9BFE0BE03182}" type="presParOf" srcId="{C651D352-06FA-1B42-81FF-A95099FE5645}" destId="{277D1FDC-6CD3-BB41-8E20-960C658417CF}" srcOrd="2" destOrd="0" presId="urn:microsoft.com/office/officeart/2005/8/layout/vList5"/>
    <dgm:cxn modelId="{8EE30A21-17AC-A34E-A945-33D32D0CD928}" type="presParOf" srcId="{277D1FDC-6CD3-BB41-8E20-960C658417CF}" destId="{6CEBA26E-9501-3E41-ACBB-39C96B19A924}" srcOrd="0" destOrd="0" presId="urn:microsoft.com/office/officeart/2005/8/layout/vList5"/>
    <dgm:cxn modelId="{3CCA96C7-C68E-DA49-A8B4-DD728A5A5A21}" type="presParOf" srcId="{277D1FDC-6CD3-BB41-8E20-960C658417CF}" destId="{2EB4DD27-0645-2048-89E9-55CE50FE52DA}" srcOrd="1" destOrd="0" presId="urn:microsoft.com/office/officeart/2005/8/layout/vList5"/>
    <dgm:cxn modelId="{4AF2BADF-B9C1-834B-AC41-60901F7D6D95}" type="presParOf" srcId="{C651D352-06FA-1B42-81FF-A95099FE5645}" destId="{33CCAA17-6648-4F4C-9AC2-5ECE7EDB6E70}" srcOrd="3" destOrd="0" presId="urn:microsoft.com/office/officeart/2005/8/layout/vList5"/>
    <dgm:cxn modelId="{2A4E440E-B7D6-6B49-8318-F6B71A21E6CF}" type="presParOf" srcId="{C651D352-06FA-1B42-81FF-A95099FE5645}" destId="{B97FC210-8EA1-614A-91AB-916C1AEFBDEE}" srcOrd="4" destOrd="0" presId="urn:microsoft.com/office/officeart/2005/8/layout/vList5"/>
    <dgm:cxn modelId="{2BDD0334-A1D2-DC42-B9D1-68F24D23B5D5}" type="presParOf" srcId="{B97FC210-8EA1-614A-91AB-916C1AEFBDEE}" destId="{A3A63788-1227-B240-AFF4-87DA3887717D}" srcOrd="0" destOrd="0" presId="urn:microsoft.com/office/officeart/2005/8/layout/vList5"/>
    <dgm:cxn modelId="{C69877D5-79C1-9F4C-B7F4-8AD7D15754EE}" type="presParOf" srcId="{B97FC210-8EA1-614A-91AB-916C1AEFBDEE}" destId="{5432570E-A980-7C49-B78B-FBD7E95247D6}" srcOrd="1" destOrd="0" presId="urn:microsoft.com/office/officeart/2005/8/layout/vList5"/>
    <dgm:cxn modelId="{33ACEA31-C6CD-5547-BED3-2458723FCA4A}" type="presParOf" srcId="{C651D352-06FA-1B42-81FF-A95099FE5645}" destId="{3E055F9F-21A2-424C-8A4E-65EE89C8A916}" srcOrd="5" destOrd="0" presId="urn:microsoft.com/office/officeart/2005/8/layout/vList5"/>
    <dgm:cxn modelId="{A37DA9BE-A47E-BB4D-9CC1-632CE186629D}" type="presParOf" srcId="{C651D352-06FA-1B42-81FF-A95099FE5645}" destId="{3D7F3715-4665-FB42-B9D8-1FF06FE7ED04}" srcOrd="6" destOrd="0" presId="urn:microsoft.com/office/officeart/2005/8/layout/vList5"/>
    <dgm:cxn modelId="{C891109C-0686-B74F-8141-60300585C701}" type="presParOf" srcId="{3D7F3715-4665-FB42-B9D8-1FF06FE7ED04}" destId="{F459C834-8503-9C47-9E88-19B5B264D39A}" srcOrd="0" destOrd="0" presId="urn:microsoft.com/office/officeart/2005/8/layout/vList5"/>
    <dgm:cxn modelId="{2F31821D-0811-794B-B121-3DE9146709AD}" type="presParOf" srcId="{3D7F3715-4665-FB42-B9D8-1FF06FE7ED04}" destId="{B11406A9-5BCB-7247-9C38-2B1D2505F2B8}" srcOrd="1" destOrd="0" presId="urn:microsoft.com/office/officeart/2005/8/layout/vList5"/>
    <dgm:cxn modelId="{0F8FFFCC-28B5-A844-A0C0-4277188A3AC8}" type="presParOf" srcId="{C651D352-06FA-1B42-81FF-A95099FE5645}" destId="{E355AC6F-4099-CB47-B889-4B740E437363}" srcOrd="7" destOrd="0" presId="urn:microsoft.com/office/officeart/2005/8/layout/vList5"/>
    <dgm:cxn modelId="{53EF242F-1951-6046-AB59-C18248626329}" type="presParOf" srcId="{C651D352-06FA-1B42-81FF-A95099FE5645}" destId="{A60CA7D8-39CB-954A-95BD-9B247DA4C063}" srcOrd="8" destOrd="0" presId="urn:microsoft.com/office/officeart/2005/8/layout/vList5"/>
    <dgm:cxn modelId="{ED3BF37E-4F96-D544-B638-C0AB83F1A9B4}" type="presParOf" srcId="{A60CA7D8-39CB-954A-95BD-9B247DA4C063}" destId="{4D3677DD-203E-6A46-986E-4A5C658C9303}" srcOrd="0" destOrd="0" presId="urn:microsoft.com/office/officeart/2005/8/layout/vList5"/>
    <dgm:cxn modelId="{5F05AF10-2999-E74B-852A-D64954D94FF8}" type="presParOf" srcId="{A60CA7D8-39CB-954A-95BD-9B247DA4C063}" destId="{DF481026-182D-AB4B-A938-B9E12915351D}" srcOrd="1" destOrd="0" presId="urn:microsoft.com/office/officeart/2005/8/layout/vList5"/>
    <dgm:cxn modelId="{ACD94F81-0016-934D-9BD5-68D8F780E3B7}" type="presParOf" srcId="{C651D352-06FA-1B42-81FF-A95099FE5645}" destId="{0E9316E9-2C30-AB47-AE90-7E8E046E1AFD}" srcOrd="9" destOrd="0" presId="urn:microsoft.com/office/officeart/2005/8/layout/vList5"/>
    <dgm:cxn modelId="{F8E487A0-A252-584F-8A38-3822D4AF8219}" type="presParOf" srcId="{C651D352-06FA-1B42-81FF-A95099FE5645}" destId="{037794A2-D322-8E40-B011-CE07ECE52AD6}" srcOrd="10" destOrd="0" presId="urn:microsoft.com/office/officeart/2005/8/layout/vList5"/>
    <dgm:cxn modelId="{67548826-ED42-6242-AA6A-DBBB72691D13}" type="presParOf" srcId="{037794A2-D322-8E40-B011-CE07ECE52AD6}" destId="{B6C279C8-1B63-3845-ADAB-B82AEFA3D8E4}" srcOrd="0" destOrd="0" presId="urn:microsoft.com/office/officeart/2005/8/layout/vList5"/>
    <dgm:cxn modelId="{B87CE2C3-5909-4C4E-A75A-B68815D3150A}" type="presParOf" srcId="{037794A2-D322-8E40-B011-CE07ECE52AD6}" destId="{95DA0D8B-BC89-0948-909A-C298332DBD75}" srcOrd="1" destOrd="0" presId="urn:microsoft.com/office/officeart/2005/8/layout/vList5"/>
    <dgm:cxn modelId="{B702A7F2-2B11-8D48-B9AE-A25D0DE633A1}" type="presParOf" srcId="{C651D352-06FA-1B42-81FF-A95099FE5645}" destId="{05C8E7F6-EE84-404A-A830-A5238A04D5A3}" srcOrd="11" destOrd="0" presId="urn:microsoft.com/office/officeart/2005/8/layout/vList5"/>
    <dgm:cxn modelId="{5D36C750-8050-AB49-B923-84B64CB9D59C}" type="presParOf" srcId="{C651D352-06FA-1B42-81FF-A95099FE5645}" destId="{450D1F74-F684-8F4C-A8B3-6F8B553AB682}" srcOrd="12" destOrd="0" presId="urn:microsoft.com/office/officeart/2005/8/layout/vList5"/>
    <dgm:cxn modelId="{69DDD68C-0D88-6141-B93A-2DFC27495FCF}" type="presParOf" srcId="{450D1F74-F684-8F4C-A8B3-6F8B553AB682}" destId="{B67BA8B7-08DC-C244-8300-FCD547033DBD}" srcOrd="0" destOrd="0" presId="urn:microsoft.com/office/officeart/2005/8/layout/vList5"/>
    <dgm:cxn modelId="{772109BC-D0C5-5C47-B68B-C1F238D6D77F}" type="presParOf" srcId="{450D1F74-F684-8F4C-A8B3-6F8B553AB682}" destId="{9D2B4FF6-13FB-EF49-977A-31DF5EE58099}" srcOrd="1" destOrd="0" presId="urn:microsoft.com/office/officeart/2005/8/layout/vList5"/>
    <dgm:cxn modelId="{5EBAD0AC-A244-A44E-ADFB-53F20C58044C}" type="presParOf" srcId="{C651D352-06FA-1B42-81FF-A95099FE5645}" destId="{580F7313-AC0F-FA49-A45E-0C9486F52D6E}" srcOrd="13" destOrd="0" presId="urn:microsoft.com/office/officeart/2005/8/layout/vList5"/>
    <dgm:cxn modelId="{6E9922E5-478F-AF4D-9DCA-7A72508F4F6D}" type="presParOf" srcId="{C651D352-06FA-1B42-81FF-A95099FE5645}" destId="{E737A561-EB87-EC46-B404-0D8CDB0DE287}" srcOrd="14" destOrd="0" presId="urn:microsoft.com/office/officeart/2005/8/layout/vList5"/>
    <dgm:cxn modelId="{8E470ECC-4731-EF49-B2A8-AD4470B8AD53}" type="presParOf" srcId="{E737A561-EB87-EC46-B404-0D8CDB0DE287}" destId="{D5D04DA4-D0C2-DE47-8C8C-0B8EFFA304FE}" srcOrd="0" destOrd="0" presId="urn:microsoft.com/office/officeart/2005/8/layout/vList5"/>
    <dgm:cxn modelId="{B9608D4F-B546-F142-90CB-D6437FE05ACF}" type="presParOf" srcId="{E737A561-EB87-EC46-B404-0D8CDB0DE287}" destId="{8CF3EAF4-8574-9841-9B3E-4FBF8CB57172}"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CE7EC2B3-709C-7049-AC98-40D647A08CD5}" type="doc">
      <dgm:prSet loTypeId="urn:microsoft.com/office/officeart/2005/8/layout/vList5" loCatId="" qsTypeId="urn:microsoft.com/office/officeart/2005/8/quickstyle/simple1" qsCatId="simple" csTypeId="urn:microsoft.com/office/officeart/2005/8/colors/accent1_2" csCatId="accent1" phldr="1"/>
      <dgm:spPr/>
      <dgm:t>
        <a:bodyPr/>
        <a:lstStyle/>
        <a:p>
          <a:endParaRPr lang="en-US"/>
        </a:p>
      </dgm:t>
    </dgm:pt>
    <dgm:pt modelId="{54EB0C78-47D0-4144-BBA1-ED83F2276A80}">
      <dgm:prSet phldrT="[Text]"/>
      <dgm:spPr/>
      <dgm:t>
        <a:bodyPr/>
        <a:lstStyle/>
        <a:p>
          <a:r>
            <a:rPr lang="en-US" dirty="0"/>
            <a:t>1</a:t>
          </a:r>
        </a:p>
      </dgm:t>
    </dgm:pt>
    <dgm:pt modelId="{46A28A5B-8A7C-BF49-A5DC-996D874F74B0}" type="parTrans" cxnId="{54AEA8B7-F89B-724F-98A1-0AEC5D7FC3A2}">
      <dgm:prSet/>
      <dgm:spPr/>
      <dgm:t>
        <a:bodyPr/>
        <a:lstStyle/>
        <a:p>
          <a:endParaRPr lang="en-US"/>
        </a:p>
      </dgm:t>
    </dgm:pt>
    <dgm:pt modelId="{E8376F97-8FAC-AA43-868D-BB3E335B92F2}" type="sibTrans" cxnId="{54AEA8B7-F89B-724F-98A1-0AEC5D7FC3A2}">
      <dgm:prSet/>
      <dgm:spPr/>
      <dgm:t>
        <a:bodyPr/>
        <a:lstStyle/>
        <a:p>
          <a:endParaRPr lang="en-US"/>
        </a:p>
      </dgm:t>
    </dgm:pt>
    <dgm:pt modelId="{D57A6E2B-1DF9-5046-BC1D-709A01F64D7F}">
      <dgm:prSet phldrT="[Text]"/>
      <dgm:spPr/>
      <dgm:t>
        <a:bodyPr/>
        <a:lstStyle/>
        <a:p>
          <a:r>
            <a:rPr lang="en-US"/>
            <a:t>Patient stability</a:t>
          </a:r>
          <a:endParaRPr lang="en-US" dirty="0"/>
        </a:p>
      </dgm:t>
    </dgm:pt>
    <dgm:pt modelId="{C76AEE8B-D94A-7D44-B03A-3FE0785274DD}" type="parTrans" cxnId="{B2C59790-5949-8740-B37D-5567793C306C}">
      <dgm:prSet/>
      <dgm:spPr/>
      <dgm:t>
        <a:bodyPr/>
        <a:lstStyle/>
        <a:p>
          <a:endParaRPr lang="en-US"/>
        </a:p>
      </dgm:t>
    </dgm:pt>
    <dgm:pt modelId="{55132C62-F393-2540-A3F5-1E79E69F36CF}" type="sibTrans" cxnId="{B2C59790-5949-8740-B37D-5567793C306C}">
      <dgm:prSet/>
      <dgm:spPr/>
      <dgm:t>
        <a:bodyPr/>
        <a:lstStyle/>
        <a:p>
          <a:endParaRPr lang="en-US"/>
        </a:p>
      </dgm:t>
    </dgm:pt>
    <dgm:pt modelId="{8E966A69-49F1-5E4B-B606-FCAEDAA984ED}">
      <dgm:prSet phldrT="[Text]"/>
      <dgm:spPr/>
      <dgm:t>
        <a:bodyPr/>
        <a:lstStyle/>
        <a:p>
          <a:r>
            <a:rPr lang="en-US" dirty="0"/>
            <a:t>Emotional check</a:t>
          </a:r>
        </a:p>
      </dgm:t>
    </dgm:pt>
    <dgm:pt modelId="{6E022D76-54D3-5040-BFB1-6E3CF648085C}" type="sibTrans" cxnId="{FBB45EE4-904A-AF48-A0C9-CB655E66EF52}">
      <dgm:prSet/>
      <dgm:spPr/>
      <dgm:t>
        <a:bodyPr/>
        <a:lstStyle/>
        <a:p>
          <a:endParaRPr lang="en-US"/>
        </a:p>
      </dgm:t>
    </dgm:pt>
    <dgm:pt modelId="{DBAD8E5C-BD8A-8D4C-B4F0-8493200D7696}" type="parTrans" cxnId="{FBB45EE4-904A-AF48-A0C9-CB655E66EF52}">
      <dgm:prSet/>
      <dgm:spPr/>
      <dgm:t>
        <a:bodyPr/>
        <a:lstStyle/>
        <a:p>
          <a:endParaRPr lang="en-US"/>
        </a:p>
      </dgm:t>
    </dgm:pt>
    <dgm:pt modelId="{E900B89A-C42B-5249-B68C-A3D7ECDC2722}">
      <dgm:prSet phldrT="[Text]"/>
      <dgm:spPr/>
      <dgm:t>
        <a:bodyPr/>
        <a:lstStyle/>
        <a:p>
          <a:r>
            <a:rPr lang="en-US" dirty="0"/>
            <a:t>Address bias</a:t>
          </a:r>
        </a:p>
      </dgm:t>
    </dgm:pt>
    <dgm:pt modelId="{1CCB8A03-5593-CE44-86BA-AACEAE0CCB98}" type="sibTrans" cxnId="{8EA459AB-225B-8C4D-9825-5D1C6BF10277}">
      <dgm:prSet/>
      <dgm:spPr/>
      <dgm:t>
        <a:bodyPr/>
        <a:lstStyle/>
        <a:p>
          <a:endParaRPr lang="en-US"/>
        </a:p>
      </dgm:t>
    </dgm:pt>
    <dgm:pt modelId="{8E839505-C7B5-E846-B572-409C6E14F87D}" type="parTrans" cxnId="{8EA459AB-225B-8C4D-9825-5D1C6BF10277}">
      <dgm:prSet/>
      <dgm:spPr/>
      <dgm:t>
        <a:bodyPr/>
        <a:lstStyle/>
        <a:p>
          <a:endParaRPr lang="en-US"/>
        </a:p>
      </dgm:t>
    </dgm:pt>
    <dgm:pt modelId="{77E26394-E137-5E44-9434-AC75CD3E8E1C}">
      <dgm:prSet/>
      <dgm:spPr/>
      <dgm:t>
        <a:bodyPr/>
        <a:lstStyle/>
        <a:p>
          <a:r>
            <a:rPr lang="en-US" dirty="0"/>
            <a:t>Align with patient</a:t>
          </a:r>
        </a:p>
      </dgm:t>
    </dgm:pt>
    <dgm:pt modelId="{4162CFAB-B676-8E4E-8FEB-32BD16B62DEC}" type="sibTrans" cxnId="{3055A850-65BD-2C48-A538-0AAEB9138E85}">
      <dgm:prSet/>
      <dgm:spPr/>
      <dgm:t>
        <a:bodyPr/>
        <a:lstStyle/>
        <a:p>
          <a:endParaRPr lang="en-US"/>
        </a:p>
      </dgm:t>
    </dgm:pt>
    <dgm:pt modelId="{0106416C-C608-3E4B-95A9-3A27F212EF0D}" type="parTrans" cxnId="{3055A850-65BD-2C48-A538-0AAEB9138E85}">
      <dgm:prSet/>
      <dgm:spPr/>
      <dgm:t>
        <a:bodyPr/>
        <a:lstStyle/>
        <a:p>
          <a:endParaRPr lang="en-US"/>
        </a:p>
      </dgm:t>
    </dgm:pt>
    <dgm:pt modelId="{B3ABDBBC-28C2-CC44-9EA0-940A074F9BF0}">
      <dgm:prSet/>
      <dgm:spPr/>
      <dgm:t>
        <a:bodyPr/>
        <a:lstStyle/>
        <a:p>
          <a:r>
            <a:rPr lang="en-US" dirty="0"/>
            <a:t>Align with team</a:t>
          </a:r>
        </a:p>
      </dgm:t>
    </dgm:pt>
    <dgm:pt modelId="{B1A1C092-087B-F241-9B26-AD1D13C72D4D}" type="sibTrans" cxnId="{D85391B8-F585-FD43-82E0-8ACB9B810BF4}">
      <dgm:prSet/>
      <dgm:spPr/>
      <dgm:t>
        <a:bodyPr/>
        <a:lstStyle/>
        <a:p>
          <a:endParaRPr lang="en-US"/>
        </a:p>
      </dgm:t>
    </dgm:pt>
    <dgm:pt modelId="{D1297B60-D255-DA44-8D75-399213932CFB}" type="parTrans" cxnId="{D85391B8-F585-FD43-82E0-8ACB9B810BF4}">
      <dgm:prSet/>
      <dgm:spPr/>
      <dgm:t>
        <a:bodyPr/>
        <a:lstStyle/>
        <a:p>
          <a:endParaRPr lang="en-US"/>
        </a:p>
      </dgm:t>
    </dgm:pt>
    <dgm:pt modelId="{D6BB4A41-00B2-5448-BB3F-80605AC75A4E}">
      <dgm:prSet/>
      <dgm:spPr/>
      <dgm:t>
        <a:bodyPr/>
        <a:lstStyle/>
        <a:p>
          <a:r>
            <a:rPr lang="en-US" dirty="0"/>
            <a:t>Set boundaries</a:t>
          </a:r>
        </a:p>
      </dgm:t>
    </dgm:pt>
    <dgm:pt modelId="{A3F6C628-648D-0249-B65F-551AF9ECEEA6}" type="sibTrans" cxnId="{DF1A41C0-D8B8-6D4F-A8A5-91EC68AFBCAD}">
      <dgm:prSet/>
      <dgm:spPr/>
      <dgm:t>
        <a:bodyPr/>
        <a:lstStyle/>
        <a:p>
          <a:endParaRPr lang="en-US"/>
        </a:p>
      </dgm:t>
    </dgm:pt>
    <dgm:pt modelId="{4E04882C-8060-1D42-8502-5D210AA0DCD3}" type="parTrans" cxnId="{DF1A41C0-D8B8-6D4F-A8A5-91EC68AFBCAD}">
      <dgm:prSet/>
      <dgm:spPr/>
      <dgm:t>
        <a:bodyPr/>
        <a:lstStyle/>
        <a:p>
          <a:endParaRPr lang="en-US"/>
        </a:p>
      </dgm:t>
    </dgm:pt>
    <dgm:pt modelId="{4042EA18-93B7-8447-AC0A-58BAED6135AA}">
      <dgm:prSet/>
      <dgm:spPr/>
      <dgm:t>
        <a:bodyPr/>
        <a:lstStyle/>
        <a:p>
          <a:r>
            <a:rPr lang="en-US" dirty="0"/>
            <a:t>Seek support</a:t>
          </a:r>
        </a:p>
      </dgm:t>
    </dgm:pt>
    <dgm:pt modelId="{A608511D-1BB9-EB4E-9E74-CCD7B0DB861D}" type="sibTrans" cxnId="{BBBA16DC-BC73-8048-A725-FE1EF1BF6593}">
      <dgm:prSet/>
      <dgm:spPr/>
      <dgm:t>
        <a:bodyPr/>
        <a:lstStyle/>
        <a:p>
          <a:endParaRPr lang="en-US"/>
        </a:p>
      </dgm:t>
    </dgm:pt>
    <dgm:pt modelId="{2F5CB061-56DE-EB4D-BFD4-36B00E6055CB}" type="parTrans" cxnId="{BBBA16DC-BC73-8048-A725-FE1EF1BF6593}">
      <dgm:prSet/>
      <dgm:spPr/>
      <dgm:t>
        <a:bodyPr/>
        <a:lstStyle/>
        <a:p>
          <a:endParaRPr lang="en-US"/>
        </a:p>
      </dgm:t>
    </dgm:pt>
    <dgm:pt modelId="{0545D5E0-C6B3-A447-B001-E955BFE39730}">
      <dgm:prSet/>
      <dgm:spPr/>
      <dgm:t>
        <a:bodyPr/>
        <a:lstStyle/>
        <a:p>
          <a:r>
            <a:rPr lang="en-US" dirty="0"/>
            <a:t>Give space</a:t>
          </a:r>
        </a:p>
      </dgm:t>
    </dgm:pt>
    <dgm:pt modelId="{43A03E68-4CAE-A344-B58C-38B13B6EE776}" type="sibTrans" cxnId="{E2BB9BC9-6DB1-9443-8E35-6250A99E4AD7}">
      <dgm:prSet/>
      <dgm:spPr/>
      <dgm:t>
        <a:bodyPr/>
        <a:lstStyle/>
        <a:p>
          <a:endParaRPr lang="en-US"/>
        </a:p>
      </dgm:t>
    </dgm:pt>
    <dgm:pt modelId="{74548467-254B-2943-9A99-08C07F3E448D}" type="parTrans" cxnId="{E2BB9BC9-6DB1-9443-8E35-6250A99E4AD7}">
      <dgm:prSet/>
      <dgm:spPr/>
      <dgm:t>
        <a:bodyPr/>
        <a:lstStyle/>
        <a:p>
          <a:endParaRPr lang="en-US"/>
        </a:p>
      </dgm:t>
    </dgm:pt>
    <dgm:pt modelId="{7CF6944D-D814-F446-BDE2-B55C1C344687}">
      <dgm:prSet/>
      <dgm:spPr/>
      <dgm:t>
        <a:bodyPr/>
        <a:lstStyle/>
        <a:p>
          <a:r>
            <a:rPr lang="en-US" dirty="0"/>
            <a:t>8</a:t>
          </a:r>
        </a:p>
      </dgm:t>
    </dgm:pt>
    <dgm:pt modelId="{41CA9CD1-BD05-D240-8585-F6D044F469D5}" type="sibTrans" cxnId="{B4BAA057-82A7-8F4F-B3AE-D2474B9F0D61}">
      <dgm:prSet/>
      <dgm:spPr/>
      <dgm:t>
        <a:bodyPr/>
        <a:lstStyle/>
        <a:p>
          <a:endParaRPr lang="en-US"/>
        </a:p>
      </dgm:t>
    </dgm:pt>
    <dgm:pt modelId="{18766106-4E88-954F-80B4-8435CD7E3607}" type="parTrans" cxnId="{B4BAA057-82A7-8F4F-B3AE-D2474B9F0D61}">
      <dgm:prSet/>
      <dgm:spPr/>
      <dgm:t>
        <a:bodyPr/>
        <a:lstStyle/>
        <a:p>
          <a:endParaRPr lang="en-US"/>
        </a:p>
      </dgm:t>
    </dgm:pt>
    <dgm:pt modelId="{02BDF100-8338-E043-96F5-EE898B9D5AB2}">
      <dgm:prSet/>
      <dgm:spPr/>
      <dgm:t>
        <a:bodyPr/>
        <a:lstStyle/>
        <a:p>
          <a:r>
            <a:rPr lang="en-US" dirty="0"/>
            <a:t>7</a:t>
          </a:r>
        </a:p>
      </dgm:t>
    </dgm:pt>
    <dgm:pt modelId="{BCE247F3-63ED-824C-BC43-9D645F88694B}" type="sibTrans" cxnId="{F6183E77-6BBF-FA47-854D-F0D53AE21A8A}">
      <dgm:prSet/>
      <dgm:spPr/>
      <dgm:t>
        <a:bodyPr/>
        <a:lstStyle/>
        <a:p>
          <a:endParaRPr lang="en-US"/>
        </a:p>
      </dgm:t>
    </dgm:pt>
    <dgm:pt modelId="{1B53CCA0-CFF2-384B-856E-1EBDFA4D02AD}" type="parTrans" cxnId="{F6183E77-6BBF-FA47-854D-F0D53AE21A8A}">
      <dgm:prSet/>
      <dgm:spPr/>
      <dgm:t>
        <a:bodyPr/>
        <a:lstStyle/>
        <a:p>
          <a:endParaRPr lang="en-US"/>
        </a:p>
      </dgm:t>
    </dgm:pt>
    <dgm:pt modelId="{9F6E5C8F-12F1-3545-94A6-291C5042E69E}">
      <dgm:prSet/>
      <dgm:spPr/>
      <dgm:t>
        <a:bodyPr/>
        <a:lstStyle/>
        <a:p>
          <a:r>
            <a:rPr lang="en-US" dirty="0"/>
            <a:t>6</a:t>
          </a:r>
        </a:p>
      </dgm:t>
    </dgm:pt>
    <dgm:pt modelId="{F501E3C1-886B-5244-A7B1-7A80D72A4D8C}" type="sibTrans" cxnId="{545F95DE-9A10-3948-9807-36C195D34A35}">
      <dgm:prSet/>
      <dgm:spPr/>
      <dgm:t>
        <a:bodyPr/>
        <a:lstStyle/>
        <a:p>
          <a:endParaRPr lang="en-US"/>
        </a:p>
      </dgm:t>
    </dgm:pt>
    <dgm:pt modelId="{F878F1E0-BA83-0B4F-8407-D69A3E0606E8}" type="parTrans" cxnId="{545F95DE-9A10-3948-9807-36C195D34A35}">
      <dgm:prSet/>
      <dgm:spPr/>
      <dgm:t>
        <a:bodyPr/>
        <a:lstStyle/>
        <a:p>
          <a:endParaRPr lang="en-US"/>
        </a:p>
      </dgm:t>
    </dgm:pt>
    <dgm:pt modelId="{827957E1-E296-1C4F-A5F6-1C5FE324A00C}">
      <dgm:prSet/>
      <dgm:spPr/>
      <dgm:t>
        <a:bodyPr/>
        <a:lstStyle/>
        <a:p>
          <a:r>
            <a:rPr lang="en-US" dirty="0"/>
            <a:t>5</a:t>
          </a:r>
        </a:p>
      </dgm:t>
    </dgm:pt>
    <dgm:pt modelId="{9F52F0F0-B16C-AB44-86AF-35AA79D5B0BB}" type="sibTrans" cxnId="{C5A31E1B-1939-A943-9EA9-0D1F931C9095}">
      <dgm:prSet/>
      <dgm:spPr/>
      <dgm:t>
        <a:bodyPr/>
        <a:lstStyle/>
        <a:p>
          <a:endParaRPr lang="en-US"/>
        </a:p>
      </dgm:t>
    </dgm:pt>
    <dgm:pt modelId="{AC89EDA2-97A0-704F-A224-66777968DC79}" type="parTrans" cxnId="{C5A31E1B-1939-A943-9EA9-0D1F931C9095}">
      <dgm:prSet/>
      <dgm:spPr/>
      <dgm:t>
        <a:bodyPr/>
        <a:lstStyle/>
        <a:p>
          <a:endParaRPr lang="en-US"/>
        </a:p>
      </dgm:t>
    </dgm:pt>
    <dgm:pt modelId="{418E94F4-4F87-154C-8C2C-4FA1854F2962}">
      <dgm:prSet/>
      <dgm:spPr/>
      <dgm:t>
        <a:bodyPr/>
        <a:lstStyle/>
        <a:p>
          <a:r>
            <a:rPr lang="en-US" dirty="0"/>
            <a:t>4</a:t>
          </a:r>
        </a:p>
      </dgm:t>
    </dgm:pt>
    <dgm:pt modelId="{A5C1BCA8-59E6-2D47-BF9C-24A0A56844F7}" type="sibTrans" cxnId="{2BBF3C50-1ED6-9847-B76B-936F9EDE5606}">
      <dgm:prSet/>
      <dgm:spPr/>
      <dgm:t>
        <a:bodyPr/>
        <a:lstStyle/>
        <a:p>
          <a:endParaRPr lang="en-US"/>
        </a:p>
      </dgm:t>
    </dgm:pt>
    <dgm:pt modelId="{67B29BF1-08A2-E04F-9D69-0598739CF13B}" type="parTrans" cxnId="{2BBF3C50-1ED6-9847-B76B-936F9EDE5606}">
      <dgm:prSet/>
      <dgm:spPr/>
      <dgm:t>
        <a:bodyPr/>
        <a:lstStyle/>
        <a:p>
          <a:endParaRPr lang="en-US"/>
        </a:p>
      </dgm:t>
    </dgm:pt>
    <dgm:pt modelId="{73A345CE-36FD-894D-BBC6-F1148569A643}">
      <dgm:prSet phldrT="[Text]"/>
      <dgm:spPr/>
      <dgm:t>
        <a:bodyPr/>
        <a:lstStyle/>
        <a:p>
          <a:r>
            <a:rPr lang="en-US" dirty="0"/>
            <a:t>3</a:t>
          </a:r>
        </a:p>
      </dgm:t>
    </dgm:pt>
    <dgm:pt modelId="{7A99C83F-BC00-3743-81E8-552BD253CEC3}" type="sibTrans" cxnId="{408ED183-BF58-1C4B-97FD-732582625FEF}">
      <dgm:prSet/>
      <dgm:spPr/>
      <dgm:t>
        <a:bodyPr/>
        <a:lstStyle/>
        <a:p>
          <a:endParaRPr lang="en-US"/>
        </a:p>
      </dgm:t>
    </dgm:pt>
    <dgm:pt modelId="{E3B27BD6-FBE2-5640-8D4A-26A5222CC3EA}" type="parTrans" cxnId="{408ED183-BF58-1C4B-97FD-732582625FEF}">
      <dgm:prSet/>
      <dgm:spPr/>
      <dgm:t>
        <a:bodyPr/>
        <a:lstStyle/>
        <a:p>
          <a:endParaRPr lang="en-US"/>
        </a:p>
      </dgm:t>
    </dgm:pt>
    <dgm:pt modelId="{D03F059F-5021-1F40-A19F-9647158C52AD}">
      <dgm:prSet phldrT="[Text]"/>
      <dgm:spPr/>
      <dgm:t>
        <a:bodyPr/>
        <a:lstStyle/>
        <a:p>
          <a:r>
            <a:rPr lang="en-US" dirty="0"/>
            <a:t>2</a:t>
          </a:r>
        </a:p>
      </dgm:t>
    </dgm:pt>
    <dgm:pt modelId="{294C2440-29C3-A948-ADDD-2D4D34880BDD}" type="sibTrans" cxnId="{65CEA44F-9E16-EA4E-A309-EC3B3016297A}">
      <dgm:prSet/>
      <dgm:spPr/>
      <dgm:t>
        <a:bodyPr/>
        <a:lstStyle/>
        <a:p>
          <a:endParaRPr lang="en-US"/>
        </a:p>
      </dgm:t>
    </dgm:pt>
    <dgm:pt modelId="{CF000D09-B476-0444-AE02-AACE5A32ABB9}" type="parTrans" cxnId="{65CEA44F-9E16-EA4E-A309-EC3B3016297A}">
      <dgm:prSet/>
      <dgm:spPr/>
      <dgm:t>
        <a:bodyPr/>
        <a:lstStyle/>
        <a:p>
          <a:endParaRPr lang="en-US"/>
        </a:p>
      </dgm:t>
    </dgm:pt>
    <dgm:pt modelId="{C651D352-06FA-1B42-81FF-A95099FE5645}" type="pres">
      <dgm:prSet presAssocID="{CE7EC2B3-709C-7049-AC98-40D647A08CD5}" presName="Name0" presStyleCnt="0">
        <dgm:presLayoutVars>
          <dgm:dir/>
          <dgm:animLvl val="lvl"/>
          <dgm:resizeHandles val="exact"/>
        </dgm:presLayoutVars>
      </dgm:prSet>
      <dgm:spPr/>
    </dgm:pt>
    <dgm:pt modelId="{2E2FEDEA-0CB5-FD4B-8718-95B9D6A14304}" type="pres">
      <dgm:prSet presAssocID="{54EB0C78-47D0-4144-BBA1-ED83F2276A80}" presName="linNode" presStyleCnt="0"/>
      <dgm:spPr/>
    </dgm:pt>
    <dgm:pt modelId="{2F0271A3-745A-A943-B67B-E4069A93AE61}" type="pres">
      <dgm:prSet presAssocID="{54EB0C78-47D0-4144-BBA1-ED83F2276A80}" presName="parentText" presStyleLbl="node1" presStyleIdx="0" presStyleCnt="8" custScaleX="67001">
        <dgm:presLayoutVars>
          <dgm:chMax val="1"/>
          <dgm:bulletEnabled val="1"/>
        </dgm:presLayoutVars>
      </dgm:prSet>
      <dgm:spPr/>
    </dgm:pt>
    <dgm:pt modelId="{21D64796-42C1-6A47-B16B-F23C35A117FF}" type="pres">
      <dgm:prSet presAssocID="{54EB0C78-47D0-4144-BBA1-ED83F2276A80}" presName="descendantText" presStyleLbl="alignAccFollowNode1" presStyleIdx="0" presStyleCnt="8">
        <dgm:presLayoutVars>
          <dgm:bulletEnabled val="1"/>
        </dgm:presLayoutVars>
      </dgm:prSet>
      <dgm:spPr/>
    </dgm:pt>
    <dgm:pt modelId="{B2C4C361-6A0B-BC45-90FD-318B0EB08F6D}" type="pres">
      <dgm:prSet presAssocID="{E8376F97-8FAC-AA43-868D-BB3E335B92F2}" presName="sp" presStyleCnt="0"/>
      <dgm:spPr/>
    </dgm:pt>
    <dgm:pt modelId="{277D1FDC-6CD3-BB41-8E20-960C658417CF}" type="pres">
      <dgm:prSet presAssocID="{D03F059F-5021-1F40-A19F-9647158C52AD}" presName="linNode" presStyleCnt="0"/>
      <dgm:spPr/>
    </dgm:pt>
    <dgm:pt modelId="{6CEBA26E-9501-3E41-ACBB-39C96B19A924}" type="pres">
      <dgm:prSet presAssocID="{D03F059F-5021-1F40-A19F-9647158C52AD}" presName="parentText" presStyleLbl="node1" presStyleIdx="1" presStyleCnt="8" custScaleX="67001">
        <dgm:presLayoutVars>
          <dgm:chMax val="1"/>
          <dgm:bulletEnabled val="1"/>
        </dgm:presLayoutVars>
      </dgm:prSet>
      <dgm:spPr/>
    </dgm:pt>
    <dgm:pt modelId="{2EB4DD27-0645-2048-89E9-55CE50FE52DA}" type="pres">
      <dgm:prSet presAssocID="{D03F059F-5021-1F40-A19F-9647158C52AD}" presName="descendantText" presStyleLbl="alignAccFollowNode1" presStyleIdx="1" presStyleCnt="8">
        <dgm:presLayoutVars>
          <dgm:bulletEnabled val="1"/>
        </dgm:presLayoutVars>
      </dgm:prSet>
      <dgm:spPr/>
    </dgm:pt>
    <dgm:pt modelId="{33CCAA17-6648-4F4C-9AC2-5ECE7EDB6E70}" type="pres">
      <dgm:prSet presAssocID="{294C2440-29C3-A948-ADDD-2D4D34880BDD}" presName="sp" presStyleCnt="0"/>
      <dgm:spPr/>
    </dgm:pt>
    <dgm:pt modelId="{B97FC210-8EA1-614A-91AB-916C1AEFBDEE}" type="pres">
      <dgm:prSet presAssocID="{73A345CE-36FD-894D-BBC6-F1148569A643}" presName="linNode" presStyleCnt="0"/>
      <dgm:spPr/>
    </dgm:pt>
    <dgm:pt modelId="{A3A63788-1227-B240-AFF4-87DA3887717D}" type="pres">
      <dgm:prSet presAssocID="{73A345CE-36FD-894D-BBC6-F1148569A643}" presName="parentText" presStyleLbl="node1" presStyleIdx="2" presStyleCnt="8" custScaleX="67001">
        <dgm:presLayoutVars>
          <dgm:chMax val="1"/>
          <dgm:bulletEnabled val="1"/>
        </dgm:presLayoutVars>
      </dgm:prSet>
      <dgm:spPr/>
    </dgm:pt>
    <dgm:pt modelId="{5432570E-A980-7C49-B78B-FBD7E95247D6}" type="pres">
      <dgm:prSet presAssocID="{73A345CE-36FD-894D-BBC6-F1148569A643}" presName="descendantText" presStyleLbl="alignAccFollowNode1" presStyleIdx="2" presStyleCnt="8">
        <dgm:presLayoutVars>
          <dgm:bulletEnabled val="1"/>
        </dgm:presLayoutVars>
      </dgm:prSet>
      <dgm:spPr/>
    </dgm:pt>
    <dgm:pt modelId="{3E055F9F-21A2-424C-8A4E-65EE89C8A916}" type="pres">
      <dgm:prSet presAssocID="{7A99C83F-BC00-3743-81E8-552BD253CEC3}" presName="sp" presStyleCnt="0"/>
      <dgm:spPr/>
    </dgm:pt>
    <dgm:pt modelId="{3D7F3715-4665-FB42-B9D8-1FF06FE7ED04}" type="pres">
      <dgm:prSet presAssocID="{418E94F4-4F87-154C-8C2C-4FA1854F2962}" presName="linNode" presStyleCnt="0"/>
      <dgm:spPr/>
    </dgm:pt>
    <dgm:pt modelId="{F459C834-8503-9C47-9E88-19B5B264D39A}" type="pres">
      <dgm:prSet presAssocID="{418E94F4-4F87-154C-8C2C-4FA1854F2962}" presName="parentText" presStyleLbl="node1" presStyleIdx="3" presStyleCnt="8" custScaleX="67001">
        <dgm:presLayoutVars>
          <dgm:chMax val="1"/>
          <dgm:bulletEnabled val="1"/>
        </dgm:presLayoutVars>
      </dgm:prSet>
      <dgm:spPr/>
    </dgm:pt>
    <dgm:pt modelId="{B11406A9-5BCB-7247-9C38-2B1D2505F2B8}" type="pres">
      <dgm:prSet presAssocID="{418E94F4-4F87-154C-8C2C-4FA1854F2962}" presName="descendantText" presStyleLbl="alignAccFollowNode1" presStyleIdx="3" presStyleCnt="8">
        <dgm:presLayoutVars>
          <dgm:bulletEnabled val="1"/>
        </dgm:presLayoutVars>
      </dgm:prSet>
      <dgm:spPr/>
    </dgm:pt>
    <dgm:pt modelId="{E355AC6F-4099-CB47-B889-4B740E437363}" type="pres">
      <dgm:prSet presAssocID="{A5C1BCA8-59E6-2D47-BF9C-24A0A56844F7}" presName="sp" presStyleCnt="0"/>
      <dgm:spPr/>
    </dgm:pt>
    <dgm:pt modelId="{A60CA7D8-39CB-954A-95BD-9B247DA4C063}" type="pres">
      <dgm:prSet presAssocID="{827957E1-E296-1C4F-A5F6-1C5FE324A00C}" presName="linNode" presStyleCnt="0"/>
      <dgm:spPr/>
    </dgm:pt>
    <dgm:pt modelId="{4D3677DD-203E-6A46-986E-4A5C658C9303}" type="pres">
      <dgm:prSet presAssocID="{827957E1-E296-1C4F-A5F6-1C5FE324A00C}" presName="parentText" presStyleLbl="node1" presStyleIdx="4" presStyleCnt="8" custScaleX="67001">
        <dgm:presLayoutVars>
          <dgm:chMax val="1"/>
          <dgm:bulletEnabled val="1"/>
        </dgm:presLayoutVars>
      </dgm:prSet>
      <dgm:spPr/>
    </dgm:pt>
    <dgm:pt modelId="{DF481026-182D-AB4B-A938-B9E12915351D}" type="pres">
      <dgm:prSet presAssocID="{827957E1-E296-1C4F-A5F6-1C5FE324A00C}" presName="descendantText" presStyleLbl="alignAccFollowNode1" presStyleIdx="4" presStyleCnt="8">
        <dgm:presLayoutVars>
          <dgm:bulletEnabled val="1"/>
        </dgm:presLayoutVars>
      </dgm:prSet>
      <dgm:spPr/>
    </dgm:pt>
    <dgm:pt modelId="{0E9316E9-2C30-AB47-AE90-7E8E046E1AFD}" type="pres">
      <dgm:prSet presAssocID="{9F52F0F0-B16C-AB44-86AF-35AA79D5B0BB}" presName="sp" presStyleCnt="0"/>
      <dgm:spPr/>
    </dgm:pt>
    <dgm:pt modelId="{037794A2-D322-8E40-B011-CE07ECE52AD6}" type="pres">
      <dgm:prSet presAssocID="{9F6E5C8F-12F1-3545-94A6-291C5042E69E}" presName="linNode" presStyleCnt="0"/>
      <dgm:spPr/>
    </dgm:pt>
    <dgm:pt modelId="{B6C279C8-1B63-3845-ADAB-B82AEFA3D8E4}" type="pres">
      <dgm:prSet presAssocID="{9F6E5C8F-12F1-3545-94A6-291C5042E69E}" presName="parentText" presStyleLbl="node1" presStyleIdx="5" presStyleCnt="8" custScaleX="67001">
        <dgm:presLayoutVars>
          <dgm:chMax val="1"/>
          <dgm:bulletEnabled val="1"/>
        </dgm:presLayoutVars>
      </dgm:prSet>
      <dgm:spPr/>
    </dgm:pt>
    <dgm:pt modelId="{95DA0D8B-BC89-0948-909A-C298332DBD75}" type="pres">
      <dgm:prSet presAssocID="{9F6E5C8F-12F1-3545-94A6-291C5042E69E}" presName="descendantText" presStyleLbl="alignAccFollowNode1" presStyleIdx="5" presStyleCnt="8">
        <dgm:presLayoutVars>
          <dgm:bulletEnabled val="1"/>
        </dgm:presLayoutVars>
      </dgm:prSet>
      <dgm:spPr/>
    </dgm:pt>
    <dgm:pt modelId="{05C8E7F6-EE84-404A-A830-A5238A04D5A3}" type="pres">
      <dgm:prSet presAssocID="{F501E3C1-886B-5244-A7B1-7A80D72A4D8C}" presName="sp" presStyleCnt="0"/>
      <dgm:spPr/>
    </dgm:pt>
    <dgm:pt modelId="{450D1F74-F684-8F4C-A8B3-6F8B553AB682}" type="pres">
      <dgm:prSet presAssocID="{02BDF100-8338-E043-96F5-EE898B9D5AB2}" presName="linNode" presStyleCnt="0"/>
      <dgm:spPr/>
    </dgm:pt>
    <dgm:pt modelId="{B67BA8B7-08DC-C244-8300-FCD547033DBD}" type="pres">
      <dgm:prSet presAssocID="{02BDF100-8338-E043-96F5-EE898B9D5AB2}" presName="parentText" presStyleLbl="node1" presStyleIdx="6" presStyleCnt="8" custScaleX="67001">
        <dgm:presLayoutVars>
          <dgm:chMax val="1"/>
          <dgm:bulletEnabled val="1"/>
        </dgm:presLayoutVars>
      </dgm:prSet>
      <dgm:spPr/>
    </dgm:pt>
    <dgm:pt modelId="{9D2B4FF6-13FB-EF49-977A-31DF5EE58099}" type="pres">
      <dgm:prSet presAssocID="{02BDF100-8338-E043-96F5-EE898B9D5AB2}" presName="descendantText" presStyleLbl="alignAccFollowNode1" presStyleIdx="6" presStyleCnt="8">
        <dgm:presLayoutVars>
          <dgm:bulletEnabled val="1"/>
        </dgm:presLayoutVars>
      </dgm:prSet>
      <dgm:spPr/>
    </dgm:pt>
    <dgm:pt modelId="{580F7313-AC0F-FA49-A45E-0C9486F52D6E}" type="pres">
      <dgm:prSet presAssocID="{BCE247F3-63ED-824C-BC43-9D645F88694B}" presName="sp" presStyleCnt="0"/>
      <dgm:spPr/>
    </dgm:pt>
    <dgm:pt modelId="{E737A561-EB87-EC46-B404-0D8CDB0DE287}" type="pres">
      <dgm:prSet presAssocID="{7CF6944D-D814-F446-BDE2-B55C1C344687}" presName="linNode" presStyleCnt="0"/>
      <dgm:spPr/>
    </dgm:pt>
    <dgm:pt modelId="{D5D04DA4-D0C2-DE47-8C8C-0B8EFFA304FE}" type="pres">
      <dgm:prSet presAssocID="{7CF6944D-D814-F446-BDE2-B55C1C344687}" presName="parentText" presStyleLbl="node1" presStyleIdx="7" presStyleCnt="8" custScaleX="67001">
        <dgm:presLayoutVars>
          <dgm:chMax val="1"/>
          <dgm:bulletEnabled val="1"/>
        </dgm:presLayoutVars>
      </dgm:prSet>
      <dgm:spPr/>
    </dgm:pt>
    <dgm:pt modelId="{8CF3EAF4-8574-9841-9B3E-4FBF8CB57172}" type="pres">
      <dgm:prSet presAssocID="{7CF6944D-D814-F446-BDE2-B55C1C344687}" presName="descendantText" presStyleLbl="alignAccFollowNode1" presStyleIdx="7" presStyleCnt="8">
        <dgm:presLayoutVars>
          <dgm:bulletEnabled val="1"/>
        </dgm:presLayoutVars>
      </dgm:prSet>
      <dgm:spPr/>
    </dgm:pt>
  </dgm:ptLst>
  <dgm:cxnLst>
    <dgm:cxn modelId="{E4273A05-E6BD-7B48-BAB7-FF2C885BDD30}" type="presOf" srcId="{02BDF100-8338-E043-96F5-EE898B9D5AB2}" destId="{B67BA8B7-08DC-C244-8300-FCD547033DBD}" srcOrd="0" destOrd="0" presId="urn:microsoft.com/office/officeart/2005/8/layout/vList5"/>
    <dgm:cxn modelId="{E9D1E10C-1628-524C-9321-D84C071FF74D}" type="presOf" srcId="{CE7EC2B3-709C-7049-AC98-40D647A08CD5}" destId="{C651D352-06FA-1B42-81FF-A95099FE5645}" srcOrd="0" destOrd="0" presId="urn:microsoft.com/office/officeart/2005/8/layout/vList5"/>
    <dgm:cxn modelId="{C4160712-DF53-0F4F-9BBA-78BD9BBF4B88}" type="presOf" srcId="{77E26394-E137-5E44-9434-AC75CD3E8E1C}" destId="{B11406A9-5BCB-7247-9C38-2B1D2505F2B8}" srcOrd="0" destOrd="0" presId="urn:microsoft.com/office/officeart/2005/8/layout/vList5"/>
    <dgm:cxn modelId="{C5A31E1B-1939-A943-9EA9-0D1F931C9095}" srcId="{CE7EC2B3-709C-7049-AC98-40D647A08CD5}" destId="{827957E1-E296-1C4F-A5F6-1C5FE324A00C}" srcOrd="4" destOrd="0" parTransId="{AC89EDA2-97A0-704F-A224-66777968DC79}" sibTransId="{9F52F0F0-B16C-AB44-86AF-35AA79D5B0BB}"/>
    <dgm:cxn modelId="{086EAA1D-3224-4E41-87B1-9FA27037DE47}" type="presOf" srcId="{9F6E5C8F-12F1-3545-94A6-291C5042E69E}" destId="{B6C279C8-1B63-3845-ADAB-B82AEFA3D8E4}" srcOrd="0" destOrd="0" presId="urn:microsoft.com/office/officeart/2005/8/layout/vList5"/>
    <dgm:cxn modelId="{71BBC71D-E55C-424F-B6C9-6E507D91D4E5}" type="presOf" srcId="{D6BB4A41-00B2-5448-BB3F-80605AC75A4E}" destId="{95DA0D8B-BC89-0948-909A-C298332DBD75}" srcOrd="0" destOrd="0" presId="urn:microsoft.com/office/officeart/2005/8/layout/vList5"/>
    <dgm:cxn modelId="{7A4CD21E-5C30-9844-B8CC-04D4CC71350C}" type="presOf" srcId="{4042EA18-93B7-8447-AC0A-58BAED6135AA}" destId="{8CF3EAF4-8574-9841-9B3E-4FBF8CB57172}" srcOrd="0" destOrd="0" presId="urn:microsoft.com/office/officeart/2005/8/layout/vList5"/>
    <dgm:cxn modelId="{EA0CCB2E-33A7-7842-AF42-FDB163C3A0DB}" type="presOf" srcId="{8E966A69-49F1-5E4B-B606-FCAEDAA984ED}" destId="{2EB4DD27-0645-2048-89E9-55CE50FE52DA}" srcOrd="0" destOrd="0" presId="urn:microsoft.com/office/officeart/2005/8/layout/vList5"/>
    <dgm:cxn modelId="{65CEA44F-9E16-EA4E-A309-EC3B3016297A}" srcId="{CE7EC2B3-709C-7049-AC98-40D647A08CD5}" destId="{D03F059F-5021-1F40-A19F-9647158C52AD}" srcOrd="1" destOrd="0" parTransId="{CF000D09-B476-0444-AE02-AACE5A32ABB9}" sibTransId="{294C2440-29C3-A948-ADDD-2D4D34880BDD}"/>
    <dgm:cxn modelId="{2BBF3C50-1ED6-9847-B76B-936F9EDE5606}" srcId="{CE7EC2B3-709C-7049-AC98-40D647A08CD5}" destId="{418E94F4-4F87-154C-8C2C-4FA1854F2962}" srcOrd="3" destOrd="0" parTransId="{67B29BF1-08A2-E04F-9D69-0598739CF13B}" sibTransId="{A5C1BCA8-59E6-2D47-BF9C-24A0A56844F7}"/>
    <dgm:cxn modelId="{3055A850-65BD-2C48-A538-0AAEB9138E85}" srcId="{418E94F4-4F87-154C-8C2C-4FA1854F2962}" destId="{77E26394-E137-5E44-9434-AC75CD3E8E1C}" srcOrd="0" destOrd="0" parTransId="{0106416C-C608-3E4B-95A9-3A27F212EF0D}" sibTransId="{4162CFAB-B676-8E4E-8FEB-32BD16B62DEC}"/>
    <dgm:cxn modelId="{B3273152-AF0F-EE4B-8C28-8B1E95E5CD89}" type="presOf" srcId="{E900B89A-C42B-5249-B68C-A3D7ECDC2722}" destId="{5432570E-A980-7C49-B78B-FBD7E95247D6}" srcOrd="0" destOrd="0" presId="urn:microsoft.com/office/officeart/2005/8/layout/vList5"/>
    <dgm:cxn modelId="{90712D57-061F-8444-BA8A-D8DA5E4630C5}" type="presOf" srcId="{73A345CE-36FD-894D-BBC6-F1148569A643}" destId="{A3A63788-1227-B240-AFF4-87DA3887717D}" srcOrd="0" destOrd="0" presId="urn:microsoft.com/office/officeart/2005/8/layout/vList5"/>
    <dgm:cxn modelId="{B4BAA057-82A7-8F4F-B3AE-D2474B9F0D61}" srcId="{CE7EC2B3-709C-7049-AC98-40D647A08CD5}" destId="{7CF6944D-D814-F446-BDE2-B55C1C344687}" srcOrd="7" destOrd="0" parTransId="{18766106-4E88-954F-80B4-8435CD7E3607}" sibTransId="{41CA9CD1-BD05-D240-8585-F6D044F469D5}"/>
    <dgm:cxn modelId="{BAD62360-A798-6A47-A994-B5126C6DDBBA}" type="presOf" srcId="{D57A6E2B-1DF9-5046-BC1D-709A01F64D7F}" destId="{21D64796-42C1-6A47-B16B-F23C35A117FF}" srcOrd="0" destOrd="0" presId="urn:microsoft.com/office/officeart/2005/8/layout/vList5"/>
    <dgm:cxn modelId="{F6183E77-6BBF-FA47-854D-F0D53AE21A8A}" srcId="{CE7EC2B3-709C-7049-AC98-40D647A08CD5}" destId="{02BDF100-8338-E043-96F5-EE898B9D5AB2}" srcOrd="6" destOrd="0" parTransId="{1B53CCA0-CFF2-384B-856E-1EBDFA4D02AD}" sibTransId="{BCE247F3-63ED-824C-BC43-9D645F88694B}"/>
    <dgm:cxn modelId="{89198578-5DCB-6140-878F-E9FD8D67271F}" type="presOf" srcId="{7CF6944D-D814-F446-BDE2-B55C1C344687}" destId="{D5D04DA4-D0C2-DE47-8C8C-0B8EFFA304FE}" srcOrd="0" destOrd="0" presId="urn:microsoft.com/office/officeart/2005/8/layout/vList5"/>
    <dgm:cxn modelId="{408ED183-BF58-1C4B-97FD-732582625FEF}" srcId="{CE7EC2B3-709C-7049-AC98-40D647A08CD5}" destId="{73A345CE-36FD-894D-BBC6-F1148569A643}" srcOrd="2" destOrd="0" parTransId="{E3B27BD6-FBE2-5640-8D4A-26A5222CC3EA}" sibTransId="{7A99C83F-BC00-3743-81E8-552BD253CEC3}"/>
    <dgm:cxn modelId="{B2C59790-5949-8740-B37D-5567793C306C}" srcId="{54EB0C78-47D0-4144-BBA1-ED83F2276A80}" destId="{D57A6E2B-1DF9-5046-BC1D-709A01F64D7F}" srcOrd="0" destOrd="0" parTransId="{C76AEE8B-D94A-7D44-B03A-3FE0785274DD}" sibTransId="{55132C62-F393-2540-A3F5-1E79E69F36CF}"/>
    <dgm:cxn modelId="{2D83CF9B-C8D2-5645-B148-7557D123AE42}" type="presOf" srcId="{827957E1-E296-1C4F-A5F6-1C5FE324A00C}" destId="{4D3677DD-203E-6A46-986E-4A5C658C9303}" srcOrd="0" destOrd="0" presId="urn:microsoft.com/office/officeart/2005/8/layout/vList5"/>
    <dgm:cxn modelId="{D734F3A8-F28E-EC4B-833E-A76A8DF839E2}" type="presOf" srcId="{D03F059F-5021-1F40-A19F-9647158C52AD}" destId="{6CEBA26E-9501-3E41-ACBB-39C96B19A924}" srcOrd="0" destOrd="0" presId="urn:microsoft.com/office/officeart/2005/8/layout/vList5"/>
    <dgm:cxn modelId="{8EA459AB-225B-8C4D-9825-5D1C6BF10277}" srcId="{73A345CE-36FD-894D-BBC6-F1148569A643}" destId="{E900B89A-C42B-5249-B68C-A3D7ECDC2722}" srcOrd="0" destOrd="0" parTransId="{8E839505-C7B5-E846-B572-409C6E14F87D}" sibTransId="{1CCB8A03-5593-CE44-86BA-AACEAE0CCB98}"/>
    <dgm:cxn modelId="{54AEA8B7-F89B-724F-98A1-0AEC5D7FC3A2}" srcId="{CE7EC2B3-709C-7049-AC98-40D647A08CD5}" destId="{54EB0C78-47D0-4144-BBA1-ED83F2276A80}" srcOrd="0" destOrd="0" parTransId="{46A28A5B-8A7C-BF49-A5DC-996D874F74B0}" sibTransId="{E8376F97-8FAC-AA43-868D-BB3E335B92F2}"/>
    <dgm:cxn modelId="{D85391B8-F585-FD43-82E0-8ACB9B810BF4}" srcId="{827957E1-E296-1C4F-A5F6-1C5FE324A00C}" destId="{B3ABDBBC-28C2-CC44-9EA0-940A074F9BF0}" srcOrd="0" destOrd="0" parTransId="{D1297B60-D255-DA44-8D75-399213932CFB}" sibTransId="{B1A1C092-087B-F241-9B26-AD1D13C72D4D}"/>
    <dgm:cxn modelId="{DF1A41C0-D8B8-6D4F-A8A5-91EC68AFBCAD}" srcId="{9F6E5C8F-12F1-3545-94A6-291C5042E69E}" destId="{D6BB4A41-00B2-5448-BB3F-80605AC75A4E}" srcOrd="0" destOrd="0" parTransId="{4E04882C-8060-1D42-8502-5D210AA0DCD3}" sibTransId="{A3F6C628-648D-0249-B65F-551AF9ECEEA6}"/>
    <dgm:cxn modelId="{F2E046C8-391B-6946-ACE6-697EC224AB98}" type="presOf" srcId="{B3ABDBBC-28C2-CC44-9EA0-940A074F9BF0}" destId="{DF481026-182D-AB4B-A938-B9E12915351D}" srcOrd="0" destOrd="0" presId="urn:microsoft.com/office/officeart/2005/8/layout/vList5"/>
    <dgm:cxn modelId="{E2BB9BC9-6DB1-9443-8E35-6250A99E4AD7}" srcId="{02BDF100-8338-E043-96F5-EE898B9D5AB2}" destId="{0545D5E0-C6B3-A447-B001-E955BFE39730}" srcOrd="0" destOrd="0" parTransId="{74548467-254B-2943-9A99-08C07F3E448D}" sibTransId="{43A03E68-4CAE-A344-B58C-38B13B6EE776}"/>
    <dgm:cxn modelId="{A16837DB-2A15-1C45-807B-67AB4EF8E75E}" type="presOf" srcId="{0545D5E0-C6B3-A447-B001-E955BFE39730}" destId="{9D2B4FF6-13FB-EF49-977A-31DF5EE58099}" srcOrd="0" destOrd="0" presId="urn:microsoft.com/office/officeart/2005/8/layout/vList5"/>
    <dgm:cxn modelId="{BBBA16DC-BC73-8048-A725-FE1EF1BF6593}" srcId="{7CF6944D-D814-F446-BDE2-B55C1C344687}" destId="{4042EA18-93B7-8447-AC0A-58BAED6135AA}" srcOrd="0" destOrd="0" parTransId="{2F5CB061-56DE-EB4D-BFD4-36B00E6055CB}" sibTransId="{A608511D-1BB9-EB4E-9E74-CCD7B0DB861D}"/>
    <dgm:cxn modelId="{545F95DE-9A10-3948-9807-36C195D34A35}" srcId="{CE7EC2B3-709C-7049-AC98-40D647A08CD5}" destId="{9F6E5C8F-12F1-3545-94A6-291C5042E69E}" srcOrd="5" destOrd="0" parTransId="{F878F1E0-BA83-0B4F-8407-D69A3E0606E8}" sibTransId="{F501E3C1-886B-5244-A7B1-7A80D72A4D8C}"/>
    <dgm:cxn modelId="{1AC639E1-2DD4-8C49-9596-C5731579DC3A}" type="presOf" srcId="{54EB0C78-47D0-4144-BBA1-ED83F2276A80}" destId="{2F0271A3-745A-A943-B67B-E4069A93AE61}" srcOrd="0" destOrd="0" presId="urn:microsoft.com/office/officeart/2005/8/layout/vList5"/>
    <dgm:cxn modelId="{FBB45EE4-904A-AF48-A0C9-CB655E66EF52}" srcId="{D03F059F-5021-1F40-A19F-9647158C52AD}" destId="{8E966A69-49F1-5E4B-B606-FCAEDAA984ED}" srcOrd="0" destOrd="0" parTransId="{DBAD8E5C-BD8A-8D4C-B4F0-8493200D7696}" sibTransId="{6E022D76-54D3-5040-BFB1-6E3CF648085C}"/>
    <dgm:cxn modelId="{CE4D51EC-1171-9740-9774-3550157EF9C1}" type="presOf" srcId="{418E94F4-4F87-154C-8C2C-4FA1854F2962}" destId="{F459C834-8503-9C47-9E88-19B5B264D39A}" srcOrd="0" destOrd="0" presId="urn:microsoft.com/office/officeart/2005/8/layout/vList5"/>
    <dgm:cxn modelId="{BF236B13-02D1-B64C-986F-0CAF7E0612E5}" type="presParOf" srcId="{C651D352-06FA-1B42-81FF-A95099FE5645}" destId="{2E2FEDEA-0CB5-FD4B-8718-95B9D6A14304}" srcOrd="0" destOrd="0" presId="urn:microsoft.com/office/officeart/2005/8/layout/vList5"/>
    <dgm:cxn modelId="{9578A504-AB23-5044-A923-D3DEFAE4D5E7}" type="presParOf" srcId="{2E2FEDEA-0CB5-FD4B-8718-95B9D6A14304}" destId="{2F0271A3-745A-A943-B67B-E4069A93AE61}" srcOrd="0" destOrd="0" presId="urn:microsoft.com/office/officeart/2005/8/layout/vList5"/>
    <dgm:cxn modelId="{253C94D8-1885-B543-AF3D-F6A1DD424873}" type="presParOf" srcId="{2E2FEDEA-0CB5-FD4B-8718-95B9D6A14304}" destId="{21D64796-42C1-6A47-B16B-F23C35A117FF}" srcOrd="1" destOrd="0" presId="urn:microsoft.com/office/officeart/2005/8/layout/vList5"/>
    <dgm:cxn modelId="{C06B9A2B-4F20-7C45-806D-5E7956B4F171}" type="presParOf" srcId="{C651D352-06FA-1B42-81FF-A95099FE5645}" destId="{B2C4C361-6A0B-BC45-90FD-318B0EB08F6D}" srcOrd="1" destOrd="0" presId="urn:microsoft.com/office/officeart/2005/8/layout/vList5"/>
    <dgm:cxn modelId="{7BF712B5-32BC-7844-BF86-9BFE0BE03182}" type="presParOf" srcId="{C651D352-06FA-1B42-81FF-A95099FE5645}" destId="{277D1FDC-6CD3-BB41-8E20-960C658417CF}" srcOrd="2" destOrd="0" presId="urn:microsoft.com/office/officeart/2005/8/layout/vList5"/>
    <dgm:cxn modelId="{8EE30A21-17AC-A34E-A945-33D32D0CD928}" type="presParOf" srcId="{277D1FDC-6CD3-BB41-8E20-960C658417CF}" destId="{6CEBA26E-9501-3E41-ACBB-39C96B19A924}" srcOrd="0" destOrd="0" presId="urn:microsoft.com/office/officeart/2005/8/layout/vList5"/>
    <dgm:cxn modelId="{3CCA96C7-C68E-DA49-A8B4-DD728A5A5A21}" type="presParOf" srcId="{277D1FDC-6CD3-BB41-8E20-960C658417CF}" destId="{2EB4DD27-0645-2048-89E9-55CE50FE52DA}" srcOrd="1" destOrd="0" presId="urn:microsoft.com/office/officeart/2005/8/layout/vList5"/>
    <dgm:cxn modelId="{4AF2BADF-B9C1-834B-AC41-60901F7D6D95}" type="presParOf" srcId="{C651D352-06FA-1B42-81FF-A95099FE5645}" destId="{33CCAA17-6648-4F4C-9AC2-5ECE7EDB6E70}" srcOrd="3" destOrd="0" presId="urn:microsoft.com/office/officeart/2005/8/layout/vList5"/>
    <dgm:cxn modelId="{2A4E440E-B7D6-6B49-8318-F6B71A21E6CF}" type="presParOf" srcId="{C651D352-06FA-1B42-81FF-A95099FE5645}" destId="{B97FC210-8EA1-614A-91AB-916C1AEFBDEE}" srcOrd="4" destOrd="0" presId="urn:microsoft.com/office/officeart/2005/8/layout/vList5"/>
    <dgm:cxn modelId="{2BDD0334-A1D2-DC42-B9D1-68F24D23B5D5}" type="presParOf" srcId="{B97FC210-8EA1-614A-91AB-916C1AEFBDEE}" destId="{A3A63788-1227-B240-AFF4-87DA3887717D}" srcOrd="0" destOrd="0" presId="urn:microsoft.com/office/officeart/2005/8/layout/vList5"/>
    <dgm:cxn modelId="{C69877D5-79C1-9F4C-B7F4-8AD7D15754EE}" type="presParOf" srcId="{B97FC210-8EA1-614A-91AB-916C1AEFBDEE}" destId="{5432570E-A980-7C49-B78B-FBD7E95247D6}" srcOrd="1" destOrd="0" presId="urn:microsoft.com/office/officeart/2005/8/layout/vList5"/>
    <dgm:cxn modelId="{33ACEA31-C6CD-5547-BED3-2458723FCA4A}" type="presParOf" srcId="{C651D352-06FA-1B42-81FF-A95099FE5645}" destId="{3E055F9F-21A2-424C-8A4E-65EE89C8A916}" srcOrd="5" destOrd="0" presId="urn:microsoft.com/office/officeart/2005/8/layout/vList5"/>
    <dgm:cxn modelId="{A37DA9BE-A47E-BB4D-9CC1-632CE186629D}" type="presParOf" srcId="{C651D352-06FA-1B42-81FF-A95099FE5645}" destId="{3D7F3715-4665-FB42-B9D8-1FF06FE7ED04}" srcOrd="6" destOrd="0" presId="urn:microsoft.com/office/officeart/2005/8/layout/vList5"/>
    <dgm:cxn modelId="{C891109C-0686-B74F-8141-60300585C701}" type="presParOf" srcId="{3D7F3715-4665-FB42-B9D8-1FF06FE7ED04}" destId="{F459C834-8503-9C47-9E88-19B5B264D39A}" srcOrd="0" destOrd="0" presId="urn:microsoft.com/office/officeart/2005/8/layout/vList5"/>
    <dgm:cxn modelId="{2F31821D-0811-794B-B121-3DE9146709AD}" type="presParOf" srcId="{3D7F3715-4665-FB42-B9D8-1FF06FE7ED04}" destId="{B11406A9-5BCB-7247-9C38-2B1D2505F2B8}" srcOrd="1" destOrd="0" presId="urn:microsoft.com/office/officeart/2005/8/layout/vList5"/>
    <dgm:cxn modelId="{0F8FFFCC-28B5-A844-A0C0-4277188A3AC8}" type="presParOf" srcId="{C651D352-06FA-1B42-81FF-A95099FE5645}" destId="{E355AC6F-4099-CB47-B889-4B740E437363}" srcOrd="7" destOrd="0" presId="urn:microsoft.com/office/officeart/2005/8/layout/vList5"/>
    <dgm:cxn modelId="{53EF242F-1951-6046-AB59-C18248626329}" type="presParOf" srcId="{C651D352-06FA-1B42-81FF-A95099FE5645}" destId="{A60CA7D8-39CB-954A-95BD-9B247DA4C063}" srcOrd="8" destOrd="0" presId="urn:microsoft.com/office/officeart/2005/8/layout/vList5"/>
    <dgm:cxn modelId="{ED3BF37E-4F96-D544-B638-C0AB83F1A9B4}" type="presParOf" srcId="{A60CA7D8-39CB-954A-95BD-9B247DA4C063}" destId="{4D3677DD-203E-6A46-986E-4A5C658C9303}" srcOrd="0" destOrd="0" presId="urn:microsoft.com/office/officeart/2005/8/layout/vList5"/>
    <dgm:cxn modelId="{5F05AF10-2999-E74B-852A-D64954D94FF8}" type="presParOf" srcId="{A60CA7D8-39CB-954A-95BD-9B247DA4C063}" destId="{DF481026-182D-AB4B-A938-B9E12915351D}" srcOrd="1" destOrd="0" presId="urn:microsoft.com/office/officeart/2005/8/layout/vList5"/>
    <dgm:cxn modelId="{ACD94F81-0016-934D-9BD5-68D8F780E3B7}" type="presParOf" srcId="{C651D352-06FA-1B42-81FF-A95099FE5645}" destId="{0E9316E9-2C30-AB47-AE90-7E8E046E1AFD}" srcOrd="9" destOrd="0" presId="urn:microsoft.com/office/officeart/2005/8/layout/vList5"/>
    <dgm:cxn modelId="{F8E487A0-A252-584F-8A38-3822D4AF8219}" type="presParOf" srcId="{C651D352-06FA-1B42-81FF-A95099FE5645}" destId="{037794A2-D322-8E40-B011-CE07ECE52AD6}" srcOrd="10" destOrd="0" presId="urn:microsoft.com/office/officeart/2005/8/layout/vList5"/>
    <dgm:cxn modelId="{67548826-ED42-6242-AA6A-DBBB72691D13}" type="presParOf" srcId="{037794A2-D322-8E40-B011-CE07ECE52AD6}" destId="{B6C279C8-1B63-3845-ADAB-B82AEFA3D8E4}" srcOrd="0" destOrd="0" presId="urn:microsoft.com/office/officeart/2005/8/layout/vList5"/>
    <dgm:cxn modelId="{B87CE2C3-5909-4C4E-A75A-B68815D3150A}" type="presParOf" srcId="{037794A2-D322-8E40-B011-CE07ECE52AD6}" destId="{95DA0D8B-BC89-0948-909A-C298332DBD75}" srcOrd="1" destOrd="0" presId="urn:microsoft.com/office/officeart/2005/8/layout/vList5"/>
    <dgm:cxn modelId="{B702A7F2-2B11-8D48-B9AE-A25D0DE633A1}" type="presParOf" srcId="{C651D352-06FA-1B42-81FF-A95099FE5645}" destId="{05C8E7F6-EE84-404A-A830-A5238A04D5A3}" srcOrd="11" destOrd="0" presId="urn:microsoft.com/office/officeart/2005/8/layout/vList5"/>
    <dgm:cxn modelId="{5D36C750-8050-AB49-B923-84B64CB9D59C}" type="presParOf" srcId="{C651D352-06FA-1B42-81FF-A95099FE5645}" destId="{450D1F74-F684-8F4C-A8B3-6F8B553AB682}" srcOrd="12" destOrd="0" presId="urn:microsoft.com/office/officeart/2005/8/layout/vList5"/>
    <dgm:cxn modelId="{69DDD68C-0D88-6141-B93A-2DFC27495FCF}" type="presParOf" srcId="{450D1F74-F684-8F4C-A8B3-6F8B553AB682}" destId="{B67BA8B7-08DC-C244-8300-FCD547033DBD}" srcOrd="0" destOrd="0" presId="urn:microsoft.com/office/officeart/2005/8/layout/vList5"/>
    <dgm:cxn modelId="{772109BC-D0C5-5C47-B68B-C1F238D6D77F}" type="presParOf" srcId="{450D1F74-F684-8F4C-A8B3-6F8B553AB682}" destId="{9D2B4FF6-13FB-EF49-977A-31DF5EE58099}" srcOrd="1" destOrd="0" presId="urn:microsoft.com/office/officeart/2005/8/layout/vList5"/>
    <dgm:cxn modelId="{5EBAD0AC-A244-A44E-ADFB-53F20C58044C}" type="presParOf" srcId="{C651D352-06FA-1B42-81FF-A95099FE5645}" destId="{580F7313-AC0F-FA49-A45E-0C9486F52D6E}" srcOrd="13" destOrd="0" presId="urn:microsoft.com/office/officeart/2005/8/layout/vList5"/>
    <dgm:cxn modelId="{6E9922E5-478F-AF4D-9DCA-7A72508F4F6D}" type="presParOf" srcId="{C651D352-06FA-1B42-81FF-A95099FE5645}" destId="{E737A561-EB87-EC46-B404-0D8CDB0DE287}" srcOrd="14" destOrd="0" presId="urn:microsoft.com/office/officeart/2005/8/layout/vList5"/>
    <dgm:cxn modelId="{8E470ECC-4731-EF49-B2A8-AD4470B8AD53}" type="presParOf" srcId="{E737A561-EB87-EC46-B404-0D8CDB0DE287}" destId="{D5D04DA4-D0C2-DE47-8C8C-0B8EFFA304FE}" srcOrd="0" destOrd="0" presId="urn:microsoft.com/office/officeart/2005/8/layout/vList5"/>
    <dgm:cxn modelId="{B9608D4F-B546-F142-90CB-D6437FE05ACF}" type="presParOf" srcId="{E737A561-EB87-EC46-B404-0D8CDB0DE287}" destId="{8CF3EAF4-8574-9841-9B3E-4FBF8CB57172}"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FCDD7C81-9563-C84F-A588-E11178385414}" type="doc">
      <dgm:prSet loTypeId="urn:microsoft.com/office/officeart/2005/8/layout/hierarchy1" loCatId="" qsTypeId="urn:microsoft.com/office/officeart/2005/8/quickstyle/simple1" qsCatId="simple" csTypeId="urn:microsoft.com/office/officeart/2005/8/colors/accent1_2" csCatId="accent1" phldr="1"/>
      <dgm:spPr/>
      <dgm:t>
        <a:bodyPr/>
        <a:lstStyle/>
        <a:p>
          <a:endParaRPr lang="en-US"/>
        </a:p>
      </dgm:t>
    </dgm:pt>
    <dgm:pt modelId="{2C030FA6-7E81-4A48-9C9E-4527EEC13AED}">
      <dgm:prSet phldrT="[Text]"/>
      <dgm:spPr/>
      <dgm:t>
        <a:bodyPr/>
        <a:lstStyle/>
        <a:p>
          <a:r>
            <a:rPr lang="en-US" dirty="0"/>
            <a:t>Is your patient stable?</a:t>
          </a:r>
        </a:p>
      </dgm:t>
    </dgm:pt>
    <dgm:pt modelId="{BB454A16-3246-614E-A2AD-4A1877F3B71F}" type="parTrans" cxnId="{4D759AC0-E23F-AF4C-812F-23C3F59325E0}">
      <dgm:prSet/>
      <dgm:spPr/>
      <dgm:t>
        <a:bodyPr/>
        <a:lstStyle/>
        <a:p>
          <a:endParaRPr lang="en-US"/>
        </a:p>
      </dgm:t>
    </dgm:pt>
    <dgm:pt modelId="{1DC69C20-133B-3E46-9476-42C7478A420C}" type="sibTrans" cxnId="{4D759AC0-E23F-AF4C-812F-23C3F59325E0}">
      <dgm:prSet/>
      <dgm:spPr/>
      <dgm:t>
        <a:bodyPr/>
        <a:lstStyle/>
        <a:p>
          <a:endParaRPr lang="en-US"/>
        </a:p>
      </dgm:t>
    </dgm:pt>
    <dgm:pt modelId="{D8FFBF56-9A3E-3A4D-A0F9-9C0EA2722ECE}">
      <dgm:prSet phldrT="[Text]"/>
      <dgm:spPr/>
      <dgm:t>
        <a:bodyPr/>
        <a:lstStyle/>
        <a:p>
          <a:r>
            <a:rPr lang="en-US" dirty="0"/>
            <a:t>Is your patient altered?</a:t>
          </a:r>
        </a:p>
      </dgm:t>
    </dgm:pt>
    <dgm:pt modelId="{21E55324-976B-B24E-B30C-5249ADD7FCBD}" type="parTrans" cxnId="{343804EC-922E-CF4F-930A-E589806016BF}">
      <dgm:prSet/>
      <dgm:spPr/>
      <dgm:t>
        <a:bodyPr/>
        <a:lstStyle/>
        <a:p>
          <a:endParaRPr lang="en-US"/>
        </a:p>
      </dgm:t>
    </dgm:pt>
    <dgm:pt modelId="{062139DC-FB61-A640-B739-2CC34C5A7EC7}" type="sibTrans" cxnId="{343804EC-922E-CF4F-930A-E589806016BF}">
      <dgm:prSet/>
      <dgm:spPr/>
      <dgm:t>
        <a:bodyPr/>
        <a:lstStyle/>
        <a:p>
          <a:endParaRPr lang="en-US"/>
        </a:p>
      </dgm:t>
    </dgm:pt>
    <dgm:pt modelId="{E18EAF26-6F83-0E40-BE4F-8658DF6118F3}">
      <dgm:prSet phldrT="[Text]"/>
      <dgm:spPr/>
      <dgm:t>
        <a:bodyPr/>
        <a:lstStyle/>
        <a:p>
          <a:r>
            <a:rPr lang="en-US" dirty="0"/>
            <a:t>Proceed with the toolkit</a:t>
          </a:r>
        </a:p>
      </dgm:t>
    </dgm:pt>
    <dgm:pt modelId="{D44CC24A-35FE-3C49-95B7-4688C4392DE9}" type="parTrans" cxnId="{9CADC682-CE69-FC47-8A65-5B4E7FAA4D85}">
      <dgm:prSet/>
      <dgm:spPr/>
      <dgm:t>
        <a:bodyPr/>
        <a:lstStyle/>
        <a:p>
          <a:endParaRPr lang="en-US"/>
        </a:p>
      </dgm:t>
    </dgm:pt>
    <dgm:pt modelId="{99B9CB4A-2664-F549-B090-5B53C78B5357}" type="sibTrans" cxnId="{9CADC682-CE69-FC47-8A65-5B4E7FAA4D85}">
      <dgm:prSet/>
      <dgm:spPr/>
      <dgm:t>
        <a:bodyPr/>
        <a:lstStyle/>
        <a:p>
          <a:endParaRPr lang="en-US"/>
        </a:p>
      </dgm:t>
    </dgm:pt>
    <dgm:pt modelId="{AF9ADC8D-3CEA-AC4B-8D80-00D91BFDBED6}">
      <dgm:prSet phldrT="[Text]"/>
      <dgm:spPr/>
      <dgm:t>
        <a:bodyPr/>
        <a:lstStyle/>
        <a:p>
          <a:r>
            <a:rPr lang="en-US" dirty="0"/>
            <a:t>Consider redirection &amp; lean on debriefs</a:t>
          </a:r>
        </a:p>
      </dgm:t>
    </dgm:pt>
    <dgm:pt modelId="{6BA0E476-5486-554B-A68E-5BF65636FF6C}" type="parTrans" cxnId="{3A32EDC3-9E7F-E543-AF95-73575C3A37DC}">
      <dgm:prSet/>
      <dgm:spPr/>
      <dgm:t>
        <a:bodyPr/>
        <a:lstStyle/>
        <a:p>
          <a:endParaRPr lang="en-US"/>
        </a:p>
      </dgm:t>
    </dgm:pt>
    <dgm:pt modelId="{3ACD9FE0-9416-894D-8291-C1B36287D0B8}" type="sibTrans" cxnId="{3A32EDC3-9E7F-E543-AF95-73575C3A37DC}">
      <dgm:prSet/>
      <dgm:spPr/>
      <dgm:t>
        <a:bodyPr/>
        <a:lstStyle/>
        <a:p>
          <a:endParaRPr lang="en-US"/>
        </a:p>
      </dgm:t>
    </dgm:pt>
    <dgm:pt modelId="{EF9B1202-8EEE-BD44-AB46-579C4BBF9197}">
      <dgm:prSet phldrT="[Text]"/>
      <dgm:spPr/>
      <dgm:t>
        <a:bodyPr/>
        <a:lstStyle/>
        <a:p>
          <a:r>
            <a:rPr lang="en-US" dirty="0"/>
            <a:t>Call for help</a:t>
          </a:r>
        </a:p>
      </dgm:t>
    </dgm:pt>
    <dgm:pt modelId="{34646B74-90F6-9B4C-9D79-FC194E6FF100}" type="parTrans" cxnId="{9252B173-130B-A240-AE47-4796AE173E04}">
      <dgm:prSet/>
      <dgm:spPr/>
      <dgm:t>
        <a:bodyPr/>
        <a:lstStyle/>
        <a:p>
          <a:endParaRPr lang="en-US"/>
        </a:p>
      </dgm:t>
    </dgm:pt>
    <dgm:pt modelId="{BD355D7E-FF05-9246-99E2-800B9961010C}" type="sibTrans" cxnId="{9252B173-130B-A240-AE47-4796AE173E04}">
      <dgm:prSet/>
      <dgm:spPr/>
      <dgm:t>
        <a:bodyPr/>
        <a:lstStyle/>
        <a:p>
          <a:endParaRPr lang="en-US"/>
        </a:p>
      </dgm:t>
    </dgm:pt>
    <dgm:pt modelId="{F94DC12B-6B69-014C-AEFD-1F4814E2B9C1}" type="pres">
      <dgm:prSet presAssocID="{FCDD7C81-9563-C84F-A588-E11178385414}" presName="hierChild1" presStyleCnt="0">
        <dgm:presLayoutVars>
          <dgm:chPref val="1"/>
          <dgm:dir/>
          <dgm:animOne val="branch"/>
          <dgm:animLvl val="lvl"/>
          <dgm:resizeHandles/>
        </dgm:presLayoutVars>
      </dgm:prSet>
      <dgm:spPr/>
    </dgm:pt>
    <dgm:pt modelId="{441AA63F-4561-6F42-9B72-3FC298F5FABF}" type="pres">
      <dgm:prSet presAssocID="{2C030FA6-7E81-4A48-9C9E-4527EEC13AED}" presName="hierRoot1" presStyleCnt="0"/>
      <dgm:spPr/>
    </dgm:pt>
    <dgm:pt modelId="{7A138EA4-2608-8E4D-93C0-4652A1963DFC}" type="pres">
      <dgm:prSet presAssocID="{2C030FA6-7E81-4A48-9C9E-4527EEC13AED}" presName="composite" presStyleCnt="0"/>
      <dgm:spPr/>
    </dgm:pt>
    <dgm:pt modelId="{8052D55D-B261-7642-8B61-F8E9E779D0FA}" type="pres">
      <dgm:prSet presAssocID="{2C030FA6-7E81-4A48-9C9E-4527EEC13AED}" presName="background" presStyleLbl="node0" presStyleIdx="0" presStyleCnt="1"/>
      <dgm:spPr/>
    </dgm:pt>
    <dgm:pt modelId="{D2B5DB64-631D-B24D-9ED7-813FE7B29263}" type="pres">
      <dgm:prSet presAssocID="{2C030FA6-7E81-4A48-9C9E-4527EEC13AED}" presName="text" presStyleLbl="fgAcc0" presStyleIdx="0" presStyleCnt="1" custScaleY="46028">
        <dgm:presLayoutVars>
          <dgm:chPref val="3"/>
        </dgm:presLayoutVars>
      </dgm:prSet>
      <dgm:spPr/>
    </dgm:pt>
    <dgm:pt modelId="{A01F1F48-2D85-4048-AB61-928A3AC81055}" type="pres">
      <dgm:prSet presAssocID="{2C030FA6-7E81-4A48-9C9E-4527EEC13AED}" presName="hierChild2" presStyleCnt="0"/>
      <dgm:spPr/>
    </dgm:pt>
    <dgm:pt modelId="{D39A8AD1-7CE3-C34F-B134-0CE95B3FFC60}" type="pres">
      <dgm:prSet presAssocID="{21E55324-976B-B24E-B30C-5249ADD7FCBD}" presName="Name10" presStyleLbl="parChTrans1D2" presStyleIdx="0" presStyleCnt="2"/>
      <dgm:spPr/>
    </dgm:pt>
    <dgm:pt modelId="{426A41A0-C58F-064E-985B-CA98B4D57112}" type="pres">
      <dgm:prSet presAssocID="{D8FFBF56-9A3E-3A4D-A0F9-9C0EA2722ECE}" presName="hierRoot2" presStyleCnt="0"/>
      <dgm:spPr/>
    </dgm:pt>
    <dgm:pt modelId="{21AF1302-1452-B14A-A9E7-55CEBF30AFD3}" type="pres">
      <dgm:prSet presAssocID="{D8FFBF56-9A3E-3A4D-A0F9-9C0EA2722ECE}" presName="composite2" presStyleCnt="0"/>
      <dgm:spPr/>
    </dgm:pt>
    <dgm:pt modelId="{2537D348-0A60-F64D-A40A-7A3C9A6F3688}" type="pres">
      <dgm:prSet presAssocID="{D8FFBF56-9A3E-3A4D-A0F9-9C0EA2722ECE}" presName="background2" presStyleLbl="node2" presStyleIdx="0" presStyleCnt="2"/>
      <dgm:spPr/>
    </dgm:pt>
    <dgm:pt modelId="{EF3C079A-5D7F-5246-A7DB-73AB70CC18BF}" type="pres">
      <dgm:prSet presAssocID="{D8FFBF56-9A3E-3A4D-A0F9-9C0EA2722ECE}" presName="text2" presStyleLbl="fgAcc2" presStyleIdx="0" presStyleCnt="2" custScaleY="46028">
        <dgm:presLayoutVars>
          <dgm:chPref val="3"/>
        </dgm:presLayoutVars>
      </dgm:prSet>
      <dgm:spPr/>
    </dgm:pt>
    <dgm:pt modelId="{71CED217-3CC9-C94D-801E-059D1353D003}" type="pres">
      <dgm:prSet presAssocID="{D8FFBF56-9A3E-3A4D-A0F9-9C0EA2722ECE}" presName="hierChild3" presStyleCnt="0"/>
      <dgm:spPr/>
    </dgm:pt>
    <dgm:pt modelId="{9D58F763-DC5B-4449-9D55-E52EFAB978AC}" type="pres">
      <dgm:prSet presAssocID="{D44CC24A-35FE-3C49-95B7-4688C4392DE9}" presName="Name17" presStyleLbl="parChTrans1D3" presStyleIdx="0" presStyleCnt="2"/>
      <dgm:spPr/>
    </dgm:pt>
    <dgm:pt modelId="{ED699817-A706-A345-943F-545C26A8ECD0}" type="pres">
      <dgm:prSet presAssocID="{E18EAF26-6F83-0E40-BE4F-8658DF6118F3}" presName="hierRoot3" presStyleCnt="0"/>
      <dgm:spPr/>
    </dgm:pt>
    <dgm:pt modelId="{C335220C-0180-D949-8722-E3531580AA05}" type="pres">
      <dgm:prSet presAssocID="{E18EAF26-6F83-0E40-BE4F-8658DF6118F3}" presName="composite3" presStyleCnt="0"/>
      <dgm:spPr/>
    </dgm:pt>
    <dgm:pt modelId="{C79C7631-E591-5C40-ADA0-BFFED70AD127}" type="pres">
      <dgm:prSet presAssocID="{E18EAF26-6F83-0E40-BE4F-8658DF6118F3}" presName="background3" presStyleLbl="node3" presStyleIdx="0" presStyleCnt="2"/>
      <dgm:spPr/>
    </dgm:pt>
    <dgm:pt modelId="{AD4EBA35-6F4A-E041-B6B1-E9A60439915E}" type="pres">
      <dgm:prSet presAssocID="{E18EAF26-6F83-0E40-BE4F-8658DF6118F3}" presName="text3" presStyleLbl="fgAcc3" presStyleIdx="0" presStyleCnt="2" custScaleY="46028">
        <dgm:presLayoutVars>
          <dgm:chPref val="3"/>
        </dgm:presLayoutVars>
      </dgm:prSet>
      <dgm:spPr/>
    </dgm:pt>
    <dgm:pt modelId="{72EC3379-EDAE-8949-BFA0-6193DA786235}" type="pres">
      <dgm:prSet presAssocID="{E18EAF26-6F83-0E40-BE4F-8658DF6118F3}" presName="hierChild4" presStyleCnt="0"/>
      <dgm:spPr/>
    </dgm:pt>
    <dgm:pt modelId="{3033233B-3142-7141-A450-F85AAA8AC8F2}" type="pres">
      <dgm:prSet presAssocID="{6BA0E476-5486-554B-A68E-5BF65636FF6C}" presName="Name17" presStyleLbl="parChTrans1D3" presStyleIdx="1" presStyleCnt="2"/>
      <dgm:spPr/>
    </dgm:pt>
    <dgm:pt modelId="{D570F39C-25A4-AB40-A7A1-2607B8B65A8C}" type="pres">
      <dgm:prSet presAssocID="{AF9ADC8D-3CEA-AC4B-8D80-00D91BFDBED6}" presName="hierRoot3" presStyleCnt="0"/>
      <dgm:spPr/>
    </dgm:pt>
    <dgm:pt modelId="{C25C3063-2373-DA4F-AD19-296101386938}" type="pres">
      <dgm:prSet presAssocID="{AF9ADC8D-3CEA-AC4B-8D80-00D91BFDBED6}" presName="composite3" presStyleCnt="0"/>
      <dgm:spPr/>
    </dgm:pt>
    <dgm:pt modelId="{5D8B4A0C-9602-5440-B473-8EE1143E33EF}" type="pres">
      <dgm:prSet presAssocID="{AF9ADC8D-3CEA-AC4B-8D80-00D91BFDBED6}" presName="background3" presStyleLbl="node3" presStyleIdx="1" presStyleCnt="2"/>
      <dgm:spPr/>
    </dgm:pt>
    <dgm:pt modelId="{604D342C-A759-3745-AA61-7E9DFE12CA7B}" type="pres">
      <dgm:prSet presAssocID="{AF9ADC8D-3CEA-AC4B-8D80-00D91BFDBED6}" presName="text3" presStyleLbl="fgAcc3" presStyleIdx="1" presStyleCnt="2" custScaleY="46028">
        <dgm:presLayoutVars>
          <dgm:chPref val="3"/>
        </dgm:presLayoutVars>
      </dgm:prSet>
      <dgm:spPr/>
    </dgm:pt>
    <dgm:pt modelId="{4DB34CF4-E1F7-7240-B60C-5D1B1ED14DE8}" type="pres">
      <dgm:prSet presAssocID="{AF9ADC8D-3CEA-AC4B-8D80-00D91BFDBED6}" presName="hierChild4" presStyleCnt="0"/>
      <dgm:spPr/>
    </dgm:pt>
    <dgm:pt modelId="{19CDD79B-5F7C-524F-AFDA-B8B9EDF45DDA}" type="pres">
      <dgm:prSet presAssocID="{34646B74-90F6-9B4C-9D79-FC194E6FF100}" presName="Name10" presStyleLbl="parChTrans1D2" presStyleIdx="1" presStyleCnt="2"/>
      <dgm:spPr/>
    </dgm:pt>
    <dgm:pt modelId="{99E2225B-A5C3-0341-AAFF-E944C5AF0176}" type="pres">
      <dgm:prSet presAssocID="{EF9B1202-8EEE-BD44-AB46-579C4BBF9197}" presName="hierRoot2" presStyleCnt="0"/>
      <dgm:spPr/>
    </dgm:pt>
    <dgm:pt modelId="{2AA133AE-C788-4142-B70E-5613E3E81EDF}" type="pres">
      <dgm:prSet presAssocID="{EF9B1202-8EEE-BD44-AB46-579C4BBF9197}" presName="composite2" presStyleCnt="0"/>
      <dgm:spPr/>
    </dgm:pt>
    <dgm:pt modelId="{93F31CF9-F237-5443-8BAB-D74798F1326D}" type="pres">
      <dgm:prSet presAssocID="{EF9B1202-8EEE-BD44-AB46-579C4BBF9197}" presName="background2" presStyleLbl="node2" presStyleIdx="1" presStyleCnt="2"/>
      <dgm:spPr/>
    </dgm:pt>
    <dgm:pt modelId="{252EE175-1C23-734D-90A4-182E0CC8C50C}" type="pres">
      <dgm:prSet presAssocID="{EF9B1202-8EEE-BD44-AB46-579C4BBF9197}" presName="text2" presStyleLbl="fgAcc2" presStyleIdx="1" presStyleCnt="2" custScaleY="46028">
        <dgm:presLayoutVars>
          <dgm:chPref val="3"/>
        </dgm:presLayoutVars>
      </dgm:prSet>
      <dgm:spPr/>
    </dgm:pt>
    <dgm:pt modelId="{74D72095-A98C-C443-AA71-07D20FE31227}" type="pres">
      <dgm:prSet presAssocID="{EF9B1202-8EEE-BD44-AB46-579C4BBF9197}" presName="hierChild3" presStyleCnt="0"/>
      <dgm:spPr/>
    </dgm:pt>
  </dgm:ptLst>
  <dgm:cxnLst>
    <dgm:cxn modelId="{425B1C0A-AD4A-2C4F-997A-49C18484475A}" type="presOf" srcId="{D8FFBF56-9A3E-3A4D-A0F9-9C0EA2722ECE}" destId="{EF3C079A-5D7F-5246-A7DB-73AB70CC18BF}" srcOrd="0" destOrd="0" presId="urn:microsoft.com/office/officeart/2005/8/layout/hierarchy1"/>
    <dgm:cxn modelId="{4CDC3638-8389-914B-98C2-EDD142575B7A}" type="presOf" srcId="{34646B74-90F6-9B4C-9D79-FC194E6FF100}" destId="{19CDD79B-5F7C-524F-AFDA-B8B9EDF45DDA}" srcOrd="0" destOrd="0" presId="urn:microsoft.com/office/officeart/2005/8/layout/hierarchy1"/>
    <dgm:cxn modelId="{08AE7A39-9A1C-4148-93EA-40C7C2E1FE85}" type="presOf" srcId="{E18EAF26-6F83-0E40-BE4F-8658DF6118F3}" destId="{AD4EBA35-6F4A-E041-B6B1-E9A60439915E}" srcOrd="0" destOrd="0" presId="urn:microsoft.com/office/officeart/2005/8/layout/hierarchy1"/>
    <dgm:cxn modelId="{3F135A41-EE54-174D-8282-CC94D21FA54C}" type="presOf" srcId="{21E55324-976B-B24E-B30C-5249ADD7FCBD}" destId="{D39A8AD1-7CE3-C34F-B134-0CE95B3FFC60}" srcOrd="0" destOrd="0" presId="urn:microsoft.com/office/officeart/2005/8/layout/hierarchy1"/>
    <dgm:cxn modelId="{E3EEED4F-0F74-CE40-95C9-CC5C37326698}" type="presOf" srcId="{6BA0E476-5486-554B-A68E-5BF65636FF6C}" destId="{3033233B-3142-7141-A450-F85AAA8AC8F2}" srcOrd="0" destOrd="0" presId="urn:microsoft.com/office/officeart/2005/8/layout/hierarchy1"/>
    <dgm:cxn modelId="{4AF6E05D-7439-5645-81D2-E4B90BC5DB4A}" type="presOf" srcId="{EF9B1202-8EEE-BD44-AB46-579C4BBF9197}" destId="{252EE175-1C23-734D-90A4-182E0CC8C50C}" srcOrd="0" destOrd="0" presId="urn:microsoft.com/office/officeart/2005/8/layout/hierarchy1"/>
    <dgm:cxn modelId="{9252B173-130B-A240-AE47-4796AE173E04}" srcId="{2C030FA6-7E81-4A48-9C9E-4527EEC13AED}" destId="{EF9B1202-8EEE-BD44-AB46-579C4BBF9197}" srcOrd="1" destOrd="0" parTransId="{34646B74-90F6-9B4C-9D79-FC194E6FF100}" sibTransId="{BD355D7E-FF05-9246-99E2-800B9961010C}"/>
    <dgm:cxn modelId="{902F5482-4925-0048-A5D6-21746CF6302C}" type="presOf" srcId="{2C030FA6-7E81-4A48-9C9E-4527EEC13AED}" destId="{D2B5DB64-631D-B24D-9ED7-813FE7B29263}" srcOrd="0" destOrd="0" presId="urn:microsoft.com/office/officeart/2005/8/layout/hierarchy1"/>
    <dgm:cxn modelId="{9CADC682-CE69-FC47-8A65-5B4E7FAA4D85}" srcId="{D8FFBF56-9A3E-3A4D-A0F9-9C0EA2722ECE}" destId="{E18EAF26-6F83-0E40-BE4F-8658DF6118F3}" srcOrd="0" destOrd="0" parTransId="{D44CC24A-35FE-3C49-95B7-4688C4392DE9}" sibTransId="{99B9CB4A-2664-F549-B090-5B53C78B5357}"/>
    <dgm:cxn modelId="{93FE4A9D-0EA3-9A4D-988C-7537880BDFD0}" type="presOf" srcId="{FCDD7C81-9563-C84F-A588-E11178385414}" destId="{F94DC12B-6B69-014C-AEFD-1F4814E2B9C1}" srcOrd="0" destOrd="0" presId="urn:microsoft.com/office/officeart/2005/8/layout/hierarchy1"/>
    <dgm:cxn modelId="{4D759AC0-E23F-AF4C-812F-23C3F59325E0}" srcId="{FCDD7C81-9563-C84F-A588-E11178385414}" destId="{2C030FA6-7E81-4A48-9C9E-4527EEC13AED}" srcOrd="0" destOrd="0" parTransId="{BB454A16-3246-614E-A2AD-4A1877F3B71F}" sibTransId="{1DC69C20-133B-3E46-9476-42C7478A420C}"/>
    <dgm:cxn modelId="{3A32EDC3-9E7F-E543-AF95-73575C3A37DC}" srcId="{D8FFBF56-9A3E-3A4D-A0F9-9C0EA2722ECE}" destId="{AF9ADC8D-3CEA-AC4B-8D80-00D91BFDBED6}" srcOrd="1" destOrd="0" parTransId="{6BA0E476-5486-554B-A68E-5BF65636FF6C}" sibTransId="{3ACD9FE0-9416-894D-8291-C1B36287D0B8}"/>
    <dgm:cxn modelId="{3C0F3AD1-2B68-5A43-92FA-0F7763844C9C}" type="presOf" srcId="{D44CC24A-35FE-3C49-95B7-4688C4392DE9}" destId="{9D58F763-DC5B-4449-9D55-E52EFAB978AC}" srcOrd="0" destOrd="0" presId="urn:microsoft.com/office/officeart/2005/8/layout/hierarchy1"/>
    <dgm:cxn modelId="{ACC6C5E5-8481-B847-87A0-98BE8F6B9933}" type="presOf" srcId="{AF9ADC8D-3CEA-AC4B-8D80-00D91BFDBED6}" destId="{604D342C-A759-3745-AA61-7E9DFE12CA7B}" srcOrd="0" destOrd="0" presId="urn:microsoft.com/office/officeart/2005/8/layout/hierarchy1"/>
    <dgm:cxn modelId="{343804EC-922E-CF4F-930A-E589806016BF}" srcId="{2C030FA6-7E81-4A48-9C9E-4527EEC13AED}" destId="{D8FFBF56-9A3E-3A4D-A0F9-9C0EA2722ECE}" srcOrd="0" destOrd="0" parTransId="{21E55324-976B-B24E-B30C-5249ADD7FCBD}" sibTransId="{062139DC-FB61-A640-B739-2CC34C5A7EC7}"/>
    <dgm:cxn modelId="{10BA4D0B-D16F-F64E-A320-608A7CD6BCE5}" type="presParOf" srcId="{F94DC12B-6B69-014C-AEFD-1F4814E2B9C1}" destId="{441AA63F-4561-6F42-9B72-3FC298F5FABF}" srcOrd="0" destOrd="0" presId="urn:microsoft.com/office/officeart/2005/8/layout/hierarchy1"/>
    <dgm:cxn modelId="{8D827543-DB05-3346-9BD4-46BB15B586B5}" type="presParOf" srcId="{441AA63F-4561-6F42-9B72-3FC298F5FABF}" destId="{7A138EA4-2608-8E4D-93C0-4652A1963DFC}" srcOrd="0" destOrd="0" presId="urn:microsoft.com/office/officeart/2005/8/layout/hierarchy1"/>
    <dgm:cxn modelId="{DB9DA64D-5624-A344-B923-AE9F6A62068A}" type="presParOf" srcId="{7A138EA4-2608-8E4D-93C0-4652A1963DFC}" destId="{8052D55D-B261-7642-8B61-F8E9E779D0FA}" srcOrd="0" destOrd="0" presId="urn:microsoft.com/office/officeart/2005/8/layout/hierarchy1"/>
    <dgm:cxn modelId="{594FB602-9278-E242-91CF-079C38CC4253}" type="presParOf" srcId="{7A138EA4-2608-8E4D-93C0-4652A1963DFC}" destId="{D2B5DB64-631D-B24D-9ED7-813FE7B29263}" srcOrd="1" destOrd="0" presId="urn:microsoft.com/office/officeart/2005/8/layout/hierarchy1"/>
    <dgm:cxn modelId="{BF28022E-F6D1-9940-90FF-586184CCCB0E}" type="presParOf" srcId="{441AA63F-4561-6F42-9B72-3FC298F5FABF}" destId="{A01F1F48-2D85-4048-AB61-928A3AC81055}" srcOrd="1" destOrd="0" presId="urn:microsoft.com/office/officeart/2005/8/layout/hierarchy1"/>
    <dgm:cxn modelId="{E403159C-91C6-5B41-B03E-C00A99336BB9}" type="presParOf" srcId="{A01F1F48-2D85-4048-AB61-928A3AC81055}" destId="{D39A8AD1-7CE3-C34F-B134-0CE95B3FFC60}" srcOrd="0" destOrd="0" presId="urn:microsoft.com/office/officeart/2005/8/layout/hierarchy1"/>
    <dgm:cxn modelId="{9FA0CB42-56A0-A44A-86EE-A315ACB81266}" type="presParOf" srcId="{A01F1F48-2D85-4048-AB61-928A3AC81055}" destId="{426A41A0-C58F-064E-985B-CA98B4D57112}" srcOrd="1" destOrd="0" presId="urn:microsoft.com/office/officeart/2005/8/layout/hierarchy1"/>
    <dgm:cxn modelId="{F04BD9C6-4273-C048-841F-CFD681FE4AE9}" type="presParOf" srcId="{426A41A0-C58F-064E-985B-CA98B4D57112}" destId="{21AF1302-1452-B14A-A9E7-55CEBF30AFD3}" srcOrd="0" destOrd="0" presId="urn:microsoft.com/office/officeart/2005/8/layout/hierarchy1"/>
    <dgm:cxn modelId="{97A4F570-7AC1-1047-A5A9-ACDAA2812710}" type="presParOf" srcId="{21AF1302-1452-B14A-A9E7-55CEBF30AFD3}" destId="{2537D348-0A60-F64D-A40A-7A3C9A6F3688}" srcOrd="0" destOrd="0" presId="urn:microsoft.com/office/officeart/2005/8/layout/hierarchy1"/>
    <dgm:cxn modelId="{CD78F0FF-A590-764E-8354-6409BC78C32A}" type="presParOf" srcId="{21AF1302-1452-B14A-A9E7-55CEBF30AFD3}" destId="{EF3C079A-5D7F-5246-A7DB-73AB70CC18BF}" srcOrd="1" destOrd="0" presId="urn:microsoft.com/office/officeart/2005/8/layout/hierarchy1"/>
    <dgm:cxn modelId="{41A4A5F4-53FB-6B46-A8F6-C806EA488A2B}" type="presParOf" srcId="{426A41A0-C58F-064E-985B-CA98B4D57112}" destId="{71CED217-3CC9-C94D-801E-059D1353D003}" srcOrd="1" destOrd="0" presId="urn:microsoft.com/office/officeart/2005/8/layout/hierarchy1"/>
    <dgm:cxn modelId="{414B2EAB-449F-FA47-8695-F3E2F89C5C5D}" type="presParOf" srcId="{71CED217-3CC9-C94D-801E-059D1353D003}" destId="{9D58F763-DC5B-4449-9D55-E52EFAB978AC}" srcOrd="0" destOrd="0" presId="urn:microsoft.com/office/officeart/2005/8/layout/hierarchy1"/>
    <dgm:cxn modelId="{42FBBD26-9295-CA44-8011-E900681A9764}" type="presParOf" srcId="{71CED217-3CC9-C94D-801E-059D1353D003}" destId="{ED699817-A706-A345-943F-545C26A8ECD0}" srcOrd="1" destOrd="0" presId="urn:microsoft.com/office/officeart/2005/8/layout/hierarchy1"/>
    <dgm:cxn modelId="{1AC35319-67ED-DD4B-87CD-A49D26052FC4}" type="presParOf" srcId="{ED699817-A706-A345-943F-545C26A8ECD0}" destId="{C335220C-0180-D949-8722-E3531580AA05}" srcOrd="0" destOrd="0" presId="urn:microsoft.com/office/officeart/2005/8/layout/hierarchy1"/>
    <dgm:cxn modelId="{7F051AC3-920C-7343-9587-4B8D7E0E12EC}" type="presParOf" srcId="{C335220C-0180-D949-8722-E3531580AA05}" destId="{C79C7631-E591-5C40-ADA0-BFFED70AD127}" srcOrd="0" destOrd="0" presId="urn:microsoft.com/office/officeart/2005/8/layout/hierarchy1"/>
    <dgm:cxn modelId="{12D54B22-B1E2-B54D-A1D0-3BD30D21DE45}" type="presParOf" srcId="{C335220C-0180-D949-8722-E3531580AA05}" destId="{AD4EBA35-6F4A-E041-B6B1-E9A60439915E}" srcOrd="1" destOrd="0" presId="urn:microsoft.com/office/officeart/2005/8/layout/hierarchy1"/>
    <dgm:cxn modelId="{8C757B69-C6C1-A345-85DC-08413735BA82}" type="presParOf" srcId="{ED699817-A706-A345-943F-545C26A8ECD0}" destId="{72EC3379-EDAE-8949-BFA0-6193DA786235}" srcOrd="1" destOrd="0" presId="urn:microsoft.com/office/officeart/2005/8/layout/hierarchy1"/>
    <dgm:cxn modelId="{B0168F7A-FBB1-6542-BB54-6BE8FA102A6D}" type="presParOf" srcId="{71CED217-3CC9-C94D-801E-059D1353D003}" destId="{3033233B-3142-7141-A450-F85AAA8AC8F2}" srcOrd="2" destOrd="0" presId="urn:microsoft.com/office/officeart/2005/8/layout/hierarchy1"/>
    <dgm:cxn modelId="{F94C10C1-934D-FF47-BC8E-139CB06A3CCC}" type="presParOf" srcId="{71CED217-3CC9-C94D-801E-059D1353D003}" destId="{D570F39C-25A4-AB40-A7A1-2607B8B65A8C}" srcOrd="3" destOrd="0" presId="urn:microsoft.com/office/officeart/2005/8/layout/hierarchy1"/>
    <dgm:cxn modelId="{7A7B5DFF-2B36-7B41-B584-07842F6028A6}" type="presParOf" srcId="{D570F39C-25A4-AB40-A7A1-2607B8B65A8C}" destId="{C25C3063-2373-DA4F-AD19-296101386938}" srcOrd="0" destOrd="0" presId="urn:microsoft.com/office/officeart/2005/8/layout/hierarchy1"/>
    <dgm:cxn modelId="{9E8359D4-5727-5440-BF64-14AA531B1698}" type="presParOf" srcId="{C25C3063-2373-DA4F-AD19-296101386938}" destId="{5D8B4A0C-9602-5440-B473-8EE1143E33EF}" srcOrd="0" destOrd="0" presId="urn:microsoft.com/office/officeart/2005/8/layout/hierarchy1"/>
    <dgm:cxn modelId="{E47D4094-55B8-3449-B370-147E62A4DD92}" type="presParOf" srcId="{C25C3063-2373-DA4F-AD19-296101386938}" destId="{604D342C-A759-3745-AA61-7E9DFE12CA7B}" srcOrd="1" destOrd="0" presId="urn:microsoft.com/office/officeart/2005/8/layout/hierarchy1"/>
    <dgm:cxn modelId="{B06DC1E1-1D73-3C4A-8D8F-33E2D8742884}" type="presParOf" srcId="{D570F39C-25A4-AB40-A7A1-2607B8B65A8C}" destId="{4DB34CF4-E1F7-7240-B60C-5D1B1ED14DE8}" srcOrd="1" destOrd="0" presId="urn:microsoft.com/office/officeart/2005/8/layout/hierarchy1"/>
    <dgm:cxn modelId="{6352677C-1BC2-4949-9D13-B3ABC7FBDE64}" type="presParOf" srcId="{A01F1F48-2D85-4048-AB61-928A3AC81055}" destId="{19CDD79B-5F7C-524F-AFDA-B8B9EDF45DDA}" srcOrd="2" destOrd="0" presId="urn:microsoft.com/office/officeart/2005/8/layout/hierarchy1"/>
    <dgm:cxn modelId="{949B4681-3931-7C4E-8DAF-95CD3F2F0866}" type="presParOf" srcId="{A01F1F48-2D85-4048-AB61-928A3AC81055}" destId="{99E2225B-A5C3-0341-AAFF-E944C5AF0176}" srcOrd="3" destOrd="0" presId="urn:microsoft.com/office/officeart/2005/8/layout/hierarchy1"/>
    <dgm:cxn modelId="{86842635-426A-BC4D-88D3-26AF6A1C5E08}" type="presParOf" srcId="{99E2225B-A5C3-0341-AAFF-E944C5AF0176}" destId="{2AA133AE-C788-4142-B70E-5613E3E81EDF}" srcOrd="0" destOrd="0" presId="urn:microsoft.com/office/officeart/2005/8/layout/hierarchy1"/>
    <dgm:cxn modelId="{FD2029CB-EDAB-5049-B964-A8CE7F1BE106}" type="presParOf" srcId="{2AA133AE-C788-4142-B70E-5613E3E81EDF}" destId="{93F31CF9-F237-5443-8BAB-D74798F1326D}" srcOrd="0" destOrd="0" presId="urn:microsoft.com/office/officeart/2005/8/layout/hierarchy1"/>
    <dgm:cxn modelId="{13F9196B-726F-1243-97EB-B813234EAA62}" type="presParOf" srcId="{2AA133AE-C788-4142-B70E-5613E3E81EDF}" destId="{252EE175-1C23-734D-90A4-182E0CC8C50C}" srcOrd="1" destOrd="0" presId="urn:microsoft.com/office/officeart/2005/8/layout/hierarchy1"/>
    <dgm:cxn modelId="{76F1DECA-D2D3-E04B-9504-D2D994B92647}" type="presParOf" srcId="{99E2225B-A5C3-0341-AAFF-E944C5AF0176}" destId="{74D72095-A98C-C443-AA71-07D20FE31227}" srcOrd="1" destOrd="0" presId="urn:microsoft.com/office/officeart/2005/8/layout/hierarchy1"/>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CE7EC2B3-709C-7049-AC98-40D647A08CD5}" type="doc">
      <dgm:prSet loTypeId="urn:microsoft.com/office/officeart/2005/8/layout/vList5" loCatId="" qsTypeId="urn:microsoft.com/office/officeart/2005/8/quickstyle/simple1" qsCatId="simple" csTypeId="urn:microsoft.com/office/officeart/2005/8/colors/accent1_2" csCatId="accent1" phldr="1"/>
      <dgm:spPr/>
      <dgm:t>
        <a:bodyPr/>
        <a:lstStyle/>
        <a:p>
          <a:endParaRPr lang="en-US"/>
        </a:p>
      </dgm:t>
    </dgm:pt>
    <dgm:pt modelId="{54EB0C78-47D0-4144-BBA1-ED83F2276A80}">
      <dgm:prSet phldrT="[Text]"/>
      <dgm:spPr/>
      <dgm:t>
        <a:bodyPr/>
        <a:lstStyle/>
        <a:p>
          <a:r>
            <a:rPr lang="en-US" dirty="0"/>
            <a:t>1</a:t>
          </a:r>
        </a:p>
      </dgm:t>
    </dgm:pt>
    <dgm:pt modelId="{46A28A5B-8A7C-BF49-A5DC-996D874F74B0}" type="parTrans" cxnId="{54AEA8B7-F89B-724F-98A1-0AEC5D7FC3A2}">
      <dgm:prSet/>
      <dgm:spPr/>
      <dgm:t>
        <a:bodyPr/>
        <a:lstStyle/>
        <a:p>
          <a:endParaRPr lang="en-US"/>
        </a:p>
      </dgm:t>
    </dgm:pt>
    <dgm:pt modelId="{E8376F97-8FAC-AA43-868D-BB3E335B92F2}" type="sibTrans" cxnId="{54AEA8B7-F89B-724F-98A1-0AEC5D7FC3A2}">
      <dgm:prSet/>
      <dgm:spPr/>
      <dgm:t>
        <a:bodyPr/>
        <a:lstStyle/>
        <a:p>
          <a:endParaRPr lang="en-US"/>
        </a:p>
      </dgm:t>
    </dgm:pt>
    <dgm:pt modelId="{D57A6E2B-1DF9-5046-BC1D-709A01F64D7F}">
      <dgm:prSet phldrT="[Text]"/>
      <dgm:spPr/>
      <dgm:t>
        <a:bodyPr/>
        <a:lstStyle/>
        <a:p>
          <a:r>
            <a:rPr lang="en-US"/>
            <a:t>Patient stability</a:t>
          </a:r>
          <a:endParaRPr lang="en-US" dirty="0"/>
        </a:p>
      </dgm:t>
    </dgm:pt>
    <dgm:pt modelId="{C76AEE8B-D94A-7D44-B03A-3FE0785274DD}" type="parTrans" cxnId="{B2C59790-5949-8740-B37D-5567793C306C}">
      <dgm:prSet/>
      <dgm:spPr/>
      <dgm:t>
        <a:bodyPr/>
        <a:lstStyle/>
        <a:p>
          <a:endParaRPr lang="en-US"/>
        </a:p>
      </dgm:t>
    </dgm:pt>
    <dgm:pt modelId="{55132C62-F393-2540-A3F5-1E79E69F36CF}" type="sibTrans" cxnId="{B2C59790-5949-8740-B37D-5567793C306C}">
      <dgm:prSet/>
      <dgm:spPr/>
      <dgm:t>
        <a:bodyPr/>
        <a:lstStyle/>
        <a:p>
          <a:endParaRPr lang="en-US"/>
        </a:p>
      </dgm:t>
    </dgm:pt>
    <dgm:pt modelId="{8E966A69-49F1-5E4B-B606-FCAEDAA984ED}">
      <dgm:prSet phldrT="[Text]"/>
      <dgm:spPr/>
      <dgm:t>
        <a:bodyPr/>
        <a:lstStyle/>
        <a:p>
          <a:r>
            <a:rPr lang="en-US" dirty="0"/>
            <a:t>Emotional check</a:t>
          </a:r>
        </a:p>
      </dgm:t>
    </dgm:pt>
    <dgm:pt modelId="{6E022D76-54D3-5040-BFB1-6E3CF648085C}" type="sibTrans" cxnId="{FBB45EE4-904A-AF48-A0C9-CB655E66EF52}">
      <dgm:prSet/>
      <dgm:spPr/>
      <dgm:t>
        <a:bodyPr/>
        <a:lstStyle/>
        <a:p>
          <a:endParaRPr lang="en-US"/>
        </a:p>
      </dgm:t>
    </dgm:pt>
    <dgm:pt modelId="{DBAD8E5C-BD8A-8D4C-B4F0-8493200D7696}" type="parTrans" cxnId="{FBB45EE4-904A-AF48-A0C9-CB655E66EF52}">
      <dgm:prSet/>
      <dgm:spPr/>
      <dgm:t>
        <a:bodyPr/>
        <a:lstStyle/>
        <a:p>
          <a:endParaRPr lang="en-US"/>
        </a:p>
      </dgm:t>
    </dgm:pt>
    <dgm:pt modelId="{E900B89A-C42B-5249-B68C-A3D7ECDC2722}">
      <dgm:prSet phldrT="[Text]"/>
      <dgm:spPr/>
      <dgm:t>
        <a:bodyPr/>
        <a:lstStyle/>
        <a:p>
          <a:r>
            <a:rPr lang="en-US" dirty="0"/>
            <a:t>Address bias</a:t>
          </a:r>
        </a:p>
      </dgm:t>
    </dgm:pt>
    <dgm:pt modelId="{1CCB8A03-5593-CE44-86BA-AACEAE0CCB98}" type="sibTrans" cxnId="{8EA459AB-225B-8C4D-9825-5D1C6BF10277}">
      <dgm:prSet/>
      <dgm:spPr/>
      <dgm:t>
        <a:bodyPr/>
        <a:lstStyle/>
        <a:p>
          <a:endParaRPr lang="en-US"/>
        </a:p>
      </dgm:t>
    </dgm:pt>
    <dgm:pt modelId="{8E839505-C7B5-E846-B572-409C6E14F87D}" type="parTrans" cxnId="{8EA459AB-225B-8C4D-9825-5D1C6BF10277}">
      <dgm:prSet/>
      <dgm:spPr/>
      <dgm:t>
        <a:bodyPr/>
        <a:lstStyle/>
        <a:p>
          <a:endParaRPr lang="en-US"/>
        </a:p>
      </dgm:t>
    </dgm:pt>
    <dgm:pt modelId="{77E26394-E137-5E44-9434-AC75CD3E8E1C}">
      <dgm:prSet/>
      <dgm:spPr/>
      <dgm:t>
        <a:bodyPr/>
        <a:lstStyle/>
        <a:p>
          <a:r>
            <a:rPr lang="en-US" dirty="0"/>
            <a:t>Align with patient</a:t>
          </a:r>
        </a:p>
      </dgm:t>
    </dgm:pt>
    <dgm:pt modelId="{4162CFAB-B676-8E4E-8FEB-32BD16B62DEC}" type="sibTrans" cxnId="{3055A850-65BD-2C48-A538-0AAEB9138E85}">
      <dgm:prSet/>
      <dgm:spPr/>
      <dgm:t>
        <a:bodyPr/>
        <a:lstStyle/>
        <a:p>
          <a:endParaRPr lang="en-US"/>
        </a:p>
      </dgm:t>
    </dgm:pt>
    <dgm:pt modelId="{0106416C-C608-3E4B-95A9-3A27F212EF0D}" type="parTrans" cxnId="{3055A850-65BD-2C48-A538-0AAEB9138E85}">
      <dgm:prSet/>
      <dgm:spPr/>
      <dgm:t>
        <a:bodyPr/>
        <a:lstStyle/>
        <a:p>
          <a:endParaRPr lang="en-US"/>
        </a:p>
      </dgm:t>
    </dgm:pt>
    <dgm:pt modelId="{B3ABDBBC-28C2-CC44-9EA0-940A074F9BF0}">
      <dgm:prSet/>
      <dgm:spPr/>
      <dgm:t>
        <a:bodyPr/>
        <a:lstStyle/>
        <a:p>
          <a:r>
            <a:rPr lang="en-US" dirty="0"/>
            <a:t>Align with team</a:t>
          </a:r>
        </a:p>
      </dgm:t>
    </dgm:pt>
    <dgm:pt modelId="{B1A1C092-087B-F241-9B26-AD1D13C72D4D}" type="sibTrans" cxnId="{D85391B8-F585-FD43-82E0-8ACB9B810BF4}">
      <dgm:prSet/>
      <dgm:spPr/>
      <dgm:t>
        <a:bodyPr/>
        <a:lstStyle/>
        <a:p>
          <a:endParaRPr lang="en-US"/>
        </a:p>
      </dgm:t>
    </dgm:pt>
    <dgm:pt modelId="{D1297B60-D255-DA44-8D75-399213932CFB}" type="parTrans" cxnId="{D85391B8-F585-FD43-82E0-8ACB9B810BF4}">
      <dgm:prSet/>
      <dgm:spPr/>
      <dgm:t>
        <a:bodyPr/>
        <a:lstStyle/>
        <a:p>
          <a:endParaRPr lang="en-US"/>
        </a:p>
      </dgm:t>
    </dgm:pt>
    <dgm:pt modelId="{D6BB4A41-00B2-5448-BB3F-80605AC75A4E}">
      <dgm:prSet/>
      <dgm:spPr/>
      <dgm:t>
        <a:bodyPr/>
        <a:lstStyle/>
        <a:p>
          <a:r>
            <a:rPr lang="en-US" dirty="0"/>
            <a:t>Set boundaries</a:t>
          </a:r>
        </a:p>
      </dgm:t>
    </dgm:pt>
    <dgm:pt modelId="{A3F6C628-648D-0249-B65F-551AF9ECEEA6}" type="sibTrans" cxnId="{DF1A41C0-D8B8-6D4F-A8A5-91EC68AFBCAD}">
      <dgm:prSet/>
      <dgm:spPr/>
      <dgm:t>
        <a:bodyPr/>
        <a:lstStyle/>
        <a:p>
          <a:endParaRPr lang="en-US"/>
        </a:p>
      </dgm:t>
    </dgm:pt>
    <dgm:pt modelId="{4E04882C-8060-1D42-8502-5D210AA0DCD3}" type="parTrans" cxnId="{DF1A41C0-D8B8-6D4F-A8A5-91EC68AFBCAD}">
      <dgm:prSet/>
      <dgm:spPr/>
      <dgm:t>
        <a:bodyPr/>
        <a:lstStyle/>
        <a:p>
          <a:endParaRPr lang="en-US"/>
        </a:p>
      </dgm:t>
    </dgm:pt>
    <dgm:pt modelId="{4042EA18-93B7-8447-AC0A-58BAED6135AA}">
      <dgm:prSet/>
      <dgm:spPr/>
      <dgm:t>
        <a:bodyPr/>
        <a:lstStyle/>
        <a:p>
          <a:r>
            <a:rPr lang="en-US" dirty="0"/>
            <a:t>Seek support</a:t>
          </a:r>
        </a:p>
      </dgm:t>
    </dgm:pt>
    <dgm:pt modelId="{A608511D-1BB9-EB4E-9E74-CCD7B0DB861D}" type="sibTrans" cxnId="{BBBA16DC-BC73-8048-A725-FE1EF1BF6593}">
      <dgm:prSet/>
      <dgm:spPr/>
      <dgm:t>
        <a:bodyPr/>
        <a:lstStyle/>
        <a:p>
          <a:endParaRPr lang="en-US"/>
        </a:p>
      </dgm:t>
    </dgm:pt>
    <dgm:pt modelId="{2F5CB061-56DE-EB4D-BFD4-36B00E6055CB}" type="parTrans" cxnId="{BBBA16DC-BC73-8048-A725-FE1EF1BF6593}">
      <dgm:prSet/>
      <dgm:spPr/>
      <dgm:t>
        <a:bodyPr/>
        <a:lstStyle/>
        <a:p>
          <a:endParaRPr lang="en-US"/>
        </a:p>
      </dgm:t>
    </dgm:pt>
    <dgm:pt modelId="{0545D5E0-C6B3-A447-B001-E955BFE39730}">
      <dgm:prSet/>
      <dgm:spPr/>
      <dgm:t>
        <a:bodyPr/>
        <a:lstStyle/>
        <a:p>
          <a:r>
            <a:rPr lang="en-US" dirty="0"/>
            <a:t>Give space</a:t>
          </a:r>
        </a:p>
      </dgm:t>
    </dgm:pt>
    <dgm:pt modelId="{43A03E68-4CAE-A344-B58C-38B13B6EE776}" type="sibTrans" cxnId="{E2BB9BC9-6DB1-9443-8E35-6250A99E4AD7}">
      <dgm:prSet/>
      <dgm:spPr/>
      <dgm:t>
        <a:bodyPr/>
        <a:lstStyle/>
        <a:p>
          <a:endParaRPr lang="en-US"/>
        </a:p>
      </dgm:t>
    </dgm:pt>
    <dgm:pt modelId="{74548467-254B-2943-9A99-08C07F3E448D}" type="parTrans" cxnId="{E2BB9BC9-6DB1-9443-8E35-6250A99E4AD7}">
      <dgm:prSet/>
      <dgm:spPr/>
      <dgm:t>
        <a:bodyPr/>
        <a:lstStyle/>
        <a:p>
          <a:endParaRPr lang="en-US"/>
        </a:p>
      </dgm:t>
    </dgm:pt>
    <dgm:pt modelId="{7CF6944D-D814-F446-BDE2-B55C1C344687}">
      <dgm:prSet/>
      <dgm:spPr/>
      <dgm:t>
        <a:bodyPr/>
        <a:lstStyle/>
        <a:p>
          <a:r>
            <a:rPr lang="en-US" dirty="0"/>
            <a:t>8</a:t>
          </a:r>
        </a:p>
      </dgm:t>
    </dgm:pt>
    <dgm:pt modelId="{41CA9CD1-BD05-D240-8585-F6D044F469D5}" type="sibTrans" cxnId="{B4BAA057-82A7-8F4F-B3AE-D2474B9F0D61}">
      <dgm:prSet/>
      <dgm:spPr/>
      <dgm:t>
        <a:bodyPr/>
        <a:lstStyle/>
        <a:p>
          <a:endParaRPr lang="en-US"/>
        </a:p>
      </dgm:t>
    </dgm:pt>
    <dgm:pt modelId="{18766106-4E88-954F-80B4-8435CD7E3607}" type="parTrans" cxnId="{B4BAA057-82A7-8F4F-B3AE-D2474B9F0D61}">
      <dgm:prSet/>
      <dgm:spPr/>
      <dgm:t>
        <a:bodyPr/>
        <a:lstStyle/>
        <a:p>
          <a:endParaRPr lang="en-US"/>
        </a:p>
      </dgm:t>
    </dgm:pt>
    <dgm:pt modelId="{02BDF100-8338-E043-96F5-EE898B9D5AB2}">
      <dgm:prSet/>
      <dgm:spPr/>
      <dgm:t>
        <a:bodyPr/>
        <a:lstStyle/>
        <a:p>
          <a:r>
            <a:rPr lang="en-US" dirty="0"/>
            <a:t>7</a:t>
          </a:r>
        </a:p>
      </dgm:t>
    </dgm:pt>
    <dgm:pt modelId="{BCE247F3-63ED-824C-BC43-9D645F88694B}" type="sibTrans" cxnId="{F6183E77-6BBF-FA47-854D-F0D53AE21A8A}">
      <dgm:prSet/>
      <dgm:spPr/>
      <dgm:t>
        <a:bodyPr/>
        <a:lstStyle/>
        <a:p>
          <a:endParaRPr lang="en-US"/>
        </a:p>
      </dgm:t>
    </dgm:pt>
    <dgm:pt modelId="{1B53CCA0-CFF2-384B-856E-1EBDFA4D02AD}" type="parTrans" cxnId="{F6183E77-6BBF-FA47-854D-F0D53AE21A8A}">
      <dgm:prSet/>
      <dgm:spPr/>
      <dgm:t>
        <a:bodyPr/>
        <a:lstStyle/>
        <a:p>
          <a:endParaRPr lang="en-US"/>
        </a:p>
      </dgm:t>
    </dgm:pt>
    <dgm:pt modelId="{9F6E5C8F-12F1-3545-94A6-291C5042E69E}">
      <dgm:prSet/>
      <dgm:spPr/>
      <dgm:t>
        <a:bodyPr/>
        <a:lstStyle/>
        <a:p>
          <a:r>
            <a:rPr lang="en-US" dirty="0"/>
            <a:t>6</a:t>
          </a:r>
        </a:p>
      </dgm:t>
    </dgm:pt>
    <dgm:pt modelId="{F501E3C1-886B-5244-A7B1-7A80D72A4D8C}" type="sibTrans" cxnId="{545F95DE-9A10-3948-9807-36C195D34A35}">
      <dgm:prSet/>
      <dgm:spPr/>
      <dgm:t>
        <a:bodyPr/>
        <a:lstStyle/>
        <a:p>
          <a:endParaRPr lang="en-US"/>
        </a:p>
      </dgm:t>
    </dgm:pt>
    <dgm:pt modelId="{F878F1E0-BA83-0B4F-8407-D69A3E0606E8}" type="parTrans" cxnId="{545F95DE-9A10-3948-9807-36C195D34A35}">
      <dgm:prSet/>
      <dgm:spPr/>
      <dgm:t>
        <a:bodyPr/>
        <a:lstStyle/>
        <a:p>
          <a:endParaRPr lang="en-US"/>
        </a:p>
      </dgm:t>
    </dgm:pt>
    <dgm:pt modelId="{827957E1-E296-1C4F-A5F6-1C5FE324A00C}">
      <dgm:prSet/>
      <dgm:spPr/>
      <dgm:t>
        <a:bodyPr/>
        <a:lstStyle/>
        <a:p>
          <a:r>
            <a:rPr lang="en-US" dirty="0"/>
            <a:t>5</a:t>
          </a:r>
        </a:p>
      </dgm:t>
    </dgm:pt>
    <dgm:pt modelId="{9F52F0F0-B16C-AB44-86AF-35AA79D5B0BB}" type="sibTrans" cxnId="{C5A31E1B-1939-A943-9EA9-0D1F931C9095}">
      <dgm:prSet/>
      <dgm:spPr/>
      <dgm:t>
        <a:bodyPr/>
        <a:lstStyle/>
        <a:p>
          <a:endParaRPr lang="en-US"/>
        </a:p>
      </dgm:t>
    </dgm:pt>
    <dgm:pt modelId="{AC89EDA2-97A0-704F-A224-66777968DC79}" type="parTrans" cxnId="{C5A31E1B-1939-A943-9EA9-0D1F931C9095}">
      <dgm:prSet/>
      <dgm:spPr/>
      <dgm:t>
        <a:bodyPr/>
        <a:lstStyle/>
        <a:p>
          <a:endParaRPr lang="en-US"/>
        </a:p>
      </dgm:t>
    </dgm:pt>
    <dgm:pt modelId="{418E94F4-4F87-154C-8C2C-4FA1854F2962}">
      <dgm:prSet/>
      <dgm:spPr/>
      <dgm:t>
        <a:bodyPr/>
        <a:lstStyle/>
        <a:p>
          <a:r>
            <a:rPr lang="en-US" dirty="0"/>
            <a:t>4</a:t>
          </a:r>
        </a:p>
      </dgm:t>
    </dgm:pt>
    <dgm:pt modelId="{A5C1BCA8-59E6-2D47-BF9C-24A0A56844F7}" type="sibTrans" cxnId="{2BBF3C50-1ED6-9847-B76B-936F9EDE5606}">
      <dgm:prSet/>
      <dgm:spPr/>
      <dgm:t>
        <a:bodyPr/>
        <a:lstStyle/>
        <a:p>
          <a:endParaRPr lang="en-US"/>
        </a:p>
      </dgm:t>
    </dgm:pt>
    <dgm:pt modelId="{67B29BF1-08A2-E04F-9D69-0598739CF13B}" type="parTrans" cxnId="{2BBF3C50-1ED6-9847-B76B-936F9EDE5606}">
      <dgm:prSet/>
      <dgm:spPr/>
      <dgm:t>
        <a:bodyPr/>
        <a:lstStyle/>
        <a:p>
          <a:endParaRPr lang="en-US"/>
        </a:p>
      </dgm:t>
    </dgm:pt>
    <dgm:pt modelId="{73A345CE-36FD-894D-BBC6-F1148569A643}">
      <dgm:prSet phldrT="[Text]"/>
      <dgm:spPr/>
      <dgm:t>
        <a:bodyPr/>
        <a:lstStyle/>
        <a:p>
          <a:r>
            <a:rPr lang="en-US" dirty="0"/>
            <a:t>3</a:t>
          </a:r>
        </a:p>
      </dgm:t>
    </dgm:pt>
    <dgm:pt modelId="{7A99C83F-BC00-3743-81E8-552BD253CEC3}" type="sibTrans" cxnId="{408ED183-BF58-1C4B-97FD-732582625FEF}">
      <dgm:prSet/>
      <dgm:spPr/>
      <dgm:t>
        <a:bodyPr/>
        <a:lstStyle/>
        <a:p>
          <a:endParaRPr lang="en-US"/>
        </a:p>
      </dgm:t>
    </dgm:pt>
    <dgm:pt modelId="{E3B27BD6-FBE2-5640-8D4A-26A5222CC3EA}" type="parTrans" cxnId="{408ED183-BF58-1C4B-97FD-732582625FEF}">
      <dgm:prSet/>
      <dgm:spPr/>
      <dgm:t>
        <a:bodyPr/>
        <a:lstStyle/>
        <a:p>
          <a:endParaRPr lang="en-US"/>
        </a:p>
      </dgm:t>
    </dgm:pt>
    <dgm:pt modelId="{D03F059F-5021-1F40-A19F-9647158C52AD}">
      <dgm:prSet phldrT="[Text]"/>
      <dgm:spPr/>
      <dgm:t>
        <a:bodyPr/>
        <a:lstStyle/>
        <a:p>
          <a:r>
            <a:rPr lang="en-US" dirty="0"/>
            <a:t>2</a:t>
          </a:r>
        </a:p>
      </dgm:t>
    </dgm:pt>
    <dgm:pt modelId="{294C2440-29C3-A948-ADDD-2D4D34880BDD}" type="sibTrans" cxnId="{65CEA44F-9E16-EA4E-A309-EC3B3016297A}">
      <dgm:prSet/>
      <dgm:spPr/>
      <dgm:t>
        <a:bodyPr/>
        <a:lstStyle/>
        <a:p>
          <a:endParaRPr lang="en-US"/>
        </a:p>
      </dgm:t>
    </dgm:pt>
    <dgm:pt modelId="{CF000D09-B476-0444-AE02-AACE5A32ABB9}" type="parTrans" cxnId="{65CEA44F-9E16-EA4E-A309-EC3B3016297A}">
      <dgm:prSet/>
      <dgm:spPr/>
      <dgm:t>
        <a:bodyPr/>
        <a:lstStyle/>
        <a:p>
          <a:endParaRPr lang="en-US"/>
        </a:p>
      </dgm:t>
    </dgm:pt>
    <dgm:pt modelId="{C651D352-06FA-1B42-81FF-A95099FE5645}" type="pres">
      <dgm:prSet presAssocID="{CE7EC2B3-709C-7049-AC98-40D647A08CD5}" presName="Name0" presStyleCnt="0">
        <dgm:presLayoutVars>
          <dgm:dir/>
          <dgm:animLvl val="lvl"/>
          <dgm:resizeHandles val="exact"/>
        </dgm:presLayoutVars>
      </dgm:prSet>
      <dgm:spPr/>
    </dgm:pt>
    <dgm:pt modelId="{2E2FEDEA-0CB5-FD4B-8718-95B9D6A14304}" type="pres">
      <dgm:prSet presAssocID="{54EB0C78-47D0-4144-BBA1-ED83F2276A80}" presName="linNode" presStyleCnt="0"/>
      <dgm:spPr/>
    </dgm:pt>
    <dgm:pt modelId="{2F0271A3-745A-A943-B67B-E4069A93AE61}" type="pres">
      <dgm:prSet presAssocID="{54EB0C78-47D0-4144-BBA1-ED83F2276A80}" presName="parentText" presStyleLbl="node1" presStyleIdx="0" presStyleCnt="8" custScaleX="67001">
        <dgm:presLayoutVars>
          <dgm:chMax val="1"/>
          <dgm:bulletEnabled val="1"/>
        </dgm:presLayoutVars>
      </dgm:prSet>
      <dgm:spPr/>
    </dgm:pt>
    <dgm:pt modelId="{21D64796-42C1-6A47-B16B-F23C35A117FF}" type="pres">
      <dgm:prSet presAssocID="{54EB0C78-47D0-4144-BBA1-ED83F2276A80}" presName="descendantText" presStyleLbl="alignAccFollowNode1" presStyleIdx="0" presStyleCnt="8">
        <dgm:presLayoutVars>
          <dgm:bulletEnabled val="1"/>
        </dgm:presLayoutVars>
      </dgm:prSet>
      <dgm:spPr/>
    </dgm:pt>
    <dgm:pt modelId="{B2C4C361-6A0B-BC45-90FD-318B0EB08F6D}" type="pres">
      <dgm:prSet presAssocID="{E8376F97-8FAC-AA43-868D-BB3E335B92F2}" presName="sp" presStyleCnt="0"/>
      <dgm:spPr/>
    </dgm:pt>
    <dgm:pt modelId="{277D1FDC-6CD3-BB41-8E20-960C658417CF}" type="pres">
      <dgm:prSet presAssocID="{D03F059F-5021-1F40-A19F-9647158C52AD}" presName="linNode" presStyleCnt="0"/>
      <dgm:spPr/>
    </dgm:pt>
    <dgm:pt modelId="{6CEBA26E-9501-3E41-ACBB-39C96B19A924}" type="pres">
      <dgm:prSet presAssocID="{D03F059F-5021-1F40-A19F-9647158C52AD}" presName="parentText" presStyleLbl="node1" presStyleIdx="1" presStyleCnt="8" custScaleX="67001">
        <dgm:presLayoutVars>
          <dgm:chMax val="1"/>
          <dgm:bulletEnabled val="1"/>
        </dgm:presLayoutVars>
      </dgm:prSet>
      <dgm:spPr/>
    </dgm:pt>
    <dgm:pt modelId="{2EB4DD27-0645-2048-89E9-55CE50FE52DA}" type="pres">
      <dgm:prSet presAssocID="{D03F059F-5021-1F40-A19F-9647158C52AD}" presName="descendantText" presStyleLbl="alignAccFollowNode1" presStyleIdx="1" presStyleCnt="8">
        <dgm:presLayoutVars>
          <dgm:bulletEnabled val="1"/>
        </dgm:presLayoutVars>
      </dgm:prSet>
      <dgm:spPr/>
    </dgm:pt>
    <dgm:pt modelId="{33CCAA17-6648-4F4C-9AC2-5ECE7EDB6E70}" type="pres">
      <dgm:prSet presAssocID="{294C2440-29C3-A948-ADDD-2D4D34880BDD}" presName="sp" presStyleCnt="0"/>
      <dgm:spPr/>
    </dgm:pt>
    <dgm:pt modelId="{B97FC210-8EA1-614A-91AB-916C1AEFBDEE}" type="pres">
      <dgm:prSet presAssocID="{73A345CE-36FD-894D-BBC6-F1148569A643}" presName="linNode" presStyleCnt="0"/>
      <dgm:spPr/>
    </dgm:pt>
    <dgm:pt modelId="{A3A63788-1227-B240-AFF4-87DA3887717D}" type="pres">
      <dgm:prSet presAssocID="{73A345CE-36FD-894D-BBC6-F1148569A643}" presName="parentText" presStyleLbl="node1" presStyleIdx="2" presStyleCnt="8" custScaleX="67001">
        <dgm:presLayoutVars>
          <dgm:chMax val="1"/>
          <dgm:bulletEnabled val="1"/>
        </dgm:presLayoutVars>
      </dgm:prSet>
      <dgm:spPr/>
    </dgm:pt>
    <dgm:pt modelId="{5432570E-A980-7C49-B78B-FBD7E95247D6}" type="pres">
      <dgm:prSet presAssocID="{73A345CE-36FD-894D-BBC6-F1148569A643}" presName="descendantText" presStyleLbl="alignAccFollowNode1" presStyleIdx="2" presStyleCnt="8">
        <dgm:presLayoutVars>
          <dgm:bulletEnabled val="1"/>
        </dgm:presLayoutVars>
      </dgm:prSet>
      <dgm:spPr/>
    </dgm:pt>
    <dgm:pt modelId="{3E055F9F-21A2-424C-8A4E-65EE89C8A916}" type="pres">
      <dgm:prSet presAssocID="{7A99C83F-BC00-3743-81E8-552BD253CEC3}" presName="sp" presStyleCnt="0"/>
      <dgm:spPr/>
    </dgm:pt>
    <dgm:pt modelId="{3D7F3715-4665-FB42-B9D8-1FF06FE7ED04}" type="pres">
      <dgm:prSet presAssocID="{418E94F4-4F87-154C-8C2C-4FA1854F2962}" presName="linNode" presStyleCnt="0"/>
      <dgm:spPr/>
    </dgm:pt>
    <dgm:pt modelId="{F459C834-8503-9C47-9E88-19B5B264D39A}" type="pres">
      <dgm:prSet presAssocID="{418E94F4-4F87-154C-8C2C-4FA1854F2962}" presName="parentText" presStyleLbl="node1" presStyleIdx="3" presStyleCnt="8" custScaleX="67001">
        <dgm:presLayoutVars>
          <dgm:chMax val="1"/>
          <dgm:bulletEnabled val="1"/>
        </dgm:presLayoutVars>
      </dgm:prSet>
      <dgm:spPr/>
    </dgm:pt>
    <dgm:pt modelId="{B11406A9-5BCB-7247-9C38-2B1D2505F2B8}" type="pres">
      <dgm:prSet presAssocID="{418E94F4-4F87-154C-8C2C-4FA1854F2962}" presName="descendantText" presStyleLbl="alignAccFollowNode1" presStyleIdx="3" presStyleCnt="8">
        <dgm:presLayoutVars>
          <dgm:bulletEnabled val="1"/>
        </dgm:presLayoutVars>
      </dgm:prSet>
      <dgm:spPr/>
    </dgm:pt>
    <dgm:pt modelId="{E355AC6F-4099-CB47-B889-4B740E437363}" type="pres">
      <dgm:prSet presAssocID="{A5C1BCA8-59E6-2D47-BF9C-24A0A56844F7}" presName="sp" presStyleCnt="0"/>
      <dgm:spPr/>
    </dgm:pt>
    <dgm:pt modelId="{A60CA7D8-39CB-954A-95BD-9B247DA4C063}" type="pres">
      <dgm:prSet presAssocID="{827957E1-E296-1C4F-A5F6-1C5FE324A00C}" presName="linNode" presStyleCnt="0"/>
      <dgm:spPr/>
    </dgm:pt>
    <dgm:pt modelId="{4D3677DD-203E-6A46-986E-4A5C658C9303}" type="pres">
      <dgm:prSet presAssocID="{827957E1-E296-1C4F-A5F6-1C5FE324A00C}" presName="parentText" presStyleLbl="node1" presStyleIdx="4" presStyleCnt="8" custScaleX="67001">
        <dgm:presLayoutVars>
          <dgm:chMax val="1"/>
          <dgm:bulletEnabled val="1"/>
        </dgm:presLayoutVars>
      </dgm:prSet>
      <dgm:spPr/>
    </dgm:pt>
    <dgm:pt modelId="{DF481026-182D-AB4B-A938-B9E12915351D}" type="pres">
      <dgm:prSet presAssocID="{827957E1-E296-1C4F-A5F6-1C5FE324A00C}" presName="descendantText" presStyleLbl="alignAccFollowNode1" presStyleIdx="4" presStyleCnt="8">
        <dgm:presLayoutVars>
          <dgm:bulletEnabled val="1"/>
        </dgm:presLayoutVars>
      </dgm:prSet>
      <dgm:spPr/>
    </dgm:pt>
    <dgm:pt modelId="{0E9316E9-2C30-AB47-AE90-7E8E046E1AFD}" type="pres">
      <dgm:prSet presAssocID="{9F52F0F0-B16C-AB44-86AF-35AA79D5B0BB}" presName="sp" presStyleCnt="0"/>
      <dgm:spPr/>
    </dgm:pt>
    <dgm:pt modelId="{037794A2-D322-8E40-B011-CE07ECE52AD6}" type="pres">
      <dgm:prSet presAssocID="{9F6E5C8F-12F1-3545-94A6-291C5042E69E}" presName="linNode" presStyleCnt="0"/>
      <dgm:spPr/>
    </dgm:pt>
    <dgm:pt modelId="{B6C279C8-1B63-3845-ADAB-B82AEFA3D8E4}" type="pres">
      <dgm:prSet presAssocID="{9F6E5C8F-12F1-3545-94A6-291C5042E69E}" presName="parentText" presStyleLbl="node1" presStyleIdx="5" presStyleCnt="8" custScaleX="67001">
        <dgm:presLayoutVars>
          <dgm:chMax val="1"/>
          <dgm:bulletEnabled val="1"/>
        </dgm:presLayoutVars>
      </dgm:prSet>
      <dgm:spPr/>
    </dgm:pt>
    <dgm:pt modelId="{95DA0D8B-BC89-0948-909A-C298332DBD75}" type="pres">
      <dgm:prSet presAssocID="{9F6E5C8F-12F1-3545-94A6-291C5042E69E}" presName="descendantText" presStyleLbl="alignAccFollowNode1" presStyleIdx="5" presStyleCnt="8">
        <dgm:presLayoutVars>
          <dgm:bulletEnabled val="1"/>
        </dgm:presLayoutVars>
      </dgm:prSet>
      <dgm:spPr/>
    </dgm:pt>
    <dgm:pt modelId="{05C8E7F6-EE84-404A-A830-A5238A04D5A3}" type="pres">
      <dgm:prSet presAssocID="{F501E3C1-886B-5244-A7B1-7A80D72A4D8C}" presName="sp" presStyleCnt="0"/>
      <dgm:spPr/>
    </dgm:pt>
    <dgm:pt modelId="{450D1F74-F684-8F4C-A8B3-6F8B553AB682}" type="pres">
      <dgm:prSet presAssocID="{02BDF100-8338-E043-96F5-EE898B9D5AB2}" presName="linNode" presStyleCnt="0"/>
      <dgm:spPr/>
    </dgm:pt>
    <dgm:pt modelId="{B67BA8B7-08DC-C244-8300-FCD547033DBD}" type="pres">
      <dgm:prSet presAssocID="{02BDF100-8338-E043-96F5-EE898B9D5AB2}" presName="parentText" presStyleLbl="node1" presStyleIdx="6" presStyleCnt="8" custScaleX="67001">
        <dgm:presLayoutVars>
          <dgm:chMax val="1"/>
          <dgm:bulletEnabled val="1"/>
        </dgm:presLayoutVars>
      </dgm:prSet>
      <dgm:spPr/>
    </dgm:pt>
    <dgm:pt modelId="{9D2B4FF6-13FB-EF49-977A-31DF5EE58099}" type="pres">
      <dgm:prSet presAssocID="{02BDF100-8338-E043-96F5-EE898B9D5AB2}" presName="descendantText" presStyleLbl="alignAccFollowNode1" presStyleIdx="6" presStyleCnt="8">
        <dgm:presLayoutVars>
          <dgm:bulletEnabled val="1"/>
        </dgm:presLayoutVars>
      </dgm:prSet>
      <dgm:spPr/>
    </dgm:pt>
    <dgm:pt modelId="{580F7313-AC0F-FA49-A45E-0C9486F52D6E}" type="pres">
      <dgm:prSet presAssocID="{BCE247F3-63ED-824C-BC43-9D645F88694B}" presName="sp" presStyleCnt="0"/>
      <dgm:spPr/>
    </dgm:pt>
    <dgm:pt modelId="{E737A561-EB87-EC46-B404-0D8CDB0DE287}" type="pres">
      <dgm:prSet presAssocID="{7CF6944D-D814-F446-BDE2-B55C1C344687}" presName="linNode" presStyleCnt="0"/>
      <dgm:spPr/>
    </dgm:pt>
    <dgm:pt modelId="{D5D04DA4-D0C2-DE47-8C8C-0B8EFFA304FE}" type="pres">
      <dgm:prSet presAssocID="{7CF6944D-D814-F446-BDE2-B55C1C344687}" presName="parentText" presStyleLbl="node1" presStyleIdx="7" presStyleCnt="8" custScaleX="67001">
        <dgm:presLayoutVars>
          <dgm:chMax val="1"/>
          <dgm:bulletEnabled val="1"/>
        </dgm:presLayoutVars>
      </dgm:prSet>
      <dgm:spPr/>
    </dgm:pt>
    <dgm:pt modelId="{8CF3EAF4-8574-9841-9B3E-4FBF8CB57172}" type="pres">
      <dgm:prSet presAssocID="{7CF6944D-D814-F446-BDE2-B55C1C344687}" presName="descendantText" presStyleLbl="alignAccFollowNode1" presStyleIdx="7" presStyleCnt="8">
        <dgm:presLayoutVars>
          <dgm:bulletEnabled val="1"/>
        </dgm:presLayoutVars>
      </dgm:prSet>
      <dgm:spPr/>
    </dgm:pt>
  </dgm:ptLst>
  <dgm:cxnLst>
    <dgm:cxn modelId="{E4273A05-E6BD-7B48-BAB7-FF2C885BDD30}" type="presOf" srcId="{02BDF100-8338-E043-96F5-EE898B9D5AB2}" destId="{B67BA8B7-08DC-C244-8300-FCD547033DBD}" srcOrd="0" destOrd="0" presId="urn:microsoft.com/office/officeart/2005/8/layout/vList5"/>
    <dgm:cxn modelId="{E9D1E10C-1628-524C-9321-D84C071FF74D}" type="presOf" srcId="{CE7EC2B3-709C-7049-AC98-40D647A08CD5}" destId="{C651D352-06FA-1B42-81FF-A95099FE5645}" srcOrd="0" destOrd="0" presId="urn:microsoft.com/office/officeart/2005/8/layout/vList5"/>
    <dgm:cxn modelId="{C4160712-DF53-0F4F-9BBA-78BD9BBF4B88}" type="presOf" srcId="{77E26394-E137-5E44-9434-AC75CD3E8E1C}" destId="{B11406A9-5BCB-7247-9C38-2B1D2505F2B8}" srcOrd="0" destOrd="0" presId="urn:microsoft.com/office/officeart/2005/8/layout/vList5"/>
    <dgm:cxn modelId="{C5A31E1B-1939-A943-9EA9-0D1F931C9095}" srcId="{CE7EC2B3-709C-7049-AC98-40D647A08CD5}" destId="{827957E1-E296-1C4F-A5F6-1C5FE324A00C}" srcOrd="4" destOrd="0" parTransId="{AC89EDA2-97A0-704F-A224-66777968DC79}" sibTransId="{9F52F0F0-B16C-AB44-86AF-35AA79D5B0BB}"/>
    <dgm:cxn modelId="{086EAA1D-3224-4E41-87B1-9FA27037DE47}" type="presOf" srcId="{9F6E5C8F-12F1-3545-94A6-291C5042E69E}" destId="{B6C279C8-1B63-3845-ADAB-B82AEFA3D8E4}" srcOrd="0" destOrd="0" presId="urn:microsoft.com/office/officeart/2005/8/layout/vList5"/>
    <dgm:cxn modelId="{71BBC71D-E55C-424F-B6C9-6E507D91D4E5}" type="presOf" srcId="{D6BB4A41-00B2-5448-BB3F-80605AC75A4E}" destId="{95DA0D8B-BC89-0948-909A-C298332DBD75}" srcOrd="0" destOrd="0" presId="urn:microsoft.com/office/officeart/2005/8/layout/vList5"/>
    <dgm:cxn modelId="{7A4CD21E-5C30-9844-B8CC-04D4CC71350C}" type="presOf" srcId="{4042EA18-93B7-8447-AC0A-58BAED6135AA}" destId="{8CF3EAF4-8574-9841-9B3E-4FBF8CB57172}" srcOrd="0" destOrd="0" presId="urn:microsoft.com/office/officeart/2005/8/layout/vList5"/>
    <dgm:cxn modelId="{EA0CCB2E-33A7-7842-AF42-FDB163C3A0DB}" type="presOf" srcId="{8E966A69-49F1-5E4B-B606-FCAEDAA984ED}" destId="{2EB4DD27-0645-2048-89E9-55CE50FE52DA}" srcOrd="0" destOrd="0" presId="urn:microsoft.com/office/officeart/2005/8/layout/vList5"/>
    <dgm:cxn modelId="{65CEA44F-9E16-EA4E-A309-EC3B3016297A}" srcId="{CE7EC2B3-709C-7049-AC98-40D647A08CD5}" destId="{D03F059F-5021-1F40-A19F-9647158C52AD}" srcOrd="1" destOrd="0" parTransId="{CF000D09-B476-0444-AE02-AACE5A32ABB9}" sibTransId="{294C2440-29C3-A948-ADDD-2D4D34880BDD}"/>
    <dgm:cxn modelId="{2BBF3C50-1ED6-9847-B76B-936F9EDE5606}" srcId="{CE7EC2B3-709C-7049-AC98-40D647A08CD5}" destId="{418E94F4-4F87-154C-8C2C-4FA1854F2962}" srcOrd="3" destOrd="0" parTransId="{67B29BF1-08A2-E04F-9D69-0598739CF13B}" sibTransId="{A5C1BCA8-59E6-2D47-BF9C-24A0A56844F7}"/>
    <dgm:cxn modelId="{3055A850-65BD-2C48-A538-0AAEB9138E85}" srcId="{418E94F4-4F87-154C-8C2C-4FA1854F2962}" destId="{77E26394-E137-5E44-9434-AC75CD3E8E1C}" srcOrd="0" destOrd="0" parTransId="{0106416C-C608-3E4B-95A9-3A27F212EF0D}" sibTransId="{4162CFAB-B676-8E4E-8FEB-32BD16B62DEC}"/>
    <dgm:cxn modelId="{B3273152-AF0F-EE4B-8C28-8B1E95E5CD89}" type="presOf" srcId="{E900B89A-C42B-5249-B68C-A3D7ECDC2722}" destId="{5432570E-A980-7C49-B78B-FBD7E95247D6}" srcOrd="0" destOrd="0" presId="urn:microsoft.com/office/officeart/2005/8/layout/vList5"/>
    <dgm:cxn modelId="{90712D57-061F-8444-BA8A-D8DA5E4630C5}" type="presOf" srcId="{73A345CE-36FD-894D-BBC6-F1148569A643}" destId="{A3A63788-1227-B240-AFF4-87DA3887717D}" srcOrd="0" destOrd="0" presId="urn:microsoft.com/office/officeart/2005/8/layout/vList5"/>
    <dgm:cxn modelId="{B4BAA057-82A7-8F4F-B3AE-D2474B9F0D61}" srcId="{CE7EC2B3-709C-7049-AC98-40D647A08CD5}" destId="{7CF6944D-D814-F446-BDE2-B55C1C344687}" srcOrd="7" destOrd="0" parTransId="{18766106-4E88-954F-80B4-8435CD7E3607}" sibTransId="{41CA9CD1-BD05-D240-8585-F6D044F469D5}"/>
    <dgm:cxn modelId="{BAD62360-A798-6A47-A994-B5126C6DDBBA}" type="presOf" srcId="{D57A6E2B-1DF9-5046-BC1D-709A01F64D7F}" destId="{21D64796-42C1-6A47-B16B-F23C35A117FF}" srcOrd="0" destOrd="0" presId="urn:microsoft.com/office/officeart/2005/8/layout/vList5"/>
    <dgm:cxn modelId="{F6183E77-6BBF-FA47-854D-F0D53AE21A8A}" srcId="{CE7EC2B3-709C-7049-AC98-40D647A08CD5}" destId="{02BDF100-8338-E043-96F5-EE898B9D5AB2}" srcOrd="6" destOrd="0" parTransId="{1B53CCA0-CFF2-384B-856E-1EBDFA4D02AD}" sibTransId="{BCE247F3-63ED-824C-BC43-9D645F88694B}"/>
    <dgm:cxn modelId="{89198578-5DCB-6140-878F-E9FD8D67271F}" type="presOf" srcId="{7CF6944D-D814-F446-BDE2-B55C1C344687}" destId="{D5D04DA4-D0C2-DE47-8C8C-0B8EFFA304FE}" srcOrd="0" destOrd="0" presId="urn:microsoft.com/office/officeart/2005/8/layout/vList5"/>
    <dgm:cxn modelId="{408ED183-BF58-1C4B-97FD-732582625FEF}" srcId="{CE7EC2B3-709C-7049-AC98-40D647A08CD5}" destId="{73A345CE-36FD-894D-BBC6-F1148569A643}" srcOrd="2" destOrd="0" parTransId="{E3B27BD6-FBE2-5640-8D4A-26A5222CC3EA}" sibTransId="{7A99C83F-BC00-3743-81E8-552BD253CEC3}"/>
    <dgm:cxn modelId="{B2C59790-5949-8740-B37D-5567793C306C}" srcId="{54EB0C78-47D0-4144-BBA1-ED83F2276A80}" destId="{D57A6E2B-1DF9-5046-BC1D-709A01F64D7F}" srcOrd="0" destOrd="0" parTransId="{C76AEE8B-D94A-7D44-B03A-3FE0785274DD}" sibTransId="{55132C62-F393-2540-A3F5-1E79E69F36CF}"/>
    <dgm:cxn modelId="{2D83CF9B-C8D2-5645-B148-7557D123AE42}" type="presOf" srcId="{827957E1-E296-1C4F-A5F6-1C5FE324A00C}" destId="{4D3677DD-203E-6A46-986E-4A5C658C9303}" srcOrd="0" destOrd="0" presId="urn:microsoft.com/office/officeart/2005/8/layout/vList5"/>
    <dgm:cxn modelId="{D734F3A8-F28E-EC4B-833E-A76A8DF839E2}" type="presOf" srcId="{D03F059F-5021-1F40-A19F-9647158C52AD}" destId="{6CEBA26E-9501-3E41-ACBB-39C96B19A924}" srcOrd="0" destOrd="0" presId="urn:microsoft.com/office/officeart/2005/8/layout/vList5"/>
    <dgm:cxn modelId="{8EA459AB-225B-8C4D-9825-5D1C6BF10277}" srcId="{73A345CE-36FD-894D-BBC6-F1148569A643}" destId="{E900B89A-C42B-5249-B68C-A3D7ECDC2722}" srcOrd="0" destOrd="0" parTransId="{8E839505-C7B5-E846-B572-409C6E14F87D}" sibTransId="{1CCB8A03-5593-CE44-86BA-AACEAE0CCB98}"/>
    <dgm:cxn modelId="{54AEA8B7-F89B-724F-98A1-0AEC5D7FC3A2}" srcId="{CE7EC2B3-709C-7049-AC98-40D647A08CD5}" destId="{54EB0C78-47D0-4144-BBA1-ED83F2276A80}" srcOrd="0" destOrd="0" parTransId="{46A28A5B-8A7C-BF49-A5DC-996D874F74B0}" sibTransId="{E8376F97-8FAC-AA43-868D-BB3E335B92F2}"/>
    <dgm:cxn modelId="{D85391B8-F585-FD43-82E0-8ACB9B810BF4}" srcId="{827957E1-E296-1C4F-A5F6-1C5FE324A00C}" destId="{B3ABDBBC-28C2-CC44-9EA0-940A074F9BF0}" srcOrd="0" destOrd="0" parTransId="{D1297B60-D255-DA44-8D75-399213932CFB}" sibTransId="{B1A1C092-087B-F241-9B26-AD1D13C72D4D}"/>
    <dgm:cxn modelId="{DF1A41C0-D8B8-6D4F-A8A5-91EC68AFBCAD}" srcId="{9F6E5C8F-12F1-3545-94A6-291C5042E69E}" destId="{D6BB4A41-00B2-5448-BB3F-80605AC75A4E}" srcOrd="0" destOrd="0" parTransId="{4E04882C-8060-1D42-8502-5D210AA0DCD3}" sibTransId="{A3F6C628-648D-0249-B65F-551AF9ECEEA6}"/>
    <dgm:cxn modelId="{F2E046C8-391B-6946-ACE6-697EC224AB98}" type="presOf" srcId="{B3ABDBBC-28C2-CC44-9EA0-940A074F9BF0}" destId="{DF481026-182D-AB4B-A938-B9E12915351D}" srcOrd="0" destOrd="0" presId="urn:microsoft.com/office/officeart/2005/8/layout/vList5"/>
    <dgm:cxn modelId="{E2BB9BC9-6DB1-9443-8E35-6250A99E4AD7}" srcId="{02BDF100-8338-E043-96F5-EE898B9D5AB2}" destId="{0545D5E0-C6B3-A447-B001-E955BFE39730}" srcOrd="0" destOrd="0" parTransId="{74548467-254B-2943-9A99-08C07F3E448D}" sibTransId="{43A03E68-4CAE-A344-B58C-38B13B6EE776}"/>
    <dgm:cxn modelId="{A16837DB-2A15-1C45-807B-67AB4EF8E75E}" type="presOf" srcId="{0545D5E0-C6B3-A447-B001-E955BFE39730}" destId="{9D2B4FF6-13FB-EF49-977A-31DF5EE58099}" srcOrd="0" destOrd="0" presId="urn:microsoft.com/office/officeart/2005/8/layout/vList5"/>
    <dgm:cxn modelId="{BBBA16DC-BC73-8048-A725-FE1EF1BF6593}" srcId="{7CF6944D-D814-F446-BDE2-B55C1C344687}" destId="{4042EA18-93B7-8447-AC0A-58BAED6135AA}" srcOrd="0" destOrd="0" parTransId="{2F5CB061-56DE-EB4D-BFD4-36B00E6055CB}" sibTransId="{A608511D-1BB9-EB4E-9E74-CCD7B0DB861D}"/>
    <dgm:cxn modelId="{545F95DE-9A10-3948-9807-36C195D34A35}" srcId="{CE7EC2B3-709C-7049-AC98-40D647A08CD5}" destId="{9F6E5C8F-12F1-3545-94A6-291C5042E69E}" srcOrd="5" destOrd="0" parTransId="{F878F1E0-BA83-0B4F-8407-D69A3E0606E8}" sibTransId="{F501E3C1-886B-5244-A7B1-7A80D72A4D8C}"/>
    <dgm:cxn modelId="{1AC639E1-2DD4-8C49-9596-C5731579DC3A}" type="presOf" srcId="{54EB0C78-47D0-4144-BBA1-ED83F2276A80}" destId="{2F0271A3-745A-A943-B67B-E4069A93AE61}" srcOrd="0" destOrd="0" presId="urn:microsoft.com/office/officeart/2005/8/layout/vList5"/>
    <dgm:cxn modelId="{FBB45EE4-904A-AF48-A0C9-CB655E66EF52}" srcId="{D03F059F-5021-1F40-A19F-9647158C52AD}" destId="{8E966A69-49F1-5E4B-B606-FCAEDAA984ED}" srcOrd="0" destOrd="0" parTransId="{DBAD8E5C-BD8A-8D4C-B4F0-8493200D7696}" sibTransId="{6E022D76-54D3-5040-BFB1-6E3CF648085C}"/>
    <dgm:cxn modelId="{CE4D51EC-1171-9740-9774-3550157EF9C1}" type="presOf" srcId="{418E94F4-4F87-154C-8C2C-4FA1854F2962}" destId="{F459C834-8503-9C47-9E88-19B5B264D39A}" srcOrd="0" destOrd="0" presId="urn:microsoft.com/office/officeart/2005/8/layout/vList5"/>
    <dgm:cxn modelId="{BF236B13-02D1-B64C-986F-0CAF7E0612E5}" type="presParOf" srcId="{C651D352-06FA-1B42-81FF-A95099FE5645}" destId="{2E2FEDEA-0CB5-FD4B-8718-95B9D6A14304}" srcOrd="0" destOrd="0" presId="urn:microsoft.com/office/officeart/2005/8/layout/vList5"/>
    <dgm:cxn modelId="{9578A504-AB23-5044-A923-D3DEFAE4D5E7}" type="presParOf" srcId="{2E2FEDEA-0CB5-FD4B-8718-95B9D6A14304}" destId="{2F0271A3-745A-A943-B67B-E4069A93AE61}" srcOrd="0" destOrd="0" presId="urn:microsoft.com/office/officeart/2005/8/layout/vList5"/>
    <dgm:cxn modelId="{253C94D8-1885-B543-AF3D-F6A1DD424873}" type="presParOf" srcId="{2E2FEDEA-0CB5-FD4B-8718-95B9D6A14304}" destId="{21D64796-42C1-6A47-B16B-F23C35A117FF}" srcOrd="1" destOrd="0" presId="urn:microsoft.com/office/officeart/2005/8/layout/vList5"/>
    <dgm:cxn modelId="{C06B9A2B-4F20-7C45-806D-5E7956B4F171}" type="presParOf" srcId="{C651D352-06FA-1B42-81FF-A95099FE5645}" destId="{B2C4C361-6A0B-BC45-90FD-318B0EB08F6D}" srcOrd="1" destOrd="0" presId="urn:microsoft.com/office/officeart/2005/8/layout/vList5"/>
    <dgm:cxn modelId="{7BF712B5-32BC-7844-BF86-9BFE0BE03182}" type="presParOf" srcId="{C651D352-06FA-1B42-81FF-A95099FE5645}" destId="{277D1FDC-6CD3-BB41-8E20-960C658417CF}" srcOrd="2" destOrd="0" presId="urn:microsoft.com/office/officeart/2005/8/layout/vList5"/>
    <dgm:cxn modelId="{8EE30A21-17AC-A34E-A945-33D32D0CD928}" type="presParOf" srcId="{277D1FDC-6CD3-BB41-8E20-960C658417CF}" destId="{6CEBA26E-9501-3E41-ACBB-39C96B19A924}" srcOrd="0" destOrd="0" presId="urn:microsoft.com/office/officeart/2005/8/layout/vList5"/>
    <dgm:cxn modelId="{3CCA96C7-C68E-DA49-A8B4-DD728A5A5A21}" type="presParOf" srcId="{277D1FDC-6CD3-BB41-8E20-960C658417CF}" destId="{2EB4DD27-0645-2048-89E9-55CE50FE52DA}" srcOrd="1" destOrd="0" presId="urn:microsoft.com/office/officeart/2005/8/layout/vList5"/>
    <dgm:cxn modelId="{4AF2BADF-B9C1-834B-AC41-60901F7D6D95}" type="presParOf" srcId="{C651D352-06FA-1B42-81FF-A95099FE5645}" destId="{33CCAA17-6648-4F4C-9AC2-5ECE7EDB6E70}" srcOrd="3" destOrd="0" presId="urn:microsoft.com/office/officeart/2005/8/layout/vList5"/>
    <dgm:cxn modelId="{2A4E440E-B7D6-6B49-8318-F6B71A21E6CF}" type="presParOf" srcId="{C651D352-06FA-1B42-81FF-A95099FE5645}" destId="{B97FC210-8EA1-614A-91AB-916C1AEFBDEE}" srcOrd="4" destOrd="0" presId="urn:microsoft.com/office/officeart/2005/8/layout/vList5"/>
    <dgm:cxn modelId="{2BDD0334-A1D2-DC42-B9D1-68F24D23B5D5}" type="presParOf" srcId="{B97FC210-8EA1-614A-91AB-916C1AEFBDEE}" destId="{A3A63788-1227-B240-AFF4-87DA3887717D}" srcOrd="0" destOrd="0" presId="urn:microsoft.com/office/officeart/2005/8/layout/vList5"/>
    <dgm:cxn modelId="{C69877D5-79C1-9F4C-B7F4-8AD7D15754EE}" type="presParOf" srcId="{B97FC210-8EA1-614A-91AB-916C1AEFBDEE}" destId="{5432570E-A980-7C49-B78B-FBD7E95247D6}" srcOrd="1" destOrd="0" presId="urn:microsoft.com/office/officeart/2005/8/layout/vList5"/>
    <dgm:cxn modelId="{33ACEA31-C6CD-5547-BED3-2458723FCA4A}" type="presParOf" srcId="{C651D352-06FA-1B42-81FF-A95099FE5645}" destId="{3E055F9F-21A2-424C-8A4E-65EE89C8A916}" srcOrd="5" destOrd="0" presId="urn:microsoft.com/office/officeart/2005/8/layout/vList5"/>
    <dgm:cxn modelId="{A37DA9BE-A47E-BB4D-9CC1-632CE186629D}" type="presParOf" srcId="{C651D352-06FA-1B42-81FF-A95099FE5645}" destId="{3D7F3715-4665-FB42-B9D8-1FF06FE7ED04}" srcOrd="6" destOrd="0" presId="urn:microsoft.com/office/officeart/2005/8/layout/vList5"/>
    <dgm:cxn modelId="{C891109C-0686-B74F-8141-60300585C701}" type="presParOf" srcId="{3D7F3715-4665-FB42-B9D8-1FF06FE7ED04}" destId="{F459C834-8503-9C47-9E88-19B5B264D39A}" srcOrd="0" destOrd="0" presId="urn:microsoft.com/office/officeart/2005/8/layout/vList5"/>
    <dgm:cxn modelId="{2F31821D-0811-794B-B121-3DE9146709AD}" type="presParOf" srcId="{3D7F3715-4665-FB42-B9D8-1FF06FE7ED04}" destId="{B11406A9-5BCB-7247-9C38-2B1D2505F2B8}" srcOrd="1" destOrd="0" presId="urn:microsoft.com/office/officeart/2005/8/layout/vList5"/>
    <dgm:cxn modelId="{0F8FFFCC-28B5-A844-A0C0-4277188A3AC8}" type="presParOf" srcId="{C651D352-06FA-1B42-81FF-A95099FE5645}" destId="{E355AC6F-4099-CB47-B889-4B740E437363}" srcOrd="7" destOrd="0" presId="urn:microsoft.com/office/officeart/2005/8/layout/vList5"/>
    <dgm:cxn modelId="{53EF242F-1951-6046-AB59-C18248626329}" type="presParOf" srcId="{C651D352-06FA-1B42-81FF-A95099FE5645}" destId="{A60CA7D8-39CB-954A-95BD-9B247DA4C063}" srcOrd="8" destOrd="0" presId="urn:microsoft.com/office/officeart/2005/8/layout/vList5"/>
    <dgm:cxn modelId="{ED3BF37E-4F96-D544-B638-C0AB83F1A9B4}" type="presParOf" srcId="{A60CA7D8-39CB-954A-95BD-9B247DA4C063}" destId="{4D3677DD-203E-6A46-986E-4A5C658C9303}" srcOrd="0" destOrd="0" presId="urn:microsoft.com/office/officeart/2005/8/layout/vList5"/>
    <dgm:cxn modelId="{5F05AF10-2999-E74B-852A-D64954D94FF8}" type="presParOf" srcId="{A60CA7D8-39CB-954A-95BD-9B247DA4C063}" destId="{DF481026-182D-AB4B-A938-B9E12915351D}" srcOrd="1" destOrd="0" presId="urn:microsoft.com/office/officeart/2005/8/layout/vList5"/>
    <dgm:cxn modelId="{ACD94F81-0016-934D-9BD5-68D8F780E3B7}" type="presParOf" srcId="{C651D352-06FA-1B42-81FF-A95099FE5645}" destId="{0E9316E9-2C30-AB47-AE90-7E8E046E1AFD}" srcOrd="9" destOrd="0" presId="urn:microsoft.com/office/officeart/2005/8/layout/vList5"/>
    <dgm:cxn modelId="{F8E487A0-A252-584F-8A38-3822D4AF8219}" type="presParOf" srcId="{C651D352-06FA-1B42-81FF-A95099FE5645}" destId="{037794A2-D322-8E40-B011-CE07ECE52AD6}" srcOrd="10" destOrd="0" presId="urn:microsoft.com/office/officeart/2005/8/layout/vList5"/>
    <dgm:cxn modelId="{67548826-ED42-6242-AA6A-DBBB72691D13}" type="presParOf" srcId="{037794A2-D322-8E40-B011-CE07ECE52AD6}" destId="{B6C279C8-1B63-3845-ADAB-B82AEFA3D8E4}" srcOrd="0" destOrd="0" presId="urn:microsoft.com/office/officeart/2005/8/layout/vList5"/>
    <dgm:cxn modelId="{B87CE2C3-5909-4C4E-A75A-B68815D3150A}" type="presParOf" srcId="{037794A2-D322-8E40-B011-CE07ECE52AD6}" destId="{95DA0D8B-BC89-0948-909A-C298332DBD75}" srcOrd="1" destOrd="0" presId="urn:microsoft.com/office/officeart/2005/8/layout/vList5"/>
    <dgm:cxn modelId="{B702A7F2-2B11-8D48-B9AE-A25D0DE633A1}" type="presParOf" srcId="{C651D352-06FA-1B42-81FF-A95099FE5645}" destId="{05C8E7F6-EE84-404A-A830-A5238A04D5A3}" srcOrd="11" destOrd="0" presId="urn:microsoft.com/office/officeart/2005/8/layout/vList5"/>
    <dgm:cxn modelId="{5D36C750-8050-AB49-B923-84B64CB9D59C}" type="presParOf" srcId="{C651D352-06FA-1B42-81FF-A95099FE5645}" destId="{450D1F74-F684-8F4C-A8B3-6F8B553AB682}" srcOrd="12" destOrd="0" presId="urn:microsoft.com/office/officeart/2005/8/layout/vList5"/>
    <dgm:cxn modelId="{69DDD68C-0D88-6141-B93A-2DFC27495FCF}" type="presParOf" srcId="{450D1F74-F684-8F4C-A8B3-6F8B553AB682}" destId="{B67BA8B7-08DC-C244-8300-FCD547033DBD}" srcOrd="0" destOrd="0" presId="urn:microsoft.com/office/officeart/2005/8/layout/vList5"/>
    <dgm:cxn modelId="{772109BC-D0C5-5C47-B68B-C1F238D6D77F}" type="presParOf" srcId="{450D1F74-F684-8F4C-A8B3-6F8B553AB682}" destId="{9D2B4FF6-13FB-EF49-977A-31DF5EE58099}" srcOrd="1" destOrd="0" presId="urn:microsoft.com/office/officeart/2005/8/layout/vList5"/>
    <dgm:cxn modelId="{5EBAD0AC-A244-A44E-ADFB-53F20C58044C}" type="presParOf" srcId="{C651D352-06FA-1B42-81FF-A95099FE5645}" destId="{580F7313-AC0F-FA49-A45E-0C9486F52D6E}" srcOrd="13" destOrd="0" presId="urn:microsoft.com/office/officeart/2005/8/layout/vList5"/>
    <dgm:cxn modelId="{6E9922E5-478F-AF4D-9DCA-7A72508F4F6D}" type="presParOf" srcId="{C651D352-06FA-1B42-81FF-A95099FE5645}" destId="{E737A561-EB87-EC46-B404-0D8CDB0DE287}" srcOrd="14" destOrd="0" presId="urn:microsoft.com/office/officeart/2005/8/layout/vList5"/>
    <dgm:cxn modelId="{8E470ECC-4731-EF49-B2A8-AD4470B8AD53}" type="presParOf" srcId="{E737A561-EB87-EC46-B404-0D8CDB0DE287}" destId="{D5D04DA4-D0C2-DE47-8C8C-0B8EFFA304FE}" srcOrd="0" destOrd="0" presId="urn:microsoft.com/office/officeart/2005/8/layout/vList5"/>
    <dgm:cxn modelId="{B9608D4F-B546-F142-90CB-D6437FE05ACF}" type="presParOf" srcId="{E737A561-EB87-EC46-B404-0D8CDB0DE287}" destId="{8CF3EAF4-8574-9841-9B3E-4FBF8CB57172}"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CE7EC2B3-709C-7049-AC98-40D647A08CD5}" type="doc">
      <dgm:prSet loTypeId="urn:microsoft.com/office/officeart/2005/8/layout/vList5" loCatId="" qsTypeId="urn:microsoft.com/office/officeart/2005/8/quickstyle/simple1" qsCatId="simple" csTypeId="urn:microsoft.com/office/officeart/2005/8/colors/accent1_2" csCatId="accent1" phldr="1"/>
      <dgm:spPr/>
      <dgm:t>
        <a:bodyPr/>
        <a:lstStyle/>
        <a:p>
          <a:endParaRPr lang="en-US"/>
        </a:p>
      </dgm:t>
    </dgm:pt>
    <dgm:pt modelId="{54EB0C78-47D0-4144-BBA1-ED83F2276A80}">
      <dgm:prSet phldrT="[Text]"/>
      <dgm:spPr/>
      <dgm:t>
        <a:bodyPr/>
        <a:lstStyle/>
        <a:p>
          <a:r>
            <a:rPr lang="en-US" dirty="0"/>
            <a:t>1</a:t>
          </a:r>
        </a:p>
      </dgm:t>
    </dgm:pt>
    <dgm:pt modelId="{46A28A5B-8A7C-BF49-A5DC-996D874F74B0}" type="parTrans" cxnId="{54AEA8B7-F89B-724F-98A1-0AEC5D7FC3A2}">
      <dgm:prSet/>
      <dgm:spPr/>
      <dgm:t>
        <a:bodyPr/>
        <a:lstStyle/>
        <a:p>
          <a:endParaRPr lang="en-US"/>
        </a:p>
      </dgm:t>
    </dgm:pt>
    <dgm:pt modelId="{E8376F97-8FAC-AA43-868D-BB3E335B92F2}" type="sibTrans" cxnId="{54AEA8B7-F89B-724F-98A1-0AEC5D7FC3A2}">
      <dgm:prSet/>
      <dgm:spPr/>
      <dgm:t>
        <a:bodyPr/>
        <a:lstStyle/>
        <a:p>
          <a:endParaRPr lang="en-US"/>
        </a:p>
      </dgm:t>
    </dgm:pt>
    <dgm:pt modelId="{D57A6E2B-1DF9-5046-BC1D-709A01F64D7F}">
      <dgm:prSet phldrT="[Text]"/>
      <dgm:spPr/>
      <dgm:t>
        <a:bodyPr/>
        <a:lstStyle/>
        <a:p>
          <a:r>
            <a:rPr lang="en-US"/>
            <a:t>Patient stability</a:t>
          </a:r>
          <a:endParaRPr lang="en-US" dirty="0"/>
        </a:p>
      </dgm:t>
    </dgm:pt>
    <dgm:pt modelId="{C76AEE8B-D94A-7D44-B03A-3FE0785274DD}" type="parTrans" cxnId="{B2C59790-5949-8740-B37D-5567793C306C}">
      <dgm:prSet/>
      <dgm:spPr/>
      <dgm:t>
        <a:bodyPr/>
        <a:lstStyle/>
        <a:p>
          <a:endParaRPr lang="en-US"/>
        </a:p>
      </dgm:t>
    </dgm:pt>
    <dgm:pt modelId="{55132C62-F393-2540-A3F5-1E79E69F36CF}" type="sibTrans" cxnId="{B2C59790-5949-8740-B37D-5567793C306C}">
      <dgm:prSet/>
      <dgm:spPr/>
      <dgm:t>
        <a:bodyPr/>
        <a:lstStyle/>
        <a:p>
          <a:endParaRPr lang="en-US"/>
        </a:p>
      </dgm:t>
    </dgm:pt>
    <dgm:pt modelId="{8E966A69-49F1-5E4B-B606-FCAEDAA984ED}">
      <dgm:prSet phldrT="[Text]"/>
      <dgm:spPr/>
      <dgm:t>
        <a:bodyPr/>
        <a:lstStyle/>
        <a:p>
          <a:r>
            <a:rPr lang="en-US" dirty="0"/>
            <a:t>Emotional check</a:t>
          </a:r>
        </a:p>
      </dgm:t>
    </dgm:pt>
    <dgm:pt modelId="{6E022D76-54D3-5040-BFB1-6E3CF648085C}" type="sibTrans" cxnId="{FBB45EE4-904A-AF48-A0C9-CB655E66EF52}">
      <dgm:prSet/>
      <dgm:spPr/>
      <dgm:t>
        <a:bodyPr/>
        <a:lstStyle/>
        <a:p>
          <a:endParaRPr lang="en-US"/>
        </a:p>
      </dgm:t>
    </dgm:pt>
    <dgm:pt modelId="{DBAD8E5C-BD8A-8D4C-B4F0-8493200D7696}" type="parTrans" cxnId="{FBB45EE4-904A-AF48-A0C9-CB655E66EF52}">
      <dgm:prSet/>
      <dgm:spPr/>
      <dgm:t>
        <a:bodyPr/>
        <a:lstStyle/>
        <a:p>
          <a:endParaRPr lang="en-US"/>
        </a:p>
      </dgm:t>
    </dgm:pt>
    <dgm:pt modelId="{E900B89A-C42B-5249-B68C-A3D7ECDC2722}">
      <dgm:prSet phldrT="[Text]"/>
      <dgm:spPr/>
      <dgm:t>
        <a:bodyPr/>
        <a:lstStyle/>
        <a:p>
          <a:r>
            <a:rPr lang="en-US" dirty="0"/>
            <a:t>Address bias</a:t>
          </a:r>
        </a:p>
      </dgm:t>
    </dgm:pt>
    <dgm:pt modelId="{1CCB8A03-5593-CE44-86BA-AACEAE0CCB98}" type="sibTrans" cxnId="{8EA459AB-225B-8C4D-9825-5D1C6BF10277}">
      <dgm:prSet/>
      <dgm:spPr/>
      <dgm:t>
        <a:bodyPr/>
        <a:lstStyle/>
        <a:p>
          <a:endParaRPr lang="en-US"/>
        </a:p>
      </dgm:t>
    </dgm:pt>
    <dgm:pt modelId="{8E839505-C7B5-E846-B572-409C6E14F87D}" type="parTrans" cxnId="{8EA459AB-225B-8C4D-9825-5D1C6BF10277}">
      <dgm:prSet/>
      <dgm:spPr/>
      <dgm:t>
        <a:bodyPr/>
        <a:lstStyle/>
        <a:p>
          <a:endParaRPr lang="en-US"/>
        </a:p>
      </dgm:t>
    </dgm:pt>
    <dgm:pt modelId="{77E26394-E137-5E44-9434-AC75CD3E8E1C}">
      <dgm:prSet/>
      <dgm:spPr/>
      <dgm:t>
        <a:bodyPr/>
        <a:lstStyle/>
        <a:p>
          <a:r>
            <a:rPr lang="en-US" dirty="0"/>
            <a:t>Align with patient</a:t>
          </a:r>
        </a:p>
      </dgm:t>
    </dgm:pt>
    <dgm:pt modelId="{4162CFAB-B676-8E4E-8FEB-32BD16B62DEC}" type="sibTrans" cxnId="{3055A850-65BD-2C48-A538-0AAEB9138E85}">
      <dgm:prSet/>
      <dgm:spPr/>
      <dgm:t>
        <a:bodyPr/>
        <a:lstStyle/>
        <a:p>
          <a:endParaRPr lang="en-US"/>
        </a:p>
      </dgm:t>
    </dgm:pt>
    <dgm:pt modelId="{0106416C-C608-3E4B-95A9-3A27F212EF0D}" type="parTrans" cxnId="{3055A850-65BD-2C48-A538-0AAEB9138E85}">
      <dgm:prSet/>
      <dgm:spPr/>
      <dgm:t>
        <a:bodyPr/>
        <a:lstStyle/>
        <a:p>
          <a:endParaRPr lang="en-US"/>
        </a:p>
      </dgm:t>
    </dgm:pt>
    <dgm:pt modelId="{B3ABDBBC-28C2-CC44-9EA0-940A074F9BF0}">
      <dgm:prSet/>
      <dgm:spPr/>
      <dgm:t>
        <a:bodyPr/>
        <a:lstStyle/>
        <a:p>
          <a:r>
            <a:rPr lang="en-US" dirty="0"/>
            <a:t>Align with team</a:t>
          </a:r>
        </a:p>
      </dgm:t>
    </dgm:pt>
    <dgm:pt modelId="{B1A1C092-087B-F241-9B26-AD1D13C72D4D}" type="sibTrans" cxnId="{D85391B8-F585-FD43-82E0-8ACB9B810BF4}">
      <dgm:prSet/>
      <dgm:spPr/>
      <dgm:t>
        <a:bodyPr/>
        <a:lstStyle/>
        <a:p>
          <a:endParaRPr lang="en-US"/>
        </a:p>
      </dgm:t>
    </dgm:pt>
    <dgm:pt modelId="{D1297B60-D255-DA44-8D75-399213932CFB}" type="parTrans" cxnId="{D85391B8-F585-FD43-82E0-8ACB9B810BF4}">
      <dgm:prSet/>
      <dgm:spPr/>
      <dgm:t>
        <a:bodyPr/>
        <a:lstStyle/>
        <a:p>
          <a:endParaRPr lang="en-US"/>
        </a:p>
      </dgm:t>
    </dgm:pt>
    <dgm:pt modelId="{D6BB4A41-00B2-5448-BB3F-80605AC75A4E}">
      <dgm:prSet/>
      <dgm:spPr/>
      <dgm:t>
        <a:bodyPr/>
        <a:lstStyle/>
        <a:p>
          <a:r>
            <a:rPr lang="en-US" dirty="0"/>
            <a:t>Set boundaries</a:t>
          </a:r>
        </a:p>
      </dgm:t>
    </dgm:pt>
    <dgm:pt modelId="{A3F6C628-648D-0249-B65F-551AF9ECEEA6}" type="sibTrans" cxnId="{DF1A41C0-D8B8-6D4F-A8A5-91EC68AFBCAD}">
      <dgm:prSet/>
      <dgm:spPr/>
      <dgm:t>
        <a:bodyPr/>
        <a:lstStyle/>
        <a:p>
          <a:endParaRPr lang="en-US"/>
        </a:p>
      </dgm:t>
    </dgm:pt>
    <dgm:pt modelId="{4E04882C-8060-1D42-8502-5D210AA0DCD3}" type="parTrans" cxnId="{DF1A41C0-D8B8-6D4F-A8A5-91EC68AFBCAD}">
      <dgm:prSet/>
      <dgm:spPr/>
      <dgm:t>
        <a:bodyPr/>
        <a:lstStyle/>
        <a:p>
          <a:endParaRPr lang="en-US"/>
        </a:p>
      </dgm:t>
    </dgm:pt>
    <dgm:pt modelId="{4042EA18-93B7-8447-AC0A-58BAED6135AA}">
      <dgm:prSet/>
      <dgm:spPr/>
      <dgm:t>
        <a:bodyPr/>
        <a:lstStyle/>
        <a:p>
          <a:r>
            <a:rPr lang="en-US" dirty="0"/>
            <a:t>Seek support</a:t>
          </a:r>
        </a:p>
      </dgm:t>
    </dgm:pt>
    <dgm:pt modelId="{A608511D-1BB9-EB4E-9E74-CCD7B0DB861D}" type="sibTrans" cxnId="{BBBA16DC-BC73-8048-A725-FE1EF1BF6593}">
      <dgm:prSet/>
      <dgm:spPr/>
      <dgm:t>
        <a:bodyPr/>
        <a:lstStyle/>
        <a:p>
          <a:endParaRPr lang="en-US"/>
        </a:p>
      </dgm:t>
    </dgm:pt>
    <dgm:pt modelId="{2F5CB061-56DE-EB4D-BFD4-36B00E6055CB}" type="parTrans" cxnId="{BBBA16DC-BC73-8048-A725-FE1EF1BF6593}">
      <dgm:prSet/>
      <dgm:spPr/>
      <dgm:t>
        <a:bodyPr/>
        <a:lstStyle/>
        <a:p>
          <a:endParaRPr lang="en-US"/>
        </a:p>
      </dgm:t>
    </dgm:pt>
    <dgm:pt modelId="{0545D5E0-C6B3-A447-B001-E955BFE39730}">
      <dgm:prSet/>
      <dgm:spPr/>
      <dgm:t>
        <a:bodyPr/>
        <a:lstStyle/>
        <a:p>
          <a:r>
            <a:rPr lang="en-US" dirty="0"/>
            <a:t>Give space</a:t>
          </a:r>
        </a:p>
      </dgm:t>
    </dgm:pt>
    <dgm:pt modelId="{43A03E68-4CAE-A344-B58C-38B13B6EE776}" type="sibTrans" cxnId="{E2BB9BC9-6DB1-9443-8E35-6250A99E4AD7}">
      <dgm:prSet/>
      <dgm:spPr/>
      <dgm:t>
        <a:bodyPr/>
        <a:lstStyle/>
        <a:p>
          <a:endParaRPr lang="en-US"/>
        </a:p>
      </dgm:t>
    </dgm:pt>
    <dgm:pt modelId="{74548467-254B-2943-9A99-08C07F3E448D}" type="parTrans" cxnId="{E2BB9BC9-6DB1-9443-8E35-6250A99E4AD7}">
      <dgm:prSet/>
      <dgm:spPr/>
      <dgm:t>
        <a:bodyPr/>
        <a:lstStyle/>
        <a:p>
          <a:endParaRPr lang="en-US"/>
        </a:p>
      </dgm:t>
    </dgm:pt>
    <dgm:pt modelId="{7CF6944D-D814-F446-BDE2-B55C1C344687}">
      <dgm:prSet/>
      <dgm:spPr/>
      <dgm:t>
        <a:bodyPr/>
        <a:lstStyle/>
        <a:p>
          <a:r>
            <a:rPr lang="en-US" dirty="0"/>
            <a:t>8</a:t>
          </a:r>
        </a:p>
      </dgm:t>
    </dgm:pt>
    <dgm:pt modelId="{41CA9CD1-BD05-D240-8585-F6D044F469D5}" type="sibTrans" cxnId="{B4BAA057-82A7-8F4F-B3AE-D2474B9F0D61}">
      <dgm:prSet/>
      <dgm:spPr/>
      <dgm:t>
        <a:bodyPr/>
        <a:lstStyle/>
        <a:p>
          <a:endParaRPr lang="en-US"/>
        </a:p>
      </dgm:t>
    </dgm:pt>
    <dgm:pt modelId="{18766106-4E88-954F-80B4-8435CD7E3607}" type="parTrans" cxnId="{B4BAA057-82A7-8F4F-B3AE-D2474B9F0D61}">
      <dgm:prSet/>
      <dgm:spPr/>
      <dgm:t>
        <a:bodyPr/>
        <a:lstStyle/>
        <a:p>
          <a:endParaRPr lang="en-US"/>
        </a:p>
      </dgm:t>
    </dgm:pt>
    <dgm:pt modelId="{02BDF100-8338-E043-96F5-EE898B9D5AB2}">
      <dgm:prSet/>
      <dgm:spPr/>
      <dgm:t>
        <a:bodyPr/>
        <a:lstStyle/>
        <a:p>
          <a:r>
            <a:rPr lang="en-US" dirty="0"/>
            <a:t>7</a:t>
          </a:r>
        </a:p>
      </dgm:t>
    </dgm:pt>
    <dgm:pt modelId="{BCE247F3-63ED-824C-BC43-9D645F88694B}" type="sibTrans" cxnId="{F6183E77-6BBF-FA47-854D-F0D53AE21A8A}">
      <dgm:prSet/>
      <dgm:spPr/>
      <dgm:t>
        <a:bodyPr/>
        <a:lstStyle/>
        <a:p>
          <a:endParaRPr lang="en-US"/>
        </a:p>
      </dgm:t>
    </dgm:pt>
    <dgm:pt modelId="{1B53CCA0-CFF2-384B-856E-1EBDFA4D02AD}" type="parTrans" cxnId="{F6183E77-6BBF-FA47-854D-F0D53AE21A8A}">
      <dgm:prSet/>
      <dgm:spPr/>
      <dgm:t>
        <a:bodyPr/>
        <a:lstStyle/>
        <a:p>
          <a:endParaRPr lang="en-US"/>
        </a:p>
      </dgm:t>
    </dgm:pt>
    <dgm:pt modelId="{9F6E5C8F-12F1-3545-94A6-291C5042E69E}">
      <dgm:prSet/>
      <dgm:spPr/>
      <dgm:t>
        <a:bodyPr/>
        <a:lstStyle/>
        <a:p>
          <a:r>
            <a:rPr lang="en-US" dirty="0"/>
            <a:t>6</a:t>
          </a:r>
        </a:p>
      </dgm:t>
    </dgm:pt>
    <dgm:pt modelId="{F501E3C1-886B-5244-A7B1-7A80D72A4D8C}" type="sibTrans" cxnId="{545F95DE-9A10-3948-9807-36C195D34A35}">
      <dgm:prSet/>
      <dgm:spPr/>
      <dgm:t>
        <a:bodyPr/>
        <a:lstStyle/>
        <a:p>
          <a:endParaRPr lang="en-US"/>
        </a:p>
      </dgm:t>
    </dgm:pt>
    <dgm:pt modelId="{F878F1E0-BA83-0B4F-8407-D69A3E0606E8}" type="parTrans" cxnId="{545F95DE-9A10-3948-9807-36C195D34A35}">
      <dgm:prSet/>
      <dgm:spPr/>
      <dgm:t>
        <a:bodyPr/>
        <a:lstStyle/>
        <a:p>
          <a:endParaRPr lang="en-US"/>
        </a:p>
      </dgm:t>
    </dgm:pt>
    <dgm:pt modelId="{827957E1-E296-1C4F-A5F6-1C5FE324A00C}">
      <dgm:prSet/>
      <dgm:spPr/>
      <dgm:t>
        <a:bodyPr/>
        <a:lstStyle/>
        <a:p>
          <a:r>
            <a:rPr lang="en-US" dirty="0"/>
            <a:t>5</a:t>
          </a:r>
        </a:p>
      </dgm:t>
    </dgm:pt>
    <dgm:pt modelId="{9F52F0F0-B16C-AB44-86AF-35AA79D5B0BB}" type="sibTrans" cxnId="{C5A31E1B-1939-A943-9EA9-0D1F931C9095}">
      <dgm:prSet/>
      <dgm:spPr/>
      <dgm:t>
        <a:bodyPr/>
        <a:lstStyle/>
        <a:p>
          <a:endParaRPr lang="en-US"/>
        </a:p>
      </dgm:t>
    </dgm:pt>
    <dgm:pt modelId="{AC89EDA2-97A0-704F-A224-66777968DC79}" type="parTrans" cxnId="{C5A31E1B-1939-A943-9EA9-0D1F931C9095}">
      <dgm:prSet/>
      <dgm:spPr/>
      <dgm:t>
        <a:bodyPr/>
        <a:lstStyle/>
        <a:p>
          <a:endParaRPr lang="en-US"/>
        </a:p>
      </dgm:t>
    </dgm:pt>
    <dgm:pt modelId="{418E94F4-4F87-154C-8C2C-4FA1854F2962}">
      <dgm:prSet/>
      <dgm:spPr/>
      <dgm:t>
        <a:bodyPr/>
        <a:lstStyle/>
        <a:p>
          <a:r>
            <a:rPr lang="en-US" dirty="0"/>
            <a:t>4</a:t>
          </a:r>
        </a:p>
      </dgm:t>
    </dgm:pt>
    <dgm:pt modelId="{A5C1BCA8-59E6-2D47-BF9C-24A0A56844F7}" type="sibTrans" cxnId="{2BBF3C50-1ED6-9847-B76B-936F9EDE5606}">
      <dgm:prSet/>
      <dgm:spPr/>
      <dgm:t>
        <a:bodyPr/>
        <a:lstStyle/>
        <a:p>
          <a:endParaRPr lang="en-US"/>
        </a:p>
      </dgm:t>
    </dgm:pt>
    <dgm:pt modelId="{67B29BF1-08A2-E04F-9D69-0598739CF13B}" type="parTrans" cxnId="{2BBF3C50-1ED6-9847-B76B-936F9EDE5606}">
      <dgm:prSet/>
      <dgm:spPr/>
      <dgm:t>
        <a:bodyPr/>
        <a:lstStyle/>
        <a:p>
          <a:endParaRPr lang="en-US"/>
        </a:p>
      </dgm:t>
    </dgm:pt>
    <dgm:pt modelId="{73A345CE-36FD-894D-BBC6-F1148569A643}">
      <dgm:prSet phldrT="[Text]"/>
      <dgm:spPr/>
      <dgm:t>
        <a:bodyPr/>
        <a:lstStyle/>
        <a:p>
          <a:r>
            <a:rPr lang="en-US" dirty="0"/>
            <a:t>3</a:t>
          </a:r>
        </a:p>
      </dgm:t>
    </dgm:pt>
    <dgm:pt modelId="{7A99C83F-BC00-3743-81E8-552BD253CEC3}" type="sibTrans" cxnId="{408ED183-BF58-1C4B-97FD-732582625FEF}">
      <dgm:prSet/>
      <dgm:spPr/>
      <dgm:t>
        <a:bodyPr/>
        <a:lstStyle/>
        <a:p>
          <a:endParaRPr lang="en-US"/>
        </a:p>
      </dgm:t>
    </dgm:pt>
    <dgm:pt modelId="{E3B27BD6-FBE2-5640-8D4A-26A5222CC3EA}" type="parTrans" cxnId="{408ED183-BF58-1C4B-97FD-732582625FEF}">
      <dgm:prSet/>
      <dgm:spPr/>
      <dgm:t>
        <a:bodyPr/>
        <a:lstStyle/>
        <a:p>
          <a:endParaRPr lang="en-US"/>
        </a:p>
      </dgm:t>
    </dgm:pt>
    <dgm:pt modelId="{D03F059F-5021-1F40-A19F-9647158C52AD}">
      <dgm:prSet phldrT="[Text]"/>
      <dgm:spPr/>
      <dgm:t>
        <a:bodyPr/>
        <a:lstStyle/>
        <a:p>
          <a:r>
            <a:rPr lang="en-US" dirty="0"/>
            <a:t>2</a:t>
          </a:r>
        </a:p>
      </dgm:t>
    </dgm:pt>
    <dgm:pt modelId="{294C2440-29C3-A948-ADDD-2D4D34880BDD}" type="sibTrans" cxnId="{65CEA44F-9E16-EA4E-A309-EC3B3016297A}">
      <dgm:prSet/>
      <dgm:spPr/>
      <dgm:t>
        <a:bodyPr/>
        <a:lstStyle/>
        <a:p>
          <a:endParaRPr lang="en-US"/>
        </a:p>
      </dgm:t>
    </dgm:pt>
    <dgm:pt modelId="{CF000D09-B476-0444-AE02-AACE5A32ABB9}" type="parTrans" cxnId="{65CEA44F-9E16-EA4E-A309-EC3B3016297A}">
      <dgm:prSet/>
      <dgm:spPr/>
      <dgm:t>
        <a:bodyPr/>
        <a:lstStyle/>
        <a:p>
          <a:endParaRPr lang="en-US"/>
        </a:p>
      </dgm:t>
    </dgm:pt>
    <dgm:pt modelId="{C651D352-06FA-1B42-81FF-A95099FE5645}" type="pres">
      <dgm:prSet presAssocID="{CE7EC2B3-709C-7049-AC98-40D647A08CD5}" presName="Name0" presStyleCnt="0">
        <dgm:presLayoutVars>
          <dgm:dir/>
          <dgm:animLvl val="lvl"/>
          <dgm:resizeHandles val="exact"/>
        </dgm:presLayoutVars>
      </dgm:prSet>
      <dgm:spPr/>
    </dgm:pt>
    <dgm:pt modelId="{2E2FEDEA-0CB5-FD4B-8718-95B9D6A14304}" type="pres">
      <dgm:prSet presAssocID="{54EB0C78-47D0-4144-BBA1-ED83F2276A80}" presName="linNode" presStyleCnt="0"/>
      <dgm:spPr/>
    </dgm:pt>
    <dgm:pt modelId="{2F0271A3-745A-A943-B67B-E4069A93AE61}" type="pres">
      <dgm:prSet presAssocID="{54EB0C78-47D0-4144-BBA1-ED83F2276A80}" presName="parentText" presStyleLbl="node1" presStyleIdx="0" presStyleCnt="8" custScaleX="67001">
        <dgm:presLayoutVars>
          <dgm:chMax val="1"/>
          <dgm:bulletEnabled val="1"/>
        </dgm:presLayoutVars>
      </dgm:prSet>
      <dgm:spPr/>
    </dgm:pt>
    <dgm:pt modelId="{21D64796-42C1-6A47-B16B-F23C35A117FF}" type="pres">
      <dgm:prSet presAssocID="{54EB0C78-47D0-4144-BBA1-ED83F2276A80}" presName="descendantText" presStyleLbl="alignAccFollowNode1" presStyleIdx="0" presStyleCnt="8">
        <dgm:presLayoutVars>
          <dgm:bulletEnabled val="1"/>
        </dgm:presLayoutVars>
      </dgm:prSet>
      <dgm:spPr/>
    </dgm:pt>
    <dgm:pt modelId="{B2C4C361-6A0B-BC45-90FD-318B0EB08F6D}" type="pres">
      <dgm:prSet presAssocID="{E8376F97-8FAC-AA43-868D-BB3E335B92F2}" presName="sp" presStyleCnt="0"/>
      <dgm:spPr/>
    </dgm:pt>
    <dgm:pt modelId="{277D1FDC-6CD3-BB41-8E20-960C658417CF}" type="pres">
      <dgm:prSet presAssocID="{D03F059F-5021-1F40-A19F-9647158C52AD}" presName="linNode" presStyleCnt="0"/>
      <dgm:spPr/>
    </dgm:pt>
    <dgm:pt modelId="{6CEBA26E-9501-3E41-ACBB-39C96B19A924}" type="pres">
      <dgm:prSet presAssocID="{D03F059F-5021-1F40-A19F-9647158C52AD}" presName="parentText" presStyleLbl="node1" presStyleIdx="1" presStyleCnt="8" custScaleX="67001">
        <dgm:presLayoutVars>
          <dgm:chMax val="1"/>
          <dgm:bulletEnabled val="1"/>
        </dgm:presLayoutVars>
      </dgm:prSet>
      <dgm:spPr/>
    </dgm:pt>
    <dgm:pt modelId="{2EB4DD27-0645-2048-89E9-55CE50FE52DA}" type="pres">
      <dgm:prSet presAssocID="{D03F059F-5021-1F40-A19F-9647158C52AD}" presName="descendantText" presStyleLbl="alignAccFollowNode1" presStyleIdx="1" presStyleCnt="8">
        <dgm:presLayoutVars>
          <dgm:bulletEnabled val="1"/>
        </dgm:presLayoutVars>
      </dgm:prSet>
      <dgm:spPr/>
    </dgm:pt>
    <dgm:pt modelId="{33CCAA17-6648-4F4C-9AC2-5ECE7EDB6E70}" type="pres">
      <dgm:prSet presAssocID="{294C2440-29C3-A948-ADDD-2D4D34880BDD}" presName="sp" presStyleCnt="0"/>
      <dgm:spPr/>
    </dgm:pt>
    <dgm:pt modelId="{B97FC210-8EA1-614A-91AB-916C1AEFBDEE}" type="pres">
      <dgm:prSet presAssocID="{73A345CE-36FD-894D-BBC6-F1148569A643}" presName="linNode" presStyleCnt="0"/>
      <dgm:spPr/>
    </dgm:pt>
    <dgm:pt modelId="{A3A63788-1227-B240-AFF4-87DA3887717D}" type="pres">
      <dgm:prSet presAssocID="{73A345CE-36FD-894D-BBC6-F1148569A643}" presName="parentText" presStyleLbl="node1" presStyleIdx="2" presStyleCnt="8" custScaleX="67001">
        <dgm:presLayoutVars>
          <dgm:chMax val="1"/>
          <dgm:bulletEnabled val="1"/>
        </dgm:presLayoutVars>
      </dgm:prSet>
      <dgm:spPr/>
    </dgm:pt>
    <dgm:pt modelId="{5432570E-A980-7C49-B78B-FBD7E95247D6}" type="pres">
      <dgm:prSet presAssocID="{73A345CE-36FD-894D-BBC6-F1148569A643}" presName="descendantText" presStyleLbl="alignAccFollowNode1" presStyleIdx="2" presStyleCnt="8">
        <dgm:presLayoutVars>
          <dgm:bulletEnabled val="1"/>
        </dgm:presLayoutVars>
      </dgm:prSet>
      <dgm:spPr/>
    </dgm:pt>
    <dgm:pt modelId="{3E055F9F-21A2-424C-8A4E-65EE89C8A916}" type="pres">
      <dgm:prSet presAssocID="{7A99C83F-BC00-3743-81E8-552BD253CEC3}" presName="sp" presStyleCnt="0"/>
      <dgm:spPr/>
    </dgm:pt>
    <dgm:pt modelId="{3D7F3715-4665-FB42-B9D8-1FF06FE7ED04}" type="pres">
      <dgm:prSet presAssocID="{418E94F4-4F87-154C-8C2C-4FA1854F2962}" presName="linNode" presStyleCnt="0"/>
      <dgm:spPr/>
    </dgm:pt>
    <dgm:pt modelId="{F459C834-8503-9C47-9E88-19B5B264D39A}" type="pres">
      <dgm:prSet presAssocID="{418E94F4-4F87-154C-8C2C-4FA1854F2962}" presName="parentText" presStyleLbl="node1" presStyleIdx="3" presStyleCnt="8" custScaleX="67001">
        <dgm:presLayoutVars>
          <dgm:chMax val="1"/>
          <dgm:bulletEnabled val="1"/>
        </dgm:presLayoutVars>
      </dgm:prSet>
      <dgm:spPr/>
    </dgm:pt>
    <dgm:pt modelId="{B11406A9-5BCB-7247-9C38-2B1D2505F2B8}" type="pres">
      <dgm:prSet presAssocID="{418E94F4-4F87-154C-8C2C-4FA1854F2962}" presName="descendantText" presStyleLbl="alignAccFollowNode1" presStyleIdx="3" presStyleCnt="8">
        <dgm:presLayoutVars>
          <dgm:bulletEnabled val="1"/>
        </dgm:presLayoutVars>
      </dgm:prSet>
      <dgm:spPr/>
    </dgm:pt>
    <dgm:pt modelId="{E355AC6F-4099-CB47-B889-4B740E437363}" type="pres">
      <dgm:prSet presAssocID="{A5C1BCA8-59E6-2D47-BF9C-24A0A56844F7}" presName="sp" presStyleCnt="0"/>
      <dgm:spPr/>
    </dgm:pt>
    <dgm:pt modelId="{A60CA7D8-39CB-954A-95BD-9B247DA4C063}" type="pres">
      <dgm:prSet presAssocID="{827957E1-E296-1C4F-A5F6-1C5FE324A00C}" presName="linNode" presStyleCnt="0"/>
      <dgm:spPr/>
    </dgm:pt>
    <dgm:pt modelId="{4D3677DD-203E-6A46-986E-4A5C658C9303}" type="pres">
      <dgm:prSet presAssocID="{827957E1-E296-1C4F-A5F6-1C5FE324A00C}" presName="parentText" presStyleLbl="node1" presStyleIdx="4" presStyleCnt="8" custScaleX="67001">
        <dgm:presLayoutVars>
          <dgm:chMax val="1"/>
          <dgm:bulletEnabled val="1"/>
        </dgm:presLayoutVars>
      </dgm:prSet>
      <dgm:spPr/>
    </dgm:pt>
    <dgm:pt modelId="{DF481026-182D-AB4B-A938-B9E12915351D}" type="pres">
      <dgm:prSet presAssocID="{827957E1-E296-1C4F-A5F6-1C5FE324A00C}" presName="descendantText" presStyleLbl="alignAccFollowNode1" presStyleIdx="4" presStyleCnt="8">
        <dgm:presLayoutVars>
          <dgm:bulletEnabled val="1"/>
        </dgm:presLayoutVars>
      </dgm:prSet>
      <dgm:spPr/>
    </dgm:pt>
    <dgm:pt modelId="{0E9316E9-2C30-AB47-AE90-7E8E046E1AFD}" type="pres">
      <dgm:prSet presAssocID="{9F52F0F0-B16C-AB44-86AF-35AA79D5B0BB}" presName="sp" presStyleCnt="0"/>
      <dgm:spPr/>
    </dgm:pt>
    <dgm:pt modelId="{037794A2-D322-8E40-B011-CE07ECE52AD6}" type="pres">
      <dgm:prSet presAssocID="{9F6E5C8F-12F1-3545-94A6-291C5042E69E}" presName="linNode" presStyleCnt="0"/>
      <dgm:spPr/>
    </dgm:pt>
    <dgm:pt modelId="{B6C279C8-1B63-3845-ADAB-B82AEFA3D8E4}" type="pres">
      <dgm:prSet presAssocID="{9F6E5C8F-12F1-3545-94A6-291C5042E69E}" presName="parentText" presStyleLbl="node1" presStyleIdx="5" presStyleCnt="8" custScaleX="67001">
        <dgm:presLayoutVars>
          <dgm:chMax val="1"/>
          <dgm:bulletEnabled val="1"/>
        </dgm:presLayoutVars>
      </dgm:prSet>
      <dgm:spPr/>
    </dgm:pt>
    <dgm:pt modelId="{95DA0D8B-BC89-0948-909A-C298332DBD75}" type="pres">
      <dgm:prSet presAssocID="{9F6E5C8F-12F1-3545-94A6-291C5042E69E}" presName="descendantText" presStyleLbl="alignAccFollowNode1" presStyleIdx="5" presStyleCnt="8">
        <dgm:presLayoutVars>
          <dgm:bulletEnabled val="1"/>
        </dgm:presLayoutVars>
      </dgm:prSet>
      <dgm:spPr/>
    </dgm:pt>
    <dgm:pt modelId="{05C8E7F6-EE84-404A-A830-A5238A04D5A3}" type="pres">
      <dgm:prSet presAssocID="{F501E3C1-886B-5244-A7B1-7A80D72A4D8C}" presName="sp" presStyleCnt="0"/>
      <dgm:spPr/>
    </dgm:pt>
    <dgm:pt modelId="{450D1F74-F684-8F4C-A8B3-6F8B553AB682}" type="pres">
      <dgm:prSet presAssocID="{02BDF100-8338-E043-96F5-EE898B9D5AB2}" presName="linNode" presStyleCnt="0"/>
      <dgm:spPr/>
    </dgm:pt>
    <dgm:pt modelId="{B67BA8B7-08DC-C244-8300-FCD547033DBD}" type="pres">
      <dgm:prSet presAssocID="{02BDF100-8338-E043-96F5-EE898B9D5AB2}" presName="parentText" presStyleLbl="node1" presStyleIdx="6" presStyleCnt="8" custScaleX="67001">
        <dgm:presLayoutVars>
          <dgm:chMax val="1"/>
          <dgm:bulletEnabled val="1"/>
        </dgm:presLayoutVars>
      </dgm:prSet>
      <dgm:spPr/>
    </dgm:pt>
    <dgm:pt modelId="{9D2B4FF6-13FB-EF49-977A-31DF5EE58099}" type="pres">
      <dgm:prSet presAssocID="{02BDF100-8338-E043-96F5-EE898B9D5AB2}" presName="descendantText" presStyleLbl="alignAccFollowNode1" presStyleIdx="6" presStyleCnt="8">
        <dgm:presLayoutVars>
          <dgm:bulletEnabled val="1"/>
        </dgm:presLayoutVars>
      </dgm:prSet>
      <dgm:spPr/>
    </dgm:pt>
    <dgm:pt modelId="{580F7313-AC0F-FA49-A45E-0C9486F52D6E}" type="pres">
      <dgm:prSet presAssocID="{BCE247F3-63ED-824C-BC43-9D645F88694B}" presName="sp" presStyleCnt="0"/>
      <dgm:spPr/>
    </dgm:pt>
    <dgm:pt modelId="{E737A561-EB87-EC46-B404-0D8CDB0DE287}" type="pres">
      <dgm:prSet presAssocID="{7CF6944D-D814-F446-BDE2-B55C1C344687}" presName="linNode" presStyleCnt="0"/>
      <dgm:spPr/>
    </dgm:pt>
    <dgm:pt modelId="{D5D04DA4-D0C2-DE47-8C8C-0B8EFFA304FE}" type="pres">
      <dgm:prSet presAssocID="{7CF6944D-D814-F446-BDE2-B55C1C344687}" presName="parentText" presStyleLbl="node1" presStyleIdx="7" presStyleCnt="8" custScaleX="67001">
        <dgm:presLayoutVars>
          <dgm:chMax val="1"/>
          <dgm:bulletEnabled val="1"/>
        </dgm:presLayoutVars>
      </dgm:prSet>
      <dgm:spPr/>
    </dgm:pt>
    <dgm:pt modelId="{8CF3EAF4-8574-9841-9B3E-4FBF8CB57172}" type="pres">
      <dgm:prSet presAssocID="{7CF6944D-D814-F446-BDE2-B55C1C344687}" presName="descendantText" presStyleLbl="alignAccFollowNode1" presStyleIdx="7" presStyleCnt="8">
        <dgm:presLayoutVars>
          <dgm:bulletEnabled val="1"/>
        </dgm:presLayoutVars>
      </dgm:prSet>
      <dgm:spPr/>
    </dgm:pt>
  </dgm:ptLst>
  <dgm:cxnLst>
    <dgm:cxn modelId="{E4273A05-E6BD-7B48-BAB7-FF2C885BDD30}" type="presOf" srcId="{02BDF100-8338-E043-96F5-EE898B9D5AB2}" destId="{B67BA8B7-08DC-C244-8300-FCD547033DBD}" srcOrd="0" destOrd="0" presId="urn:microsoft.com/office/officeart/2005/8/layout/vList5"/>
    <dgm:cxn modelId="{E9D1E10C-1628-524C-9321-D84C071FF74D}" type="presOf" srcId="{CE7EC2B3-709C-7049-AC98-40D647A08CD5}" destId="{C651D352-06FA-1B42-81FF-A95099FE5645}" srcOrd="0" destOrd="0" presId="urn:microsoft.com/office/officeart/2005/8/layout/vList5"/>
    <dgm:cxn modelId="{C4160712-DF53-0F4F-9BBA-78BD9BBF4B88}" type="presOf" srcId="{77E26394-E137-5E44-9434-AC75CD3E8E1C}" destId="{B11406A9-5BCB-7247-9C38-2B1D2505F2B8}" srcOrd="0" destOrd="0" presId="urn:microsoft.com/office/officeart/2005/8/layout/vList5"/>
    <dgm:cxn modelId="{C5A31E1B-1939-A943-9EA9-0D1F931C9095}" srcId="{CE7EC2B3-709C-7049-AC98-40D647A08CD5}" destId="{827957E1-E296-1C4F-A5F6-1C5FE324A00C}" srcOrd="4" destOrd="0" parTransId="{AC89EDA2-97A0-704F-A224-66777968DC79}" sibTransId="{9F52F0F0-B16C-AB44-86AF-35AA79D5B0BB}"/>
    <dgm:cxn modelId="{086EAA1D-3224-4E41-87B1-9FA27037DE47}" type="presOf" srcId="{9F6E5C8F-12F1-3545-94A6-291C5042E69E}" destId="{B6C279C8-1B63-3845-ADAB-B82AEFA3D8E4}" srcOrd="0" destOrd="0" presId="urn:microsoft.com/office/officeart/2005/8/layout/vList5"/>
    <dgm:cxn modelId="{71BBC71D-E55C-424F-B6C9-6E507D91D4E5}" type="presOf" srcId="{D6BB4A41-00B2-5448-BB3F-80605AC75A4E}" destId="{95DA0D8B-BC89-0948-909A-C298332DBD75}" srcOrd="0" destOrd="0" presId="urn:microsoft.com/office/officeart/2005/8/layout/vList5"/>
    <dgm:cxn modelId="{7A4CD21E-5C30-9844-B8CC-04D4CC71350C}" type="presOf" srcId="{4042EA18-93B7-8447-AC0A-58BAED6135AA}" destId="{8CF3EAF4-8574-9841-9B3E-4FBF8CB57172}" srcOrd="0" destOrd="0" presId="urn:microsoft.com/office/officeart/2005/8/layout/vList5"/>
    <dgm:cxn modelId="{EA0CCB2E-33A7-7842-AF42-FDB163C3A0DB}" type="presOf" srcId="{8E966A69-49F1-5E4B-B606-FCAEDAA984ED}" destId="{2EB4DD27-0645-2048-89E9-55CE50FE52DA}" srcOrd="0" destOrd="0" presId="urn:microsoft.com/office/officeart/2005/8/layout/vList5"/>
    <dgm:cxn modelId="{65CEA44F-9E16-EA4E-A309-EC3B3016297A}" srcId="{CE7EC2B3-709C-7049-AC98-40D647A08CD5}" destId="{D03F059F-5021-1F40-A19F-9647158C52AD}" srcOrd="1" destOrd="0" parTransId="{CF000D09-B476-0444-AE02-AACE5A32ABB9}" sibTransId="{294C2440-29C3-A948-ADDD-2D4D34880BDD}"/>
    <dgm:cxn modelId="{2BBF3C50-1ED6-9847-B76B-936F9EDE5606}" srcId="{CE7EC2B3-709C-7049-AC98-40D647A08CD5}" destId="{418E94F4-4F87-154C-8C2C-4FA1854F2962}" srcOrd="3" destOrd="0" parTransId="{67B29BF1-08A2-E04F-9D69-0598739CF13B}" sibTransId="{A5C1BCA8-59E6-2D47-BF9C-24A0A56844F7}"/>
    <dgm:cxn modelId="{3055A850-65BD-2C48-A538-0AAEB9138E85}" srcId="{418E94F4-4F87-154C-8C2C-4FA1854F2962}" destId="{77E26394-E137-5E44-9434-AC75CD3E8E1C}" srcOrd="0" destOrd="0" parTransId="{0106416C-C608-3E4B-95A9-3A27F212EF0D}" sibTransId="{4162CFAB-B676-8E4E-8FEB-32BD16B62DEC}"/>
    <dgm:cxn modelId="{B3273152-AF0F-EE4B-8C28-8B1E95E5CD89}" type="presOf" srcId="{E900B89A-C42B-5249-B68C-A3D7ECDC2722}" destId="{5432570E-A980-7C49-B78B-FBD7E95247D6}" srcOrd="0" destOrd="0" presId="urn:microsoft.com/office/officeart/2005/8/layout/vList5"/>
    <dgm:cxn modelId="{90712D57-061F-8444-BA8A-D8DA5E4630C5}" type="presOf" srcId="{73A345CE-36FD-894D-BBC6-F1148569A643}" destId="{A3A63788-1227-B240-AFF4-87DA3887717D}" srcOrd="0" destOrd="0" presId="urn:microsoft.com/office/officeart/2005/8/layout/vList5"/>
    <dgm:cxn modelId="{B4BAA057-82A7-8F4F-B3AE-D2474B9F0D61}" srcId="{CE7EC2B3-709C-7049-AC98-40D647A08CD5}" destId="{7CF6944D-D814-F446-BDE2-B55C1C344687}" srcOrd="7" destOrd="0" parTransId="{18766106-4E88-954F-80B4-8435CD7E3607}" sibTransId="{41CA9CD1-BD05-D240-8585-F6D044F469D5}"/>
    <dgm:cxn modelId="{BAD62360-A798-6A47-A994-B5126C6DDBBA}" type="presOf" srcId="{D57A6E2B-1DF9-5046-BC1D-709A01F64D7F}" destId="{21D64796-42C1-6A47-B16B-F23C35A117FF}" srcOrd="0" destOrd="0" presId="urn:microsoft.com/office/officeart/2005/8/layout/vList5"/>
    <dgm:cxn modelId="{F6183E77-6BBF-FA47-854D-F0D53AE21A8A}" srcId="{CE7EC2B3-709C-7049-AC98-40D647A08CD5}" destId="{02BDF100-8338-E043-96F5-EE898B9D5AB2}" srcOrd="6" destOrd="0" parTransId="{1B53CCA0-CFF2-384B-856E-1EBDFA4D02AD}" sibTransId="{BCE247F3-63ED-824C-BC43-9D645F88694B}"/>
    <dgm:cxn modelId="{89198578-5DCB-6140-878F-E9FD8D67271F}" type="presOf" srcId="{7CF6944D-D814-F446-BDE2-B55C1C344687}" destId="{D5D04DA4-D0C2-DE47-8C8C-0B8EFFA304FE}" srcOrd="0" destOrd="0" presId="urn:microsoft.com/office/officeart/2005/8/layout/vList5"/>
    <dgm:cxn modelId="{408ED183-BF58-1C4B-97FD-732582625FEF}" srcId="{CE7EC2B3-709C-7049-AC98-40D647A08CD5}" destId="{73A345CE-36FD-894D-BBC6-F1148569A643}" srcOrd="2" destOrd="0" parTransId="{E3B27BD6-FBE2-5640-8D4A-26A5222CC3EA}" sibTransId="{7A99C83F-BC00-3743-81E8-552BD253CEC3}"/>
    <dgm:cxn modelId="{B2C59790-5949-8740-B37D-5567793C306C}" srcId="{54EB0C78-47D0-4144-BBA1-ED83F2276A80}" destId="{D57A6E2B-1DF9-5046-BC1D-709A01F64D7F}" srcOrd="0" destOrd="0" parTransId="{C76AEE8B-D94A-7D44-B03A-3FE0785274DD}" sibTransId="{55132C62-F393-2540-A3F5-1E79E69F36CF}"/>
    <dgm:cxn modelId="{2D83CF9B-C8D2-5645-B148-7557D123AE42}" type="presOf" srcId="{827957E1-E296-1C4F-A5F6-1C5FE324A00C}" destId="{4D3677DD-203E-6A46-986E-4A5C658C9303}" srcOrd="0" destOrd="0" presId="urn:microsoft.com/office/officeart/2005/8/layout/vList5"/>
    <dgm:cxn modelId="{D734F3A8-F28E-EC4B-833E-A76A8DF839E2}" type="presOf" srcId="{D03F059F-5021-1F40-A19F-9647158C52AD}" destId="{6CEBA26E-9501-3E41-ACBB-39C96B19A924}" srcOrd="0" destOrd="0" presId="urn:microsoft.com/office/officeart/2005/8/layout/vList5"/>
    <dgm:cxn modelId="{8EA459AB-225B-8C4D-9825-5D1C6BF10277}" srcId="{73A345CE-36FD-894D-BBC6-F1148569A643}" destId="{E900B89A-C42B-5249-B68C-A3D7ECDC2722}" srcOrd="0" destOrd="0" parTransId="{8E839505-C7B5-E846-B572-409C6E14F87D}" sibTransId="{1CCB8A03-5593-CE44-86BA-AACEAE0CCB98}"/>
    <dgm:cxn modelId="{54AEA8B7-F89B-724F-98A1-0AEC5D7FC3A2}" srcId="{CE7EC2B3-709C-7049-AC98-40D647A08CD5}" destId="{54EB0C78-47D0-4144-BBA1-ED83F2276A80}" srcOrd="0" destOrd="0" parTransId="{46A28A5B-8A7C-BF49-A5DC-996D874F74B0}" sibTransId="{E8376F97-8FAC-AA43-868D-BB3E335B92F2}"/>
    <dgm:cxn modelId="{D85391B8-F585-FD43-82E0-8ACB9B810BF4}" srcId="{827957E1-E296-1C4F-A5F6-1C5FE324A00C}" destId="{B3ABDBBC-28C2-CC44-9EA0-940A074F9BF0}" srcOrd="0" destOrd="0" parTransId="{D1297B60-D255-DA44-8D75-399213932CFB}" sibTransId="{B1A1C092-087B-F241-9B26-AD1D13C72D4D}"/>
    <dgm:cxn modelId="{DF1A41C0-D8B8-6D4F-A8A5-91EC68AFBCAD}" srcId="{9F6E5C8F-12F1-3545-94A6-291C5042E69E}" destId="{D6BB4A41-00B2-5448-BB3F-80605AC75A4E}" srcOrd="0" destOrd="0" parTransId="{4E04882C-8060-1D42-8502-5D210AA0DCD3}" sibTransId="{A3F6C628-648D-0249-B65F-551AF9ECEEA6}"/>
    <dgm:cxn modelId="{F2E046C8-391B-6946-ACE6-697EC224AB98}" type="presOf" srcId="{B3ABDBBC-28C2-CC44-9EA0-940A074F9BF0}" destId="{DF481026-182D-AB4B-A938-B9E12915351D}" srcOrd="0" destOrd="0" presId="urn:microsoft.com/office/officeart/2005/8/layout/vList5"/>
    <dgm:cxn modelId="{E2BB9BC9-6DB1-9443-8E35-6250A99E4AD7}" srcId="{02BDF100-8338-E043-96F5-EE898B9D5AB2}" destId="{0545D5E0-C6B3-A447-B001-E955BFE39730}" srcOrd="0" destOrd="0" parTransId="{74548467-254B-2943-9A99-08C07F3E448D}" sibTransId="{43A03E68-4CAE-A344-B58C-38B13B6EE776}"/>
    <dgm:cxn modelId="{A16837DB-2A15-1C45-807B-67AB4EF8E75E}" type="presOf" srcId="{0545D5E0-C6B3-A447-B001-E955BFE39730}" destId="{9D2B4FF6-13FB-EF49-977A-31DF5EE58099}" srcOrd="0" destOrd="0" presId="urn:microsoft.com/office/officeart/2005/8/layout/vList5"/>
    <dgm:cxn modelId="{BBBA16DC-BC73-8048-A725-FE1EF1BF6593}" srcId="{7CF6944D-D814-F446-BDE2-B55C1C344687}" destId="{4042EA18-93B7-8447-AC0A-58BAED6135AA}" srcOrd="0" destOrd="0" parTransId="{2F5CB061-56DE-EB4D-BFD4-36B00E6055CB}" sibTransId="{A608511D-1BB9-EB4E-9E74-CCD7B0DB861D}"/>
    <dgm:cxn modelId="{545F95DE-9A10-3948-9807-36C195D34A35}" srcId="{CE7EC2B3-709C-7049-AC98-40D647A08CD5}" destId="{9F6E5C8F-12F1-3545-94A6-291C5042E69E}" srcOrd="5" destOrd="0" parTransId="{F878F1E0-BA83-0B4F-8407-D69A3E0606E8}" sibTransId="{F501E3C1-886B-5244-A7B1-7A80D72A4D8C}"/>
    <dgm:cxn modelId="{1AC639E1-2DD4-8C49-9596-C5731579DC3A}" type="presOf" srcId="{54EB0C78-47D0-4144-BBA1-ED83F2276A80}" destId="{2F0271A3-745A-A943-B67B-E4069A93AE61}" srcOrd="0" destOrd="0" presId="urn:microsoft.com/office/officeart/2005/8/layout/vList5"/>
    <dgm:cxn modelId="{FBB45EE4-904A-AF48-A0C9-CB655E66EF52}" srcId="{D03F059F-5021-1F40-A19F-9647158C52AD}" destId="{8E966A69-49F1-5E4B-B606-FCAEDAA984ED}" srcOrd="0" destOrd="0" parTransId="{DBAD8E5C-BD8A-8D4C-B4F0-8493200D7696}" sibTransId="{6E022D76-54D3-5040-BFB1-6E3CF648085C}"/>
    <dgm:cxn modelId="{CE4D51EC-1171-9740-9774-3550157EF9C1}" type="presOf" srcId="{418E94F4-4F87-154C-8C2C-4FA1854F2962}" destId="{F459C834-8503-9C47-9E88-19B5B264D39A}" srcOrd="0" destOrd="0" presId="urn:microsoft.com/office/officeart/2005/8/layout/vList5"/>
    <dgm:cxn modelId="{BF236B13-02D1-B64C-986F-0CAF7E0612E5}" type="presParOf" srcId="{C651D352-06FA-1B42-81FF-A95099FE5645}" destId="{2E2FEDEA-0CB5-FD4B-8718-95B9D6A14304}" srcOrd="0" destOrd="0" presId="urn:microsoft.com/office/officeart/2005/8/layout/vList5"/>
    <dgm:cxn modelId="{9578A504-AB23-5044-A923-D3DEFAE4D5E7}" type="presParOf" srcId="{2E2FEDEA-0CB5-FD4B-8718-95B9D6A14304}" destId="{2F0271A3-745A-A943-B67B-E4069A93AE61}" srcOrd="0" destOrd="0" presId="urn:microsoft.com/office/officeart/2005/8/layout/vList5"/>
    <dgm:cxn modelId="{253C94D8-1885-B543-AF3D-F6A1DD424873}" type="presParOf" srcId="{2E2FEDEA-0CB5-FD4B-8718-95B9D6A14304}" destId="{21D64796-42C1-6A47-B16B-F23C35A117FF}" srcOrd="1" destOrd="0" presId="urn:microsoft.com/office/officeart/2005/8/layout/vList5"/>
    <dgm:cxn modelId="{C06B9A2B-4F20-7C45-806D-5E7956B4F171}" type="presParOf" srcId="{C651D352-06FA-1B42-81FF-A95099FE5645}" destId="{B2C4C361-6A0B-BC45-90FD-318B0EB08F6D}" srcOrd="1" destOrd="0" presId="urn:microsoft.com/office/officeart/2005/8/layout/vList5"/>
    <dgm:cxn modelId="{7BF712B5-32BC-7844-BF86-9BFE0BE03182}" type="presParOf" srcId="{C651D352-06FA-1B42-81FF-A95099FE5645}" destId="{277D1FDC-6CD3-BB41-8E20-960C658417CF}" srcOrd="2" destOrd="0" presId="urn:microsoft.com/office/officeart/2005/8/layout/vList5"/>
    <dgm:cxn modelId="{8EE30A21-17AC-A34E-A945-33D32D0CD928}" type="presParOf" srcId="{277D1FDC-6CD3-BB41-8E20-960C658417CF}" destId="{6CEBA26E-9501-3E41-ACBB-39C96B19A924}" srcOrd="0" destOrd="0" presId="urn:microsoft.com/office/officeart/2005/8/layout/vList5"/>
    <dgm:cxn modelId="{3CCA96C7-C68E-DA49-A8B4-DD728A5A5A21}" type="presParOf" srcId="{277D1FDC-6CD3-BB41-8E20-960C658417CF}" destId="{2EB4DD27-0645-2048-89E9-55CE50FE52DA}" srcOrd="1" destOrd="0" presId="urn:microsoft.com/office/officeart/2005/8/layout/vList5"/>
    <dgm:cxn modelId="{4AF2BADF-B9C1-834B-AC41-60901F7D6D95}" type="presParOf" srcId="{C651D352-06FA-1B42-81FF-A95099FE5645}" destId="{33CCAA17-6648-4F4C-9AC2-5ECE7EDB6E70}" srcOrd="3" destOrd="0" presId="urn:microsoft.com/office/officeart/2005/8/layout/vList5"/>
    <dgm:cxn modelId="{2A4E440E-B7D6-6B49-8318-F6B71A21E6CF}" type="presParOf" srcId="{C651D352-06FA-1B42-81FF-A95099FE5645}" destId="{B97FC210-8EA1-614A-91AB-916C1AEFBDEE}" srcOrd="4" destOrd="0" presId="urn:microsoft.com/office/officeart/2005/8/layout/vList5"/>
    <dgm:cxn modelId="{2BDD0334-A1D2-DC42-B9D1-68F24D23B5D5}" type="presParOf" srcId="{B97FC210-8EA1-614A-91AB-916C1AEFBDEE}" destId="{A3A63788-1227-B240-AFF4-87DA3887717D}" srcOrd="0" destOrd="0" presId="urn:microsoft.com/office/officeart/2005/8/layout/vList5"/>
    <dgm:cxn modelId="{C69877D5-79C1-9F4C-B7F4-8AD7D15754EE}" type="presParOf" srcId="{B97FC210-8EA1-614A-91AB-916C1AEFBDEE}" destId="{5432570E-A980-7C49-B78B-FBD7E95247D6}" srcOrd="1" destOrd="0" presId="urn:microsoft.com/office/officeart/2005/8/layout/vList5"/>
    <dgm:cxn modelId="{33ACEA31-C6CD-5547-BED3-2458723FCA4A}" type="presParOf" srcId="{C651D352-06FA-1B42-81FF-A95099FE5645}" destId="{3E055F9F-21A2-424C-8A4E-65EE89C8A916}" srcOrd="5" destOrd="0" presId="urn:microsoft.com/office/officeart/2005/8/layout/vList5"/>
    <dgm:cxn modelId="{A37DA9BE-A47E-BB4D-9CC1-632CE186629D}" type="presParOf" srcId="{C651D352-06FA-1B42-81FF-A95099FE5645}" destId="{3D7F3715-4665-FB42-B9D8-1FF06FE7ED04}" srcOrd="6" destOrd="0" presId="urn:microsoft.com/office/officeart/2005/8/layout/vList5"/>
    <dgm:cxn modelId="{C891109C-0686-B74F-8141-60300585C701}" type="presParOf" srcId="{3D7F3715-4665-FB42-B9D8-1FF06FE7ED04}" destId="{F459C834-8503-9C47-9E88-19B5B264D39A}" srcOrd="0" destOrd="0" presId="urn:microsoft.com/office/officeart/2005/8/layout/vList5"/>
    <dgm:cxn modelId="{2F31821D-0811-794B-B121-3DE9146709AD}" type="presParOf" srcId="{3D7F3715-4665-FB42-B9D8-1FF06FE7ED04}" destId="{B11406A9-5BCB-7247-9C38-2B1D2505F2B8}" srcOrd="1" destOrd="0" presId="urn:microsoft.com/office/officeart/2005/8/layout/vList5"/>
    <dgm:cxn modelId="{0F8FFFCC-28B5-A844-A0C0-4277188A3AC8}" type="presParOf" srcId="{C651D352-06FA-1B42-81FF-A95099FE5645}" destId="{E355AC6F-4099-CB47-B889-4B740E437363}" srcOrd="7" destOrd="0" presId="urn:microsoft.com/office/officeart/2005/8/layout/vList5"/>
    <dgm:cxn modelId="{53EF242F-1951-6046-AB59-C18248626329}" type="presParOf" srcId="{C651D352-06FA-1B42-81FF-A95099FE5645}" destId="{A60CA7D8-39CB-954A-95BD-9B247DA4C063}" srcOrd="8" destOrd="0" presId="urn:microsoft.com/office/officeart/2005/8/layout/vList5"/>
    <dgm:cxn modelId="{ED3BF37E-4F96-D544-B638-C0AB83F1A9B4}" type="presParOf" srcId="{A60CA7D8-39CB-954A-95BD-9B247DA4C063}" destId="{4D3677DD-203E-6A46-986E-4A5C658C9303}" srcOrd="0" destOrd="0" presId="urn:microsoft.com/office/officeart/2005/8/layout/vList5"/>
    <dgm:cxn modelId="{5F05AF10-2999-E74B-852A-D64954D94FF8}" type="presParOf" srcId="{A60CA7D8-39CB-954A-95BD-9B247DA4C063}" destId="{DF481026-182D-AB4B-A938-B9E12915351D}" srcOrd="1" destOrd="0" presId="urn:microsoft.com/office/officeart/2005/8/layout/vList5"/>
    <dgm:cxn modelId="{ACD94F81-0016-934D-9BD5-68D8F780E3B7}" type="presParOf" srcId="{C651D352-06FA-1B42-81FF-A95099FE5645}" destId="{0E9316E9-2C30-AB47-AE90-7E8E046E1AFD}" srcOrd="9" destOrd="0" presId="urn:microsoft.com/office/officeart/2005/8/layout/vList5"/>
    <dgm:cxn modelId="{F8E487A0-A252-584F-8A38-3822D4AF8219}" type="presParOf" srcId="{C651D352-06FA-1B42-81FF-A95099FE5645}" destId="{037794A2-D322-8E40-B011-CE07ECE52AD6}" srcOrd="10" destOrd="0" presId="urn:microsoft.com/office/officeart/2005/8/layout/vList5"/>
    <dgm:cxn modelId="{67548826-ED42-6242-AA6A-DBBB72691D13}" type="presParOf" srcId="{037794A2-D322-8E40-B011-CE07ECE52AD6}" destId="{B6C279C8-1B63-3845-ADAB-B82AEFA3D8E4}" srcOrd="0" destOrd="0" presId="urn:microsoft.com/office/officeart/2005/8/layout/vList5"/>
    <dgm:cxn modelId="{B87CE2C3-5909-4C4E-A75A-B68815D3150A}" type="presParOf" srcId="{037794A2-D322-8E40-B011-CE07ECE52AD6}" destId="{95DA0D8B-BC89-0948-909A-C298332DBD75}" srcOrd="1" destOrd="0" presId="urn:microsoft.com/office/officeart/2005/8/layout/vList5"/>
    <dgm:cxn modelId="{B702A7F2-2B11-8D48-B9AE-A25D0DE633A1}" type="presParOf" srcId="{C651D352-06FA-1B42-81FF-A95099FE5645}" destId="{05C8E7F6-EE84-404A-A830-A5238A04D5A3}" srcOrd="11" destOrd="0" presId="urn:microsoft.com/office/officeart/2005/8/layout/vList5"/>
    <dgm:cxn modelId="{5D36C750-8050-AB49-B923-84B64CB9D59C}" type="presParOf" srcId="{C651D352-06FA-1B42-81FF-A95099FE5645}" destId="{450D1F74-F684-8F4C-A8B3-6F8B553AB682}" srcOrd="12" destOrd="0" presId="urn:microsoft.com/office/officeart/2005/8/layout/vList5"/>
    <dgm:cxn modelId="{69DDD68C-0D88-6141-B93A-2DFC27495FCF}" type="presParOf" srcId="{450D1F74-F684-8F4C-A8B3-6F8B553AB682}" destId="{B67BA8B7-08DC-C244-8300-FCD547033DBD}" srcOrd="0" destOrd="0" presId="urn:microsoft.com/office/officeart/2005/8/layout/vList5"/>
    <dgm:cxn modelId="{772109BC-D0C5-5C47-B68B-C1F238D6D77F}" type="presParOf" srcId="{450D1F74-F684-8F4C-A8B3-6F8B553AB682}" destId="{9D2B4FF6-13FB-EF49-977A-31DF5EE58099}" srcOrd="1" destOrd="0" presId="urn:microsoft.com/office/officeart/2005/8/layout/vList5"/>
    <dgm:cxn modelId="{5EBAD0AC-A244-A44E-ADFB-53F20C58044C}" type="presParOf" srcId="{C651D352-06FA-1B42-81FF-A95099FE5645}" destId="{580F7313-AC0F-FA49-A45E-0C9486F52D6E}" srcOrd="13" destOrd="0" presId="urn:microsoft.com/office/officeart/2005/8/layout/vList5"/>
    <dgm:cxn modelId="{6E9922E5-478F-AF4D-9DCA-7A72508F4F6D}" type="presParOf" srcId="{C651D352-06FA-1B42-81FF-A95099FE5645}" destId="{E737A561-EB87-EC46-B404-0D8CDB0DE287}" srcOrd="14" destOrd="0" presId="urn:microsoft.com/office/officeart/2005/8/layout/vList5"/>
    <dgm:cxn modelId="{8E470ECC-4731-EF49-B2A8-AD4470B8AD53}" type="presParOf" srcId="{E737A561-EB87-EC46-B404-0D8CDB0DE287}" destId="{D5D04DA4-D0C2-DE47-8C8C-0B8EFFA304FE}" srcOrd="0" destOrd="0" presId="urn:microsoft.com/office/officeart/2005/8/layout/vList5"/>
    <dgm:cxn modelId="{B9608D4F-B546-F142-90CB-D6437FE05ACF}" type="presParOf" srcId="{E737A561-EB87-EC46-B404-0D8CDB0DE287}" destId="{8CF3EAF4-8574-9841-9B3E-4FBF8CB57172}"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CE7EC2B3-709C-7049-AC98-40D647A08CD5}" type="doc">
      <dgm:prSet loTypeId="urn:microsoft.com/office/officeart/2005/8/layout/vList5" loCatId="" qsTypeId="urn:microsoft.com/office/officeart/2005/8/quickstyle/simple1" qsCatId="simple" csTypeId="urn:microsoft.com/office/officeart/2005/8/colors/accent1_2" csCatId="accent1" phldr="1"/>
      <dgm:spPr/>
      <dgm:t>
        <a:bodyPr/>
        <a:lstStyle/>
        <a:p>
          <a:endParaRPr lang="en-US"/>
        </a:p>
      </dgm:t>
    </dgm:pt>
    <dgm:pt modelId="{54EB0C78-47D0-4144-BBA1-ED83F2276A80}">
      <dgm:prSet phldrT="[Text]"/>
      <dgm:spPr/>
      <dgm:t>
        <a:bodyPr/>
        <a:lstStyle/>
        <a:p>
          <a:r>
            <a:rPr lang="en-US" dirty="0"/>
            <a:t>1</a:t>
          </a:r>
        </a:p>
      </dgm:t>
    </dgm:pt>
    <dgm:pt modelId="{46A28A5B-8A7C-BF49-A5DC-996D874F74B0}" type="parTrans" cxnId="{54AEA8B7-F89B-724F-98A1-0AEC5D7FC3A2}">
      <dgm:prSet/>
      <dgm:spPr/>
      <dgm:t>
        <a:bodyPr/>
        <a:lstStyle/>
        <a:p>
          <a:endParaRPr lang="en-US"/>
        </a:p>
      </dgm:t>
    </dgm:pt>
    <dgm:pt modelId="{E8376F97-8FAC-AA43-868D-BB3E335B92F2}" type="sibTrans" cxnId="{54AEA8B7-F89B-724F-98A1-0AEC5D7FC3A2}">
      <dgm:prSet/>
      <dgm:spPr/>
      <dgm:t>
        <a:bodyPr/>
        <a:lstStyle/>
        <a:p>
          <a:endParaRPr lang="en-US"/>
        </a:p>
      </dgm:t>
    </dgm:pt>
    <dgm:pt modelId="{D57A6E2B-1DF9-5046-BC1D-709A01F64D7F}">
      <dgm:prSet phldrT="[Text]"/>
      <dgm:spPr/>
      <dgm:t>
        <a:bodyPr/>
        <a:lstStyle/>
        <a:p>
          <a:r>
            <a:rPr lang="en-US"/>
            <a:t>Patient stability</a:t>
          </a:r>
          <a:endParaRPr lang="en-US" dirty="0"/>
        </a:p>
      </dgm:t>
    </dgm:pt>
    <dgm:pt modelId="{C76AEE8B-D94A-7D44-B03A-3FE0785274DD}" type="parTrans" cxnId="{B2C59790-5949-8740-B37D-5567793C306C}">
      <dgm:prSet/>
      <dgm:spPr/>
      <dgm:t>
        <a:bodyPr/>
        <a:lstStyle/>
        <a:p>
          <a:endParaRPr lang="en-US"/>
        </a:p>
      </dgm:t>
    </dgm:pt>
    <dgm:pt modelId="{55132C62-F393-2540-A3F5-1E79E69F36CF}" type="sibTrans" cxnId="{B2C59790-5949-8740-B37D-5567793C306C}">
      <dgm:prSet/>
      <dgm:spPr/>
      <dgm:t>
        <a:bodyPr/>
        <a:lstStyle/>
        <a:p>
          <a:endParaRPr lang="en-US"/>
        </a:p>
      </dgm:t>
    </dgm:pt>
    <dgm:pt modelId="{D03F059F-5021-1F40-A19F-9647158C52AD}">
      <dgm:prSet phldrT="[Text]"/>
      <dgm:spPr/>
      <dgm:t>
        <a:bodyPr/>
        <a:lstStyle/>
        <a:p>
          <a:r>
            <a:rPr lang="en-US" dirty="0"/>
            <a:t>2</a:t>
          </a:r>
        </a:p>
      </dgm:t>
    </dgm:pt>
    <dgm:pt modelId="{CF000D09-B476-0444-AE02-AACE5A32ABB9}" type="parTrans" cxnId="{65CEA44F-9E16-EA4E-A309-EC3B3016297A}">
      <dgm:prSet/>
      <dgm:spPr/>
      <dgm:t>
        <a:bodyPr/>
        <a:lstStyle/>
        <a:p>
          <a:endParaRPr lang="en-US"/>
        </a:p>
      </dgm:t>
    </dgm:pt>
    <dgm:pt modelId="{294C2440-29C3-A948-ADDD-2D4D34880BDD}" type="sibTrans" cxnId="{65CEA44F-9E16-EA4E-A309-EC3B3016297A}">
      <dgm:prSet/>
      <dgm:spPr/>
      <dgm:t>
        <a:bodyPr/>
        <a:lstStyle/>
        <a:p>
          <a:endParaRPr lang="en-US"/>
        </a:p>
      </dgm:t>
    </dgm:pt>
    <dgm:pt modelId="{8E966A69-49F1-5E4B-B606-FCAEDAA984ED}">
      <dgm:prSet phldrT="[Text]"/>
      <dgm:spPr/>
      <dgm:t>
        <a:bodyPr/>
        <a:lstStyle/>
        <a:p>
          <a:r>
            <a:rPr lang="en-US" dirty="0"/>
            <a:t>Emotional check</a:t>
          </a:r>
        </a:p>
      </dgm:t>
    </dgm:pt>
    <dgm:pt modelId="{DBAD8E5C-BD8A-8D4C-B4F0-8493200D7696}" type="parTrans" cxnId="{FBB45EE4-904A-AF48-A0C9-CB655E66EF52}">
      <dgm:prSet/>
      <dgm:spPr/>
      <dgm:t>
        <a:bodyPr/>
        <a:lstStyle/>
        <a:p>
          <a:endParaRPr lang="en-US"/>
        </a:p>
      </dgm:t>
    </dgm:pt>
    <dgm:pt modelId="{6E022D76-54D3-5040-BFB1-6E3CF648085C}" type="sibTrans" cxnId="{FBB45EE4-904A-AF48-A0C9-CB655E66EF52}">
      <dgm:prSet/>
      <dgm:spPr/>
      <dgm:t>
        <a:bodyPr/>
        <a:lstStyle/>
        <a:p>
          <a:endParaRPr lang="en-US"/>
        </a:p>
      </dgm:t>
    </dgm:pt>
    <dgm:pt modelId="{73A345CE-36FD-894D-BBC6-F1148569A643}">
      <dgm:prSet phldrT="[Text]"/>
      <dgm:spPr/>
      <dgm:t>
        <a:bodyPr/>
        <a:lstStyle/>
        <a:p>
          <a:r>
            <a:rPr lang="en-US" dirty="0"/>
            <a:t>3</a:t>
          </a:r>
        </a:p>
      </dgm:t>
    </dgm:pt>
    <dgm:pt modelId="{E3B27BD6-FBE2-5640-8D4A-26A5222CC3EA}" type="parTrans" cxnId="{408ED183-BF58-1C4B-97FD-732582625FEF}">
      <dgm:prSet/>
      <dgm:spPr/>
      <dgm:t>
        <a:bodyPr/>
        <a:lstStyle/>
        <a:p>
          <a:endParaRPr lang="en-US"/>
        </a:p>
      </dgm:t>
    </dgm:pt>
    <dgm:pt modelId="{7A99C83F-BC00-3743-81E8-552BD253CEC3}" type="sibTrans" cxnId="{408ED183-BF58-1C4B-97FD-732582625FEF}">
      <dgm:prSet/>
      <dgm:spPr/>
      <dgm:t>
        <a:bodyPr/>
        <a:lstStyle/>
        <a:p>
          <a:endParaRPr lang="en-US"/>
        </a:p>
      </dgm:t>
    </dgm:pt>
    <dgm:pt modelId="{E900B89A-C42B-5249-B68C-A3D7ECDC2722}">
      <dgm:prSet phldrT="[Text]"/>
      <dgm:spPr/>
      <dgm:t>
        <a:bodyPr/>
        <a:lstStyle/>
        <a:p>
          <a:r>
            <a:rPr lang="en-US" dirty="0"/>
            <a:t>Address bias</a:t>
          </a:r>
        </a:p>
      </dgm:t>
    </dgm:pt>
    <dgm:pt modelId="{8E839505-C7B5-E846-B572-409C6E14F87D}" type="parTrans" cxnId="{8EA459AB-225B-8C4D-9825-5D1C6BF10277}">
      <dgm:prSet/>
      <dgm:spPr/>
      <dgm:t>
        <a:bodyPr/>
        <a:lstStyle/>
        <a:p>
          <a:endParaRPr lang="en-US"/>
        </a:p>
      </dgm:t>
    </dgm:pt>
    <dgm:pt modelId="{1CCB8A03-5593-CE44-86BA-AACEAE0CCB98}" type="sibTrans" cxnId="{8EA459AB-225B-8C4D-9825-5D1C6BF10277}">
      <dgm:prSet/>
      <dgm:spPr/>
      <dgm:t>
        <a:bodyPr/>
        <a:lstStyle/>
        <a:p>
          <a:endParaRPr lang="en-US"/>
        </a:p>
      </dgm:t>
    </dgm:pt>
    <dgm:pt modelId="{418E94F4-4F87-154C-8C2C-4FA1854F2962}">
      <dgm:prSet/>
      <dgm:spPr/>
      <dgm:t>
        <a:bodyPr/>
        <a:lstStyle/>
        <a:p>
          <a:r>
            <a:rPr lang="en-US" dirty="0"/>
            <a:t>4</a:t>
          </a:r>
        </a:p>
      </dgm:t>
    </dgm:pt>
    <dgm:pt modelId="{67B29BF1-08A2-E04F-9D69-0598739CF13B}" type="parTrans" cxnId="{2BBF3C50-1ED6-9847-B76B-936F9EDE5606}">
      <dgm:prSet/>
      <dgm:spPr/>
      <dgm:t>
        <a:bodyPr/>
        <a:lstStyle/>
        <a:p>
          <a:endParaRPr lang="en-US"/>
        </a:p>
      </dgm:t>
    </dgm:pt>
    <dgm:pt modelId="{A5C1BCA8-59E6-2D47-BF9C-24A0A56844F7}" type="sibTrans" cxnId="{2BBF3C50-1ED6-9847-B76B-936F9EDE5606}">
      <dgm:prSet/>
      <dgm:spPr/>
      <dgm:t>
        <a:bodyPr/>
        <a:lstStyle/>
        <a:p>
          <a:endParaRPr lang="en-US"/>
        </a:p>
      </dgm:t>
    </dgm:pt>
    <dgm:pt modelId="{827957E1-E296-1C4F-A5F6-1C5FE324A00C}">
      <dgm:prSet/>
      <dgm:spPr/>
      <dgm:t>
        <a:bodyPr/>
        <a:lstStyle/>
        <a:p>
          <a:r>
            <a:rPr lang="en-US" dirty="0"/>
            <a:t>5</a:t>
          </a:r>
        </a:p>
      </dgm:t>
    </dgm:pt>
    <dgm:pt modelId="{AC89EDA2-97A0-704F-A224-66777968DC79}" type="parTrans" cxnId="{C5A31E1B-1939-A943-9EA9-0D1F931C9095}">
      <dgm:prSet/>
      <dgm:spPr/>
      <dgm:t>
        <a:bodyPr/>
        <a:lstStyle/>
        <a:p>
          <a:endParaRPr lang="en-US"/>
        </a:p>
      </dgm:t>
    </dgm:pt>
    <dgm:pt modelId="{9F52F0F0-B16C-AB44-86AF-35AA79D5B0BB}" type="sibTrans" cxnId="{C5A31E1B-1939-A943-9EA9-0D1F931C9095}">
      <dgm:prSet/>
      <dgm:spPr/>
      <dgm:t>
        <a:bodyPr/>
        <a:lstStyle/>
        <a:p>
          <a:endParaRPr lang="en-US"/>
        </a:p>
      </dgm:t>
    </dgm:pt>
    <dgm:pt modelId="{9F6E5C8F-12F1-3545-94A6-291C5042E69E}">
      <dgm:prSet/>
      <dgm:spPr/>
      <dgm:t>
        <a:bodyPr/>
        <a:lstStyle/>
        <a:p>
          <a:r>
            <a:rPr lang="en-US" dirty="0"/>
            <a:t>6</a:t>
          </a:r>
        </a:p>
      </dgm:t>
    </dgm:pt>
    <dgm:pt modelId="{F878F1E0-BA83-0B4F-8407-D69A3E0606E8}" type="parTrans" cxnId="{545F95DE-9A10-3948-9807-36C195D34A35}">
      <dgm:prSet/>
      <dgm:spPr/>
      <dgm:t>
        <a:bodyPr/>
        <a:lstStyle/>
        <a:p>
          <a:endParaRPr lang="en-US"/>
        </a:p>
      </dgm:t>
    </dgm:pt>
    <dgm:pt modelId="{F501E3C1-886B-5244-A7B1-7A80D72A4D8C}" type="sibTrans" cxnId="{545F95DE-9A10-3948-9807-36C195D34A35}">
      <dgm:prSet/>
      <dgm:spPr/>
      <dgm:t>
        <a:bodyPr/>
        <a:lstStyle/>
        <a:p>
          <a:endParaRPr lang="en-US"/>
        </a:p>
      </dgm:t>
    </dgm:pt>
    <dgm:pt modelId="{02BDF100-8338-E043-96F5-EE898B9D5AB2}">
      <dgm:prSet/>
      <dgm:spPr/>
      <dgm:t>
        <a:bodyPr/>
        <a:lstStyle/>
        <a:p>
          <a:r>
            <a:rPr lang="en-US" dirty="0"/>
            <a:t>7</a:t>
          </a:r>
        </a:p>
      </dgm:t>
    </dgm:pt>
    <dgm:pt modelId="{1B53CCA0-CFF2-384B-856E-1EBDFA4D02AD}" type="parTrans" cxnId="{F6183E77-6BBF-FA47-854D-F0D53AE21A8A}">
      <dgm:prSet/>
      <dgm:spPr/>
      <dgm:t>
        <a:bodyPr/>
        <a:lstStyle/>
        <a:p>
          <a:endParaRPr lang="en-US"/>
        </a:p>
      </dgm:t>
    </dgm:pt>
    <dgm:pt modelId="{BCE247F3-63ED-824C-BC43-9D645F88694B}" type="sibTrans" cxnId="{F6183E77-6BBF-FA47-854D-F0D53AE21A8A}">
      <dgm:prSet/>
      <dgm:spPr/>
      <dgm:t>
        <a:bodyPr/>
        <a:lstStyle/>
        <a:p>
          <a:endParaRPr lang="en-US"/>
        </a:p>
      </dgm:t>
    </dgm:pt>
    <dgm:pt modelId="{7CF6944D-D814-F446-BDE2-B55C1C344687}">
      <dgm:prSet/>
      <dgm:spPr/>
      <dgm:t>
        <a:bodyPr/>
        <a:lstStyle/>
        <a:p>
          <a:r>
            <a:rPr lang="en-US" dirty="0"/>
            <a:t>8</a:t>
          </a:r>
        </a:p>
      </dgm:t>
    </dgm:pt>
    <dgm:pt modelId="{18766106-4E88-954F-80B4-8435CD7E3607}" type="parTrans" cxnId="{B4BAA057-82A7-8F4F-B3AE-D2474B9F0D61}">
      <dgm:prSet/>
      <dgm:spPr/>
      <dgm:t>
        <a:bodyPr/>
        <a:lstStyle/>
        <a:p>
          <a:endParaRPr lang="en-US"/>
        </a:p>
      </dgm:t>
    </dgm:pt>
    <dgm:pt modelId="{41CA9CD1-BD05-D240-8585-F6D044F469D5}" type="sibTrans" cxnId="{B4BAA057-82A7-8F4F-B3AE-D2474B9F0D61}">
      <dgm:prSet/>
      <dgm:spPr/>
      <dgm:t>
        <a:bodyPr/>
        <a:lstStyle/>
        <a:p>
          <a:endParaRPr lang="en-US"/>
        </a:p>
      </dgm:t>
    </dgm:pt>
    <dgm:pt modelId="{77E26394-E137-5E44-9434-AC75CD3E8E1C}">
      <dgm:prSet/>
      <dgm:spPr/>
      <dgm:t>
        <a:bodyPr/>
        <a:lstStyle/>
        <a:p>
          <a:r>
            <a:rPr lang="en-US" dirty="0"/>
            <a:t>Align with patient</a:t>
          </a:r>
        </a:p>
      </dgm:t>
    </dgm:pt>
    <dgm:pt modelId="{0106416C-C608-3E4B-95A9-3A27F212EF0D}" type="parTrans" cxnId="{3055A850-65BD-2C48-A538-0AAEB9138E85}">
      <dgm:prSet/>
      <dgm:spPr/>
      <dgm:t>
        <a:bodyPr/>
        <a:lstStyle/>
        <a:p>
          <a:endParaRPr lang="en-US"/>
        </a:p>
      </dgm:t>
    </dgm:pt>
    <dgm:pt modelId="{4162CFAB-B676-8E4E-8FEB-32BD16B62DEC}" type="sibTrans" cxnId="{3055A850-65BD-2C48-A538-0AAEB9138E85}">
      <dgm:prSet/>
      <dgm:spPr/>
      <dgm:t>
        <a:bodyPr/>
        <a:lstStyle/>
        <a:p>
          <a:endParaRPr lang="en-US"/>
        </a:p>
      </dgm:t>
    </dgm:pt>
    <dgm:pt modelId="{B3ABDBBC-28C2-CC44-9EA0-940A074F9BF0}">
      <dgm:prSet/>
      <dgm:spPr/>
      <dgm:t>
        <a:bodyPr/>
        <a:lstStyle/>
        <a:p>
          <a:r>
            <a:rPr lang="en-US" dirty="0"/>
            <a:t>Align with team</a:t>
          </a:r>
        </a:p>
      </dgm:t>
    </dgm:pt>
    <dgm:pt modelId="{D1297B60-D255-DA44-8D75-399213932CFB}" type="parTrans" cxnId="{D85391B8-F585-FD43-82E0-8ACB9B810BF4}">
      <dgm:prSet/>
      <dgm:spPr/>
      <dgm:t>
        <a:bodyPr/>
        <a:lstStyle/>
        <a:p>
          <a:endParaRPr lang="en-US"/>
        </a:p>
      </dgm:t>
    </dgm:pt>
    <dgm:pt modelId="{B1A1C092-087B-F241-9B26-AD1D13C72D4D}" type="sibTrans" cxnId="{D85391B8-F585-FD43-82E0-8ACB9B810BF4}">
      <dgm:prSet/>
      <dgm:spPr/>
      <dgm:t>
        <a:bodyPr/>
        <a:lstStyle/>
        <a:p>
          <a:endParaRPr lang="en-US"/>
        </a:p>
      </dgm:t>
    </dgm:pt>
    <dgm:pt modelId="{D6BB4A41-00B2-5448-BB3F-80605AC75A4E}">
      <dgm:prSet/>
      <dgm:spPr/>
      <dgm:t>
        <a:bodyPr/>
        <a:lstStyle/>
        <a:p>
          <a:r>
            <a:rPr lang="en-US" dirty="0"/>
            <a:t>Set boundaries</a:t>
          </a:r>
        </a:p>
      </dgm:t>
    </dgm:pt>
    <dgm:pt modelId="{4E04882C-8060-1D42-8502-5D210AA0DCD3}" type="parTrans" cxnId="{DF1A41C0-D8B8-6D4F-A8A5-91EC68AFBCAD}">
      <dgm:prSet/>
      <dgm:spPr/>
      <dgm:t>
        <a:bodyPr/>
        <a:lstStyle/>
        <a:p>
          <a:endParaRPr lang="en-US"/>
        </a:p>
      </dgm:t>
    </dgm:pt>
    <dgm:pt modelId="{A3F6C628-648D-0249-B65F-551AF9ECEEA6}" type="sibTrans" cxnId="{DF1A41C0-D8B8-6D4F-A8A5-91EC68AFBCAD}">
      <dgm:prSet/>
      <dgm:spPr/>
      <dgm:t>
        <a:bodyPr/>
        <a:lstStyle/>
        <a:p>
          <a:endParaRPr lang="en-US"/>
        </a:p>
      </dgm:t>
    </dgm:pt>
    <dgm:pt modelId="{0545D5E0-C6B3-A447-B001-E955BFE39730}">
      <dgm:prSet/>
      <dgm:spPr/>
      <dgm:t>
        <a:bodyPr/>
        <a:lstStyle/>
        <a:p>
          <a:r>
            <a:rPr lang="en-US" dirty="0"/>
            <a:t>Give space</a:t>
          </a:r>
        </a:p>
      </dgm:t>
    </dgm:pt>
    <dgm:pt modelId="{74548467-254B-2943-9A99-08C07F3E448D}" type="parTrans" cxnId="{E2BB9BC9-6DB1-9443-8E35-6250A99E4AD7}">
      <dgm:prSet/>
      <dgm:spPr/>
      <dgm:t>
        <a:bodyPr/>
        <a:lstStyle/>
        <a:p>
          <a:endParaRPr lang="en-US"/>
        </a:p>
      </dgm:t>
    </dgm:pt>
    <dgm:pt modelId="{43A03E68-4CAE-A344-B58C-38B13B6EE776}" type="sibTrans" cxnId="{E2BB9BC9-6DB1-9443-8E35-6250A99E4AD7}">
      <dgm:prSet/>
      <dgm:spPr/>
      <dgm:t>
        <a:bodyPr/>
        <a:lstStyle/>
        <a:p>
          <a:endParaRPr lang="en-US"/>
        </a:p>
      </dgm:t>
    </dgm:pt>
    <dgm:pt modelId="{4042EA18-93B7-8447-AC0A-58BAED6135AA}">
      <dgm:prSet/>
      <dgm:spPr/>
      <dgm:t>
        <a:bodyPr/>
        <a:lstStyle/>
        <a:p>
          <a:r>
            <a:rPr lang="en-US" dirty="0"/>
            <a:t>Seek support</a:t>
          </a:r>
        </a:p>
      </dgm:t>
    </dgm:pt>
    <dgm:pt modelId="{2F5CB061-56DE-EB4D-BFD4-36B00E6055CB}" type="parTrans" cxnId="{BBBA16DC-BC73-8048-A725-FE1EF1BF6593}">
      <dgm:prSet/>
      <dgm:spPr/>
      <dgm:t>
        <a:bodyPr/>
        <a:lstStyle/>
        <a:p>
          <a:endParaRPr lang="en-US"/>
        </a:p>
      </dgm:t>
    </dgm:pt>
    <dgm:pt modelId="{A608511D-1BB9-EB4E-9E74-CCD7B0DB861D}" type="sibTrans" cxnId="{BBBA16DC-BC73-8048-A725-FE1EF1BF6593}">
      <dgm:prSet/>
      <dgm:spPr/>
      <dgm:t>
        <a:bodyPr/>
        <a:lstStyle/>
        <a:p>
          <a:endParaRPr lang="en-US"/>
        </a:p>
      </dgm:t>
    </dgm:pt>
    <dgm:pt modelId="{C651D352-06FA-1B42-81FF-A95099FE5645}" type="pres">
      <dgm:prSet presAssocID="{CE7EC2B3-709C-7049-AC98-40D647A08CD5}" presName="Name0" presStyleCnt="0">
        <dgm:presLayoutVars>
          <dgm:dir/>
          <dgm:animLvl val="lvl"/>
          <dgm:resizeHandles val="exact"/>
        </dgm:presLayoutVars>
      </dgm:prSet>
      <dgm:spPr/>
    </dgm:pt>
    <dgm:pt modelId="{2E2FEDEA-0CB5-FD4B-8718-95B9D6A14304}" type="pres">
      <dgm:prSet presAssocID="{54EB0C78-47D0-4144-BBA1-ED83F2276A80}" presName="linNode" presStyleCnt="0"/>
      <dgm:spPr/>
    </dgm:pt>
    <dgm:pt modelId="{2F0271A3-745A-A943-B67B-E4069A93AE61}" type="pres">
      <dgm:prSet presAssocID="{54EB0C78-47D0-4144-BBA1-ED83F2276A80}" presName="parentText" presStyleLbl="node1" presStyleIdx="0" presStyleCnt="8" custScaleX="67001">
        <dgm:presLayoutVars>
          <dgm:chMax val="1"/>
          <dgm:bulletEnabled val="1"/>
        </dgm:presLayoutVars>
      </dgm:prSet>
      <dgm:spPr/>
    </dgm:pt>
    <dgm:pt modelId="{21D64796-42C1-6A47-B16B-F23C35A117FF}" type="pres">
      <dgm:prSet presAssocID="{54EB0C78-47D0-4144-BBA1-ED83F2276A80}" presName="descendantText" presStyleLbl="alignAccFollowNode1" presStyleIdx="0" presStyleCnt="8">
        <dgm:presLayoutVars>
          <dgm:bulletEnabled val="1"/>
        </dgm:presLayoutVars>
      </dgm:prSet>
      <dgm:spPr/>
    </dgm:pt>
    <dgm:pt modelId="{B2C4C361-6A0B-BC45-90FD-318B0EB08F6D}" type="pres">
      <dgm:prSet presAssocID="{E8376F97-8FAC-AA43-868D-BB3E335B92F2}" presName="sp" presStyleCnt="0"/>
      <dgm:spPr/>
    </dgm:pt>
    <dgm:pt modelId="{277D1FDC-6CD3-BB41-8E20-960C658417CF}" type="pres">
      <dgm:prSet presAssocID="{D03F059F-5021-1F40-A19F-9647158C52AD}" presName="linNode" presStyleCnt="0"/>
      <dgm:spPr/>
    </dgm:pt>
    <dgm:pt modelId="{6CEBA26E-9501-3E41-ACBB-39C96B19A924}" type="pres">
      <dgm:prSet presAssocID="{D03F059F-5021-1F40-A19F-9647158C52AD}" presName="parentText" presStyleLbl="node1" presStyleIdx="1" presStyleCnt="8" custScaleX="67001">
        <dgm:presLayoutVars>
          <dgm:chMax val="1"/>
          <dgm:bulletEnabled val="1"/>
        </dgm:presLayoutVars>
      </dgm:prSet>
      <dgm:spPr/>
    </dgm:pt>
    <dgm:pt modelId="{2EB4DD27-0645-2048-89E9-55CE50FE52DA}" type="pres">
      <dgm:prSet presAssocID="{D03F059F-5021-1F40-A19F-9647158C52AD}" presName="descendantText" presStyleLbl="alignAccFollowNode1" presStyleIdx="1" presStyleCnt="8">
        <dgm:presLayoutVars>
          <dgm:bulletEnabled val="1"/>
        </dgm:presLayoutVars>
      </dgm:prSet>
      <dgm:spPr/>
    </dgm:pt>
    <dgm:pt modelId="{33CCAA17-6648-4F4C-9AC2-5ECE7EDB6E70}" type="pres">
      <dgm:prSet presAssocID="{294C2440-29C3-A948-ADDD-2D4D34880BDD}" presName="sp" presStyleCnt="0"/>
      <dgm:spPr/>
    </dgm:pt>
    <dgm:pt modelId="{B97FC210-8EA1-614A-91AB-916C1AEFBDEE}" type="pres">
      <dgm:prSet presAssocID="{73A345CE-36FD-894D-BBC6-F1148569A643}" presName="linNode" presStyleCnt="0"/>
      <dgm:spPr/>
    </dgm:pt>
    <dgm:pt modelId="{A3A63788-1227-B240-AFF4-87DA3887717D}" type="pres">
      <dgm:prSet presAssocID="{73A345CE-36FD-894D-BBC6-F1148569A643}" presName="parentText" presStyleLbl="node1" presStyleIdx="2" presStyleCnt="8" custScaleX="67001">
        <dgm:presLayoutVars>
          <dgm:chMax val="1"/>
          <dgm:bulletEnabled val="1"/>
        </dgm:presLayoutVars>
      </dgm:prSet>
      <dgm:spPr/>
    </dgm:pt>
    <dgm:pt modelId="{5432570E-A980-7C49-B78B-FBD7E95247D6}" type="pres">
      <dgm:prSet presAssocID="{73A345CE-36FD-894D-BBC6-F1148569A643}" presName="descendantText" presStyleLbl="alignAccFollowNode1" presStyleIdx="2" presStyleCnt="8">
        <dgm:presLayoutVars>
          <dgm:bulletEnabled val="1"/>
        </dgm:presLayoutVars>
      </dgm:prSet>
      <dgm:spPr/>
    </dgm:pt>
    <dgm:pt modelId="{3E055F9F-21A2-424C-8A4E-65EE89C8A916}" type="pres">
      <dgm:prSet presAssocID="{7A99C83F-BC00-3743-81E8-552BD253CEC3}" presName="sp" presStyleCnt="0"/>
      <dgm:spPr/>
    </dgm:pt>
    <dgm:pt modelId="{3D7F3715-4665-FB42-B9D8-1FF06FE7ED04}" type="pres">
      <dgm:prSet presAssocID="{418E94F4-4F87-154C-8C2C-4FA1854F2962}" presName="linNode" presStyleCnt="0"/>
      <dgm:spPr/>
    </dgm:pt>
    <dgm:pt modelId="{F459C834-8503-9C47-9E88-19B5B264D39A}" type="pres">
      <dgm:prSet presAssocID="{418E94F4-4F87-154C-8C2C-4FA1854F2962}" presName="parentText" presStyleLbl="node1" presStyleIdx="3" presStyleCnt="8" custScaleX="67001">
        <dgm:presLayoutVars>
          <dgm:chMax val="1"/>
          <dgm:bulletEnabled val="1"/>
        </dgm:presLayoutVars>
      </dgm:prSet>
      <dgm:spPr/>
    </dgm:pt>
    <dgm:pt modelId="{B11406A9-5BCB-7247-9C38-2B1D2505F2B8}" type="pres">
      <dgm:prSet presAssocID="{418E94F4-4F87-154C-8C2C-4FA1854F2962}" presName="descendantText" presStyleLbl="alignAccFollowNode1" presStyleIdx="3" presStyleCnt="8">
        <dgm:presLayoutVars>
          <dgm:bulletEnabled val="1"/>
        </dgm:presLayoutVars>
      </dgm:prSet>
      <dgm:spPr/>
    </dgm:pt>
    <dgm:pt modelId="{E355AC6F-4099-CB47-B889-4B740E437363}" type="pres">
      <dgm:prSet presAssocID="{A5C1BCA8-59E6-2D47-BF9C-24A0A56844F7}" presName="sp" presStyleCnt="0"/>
      <dgm:spPr/>
    </dgm:pt>
    <dgm:pt modelId="{A60CA7D8-39CB-954A-95BD-9B247DA4C063}" type="pres">
      <dgm:prSet presAssocID="{827957E1-E296-1C4F-A5F6-1C5FE324A00C}" presName="linNode" presStyleCnt="0"/>
      <dgm:spPr/>
    </dgm:pt>
    <dgm:pt modelId="{4D3677DD-203E-6A46-986E-4A5C658C9303}" type="pres">
      <dgm:prSet presAssocID="{827957E1-E296-1C4F-A5F6-1C5FE324A00C}" presName="parentText" presStyleLbl="node1" presStyleIdx="4" presStyleCnt="8" custScaleX="67001">
        <dgm:presLayoutVars>
          <dgm:chMax val="1"/>
          <dgm:bulletEnabled val="1"/>
        </dgm:presLayoutVars>
      </dgm:prSet>
      <dgm:spPr/>
    </dgm:pt>
    <dgm:pt modelId="{DF481026-182D-AB4B-A938-B9E12915351D}" type="pres">
      <dgm:prSet presAssocID="{827957E1-E296-1C4F-A5F6-1C5FE324A00C}" presName="descendantText" presStyleLbl="alignAccFollowNode1" presStyleIdx="4" presStyleCnt="8">
        <dgm:presLayoutVars>
          <dgm:bulletEnabled val="1"/>
        </dgm:presLayoutVars>
      </dgm:prSet>
      <dgm:spPr/>
    </dgm:pt>
    <dgm:pt modelId="{0E9316E9-2C30-AB47-AE90-7E8E046E1AFD}" type="pres">
      <dgm:prSet presAssocID="{9F52F0F0-B16C-AB44-86AF-35AA79D5B0BB}" presName="sp" presStyleCnt="0"/>
      <dgm:spPr/>
    </dgm:pt>
    <dgm:pt modelId="{037794A2-D322-8E40-B011-CE07ECE52AD6}" type="pres">
      <dgm:prSet presAssocID="{9F6E5C8F-12F1-3545-94A6-291C5042E69E}" presName="linNode" presStyleCnt="0"/>
      <dgm:spPr/>
    </dgm:pt>
    <dgm:pt modelId="{B6C279C8-1B63-3845-ADAB-B82AEFA3D8E4}" type="pres">
      <dgm:prSet presAssocID="{9F6E5C8F-12F1-3545-94A6-291C5042E69E}" presName="parentText" presStyleLbl="node1" presStyleIdx="5" presStyleCnt="8" custScaleX="67001">
        <dgm:presLayoutVars>
          <dgm:chMax val="1"/>
          <dgm:bulletEnabled val="1"/>
        </dgm:presLayoutVars>
      </dgm:prSet>
      <dgm:spPr/>
    </dgm:pt>
    <dgm:pt modelId="{95DA0D8B-BC89-0948-909A-C298332DBD75}" type="pres">
      <dgm:prSet presAssocID="{9F6E5C8F-12F1-3545-94A6-291C5042E69E}" presName="descendantText" presStyleLbl="alignAccFollowNode1" presStyleIdx="5" presStyleCnt="8">
        <dgm:presLayoutVars>
          <dgm:bulletEnabled val="1"/>
        </dgm:presLayoutVars>
      </dgm:prSet>
      <dgm:spPr/>
    </dgm:pt>
    <dgm:pt modelId="{05C8E7F6-EE84-404A-A830-A5238A04D5A3}" type="pres">
      <dgm:prSet presAssocID="{F501E3C1-886B-5244-A7B1-7A80D72A4D8C}" presName="sp" presStyleCnt="0"/>
      <dgm:spPr/>
    </dgm:pt>
    <dgm:pt modelId="{450D1F74-F684-8F4C-A8B3-6F8B553AB682}" type="pres">
      <dgm:prSet presAssocID="{02BDF100-8338-E043-96F5-EE898B9D5AB2}" presName="linNode" presStyleCnt="0"/>
      <dgm:spPr/>
    </dgm:pt>
    <dgm:pt modelId="{B67BA8B7-08DC-C244-8300-FCD547033DBD}" type="pres">
      <dgm:prSet presAssocID="{02BDF100-8338-E043-96F5-EE898B9D5AB2}" presName="parentText" presStyleLbl="node1" presStyleIdx="6" presStyleCnt="8" custScaleX="67001">
        <dgm:presLayoutVars>
          <dgm:chMax val="1"/>
          <dgm:bulletEnabled val="1"/>
        </dgm:presLayoutVars>
      </dgm:prSet>
      <dgm:spPr/>
    </dgm:pt>
    <dgm:pt modelId="{9D2B4FF6-13FB-EF49-977A-31DF5EE58099}" type="pres">
      <dgm:prSet presAssocID="{02BDF100-8338-E043-96F5-EE898B9D5AB2}" presName="descendantText" presStyleLbl="alignAccFollowNode1" presStyleIdx="6" presStyleCnt="8">
        <dgm:presLayoutVars>
          <dgm:bulletEnabled val="1"/>
        </dgm:presLayoutVars>
      </dgm:prSet>
      <dgm:spPr/>
    </dgm:pt>
    <dgm:pt modelId="{580F7313-AC0F-FA49-A45E-0C9486F52D6E}" type="pres">
      <dgm:prSet presAssocID="{BCE247F3-63ED-824C-BC43-9D645F88694B}" presName="sp" presStyleCnt="0"/>
      <dgm:spPr/>
    </dgm:pt>
    <dgm:pt modelId="{E737A561-EB87-EC46-B404-0D8CDB0DE287}" type="pres">
      <dgm:prSet presAssocID="{7CF6944D-D814-F446-BDE2-B55C1C344687}" presName="linNode" presStyleCnt="0"/>
      <dgm:spPr/>
    </dgm:pt>
    <dgm:pt modelId="{D5D04DA4-D0C2-DE47-8C8C-0B8EFFA304FE}" type="pres">
      <dgm:prSet presAssocID="{7CF6944D-D814-F446-BDE2-B55C1C344687}" presName="parentText" presStyleLbl="node1" presStyleIdx="7" presStyleCnt="8" custScaleX="67001">
        <dgm:presLayoutVars>
          <dgm:chMax val="1"/>
          <dgm:bulletEnabled val="1"/>
        </dgm:presLayoutVars>
      </dgm:prSet>
      <dgm:spPr/>
    </dgm:pt>
    <dgm:pt modelId="{8CF3EAF4-8574-9841-9B3E-4FBF8CB57172}" type="pres">
      <dgm:prSet presAssocID="{7CF6944D-D814-F446-BDE2-B55C1C344687}" presName="descendantText" presStyleLbl="alignAccFollowNode1" presStyleIdx="7" presStyleCnt="8">
        <dgm:presLayoutVars>
          <dgm:bulletEnabled val="1"/>
        </dgm:presLayoutVars>
      </dgm:prSet>
      <dgm:spPr/>
    </dgm:pt>
  </dgm:ptLst>
  <dgm:cxnLst>
    <dgm:cxn modelId="{E4273A05-E6BD-7B48-BAB7-FF2C885BDD30}" type="presOf" srcId="{02BDF100-8338-E043-96F5-EE898B9D5AB2}" destId="{B67BA8B7-08DC-C244-8300-FCD547033DBD}" srcOrd="0" destOrd="0" presId="urn:microsoft.com/office/officeart/2005/8/layout/vList5"/>
    <dgm:cxn modelId="{E9D1E10C-1628-524C-9321-D84C071FF74D}" type="presOf" srcId="{CE7EC2B3-709C-7049-AC98-40D647A08CD5}" destId="{C651D352-06FA-1B42-81FF-A95099FE5645}" srcOrd="0" destOrd="0" presId="urn:microsoft.com/office/officeart/2005/8/layout/vList5"/>
    <dgm:cxn modelId="{C4160712-DF53-0F4F-9BBA-78BD9BBF4B88}" type="presOf" srcId="{77E26394-E137-5E44-9434-AC75CD3E8E1C}" destId="{B11406A9-5BCB-7247-9C38-2B1D2505F2B8}" srcOrd="0" destOrd="0" presId="urn:microsoft.com/office/officeart/2005/8/layout/vList5"/>
    <dgm:cxn modelId="{C5A31E1B-1939-A943-9EA9-0D1F931C9095}" srcId="{CE7EC2B3-709C-7049-AC98-40D647A08CD5}" destId="{827957E1-E296-1C4F-A5F6-1C5FE324A00C}" srcOrd="4" destOrd="0" parTransId="{AC89EDA2-97A0-704F-A224-66777968DC79}" sibTransId="{9F52F0F0-B16C-AB44-86AF-35AA79D5B0BB}"/>
    <dgm:cxn modelId="{086EAA1D-3224-4E41-87B1-9FA27037DE47}" type="presOf" srcId="{9F6E5C8F-12F1-3545-94A6-291C5042E69E}" destId="{B6C279C8-1B63-3845-ADAB-B82AEFA3D8E4}" srcOrd="0" destOrd="0" presId="urn:microsoft.com/office/officeart/2005/8/layout/vList5"/>
    <dgm:cxn modelId="{71BBC71D-E55C-424F-B6C9-6E507D91D4E5}" type="presOf" srcId="{D6BB4A41-00B2-5448-BB3F-80605AC75A4E}" destId="{95DA0D8B-BC89-0948-909A-C298332DBD75}" srcOrd="0" destOrd="0" presId="urn:microsoft.com/office/officeart/2005/8/layout/vList5"/>
    <dgm:cxn modelId="{7A4CD21E-5C30-9844-B8CC-04D4CC71350C}" type="presOf" srcId="{4042EA18-93B7-8447-AC0A-58BAED6135AA}" destId="{8CF3EAF4-8574-9841-9B3E-4FBF8CB57172}" srcOrd="0" destOrd="0" presId="urn:microsoft.com/office/officeart/2005/8/layout/vList5"/>
    <dgm:cxn modelId="{EA0CCB2E-33A7-7842-AF42-FDB163C3A0DB}" type="presOf" srcId="{8E966A69-49F1-5E4B-B606-FCAEDAA984ED}" destId="{2EB4DD27-0645-2048-89E9-55CE50FE52DA}" srcOrd="0" destOrd="0" presId="urn:microsoft.com/office/officeart/2005/8/layout/vList5"/>
    <dgm:cxn modelId="{65CEA44F-9E16-EA4E-A309-EC3B3016297A}" srcId="{CE7EC2B3-709C-7049-AC98-40D647A08CD5}" destId="{D03F059F-5021-1F40-A19F-9647158C52AD}" srcOrd="1" destOrd="0" parTransId="{CF000D09-B476-0444-AE02-AACE5A32ABB9}" sibTransId="{294C2440-29C3-A948-ADDD-2D4D34880BDD}"/>
    <dgm:cxn modelId="{2BBF3C50-1ED6-9847-B76B-936F9EDE5606}" srcId="{CE7EC2B3-709C-7049-AC98-40D647A08CD5}" destId="{418E94F4-4F87-154C-8C2C-4FA1854F2962}" srcOrd="3" destOrd="0" parTransId="{67B29BF1-08A2-E04F-9D69-0598739CF13B}" sibTransId="{A5C1BCA8-59E6-2D47-BF9C-24A0A56844F7}"/>
    <dgm:cxn modelId="{3055A850-65BD-2C48-A538-0AAEB9138E85}" srcId="{418E94F4-4F87-154C-8C2C-4FA1854F2962}" destId="{77E26394-E137-5E44-9434-AC75CD3E8E1C}" srcOrd="0" destOrd="0" parTransId="{0106416C-C608-3E4B-95A9-3A27F212EF0D}" sibTransId="{4162CFAB-B676-8E4E-8FEB-32BD16B62DEC}"/>
    <dgm:cxn modelId="{B3273152-AF0F-EE4B-8C28-8B1E95E5CD89}" type="presOf" srcId="{E900B89A-C42B-5249-B68C-A3D7ECDC2722}" destId="{5432570E-A980-7C49-B78B-FBD7E95247D6}" srcOrd="0" destOrd="0" presId="urn:microsoft.com/office/officeart/2005/8/layout/vList5"/>
    <dgm:cxn modelId="{90712D57-061F-8444-BA8A-D8DA5E4630C5}" type="presOf" srcId="{73A345CE-36FD-894D-BBC6-F1148569A643}" destId="{A3A63788-1227-B240-AFF4-87DA3887717D}" srcOrd="0" destOrd="0" presId="urn:microsoft.com/office/officeart/2005/8/layout/vList5"/>
    <dgm:cxn modelId="{B4BAA057-82A7-8F4F-B3AE-D2474B9F0D61}" srcId="{CE7EC2B3-709C-7049-AC98-40D647A08CD5}" destId="{7CF6944D-D814-F446-BDE2-B55C1C344687}" srcOrd="7" destOrd="0" parTransId="{18766106-4E88-954F-80B4-8435CD7E3607}" sibTransId="{41CA9CD1-BD05-D240-8585-F6D044F469D5}"/>
    <dgm:cxn modelId="{BAD62360-A798-6A47-A994-B5126C6DDBBA}" type="presOf" srcId="{D57A6E2B-1DF9-5046-BC1D-709A01F64D7F}" destId="{21D64796-42C1-6A47-B16B-F23C35A117FF}" srcOrd="0" destOrd="0" presId="urn:microsoft.com/office/officeart/2005/8/layout/vList5"/>
    <dgm:cxn modelId="{F6183E77-6BBF-FA47-854D-F0D53AE21A8A}" srcId="{CE7EC2B3-709C-7049-AC98-40D647A08CD5}" destId="{02BDF100-8338-E043-96F5-EE898B9D5AB2}" srcOrd="6" destOrd="0" parTransId="{1B53CCA0-CFF2-384B-856E-1EBDFA4D02AD}" sibTransId="{BCE247F3-63ED-824C-BC43-9D645F88694B}"/>
    <dgm:cxn modelId="{89198578-5DCB-6140-878F-E9FD8D67271F}" type="presOf" srcId="{7CF6944D-D814-F446-BDE2-B55C1C344687}" destId="{D5D04DA4-D0C2-DE47-8C8C-0B8EFFA304FE}" srcOrd="0" destOrd="0" presId="urn:microsoft.com/office/officeart/2005/8/layout/vList5"/>
    <dgm:cxn modelId="{408ED183-BF58-1C4B-97FD-732582625FEF}" srcId="{CE7EC2B3-709C-7049-AC98-40D647A08CD5}" destId="{73A345CE-36FD-894D-BBC6-F1148569A643}" srcOrd="2" destOrd="0" parTransId="{E3B27BD6-FBE2-5640-8D4A-26A5222CC3EA}" sibTransId="{7A99C83F-BC00-3743-81E8-552BD253CEC3}"/>
    <dgm:cxn modelId="{B2C59790-5949-8740-B37D-5567793C306C}" srcId="{54EB0C78-47D0-4144-BBA1-ED83F2276A80}" destId="{D57A6E2B-1DF9-5046-BC1D-709A01F64D7F}" srcOrd="0" destOrd="0" parTransId="{C76AEE8B-D94A-7D44-B03A-3FE0785274DD}" sibTransId="{55132C62-F393-2540-A3F5-1E79E69F36CF}"/>
    <dgm:cxn modelId="{2D83CF9B-C8D2-5645-B148-7557D123AE42}" type="presOf" srcId="{827957E1-E296-1C4F-A5F6-1C5FE324A00C}" destId="{4D3677DD-203E-6A46-986E-4A5C658C9303}" srcOrd="0" destOrd="0" presId="urn:microsoft.com/office/officeart/2005/8/layout/vList5"/>
    <dgm:cxn modelId="{D734F3A8-F28E-EC4B-833E-A76A8DF839E2}" type="presOf" srcId="{D03F059F-5021-1F40-A19F-9647158C52AD}" destId="{6CEBA26E-9501-3E41-ACBB-39C96B19A924}" srcOrd="0" destOrd="0" presId="urn:microsoft.com/office/officeart/2005/8/layout/vList5"/>
    <dgm:cxn modelId="{8EA459AB-225B-8C4D-9825-5D1C6BF10277}" srcId="{73A345CE-36FD-894D-BBC6-F1148569A643}" destId="{E900B89A-C42B-5249-B68C-A3D7ECDC2722}" srcOrd="0" destOrd="0" parTransId="{8E839505-C7B5-E846-B572-409C6E14F87D}" sibTransId="{1CCB8A03-5593-CE44-86BA-AACEAE0CCB98}"/>
    <dgm:cxn modelId="{54AEA8B7-F89B-724F-98A1-0AEC5D7FC3A2}" srcId="{CE7EC2B3-709C-7049-AC98-40D647A08CD5}" destId="{54EB0C78-47D0-4144-BBA1-ED83F2276A80}" srcOrd="0" destOrd="0" parTransId="{46A28A5B-8A7C-BF49-A5DC-996D874F74B0}" sibTransId="{E8376F97-8FAC-AA43-868D-BB3E335B92F2}"/>
    <dgm:cxn modelId="{D85391B8-F585-FD43-82E0-8ACB9B810BF4}" srcId="{827957E1-E296-1C4F-A5F6-1C5FE324A00C}" destId="{B3ABDBBC-28C2-CC44-9EA0-940A074F9BF0}" srcOrd="0" destOrd="0" parTransId="{D1297B60-D255-DA44-8D75-399213932CFB}" sibTransId="{B1A1C092-087B-F241-9B26-AD1D13C72D4D}"/>
    <dgm:cxn modelId="{DF1A41C0-D8B8-6D4F-A8A5-91EC68AFBCAD}" srcId="{9F6E5C8F-12F1-3545-94A6-291C5042E69E}" destId="{D6BB4A41-00B2-5448-BB3F-80605AC75A4E}" srcOrd="0" destOrd="0" parTransId="{4E04882C-8060-1D42-8502-5D210AA0DCD3}" sibTransId="{A3F6C628-648D-0249-B65F-551AF9ECEEA6}"/>
    <dgm:cxn modelId="{F2E046C8-391B-6946-ACE6-697EC224AB98}" type="presOf" srcId="{B3ABDBBC-28C2-CC44-9EA0-940A074F9BF0}" destId="{DF481026-182D-AB4B-A938-B9E12915351D}" srcOrd="0" destOrd="0" presId="urn:microsoft.com/office/officeart/2005/8/layout/vList5"/>
    <dgm:cxn modelId="{E2BB9BC9-6DB1-9443-8E35-6250A99E4AD7}" srcId="{02BDF100-8338-E043-96F5-EE898B9D5AB2}" destId="{0545D5E0-C6B3-A447-B001-E955BFE39730}" srcOrd="0" destOrd="0" parTransId="{74548467-254B-2943-9A99-08C07F3E448D}" sibTransId="{43A03E68-4CAE-A344-B58C-38B13B6EE776}"/>
    <dgm:cxn modelId="{A16837DB-2A15-1C45-807B-67AB4EF8E75E}" type="presOf" srcId="{0545D5E0-C6B3-A447-B001-E955BFE39730}" destId="{9D2B4FF6-13FB-EF49-977A-31DF5EE58099}" srcOrd="0" destOrd="0" presId="urn:microsoft.com/office/officeart/2005/8/layout/vList5"/>
    <dgm:cxn modelId="{BBBA16DC-BC73-8048-A725-FE1EF1BF6593}" srcId="{7CF6944D-D814-F446-BDE2-B55C1C344687}" destId="{4042EA18-93B7-8447-AC0A-58BAED6135AA}" srcOrd="0" destOrd="0" parTransId="{2F5CB061-56DE-EB4D-BFD4-36B00E6055CB}" sibTransId="{A608511D-1BB9-EB4E-9E74-CCD7B0DB861D}"/>
    <dgm:cxn modelId="{545F95DE-9A10-3948-9807-36C195D34A35}" srcId="{CE7EC2B3-709C-7049-AC98-40D647A08CD5}" destId="{9F6E5C8F-12F1-3545-94A6-291C5042E69E}" srcOrd="5" destOrd="0" parTransId="{F878F1E0-BA83-0B4F-8407-D69A3E0606E8}" sibTransId="{F501E3C1-886B-5244-A7B1-7A80D72A4D8C}"/>
    <dgm:cxn modelId="{1AC639E1-2DD4-8C49-9596-C5731579DC3A}" type="presOf" srcId="{54EB0C78-47D0-4144-BBA1-ED83F2276A80}" destId="{2F0271A3-745A-A943-B67B-E4069A93AE61}" srcOrd="0" destOrd="0" presId="urn:microsoft.com/office/officeart/2005/8/layout/vList5"/>
    <dgm:cxn modelId="{FBB45EE4-904A-AF48-A0C9-CB655E66EF52}" srcId="{D03F059F-5021-1F40-A19F-9647158C52AD}" destId="{8E966A69-49F1-5E4B-B606-FCAEDAA984ED}" srcOrd="0" destOrd="0" parTransId="{DBAD8E5C-BD8A-8D4C-B4F0-8493200D7696}" sibTransId="{6E022D76-54D3-5040-BFB1-6E3CF648085C}"/>
    <dgm:cxn modelId="{CE4D51EC-1171-9740-9774-3550157EF9C1}" type="presOf" srcId="{418E94F4-4F87-154C-8C2C-4FA1854F2962}" destId="{F459C834-8503-9C47-9E88-19B5B264D39A}" srcOrd="0" destOrd="0" presId="urn:microsoft.com/office/officeart/2005/8/layout/vList5"/>
    <dgm:cxn modelId="{BF236B13-02D1-B64C-986F-0CAF7E0612E5}" type="presParOf" srcId="{C651D352-06FA-1B42-81FF-A95099FE5645}" destId="{2E2FEDEA-0CB5-FD4B-8718-95B9D6A14304}" srcOrd="0" destOrd="0" presId="urn:microsoft.com/office/officeart/2005/8/layout/vList5"/>
    <dgm:cxn modelId="{9578A504-AB23-5044-A923-D3DEFAE4D5E7}" type="presParOf" srcId="{2E2FEDEA-0CB5-FD4B-8718-95B9D6A14304}" destId="{2F0271A3-745A-A943-B67B-E4069A93AE61}" srcOrd="0" destOrd="0" presId="urn:microsoft.com/office/officeart/2005/8/layout/vList5"/>
    <dgm:cxn modelId="{253C94D8-1885-B543-AF3D-F6A1DD424873}" type="presParOf" srcId="{2E2FEDEA-0CB5-FD4B-8718-95B9D6A14304}" destId="{21D64796-42C1-6A47-B16B-F23C35A117FF}" srcOrd="1" destOrd="0" presId="urn:microsoft.com/office/officeart/2005/8/layout/vList5"/>
    <dgm:cxn modelId="{C06B9A2B-4F20-7C45-806D-5E7956B4F171}" type="presParOf" srcId="{C651D352-06FA-1B42-81FF-A95099FE5645}" destId="{B2C4C361-6A0B-BC45-90FD-318B0EB08F6D}" srcOrd="1" destOrd="0" presId="urn:microsoft.com/office/officeart/2005/8/layout/vList5"/>
    <dgm:cxn modelId="{7BF712B5-32BC-7844-BF86-9BFE0BE03182}" type="presParOf" srcId="{C651D352-06FA-1B42-81FF-A95099FE5645}" destId="{277D1FDC-6CD3-BB41-8E20-960C658417CF}" srcOrd="2" destOrd="0" presId="urn:microsoft.com/office/officeart/2005/8/layout/vList5"/>
    <dgm:cxn modelId="{8EE30A21-17AC-A34E-A945-33D32D0CD928}" type="presParOf" srcId="{277D1FDC-6CD3-BB41-8E20-960C658417CF}" destId="{6CEBA26E-9501-3E41-ACBB-39C96B19A924}" srcOrd="0" destOrd="0" presId="urn:microsoft.com/office/officeart/2005/8/layout/vList5"/>
    <dgm:cxn modelId="{3CCA96C7-C68E-DA49-A8B4-DD728A5A5A21}" type="presParOf" srcId="{277D1FDC-6CD3-BB41-8E20-960C658417CF}" destId="{2EB4DD27-0645-2048-89E9-55CE50FE52DA}" srcOrd="1" destOrd="0" presId="urn:microsoft.com/office/officeart/2005/8/layout/vList5"/>
    <dgm:cxn modelId="{4AF2BADF-B9C1-834B-AC41-60901F7D6D95}" type="presParOf" srcId="{C651D352-06FA-1B42-81FF-A95099FE5645}" destId="{33CCAA17-6648-4F4C-9AC2-5ECE7EDB6E70}" srcOrd="3" destOrd="0" presId="urn:microsoft.com/office/officeart/2005/8/layout/vList5"/>
    <dgm:cxn modelId="{2A4E440E-B7D6-6B49-8318-F6B71A21E6CF}" type="presParOf" srcId="{C651D352-06FA-1B42-81FF-A95099FE5645}" destId="{B97FC210-8EA1-614A-91AB-916C1AEFBDEE}" srcOrd="4" destOrd="0" presId="urn:microsoft.com/office/officeart/2005/8/layout/vList5"/>
    <dgm:cxn modelId="{2BDD0334-A1D2-DC42-B9D1-68F24D23B5D5}" type="presParOf" srcId="{B97FC210-8EA1-614A-91AB-916C1AEFBDEE}" destId="{A3A63788-1227-B240-AFF4-87DA3887717D}" srcOrd="0" destOrd="0" presId="urn:microsoft.com/office/officeart/2005/8/layout/vList5"/>
    <dgm:cxn modelId="{C69877D5-79C1-9F4C-B7F4-8AD7D15754EE}" type="presParOf" srcId="{B97FC210-8EA1-614A-91AB-916C1AEFBDEE}" destId="{5432570E-A980-7C49-B78B-FBD7E95247D6}" srcOrd="1" destOrd="0" presId="urn:microsoft.com/office/officeart/2005/8/layout/vList5"/>
    <dgm:cxn modelId="{33ACEA31-C6CD-5547-BED3-2458723FCA4A}" type="presParOf" srcId="{C651D352-06FA-1B42-81FF-A95099FE5645}" destId="{3E055F9F-21A2-424C-8A4E-65EE89C8A916}" srcOrd="5" destOrd="0" presId="urn:microsoft.com/office/officeart/2005/8/layout/vList5"/>
    <dgm:cxn modelId="{A37DA9BE-A47E-BB4D-9CC1-632CE186629D}" type="presParOf" srcId="{C651D352-06FA-1B42-81FF-A95099FE5645}" destId="{3D7F3715-4665-FB42-B9D8-1FF06FE7ED04}" srcOrd="6" destOrd="0" presId="urn:microsoft.com/office/officeart/2005/8/layout/vList5"/>
    <dgm:cxn modelId="{C891109C-0686-B74F-8141-60300585C701}" type="presParOf" srcId="{3D7F3715-4665-FB42-B9D8-1FF06FE7ED04}" destId="{F459C834-8503-9C47-9E88-19B5B264D39A}" srcOrd="0" destOrd="0" presId="urn:microsoft.com/office/officeart/2005/8/layout/vList5"/>
    <dgm:cxn modelId="{2F31821D-0811-794B-B121-3DE9146709AD}" type="presParOf" srcId="{3D7F3715-4665-FB42-B9D8-1FF06FE7ED04}" destId="{B11406A9-5BCB-7247-9C38-2B1D2505F2B8}" srcOrd="1" destOrd="0" presId="urn:microsoft.com/office/officeart/2005/8/layout/vList5"/>
    <dgm:cxn modelId="{0F8FFFCC-28B5-A844-A0C0-4277188A3AC8}" type="presParOf" srcId="{C651D352-06FA-1B42-81FF-A95099FE5645}" destId="{E355AC6F-4099-CB47-B889-4B740E437363}" srcOrd="7" destOrd="0" presId="urn:microsoft.com/office/officeart/2005/8/layout/vList5"/>
    <dgm:cxn modelId="{53EF242F-1951-6046-AB59-C18248626329}" type="presParOf" srcId="{C651D352-06FA-1B42-81FF-A95099FE5645}" destId="{A60CA7D8-39CB-954A-95BD-9B247DA4C063}" srcOrd="8" destOrd="0" presId="urn:microsoft.com/office/officeart/2005/8/layout/vList5"/>
    <dgm:cxn modelId="{ED3BF37E-4F96-D544-B638-C0AB83F1A9B4}" type="presParOf" srcId="{A60CA7D8-39CB-954A-95BD-9B247DA4C063}" destId="{4D3677DD-203E-6A46-986E-4A5C658C9303}" srcOrd="0" destOrd="0" presId="urn:microsoft.com/office/officeart/2005/8/layout/vList5"/>
    <dgm:cxn modelId="{5F05AF10-2999-E74B-852A-D64954D94FF8}" type="presParOf" srcId="{A60CA7D8-39CB-954A-95BD-9B247DA4C063}" destId="{DF481026-182D-AB4B-A938-B9E12915351D}" srcOrd="1" destOrd="0" presId="urn:microsoft.com/office/officeart/2005/8/layout/vList5"/>
    <dgm:cxn modelId="{ACD94F81-0016-934D-9BD5-68D8F780E3B7}" type="presParOf" srcId="{C651D352-06FA-1B42-81FF-A95099FE5645}" destId="{0E9316E9-2C30-AB47-AE90-7E8E046E1AFD}" srcOrd="9" destOrd="0" presId="urn:microsoft.com/office/officeart/2005/8/layout/vList5"/>
    <dgm:cxn modelId="{F8E487A0-A252-584F-8A38-3822D4AF8219}" type="presParOf" srcId="{C651D352-06FA-1B42-81FF-A95099FE5645}" destId="{037794A2-D322-8E40-B011-CE07ECE52AD6}" srcOrd="10" destOrd="0" presId="urn:microsoft.com/office/officeart/2005/8/layout/vList5"/>
    <dgm:cxn modelId="{67548826-ED42-6242-AA6A-DBBB72691D13}" type="presParOf" srcId="{037794A2-D322-8E40-B011-CE07ECE52AD6}" destId="{B6C279C8-1B63-3845-ADAB-B82AEFA3D8E4}" srcOrd="0" destOrd="0" presId="urn:microsoft.com/office/officeart/2005/8/layout/vList5"/>
    <dgm:cxn modelId="{B87CE2C3-5909-4C4E-A75A-B68815D3150A}" type="presParOf" srcId="{037794A2-D322-8E40-B011-CE07ECE52AD6}" destId="{95DA0D8B-BC89-0948-909A-C298332DBD75}" srcOrd="1" destOrd="0" presId="urn:microsoft.com/office/officeart/2005/8/layout/vList5"/>
    <dgm:cxn modelId="{B702A7F2-2B11-8D48-B9AE-A25D0DE633A1}" type="presParOf" srcId="{C651D352-06FA-1B42-81FF-A95099FE5645}" destId="{05C8E7F6-EE84-404A-A830-A5238A04D5A3}" srcOrd="11" destOrd="0" presId="urn:microsoft.com/office/officeart/2005/8/layout/vList5"/>
    <dgm:cxn modelId="{5D36C750-8050-AB49-B923-84B64CB9D59C}" type="presParOf" srcId="{C651D352-06FA-1B42-81FF-A95099FE5645}" destId="{450D1F74-F684-8F4C-A8B3-6F8B553AB682}" srcOrd="12" destOrd="0" presId="urn:microsoft.com/office/officeart/2005/8/layout/vList5"/>
    <dgm:cxn modelId="{69DDD68C-0D88-6141-B93A-2DFC27495FCF}" type="presParOf" srcId="{450D1F74-F684-8F4C-A8B3-6F8B553AB682}" destId="{B67BA8B7-08DC-C244-8300-FCD547033DBD}" srcOrd="0" destOrd="0" presId="urn:microsoft.com/office/officeart/2005/8/layout/vList5"/>
    <dgm:cxn modelId="{772109BC-D0C5-5C47-B68B-C1F238D6D77F}" type="presParOf" srcId="{450D1F74-F684-8F4C-A8B3-6F8B553AB682}" destId="{9D2B4FF6-13FB-EF49-977A-31DF5EE58099}" srcOrd="1" destOrd="0" presId="urn:microsoft.com/office/officeart/2005/8/layout/vList5"/>
    <dgm:cxn modelId="{5EBAD0AC-A244-A44E-ADFB-53F20C58044C}" type="presParOf" srcId="{C651D352-06FA-1B42-81FF-A95099FE5645}" destId="{580F7313-AC0F-FA49-A45E-0C9486F52D6E}" srcOrd="13" destOrd="0" presId="urn:microsoft.com/office/officeart/2005/8/layout/vList5"/>
    <dgm:cxn modelId="{6E9922E5-478F-AF4D-9DCA-7A72508F4F6D}" type="presParOf" srcId="{C651D352-06FA-1B42-81FF-A95099FE5645}" destId="{E737A561-EB87-EC46-B404-0D8CDB0DE287}" srcOrd="14" destOrd="0" presId="urn:microsoft.com/office/officeart/2005/8/layout/vList5"/>
    <dgm:cxn modelId="{8E470ECC-4731-EF49-B2A8-AD4470B8AD53}" type="presParOf" srcId="{E737A561-EB87-EC46-B404-0D8CDB0DE287}" destId="{D5D04DA4-D0C2-DE47-8C8C-0B8EFFA304FE}" srcOrd="0" destOrd="0" presId="urn:microsoft.com/office/officeart/2005/8/layout/vList5"/>
    <dgm:cxn modelId="{B9608D4F-B546-F142-90CB-D6437FE05ACF}" type="presParOf" srcId="{E737A561-EB87-EC46-B404-0D8CDB0DE287}" destId="{8CF3EAF4-8574-9841-9B3E-4FBF8CB57172}"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CE7EC2B3-709C-7049-AC98-40D647A08CD5}" type="doc">
      <dgm:prSet loTypeId="urn:microsoft.com/office/officeart/2005/8/layout/vList5" loCatId="" qsTypeId="urn:microsoft.com/office/officeart/2005/8/quickstyle/simple1" qsCatId="simple" csTypeId="urn:microsoft.com/office/officeart/2005/8/colors/accent1_2" csCatId="accent1" phldr="1"/>
      <dgm:spPr/>
      <dgm:t>
        <a:bodyPr/>
        <a:lstStyle/>
        <a:p>
          <a:endParaRPr lang="en-US"/>
        </a:p>
      </dgm:t>
    </dgm:pt>
    <dgm:pt modelId="{54EB0C78-47D0-4144-BBA1-ED83F2276A80}">
      <dgm:prSet phldrT="[Text]"/>
      <dgm:spPr/>
      <dgm:t>
        <a:bodyPr/>
        <a:lstStyle/>
        <a:p>
          <a:r>
            <a:rPr lang="en-US" dirty="0"/>
            <a:t>1</a:t>
          </a:r>
        </a:p>
      </dgm:t>
    </dgm:pt>
    <dgm:pt modelId="{46A28A5B-8A7C-BF49-A5DC-996D874F74B0}" type="parTrans" cxnId="{54AEA8B7-F89B-724F-98A1-0AEC5D7FC3A2}">
      <dgm:prSet/>
      <dgm:spPr/>
      <dgm:t>
        <a:bodyPr/>
        <a:lstStyle/>
        <a:p>
          <a:endParaRPr lang="en-US"/>
        </a:p>
      </dgm:t>
    </dgm:pt>
    <dgm:pt modelId="{E8376F97-8FAC-AA43-868D-BB3E335B92F2}" type="sibTrans" cxnId="{54AEA8B7-F89B-724F-98A1-0AEC5D7FC3A2}">
      <dgm:prSet/>
      <dgm:spPr/>
      <dgm:t>
        <a:bodyPr/>
        <a:lstStyle/>
        <a:p>
          <a:endParaRPr lang="en-US"/>
        </a:p>
      </dgm:t>
    </dgm:pt>
    <dgm:pt modelId="{D57A6E2B-1DF9-5046-BC1D-709A01F64D7F}">
      <dgm:prSet phldrT="[Text]"/>
      <dgm:spPr/>
      <dgm:t>
        <a:bodyPr/>
        <a:lstStyle/>
        <a:p>
          <a:r>
            <a:rPr lang="en-US"/>
            <a:t>Patient stability</a:t>
          </a:r>
          <a:endParaRPr lang="en-US" dirty="0"/>
        </a:p>
      </dgm:t>
    </dgm:pt>
    <dgm:pt modelId="{C76AEE8B-D94A-7D44-B03A-3FE0785274DD}" type="parTrans" cxnId="{B2C59790-5949-8740-B37D-5567793C306C}">
      <dgm:prSet/>
      <dgm:spPr/>
      <dgm:t>
        <a:bodyPr/>
        <a:lstStyle/>
        <a:p>
          <a:endParaRPr lang="en-US"/>
        </a:p>
      </dgm:t>
    </dgm:pt>
    <dgm:pt modelId="{55132C62-F393-2540-A3F5-1E79E69F36CF}" type="sibTrans" cxnId="{B2C59790-5949-8740-B37D-5567793C306C}">
      <dgm:prSet/>
      <dgm:spPr/>
      <dgm:t>
        <a:bodyPr/>
        <a:lstStyle/>
        <a:p>
          <a:endParaRPr lang="en-US"/>
        </a:p>
      </dgm:t>
    </dgm:pt>
    <dgm:pt modelId="{D03F059F-5021-1F40-A19F-9647158C52AD}">
      <dgm:prSet phldrT="[Text]"/>
      <dgm:spPr/>
      <dgm:t>
        <a:bodyPr/>
        <a:lstStyle/>
        <a:p>
          <a:r>
            <a:rPr lang="en-US" dirty="0"/>
            <a:t>2</a:t>
          </a:r>
        </a:p>
      </dgm:t>
    </dgm:pt>
    <dgm:pt modelId="{CF000D09-B476-0444-AE02-AACE5A32ABB9}" type="parTrans" cxnId="{65CEA44F-9E16-EA4E-A309-EC3B3016297A}">
      <dgm:prSet/>
      <dgm:spPr/>
      <dgm:t>
        <a:bodyPr/>
        <a:lstStyle/>
        <a:p>
          <a:endParaRPr lang="en-US"/>
        </a:p>
      </dgm:t>
    </dgm:pt>
    <dgm:pt modelId="{294C2440-29C3-A948-ADDD-2D4D34880BDD}" type="sibTrans" cxnId="{65CEA44F-9E16-EA4E-A309-EC3B3016297A}">
      <dgm:prSet/>
      <dgm:spPr/>
      <dgm:t>
        <a:bodyPr/>
        <a:lstStyle/>
        <a:p>
          <a:endParaRPr lang="en-US"/>
        </a:p>
      </dgm:t>
    </dgm:pt>
    <dgm:pt modelId="{8E966A69-49F1-5E4B-B606-FCAEDAA984ED}">
      <dgm:prSet phldrT="[Text]"/>
      <dgm:spPr/>
      <dgm:t>
        <a:bodyPr/>
        <a:lstStyle/>
        <a:p>
          <a:r>
            <a:rPr lang="en-US" dirty="0"/>
            <a:t>Emotional check</a:t>
          </a:r>
        </a:p>
      </dgm:t>
    </dgm:pt>
    <dgm:pt modelId="{DBAD8E5C-BD8A-8D4C-B4F0-8493200D7696}" type="parTrans" cxnId="{FBB45EE4-904A-AF48-A0C9-CB655E66EF52}">
      <dgm:prSet/>
      <dgm:spPr/>
      <dgm:t>
        <a:bodyPr/>
        <a:lstStyle/>
        <a:p>
          <a:endParaRPr lang="en-US"/>
        </a:p>
      </dgm:t>
    </dgm:pt>
    <dgm:pt modelId="{6E022D76-54D3-5040-BFB1-6E3CF648085C}" type="sibTrans" cxnId="{FBB45EE4-904A-AF48-A0C9-CB655E66EF52}">
      <dgm:prSet/>
      <dgm:spPr/>
      <dgm:t>
        <a:bodyPr/>
        <a:lstStyle/>
        <a:p>
          <a:endParaRPr lang="en-US"/>
        </a:p>
      </dgm:t>
    </dgm:pt>
    <dgm:pt modelId="{73A345CE-36FD-894D-BBC6-F1148569A643}">
      <dgm:prSet phldrT="[Text]"/>
      <dgm:spPr/>
      <dgm:t>
        <a:bodyPr/>
        <a:lstStyle/>
        <a:p>
          <a:r>
            <a:rPr lang="en-US" dirty="0"/>
            <a:t>3</a:t>
          </a:r>
        </a:p>
      </dgm:t>
    </dgm:pt>
    <dgm:pt modelId="{E3B27BD6-FBE2-5640-8D4A-26A5222CC3EA}" type="parTrans" cxnId="{408ED183-BF58-1C4B-97FD-732582625FEF}">
      <dgm:prSet/>
      <dgm:spPr/>
      <dgm:t>
        <a:bodyPr/>
        <a:lstStyle/>
        <a:p>
          <a:endParaRPr lang="en-US"/>
        </a:p>
      </dgm:t>
    </dgm:pt>
    <dgm:pt modelId="{7A99C83F-BC00-3743-81E8-552BD253CEC3}" type="sibTrans" cxnId="{408ED183-BF58-1C4B-97FD-732582625FEF}">
      <dgm:prSet/>
      <dgm:spPr/>
      <dgm:t>
        <a:bodyPr/>
        <a:lstStyle/>
        <a:p>
          <a:endParaRPr lang="en-US"/>
        </a:p>
      </dgm:t>
    </dgm:pt>
    <dgm:pt modelId="{E900B89A-C42B-5249-B68C-A3D7ECDC2722}">
      <dgm:prSet phldrT="[Text]"/>
      <dgm:spPr/>
      <dgm:t>
        <a:bodyPr/>
        <a:lstStyle/>
        <a:p>
          <a:r>
            <a:rPr lang="en-US" dirty="0"/>
            <a:t>Address bias</a:t>
          </a:r>
        </a:p>
      </dgm:t>
    </dgm:pt>
    <dgm:pt modelId="{8E839505-C7B5-E846-B572-409C6E14F87D}" type="parTrans" cxnId="{8EA459AB-225B-8C4D-9825-5D1C6BF10277}">
      <dgm:prSet/>
      <dgm:spPr/>
      <dgm:t>
        <a:bodyPr/>
        <a:lstStyle/>
        <a:p>
          <a:endParaRPr lang="en-US"/>
        </a:p>
      </dgm:t>
    </dgm:pt>
    <dgm:pt modelId="{1CCB8A03-5593-CE44-86BA-AACEAE0CCB98}" type="sibTrans" cxnId="{8EA459AB-225B-8C4D-9825-5D1C6BF10277}">
      <dgm:prSet/>
      <dgm:spPr/>
      <dgm:t>
        <a:bodyPr/>
        <a:lstStyle/>
        <a:p>
          <a:endParaRPr lang="en-US"/>
        </a:p>
      </dgm:t>
    </dgm:pt>
    <dgm:pt modelId="{418E94F4-4F87-154C-8C2C-4FA1854F2962}">
      <dgm:prSet/>
      <dgm:spPr/>
      <dgm:t>
        <a:bodyPr/>
        <a:lstStyle/>
        <a:p>
          <a:r>
            <a:rPr lang="en-US" dirty="0"/>
            <a:t>4</a:t>
          </a:r>
        </a:p>
      </dgm:t>
    </dgm:pt>
    <dgm:pt modelId="{67B29BF1-08A2-E04F-9D69-0598739CF13B}" type="parTrans" cxnId="{2BBF3C50-1ED6-9847-B76B-936F9EDE5606}">
      <dgm:prSet/>
      <dgm:spPr/>
      <dgm:t>
        <a:bodyPr/>
        <a:lstStyle/>
        <a:p>
          <a:endParaRPr lang="en-US"/>
        </a:p>
      </dgm:t>
    </dgm:pt>
    <dgm:pt modelId="{A5C1BCA8-59E6-2D47-BF9C-24A0A56844F7}" type="sibTrans" cxnId="{2BBF3C50-1ED6-9847-B76B-936F9EDE5606}">
      <dgm:prSet/>
      <dgm:spPr/>
      <dgm:t>
        <a:bodyPr/>
        <a:lstStyle/>
        <a:p>
          <a:endParaRPr lang="en-US"/>
        </a:p>
      </dgm:t>
    </dgm:pt>
    <dgm:pt modelId="{827957E1-E296-1C4F-A5F6-1C5FE324A00C}">
      <dgm:prSet/>
      <dgm:spPr/>
      <dgm:t>
        <a:bodyPr/>
        <a:lstStyle/>
        <a:p>
          <a:r>
            <a:rPr lang="en-US" dirty="0"/>
            <a:t>5</a:t>
          </a:r>
        </a:p>
      </dgm:t>
    </dgm:pt>
    <dgm:pt modelId="{AC89EDA2-97A0-704F-A224-66777968DC79}" type="parTrans" cxnId="{C5A31E1B-1939-A943-9EA9-0D1F931C9095}">
      <dgm:prSet/>
      <dgm:spPr/>
      <dgm:t>
        <a:bodyPr/>
        <a:lstStyle/>
        <a:p>
          <a:endParaRPr lang="en-US"/>
        </a:p>
      </dgm:t>
    </dgm:pt>
    <dgm:pt modelId="{9F52F0F0-B16C-AB44-86AF-35AA79D5B0BB}" type="sibTrans" cxnId="{C5A31E1B-1939-A943-9EA9-0D1F931C9095}">
      <dgm:prSet/>
      <dgm:spPr/>
      <dgm:t>
        <a:bodyPr/>
        <a:lstStyle/>
        <a:p>
          <a:endParaRPr lang="en-US"/>
        </a:p>
      </dgm:t>
    </dgm:pt>
    <dgm:pt modelId="{9F6E5C8F-12F1-3545-94A6-291C5042E69E}">
      <dgm:prSet/>
      <dgm:spPr/>
      <dgm:t>
        <a:bodyPr/>
        <a:lstStyle/>
        <a:p>
          <a:r>
            <a:rPr lang="en-US" dirty="0"/>
            <a:t>6</a:t>
          </a:r>
        </a:p>
      </dgm:t>
    </dgm:pt>
    <dgm:pt modelId="{F878F1E0-BA83-0B4F-8407-D69A3E0606E8}" type="parTrans" cxnId="{545F95DE-9A10-3948-9807-36C195D34A35}">
      <dgm:prSet/>
      <dgm:spPr/>
      <dgm:t>
        <a:bodyPr/>
        <a:lstStyle/>
        <a:p>
          <a:endParaRPr lang="en-US"/>
        </a:p>
      </dgm:t>
    </dgm:pt>
    <dgm:pt modelId="{F501E3C1-886B-5244-A7B1-7A80D72A4D8C}" type="sibTrans" cxnId="{545F95DE-9A10-3948-9807-36C195D34A35}">
      <dgm:prSet/>
      <dgm:spPr/>
      <dgm:t>
        <a:bodyPr/>
        <a:lstStyle/>
        <a:p>
          <a:endParaRPr lang="en-US"/>
        </a:p>
      </dgm:t>
    </dgm:pt>
    <dgm:pt modelId="{02BDF100-8338-E043-96F5-EE898B9D5AB2}">
      <dgm:prSet/>
      <dgm:spPr/>
      <dgm:t>
        <a:bodyPr/>
        <a:lstStyle/>
        <a:p>
          <a:r>
            <a:rPr lang="en-US" dirty="0"/>
            <a:t>7</a:t>
          </a:r>
        </a:p>
      </dgm:t>
    </dgm:pt>
    <dgm:pt modelId="{1B53CCA0-CFF2-384B-856E-1EBDFA4D02AD}" type="parTrans" cxnId="{F6183E77-6BBF-FA47-854D-F0D53AE21A8A}">
      <dgm:prSet/>
      <dgm:spPr/>
      <dgm:t>
        <a:bodyPr/>
        <a:lstStyle/>
        <a:p>
          <a:endParaRPr lang="en-US"/>
        </a:p>
      </dgm:t>
    </dgm:pt>
    <dgm:pt modelId="{BCE247F3-63ED-824C-BC43-9D645F88694B}" type="sibTrans" cxnId="{F6183E77-6BBF-FA47-854D-F0D53AE21A8A}">
      <dgm:prSet/>
      <dgm:spPr/>
      <dgm:t>
        <a:bodyPr/>
        <a:lstStyle/>
        <a:p>
          <a:endParaRPr lang="en-US"/>
        </a:p>
      </dgm:t>
    </dgm:pt>
    <dgm:pt modelId="{7CF6944D-D814-F446-BDE2-B55C1C344687}">
      <dgm:prSet/>
      <dgm:spPr/>
      <dgm:t>
        <a:bodyPr/>
        <a:lstStyle/>
        <a:p>
          <a:r>
            <a:rPr lang="en-US" dirty="0"/>
            <a:t>8</a:t>
          </a:r>
        </a:p>
      </dgm:t>
    </dgm:pt>
    <dgm:pt modelId="{18766106-4E88-954F-80B4-8435CD7E3607}" type="parTrans" cxnId="{B4BAA057-82A7-8F4F-B3AE-D2474B9F0D61}">
      <dgm:prSet/>
      <dgm:spPr/>
      <dgm:t>
        <a:bodyPr/>
        <a:lstStyle/>
        <a:p>
          <a:endParaRPr lang="en-US"/>
        </a:p>
      </dgm:t>
    </dgm:pt>
    <dgm:pt modelId="{41CA9CD1-BD05-D240-8585-F6D044F469D5}" type="sibTrans" cxnId="{B4BAA057-82A7-8F4F-B3AE-D2474B9F0D61}">
      <dgm:prSet/>
      <dgm:spPr/>
      <dgm:t>
        <a:bodyPr/>
        <a:lstStyle/>
        <a:p>
          <a:endParaRPr lang="en-US"/>
        </a:p>
      </dgm:t>
    </dgm:pt>
    <dgm:pt modelId="{77E26394-E137-5E44-9434-AC75CD3E8E1C}">
      <dgm:prSet/>
      <dgm:spPr/>
      <dgm:t>
        <a:bodyPr/>
        <a:lstStyle/>
        <a:p>
          <a:r>
            <a:rPr lang="en-US" dirty="0"/>
            <a:t>Align with patient</a:t>
          </a:r>
        </a:p>
      </dgm:t>
    </dgm:pt>
    <dgm:pt modelId="{0106416C-C608-3E4B-95A9-3A27F212EF0D}" type="parTrans" cxnId="{3055A850-65BD-2C48-A538-0AAEB9138E85}">
      <dgm:prSet/>
      <dgm:spPr/>
      <dgm:t>
        <a:bodyPr/>
        <a:lstStyle/>
        <a:p>
          <a:endParaRPr lang="en-US"/>
        </a:p>
      </dgm:t>
    </dgm:pt>
    <dgm:pt modelId="{4162CFAB-B676-8E4E-8FEB-32BD16B62DEC}" type="sibTrans" cxnId="{3055A850-65BD-2C48-A538-0AAEB9138E85}">
      <dgm:prSet/>
      <dgm:spPr/>
      <dgm:t>
        <a:bodyPr/>
        <a:lstStyle/>
        <a:p>
          <a:endParaRPr lang="en-US"/>
        </a:p>
      </dgm:t>
    </dgm:pt>
    <dgm:pt modelId="{B3ABDBBC-28C2-CC44-9EA0-940A074F9BF0}">
      <dgm:prSet/>
      <dgm:spPr/>
      <dgm:t>
        <a:bodyPr/>
        <a:lstStyle/>
        <a:p>
          <a:r>
            <a:rPr lang="en-US" dirty="0"/>
            <a:t>Align with team</a:t>
          </a:r>
        </a:p>
      </dgm:t>
    </dgm:pt>
    <dgm:pt modelId="{D1297B60-D255-DA44-8D75-399213932CFB}" type="parTrans" cxnId="{D85391B8-F585-FD43-82E0-8ACB9B810BF4}">
      <dgm:prSet/>
      <dgm:spPr/>
      <dgm:t>
        <a:bodyPr/>
        <a:lstStyle/>
        <a:p>
          <a:endParaRPr lang="en-US"/>
        </a:p>
      </dgm:t>
    </dgm:pt>
    <dgm:pt modelId="{B1A1C092-087B-F241-9B26-AD1D13C72D4D}" type="sibTrans" cxnId="{D85391B8-F585-FD43-82E0-8ACB9B810BF4}">
      <dgm:prSet/>
      <dgm:spPr/>
      <dgm:t>
        <a:bodyPr/>
        <a:lstStyle/>
        <a:p>
          <a:endParaRPr lang="en-US"/>
        </a:p>
      </dgm:t>
    </dgm:pt>
    <dgm:pt modelId="{D6BB4A41-00B2-5448-BB3F-80605AC75A4E}">
      <dgm:prSet/>
      <dgm:spPr/>
      <dgm:t>
        <a:bodyPr/>
        <a:lstStyle/>
        <a:p>
          <a:r>
            <a:rPr lang="en-US" dirty="0"/>
            <a:t>Set boundaries</a:t>
          </a:r>
        </a:p>
      </dgm:t>
    </dgm:pt>
    <dgm:pt modelId="{4E04882C-8060-1D42-8502-5D210AA0DCD3}" type="parTrans" cxnId="{DF1A41C0-D8B8-6D4F-A8A5-91EC68AFBCAD}">
      <dgm:prSet/>
      <dgm:spPr/>
      <dgm:t>
        <a:bodyPr/>
        <a:lstStyle/>
        <a:p>
          <a:endParaRPr lang="en-US"/>
        </a:p>
      </dgm:t>
    </dgm:pt>
    <dgm:pt modelId="{A3F6C628-648D-0249-B65F-551AF9ECEEA6}" type="sibTrans" cxnId="{DF1A41C0-D8B8-6D4F-A8A5-91EC68AFBCAD}">
      <dgm:prSet/>
      <dgm:spPr/>
      <dgm:t>
        <a:bodyPr/>
        <a:lstStyle/>
        <a:p>
          <a:endParaRPr lang="en-US"/>
        </a:p>
      </dgm:t>
    </dgm:pt>
    <dgm:pt modelId="{0545D5E0-C6B3-A447-B001-E955BFE39730}">
      <dgm:prSet/>
      <dgm:spPr/>
      <dgm:t>
        <a:bodyPr/>
        <a:lstStyle/>
        <a:p>
          <a:r>
            <a:rPr lang="en-US" dirty="0"/>
            <a:t>Give space</a:t>
          </a:r>
        </a:p>
      </dgm:t>
    </dgm:pt>
    <dgm:pt modelId="{74548467-254B-2943-9A99-08C07F3E448D}" type="parTrans" cxnId="{E2BB9BC9-6DB1-9443-8E35-6250A99E4AD7}">
      <dgm:prSet/>
      <dgm:spPr/>
      <dgm:t>
        <a:bodyPr/>
        <a:lstStyle/>
        <a:p>
          <a:endParaRPr lang="en-US"/>
        </a:p>
      </dgm:t>
    </dgm:pt>
    <dgm:pt modelId="{43A03E68-4CAE-A344-B58C-38B13B6EE776}" type="sibTrans" cxnId="{E2BB9BC9-6DB1-9443-8E35-6250A99E4AD7}">
      <dgm:prSet/>
      <dgm:spPr/>
      <dgm:t>
        <a:bodyPr/>
        <a:lstStyle/>
        <a:p>
          <a:endParaRPr lang="en-US"/>
        </a:p>
      </dgm:t>
    </dgm:pt>
    <dgm:pt modelId="{4042EA18-93B7-8447-AC0A-58BAED6135AA}">
      <dgm:prSet/>
      <dgm:spPr/>
      <dgm:t>
        <a:bodyPr/>
        <a:lstStyle/>
        <a:p>
          <a:r>
            <a:rPr lang="en-US" dirty="0"/>
            <a:t>Seek support</a:t>
          </a:r>
        </a:p>
      </dgm:t>
    </dgm:pt>
    <dgm:pt modelId="{2F5CB061-56DE-EB4D-BFD4-36B00E6055CB}" type="parTrans" cxnId="{BBBA16DC-BC73-8048-A725-FE1EF1BF6593}">
      <dgm:prSet/>
      <dgm:spPr/>
      <dgm:t>
        <a:bodyPr/>
        <a:lstStyle/>
        <a:p>
          <a:endParaRPr lang="en-US"/>
        </a:p>
      </dgm:t>
    </dgm:pt>
    <dgm:pt modelId="{A608511D-1BB9-EB4E-9E74-CCD7B0DB861D}" type="sibTrans" cxnId="{BBBA16DC-BC73-8048-A725-FE1EF1BF6593}">
      <dgm:prSet/>
      <dgm:spPr/>
      <dgm:t>
        <a:bodyPr/>
        <a:lstStyle/>
        <a:p>
          <a:endParaRPr lang="en-US"/>
        </a:p>
      </dgm:t>
    </dgm:pt>
    <dgm:pt modelId="{C651D352-06FA-1B42-81FF-A95099FE5645}" type="pres">
      <dgm:prSet presAssocID="{CE7EC2B3-709C-7049-AC98-40D647A08CD5}" presName="Name0" presStyleCnt="0">
        <dgm:presLayoutVars>
          <dgm:dir/>
          <dgm:animLvl val="lvl"/>
          <dgm:resizeHandles val="exact"/>
        </dgm:presLayoutVars>
      </dgm:prSet>
      <dgm:spPr/>
    </dgm:pt>
    <dgm:pt modelId="{2E2FEDEA-0CB5-FD4B-8718-95B9D6A14304}" type="pres">
      <dgm:prSet presAssocID="{54EB0C78-47D0-4144-BBA1-ED83F2276A80}" presName="linNode" presStyleCnt="0"/>
      <dgm:spPr/>
    </dgm:pt>
    <dgm:pt modelId="{2F0271A3-745A-A943-B67B-E4069A93AE61}" type="pres">
      <dgm:prSet presAssocID="{54EB0C78-47D0-4144-BBA1-ED83F2276A80}" presName="parentText" presStyleLbl="node1" presStyleIdx="0" presStyleCnt="8" custScaleX="67001">
        <dgm:presLayoutVars>
          <dgm:chMax val="1"/>
          <dgm:bulletEnabled val="1"/>
        </dgm:presLayoutVars>
      </dgm:prSet>
      <dgm:spPr/>
    </dgm:pt>
    <dgm:pt modelId="{21D64796-42C1-6A47-B16B-F23C35A117FF}" type="pres">
      <dgm:prSet presAssocID="{54EB0C78-47D0-4144-BBA1-ED83F2276A80}" presName="descendantText" presStyleLbl="alignAccFollowNode1" presStyleIdx="0" presStyleCnt="8">
        <dgm:presLayoutVars>
          <dgm:bulletEnabled val="1"/>
        </dgm:presLayoutVars>
      </dgm:prSet>
      <dgm:spPr/>
    </dgm:pt>
    <dgm:pt modelId="{B2C4C361-6A0B-BC45-90FD-318B0EB08F6D}" type="pres">
      <dgm:prSet presAssocID="{E8376F97-8FAC-AA43-868D-BB3E335B92F2}" presName="sp" presStyleCnt="0"/>
      <dgm:spPr/>
    </dgm:pt>
    <dgm:pt modelId="{277D1FDC-6CD3-BB41-8E20-960C658417CF}" type="pres">
      <dgm:prSet presAssocID="{D03F059F-5021-1F40-A19F-9647158C52AD}" presName="linNode" presStyleCnt="0"/>
      <dgm:spPr/>
    </dgm:pt>
    <dgm:pt modelId="{6CEBA26E-9501-3E41-ACBB-39C96B19A924}" type="pres">
      <dgm:prSet presAssocID="{D03F059F-5021-1F40-A19F-9647158C52AD}" presName="parentText" presStyleLbl="node1" presStyleIdx="1" presStyleCnt="8" custScaleX="67001">
        <dgm:presLayoutVars>
          <dgm:chMax val="1"/>
          <dgm:bulletEnabled val="1"/>
        </dgm:presLayoutVars>
      </dgm:prSet>
      <dgm:spPr/>
    </dgm:pt>
    <dgm:pt modelId="{2EB4DD27-0645-2048-89E9-55CE50FE52DA}" type="pres">
      <dgm:prSet presAssocID="{D03F059F-5021-1F40-A19F-9647158C52AD}" presName="descendantText" presStyleLbl="alignAccFollowNode1" presStyleIdx="1" presStyleCnt="8">
        <dgm:presLayoutVars>
          <dgm:bulletEnabled val="1"/>
        </dgm:presLayoutVars>
      </dgm:prSet>
      <dgm:spPr/>
    </dgm:pt>
    <dgm:pt modelId="{33CCAA17-6648-4F4C-9AC2-5ECE7EDB6E70}" type="pres">
      <dgm:prSet presAssocID="{294C2440-29C3-A948-ADDD-2D4D34880BDD}" presName="sp" presStyleCnt="0"/>
      <dgm:spPr/>
    </dgm:pt>
    <dgm:pt modelId="{B97FC210-8EA1-614A-91AB-916C1AEFBDEE}" type="pres">
      <dgm:prSet presAssocID="{73A345CE-36FD-894D-BBC6-F1148569A643}" presName="linNode" presStyleCnt="0"/>
      <dgm:spPr/>
    </dgm:pt>
    <dgm:pt modelId="{A3A63788-1227-B240-AFF4-87DA3887717D}" type="pres">
      <dgm:prSet presAssocID="{73A345CE-36FD-894D-BBC6-F1148569A643}" presName="parentText" presStyleLbl="node1" presStyleIdx="2" presStyleCnt="8" custScaleX="67001">
        <dgm:presLayoutVars>
          <dgm:chMax val="1"/>
          <dgm:bulletEnabled val="1"/>
        </dgm:presLayoutVars>
      </dgm:prSet>
      <dgm:spPr/>
    </dgm:pt>
    <dgm:pt modelId="{5432570E-A980-7C49-B78B-FBD7E95247D6}" type="pres">
      <dgm:prSet presAssocID="{73A345CE-36FD-894D-BBC6-F1148569A643}" presName="descendantText" presStyleLbl="alignAccFollowNode1" presStyleIdx="2" presStyleCnt="8">
        <dgm:presLayoutVars>
          <dgm:bulletEnabled val="1"/>
        </dgm:presLayoutVars>
      </dgm:prSet>
      <dgm:spPr/>
    </dgm:pt>
    <dgm:pt modelId="{3E055F9F-21A2-424C-8A4E-65EE89C8A916}" type="pres">
      <dgm:prSet presAssocID="{7A99C83F-BC00-3743-81E8-552BD253CEC3}" presName="sp" presStyleCnt="0"/>
      <dgm:spPr/>
    </dgm:pt>
    <dgm:pt modelId="{3D7F3715-4665-FB42-B9D8-1FF06FE7ED04}" type="pres">
      <dgm:prSet presAssocID="{418E94F4-4F87-154C-8C2C-4FA1854F2962}" presName="linNode" presStyleCnt="0"/>
      <dgm:spPr/>
    </dgm:pt>
    <dgm:pt modelId="{F459C834-8503-9C47-9E88-19B5B264D39A}" type="pres">
      <dgm:prSet presAssocID="{418E94F4-4F87-154C-8C2C-4FA1854F2962}" presName="parentText" presStyleLbl="node1" presStyleIdx="3" presStyleCnt="8" custScaleX="67001">
        <dgm:presLayoutVars>
          <dgm:chMax val="1"/>
          <dgm:bulletEnabled val="1"/>
        </dgm:presLayoutVars>
      </dgm:prSet>
      <dgm:spPr/>
    </dgm:pt>
    <dgm:pt modelId="{B11406A9-5BCB-7247-9C38-2B1D2505F2B8}" type="pres">
      <dgm:prSet presAssocID="{418E94F4-4F87-154C-8C2C-4FA1854F2962}" presName="descendantText" presStyleLbl="alignAccFollowNode1" presStyleIdx="3" presStyleCnt="8">
        <dgm:presLayoutVars>
          <dgm:bulletEnabled val="1"/>
        </dgm:presLayoutVars>
      </dgm:prSet>
      <dgm:spPr/>
    </dgm:pt>
    <dgm:pt modelId="{E355AC6F-4099-CB47-B889-4B740E437363}" type="pres">
      <dgm:prSet presAssocID="{A5C1BCA8-59E6-2D47-BF9C-24A0A56844F7}" presName="sp" presStyleCnt="0"/>
      <dgm:spPr/>
    </dgm:pt>
    <dgm:pt modelId="{A60CA7D8-39CB-954A-95BD-9B247DA4C063}" type="pres">
      <dgm:prSet presAssocID="{827957E1-E296-1C4F-A5F6-1C5FE324A00C}" presName="linNode" presStyleCnt="0"/>
      <dgm:spPr/>
    </dgm:pt>
    <dgm:pt modelId="{4D3677DD-203E-6A46-986E-4A5C658C9303}" type="pres">
      <dgm:prSet presAssocID="{827957E1-E296-1C4F-A5F6-1C5FE324A00C}" presName="parentText" presStyleLbl="node1" presStyleIdx="4" presStyleCnt="8" custScaleX="67001">
        <dgm:presLayoutVars>
          <dgm:chMax val="1"/>
          <dgm:bulletEnabled val="1"/>
        </dgm:presLayoutVars>
      </dgm:prSet>
      <dgm:spPr/>
    </dgm:pt>
    <dgm:pt modelId="{DF481026-182D-AB4B-A938-B9E12915351D}" type="pres">
      <dgm:prSet presAssocID="{827957E1-E296-1C4F-A5F6-1C5FE324A00C}" presName="descendantText" presStyleLbl="alignAccFollowNode1" presStyleIdx="4" presStyleCnt="8">
        <dgm:presLayoutVars>
          <dgm:bulletEnabled val="1"/>
        </dgm:presLayoutVars>
      </dgm:prSet>
      <dgm:spPr/>
    </dgm:pt>
    <dgm:pt modelId="{0E9316E9-2C30-AB47-AE90-7E8E046E1AFD}" type="pres">
      <dgm:prSet presAssocID="{9F52F0F0-B16C-AB44-86AF-35AA79D5B0BB}" presName="sp" presStyleCnt="0"/>
      <dgm:spPr/>
    </dgm:pt>
    <dgm:pt modelId="{037794A2-D322-8E40-B011-CE07ECE52AD6}" type="pres">
      <dgm:prSet presAssocID="{9F6E5C8F-12F1-3545-94A6-291C5042E69E}" presName="linNode" presStyleCnt="0"/>
      <dgm:spPr/>
    </dgm:pt>
    <dgm:pt modelId="{B6C279C8-1B63-3845-ADAB-B82AEFA3D8E4}" type="pres">
      <dgm:prSet presAssocID="{9F6E5C8F-12F1-3545-94A6-291C5042E69E}" presName="parentText" presStyleLbl="node1" presStyleIdx="5" presStyleCnt="8" custScaleX="67001">
        <dgm:presLayoutVars>
          <dgm:chMax val="1"/>
          <dgm:bulletEnabled val="1"/>
        </dgm:presLayoutVars>
      </dgm:prSet>
      <dgm:spPr/>
    </dgm:pt>
    <dgm:pt modelId="{95DA0D8B-BC89-0948-909A-C298332DBD75}" type="pres">
      <dgm:prSet presAssocID="{9F6E5C8F-12F1-3545-94A6-291C5042E69E}" presName="descendantText" presStyleLbl="alignAccFollowNode1" presStyleIdx="5" presStyleCnt="8">
        <dgm:presLayoutVars>
          <dgm:bulletEnabled val="1"/>
        </dgm:presLayoutVars>
      </dgm:prSet>
      <dgm:spPr/>
    </dgm:pt>
    <dgm:pt modelId="{05C8E7F6-EE84-404A-A830-A5238A04D5A3}" type="pres">
      <dgm:prSet presAssocID="{F501E3C1-886B-5244-A7B1-7A80D72A4D8C}" presName="sp" presStyleCnt="0"/>
      <dgm:spPr/>
    </dgm:pt>
    <dgm:pt modelId="{450D1F74-F684-8F4C-A8B3-6F8B553AB682}" type="pres">
      <dgm:prSet presAssocID="{02BDF100-8338-E043-96F5-EE898B9D5AB2}" presName="linNode" presStyleCnt="0"/>
      <dgm:spPr/>
    </dgm:pt>
    <dgm:pt modelId="{B67BA8B7-08DC-C244-8300-FCD547033DBD}" type="pres">
      <dgm:prSet presAssocID="{02BDF100-8338-E043-96F5-EE898B9D5AB2}" presName="parentText" presStyleLbl="node1" presStyleIdx="6" presStyleCnt="8" custScaleX="67001">
        <dgm:presLayoutVars>
          <dgm:chMax val="1"/>
          <dgm:bulletEnabled val="1"/>
        </dgm:presLayoutVars>
      </dgm:prSet>
      <dgm:spPr/>
    </dgm:pt>
    <dgm:pt modelId="{9D2B4FF6-13FB-EF49-977A-31DF5EE58099}" type="pres">
      <dgm:prSet presAssocID="{02BDF100-8338-E043-96F5-EE898B9D5AB2}" presName="descendantText" presStyleLbl="alignAccFollowNode1" presStyleIdx="6" presStyleCnt="8">
        <dgm:presLayoutVars>
          <dgm:bulletEnabled val="1"/>
        </dgm:presLayoutVars>
      </dgm:prSet>
      <dgm:spPr/>
    </dgm:pt>
    <dgm:pt modelId="{580F7313-AC0F-FA49-A45E-0C9486F52D6E}" type="pres">
      <dgm:prSet presAssocID="{BCE247F3-63ED-824C-BC43-9D645F88694B}" presName="sp" presStyleCnt="0"/>
      <dgm:spPr/>
    </dgm:pt>
    <dgm:pt modelId="{E737A561-EB87-EC46-B404-0D8CDB0DE287}" type="pres">
      <dgm:prSet presAssocID="{7CF6944D-D814-F446-BDE2-B55C1C344687}" presName="linNode" presStyleCnt="0"/>
      <dgm:spPr/>
    </dgm:pt>
    <dgm:pt modelId="{D5D04DA4-D0C2-DE47-8C8C-0B8EFFA304FE}" type="pres">
      <dgm:prSet presAssocID="{7CF6944D-D814-F446-BDE2-B55C1C344687}" presName="parentText" presStyleLbl="node1" presStyleIdx="7" presStyleCnt="8" custScaleX="67001">
        <dgm:presLayoutVars>
          <dgm:chMax val="1"/>
          <dgm:bulletEnabled val="1"/>
        </dgm:presLayoutVars>
      </dgm:prSet>
      <dgm:spPr/>
    </dgm:pt>
    <dgm:pt modelId="{8CF3EAF4-8574-9841-9B3E-4FBF8CB57172}" type="pres">
      <dgm:prSet presAssocID="{7CF6944D-D814-F446-BDE2-B55C1C344687}" presName="descendantText" presStyleLbl="alignAccFollowNode1" presStyleIdx="7" presStyleCnt="8">
        <dgm:presLayoutVars>
          <dgm:bulletEnabled val="1"/>
        </dgm:presLayoutVars>
      </dgm:prSet>
      <dgm:spPr/>
    </dgm:pt>
  </dgm:ptLst>
  <dgm:cxnLst>
    <dgm:cxn modelId="{E4273A05-E6BD-7B48-BAB7-FF2C885BDD30}" type="presOf" srcId="{02BDF100-8338-E043-96F5-EE898B9D5AB2}" destId="{B67BA8B7-08DC-C244-8300-FCD547033DBD}" srcOrd="0" destOrd="0" presId="urn:microsoft.com/office/officeart/2005/8/layout/vList5"/>
    <dgm:cxn modelId="{E9D1E10C-1628-524C-9321-D84C071FF74D}" type="presOf" srcId="{CE7EC2B3-709C-7049-AC98-40D647A08CD5}" destId="{C651D352-06FA-1B42-81FF-A95099FE5645}" srcOrd="0" destOrd="0" presId="urn:microsoft.com/office/officeart/2005/8/layout/vList5"/>
    <dgm:cxn modelId="{C4160712-DF53-0F4F-9BBA-78BD9BBF4B88}" type="presOf" srcId="{77E26394-E137-5E44-9434-AC75CD3E8E1C}" destId="{B11406A9-5BCB-7247-9C38-2B1D2505F2B8}" srcOrd="0" destOrd="0" presId="urn:microsoft.com/office/officeart/2005/8/layout/vList5"/>
    <dgm:cxn modelId="{C5A31E1B-1939-A943-9EA9-0D1F931C9095}" srcId="{CE7EC2B3-709C-7049-AC98-40D647A08CD5}" destId="{827957E1-E296-1C4F-A5F6-1C5FE324A00C}" srcOrd="4" destOrd="0" parTransId="{AC89EDA2-97A0-704F-A224-66777968DC79}" sibTransId="{9F52F0F0-B16C-AB44-86AF-35AA79D5B0BB}"/>
    <dgm:cxn modelId="{086EAA1D-3224-4E41-87B1-9FA27037DE47}" type="presOf" srcId="{9F6E5C8F-12F1-3545-94A6-291C5042E69E}" destId="{B6C279C8-1B63-3845-ADAB-B82AEFA3D8E4}" srcOrd="0" destOrd="0" presId="urn:microsoft.com/office/officeart/2005/8/layout/vList5"/>
    <dgm:cxn modelId="{71BBC71D-E55C-424F-B6C9-6E507D91D4E5}" type="presOf" srcId="{D6BB4A41-00B2-5448-BB3F-80605AC75A4E}" destId="{95DA0D8B-BC89-0948-909A-C298332DBD75}" srcOrd="0" destOrd="0" presId="urn:microsoft.com/office/officeart/2005/8/layout/vList5"/>
    <dgm:cxn modelId="{7A4CD21E-5C30-9844-B8CC-04D4CC71350C}" type="presOf" srcId="{4042EA18-93B7-8447-AC0A-58BAED6135AA}" destId="{8CF3EAF4-8574-9841-9B3E-4FBF8CB57172}" srcOrd="0" destOrd="0" presId="urn:microsoft.com/office/officeart/2005/8/layout/vList5"/>
    <dgm:cxn modelId="{EA0CCB2E-33A7-7842-AF42-FDB163C3A0DB}" type="presOf" srcId="{8E966A69-49F1-5E4B-B606-FCAEDAA984ED}" destId="{2EB4DD27-0645-2048-89E9-55CE50FE52DA}" srcOrd="0" destOrd="0" presId="urn:microsoft.com/office/officeart/2005/8/layout/vList5"/>
    <dgm:cxn modelId="{65CEA44F-9E16-EA4E-A309-EC3B3016297A}" srcId="{CE7EC2B3-709C-7049-AC98-40D647A08CD5}" destId="{D03F059F-5021-1F40-A19F-9647158C52AD}" srcOrd="1" destOrd="0" parTransId="{CF000D09-B476-0444-AE02-AACE5A32ABB9}" sibTransId="{294C2440-29C3-A948-ADDD-2D4D34880BDD}"/>
    <dgm:cxn modelId="{2BBF3C50-1ED6-9847-B76B-936F9EDE5606}" srcId="{CE7EC2B3-709C-7049-AC98-40D647A08CD5}" destId="{418E94F4-4F87-154C-8C2C-4FA1854F2962}" srcOrd="3" destOrd="0" parTransId="{67B29BF1-08A2-E04F-9D69-0598739CF13B}" sibTransId="{A5C1BCA8-59E6-2D47-BF9C-24A0A56844F7}"/>
    <dgm:cxn modelId="{3055A850-65BD-2C48-A538-0AAEB9138E85}" srcId="{418E94F4-4F87-154C-8C2C-4FA1854F2962}" destId="{77E26394-E137-5E44-9434-AC75CD3E8E1C}" srcOrd="0" destOrd="0" parTransId="{0106416C-C608-3E4B-95A9-3A27F212EF0D}" sibTransId="{4162CFAB-B676-8E4E-8FEB-32BD16B62DEC}"/>
    <dgm:cxn modelId="{B3273152-AF0F-EE4B-8C28-8B1E95E5CD89}" type="presOf" srcId="{E900B89A-C42B-5249-B68C-A3D7ECDC2722}" destId="{5432570E-A980-7C49-B78B-FBD7E95247D6}" srcOrd="0" destOrd="0" presId="urn:microsoft.com/office/officeart/2005/8/layout/vList5"/>
    <dgm:cxn modelId="{90712D57-061F-8444-BA8A-D8DA5E4630C5}" type="presOf" srcId="{73A345CE-36FD-894D-BBC6-F1148569A643}" destId="{A3A63788-1227-B240-AFF4-87DA3887717D}" srcOrd="0" destOrd="0" presId="urn:microsoft.com/office/officeart/2005/8/layout/vList5"/>
    <dgm:cxn modelId="{B4BAA057-82A7-8F4F-B3AE-D2474B9F0D61}" srcId="{CE7EC2B3-709C-7049-AC98-40D647A08CD5}" destId="{7CF6944D-D814-F446-BDE2-B55C1C344687}" srcOrd="7" destOrd="0" parTransId="{18766106-4E88-954F-80B4-8435CD7E3607}" sibTransId="{41CA9CD1-BD05-D240-8585-F6D044F469D5}"/>
    <dgm:cxn modelId="{BAD62360-A798-6A47-A994-B5126C6DDBBA}" type="presOf" srcId="{D57A6E2B-1DF9-5046-BC1D-709A01F64D7F}" destId="{21D64796-42C1-6A47-B16B-F23C35A117FF}" srcOrd="0" destOrd="0" presId="urn:microsoft.com/office/officeart/2005/8/layout/vList5"/>
    <dgm:cxn modelId="{F6183E77-6BBF-FA47-854D-F0D53AE21A8A}" srcId="{CE7EC2B3-709C-7049-AC98-40D647A08CD5}" destId="{02BDF100-8338-E043-96F5-EE898B9D5AB2}" srcOrd="6" destOrd="0" parTransId="{1B53CCA0-CFF2-384B-856E-1EBDFA4D02AD}" sibTransId="{BCE247F3-63ED-824C-BC43-9D645F88694B}"/>
    <dgm:cxn modelId="{89198578-5DCB-6140-878F-E9FD8D67271F}" type="presOf" srcId="{7CF6944D-D814-F446-BDE2-B55C1C344687}" destId="{D5D04DA4-D0C2-DE47-8C8C-0B8EFFA304FE}" srcOrd="0" destOrd="0" presId="urn:microsoft.com/office/officeart/2005/8/layout/vList5"/>
    <dgm:cxn modelId="{408ED183-BF58-1C4B-97FD-732582625FEF}" srcId="{CE7EC2B3-709C-7049-AC98-40D647A08CD5}" destId="{73A345CE-36FD-894D-BBC6-F1148569A643}" srcOrd="2" destOrd="0" parTransId="{E3B27BD6-FBE2-5640-8D4A-26A5222CC3EA}" sibTransId="{7A99C83F-BC00-3743-81E8-552BD253CEC3}"/>
    <dgm:cxn modelId="{B2C59790-5949-8740-B37D-5567793C306C}" srcId="{54EB0C78-47D0-4144-BBA1-ED83F2276A80}" destId="{D57A6E2B-1DF9-5046-BC1D-709A01F64D7F}" srcOrd="0" destOrd="0" parTransId="{C76AEE8B-D94A-7D44-B03A-3FE0785274DD}" sibTransId="{55132C62-F393-2540-A3F5-1E79E69F36CF}"/>
    <dgm:cxn modelId="{2D83CF9B-C8D2-5645-B148-7557D123AE42}" type="presOf" srcId="{827957E1-E296-1C4F-A5F6-1C5FE324A00C}" destId="{4D3677DD-203E-6A46-986E-4A5C658C9303}" srcOrd="0" destOrd="0" presId="urn:microsoft.com/office/officeart/2005/8/layout/vList5"/>
    <dgm:cxn modelId="{D734F3A8-F28E-EC4B-833E-A76A8DF839E2}" type="presOf" srcId="{D03F059F-5021-1F40-A19F-9647158C52AD}" destId="{6CEBA26E-9501-3E41-ACBB-39C96B19A924}" srcOrd="0" destOrd="0" presId="urn:microsoft.com/office/officeart/2005/8/layout/vList5"/>
    <dgm:cxn modelId="{8EA459AB-225B-8C4D-9825-5D1C6BF10277}" srcId="{73A345CE-36FD-894D-BBC6-F1148569A643}" destId="{E900B89A-C42B-5249-B68C-A3D7ECDC2722}" srcOrd="0" destOrd="0" parTransId="{8E839505-C7B5-E846-B572-409C6E14F87D}" sibTransId="{1CCB8A03-5593-CE44-86BA-AACEAE0CCB98}"/>
    <dgm:cxn modelId="{54AEA8B7-F89B-724F-98A1-0AEC5D7FC3A2}" srcId="{CE7EC2B3-709C-7049-AC98-40D647A08CD5}" destId="{54EB0C78-47D0-4144-BBA1-ED83F2276A80}" srcOrd="0" destOrd="0" parTransId="{46A28A5B-8A7C-BF49-A5DC-996D874F74B0}" sibTransId="{E8376F97-8FAC-AA43-868D-BB3E335B92F2}"/>
    <dgm:cxn modelId="{D85391B8-F585-FD43-82E0-8ACB9B810BF4}" srcId="{827957E1-E296-1C4F-A5F6-1C5FE324A00C}" destId="{B3ABDBBC-28C2-CC44-9EA0-940A074F9BF0}" srcOrd="0" destOrd="0" parTransId="{D1297B60-D255-DA44-8D75-399213932CFB}" sibTransId="{B1A1C092-087B-F241-9B26-AD1D13C72D4D}"/>
    <dgm:cxn modelId="{DF1A41C0-D8B8-6D4F-A8A5-91EC68AFBCAD}" srcId="{9F6E5C8F-12F1-3545-94A6-291C5042E69E}" destId="{D6BB4A41-00B2-5448-BB3F-80605AC75A4E}" srcOrd="0" destOrd="0" parTransId="{4E04882C-8060-1D42-8502-5D210AA0DCD3}" sibTransId="{A3F6C628-648D-0249-B65F-551AF9ECEEA6}"/>
    <dgm:cxn modelId="{F2E046C8-391B-6946-ACE6-697EC224AB98}" type="presOf" srcId="{B3ABDBBC-28C2-CC44-9EA0-940A074F9BF0}" destId="{DF481026-182D-AB4B-A938-B9E12915351D}" srcOrd="0" destOrd="0" presId="urn:microsoft.com/office/officeart/2005/8/layout/vList5"/>
    <dgm:cxn modelId="{E2BB9BC9-6DB1-9443-8E35-6250A99E4AD7}" srcId="{02BDF100-8338-E043-96F5-EE898B9D5AB2}" destId="{0545D5E0-C6B3-A447-B001-E955BFE39730}" srcOrd="0" destOrd="0" parTransId="{74548467-254B-2943-9A99-08C07F3E448D}" sibTransId="{43A03E68-4CAE-A344-B58C-38B13B6EE776}"/>
    <dgm:cxn modelId="{A16837DB-2A15-1C45-807B-67AB4EF8E75E}" type="presOf" srcId="{0545D5E0-C6B3-A447-B001-E955BFE39730}" destId="{9D2B4FF6-13FB-EF49-977A-31DF5EE58099}" srcOrd="0" destOrd="0" presId="urn:microsoft.com/office/officeart/2005/8/layout/vList5"/>
    <dgm:cxn modelId="{BBBA16DC-BC73-8048-A725-FE1EF1BF6593}" srcId="{7CF6944D-D814-F446-BDE2-B55C1C344687}" destId="{4042EA18-93B7-8447-AC0A-58BAED6135AA}" srcOrd="0" destOrd="0" parTransId="{2F5CB061-56DE-EB4D-BFD4-36B00E6055CB}" sibTransId="{A608511D-1BB9-EB4E-9E74-CCD7B0DB861D}"/>
    <dgm:cxn modelId="{545F95DE-9A10-3948-9807-36C195D34A35}" srcId="{CE7EC2B3-709C-7049-AC98-40D647A08CD5}" destId="{9F6E5C8F-12F1-3545-94A6-291C5042E69E}" srcOrd="5" destOrd="0" parTransId="{F878F1E0-BA83-0B4F-8407-D69A3E0606E8}" sibTransId="{F501E3C1-886B-5244-A7B1-7A80D72A4D8C}"/>
    <dgm:cxn modelId="{1AC639E1-2DD4-8C49-9596-C5731579DC3A}" type="presOf" srcId="{54EB0C78-47D0-4144-BBA1-ED83F2276A80}" destId="{2F0271A3-745A-A943-B67B-E4069A93AE61}" srcOrd="0" destOrd="0" presId="urn:microsoft.com/office/officeart/2005/8/layout/vList5"/>
    <dgm:cxn modelId="{FBB45EE4-904A-AF48-A0C9-CB655E66EF52}" srcId="{D03F059F-5021-1F40-A19F-9647158C52AD}" destId="{8E966A69-49F1-5E4B-B606-FCAEDAA984ED}" srcOrd="0" destOrd="0" parTransId="{DBAD8E5C-BD8A-8D4C-B4F0-8493200D7696}" sibTransId="{6E022D76-54D3-5040-BFB1-6E3CF648085C}"/>
    <dgm:cxn modelId="{CE4D51EC-1171-9740-9774-3550157EF9C1}" type="presOf" srcId="{418E94F4-4F87-154C-8C2C-4FA1854F2962}" destId="{F459C834-8503-9C47-9E88-19B5B264D39A}" srcOrd="0" destOrd="0" presId="urn:microsoft.com/office/officeart/2005/8/layout/vList5"/>
    <dgm:cxn modelId="{BF236B13-02D1-B64C-986F-0CAF7E0612E5}" type="presParOf" srcId="{C651D352-06FA-1B42-81FF-A95099FE5645}" destId="{2E2FEDEA-0CB5-FD4B-8718-95B9D6A14304}" srcOrd="0" destOrd="0" presId="urn:microsoft.com/office/officeart/2005/8/layout/vList5"/>
    <dgm:cxn modelId="{9578A504-AB23-5044-A923-D3DEFAE4D5E7}" type="presParOf" srcId="{2E2FEDEA-0CB5-FD4B-8718-95B9D6A14304}" destId="{2F0271A3-745A-A943-B67B-E4069A93AE61}" srcOrd="0" destOrd="0" presId="urn:microsoft.com/office/officeart/2005/8/layout/vList5"/>
    <dgm:cxn modelId="{253C94D8-1885-B543-AF3D-F6A1DD424873}" type="presParOf" srcId="{2E2FEDEA-0CB5-FD4B-8718-95B9D6A14304}" destId="{21D64796-42C1-6A47-B16B-F23C35A117FF}" srcOrd="1" destOrd="0" presId="urn:microsoft.com/office/officeart/2005/8/layout/vList5"/>
    <dgm:cxn modelId="{C06B9A2B-4F20-7C45-806D-5E7956B4F171}" type="presParOf" srcId="{C651D352-06FA-1B42-81FF-A95099FE5645}" destId="{B2C4C361-6A0B-BC45-90FD-318B0EB08F6D}" srcOrd="1" destOrd="0" presId="urn:microsoft.com/office/officeart/2005/8/layout/vList5"/>
    <dgm:cxn modelId="{7BF712B5-32BC-7844-BF86-9BFE0BE03182}" type="presParOf" srcId="{C651D352-06FA-1B42-81FF-A95099FE5645}" destId="{277D1FDC-6CD3-BB41-8E20-960C658417CF}" srcOrd="2" destOrd="0" presId="urn:microsoft.com/office/officeart/2005/8/layout/vList5"/>
    <dgm:cxn modelId="{8EE30A21-17AC-A34E-A945-33D32D0CD928}" type="presParOf" srcId="{277D1FDC-6CD3-BB41-8E20-960C658417CF}" destId="{6CEBA26E-9501-3E41-ACBB-39C96B19A924}" srcOrd="0" destOrd="0" presId="urn:microsoft.com/office/officeart/2005/8/layout/vList5"/>
    <dgm:cxn modelId="{3CCA96C7-C68E-DA49-A8B4-DD728A5A5A21}" type="presParOf" srcId="{277D1FDC-6CD3-BB41-8E20-960C658417CF}" destId="{2EB4DD27-0645-2048-89E9-55CE50FE52DA}" srcOrd="1" destOrd="0" presId="urn:microsoft.com/office/officeart/2005/8/layout/vList5"/>
    <dgm:cxn modelId="{4AF2BADF-B9C1-834B-AC41-60901F7D6D95}" type="presParOf" srcId="{C651D352-06FA-1B42-81FF-A95099FE5645}" destId="{33CCAA17-6648-4F4C-9AC2-5ECE7EDB6E70}" srcOrd="3" destOrd="0" presId="urn:microsoft.com/office/officeart/2005/8/layout/vList5"/>
    <dgm:cxn modelId="{2A4E440E-B7D6-6B49-8318-F6B71A21E6CF}" type="presParOf" srcId="{C651D352-06FA-1B42-81FF-A95099FE5645}" destId="{B97FC210-8EA1-614A-91AB-916C1AEFBDEE}" srcOrd="4" destOrd="0" presId="urn:microsoft.com/office/officeart/2005/8/layout/vList5"/>
    <dgm:cxn modelId="{2BDD0334-A1D2-DC42-B9D1-68F24D23B5D5}" type="presParOf" srcId="{B97FC210-8EA1-614A-91AB-916C1AEFBDEE}" destId="{A3A63788-1227-B240-AFF4-87DA3887717D}" srcOrd="0" destOrd="0" presId="urn:microsoft.com/office/officeart/2005/8/layout/vList5"/>
    <dgm:cxn modelId="{C69877D5-79C1-9F4C-B7F4-8AD7D15754EE}" type="presParOf" srcId="{B97FC210-8EA1-614A-91AB-916C1AEFBDEE}" destId="{5432570E-A980-7C49-B78B-FBD7E95247D6}" srcOrd="1" destOrd="0" presId="urn:microsoft.com/office/officeart/2005/8/layout/vList5"/>
    <dgm:cxn modelId="{33ACEA31-C6CD-5547-BED3-2458723FCA4A}" type="presParOf" srcId="{C651D352-06FA-1B42-81FF-A95099FE5645}" destId="{3E055F9F-21A2-424C-8A4E-65EE89C8A916}" srcOrd="5" destOrd="0" presId="urn:microsoft.com/office/officeart/2005/8/layout/vList5"/>
    <dgm:cxn modelId="{A37DA9BE-A47E-BB4D-9CC1-632CE186629D}" type="presParOf" srcId="{C651D352-06FA-1B42-81FF-A95099FE5645}" destId="{3D7F3715-4665-FB42-B9D8-1FF06FE7ED04}" srcOrd="6" destOrd="0" presId="urn:microsoft.com/office/officeart/2005/8/layout/vList5"/>
    <dgm:cxn modelId="{C891109C-0686-B74F-8141-60300585C701}" type="presParOf" srcId="{3D7F3715-4665-FB42-B9D8-1FF06FE7ED04}" destId="{F459C834-8503-9C47-9E88-19B5B264D39A}" srcOrd="0" destOrd="0" presId="urn:microsoft.com/office/officeart/2005/8/layout/vList5"/>
    <dgm:cxn modelId="{2F31821D-0811-794B-B121-3DE9146709AD}" type="presParOf" srcId="{3D7F3715-4665-FB42-B9D8-1FF06FE7ED04}" destId="{B11406A9-5BCB-7247-9C38-2B1D2505F2B8}" srcOrd="1" destOrd="0" presId="urn:microsoft.com/office/officeart/2005/8/layout/vList5"/>
    <dgm:cxn modelId="{0F8FFFCC-28B5-A844-A0C0-4277188A3AC8}" type="presParOf" srcId="{C651D352-06FA-1B42-81FF-A95099FE5645}" destId="{E355AC6F-4099-CB47-B889-4B740E437363}" srcOrd="7" destOrd="0" presId="urn:microsoft.com/office/officeart/2005/8/layout/vList5"/>
    <dgm:cxn modelId="{53EF242F-1951-6046-AB59-C18248626329}" type="presParOf" srcId="{C651D352-06FA-1B42-81FF-A95099FE5645}" destId="{A60CA7D8-39CB-954A-95BD-9B247DA4C063}" srcOrd="8" destOrd="0" presId="urn:microsoft.com/office/officeart/2005/8/layout/vList5"/>
    <dgm:cxn modelId="{ED3BF37E-4F96-D544-B638-C0AB83F1A9B4}" type="presParOf" srcId="{A60CA7D8-39CB-954A-95BD-9B247DA4C063}" destId="{4D3677DD-203E-6A46-986E-4A5C658C9303}" srcOrd="0" destOrd="0" presId="urn:microsoft.com/office/officeart/2005/8/layout/vList5"/>
    <dgm:cxn modelId="{5F05AF10-2999-E74B-852A-D64954D94FF8}" type="presParOf" srcId="{A60CA7D8-39CB-954A-95BD-9B247DA4C063}" destId="{DF481026-182D-AB4B-A938-B9E12915351D}" srcOrd="1" destOrd="0" presId="urn:microsoft.com/office/officeart/2005/8/layout/vList5"/>
    <dgm:cxn modelId="{ACD94F81-0016-934D-9BD5-68D8F780E3B7}" type="presParOf" srcId="{C651D352-06FA-1B42-81FF-A95099FE5645}" destId="{0E9316E9-2C30-AB47-AE90-7E8E046E1AFD}" srcOrd="9" destOrd="0" presId="urn:microsoft.com/office/officeart/2005/8/layout/vList5"/>
    <dgm:cxn modelId="{F8E487A0-A252-584F-8A38-3822D4AF8219}" type="presParOf" srcId="{C651D352-06FA-1B42-81FF-A95099FE5645}" destId="{037794A2-D322-8E40-B011-CE07ECE52AD6}" srcOrd="10" destOrd="0" presId="urn:microsoft.com/office/officeart/2005/8/layout/vList5"/>
    <dgm:cxn modelId="{67548826-ED42-6242-AA6A-DBBB72691D13}" type="presParOf" srcId="{037794A2-D322-8E40-B011-CE07ECE52AD6}" destId="{B6C279C8-1B63-3845-ADAB-B82AEFA3D8E4}" srcOrd="0" destOrd="0" presId="urn:microsoft.com/office/officeart/2005/8/layout/vList5"/>
    <dgm:cxn modelId="{B87CE2C3-5909-4C4E-A75A-B68815D3150A}" type="presParOf" srcId="{037794A2-D322-8E40-B011-CE07ECE52AD6}" destId="{95DA0D8B-BC89-0948-909A-C298332DBD75}" srcOrd="1" destOrd="0" presId="urn:microsoft.com/office/officeart/2005/8/layout/vList5"/>
    <dgm:cxn modelId="{B702A7F2-2B11-8D48-B9AE-A25D0DE633A1}" type="presParOf" srcId="{C651D352-06FA-1B42-81FF-A95099FE5645}" destId="{05C8E7F6-EE84-404A-A830-A5238A04D5A3}" srcOrd="11" destOrd="0" presId="urn:microsoft.com/office/officeart/2005/8/layout/vList5"/>
    <dgm:cxn modelId="{5D36C750-8050-AB49-B923-84B64CB9D59C}" type="presParOf" srcId="{C651D352-06FA-1B42-81FF-A95099FE5645}" destId="{450D1F74-F684-8F4C-A8B3-6F8B553AB682}" srcOrd="12" destOrd="0" presId="urn:microsoft.com/office/officeart/2005/8/layout/vList5"/>
    <dgm:cxn modelId="{69DDD68C-0D88-6141-B93A-2DFC27495FCF}" type="presParOf" srcId="{450D1F74-F684-8F4C-A8B3-6F8B553AB682}" destId="{B67BA8B7-08DC-C244-8300-FCD547033DBD}" srcOrd="0" destOrd="0" presId="urn:microsoft.com/office/officeart/2005/8/layout/vList5"/>
    <dgm:cxn modelId="{772109BC-D0C5-5C47-B68B-C1F238D6D77F}" type="presParOf" srcId="{450D1F74-F684-8F4C-A8B3-6F8B553AB682}" destId="{9D2B4FF6-13FB-EF49-977A-31DF5EE58099}" srcOrd="1" destOrd="0" presId="urn:microsoft.com/office/officeart/2005/8/layout/vList5"/>
    <dgm:cxn modelId="{5EBAD0AC-A244-A44E-ADFB-53F20C58044C}" type="presParOf" srcId="{C651D352-06FA-1B42-81FF-A95099FE5645}" destId="{580F7313-AC0F-FA49-A45E-0C9486F52D6E}" srcOrd="13" destOrd="0" presId="urn:microsoft.com/office/officeart/2005/8/layout/vList5"/>
    <dgm:cxn modelId="{6E9922E5-478F-AF4D-9DCA-7A72508F4F6D}" type="presParOf" srcId="{C651D352-06FA-1B42-81FF-A95099FE5645}" destId="{E737A561-EB87-EC46-B404-0D8CDB0DE287}" srcOrd="14" destOrd="0" presId="urn:microsoft.com/office/officeart/2005/8/layout/vList5"/>
    <dgm:cxn modelId="{8E470ECC-4731-EF49-B2A8-AD4470B8AD53}" type="presParOf" srcId="{E737A561-EB87-EC46-B404-0D8CDB0DE287}" destId="{D5D04DA4-D0C2-DE47-8C8C-0B8EFFA304FE}" srcOrd="0" destOrd="0" presId="urn:microsoft.com/office/officeart/2005/8/layout/vList5"/>
    <dgm:cxn modelId="{B9608D4F-B546-F142-90CB-D6437FE05ACF}" type="presParOf" srcId="{E737A561-EB87-EC46-B404-0D8CDB0DE287}" destId="{8CF3EAF4-8574-9841-9B3E-4FBF8CB57172}"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CE7EC2B3-709C-7049-AC98-40D647A08CD5}" type="doc">
      <dgm:prSet loTypeId="urn:microsoft.com/office/officeart/2005/8/layout/vList5" loCatId="" qsTypeId="urn:microsoft.com/office/officeart/2005/8/quickstyle/simple1" qsCatId="simple" csTypeId="urn:microsoft.com/office/officeart/2005/8/colors/accent1_2" csCatId="accent1" phldr="1"/>
      <dgm:spPr/>
      <dgm:t>
        <a:bodyPr/>
        <a:lstStyle/>
        <a:p>
          <a:endParaRPr lang="en-US"/>
        </a:p>
      </dgm:t>
    </dgm:pt>
    <dgm:pt modelId="{54EB0C78-47D0-4144-BBA1-ED83F2276A80}">
      <dgm:prSet phldrT="[Text]"/>
      <dgm:spPr/>
      <dgm:t>
        <a:bodyPr/>
        <a:lstStyle/>
        <a:p>
          <a:r>
            <a:rPr lang="en-US" dirty="0"/>
            <a:t>1</a:t>
          </a:r>
        </a:p>
      </dgm:t>
    </dgm:pt>
    <dgm:pt modelId="{46A28A5B-8A7C-BF49-A5DC-996D874F74B0}" type="parTrans" cxnId="{54AEA8B7-F89B-724F-98A1-0AEC5D7FC3A2}">
      <dgm:prSet/>
      <dgm:spPr/>
      <dgm:t>
        <a:bodyPr/>
        <a:lstStyle/>
        <a:p>
          <a:endParaRPr lang="en-US"/>
        </a:p>
      </dgm:t>
    </dgm:pt>
    <dgm:pt modelId="{E8376F97-8FAC-AA43-868D-BB3E335B92F2}" type="sibTrans" cxnId="{54AEA8B7-F89B-724F-98A1-0AEC5D7FC3A2}">
      <dgm:prSet/>
      <dgm:spPr/>
      <dgm:t>
        <a:bodyPr/>
        <a:lstStyle/>
        <a:p>
          <a:endParaRPr lang="en-US"/>
        </a:p>
      </dgm:t>
    </dgm:pt>
    <dgm:pt modelId="{D57A6E2B-1DF9-5046-BC1D-709A01F64D7F}">
      <dgm:prSet phldrT="[Text]"/>
      <dgm:spPr/>
      <dgm:t>
        <a:bodyPr/>
        <a:lstStyle/>
        <a:p>
          <a:r>
            <a:rPr lang="en-US"/>
            <a:t>Patient stability</a:t>
          </a:r>
          <a:endParaRPr lang="en-US" dirty="0"/>
        </a:p>
      </dgm:t>
    </dgm:pt>
    <dgm:pt modelId="{C76AEE8B-D94A-7D44-B03A-3FE0785274DD}" type="parTrans" cxnId="{B2C59790-5949-8740-B37D-5567793C306C}">
      <dgm:prSet/>
      <dgm:spPr/>
      <dgm:t>
        <a:bodyPr/>
        <a:lstStyle/>
        <a:p>
          <a:endParaRPr lang="en-US"/>
        </a:p>
      </dgm:t>
    </dgm:pt>
    <dgm:pt modelId="{55132C62-F393-2540-A3F5-1E79E69F36CF}" type="sibTrans" cxnId="{B2C59790-5949-8740-B37D-5567793C306C}">
      <dgm:prSet/>
      <dgm:spPr/>
      <dgm:t>
        <a:bodyPr/>
        <a:lstStyle/>
        <a:p>
          <a:endParaRPr lang="en-US"/>
        </a:p>
      </dgm:t>
    </dgm:pt>
    <dgm:pt modelId="{D03F059F-5021-1F40-A19F-9647158C52AD}">
      <dgm:prSet phldrT="[Text]"/>
      <dgm:spPr/>
      <dgm:t>
        <a:bodyPr/>
        <a:lstStyle/>
        <a:p>
          <a:r>
            <a:rPr lang="en-US" dirty="0"/>
            <a:t>2</a:t>
          </a:r>
        </a:p>
      </dgm:t>
    </dgm:pt>
    <dgm:pt modelId="{CF000D09-B476-0444-AE02-AACE5A32ABB9}" type="parTrans" cxnId="{65CEA44F-9E16-EA4E-A309-EC3B3016297A}">
      <dgm:prSet/>
      <dgm:spPr/>
      <dgm:t>
        <a:bodyPr/>
        <a:lstStyle/>
        <a:p>
          <a:endParaRPr lang="en-US"/>
        </a:p>
      </dgm:t>
    </dgm:pt>
    <dgm:pt modelId="{294C2440-29C3-A948-ADDD-2D4D34880BDD}" type="sibTrans" cxnId="{65CEA44F-9E16-EA4E-A309-EC3B3016297A}">
      <dgm:prSet/>
      <dgm:spPr/>
      <dgm:t>
        <a:bodyPr/>
        <a:lstStyle/>
        <a:p>
          <a:endParaRPr lang="en-US"/>
        </a:p>
      </dgm:t>
    </dgm:pt>
    <dgm:pt modelId="{8E966A69-49F1-5E4B-B606-FCAEDAA984ED}">
      <dgm:prSet phldrT="[Text]"/>
      <dgm:spPr/>
      <dgm:t>
        <a:bodyPr/>
        <a:lstStyle/>
        <a:p>
          <a:r>
            <a:rPr lang="en-US" dirty="0"/>
            <a:t>Emotional check</a:t>
          </a:r>
        </a:p>
      </dgm:t>
    </dgm:pt>
    <dgm:pt modelId="{DBAD8E5C-BD8A-8D4C-B4F0-8493200D7696}" type="parTrans" cxnId="{FBB45EE4-904A-AF48-A0C9-CB655E66EF52}">
      <dgm:prSet/>
      <dgm:spPr/>
      <dgm:t>
        <a:bodyPr/>
        <a:lstStyle/>
        <a:p>
          <a:endParaRPr lang="en-US"/>
        </a:p>
      </dgm:t>
    </dgm:pt>
    <dgm:pt modelId="{6E022D76-54D3-5040-BFB1-6E3CF648085C}" type="sibTrans" cxnId="{FBB45EE4-904A-AF48-A0C9-CB655E66EF52}">
      <dgm:prSet/>
      <dgm:spPr/>
      <dgm:t>
        <a:bodyPr/>
        <a:lstStyle/>
        <a:p>
          <a:endParaRPr lang="en-US"/>
        </a:p>
      </dgm:t>
    </dgm:pt>
    <dgm:pt modelId="{73A345CE-36FD-894D-BBC6-F1148569A643}">
      <dgm:prSet phldrT="[Text]"/>
      <dgm:spPr/>
      <dgm:t>
        <a:bodyPr/>
        <a:lstStyle/>
        <a:p>
          <a:r>
            <a:rPr lang="en-US" dirty="0"/>
            <a:t>3</a:t>
          </a:r>
        </a:p>
      </dgm:t>
    </dgm:pt>
    <dgm:pt modelId="{E3B27BD6-FBE2-5640-8D4A-26A5222CC3EA}" type="parTrans" cxnId="{408ED183-BF58-1C4B-97FD-732582625FEF}">
      <dgm:prSet/>
      <dgm:spPr/>
      <dgm:t>
        <a:bodyPr/>
        <a:lstStyle/>
        <a:p>
          <a:endParaRPr lang="en-US"/>
        </a:p>
      </dgm:t>
    </dgm:pt>
    <dgm:pt modelId="{7A99C83F-BC00-3743-81E8-552BD253CEC3}" type="sibTrans" cxnId="{408ED183-BF58-1C4B-97FD-732582625FEF}">
      <dgm:prSet/>
      <dgm:spPr/>
      <dgm:t>
        <a:bodyPr/>
        <a:lstStyle/>
        <a:p>
          <a:endParaRPr lang="en-US"/>
        </a:p>
      </dgm:t>
    </dgm:pt>
    <dgm:pt modelId="{E900B89A-C42B-5249-B68C-A3D7ECDC2722}">
      <dgm:prSet phldrT="[Text]"/>
      <dgm:spPr/>
      <dgm:t>
        <a:bodyPr/>
        <a:lstStyle/>
        <a:p>
          <a:r>
            <a:rPr lang="en-US" dirty="0"/>
            <a:t>Address bias</a:t>
          </a:r>
        </a:p>
      </dgm:t>
    </dgm:pt>
    <dgm:pt modelId="{8E839505-C7B5-E846-B572-409C6E14F87D}" type="parTrans" cxnId="{8EA459AB-225B-8C4D-9825-5D1C6BF10277}">
      <dgm:prSet/>
      <dgm:spPr/>
      <dgm:t>
        <a:bodyPr/>
        <a:lstStyle/>
        <a:p>
          <a:endParaRPr lang="en-US"/>
        </a:p>
      </dgm:t>
    </dgm:pt>
    <dgm:pt modelId="{1CCB8A03-5593-CE44-86BA-AACEAE0CCB98}" type="sibTrans" cxnId="{8EA459AB-225B-8C4D-9825-5D1C6BF10277}">
      <dgm:prSet/>
      <dgm:spPr/>
      <dgm:t>
        <a:bodyPr/>
        <a:lstStyle/>
        <a:p>
          <a:endParaRPr lang="en-US"/>
        </a:p>
      </dgm:t>
    </dgm:pt>
    <dgm:pt modelId="{418E94F4-4F87-154C-8C2C-4FA1854F2962}">
      <dgm:prSet/>
      <dgm:spPr/>
      <dgm:t>
        <a:bodyPr/>
        <a:lstStyle/>
        <a:p>
          <a:r>
            <a:rPr lang="en-US" dirty="0"/>
            <a:t>4</a:t>
          </a:r>
        </a:p>
      </dgm:t>
    </dgm:pt>
    <dgm:pt modelId="{67B29BF1-08A2-E04F-9D69-0598739CF13B}" type="parTrans" cxnId="{2BBF3C50-1ED6-9847-B76B-936F9EDE5606}">
      <dgm:prSet/>
      <dgm:spPr/>
      <dgm:t>
        <a:bodyPr/>
        <a:lstStyle/>
        <a:p>
          <a:endParaRPr lang="en-US"/>
        </a:p>
      </dgm:t>
    </dgm:pt>
    <dgm:pt modelId="{A5C1BCA8-59E6-2D47-BF9C-24A0A56844F7}" type="sibTrans" cxnId="{2BBF3C50-1ED6-9847-B76B-936F9EDE5606}">
      <dgm:prSet/>
      <dgm:spPr/>
      <dgm:t>
        <a:bodyPr/>
        <a:lstStyle/>
        <a:p>
          <a:endParaRPr lang="en-US"/>
        </a:p>
      </dgm:t>
    </dgm:pt>
    <dgm:pt modelId="{827957E1-E296-1C4F-A5F6-1C5FE324A00C}">
      <dgm:prSet/>
      <dgm:spPr/>
      <dgm:t>
        <a:bodyPr/>
        <a:lstStyle/>
        <a:p>
          <a:r>
            <a:rPr lang="en-US" dirty="0"/>
            <a:t>5</a:t>
          </a:r>
        </a:p>
      </dgm:t>
    </dgm:pt>
    <dgm:pt modelId="{AC89EDA2-97A0-704F-A224-66777968DC79}" type="parTrans" cxnId="{C5A31E1B-1939-A943-9EA9-0D1F931C9095}">
      <dgm:prSet/>
      <dgm:spPr/>
      <dgm:t>
        <a:bodyPr/>
        <a:lstStyle/>
        <a:p>
          <a:endParaRPr lang="en-US"/>
        </a:p>
      </dgm:t>
    </dgm:pt>
    <dgm:pt modelId="{9F52F0F0-B16C-AB44-86AF-35AA79D5B0BB}" type="sibTrans" cxnId="{C5A31E1B-1939-A943-9EA9-0D1F931C9095}">
      <dgm:prSet/>
      <dgm:spPr/>
      <dgm:t>
        <a:bodyPr/>
        <a:lstStyle/>
        <a:p>
          <a:endParaRPr lang="en-US"/>
        </a:p>
      </dgm:t>
    </dgm:pt>
    <dgm:pt modelId="{9F6E5C8F-12F1-3545-94A6-291C5042E69E}">
      <dgm:prSet/>
      <dgm:spPr/>
      <dgm:t>
        <a:bodyPr/>
        <a:lstStyle/>
        <a:p>
          <a:r>
            <a:rPr lang="en-US" dirty="0"/>
            <a:t>6</a:t>
          </a:r>
        </a:p>
      </dgm:t>
    </dgm:pt>
    <dgm:pt modelId="{F878F1E0-BA83-0B4F-8407-D69A3E0606E8}" type="parTrans" cxnId="{545F95DE-9A10-3948-9807-36C195D34A35}">
      <dgm:prSet/>
      <dgm:spPr/>
      <dgm:t>
        <a:bodyPr/>
        <a:lstStyle/>
        <a:p>
          <a:endParaRPr lang="en-US"/>
        </a:p>
      </dgm:t>
    </dgm:pt>
    <dgm:pt modelId="{F501E3C1-886B-5244-A7B1-7A80D72A4D8C}" type="sibTrans" cxnId="{545F95DE-9A10-3948-9807-36C195D34A35}">
      <dgm:prSet/>
      <dgm:spPr/>
      <dgm:t>
        <a:bodyPr/>
        <a:lstStyle/>
        <a:p>
          <a:endParaRPr lang="en-US"/>
        </a:p>
      </dgm:t>
    </dgm:pt>
    <dgm:pt modelId="{02BDF100-8338-E043-96F5-EE898B9D5AB2}">
      <dgm:prSet/>
      <dgm:spPr/>
      <dgm:t>
        <a:bodyPr/>
        <a:lstStyle/>
        <a:p>
          <a:r>
            <a:rPr lang="en-US" dirty="0"/>
            <a:t>7</a:t>
          </a:r>
        </a:p>
      </dgm:t>
    </dgm:pt>
    <dgm:pt modelId="{1B53CCA0-CFF2-384B-856E-1EBDFA4D02AD}" type="parTrans" cxnId="{F6183E77-6BBF-FA47-854D-F0D53AE21A8A}">
      <dgm:prSet/>
      <dgm:spPr/>
      <dgm:t>
        <a:bodyPr/>
        <a:lstStyle/>
        <a:p>
          <a:endParaRPr lang="en-US"/>
        </a:p>
      </dgm:t>
    </dgm:pt>
    <dgm:pt modelId="{BCE247F3-63ED-824C-BC43-9D645F88694B}" type="sibTrans" cxnId="{F6183E77-6BBF-FA47-854D-F0D53AE21A8A}">
      <dgm:prSet/>
      <dgm:spPr/>
      <dgm:t>
        <a:bodyPr/>
        <a:lstStyle/>
        <a:p>
          <a:endParaRPr lang="en-US"/>
        </a:p>
      </dgm:t>
    </dgm:pt>
    <dgm:pt modelId="{7CF6944D-D814-F446-BDE2-B55C1C344687}">
      <dgm:prSet/>
      <dgm:spPr/>
      <dgm:t>
        <a:bodyPr/>
        <a:lstStyle/>
        <a:p>
          <a:r>
            <a:rPr lang="en-US" dirty="0"/>
            <a:t>8</a:t>
          </a:r>
        </a:p>
      </dgm:t>
    </dgm:pt>
    <dgm:pt modelId="{18766106-4E88-954F-80B4-8435CD7E3607}" type="parTrans" cxnId="{B4BAA057-82A7-8F4F-B3AE-D2474B9F0D61}">
      <dgm:prSet/>
      <dgm:spPr/>
      <dgm:t>
        <a:bodyPr/>
        <a:lstStyle/>
        <a:p>
          <a:endParaRPr lang="en-US"/>
        </a:p>
      </dgm:t>
    </dgm:pt>
    <dgm:pt modelId="{41CA9CD1-BD05-D240-8585-F6D044F469D5}" type="sibTrans" cxnId="{B4BAA057-82A7-8F4F-B3AE-D2474B9F0D61}">
      <dgm:prSet/>
      <dgm:spPr/>
      <dgm:t>
        <a:bodyPr/>
        <a:lstStyle/>
        <a:p>
          <a:endParaRPr lang="en-US"/>
        </a:p>
      </dgm:t>
    </dgm:pt>
    <dgm:pt modelId="{77E26394-E137-5E44-9434-AC75CD3E8E1C}">
      <dgm:prSet/>
      <dgm:spPr/>
      <dgm:t>
        <a:bodyPr/>
        <a:lstStyle/>
        <a:p>
          <a:r>
            <a:rPr lang="en-US" dirty="0"/>
            <a:t>Align with team</a:t>
          </a:r>
        </a:p>
      </dgm:t>
    </dgm:pt>
    <dgm:pt modelId="{0106416C-C608-3E4B-95A9-3A27F212EF0D}" type="parTrans" cxnId="{3055A850-65BD-2C48-A538-0AAEB9138E85}">
      <dgm:prSet/>
      <dgm:spPr/>
      <dgm:t>
        <a:bodyPr/>
        <a:lstStyle/>
        <a:p>
          <a:endParaRPr lang="en-US"/>
        </a:p>
      </dgm:t>
    </dgm:pt>
    <dgm:pt modelId="{4162CFAB-B676-8E4E-8FEB-32BD16B62DEC}" type="sibTrans" cxnId="{3055A850-65BD-2C48-A538-0AAEB9138E85}">
      <dgm:prSet/>
      <dgm:spPr/>
      <dgm:t>
        <a:bodyPr/>
        <a:lstStyle/>
        <a:p>
          <a:endParaRPr lang="en-US"/>
        </a:p>
      </dgm:t>
    </dgm:pt>
    <dgm:pt modelId="{D6BB4A41-00B2-5448-BB3F-80605AC75A4E}">
      <dgm:prSet/>
      <dgm:spPr/>
      <dgm:t>
        <a:bodyPr/>
        <a:lstStyle/>
        <a:p>
          <a:r>
            <a:rPr lang="en-US" dirty="0"/>
            <a:t>Recenter on care</a:t>
          </a:r>
        </a:p>
      </dgm:t>
    </dgm:pt>
    <dgm:pt modelId="{4E04882C-8060-1D42-8502-5D210AA0DCD3}" type="parTrans" cxnId="{DF1A41C0-D8B8-6D4F-A8A5-91EC68AFBCAD}">
      <dgm:prSet/>
      <dgm:spPr/>
      <dgm:t>
        <a:bodyPr/>
        <a:lstStyle/>
        <a:p>
          <a:endParaRPr lang="en-US"/>
        </a:p>
      </dgm:t>
    </dgm:pt>
    <dgm:pt modelId="{A3F6C628-648D-0249-B65F-551AF9ECEEA6}" type="sibTrans" cxnId="{DF1A41C0-D8B8-6D4F-A8A5-91EC68AFBCAD}">
      <dgm:prSet/>
      <dgm:spPr/>
      <dgm:t>
        <a:bodyPr/>
        <a:lstStyle/>
        <a:p>
          <a:endParaRPr lang="en-US"/>
        </a:p>
      </dgm:t>
    </dgm:pt>
    <dgm:pt modelId="{0545D5E0-C6B3-A447-B001-E955BFE39730}">
      <dgm:prSet/>
      <dgm:spPr/>
      <dgm:t>
        <a:bodyPr/>
        <a:lstStyle/>
        <a:p>
          <a:r>
            <a:rPr lang="en-US" dirty="0"/>
            <a:t>Give space</a:t>
          </a:r>
        </a:p>
      </dgm:t>
    </dgm:pt>
    <dgm:pt modelId="{74548467-254B-2943-9A99-08C07F3E448D}" type="parTrans" cxnId="{E2BB9BC9-6DB1-9443-8E35-6250A99E4AD7}">
      <dgm:prSet/>
      <dgm:spPr/>
      <dgm:t>
        <a:bodyPr/>
        <a:lstStyle/>
        <a:p>
          <a:endParaRPr lang="en-US"/>
        </a:p>
      </dgm:t>
    </dgm:pt>
    <dgm:pt modelId="{43A03E68-4CAE-A344-B58C-38B13B6EE776}" type="sibTrans" cxnId="{E2BB9BC9-6DB1-9443-8E35-6250A99E4AD7}">
      <dgm:prSet/>
      <dgm:spPr/>
      <dgm:t>
        <a:bodyPr/>
        <a:lstStyle/>
        <a:p>
          <a:endParaRPr lang="en-US"/>
        </a:p>
      </dgm:t>
    </dgm:pt>
    <dgm:pt modelId="{4042EA18-93B7-8447-AC0A-58BAED6135AA}">
      <dgm:prSet/>
      <dgm:spPr/>
      <dgm:t>
        <a:bodyPr/>
        <a:lstStyle/>
        <a:p>
          <a:r>
            <a:rPr lang="en-US" dirty="0"/>
            <a:t>Seek support</a:t>
          </a:r>
        </a:p>
      </dgm:t>
    </dgm:pt>
    <dgm:pt modelId="{2F5CB061-56DE-EB4D-BFD4-36B00E6055CB}" type="parTrans" cxnId="{BBBA16DC-BC73-8048-A725-FE1EF1BF6593}">
      <dgm:prSet/>
      <dgm:spPr/>
      <dgm:t>
        <a:bodyPr/>
        <a:lstStyle/>
        <a:p>
          <a:endParaRPr lang="en-US"/>
        </a:p>
      </dgm:t>
    </dgm:pt>
    <dgm:pt modelId="{A608511D-1BB9-EB4E-9E74-CCD7B0DB861D}" type="sibTrans" cxnId="{BBBA16DC-BC73-8048-A725-FE1EF1BF6593}">
      <dgm:prSet/>
      <dgm:spPr/>
      <dgm:t>
        <a:bodyPr/>
        <a:lstStyle/>
        <a:p>
          <a:endParaRPr lang="en-US"/>
        </a:p>
      </dgm:t>
    </dgm:pt>
    <dgm:pt modelId="{B3ABDBBC-28C2-CC44-9EA0-940A074F9BF0}">
      <dgm:prSet/>
      <dgm:spPr/>
      <dgm:t>
        <a:bodyPr/>
        <a:lstStyle/>
        <a:p>
          <a:r>
            <a:rPr lang="en-US" dirty="0"/>
            <a:t>Set boundaries</a:t>
          </a:r>
        </a:p>
      </dgm:t>
    </dgm:pt>
    <dgm:pt modelId="{B1A1C092-087B-F241-9B26-AD1D13C72D4D}" type="sibTrans" cxnId="{D85391B8-F585-FD43-82E0-8ACB9B810BF4}">
      <dgm:prSet/>
      <dgm:spPr/>
      <dgm:t>
        <a:bodyPr/>
        <a:lstStyle/>
        <a:p>
          <a:endParaRPr lang="en-US"/>
        </a:p>
      </dgm:t>
    </dgm:pt>
    <dgm:pt modelId="{D1297B60-D255-DA44-8D75-399213932CFB}" type="parTrans" cxnId="{D85391B8-F585-FD43-82E0-8ACB9B810BF4}">
      <dgm:prSet/>
      <dgm:spPr/>
      <dgm:t>
        <a:bodyPr/>
        <a:lstStyle/>
        <a:p>
          <a:endParaRPr lang="en-US"/>
        </a:p>
      </dgm:t>
    </dgm:pt>
    <dgm:pt modelId="{C651D352-06FA-1B42-81FF-A95099FE5645}" type="pres">
      <dgm:prSet presAssocID="{CE7EC2B3-709C-7049-AC98-40D647A08CD5}" presName="Name0" presStyleCnt="0">
        <dgm:presLayoutVars>
          <dgm:dir/>
          <dgm:animLvl val="lvl"/>
          <dgm:resizeHandles val="exact"/>
        </dgm:presLayoutVars>
      </dgm:prSet>
      <dgm:spPr/>
    </dgm:pt>
    <dgm:pt modelId="{2E2FEDEA-0CB5-FD4B-8718-95B9D6A14304}" type="pres">
      <dgm:prSet presAssocID="{54EB0C78-47D0-4144-BBA1-ED83F2276A80}" presName="linNode" presStyleCnt="0"/>
      <dgm:spPr/>
    </dgm:pt>
    <dgm:pt modelId="{2F0271A3-745A-A943-B67B-E4069A93AE61}" type="pres">
      <dgm:prSet presAssocID="{54EB0C78-47D0-4144-BBA1-ED83F2276A80}" presName="parentText" presStyleLbl="node1" presStyleIdx="0" presStyleCnt="8" custScaleX="67001">
        <dgm:presLayoutVars>
          <dgm:chMax val="1"/>
          <dgm:bulletEnabled val="1"/>
        </dgm:presLayoutVars>
      </dgm:prSet>
      <dgm:spPr/>
    </dgm:pt>
    <dgm:pt modelId="{21D64796-42C1-6A47-B16B-F23C35A117FF}" type="pres">
      <dgm:prSet presAssocID="{54EB0C78-47D0-4144-BBA1-ED83F2276A80}" presName="descendantText" presStyleLbl="alignAccFollowNode1" presStyleIdx="0" presStyleCnt="8">
        <dgm:presLayoutVars>
          <dgm:bulletEnabled val="1"/>
        </dgm:presLayoutVars>
      </dgm:prSet>
      <dgm:spPr/>
    </dgm:pt>
    <dgm:pt modelId="{B2C4C361-6A0B-BC45-90FD-318B0EB08F6D}" type="pres">
      <dgm:prSet presAssocID="{E8376F97-8FAC-AA43-868D-BB3E335B92F2}" presName="sp" presStyleCnt="0"/>
      <dgm:spPr/>
    </dgm:pt>
    <dgm:pt modelId="{277D1FDC-6CD3-BB41-8E20-960C658417CF}" type="pres">
      <dgm:prSet presAssocID="{D03F059F-5021-1F40-A19F-9647158C52AD}" presName="linNode" presStyleCnt="0"/>
      <dgm:spPr/>
    </dgm:pt>
    <dgm:pt modelId="{6CEBA26E-9501-3E41-ACBB-39C96B19A924}" type="pres">
      <dgm:prSet presAssocID="{D03F059F-5021-1F40-A19F-9647158C52AD}" presName="parentText" presStyleLbl="node1" presStyleIdx="1" presStyleCnt="8" custScaleX="67001">
        <dgm:presLayoutVars>
          <dgm:chMax val="1"/>
          <dgm:bulletEnabled val="1"/>
        </dgm:presLayoutVars>
      </dgm:prSet>
      <dgm:spPr/>
    </dgm:pt>
    <dgm:pt modelId="{2EB4DD27-0645-2048-89E9-55CE50FE52DA}" type="pres">
      <dgm:prSet presAssocID="{D03F059F-5021-1F40-A19F-9647158C52AD}" presName="descendantText" presStyleLbl="alignAccFollowNode1" presStyleIdx="1" presStyleCnt="8">
        <dgm:presLayoutVars>
          <dgm:bulletEnabled val="1"/>
        </dgm:presLayoutVars>
      </dgm:prSet>
      <dgm:spPr/>
    </dgm:pt>
    <dgm:pt modelId="{33CCAA17-6648-4F4C-9AC2-5ECE7EDB6E70}" type="pres">
      <dgm:prSet presAssocID="{294C2440-29C3-A948-ADDD-2D4D34880BDD}" presName="sp" presStyleCnt="0"/>
      <dgm:spPr/>
    </dgm:pt>
    <dgm:pt modelId="{B97FC210-8EA1-614A-91AB-916C1AEFBDEE}" type="pres">
      <dgm:prSet presAssocID="{73A345CE-36FD-894D-BBC6-F1148569A643}" presName="linNode" presStyleCnt="0"/>
      <dgm:spPr/>
    </dgm:pt>
    <dgm:pt modelId="{A3A63788-1227-B240-AFF4-87DA3887717D}" type="pres">
      <dgm:prSet presAssocID="{73A345CE-36FD-894D-BBC6-F1148569A643}" presName="parentText" presStyleLbl="node1" presStyleIdx="2" presStyleCnt="8" custScaleX="67001">
        <dgm:presLayoutVars>
          <dgm:chMax val="1"/>
          <dgm:bulletEnabled val="1"/>
        </dgm:presLayoutVars>
      </dgm:prSet>
      <dgm:spPr/>
    </dgm:pt>
    <dgm:pt modelId="{5432570E-A980-7C49-B78B-FBD7E95247D6}" type="pres">
      <dgm:prSet presAssocID="{73A345CE-36FD-894D-BBC6-F1148569A643}" presName="descendantText" presStyleLbl="alignAccFollowNode1" presStyleIdx="2" presStyleCnt="8">
        <dgm:presLayoutVars>
          <dgm:bulletEnabled val="1"/>
        </dgm:presLayoutVars>
      </dgm:prSet>
      <dgm:spPr/>
    </dgm:pt>
    <dgm:pt modelId="{3E055F9F-21A2-424C-8A4E-65EE89C8A916}" type="pres">
      <dgm:prSet presAssocID="{7A99C83F-BC00-3743-81E8-552BD253CEC3}" presName="sp" presStyleCnt="0"/>
      <dgm:spPr/>
    </dgm:pt>
    <dgm:pt modelId="{3D7F3715-4665-FB42-B9D8-1FF06FE7ED04}" type="pres">
      <dgm:prSet presAssocID="{418E94F4-4F87-154C-8C2C-4FA1854F2962}" presName="linNode" presStyleCnt="0"/>
      <dgm:spPr/>
    </dgm:pt>
    <dgm:pt modelId="{F459C834-8503-9C47-9E88-19B5B264D39A}" type="pres">
      <dgm:prSet presAssocID="{418E94F4-4F87-154C-8C2C-4FA1854F2962}" presName="parentText" presStyleLbl="node1" presStyleIdx="3" presStyleCnt="8" custScaleX="67001">
        <dgm:presLayoutVars>
          <dgm:chMax val="1"/>
          <dgm:bulletEnabled val="1"/>
        </dgm:presLayoutVars>
      </dgm:prSet>
      <dgm:spPr/>
    </dgm:pt>
    <dgm:pt modelId="{B11406A9-5BCB-7247-9C38-2B1D2505F2B8}" type="pres">
      <dgm:prSet presAssocID="{418E94F4-4F87-154C-8C2C-4FA1854F2962}" presName="descendantText" presStyleLbl="alignAccFollowNode1" presStyleIdx="3" presStyleCnt="8">
        <dgm:presLayoutVars>
          <dgm:bulletEnabled val="1"/>
        </dgm:presLayoutVars>
      </dgm:prSet>
      <dgm:spPr/>
    </dgm:pt>
    <dgm:pt modelId="{E355AC6F-4099-CB47-B889-4B740E437363}" type="pres">
      <dgm:prSet presAssocID="{A5C1BCA8-59E6-2D47-BF9C-24A0A56844F7}" presName="sp" presStyleCnt="0"/>
      <dgm:spPr/>
    </dgm:pt>
    <dgm:pt modelId="{A60CA7D8-39CB-954A-95BD-9B247DA4C063}" type="pres">
      <dgm:prSet presAssocID="{827957E1-E296-1C4F-A5F6-1C5FE324A00C}" presName="linNode" presStyleCnt="0"/>
      <dgm:spPr/>
    </dgm:pt>
    <dgm:pt modelId="{4D3677DD-203E-6A46-986E-4A5C658C9303}" type="pres">
      <dgm:prSet presAssocID="{827957E1-E296-1C4F-A5F6-1C5FE324A00C}" presName="parentText" presStyleLbl="node1" presStyleIdx="4" presStyleCnt="8" custScaleX="67001">
        <dgm:presLayoutVars>
          <dgm:chMax val="1"/>
          <dgm:bulletEnabled val="1"/>
        </dgm:presLayoutVars>
      </dgm:prSet>
      <dgm:spPr/>
    </dgm:pt>
    <dgm:pt modelId="{DF481026-182D-AB4B-A938-B9E12915351D}" type="pres">
      <dgm:prSet presAssocID="{827957E1-E296-1C4F-A5F6-1C5FE324A00C}" presName="descendantText" presStyleLbl="alignAccFollowNode1" presStyleIdx="4" presStyleCnt="8">
        <dgm:presLayoutVars>
          <dgm:bulletEnabled val="1"/>
        </dgm:presLayoutVars>
      </dgm:prSet>
      <dgm:spPr/>
    </dgm:pt>
    <dgm:pt modelId="{0E9316E9-2C30-AB47-AE90-7E8E046E1AFD}" type="pres">
      <dgm:prSet presAssocID="{9F52F0F0-B16C-AB44-86AF-35AA79D5B0BB}" presName="sp" presStyleCnt="0"/>
      <dgm:spPr/>
    </dgm:pt>
    <dgm:pt modelId="{037794A2-D322-8E40-B011-CE07ECE52AD6}" type="pres">
      <dgm:prSet presAssocID="{9F6E5C8F-12F1-3545-94A6-291C5042E69E}" presName="linNode" presStyleCnt="0"/>
      <dgm:spPr/>
    </dgm:pt>
    <dgm:pt modelId="{B6C279C8-1B63-3845-ADAB-B82AEFA3D8E4}" type="pres">
      <dgm:prSet presAssocID="{9F6E5C8F-12F1-3545-94A6-291C5042E69E}" presName="parentText" presStyleLbl="node1" presStyleIdx="5" presStyleCnt="8" custScaleX="67001">
        <dgm:presLayoutVars>
          <dgm:chMax val="1"/>
          <dgm:bulletEnabled val="1"/>
        </dgm:presLayoutVars>
      </dgm:prSet>
      <dgm:spPr/>
    </dgm:pt>
    <dgm:pt modelId="{95DA0D8B-BC89-0948-909A-C298332DBD75}" type="pres">
      <dgm:prSet presAssocID="{9F6E5C8F-12F1-3545-94A6-291C5042E69E}" presName="descendantText" presStyleLbl="alignAccFollowNode1" presStyleIdx="5" presStyleCnt="8">
        <dgm:presLayoutVars>
          <dgm:bulletEnabled val="1"/>
        </dgm:presLayoutVars>
      </dgm:prSet>
      <dgm:spPr/>
    </dgm:pt>
    <dgm:pt modelId="{05C8E7F6-EE84-404A-A830-A5238A04D5A3}" type="pres">
      <dgm:prSet presAssocID="{F501E3C1-886B-5244-A7B1-7A80D72A4D8C}" presName="sp" presStyleCnt="0"/>
      <dgm:spPr/>
    </dgm:pt>
    <dgm:pt modelId="{450D1F74-F684-8F4C-A8B3-6F8B553AB682}" type="pres">
      <dgm:prSet presAssocID="{02BDF100-8338-E043-96F5-EE898B9D5AB2}" presName="linNode" presStyleCnt="0"/>
      <dgm:spPr/>
    </dgm:pt>
    <dgm:pt modelId="{B67BA8B7-08DC-C244-8300-FCD547033DBD}" type="pres">
      <dgm:prSet presAssocID="{02BDF100-8338-E043-96F5-EE898B9D5AB2}" presName="parentText" presStyleLbl="node1" presStyleIdx="6" presStyleCnt="8" custScaleX="67001">
        <dgm:presLayoutVars>
          <dgm:chMax val="1"/>
          <dgm:bulletEnabled val="1"/>
        </dgm:presLayoutVars>
      </dgm:prSet>
      <dgm:spPr/>
    </dgm:pt>
    <dgm:pt modelId="{9D2B4FF6-13FB-EF49-977A-31DF5EE58099}" type="pres">
      <dgm:prSet presAssocID="{02BDF100-8338-E043-96F5-EE898B9D5AB2}" presName="descendantText" presStyleLbl="alignAccFollowNode1" presStyleIdx="6" presStyleCnt="8">
        <dgm:presLayoutVars>
          <dgm:bulletEnabled val="1"/>
        </dgm:presLayoutVars>
      </dgm:prSet>
      <dgm:spPr/>
    </dgm:pt>
    <dgm:pt modelId="{580F7313-AC0F-FA49-A45E-0C9486F52D6E}" type="pres">
      <dgm:prSet presAssocID="{BCE247F3-63ED-824C-BC43-9D645F88694B}" presName="sp" presStyleCnt="0"/>
      <dgm:spPr/>
    </dgm:pt>
    <dgm:pt modelId="{E737A561-EB87-EC46-B404-0D8CDB0DE287}" type="pres">
      <dgm:prSet presAssocID="{7CF6944D-D814-F446-BDE2-B55C1C344687}" presName="linNode" presStyleCnt="0"/>
      <dgm:spPr/>
    </dgm:pt>
    <dgm:pt modelId="{D5D04DA4-D0C2-DE47-8C8C-0B8EFFA304FE}" type="pres">
      <dgm:prSet presAssocID="{7CF6944D-D814-F446-BDE2-B55C1C344687}" presName="parentText" presStyleLbl="node1" presStyleIdx="7" presStyleCnt="8" custScaleX="67001">
        <dgm:presLayoutVars>
          <dgm:chMax val="1"/>
          <dgm:bulletEnabled val="1"/>
        </dgm:presLayoutVars>
      </dgm:prSet>
      <dgm:spPr/>
    </dgm:pt>
    <dgm:pt modelId="{8CF3EAF4-8574-9841-9B3E-4FBF8CB57172}" type="pres">
      <dgm:prSet presAssocID="{7CF6944D-D814-F446-BDE2-B55C1C344687}" presName="descendantText" presStyleLbl="alignAccFollowNode1" presStyleIdx="7" presStyleCnt="8">
        <dgm:presLayoutVars>
          <dgm:bulletEnabled val="1"/>
        </dgm:presLayoutVars>
      </dgm:prSet>
      <dgm:spPr/>
    </dgm:pt>
  </dgm:ptLst>
  <dgm:cxnLst>
    <dgm:cxn modelId="{E4273A05-E6BD-7B48-BAB7-FF2C885BDD30}" type="presOf" srcId="{02BDF100-8338-E043-96F5-EE898B9D5AB2}" destId="{B67BA8B7-08DC-C244-8300-FCD547033DBD}" srcOrd="0" destOrd="0" presId="urn:microsoft.com/office/officeart/2005/8/layout/vList5"/>
    <dgm:cxn modelId="{E9D1E10C-1628-524C-9321-D84C071FF74D}" type="presOf" srcId="{CE7EC2B3-709C-7049-AC98-40D647A08CD5}" destId="{C651D352-06FA-1B42-81FF-A95099FE5645}" srcOrd="0" destOrd="0" presId="urn:microsoft.com/office/officeart/2005/8/layout/vList5"/>
    <dgm:cxn modelId="{C4160712-DF53-0F4F-9BBA-78BD9BBF4B88}" type="presOf" srcId="{77E26394-E137-5E44-9434-AC75CD3E8E1C}" destId="{B11406A9-5BCB-7247-9C38-2B1D2505F2B8}" srcOrd="0" destOrd="0" presId="urn:microsoft.com/office/officeart/2005/8/layout/vList5"/>
    <dgm:cxn modelId="{C5A31E1B-1939-A943-9EA9-0D1F931C9095}" srcId="{CE7EC2B3-709C-7049-AC98-40D647A08CD5}" destId="{827957E1-E296-1C4F-A5F6-1C5FE324A00C}" srcOrd="4" destOrd="0" parTransId="{AC89EDA2-97A0-704F-A224-66777968DC79}" sibTransId="{9F52F0F0-B16C-AB44-86AF-35AA79D5B0BB}"/>
    <dgm:cxn modelId="{086EAA1D-3224-4E41-87B1-9FA27037DE47}" type="presOf" srcId="{9F6E5C8F-12F1-3545-94A6-291C5042E69E}" destId="{B6C279C8-1B63-3845-ADAB-B82AEFA3D8E4}" srcOrd="0" destOrd="0" presId="urn:microsoft.com/office/officeart/2005/8/layout/vList5"/>
    <dgm:cxn modelId="{71BBC71D-E55C-424F-B6C9-6E507D91D4E5}" type="presOf" srcId="{D6BB4A41-00B2-5448-BB3F-80605AC75A4E}" destId="{95DA0D8B-BC89-0948-909A-C298332DBD75}" srcOrd="0" destOrd="0" presId="urn:microsoft.com/office/officeart/2005/8/layout/vList5"/>
    <dgm:cxn modelId="{7A4CD21E-5C30-9844-B8CC-04D4CC71350C}" type="presOf" srcId="{4042EA18-93B7-8447-AC0A-58BAED6135AA}" destId="{8CF3EAF4-8574-9841-9B3E-4FBF8CB57172}" srcOrd="0" destOrd="0" presId="urn:microsoft.com/office/officeart/2005/8/layout/vList5"/>
    <dgm:cxn modelId="{EA0CCB2E-33A7-7842-AF42-FDB163C3A0DB}" type="presOf" srcId="{8E966A69-49F1-5E4B-B606-FCAEDAA984ED}" destId="{2EB4DD27-0645-2048-89E9-55CE50FE52DA}" srcOrd="0" destOrd="0" presId="urn:microsoft.com/office/officeart/2005/8/layout/vList5"/>
    <dgm:cxn modelId="{65CEA44F-9E16-EA4E-A309-EC3B3016297A}" srcId="{CE7EC2B3-709C-7049-AC98-40D647A08CD5}" destId="{D03F059F-5021-1F40-A19F-9647158C52AD}" srcOrd="1" destOrd="0" parTransId="{CF000D09-B476-0444-AE02-AACE5A32ABB9}" sibTransId="{294C2440-29C3-A948-ADDD-2D4D34880BDD}"/>
    <dgm:cxn modelId="{2BBF3C50-1ED6-9847-B76B-936F9EDE5606}" srcId="{CE7EC2B3-709C-7049-AC98-40D647A08CD5}" destId="{418E94F4-4F87-154C-8C2C-4FA1854F2962}" srcOrd="3" destOrd="0" parTransId="{67B29BF1-08A2-E04F-9D69-0598739CF13B}" sibTransId="{A5C1BCA8-59E6-2D47-BF9C-24A0A56844F7}"/>
    <dgm:cxn modelId="{3055A850-65BD-2C48-A538-0AAEB9138E85}" srcId="{418E94F4-4F87-154C-8C2C-4FA1854F2962}" destId="{77E26394-E137-5E44-9434-AC75CD3E8E1C}" srcOrd="0" destOrd="0" parTransId="{0106416C-C608-3E4B-95A9-3A27F212EF0D}" sibTransId="{4162CFAB-B676-8E4E-8FEB-32BD16B62DEC}"/>
    <dgm:cxn modelId="{B3273152-AF0F-EE4B-8C28-8B1E95E5CD89}" type="presOf" srcId="{E900B89A-C42B-5249-B68C-A3D7ECDC2722}" destId="{5432570E-A980-7C49-B78B-FBD7E95247D6}" srcOrd="0" destOrd="0" presId="urn:microsoft.com/office/officeart/2005/8/layout/vList5"/>
    <dgm:cxn modelId="{90712D57-061F-8444-BA8A-D8DA5E4630C5}" type="presOf" srcId="{73A345CE-36FD-894D-BBC6-F1148569A643}" destId="{A3A63788-1227-B240-AFF4-87DA3887717D}" srcOrd="0" destOrd="0" presId="urn:microsoft.com/office/officeart/2005/8/layout/vList5"/>
    <dgm:cxn modelId="{B4BAA057-82A7-8F4F-B3AE-D2474B9F0D61}" srcId="{CE7EC2B3-709C-7049-AC98-40D647A08CD5}" destId="{7CF6944D-D814-F446-BDE2-B55C1C344687}" srcOrd="7" destOrd="0" parTransId="{18766106-4E88-954F-80B4-8435CD7E3607}" sibTransId="{41CA9CD1-BD05-D240-8585-F6D044F469D5}"/>
    <dgm:cxn modelId="{BAD62360-A798-6A47-A994-B5126C6DDBBA}" type="presOf" srcId="{D57A6E2B-1DF9-5046-BC1D-709A01F64D7F}" destId="{21D64796-42C1-6A47-B16B-F23C35A117FF}" srcOrd="0" destOrd="0" presId="urn:microsoft.com/office/officeart/2005/8/layout/vList5"/>
    <dgm:cxn modelId="{F6183E77-6BBF-FA47-854D-F0D53AE21A8A}" srcId="{CE7EC2B3-709C-7049-AC98-40D647A08CD5}" destId="{02BDF100-8338-E043-96F5-EE898B9D5AB2}" srcOrd="6" destOrd="0" parTransId="{1B53CCA0-CFF2-384B-856E-1EBDFA4D02AD}" sibTransId="{BCE247F3-63ED-824C-BC43-9D645F88694B}"/>
    <dgm:cxn modelId="{89198578-5DCB-6140-878F-E9FD8D67271F}" type="presOf" srcId="{7CF6944D-D814-F446-BDE2-B55C1C344687}" destId="{D5D04DA4-D0C2-DE47-8C8C-0B8EFFA304FE}" srcOrd="0" destOrd="0" presId="urn:microsoft.com/office/officeart/2005/8/layout/vList5"/>
    <dgm:cxn modelId="{408ED183-BF58-1C4B-97FD-732582625FEF}" srcId="{CE7EC2B3-709C-7049-AC98-40D647A08CD5}" destId="{73A345CE-36FD-894D-BBC6-F1148569A643}" srcOrd="2" destOrd="0" parTransId="{E3B27BD6-FBE2-5640-8D4A-26A5222CC3EA}" sibTransId="{7A99C83F-BC00-3743-81E8-552BD253CEC3}"/>
    <dgm:cxn modelId="{B2C59790-5949-8740-B37D-5567793C306C}" srcId="{54EB0C78-47D0-4144-BBA1-ED83F2276A80}" destId="{D57A6E2B-1DF9-5046-BC1D-709A01F64D7F}" srcOrd="0" destOrd="0" parTransId="{C76AEE8B-D94A-7D44-B03A-3FE0785274DD}" sibTransId="{55132C62-F393-2540-A3F5-1E79E69F36CF}"/>
    <dgm:cxn modelId="{2D83CF9B-C8D2-5645-B148-7557D123AE42}" type="presOf" srcId="{827957E1-E296-1C4F-A5F6-1C5FE324A00C}" destId="{4D3677DD-203E-6A46-986E-4A5C658C9303}" srcOrd="0" destOrd="0" presId="urn:microsoft.com/office/officeart/2005/8/layout/vList5"/>
    <dgm:cxn modelId="{D734F3A8-F28E-EC4B-833E-A76A8DF839E2}" type="presOf" srcId="{D03F059F-5021-1F40-A19F-9647158C52AD}" destId="{6CEBA26E-9501-3E41-ACBB-39C96B19A924}" srcOrd="0" destOrd="0" presId="urn:microsoft.com/office/officeart/2005/8/layout/vList5"/>
    <dgm:cxn modelId="{8EA459AB-225B-8C4D-9825-5D1C6BF10277}" srcId="{73A345CE-36FD-894D-BBC6-F1148569A643}" destId="{E900B89A-C42B-5249-B68C-A3D7ECDC2722}" srcOrd="0" destOrd="0" parTransId="{8E839505-C7B5-E846-B572-409C6E14F87D}" sibTransId="{1CCB8A03-5593-CE44-86BA-AACEAE0CCB98}"/>
    <dgm:cxn modelId="{54AEA8B7-F89B-724F-98A1-0AEC5D7FC3A2}" srcId="{CE7EC2B3-709C-7049-AC98-40D647A08CD5}" destId="{54EB0C78-47D0-4144-BBA1-ED83F2276A80}" srcOrd="0" destOrd="0" parTransId="{46A28A5B-8A7C-BF49-A5DC-996D874F74B0}" sibTransId="{E8376F97-8FAC-AA43-868D-BB3E335B92F2}"/>
    <dgm:cxn modelId="{D85391B8-F585-FD43-82E0-8ACB9B810BF4}" srcId="{827957E1-E296-1C4F-A5F6-1C5FE324A00C}" destId="{B3ABDBBC-28C2-CC44-9EA0-940A074F9BF0}" srcOrd="0" destOrd="0" parTransId="{D1297B60-D255-DA44-8D75-399213932CFB}" sibTransId="{B1A1C092-087B-F241-9B26-AD1D13C72D4D}"/>
    <dgm:cxn modelId="{DF1A41C0-D8B8-6D4F-A8A5-91EC68AFBCAD}" srcId="{9F6E5C8F-12F1-3545-94A6-291C5042E69E}" destId="{D6BB4A41-00B2-5448-BB3F-80605AC75A4E}" srcOrd="0" destOrd="0" parTransId="{4E04882C-8060-1D42-8502-5D210AA0DCD3}" sibTransId="{A3F6C628-648D-0249-B65F-551AF9ECEEA6}"/>
    <dgm:cxn modelId="{F2E046C8-391B-6946-ACE6-697EC224AB98}" type="presOf" srcId="{B3ABDBBC-28C2-CC44-9EA0-940A074F9BF0}" destId="{DF481026-182D-AB4B-A938-B9E12915351D}" srcOrd="0" destOrd="0" presId="urn:microsoft.com/office/officeart/2005/8/layout/vList5"/>
    <dgm:cxn modelId="{E2BB9BC9-6DB1-9443-8E35-6250A99E4AD7}" srcId="{02BDF100-8338-E043-96F5-EE898B9D5AB2}" destId="{0545D5E0-C6B3-A447-B001-E955BFE39730}" srcOrd="0" destOrd="0" parTransId="{74548467-254B-2943-9A99-08C07F3E448D}" sibTransId="{43A03E68-4CAE-A344-B58C-38B13B6EE776}"/>
    <dgm:cxn modelId="{A16837DB-2A15-1C45-807B-67AB4EF8E75E}" type="presOf" srcId="{0545D5E0-C6B3-A447-B001-E955BFE39730}" destId="{9D2B4FF6-13FB-EF49-977A-31DF5EE58099}" srcOrd="0" destOrd="0" presId="urn:microsoft.com/office/officeart/2005/8/layout/vList5"/>
    <dgm:cxn modelId="{BBBA16DC-BC73-8048-A725-FE1EF1BF6593}" srcId="{7CF6944D-D814-F446-BDE2-B55C1C344687}" destId="{4042EA18-93B7-8447-AC0A-58BAED6135AA}" srcOrd="0" destOrd="0" parTransId="{2F5CB061-56DE-EB4D-BFD4-36B00E6055CB}" sibTransId="{A608511D-1BB9-EB4E-9E74-CCD7B0DB861D}"/>
    <dgm:cxn modelId="{545F95DE-9A10-3948-9807-36C195D34A35}" srcId="{CE7EC2B3-709C-7049-AC98-40D647A08CD5}" destId="{9F6E5C8F-12F1-3545-94A6-291C5042E69E}" srcOrd="5" destOrd="0" parTransId="{F878F1E0-BA83-0B4F-8407-D69A3E0606E8}" sibTransId="{F501E3C1-886B-5244-A7B1-7A80D72A4D8C}"/>
    <dgm:cxn modelId="{1AC639E1-2DD4-8C49-9596-C5731579DC3A}" type="presOf" srcId="{54EB0C78-47D0-4144-BBA1-ED83F2276A80}" destId="{2F0271A3-745A-A943-B67B-E4069A93AE61}" srcOrd="0" destOrd="0" presId="urn:microsoft.com/office/officeart/2005/8/layout/vList5"/>
    <dgm:cxn modelId="{FBB45EE4-904A-AF48-A0C9-CB655E66EF52}" srcId="{D03F059F-5021-1F40-A19F-9647158C52AD}" destId="{8E966A69-49F1-5E4B-B606-FCAEDAA984ED}" srcOrd="0" destOrd="0" parTransId="{DBAD8E5C-BD8A-8D4C-B4F0-8493200D7696}" sibTransId="{6E022D76-54D3-5040-BFB1-6E3CF648085C}"/>
    <dgm:cxn modelId="{CE4D51EC-1171-9740-9774-3550157EF9C1}" type="presOf" srcId="{418E94F4-4F87-154C-8C2C-4FA1854F2962}" destId="{F459C834-8503-9C47-9E88-19B5B264D39A}" srcOrd="0" destOrd="0" presId="urn:microsoft.com/office/officeart/2005/8/layout/vList5"/>
    <dgm:cxn modelId="{BF236B13-02D1-B64C-986F-0CAF7E0612E5}" type="presParOf" srcId="{C651D352-06FA-1B42-81FF-A95099FE5645}" destId="{2E2FEDEA-0CB5-FD4B-8718-95B9D6A14304}" srcOrd="0" destOrd="0" presId="urn:microsoft.com/office/officeart/2005/8/layout/vList5"/>
    <dgm:cxn modelId="{9578A504-AB23-5044-A923-D3DEFAE4D5E7}" type="presParOf" srcId="{2E2FEDEA-0CB5-FD4B-8718-95B9D6A14304}" destId="{2F0271A3-745A-A943-B67B-E4069A93AE61}" srcOrd="0" destOrd="0" presId="urn:microsoft.com/office/officeart/2005/8/layout/vList5"/>
    <dgm:cxn modelId="{253C94D8-1885-B543-AF3D-F6A1DD424873}" type="presParOf" srcId="{2E2FEDEA-0CB5-FD4B-8718-95B9D6A14304}" destId="{21D64796-42C1-6A47-B16B-F23C35A117FF}" srcOrd="1" destOrd="0" presId="urn:microsoft.com/office/officeart/2005/8/layout/vList5"/>
    <dgm:cxn modelId="{C06B9A2B-4F20-7C45-806D-5E7956B4F171}" type="presParOf" srcId="{C651D352-06FA-1B42-81FF-A95099FE5645}" destId="{B2C4C361-6A0B-BC45-90FD-318B0EB08F6D}" srcOrd="1" destOrd="0" presId="urn:microsoft.com/office/officeart/2005/8/layout/vList5"/>
    <dgm:cxn modelId="{7BF712B5-32BC-7844-BF86-9BFE0BE03182}" type="presParOf" srcId="{C651D352-06FA-1B42-81FF-A95099FE5645}" destId="{277D1FDC-6CD3-BB41-8E20-960C658417CF}" srcOrd="2" destOrd="0" presId="urn:microsoft.com/office/officeart/2005/8/layout/vList5"/>
    <dgm:cxn modelId="{8EE30A21-17AC-A34E-A945-33D32D0CD928}" type="presParOf" srcId="{277D1FDC-6CD3-BB41-8E20-960C658417CF}" destId="{6CEBA26E-9501-3E41-ACBB-39C96B19A924}" srcOrd="0" destOrd="0" presId="urn:microsoft.com/office/officeart/2005/8/layout/vList5"/>
    <dgm:cxn modelId="{3CCA96C7-C68E-DA49-A8B4-DD728A5A5A21}" type="presParOf" srcId="{277D1FDC-6CD3-BB41-8E20-960C658417CF}" destId="{2EB4DD27-0645-2048-89E9-55CE50FE52DA}" srcOrd="1" destOrd="0" presId="urn:microsoft.com/office/officeart/2005/8/layout/vList5"/>
    <dgm:cxn modelId="{4AF2BADF-B9C1-834B-AC41-60901F7D6D95}" type="presParOf" srcId="{C651D352-06FA-1B42-81FF-A95099FE5645}" destId="{33CCAA17-6648-4F4C-9AC2-5ECE7EDB6E70}" srcOrd="3" destOrd="0" presId="urn:microsoft.com/office/officeart/2005/8/layout/vList5"/>
    <dgm:cxn modelId="{2A4E440E-B7D6-6B49-8318-F6B71A21E6CF}" type="presParOf" srcId="{C651D352-06FA-1B42-81FF-A95099FE5645}" destId="{B97FC210-8EA1-614A-91AB-916C1AEFBDEE}" srcOrd="4" destOrd="0" presId="urn:microsoft.com/office/officeart/2005/8/layout/vList5"/>
    <dgm:cxn modelId="{2BDD0334-A1D2-DC42-B9D1-68F24D23B5D5}" type="presParOf" srcId="{B97FC210-8EA1-614A-91AB-916C1AEFBDEE}" destId="{A3A63788-1227-B240-AFF4-87DA3887717D}" srcOrd="0" destOrd="0" presId="urn:microsoft.com/office/officeart/2005/8/layout/vList5"/>
    <dgm:cxn modelId="{C69877D5-79C1-9F4C-B7F4-8AD7D15754EE}" type="presParOf" srcId="{B97FC210-8EA1-614A-91AB-916C1AEFBDEE}" destId="{5432570E-A980-7C49-B78B-FBD7E95247D6}" srcOrd="1" destOrd="0" presId="urn:microsoft.com/office/officeart/2005/8/layout/vList5"/>
    <dgm:cxn modelId="{33ACEA31-C6CD-5547-BED3-2458723FCA4A}" type="presParOf" srcId="{C651D352-06FA-1B42-81FF-A95099FE5645}" destId="{3E055F9F-21A2-424C-8A4E-65EE89C8A916}" srcOrd="5" destOrd="0" presId="urn:microsoft.com/office/officeart/2005/8/layout/vList5"/>
    <dgm:cxn modelId="{A37DA9BE-A47E-BB4D-9CC1-632CE186629D}" type="presParOf" srcId="{C651D352-06FA-1B42-81FF-A95099FE5645}" destId="{3D7F3715-4665-FB42-B9D8-1FF06FE7ED04}" srcOrd="6" destOrd="0" presId="urn:microsoft.com/office/officeart/2005/8/layout/vList5"/>
    <dgm:cxn modelId="{C891109C-0686-B74F-8141-60300585C701}" type="presParOf" srcId="{3D7F3715-4665-FB42-B9D8-1FF06FE7ED04}" destId="{F459C834-8503-9C47-9E88-19B5B264D39A}" srcOrd="0" destOrd="0" presId="urn:microsoft.com/office/officeart/2005/8/layout/vList5"/>
    <dgm:cxn modelId="{2F31821D-0811-794B-B121-3DE9146709AD}" type="presParOf" srcId="{3D7F3715-4665-FB42-B9D8-1FF06FE7ED04}" destId="{B11406A9-5BCB-7247-9C38-2B1D2505F2B8}" srcOrd="1" destOrd="0" presId="urn:microsoft.com/office/officeart/2005/8/layout/vList5"/>
    <dgm:cxn modelId="{0F8FFFCC-28B5-A844-A0C0-4277188A3AC8}" type="presParOf" srcId="{C651D352-06FA-1B42-81FF-A95099FE5645}" destId="{E355AC6F-4099-CB47-B889-4B740E437363}" srcOrd="7" destOrd="0" presId="urn:microsoft.com/office/officeart/2005/8/layout/vList5"/>
    <dgm:cxn modelId="{53EF242F-1951-6046-AB59-C18248626329}" type="presParOf" srcId="{C651D352-06FA-1B42-81FF-A95099FE5645}" destId="{A60CA7D8-39CB-954A-95BD-9B247DA4C063}" srcOrd="8" destOrd="0" presId="urn:microsoft.com/office/officeart/2005/8/layout/vList5"/>
    <dgm:cxn modelId="{ED3BF37E-4F96-D544-B638-C0AB83F1A9B4}" type="presParOf" srcId="{A60CA7D8-39CB-954A-95BD-9B247DA4C063}" destId="{4D3677DD-203E-6A46-986E-4A5C658C9303}" srcOrd="0" destOrd="0" presId="urn:microsoft.com/office/officeart/2005/8/layout/vList5"/>
    <dgm:cxn modelId="{5F05AF10-2999-E74B-852A-D64954D94FF8}" type="presParOf" srcId="{A60CA7D8-39CB-954A-95BD-9B247DA4C063}" destId="{DF481026-182D-AB4B-A938-B9E12915351D}" srcOrd="1" destOrd="0" presId="urn:microsoft.com/office/officeart/2005/8/layout/vList5"/>
    <dgm:cxn modelId="{ACD94F81-0016-934D-9BD5-68D8F780E3B7}" type="presParOf" srcId="{C651D352-06FA-1B42-81FF-A95099FE5645}" destId="{0E9316E9-2C30-AB47-AE90-7E8E046E1AFD}" srcOrd="9" destOrd="0" presId="urn:microsoft.com/office/officeart/2005/8/layout/vList5"/>
    <dgm:cxn modelId="{F8E487A0-A252-584F-8A38-3822D4AF8219}" type="presParOf" srcId="{C651D352-06FA-1B42-81FF-A95099FE5645}" destId="{037794A2-D322-8E40-B011-CE07ECE52AD6}" srcOrd="10" destOrd="0" presId="urn:microsoft.com/office/officeart/2005/8/layout/vList5"/>
    <dgm:cxn modelId="{67548826-ED42-6242-AA6A-DBBB72691D13}" type="presParOf" srcId="{037794A2-D322-8E40-B011-CE07ECE52AD6}" destId="{B6C279C8-1B63-3845-ADAB-B82AEFA3D8E4}" srcOrd="0" destOrd="0" presId="urn:microsoft.com/office/officeart/2005/8/layout/vList5"/>
    <dgm:cxn modelId="{B87CE2C3-5909-4C4E-A75A-B68815D3150A}" type="presParOf" srcId="{037794A2-D322-8E40-B011-CE07ECE52AD6}" destId="{95DA0D8B-BC89-0948-909A-C298332DBD75}" srcOrd="1" destOrd="0" presId="urn:microsoft.com/office/officeart/2005/8/layout/vList5"/>
    <dgm:cxn modelId="{B702A7F2-2B11-8D48-B9AE-A25D0DE633A1}" type="presParOf" srcId="{C651D352-06FA-1B42-81FF-A95099FE5645}" destId="{05C8E7F6-EE84-404A-A830-A5238A04D5A3}" srcOrd="11" destOrd="0" presId="urn:microsoft.com/office/officeart/2005/8/layout/vList5"/>
    <dgm:cxn modelId="{5D36C750-8050-AB49-B923-84B64CB9D59C}" type="presParOf" srcId="{C651D352-06FA-1B42-81FF-A95099FE5645}" destId="{450D1F74-F684-8F4C-A8B3-6F8B553AB682}" srcOrd="12" destOrd="0" presId="urn:microsoft.com/office/officeart/2005/8/layout/vList5"/>
    <dgm:cxn modelId="{69DDD68C-0D88-6141-B93A-2DFC27495FCF}" type="presParOf" srcId="{450D1F74-F684-8F4C-A8B3-6F8B553AB682}" destId="{B67BA8B7-08DC-C244-8300-FCD547033DBD}" srcOrd="0" destOrd="0" presId="urn:microsoft.com/office/officeart/2005/8/layout/vList5"/>
    <dgm:cxn modelId="{772109BC-D0C5-5C47-B68B-C1F238D6D77F}" type="presParOf" srcId="{450D1F74-F684-8F4C-A8B3-6F8B553AB682}" destId="{9D2B4FF6-13FB-EF49-977A-31DF5EE58099}" srcOrd="1" destOrd="0" presId="urn:microsoft.com/office/officeart/2005/8/layout/vList5"/>
    <dgm:cxn modelId="{5EBAD0AC-A244-A44E-ADFB-53F20C58044C}" type="presParOf" srcId="{C651D352-06FA-1B42-81FF-A95099FE5645}" destId="{580F7313-AC0F-FA49-A45E-0C9486F52D6E}" srcOrd="13" destOrd="0" presId="urn:microsoft.com/office/officeart/2005/8/layout/vList5"/>
    <dgm:cxn modelId="{6E9922E5-478F-AF4D-9DCA-7A72508F4F6D}" type="presParOf" srcId="{C651D352-06FA-1B42-81FF-A95099FE5645}" destId="{E737A561-EB87-EC46-B404-0D8CDB0DE287}" srcOrd="14" destOrd="0" presId="urn:microsoft.com/office/officeart/2005/8/layout/vList5"/>
    <dgm:cxn modelId="{8E470ECC-4731-EF49-B2A8-AD4470B8AD53}" type="presParOf" srcId="{E737A561-EB87-EC46-B404-0D8CDB0DE287}" destId="{D5D04DA4-D0C2-DE47-8C8C-0B8EFFA304FE}" srcOrd="0" destOrd="0" presId="urn:microsoft.com/office/officeart/2005/8/layout/vList5"/>
    <dgm:cxn modelId="{B9608D4F-B546-F142-90CB-D6437FE05ACF}" type="presParOf" srcId="{E737A561-EB87-EC46-B404-0D8CDB0DE287}" destId="{8CF3EAF4-8574-9841-9B3E-4FBF8CB57172}"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CE7EC2B3-709C-7049-AC98-40D647A08CD5}" type="doc">
      <dgm:prSet loTypeId="urn:microsoft.com/office/officeart/2005/8/layout/vList5" loCatId="" qsTypeId="urn:microsoft.com/office/officeart/2005/8/quickstyle/simple1" qsCatId="simple" csTypeId="urn:microsoft.com/office/officeart/2005/8/colors/accent1_2" csCatId="accent1" phldr="1"/>
      <dgm:spPr/>
      <dgm:t>
        <a:bodyPr/>
        <a:lstStyle/>
        <a:p>
          <a:endParaRPr lang="en-US"/>
        </a:p>
      </dgm:t>
    </dgm:pt>
    <dgm:pt modelId="{54EB0C78-47D0-4144-BBA1-ED83F2276A80}">
      <dgm:prSet phldrT="[Text]"/>
      <dgm:spPr/>
      <dgm:t>
        <a:bodyPr/>
        <a:lstStyle/>
        <a:p>
          <a:r>
            <a:rPr lang="en-US" dirty="0"/>
            <a:t>1</a:t>
          </a:r>
        </a:p>
      </dgm:t>
    </dgm:pt>
    <dgm:pt modelId="{46A28A5B-8A7C-BF49-A5DC-996D874F74B0}" type="parTrans" cxnId="{54AEA8B7-F89B-724F-98A1-0AEC5D7FC3A2}">
      <dgm:prSet/>
      <dgm:spPr/>
      <dgm:t>
        <a:bodyPr/>
        <a:lstStyle/>
        <a:p>
          <a:endParaRPr lang="en-US"/>
        </a:p>
      </dgm:t>
    </dgm:pt>
    <dgm:pt modelId="{E8376F97-8FAC-AA43-868D-BB3E335B92F2}" type="sibTrans" cxnId="{54AEA8B7-F89B-724F-98A1-0AEC5D7FC3A2}">
      <dgm:prSet/>
      <dgm:spPr/>
      <dgm:t>
        <a:bodyPr/>
        <a:lstStyle/>
        <a:p>
          <a:endParaRPr lang="en-US"/>
        </a:p>
      </dgm:t>
    </dgm:pt>
    <dgm:pt modelId="{D57A6E2B-1DF9-5046-BC1D-709A01F64D7F}">
      <dgm:prSet phldrT="[Text]"/>
      <dgm:spPr/>
      <dgm:t>
        <a:bodyPr/>
        <a:lstStyle/>
        <a:p>
          <a:r>
            <a:rPr lang="en-US"/>
            <a:t>Patient stability</a:t>
          </a:r>
          <a:endParaRPr lang="en-US" dirty="0"/>
        </a:p>
      </dgm:t>
    </dgm:pt>
    <dgm:pt modelId="{C76AEE8B-D94A-7D44-B03A-3FE0785274DD}" type="parTrans" cxnId="{B2C59790-5949-8740-B37D-5567793C306C}">
      <dgm:prSet/>
      <dgm:spPr/>
      <dgm:t>
        <a:bodyPr/>
        <a:lstStyle/>
        <a:p>
          <a:endParaRPr lang="en-US"/>
        </a:p>
      </dgm:t>
    </dgm:pt>
    <dgm:pt modelId="{55132C62-F393-2540-A3F5-1E79E69F36CF}" type="sibTrans" cxnId="{B2C59790-5949-8740-B37D-5567793C306C}">
      <dgm:prSet/>
      <dgm:spPr/>
      <dgm:t>
        <a:bodyPr/>
        <a:lstStyle/>
        <a:p>
          <a:endParaRPr lang="en-US"/>
        </a:p>
      </dgm:t>
    </dgm:pt>
    <dgm:pt modelId="{D03F059F-5021-1F40-A19F-9647158C52AD}">
      <dgm:prSet phldrT="[Text]"/>
      <dgm:spPr/>
      <dgm:t>
        <a:bodyPr/>
        <a:lstStyle/>
        <a:p>
          <a:r>
            <a:rPr lang="en-US" dirty="0"/>
            <a:t>2</a:t>
          </a:r>
        </a:p>
      </dgm:t>
    </dgm:pt>
    <dgm:pt modelId="{CF000D09-B476-0444-AE02-AACE5A32ABB9}" type="parTrans" cxnId="{65CEA44F-9E16-EA4E-A309-EC3B3016297A}">
      <dgm:prSet/>
      <dgm:spPr/>
      <dgm:t>
        <a:bodyPr/>
        <a:lstStyle/>
        <a:p>
          <a:endParaRPr lang="en-US"/>
        </a:p>
      </dgm:t>
    </dgm:pt>
    <dgm:pt modelId="{294C2440-29C3-A948-ADDD-2D4D34880BDD}" type="sibTrans" cxnId="{65CEA44F-9E16-EA4E-A309-EC3B3016297A}">
      <dgm:prSet/>
      <dgm:spPr/>
      <dgm:t>
        <a:bodyPr/>
        <a:lstStyle/>
        <a:p>
          <a:endParaRPr lang="en-US"/>
        </a:p>
      </dgm:t>
    </dgm:pt>
    <dgm:pt modelId="{8E966A69-49F1-5E4B-B606-FCAEDAA984ED}">
      <dgm:prSet phldrT="[Text]"/>
      <dgm:spPr/>
      <dgm:t>
        <a:bodyPr/>
        <a:lstStyle/>
        <a:p>
          <a:r>
            <a:rPr lang="en-US" dirty="0"/>
            <a:t>Emotional check</a:t>
          </a:r>
        </a:p>
      </dgm:t>
    </dgm:pt>
    <dgm:pt modelId="{DBAD8E5C-BD8A-8D4C-B4F0-8493200D7696}" type="parTrans" cxnId="{FBB45EE4-904A-AF48-A0C9-CB655E66EF52}">
      <dgm:prSet/>
      <dgm:spPr/>
      <dgm:t>
        <a:bodyPr/>
        <a:lstStyle/>
        <a:p>
          <a:endParaRPr lang="en-US"/>
        </a:p>
      </dgm:t>
    </dgm:pt>
    <dgm:pt modelId="{6E022D76-54D3-5040-BFB1-6E3CF648085C}" type="sibTrans" cxnId="{FBB45EE4-904A-AF48-A0C9-CB655E66EF52}">
      <dgm:prSet/>
      <dgm:spPr/>
      <dgm:t>
        <a:bodyPr/>
        <a:lstStyle/>
        <a:p>
          <a:endParaRPr lang="en-US"/>
        </a:p>
      </dgm:t>
    </dgm:pt>
    <dgm:pt modelId="{73A345CE-36FD-894D-BBC6-F1148569A643}">
      <dgm:prSet phldrT="[Text]"/>
      <dgm:spPr/>
      <dgm:t>
        <a:bodyPr/>
        <a:lstStyle/>
        <a:p>
          <a:r>
            <a:rPr lang="en-US" dirty="0"/>
            <a:t>3</a:t>
          </a:r>
        </a:p>
      </dgm:t>
    </dgm:pt>
    <dgm:pt modelId="{E3B27BD6-FBE2-5640-8D4A-26A5222CC3EA}" type="parTrans" cxnId="{408ED183-BF58-1C4B-97FD-732582625FEF}">
      <dgm:prSet/>
      <dgm:spPr/>
      <dgm:t>
        <a:bodyPr/>
        <a:lstStyle/>
        <a:p>
          <a:endParaRPr lang="en-US"/>
        </a:p>
      </dgm:t>
    </dgm:pt>
    <dgm:pt modelId="{7A99C83F-BC00-3743-81E8-552BD253CEC3}" type="sibTrans" cxnId="{408ED183-BF58-1C4B-97FD-732582625FEF}">
      <dgm:prSet/>
      <dgm:spPr/>
      <dgm:t>
        <a:bodyPr/>
        <a:lstStyle/>
        <a:p>
          <a:endParaRPr lang="en-US"/>
        </a:p>
      </dgm:t>
    </dgm:pt>
    <dgm:pt modelId="{E900B89A-C42B-5249-B68C-A3D7ECDC2722}">
      <dgm:prSet phldrT="[Text]"/>
      <dgm:spPr/>
      <dgm:t>
        <a:bodyPr/>
        <a:lstStyle/>
        <a:p>
          <a:r>
            <a:rPr lang="en-US" dirty="0"/>
            <a:t>Address bias</a:t>
          </a:r>
        </a:p>
      </dgm:t>
    </dgm:pt>
    <dgm:pt modelId="{8E839505-C7B5-E846-B572-409C6E14F87D}" type="parTrans" cxnId="{8EA459AB-225B-8C4D-9825-5D1C6BF10277}">
      <dgm:prSet/>
      <dgm:spPr/>
      <dgm:t>
        <a:bodyPr/>
        <a:lstStyle/>
        <a:p>
          <a:endParaRPr lang="en-US"/>
        </a:p>
      </dgm:t>
    </dgm:pt>
    <dgm:pt modelId="{1CCB8A03-5593-CE44-86BA-AACEAE0CCB98}" type="sibTrans" cxnId="{8EA459AB-225B-8C4D-9825-5D1C6BF10277}">
      <dgm:prSet/>
      <dgm:spPr/>
      <dgm:t>
        <a:bodyPr/>
        <a:lstStyle/>
        <a:p>
          <a:endParaRPr lang="en-US"/>
        </a:p>
      </dgm:t>
    </dgm:pt>
    <dgm:pt modelId="{418E94F4-4F87-154C-8C2C-4FA1854F2962}">
      <dgm:prSet/>
      <dgm:spPr/>
      <dgm:t>
        <a:bodyPr/>
        <a:lstStyle/>
        <a:p>
          <a:r>
            <a:rPr lang="en-US" dirty="0"/>
            <a:t>4</a:t>
          </a:r>
        </a:p>
      </dgm:t>
    </dgm:pt>
    <dgm:pt modelId="{67B29BF1-08A2-E04F-9D69-0598739CF13B}" type="parTrans" cxnId="{2BBF3C50-1ED6-9847-B76B-936F9EDE5606}">
      <dgm:prSet/>
      <dgm:spPr/>
      <dgm:t>
        <a:bodyPr/>
        <a:lstStyle/>
        <a:p>
          <a:endParaRPr lang="en-US"/>
        </a:p>
      </dgm:t>
    </dgm:pt>
    <dgm:pt modelId="{A5C1BCA8-59E6-2D47-BF9C-24A0A56844F7}" type="sibTrans" cxnId="{2BBF3C50-1ED6-9847-B76B-936F9EDE5606}">
      <dgm:prSet/>
      <dgm:spPr/>
      <dgm:t>
        <a:bodyPr/>
        <a:lstStyle/>
        <a:p>
          <a:endParaRPr lang="en-US"/>
        </a:p>
      </dgm:t>
    </dgm:pt>
    <dgm:pt modelId="{827957E1-E296-1C4F-A5F6-1C5FE324A00C}">
      <dgm:prSet/>
      <dgm:spPr/>
      <dgm:t>
        <a:bodyPr/>
        <a:lstStyle/>
        <a:p>
          <a:r>
            <a:rPr lang="en-US" dirty="0"/>
            <a:t>5</a:t>
          </a:r>
        </a:p>
      </dgm:t>
    </dgm:pt>
    <dgm:pt modelId="{AC89EDA2-97A0-704F-A224-66777968DC79}" type="parTrans" cxnId="{C5A31E1B-1939-A943-9EA9-0D1F931C9095}">
      <dgm:prSet/>
      <dgm:spPr/>
      <dgm:t>
        <a:bodyPr/>
        <a:lstStyle/>
        <a:p>
          <a:endParaRPr lang="en-US"/>
        </a:p>
      </dgm:t>
    </dgm:pt>
    <dgm:pt modelId="{9F52F0F0-B16C-AB44-86AF-35AA79D5B0BB}" type="sibTrans" cxnId="{C5A31E1B-1939-A943-9EA9-0D1F931C9095}">
      <dgm:prSet/>
      <dgm:spPr/>
      <dgm:t>
        <a:bodyPr/>
        <a:lstStyle/>
        <a:p>
          <a:endParaRPr lang="en-US"/>
        </a:p>
      </dgm:t>
    </dgm:pt>
    <dgm:pt modelId="{9F6E5C8F-12F1-3545-94A6-291C5042E69E}">
      <dgm:prSet/>
      <dgm:spPr/>
      <dgm:t>
        <a:bodyPr/>
        <a:lstStyle/>
        <a:p>
          <a:r>
            <a:rPr lang="en-US" dirty="0"/>
            <a:t>6</a:t>
          </a:r>
        </a:p>
      </dgm:t>
    </dgm:pt>
    <dgm:pt modelId="{F878F1E0-BA83-0B4F-8407-D69A3E0606E8}" type="parTrans" cxnId="{545F95DE-9A10-3948-9807-36C195D34A35}">
      <dgm:prSet/>
      <dgm:spPr/>
      <dgm:t>
        <a:bodyPr/>
        <a:lstStyle/>
        <a:p>
          <a:endParaRPr lang="en-US"/>
        </a:p>
      </dgm:t>
    </dgm:pt>
    <dgm:pt modelId="{F501E3C1-886B-5244-A7B1-7A80D72A4D8C}" type="sibTrans" cxnId="{545F95DE-9A10-3948-9807-36C195D34A35}">
      <dgm:prSet/>
      <dgm:spPr/>
      <dgm:t>
        <a:bodyPr/>
        <a:lstStyle/>
        <a:p>
          <a:endParaRPr lang="en-US"/>
        </a:p>
      </dgm:t>
    </dgm:pt>
    <dgm:pt modelId="{02BDF100-8338-E043-96F5-EE898B9D5AB2}">
      <dgm:prSet/>
      <dgm:spPr/>
      <dgm:t>
        <a:bodyPr/>
        <a:lstStyle/>
        <a:p>
          <a:r>
            <a:rPr lang="en-US" dirty="0"/>
            <a:t>7</a:t>
          </a:r>
        </a:p>
      </dgm:t>
    </dgm:pt>
    <dgm:pt modelId="{1B53CCA0-CFF2-384B-856E-1EBDFA4D02AD}" type="parTrans" cxnId="{F6183E77-6BBF-FA47-854D-F0D53AE21A8A}">
      <dgm:prSet/>
      <dgm:spPr/>
      <dgm:t>
        <a:bodyPr/>
        <a:lstStyle/>
        <a:p>
          <a:endParaRPr lang="en-US"/>
        </a:p>
      </dgm:t>
    </dgm:pt>
    <dgm:pt modelId="{BCE247F3-63ED-824C-BC43-9D645F88694B}" type="sibTrans" cxnId="{F6183E77-6BBF-FA47-854D-F0D53AE21A8A}">
      <dgm:prSet/>
      <dgm:spPr/>
      <dgm:t>
        <a:bodyPr/>
        <a:lstStyle/>
        <a:p>
          <a:endParaRPr lang="en-US"/>
        </a:p>
      </dgm:t>
    </dgm:pt>
    <dgm:pt modelId="{7CF6944D-D814-F446-BDE2-B55C1C344687}">
      <dgm:prSet/>
      <dgm:spPr/>
      <dgm:t>
        <a:bodyPr/>
        <a:lstStyle/>
        <a:p>
          <a:r>
            <a:rPr lang="en-US" dirty="0"/>
            <a:t>8</a:t>
          </a:r>
        </a:p>
      </dgm:t>
    </dgm:pt>
    <dgm:pt modelId="{18766106-4E88-954F-80B4-8435CD7E3607}" type="parTrans" cxnId="{B4BAA057-82A7-8F4F-B3AE-D2474B9F0D61}">
      <dgm:prSet/>
      <dgm:spPr/>
      <dgm:t>
        <a:bodyPr/>
        <a:lstStyle/>
        <a:p>
          <a:endParaRPr lang="en-US"/>
        </a:p>
      </dgm:t>
    </dgm:pt>
    <dgm:pt modelId="{41CA9CD1-BD05-D240-8585-F6D044F469D5}" type="sibTrans" cxnId="{B4BAA057-82A7-8F4F-B3AE-D2474B9F0D61}">
      <dgm:prSet/>
      <dgm:spPr/>
      <dgm:t>
        <a:bodyPr/>
        <a:lstStyle/>
        <a:p>
          <a:endParaRPr lang="en-US"/>
        </a:p>
      </dgm:t>
    </dgm:pt>
    <dgm:pt modelId="{77E26394-E137-5E44-9434-AC75CD3E8E1C}">
      <dgm:prSet/>
      <dgm:spPr/>
      <dgm:t>
        <a:bodyPr/>
        <a:lstStyle/>
        <a:p>
          <a:r>
            <a:rPr lang="en-US" dirty="0"/>
            <a:t>Align with team</a:t>
          </a:r>
        </a:p>
      </dgm:t>
    </dgm:pt>
    <dgm:pt modelId="{0106416C-C608-3E4B-95A9-3A27F212EF0D}" type="parTrans" cxnId="{3055A850-65BD-2C48-A538-0AAEB9138E85}">
      <dgm:prSet/>
      <dgm:spPr/>
      <dgm:t>
        <a:bodyPr/>
        <a:lstStyle/>
        <a:p>
          <a:endParaRPr lang="en-US"/>
        </a:p>
      </dgm:t>
    </dgm:pt>
    <dgm:pt modelId="{4162CFAB-B676-8E4E-8FEB-32BD16B62DEC}" type="sibTrans" cxnId="{3055A850-65BD-2C48-A538-0AAEB9138E85}">
      <dgm:prSet/>
      <dgm:spPr/>
      <dgm:t>
        <a:bodyPr/>
        <a:lstStyle/>
        <a:p>
          <a:endParaRPr lang="en-US"/>
        </a:p>
      </dgm:t>
    </dgm:pt>
    <dgm:pt modelId="{D6BB4A41-00B2-5448-BB3F-80605AC75A4E}">
      <dgm:prSet/>
      <dgm:spPr/>
      <dgm:t>
        <a:bodyPr/>
        <a:lstStyle/>
        <a:p>
          <a:r>
            <a:rPr lang="en-US" dirty="0"/>
            <a:t>Recenter on care</a:t>
          </a:r>
        </a:p>
      </dgm:t>
    </dgm:pt>
    <dgm:pt modelId="{4E04882C-8060-1D42-8502-5D210AA0DCD3}" type="parTrans" cxnId="{DF1A41C0-D8B8-6D4F-A8A5-91EC68AFBCAD}">
      <dgm:prSet/>
      <dgm:spPr/>
      <dgm:t>
        <a:bodyPr/>
        <a:lstStyle/>
        <a:p>
          <a:endParaRPr lang="en-US"/>
        </a:p>
      </dgm:t>
    </dgm:pt>
    <dgm:pt modelId="{A3F6C628-648D-0249-B65F-551AF9ECEEA6}" type="sibTrans" cxnId="{DF1A41C0-D8B8-6D4F-A8A5-91EC68AFBCAD}">
      <dgm:prSet/>
      <dgm:spPr/>
      <dgm:t>
        <a:bodyPr/>
        <a:lstStyle/>
        <a:p>
          <a:endParaRPr lang="en-US"/>
        </a:p>
      </dgm:t>
    </dgm:pt>
    <dgm:pt modelId="{0545D5E0-C6B3-A447-B001-E955BFE39730}">
      <dgm:prSet/>
      <dgm:spPr/>
      <dgm:t>
        <a:bodyPr/>
        <a:lstStyle/>
        <a:p>
          <a:r>
            <a:rPr lang="en-US" dirty="0"/>
            <a:t>Give space</a:t>
          </a:r>
        </a:p>
      </dgm:t>
    </dgm:pt>
    <dgm:pt modelId="{74548467-254B-2943-9A99-08C07F3E448D}" type="parTrans" cxnId="{E2BB9BC9-6DB1-9443-8E35-6250A99E4AD7}">
      <dgm:prSet/>
      <dgm:spPr/>
      <dgm:t>
        <a:bodyPr/>
        <a:lstStyle/>
        <a:p>
          <a:endParaRPr lang="en-US"/>
        </a:p>
      </dgm:t>
    </dgm:pt>
    <dgm:pt modelId="{43A03E68-4CAE-A344-B58C-38B13B6EE776}" type="sibTrans" cxnId="{E2BB9BC9-6DB1-9443-8E35-6250A99E4AD7}">
      <dgm:prSet/>
      <dgm:spPr/>
      <dgm:t>
        <a:bodyPr/>
        <a:lstStyle/>
        <a:p>
          <a:endParaRPr lang="en-US"/>
        </a:p>
      </dgm:t>
    </dgm:pt>
    <dgm:pt modelId="{4042EA18-93B7-8447-AC0A-58BAED6135AA}">
      <dgm:prSet/>
      <dgm:spPr/>
      <dgm:t>
        <a:bodyPr/>
        <a:lstStyle/>
        <a:p>
          <a:r>
            <a:rPr lang="en-US" dirty="0"/>
            <a:t>Seek support</a:t>
          </a:r>
        </a:p>
      </dgm:t>
    </dgm:pt>
    <dgm:pt modelId="{2F5CB061-56DE-EB4D-BFD4-36B00E6055CB}" type="parTrans" cxnId="{BBBA16DC-BC73-8048-A725-FE1EF1BF6593}">
      <dgm:prSet/>
      <dgm:spPr/>
      <dgm:t>
        <a:bodyPr/>
        <a:lstStyle/>
        <a:p>
          <a:endParaRPr lang="en-US"/>
        </a:p>
      </dgm:t>
    </dgm:pt>
    <dgm:pt modelId="{A608511D-1BB9-EB4E-9E74-CCD7B0DB861D}" type="sibTrans" cxnId="{BBBA16DC-BC73-8048-A725-FE1EF1BF6593}">
      <dgm:prSet/>
      <dgm:spPr/>
      <dgm:t>
        <a:bodyPr/>
        <a:lstStyle/>
        <a:p>
          <a:endParaRPr lang="en-US"/>
        </a:p>
      </dgm:t>
    </dgm:pt>
    <dgm:pt modelId="{B3ABDBBC-28C2-CC44-9EA0-940A074F9BF0}">
      <dgm:prSet/>
      <dgm:spPr/>
      <dgm:t>
        <a:bodyPr/>
        <a:lstStyle/>
        <a:p>
          <a:r>
            <a:rPr lang="en-US" dirty="0"/>
            <a:t>Set boundaries</a:t>
          </a:r>
        </a:p>
      </dgm:t>
    </dgm:pt>
    <dgm:pt modelId="{B1A1C092-087B-F241-9B26-AD1D13C72D4D}" type="sibTrans" cxnId="{D85391B8-F585-FD43-82E0-8ACB9B810BF4}">
      <dgm:prSet/>
      <dgm:spPr/>
      <dgm:t>
        <a:bodyPr/>
        <a:lstStyle/>
        <a:p>
          <a:endParaRPr lang="en-US"/>
        </a:p>
      </dgm:t>
    </dgm:pt>
    <dgm:pt modelId="{D1297B60-D255-DA44-8D75-399213932CFB}" type="parTrans" cxnId="{D85391B8-F585-FD43-82E0-8ACB9B810BF4}">
      <dgm:prSet/>
      <dgm:spPr/>
      <dgm:t>
        <a:bodyPr/>
        <a:lstStyle/>
        <a:p>
          <a:endParaRPr lang="en-US"/>
        </a:p>
      </dgm:t>
    </dgm:pt>
    <dgm:pt modelId="{C651D352-06FA-1B42-81FF-A95099FE5645}" type="pres">
      <dgm:prSet presAssocID="{CE7EC2B3-709C-7049-AC98-40D647A08CD5}" presName="Name0" presStyleCnt="0">
        <dgm:presLayoutVars>
          <dgm:dir/>
          <dgm:animLvl val="lvl"/>
          <dgm:resizeHandles val="exact"/>
        </dgm:presLayoutVars>
      </dgm:prSet>
      <dgm:spPr/>
    </dgm:pt>
    <dgm:pt modelId="{2E2FEDEA-0CB5-FD4B-8718-95B9D6A14304}" type="pres">
      <dgm:prSet presAssocID="{54EB0C78-47D0-4144-BBA1-ED83F2276A80}" presName="linNode" presStyleCnt="0"/>
      <dgm:spPr/>
    </dgm:pt>
    <dgm:pt modelId="{2F0271A3-745A-A943-B67B-E4069A93AE61}" type="pres">
      <dgm:prSet presAssocID="{54EB0C78-47D0-4144-BBA1-ED83F2276A80}" presName="parentText" presStyleLbl="node1" presStyleIdx="0" presStyleCnt="8" custScaleX="67001">
        <dgm:presLayoutVars>
          <dgm:chMax val="1"/>
          <dgm:bulletEnabled val="1"/>
        </dgm:presLayoutVars>
      </dgm:prSet>
      <dgm:spPr/>
    </dgm:pt>
    <dgm:pt modelId="{21D64796-42C1-6A47-B16B-F23C35A117FF}" type="pres">
      <dgm:prSet presAssocID="{54EB0C78-47D0-4144-BBA1-ED83F2276A80}" presName="descendantText" presStyleLbl="alignAccFollowNode1" presStyleIdx="0" presStyleCnt="8">
        <dgm:presLayoutVars>
          <dgm:bulletEnabled val="1"/>
        </dgm:presLayoutVars>
      </dgm:prSet>
      <dgm:spPr/>
    </dgm:pt>
    <dgm:pt modelId="{B2C4C361-6A0B-BC45-90FD-318B0EB08F6D}" type="pres">
      <dgm:prSet presAssocID="{E8376F97-8FAC-AA43-868D-BB3E335B92F2}" presName="sp" presStyleCnt="0"/>
      <dgm:spPr/>
    </dgm:pt>
    <dgm:pt modelId="{277D1FDC-6CD3-BB41-8E20-960C658417CF}" type="pres">
      <dgm:prSet presAssocID="{D03F059F-5021-1F40-A19F-9647158C52AD}" presName="linNode" presStyleCnt="0"/>
      <dgm:spPr/>
    </dgm:pt>
    <dgm:pt modelId="{6CEBA26E-9501-3E41-ACBB-39C96B19A924}" type="pres">
      <dgm:prSet presAssocID="{D03F059F-5021-1F40-A19F-9647158C52AD}" presName="parentText" presStyleLbl="node1" presStyleIdx="1" presStyleCnt="8" custScaleX="67001">
        <dgm:presLayoutVars>
          <dgm:chMax val="1"/>
          <dgm:bulletEnabled val="1"/>
        </dgm:presLayoutVars>
      </dgm:prSet>
      <dgm:spPr/>
    </dgm:pt>
    <dgm:pt modelId="{2EB4DD27-0645-2048-89E9-55CE50FE52DA}" type="pres">
      <dgm:prSet presAssocID="{D03F059F-5021-1F40-A19F-9647158C52AD}" presName="descendantText" presStyleLbl="alignAccFollowNode1" presStyleIdx="1" presStyleCnt="8">
        <dgm:presLayoutVars>
          <dgm:bulletEnabled val="1"/>
        </dgm:presLayoutVars>
      </dgm:prSet>
      <dgm:spPr/>
    </dgm:pt>
    <dgm:pt modelId="{33CCAA17-6648-4F4C-9AC2-5ECE7EDB6E70}" type="pres">
      <dgm:prSet presAssocID="{294C2440-29C3-A948-ADDD-2D4D34880BDD}" presName="sp" presStyleCnt="0"/>
      <dgm:spPr/>
    </dgm:pt>
    <dgm:pt modelId="{B97FC210-8EA1-614A-91AB-916C1AEFBDEE}" type="pres">
      <dgm:prSet presAssocID="{73A345CE-36FD-894D-BBC6-F1148569A643}" presName="linNode" presStyleCnt="0"/>
      <dgm:spPr/>
    </dgm:pt>
    <dgm:pt modelId="{A3A63788-1227-B240-AFF4-87DA3887717D}" type="pres">
      <dgm:prSet presAssocID="{73A345CE-36FD-894D-BBC6-F1148569A643}" presName="parentText" presStyleLbl="node1" presStyleIdx="2" presStyleCnt="8" custScaleX="67001">
        <dgm:presLayoutVars>
          <dgm:chMax val="1"/>
          <dgm:bulletEnabled val="1"/>
        </dgm:presLayoutVars>
      </dgm:prSet>
      <dgm:spPr/>
    </dgm:pt>
    <dgm:pt modelId="{5432570E-A980-7C49-B78B-FBD7E95247D6}" type="pres">
      <dgm:prSet presAssocID="{73A345CE-36FD-894D-BBC6-F1148569A643}" presName="descendantText" presStyleLbl="alignAccFollowNode1" presStyleIdx="2" presStyleCnt="8">
        <dgm:presLayoutVars>
          <dgm:bulletEnabled val="1"/>
        </dgm:presLayoutVars>
      </dgm:prSet>
      <dgm:spPr/>
    </dgm:pt>
    <dgm:pt modelId="{3E055F9F-21A2-424C-8A4E-65EE89C8A916}" type="pres">
      <dgm:prSet presAssocID="{7A99C83F-BC00-3743-81E8-552BD253CEC3}" presName="sp" presStyleCnt="0"/>
      <dgm:spPr/>
    </dgm:pt>
    <dgm:pt modelId="{3D7F3715-4665-FB42-B9D8-1FF06FE7ED04}" type="pres">
      <dgm:prSet presAssocID="{418E94F4-4F87-154C-8C2C-4FA1854F2962}" presName="linNode" presStyleCnt="0"/>
      <dgm:spPr/>
    </dgm:pt>
    <dgm:pt modelId="{F459C834-8503-9C47-9E88-19B5B264D39A}" type="pres">
      <dgm:prSet presAssocID="{418E94F4-4F87-154C-8C2C-4FA1854F2962}" presName="parentText" presStyleLbl="node1" presStyleIdx="3" presStyleCnt="8" custScaleX="67001">
        <dgm:presLayoutVars>
          <dgm:chMax val="1"/>
          <dgm:bulletEnabled val="1"/>
        </dgm:presLayoutVars>
      </dgm:prSet>
      <dgm:spPr/>
    </dgm:pt>
    <dgm:pt modelId="{B11406A9-5BCB-7247-9C38-2B1D2505F2B8}" type="pres">
      <dgm:prSet presAssocID="{418E94F4-4F87-154C-8C2C-4FA1854F2962}" presName="descendantText" presStyleLbl="alignAccFollowNode1" presStyleIdx="3" presStyleCnt="8">
        <dgm:presLayoutVars>
          <dgm:bulletEnabled val="1"/>
        </dgm:presLayoutVars>
      </dgm:prSet>
      <dgm:spPr/>
    </dgm:pt>
    <dgm:pt modelId="{E355AC6F-4099-CB47-B889-4B740E437363}" type="pres">
      <dgm:prSet presAssocID="{A5C1BCA8-59E6-2D47-BF9C-24A0A56844F7}" presName="sp" presStyleCnt="0"/>
      <dgm:spPr/>
    </dgm:pt>
    <dgm:pt modelId="{A60CA7D8-39CB-954A-95BD-9B247DA4C063}" type="pres">
      <dgm:prSet presAssocID="{827957E1-E296-1C4F-A5F6-1C5FE324A00C}" presName="linNode" presStyleCnt="0"/>
      <dgm:spPr/>
    </dgm:pt>
    <dgm:pt modelId="{4D3677DD-203E-6A46-986E-4A5C658C9303}" type="pres">
      <dgm:prSet presAssocID="{827957E1-E296-1C4F-A5F6-1C5FE324A00C}" presName="parentText" presStyleLbl="node1" presStyleIdx="4" presStyleCnt="8" custScaleX="67001">
        <dgm:presLayoutVars>
          <dgm:chMax val="1"/>
          <dgm:bulletEnabled val="1"/>
        </dgm:presLayoutVars>
      </dgm:prSet>
      <dgm:spPr/>
    </dgm:pt>
    <dgm:pt modelId="{DF481026-182D-AB4B-A938-B9E12915351D}" type="pres">
      <dgm:prSet presAssocID="{827957E1-E296-1C4F-A5F6-1C5FE324A00C}" presName="descendantText" presStyleLbl="alignAccFollowNode1" presStyleIdx="4" presStyleCnt="8">
        <dgm:presLayoutVars>
          <dgm:bulletEnabled val="1"/>
        </dgm:presLayoutVars>
      </dgm:prSet>
      <dgm:spPr/>
    </dgm:pt>
    <dgm:pt modelId="{0E9316E9-2C30-AB47-AE90-7E8E046E1AFD}" type="pres">
      <dgm:prSet presAssocID="{9F52F0F0-B16C-AB44-86AF-35AA79D5B0BB}" presName="sp" presStyleCnt="0"/>
      <dgm:spPr/>
    </dgm:pt>
    <dgm:pt modelId="{037794A2-D322-8E40-B011-CE07ECE52AD6}" type="pres">
      <dgm:prSet presAssocID="{9F6E5C8F-12F1-3545-94A6-291C5042E69E}" presName="linNode" presStyleCnt="0"/>
      <dgm:spPr/>
    </dgm:pt>
    <dgm:pt modelId="{B6C279C8-1B63-3845-ADAB-B82AEFA3D8E4}" type="pres">
      <dgm:prSet presAssocID="{9F6E5C8F-12F1-3545-94A6-291C5042E69E}" presName="parentText" presStyleLbl="node1" presStyleIdx="5" presStyleCnt="8" custScaleX="67001">
        <dgm:presLayoutVars>
          <dgm:chMax val="1"/>
          <dgm:bulletEnabled val="1"/>
        </dgm:presLayoutVars>
      </dgm:prSet>
      <dgm:spPr/>
    </dgm:pt>
    <dgm:pt modelId="{95DA0D8B-BC89-0948-909A-C298332DBD75}" type="pres">
      <dgm:prSet presAssocID="{9F6E5C8F-12F1-3545-94A6-291C5042E69E}" presName="descendantText" presStyleLbl="alignAccFollowNode1" presStyleIdx="5" presStyleCnt="8">
        <dgm:presLayoutVars>
          <dgm:bulletEnabled val="1"/>
        </dgm:presLayoutVars>
      </dgm:prSet>
      <dgm:spPr/>
    </dgm:pt>
    <dgm:pt modelId="{05C8E7F6-EE84-404A-A830-A5238A04D5A3}" type="pres">
      <dgm:prSet presAssocID="{F501E3C1-886B-5244-A7B1-7A80D72A4D8C}" presName="sp" presStyleCnt="0"/>
      <dgm:spPr/>
    </dgm:pt>
    <dgm:pt modelId="{450D1F74-F684-8F4C-A8B3-6F8B553AB682}" type="pres">
      <dgm:prSet presAssocID="{02BDF100-8338-E043-96F5-EE898B9D5AB2}" presName="linNode" presStyleCnt="0"/>
      <dgm:spPr/>
    </dgm:pt>
    <dgm:pt modelId="{B67BA8B7-08DC-C244-8300-FCD547033DBD}" type="pres">
      <dgm:prSet presAssocID="{02BDF100-8338-E043-96F5-EE898B9D5AB2}" presName="parentText" presStyleLbl="node1" presStyleIdx="6" presStyleCnt="8" custScaleX="67001">
        <dgm:presLayoutVars>
          <dgm:chMax val="1"/>
          <dgm:bulletEnabled val="1"/>
        </dgm:presLayoutVars>
      </dgm:prSet>
      <dgm:spPr/>
    </dgm:pt>
    <dgm:pt modelId="{9D2B4FF6-13FB-EF49-977A-31DF5EE58099}" type="pres">
      <dgm:prSet presAssocID="{02BDF100-8338-E043-96F5-EE898B9D5AB2}" presName="descendantText" presStyleLbl="alignAccFollowNode1" presStyleIdx="6" presStyleCnt="8">
        <dgm:presLayoutVars>
          <dgm:bulletEnabled val="1"/>
        </dgm:presLayoutVars>
      </dgm:prSet>
      <dgm:spPr/>
    </dgm:pt>
    <dgm:pt modelId="{580F7313-AC0F-FA49-A45E-0C9486F52D6E}" type="pres">
      <dgm:prSet presAssocID="{BCE247F3-63ED-824C-BC43-9D645F88694B}" presName="sp" presStyleCnt="0"/>
      <dgm:spPr/>
    </dgm:pt>
    <dgm:pt modelId="{E737A561-EB87-EC46-B404-0D8CDB0DE287}" type="pres">
      <dgm:prSet presAssocID="{7CF6944D-D814-F446-BDE2-B55C1C344687}" presName="linNode" presStyleCnt="0"/>
      <dgm:spPr/>
    </dgm:pt>
    <dgm:pt modelId="{D5D04DA4-D0C2-DE47-8C8C-0B8EFFA304FE}" type="pres">
      <dgm:prSet presAssocID="{7CF6944D-D814-F446-BDE2-B55C1C344687}" presName="parentText" presStyleLbl="node1" presStyleIdx="7" presStyleCnt="8" custScaleX="67001">
        <dgm:presLayoutVars>
          <dgm:chMax val="1"/>
          <dgm:bulletEnabled val="1"/>
        </dgm:presLayoutVars>
      </dgm:prSet>
      <dgm:spPr/>
    </dgm:pt>
    <dgm:pt modelId="{8CF3EAF4-8574-9841-9B3E-4FBF8CB57172}" type="pres">
      <dgm:prSet presAssocID="{7CF6944D-D814-F446-BDE2-B55C1C344687}" presName="descendantText" presStyleLbl="alignAccFollowNode1" presStyleIdx="7" presStyleCnt="8">
        <dgm:presLayoutVars>
          <dgm:bulletEnabled val="1"/>
        </dgm:presLayoutVars>
      </dgm:prSet>
      <dgm:spPr/>
    </dgm:pt>
  </dgm:ptLst>
  <dgm:cxnLst>
    <dgm:cxn modelId="{E4273A05-E6BD-7B48-BAB7-FF2C885BDD30}" type="presOf" srcId="{02BDF100-8338-E043-96F5-EE898B9D5AB2}" destId="{B67BA8B7-08DC-C244-8300-FCD547033DBD}" srcOrd="0" destOrd="0" presId="urn:microsoft.com/office/officeart/2005/8/layout/vList5"/>
    <dgm:cxn modelId="{E9D1E10C-1628-524C-9321-D84C071FF74D}" type="presOf" srcId="{CE7EC2B3-709C-7049-AC98-40D647A08CD5}" destId="{C651D352-06FA-1B42-81FF-A95099FE5645}" srcOrd="0" destOrd="0" presId="urn:microsoft.com/office/officeart/2005/8/layout/vList5"/>
    <dgm:cxn modelId="{C4160712-DF53-0F4F-9BBA-78BD9BBF4B88}" type="presOf" srcId="{77E26394-E137-5E44-9434-AC75CD3E8E1C}" destId="{B11406A9-5BCB-7247-9C38-2B1D2505F2B8}" srcOrd="0" destOrd="0" presId="urn:microsoft.com/office/officeart/2005/8/layout/vList5"/>
    <dgm:cxn modelId="{C5A31E1B-1939-A943-9EA9-0D1F931C9095}" srcId="{CE7EC2B3-709C-7049-AC98-40D647A08CD5}" destId="{827957E1-E296-1C4F-A5F6-1C5FE324A00C}" srcOrd="4" destOrd="0" parTransId="{AC89EDA2-97A0-704F-A224-66777968DC79}" sibTransId="{9F52F0F0-B16C-AB44-86AF-35AA79D5B0BB}"/>
    <dgm:cxn modelId="{086EAA1D-3224-4E41-87B1-9FA27037DE47}" type="presOf" srcId="{9F6E5C8F-12F1-3545-94A6-291C5042E69E}" destId="{B6C279C8-1B63-3845-ADAB-B82AEFA3D8E4}" srcOrd="0" destOrd="0" presId="urn:microsoft.com/office/officeart/2005/8/layout/vList5"/>
    <dgm:cxn modelId="{71BBC71D-E55C-424F-B6C9-6E507D91D4E5}" type="presOf" srcId="{D6BB4A41-00B2-5448-BB3F-80605AC75A4E}" destId="{95DA0D8B-BC89-0948-909A-C298332DBD75}" srcOrd="0" destOrd="0" presId="urn:microsoft.com/office/officeart/2005/8/layout/vList5"/>
    <dgm:cxn modelId="{7A4CD21E-5C30-9844-B8CC-04D4CC71350C}" type="presOf" srcId="{4042EA18-93B7-8447-AC0A-58BAED6135AA}" destId="{8CF3EAF4-8574-9841-9B3E-4FBF8CB57172}" srcOrd="0" destOrd="0" presId="urn:microsoft.com/office/officeart/2005/8/layout/vList5"/>
    <dgm:cxn modelId="{EA0CCB2E-33A7-7842-AF42-FDB163C3A0DB}" type="presOf" srcId="{8E966A69-49F1-5E4B-B606-FCAEDAA984ED}" destId="{2EB4DD27-0645-2048-89E9-55CE50FE52DA}" srcOrd="0" destOrd="0" presId="urn:microsoft.com/office/officeart/2005/8/layout/vList5"/>
    <dgm:cxn modelId="{65CEA44F-9E16-EA4E-A309-EC3B3016297A}" srcId="{CE7EC2B3-709C-7049-AC98-40D647A08CD5}" destId="{D03F059F-5021-1F40-A19F-9647158C52AD}" srcOrd="1" destOrd="0" parTransId="{CF000D09-B476-0444-AE02-AACE5A32ABB9}" sibTransId="{294C2440-29C3-A948-ADDD-2D4D34880BDD}"/>
    <dgm:cxn modelId="{2BBF3C50-1ED6-9847-B76B-936F9EDE5606}" srcId="{CE7EC2B3-709C-7049-AC98-40D647A08CD5}" destId="{418E94F4-4F87-154C-8C2C-4FA1854F2962}" srcOrd="3" destOrd="0" parTransId="{67B29BF1-08A2-E04F-9D69-0598739CF13B}" sibTransId="{A5C1BCA8-59E6-2D47-BF9C-24A0A56844F7}"/>
    <dgm:cxn modelId="{3055A850-65BD-2C48-A538-0AAEB9138E85}" srcId="{418E94F4-4F87-154C-8C2C-4FA1854F2962}" destId="{77E26394-E137-5E44-9434-AC75CD3E8E1C}" srcOrd="0" destOrd="0" parTransId="{0106416C-C608-3E4B-95A9-3A27F212EF0D}" sibTransId="{4162CFAB-B676-8E4E-8FEB-32BD16B62DEC}"/>
    <dgm:cxn modelId="{B3273152-AF0F-EE4B-8C28-8B1E95E5CD89}" type="presOf" srcId="{E900B89A-C42B-5249-B68C-A3D7ECDC2722}" destId="{5432570E-A980-7C49-B78B-FBD7E95247D6}" srcOrd="0" destOrd="0" presId="urn:microsoft.com/office/officeart/2005/8/layout/vList5"/>
    <dgm:cxn modelId="{90712D57-061F-8444-BA8A-D8DA5E4630C5}" type="presOf" srcId="{73A345CE-36FD-894D-BBC6-F1148569A643}" destId="{A3A63788-1227-B240-AFF4-87DA3887717D}" srcOrd="0" destOrd="0" presId="urn:microsoft.com/office/officeart/2005/8/layout/vList5"/>
    <dgm:cxn modelId="{B4BAA057-82A7-8F4F-B3AE-D2474B9F0D61}" srcId="{CE7EC2B3-709C-7049-AC98-40D647A08CD5}" destId="{7CF6944D-D814-F446-BDE2-B55C1C344687}" srcOrd="7" destOrd="0" parTransId="{18766106-4E88-954F-80B4-8435CD7E3607}" sibTransId="{41CA9CD1-BD05-D240-8585-F6D044F469D5}"/>
    <dgm:cxn modelId="{BAD62360-A798-6A47-A994-B5126C6DDBBA}" type="presOf" srcId="{D57A6E2B-1DF9-5046-BC1D-709A01F64D7F}" destId="{21D64796-42C1-6A47-B16B-F23C35A117FF}" srcOrd="0" destOrd="0" presId="urn:microsoft.com/office/officeart/2005/8/layout/vList5"/>
    <dgm:cxn modelId="{F6183E77-6BBF-FA47-854D-F0D53AE21A8A}" srcId="{CE7EC2B3-709C-7049-AC98-40D647A08CD5}" destId="{02BDF100-8338-E043-96F5-EE898B9D5AB2}" srcOrd="6" destOrd="0" parTransId="{1B53CCA0-CFF2-384B-856E-1EBDFA4D02AD}" sibTransId="{BCE247F3-63ED-824C-BC43-9D645F88694B}"/>
    <dgm:cxn modelId="{89198578-5DCB-6140-878F-E9FD8D67271F}" type="presOf" srcId="{7CF6944D-D814-F446-BDE2-B55C1C344687}" destId="{D5D04DA4-D0C2-DE47-8C8C-0B8EFFA304FE}" srcOrd="0" destOrd="0" presId="urn:microsoft.com/office/officeart/2005/8/layout/vList5"/>
    <dgm:cxn modelId="{408ED183-BF58-1C4B-97FD-732582625FEF}" srcId="{CE7EC2B3-709C-7049-AC98-40D647A08CD5}" destId="{73A345CE-36FD-894D-BBC6-F1148569A643}" srcOrd="2" destOrd="0" parTransId="{E3B27BD6-FBE2-5640-8D4A-26A5222CC3EA}" sibTransId="{7A99C83F-BC00-3743-81E8-552BD253CEC3}"/>
    <dgm:cxn modelId="{B2C59790-5949-8740-B37D-5567793C306C}" srcId="{54EB0C78-47D0-4144-BBA1-ED83F2276A80}" destId="{D57A6E2B-1DF9-5046-BC1D-709A01F64D7F}" srcOrd="0" destOrd="0" parTransId="{C76AEE8B-D94A-7D44-B03A-3FE0785274DD}" sibTransId="{55132C62-F393-2540-A3F5-1E79E69F36CF}"/>
    <dgm:cxn modelId="{2D83CF9B-C8D2-5645-B148-7557D123AE42}" type="presOf" srcId="{827957E1-E296-1C4F-A5F6-1C5FE324A00C}" destId="{4D3677DD-203E-6A46-986E-4A5C658C9303}" srcOrd="0" destOrd="0" presId="urn:microsoft.com/office/officeart/2005/8/layout/vList5"/>
    <dgm:cxn modelId="{D734F3A8-F28E-EC4B-833E-A76A8DF839E2}" type="presOf" srcId="{D03F059F-5021-1F40-A19F-9647158C52AD}" destId="{6CEBA26E-9501-3E41-ACBB-39C96B19A924}" srcOrd="0" destOrd="0" presId="urn:microsoft.com/office/officeart/2005/8/layout/vList5"/>
    <dgm:cxn modelId="{8EA459AB-225B-8C4D-9825-5D1C6BF10277}" srcId="{73A345CE-36FD-894D-BBC6-F1148569A643}" destId="{E900B89A-C42B-5249-B68C-A3D7ECDC2722}" srcOrd="0" destOrd="0" parTransId="{8E839505-C7B5-E846-B572-409C6E14F87D}" sibTransId="{1CCB8A03-5593-CE44-86BA-AACEAE0CCB98}"/>
    <dgm:cxn modelId="{54AEA8B7-F89B-724F-98A1-0AEC5D7FC3A2}" srcId="{CE7EC2B3-709C-7049-AC98-40D647A08CD5}" destId="{54EB0C78-47D0-4144-BBA1-ED83F2276A80}" srcOrd="0" destOrd="0" parTransId="{46A28A5B-8A7C-BF49-A5DC-996D874F74B0}" sibTransId="{E8376F97-8FAC-AA43-868D-BB3E335B92F2}"/>
    <dgm:cxn modelId="{D85391B8-F585-FD43-82E0-8ACB9B810BF4}" srcId="{827957E1-E296-1C4F-A5F6-1C5FE324A00C}" destId="{B3ABDBBC-28C2-CC44-9EA0-940A074F9BF0}" srcOrd="0" destOrd="0" parTransId="{D1297B60-D255-DA44-8D75-399213932CFB}" sibTransId="{B1A1C092-087B-F241-9B26-AD1D13C72D4D}"/>
    <dgm:cxn modelId="{DF1A41C0-D8B8-6D4F-A8A5-91EC68AFBCAD}" srcId="{9F6E5C8F-12F1-3545-94A6-291C5042E69E}" destId="{D6BB4A41-00B2-5448-BB3F-80605AC75A4E}" srcOrd="0" destOrd="0" parTransId="{4E04882C-8060-1D42-8502-5D210AA0DCD3}" sibTransId="{A3F6C628-648D-0249-B65F-551AF9ECEEA6}"/>
    <dgm:cxn modelId="{F2E046C8-391B-6946-ACE6-697EC224AB98}" type="presOf" srcId="{B3ABDBBC-28C2-CC44-9EA0-940A074F9BF0}" destId="{DF481026-182D-AB4B-A938-B9E12915351D}" srcOrd="0" destOrd="0" presId="urn:microsoft.com/office/officeart/2005/8/layout/vList5"/>
    <dgm:cxn modelId="{E2BB9BC9-6DB1-9443-8E35-6250A99E4AD7}" srcId="{02BDF100-8338-E043-96F5-EE898B9D5AB2}" destId="{0545D5E0-C6B3-A447-B001-E955BFE39730}" srcOrd="0" destOrd="0" parTransId="{74548467-254B-2943-9A99-08C07F3E448D}" sibTransId="{43A03E68-4CAE-A344-B58C-38B13B6EE776}"/>
    <dgm:cxn modelId="{A16837DB-2A15-1C45-807B-67AB4EF8E75E}" type="presOf" srcId="{0545D5E0-C6B3-A447-B001-E955BFE39730}" destId="{9D2B4FF6-13FB-EF49-977A-31DF5EE58099}" srcOrd="0" destOrd="0" presId="urn:microsoft.com/office/officeart/2005/8/layout/vList5"/>
    <dgm:cxn modelId="{BBBA16DC-BC73-8048-A725-FE1EF1BF6593}" srcId="{7CF6944D-D814-F446-BDE2-B55C1C344687}" destId="{4042EA18-93B7-8447-AC0A-58BAED6135AA}" srcOrd="0" destOrd="0" parTransId="{2F5CB061-56DE-EB4D-BFD4-36B00E6055CB}" sibTransId="{A608511D-1BB9-EB4E-9E74-CCD7B0DB861D}"/>
    <dgm:cxn modelId="{545F95DE-9A10-3948-9807-36C195D34A35}" srcId="{CE7EC2B3-709C-7049-AC98-40D647A08CD5}" destId="{9F6E5C8F-12F1-3545-94A6-291C5042E69E}" srcOrd="5" destOrd="0" parTransId="{F878F1E0-BA83-0B4F-8407-D69A3E0606E8}" sibTransId="{F501E3C1-886B-5244-A7B1-7A80D72A4D8C}"/>
    <dgm:cxn modelId="{1AC639E1-2DD4-8C49-9596-C5731579DC3A}" type="presOf" srcId="{54EB0C78-47D0-4144-BBA1-ED83F2276A80}" destId="{2F0271A3-745A-A943-B67B-E4069A93AE61}" srcOrd="0" destOrd="0" presId="urn:microsoft.com/office/officeart/2005/8/layout/vList5"/>
    <dgm:cxn modelId="{FBB45EE4-904A-AF48-A0C9-CB655E66EF52}" srcId="{D03F059F-5021-1F40-A19F-9647158C52AD}" destId="{8E966A69-49F1-5E4B-B606-FCAEDAA984ED}" srcOrd="0" destOrd="0" parTransId="{DBAD8E5C-BD8A-8D4C-B4F0-8493200D7696}" sibTransId="{6E022D76-54D3-5040-BFB1-6E3CF648085C}"/>
    <dgm:cxn modelId="{CE4D51EC-1171-9740-9774-3550157EF9C1}" type="presOf" srcId="{418E94F4-4F87-154C-8C2C-4FA1854F2962}" destId="{F459C834-8503-9C47-9E88-19B5B264D39A}" srcOrd="0" destOrd="0" presId="urn:microsoft.com/office/officeart/2005/8/layout/vList5"/>
    <dgm:cxn modelId="{BF236B13-02D1-B64C-986F-0CAF7E0612E5}" type="presParOf" srcId="{C651D352-06FA-1B42-81FF-A95099FE5645}" destId="{2E2FEDEA-0CB5-FD4B-8718-95B9D6A14304}" srcOrd="0" destOrd="0" presId="urn:microsoft.com/office/officeart/2005/8/layout/vList5"/>
    <dgm:cxn modelId="{9578A504-AB23-5044-A923-D3DEFAE4D5E7}" type="presParOf" srcId="{2E2FEDEA-0CB5-FD4B-8718-95B9D6A14304}" destId="{2F0271A3-745A-A943-B67B-E4069A93AE61}" srcOrd="0" destOrd="0" presId="urn:microsoft.com/office/officeart/2005/8/layout/vList5"/>
    <dgm:cxn modelId="{253C94D8-1885-B543-AF3D-F6A1DD424873}" type="presParOf" srcId="{2E2FEDEA-0CB5-FD4B-8718-95B9D6A14304}" destId="{21D64796-42C1-6A47-B16B-F23C35A117FF}" srcOrd="1" destOrd="0" presId="urn:microsoft.com/office/officeart/2005/8/layout/vList5"/>
    <dgm:cxn modelId="{C06B9A2B-4F20-7C45-806D-5E7956B4F171}" type="presParOf" srcId="{C651D352-06FA-1B42-81FF-A95099FE5645}" destId="{B2C4C361-6A0B-BC45-90FD-318B0EB08F6D}" srcOrd="1" destOrd="0" presId="urn:microsoft.com/office/officeart/2005/8/layout/vList5"/>
    <dgm:cxn modelId="{7BF712B5-32BC-7844-BF86-9BFE0BE03182}" type="presParOf" srcId="{C651D352-06FA-1B42-81FF-A95099FE5645}" destId="{277D1FDC-6CD3-BB41-8E20-960C658417CF}" srcOrd="2" destOrd="0" presId="urn:microsoft.com/office/officeart/2005/8/layout/vList5"/>
    <dgm:cxn modelId="{8EE30A21-17AC-A34E-A945-33D32D0CD928}" type="presParOf" srcId="{277D1FDC-6CD3-BB41-8E20-960C658417CF}" destId="{6CEBA26E-9501-3E41-ACBB-39C96B19A924}" srcOrd="0" destOrd="0" presId="urn:microsoft.com/office/officeart/2005/8/layout/vList5"/>
    <dgm:cxn modelId="{3CCA96C7-C68E-DA49-A8B4-DD728A5A5A21}" type="presParOf" srcId="{277D1FDC-6CD3-BB41-8E20-960C658417CF}" destId="{2EB4DD27-0645-2048-89E9-55CE50FE52DA}" srcOrd="1" destOrd="0" presId="urn:microsoft.com/office/officeart/2005/8/layout/vList5"/>
    <dgm:cxn modelId="{4AF2BADF-B9C1-834B-AC41-60901F7D6D95}" type="presParOf" srcId="{C651D352-06FA-1B42-81FF-A95099FE5645}" destId="{33CCAA17-6648-4F4C-9AC2-5ECE7EDB6E70}" srcOrd="3" destOrd="0" presId="urn:microsoft.com/office/officeart/2005/8/layout/vList5"/>
    <dgm:cxn modelId="{2A4E440E-B7D6-6B49-8318-F6B71A21E6CF}" type="presParOf" srcId="{C651D352-06FA-1B42-81FF-A95099FE5645}" destId="{B97FC210-8EA1-614A-91AB-916C1AEFBDEE}" srcOrd="4" destOrd="0" presId="urn:microsoft.com/office/officeart/2005/8/layout/vList5"/>
    <dgm:cxn modelId="{2BDD0334-A1D2-DC42-B9D1-68F24D23B5D5}" type="presParOf" srcId="{B97FC210-8EA1-614A-91AB-916C1AEFBDEE}" destId="{A3A63788-1227-B240-AFF4-87DA3887717D}" srcOrd="0" destOrd="0" presId="urn:microsoft.com/office/officeart/2005/8/layout/vList5"/>
    <dgm:cxn modelId="{C69877D5-79C1-9F4C-B7F4-8AD7D15754EE}" type="presParOf" srcId="{B97FC210-8EA1-614A-91AB-916C1AEFBDEE}" destId="{5432570E-A980-7C49-B78B-FBD7E95247D6}" srcOrd="1" destOrd="0" presId="urn:microsoft.com/office/officeart/2005/8/layout/vList5"/>
    <dgm:cxn modelId="{33ACEA31-C6CD-5547-BED3-2458723FCA4A}" type="presParOf" srcId="{C651D352-06FA-1B42-81FF-A95099FE5645}" destId="{3E055F9F-21A2-424C-8A4E-65EE89C8A916}" srcOrd="5" destOrd="0" presId="urn:microsoft.com/office/officeart/2005/8/layout/vList5"/>
    <dgm:cxn modelId="{A37DA9BE-A47E-BB4D-9CC1-632CE186629D}" type="presParOf" srcId="{C651D352-06FA-1B42-81FF-A95099FE5645}" destId="{3D7F3715-4665-FB42-B9D8-1FF06FE7ED04}" srcOrd="6" destOrd="0" presId="urn:microsoft.com/office/officeart/2005/8/layout/vList5"/>
    <dgm:cxn modelId="{C891109C-0686-B74F-8141-60300585C701}" type="presParOf" srcId="{3D7F3715-4665-FB42-B9D8-1FF06FE7ED04}" destId="{F459C834-8503-9C47-9E88-19B5B264D39A}" srcOrd="0" destOrd="0" presId="urn:microsoft.com/office/officeart/2005/8/layout/vList5"/>
    <dgm:cxn modelId="{2F31821D-0811-794B-B121-3DE9146709AD}" type="presParOf" srcId="{3D7F3715-4665-FB42-B9D8-1FF06FE7ED04}" destId="{B11406A9-5BCB-7247-9C38-2B1D2505F2B8}" srcOrd="1" destOrd="0" presId="urn:microsoft.com/office/officeart/2005/8/layout/vList5"/>
    <dgm:cxn modelId="{0F8FFFCC-28B5-A844-A0C0-4277188A3AC8}" type="presParOf" srcId="{C651D352-06FA-1B42-81FF-A95099FE5645}" destId="{E355AC6F-4099-CB47-B889-4B740E437363}" srcOrd="7" destOrd="0" presId="urn:microsoft.com/office/officeart/2005/8/layout/vList5"/>
    <dgm:cxn modelId="{53EF242F-1951-6046-AB59-C18248626329}" type="presParOf" srcId="{C651D352-06FA-1B42-81FF-A95099FE5645}" destId="{A60CA7D8-39CB-954A-95BD-9B247DA4C063}" srcOrd="8" destOrd="0" presId="urn:microsoft.com/office/officeart/2005/8/layout/vList5"/>
    <dgm:cxn modelId="{ED3BF37E-4F96-D544-B638-C0AB83F1A9B4}" type="presParOf" srcId="{A60CA7D8-39CB-954A-95BD-9B247DA4C063}" destId="{4D3677DD-203E-6A46-986E-4A5C658C9303}" srcOrd="0" destOrd="0" presId="urn:microsoft.com/office/officeart/2005/8/layout/vList5"/>
    <dgm:cxn modelId="{5F05AF10-2999-E74B-852A-D64954D94FF8}" type="presParOf" srcId="{A60CA7D8-39CB-954A-95BD-9B247DA4C063}" destId="{DF481026-182D-AB4B-A938-B9E12915351D}" srcOrd="1" destOrd="0" presId="urn:microsoft.com/office/officeart/2005/8/layout/vList5"/>
    <dgm:cxn modelId="{ACD94F81-0016-934D-9BD5-68D8F780E3B7}" type="presParOf" srcId="{C651D352-06FA-1B42-81FF-A95099FE5645}" destId="{0E9316E9-2C30-AB47-AE90-7E8E046E1AFD}" srcOrd="9" destOrd="0" presId="urn:microsoft.com/office/officeart/2005/8/layout/vList5"/>
    <dgm:cxn modelId="{F8E487A0-A252-584F-8A38-3822D4AF8219}" type="presParOf" srcId="{C651D352-06FA-1B42-81FF-A95099FE5645}" destId="{037794A2-D322-8E40-B011-CE07ECE52AD6}" srcOrd="10" destOrd="0" presId="urn:microsoft.com/office/officeart/2005/8/layout/vList5"/>
    <dgm:cxn modelId="{67548826-ED42-6242-AA6A-DBBB72691D13}" type="presParOf" srcId="{037794A2-D322-8E40-B011-CE07ECE52AD6}" destId="{B6C279C8-1B63-3845-ADAB-B82AEFA3D8E4}" srcOrd="0" destOrd="0" presId="urn:microsoft.com/office/officeart/2005/8/layout/vList5"/>
    <dgm:cxn modelId="{B87CE2C3-5909-4C4E-A75A-B68815D3150A}" type="presParOf" srcId="{037794A2-D322-8E40-B011-CE07ECE52AD6}" destId="{95DA0D8B-BC89-0948-909A-C298332DBD75}" srcOrd="1" destOrd="0" presId="urn:microsoft.com/office/officeart/2005/8/layout/vList5"/>
    <dgm:cxn modelId="{B702A7F2-2B11-8D48-B9AE-A25D0DE633A1}" type="presParOf" srcId="{C651D352-06FA-1B42-81FF-A95099FE5645}" destId="{05C8E7F6-EE84-404A-A830-A5238A04D5A3}" srcOrd="11" destOrd="0" presId="urn:microsoft.com/office/officeart/2005/8/layout/vList5"/>
    <dgm:cxn modelId="{5D36C750-8050-AB49-B923-84B64CB9D59C}" type="presParOf" srcId="{C651D352-06FA-1B42-81FF-A95099FE5645}" destId="{450D1F74-F684-8F4C-A8B3-6F8B553AB682}" srcOrd="12" destOrd="0" presId="urn:microsoft.com/office/officeart/2005/8/layout/vList5"/>
    <dgm:cxn modelId="{69DDD68C-0D88-6141-B93A-2DFC27495FCF}" type="presParOf" srcId="{450D1F74-F684-8F4C-A8B3-6F8B553AB682}" destId="{B67BA8B7-08DC-C244-8300-FCD547033DBD}" srcOrd="0" destOrd="0" presId="urn:microsoft.com/office/officeart/2005/8/layout/vList5"/>
    <dgm:cxn modelId="{772109BC-D0C5-5C47-B68B-C1F238D6D77F}" type="presParOf" srcId="{450D1F74-F684-8F4C-A8B3-6F8B553AB682}" destId="{9D2B4FF6-13FB-EF49-977A-31DF5EE58099}" srcOrd="1" destOrd="0" presId="urn:microsoft.com/office/officeart/2005/8/layout/vList5"/>
    <dgm:cxn modelId="{5EBAD0AC-A244-A44E-ADFB-53F20C58044C}" type="presParOf" srcId="{C651D352-06FA-1B42-81FF-A95099FE5645}" destId="{580F7313-AC0F-FA49-A45E-0C9486F52D6E}" srcOrd="13" destOrd="0" presId="urn:microsoft.com/office/officeart/2005/8/layout/vList5"/>
    <dgm:cxn modelId="{6E9922E5-478F-AF4D-9DCA-7A72508F4F6D}" type="presParOf" srcId="{C651D352-06FA-1B42-81FF-A95099FE5645}" destId="{E737A561-EB87-EC46-B404-0D8CDB0DE287}" srcOrd="14" destOrd="0" presId="urn:microsoft.com/office/officeart/2005/8/layout/vList5"/>
    <dgm:cxn modelId="{8E470ECC-4731-EF49-B2A8-AD4470B8AD53}" type="presParOf" srcId="{E737A561-EB87-EC46-B404-0D8CDB0DE287}" destId="{D5D04DA4-D0C2-DE47-8C8C-0B8EFFA304FE}" srcOrd="0" destOrd="0" presId="urn:microsoft.com/office/officeart/2005/8/layout/vList5"/>
    <dgm:cxn modelId="{B9608D4F-B546-F142-90CB-D6437FE05ACF}" type="presParOf" srcId="{E737A561-EB87-EC46-B404-0D8CDB0DE287}" destId="{8CF3EAF4-8574-9841-9B3E-4FBF8CB57172}"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1D64796-42C1-6A47-B16B-F23C35A117FF}">
      <dsp:nvSpPr>
        <dsp:cNvPr id="0" name=""/>
        <dsp:cNvSpPr/>
      </dsp:nvSpPr>
      <dsp:spPr>
        <a:xfrm rot="5400000">
          <a:off x="1202530" y="-45270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a:t>Patient stability</a:t>
          </a:r>
          <a:endParaRPr lang="en-US" sz="1300" kern="1200" dirty="0"/>
        </a:p>
      </dsp:txBody>
      <dsp:txXfrm rot="-5400000">
        <a:off x="692728" y="79320"/>
        <a:ext cx="1452636" cy="410807"/>
      </dsp:txXfrm>
    </dsp:sp>
    <dsp:sp modelId="{2F0271A3-745A-A943-B67B-E4069A93AE61}">
      <dsp:nvSpPr>
        <dsp:cNvPr id="0" name=""/>
        <dsp:cNvSpPr/>
      </dsp:nvSpPr>
      <dsp:spPr>
        <a:xfrm>
          <a:off x="136881" y="18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1</a:t>
          </a:r>
        </a:p>
      </dsp:txBody>
      <dsp:txXfrm>
        <a:off x="164015" y="27322"/>
        <a:ext cx="501578" cy="514801"/>
      </dsp:txXfrm>
    </dsp:sp>
    <dsp:sp modelId="{2EB4DD27-0645-2048-89E9-55CE50FE52DA}">
      <dsp:nvSpPr>
        <dsp:cNvPr id="0" name=""/>
        <dsp:cNvSpPr/>
      </dsp:nvSpPr>
      <dsp:spPr>
        <a:xfrm rot="5400000">
          <a:off x="1202530" y="14481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Emotional check</a:t>
          </a:r>
        </a:p>
      </dsp:txBody>
      <dsp:txXfrm rot="-5400000">
        <a:off x="692728" y="676842"/>
        <a:ext cx="1452636" cy="410807"/>
      </dsp:txXfrm>
    </dsp:sp>
    <dsp:sp modelId="{6CEBA26E-9501-3E41-ACBB-39C96B19A924}">
      <dsp:nvSpPr>
        <dsp:cNvPr id="0" name=""/>
        <dsp:cNvSpPr/>
      </dsp:nvSpPr>
      <dsp:spPr>
        <a:xfrm>
          <a:off x="136881" y="59771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2</a:t>
          </a:r>
        </a:p>
      </dsp:txBody>
      <dsp:txXfrm>
        <a:off x="164015" y="624845"/>
        <a:ext cx="501578" cy="514801"/>
      </dsp:txXfrm>
    </dsp:sp>
    <dsp:sp modelId="{5432570E-A980-7C49-B78B-FBD7E95247D6}">
      <dsp:nvSpPr>
        <dsp:cNvPr id="0" name=""/>
        <dsp:cNvSpPr/>
      </dsp:nvSpPr>
      <dsp:spPr>
        <a:xfrm rot="5400000">
          <a:off x="1202530" y="74233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ddress bias</a:t>
          </a:r>
        </a:p>
      </dsp:txBody>
      <dsp:txXfrm rot="-5400000">
        <a:off x="692728" y="1274365"/>
        <a:ext cx="1452636" cy="410807"/>
      </dsp:txXfrm>
    </dsp:sp>
    <dsp:sp modelId="{A3A63788-1227-B240-AFF4-87DA3887717D}">
      <dsp:nvSpPr>
        <dsp:cNvPr id="0" name=""/>
        <dsp:cNvSpPr/>
      </dsp:nvSpPr>
      <dsp:spPr>
        <a:xfrm>
          <a:off x="136881" y="119523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3</a:t>
          </a:r>
        </a:p>
      </dsp:txBody>
      <dsp:txXfrm>
        <a:off x="164015" y="1222369"/>
        <a:ext cx="501578" cy="514801"/>
      </dsp:txXfrm>
    </dsp:sp>
    <dsp:sp modelId="{B11406A9-5BCB-7247-9C38-2B1D2505F2B8}">
      <dsp:nvSpPr>
        <dsp:cNvPr id="0" name=""/>
        <dsp:cNvSpPr/>
      </dsp:nvSpPr>
      <dsp:spPr>
        <a:xfrm rot="5400000">
          <a:off x="1202530" y="133986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team</a:t>
          </a:r>
        </a:p>
      </dsp:txBody>
      <dsp:txXfrm rot="-5400000">
        <a:off x="692728" y="1871888"/>
        <a:ext cx="1452636" cy="410807"/>
      </dsp:txXfrm>
    </dsp:sp>
    <dsp:sp modelId="{F459C834-8503-9C47-9E88-19B5B264D39A}">
      <dsp:nvSpPr>
        <dsp:cNvPr id="0" name=""/>
        <dsp:cNvSpPr/>
      </dsp:nvSpPr>
      <dsp:spPr>
        <a:xfrm>
          <a:off x="136881" y="179275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4</a:t>
          </a:r>
        </a:p>
      </dsp:txBody>
      <dsp:txXfrm>
        <a:off x="164015" y="1819892"/>
        <a:ext cx="501578" cy="514801"/>
      </dsp:txXfrm>
    </dsp:sp>
    <dsp:sp modelId="{DF481026-182D-AB4B-A938-B9E12915351D}">
      <dsp:nvSpPr>
        <dsp:cNvPr id="0" name=""/>
        <dsp:cNvSpPr/>
      </dsp:nvSpPr>
      <dsp:spPr>
        <a:xfrm rot="5400000">
          <a:off x="1202530" y="193738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t boundaries</a:t>
          </a:r>
        </a:p>
      </dsp:txBody>
      <dsp:txXfrm rot="-5400000">
        <a:off x="692728" y="2469412"/>
        <a:ext cx="1452636" cy="410807"/>
      </dsp:txXfrm>
    </dsp:sp>
    <dsp:sp modelId="{4D3677DD-203E-6A46-986E-4A5C658C9303}">
      <dsp:nvSpPr>
        <dsp:cNvPr id="0" name=""/>
        <dsp:cNvSpPr/>
      </dsp:nvSpPr>
      <dsp:spPr>
        <a:xfrm>
          <a:off x="136881" y="239028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5</a:t>
          </a:r>
        </a:p>
      </dsp:txBody>
      <dsp:txXfrm>
        <a:off x="164015" y="2417415"/>
        <a:ext cx="501578" cy="514801"/>
      </dsp:txXfrm>
    </dsp:sp>
    <dsp:sp modelId="{95DA0D8B-BC89-0948-909A-C298332DBD75}">
      <dsp:nvSpPr>
        <dsp:cNvPr id="0" name=""/>
        <dsp:cNvSpPr/>
      </dsp:nvSpPr>
      <dsp:spPr>
        <a:xfrm rot="5400000">
          <a:off x="1202530" y="253490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Recenter on care</a:t>
          </a:r>
        </a:p>
      </dsp:txBody>
      <dsp:txXfrm rot="-5400000">
        <a:off x="692728" y="3066935"/>
        <a:ext cx="1452636" cy="410807"/>
      </dsp:txXfrm>
    </dsp:sp>
    <dsp:sp modelId="{B6C279C8-1B63-3845-ADAB-B82AEFA3D8E4}">
      <dsp:nvSpPr>
        <dsp:cNvPr id="0" name=""/>
        <dsp:cNvSpPr/>
      </dsp:nvSpPr>
      <dsp:spPr>
        <a:xfrm>
          <a:off x="136881" y="298780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6</a:t>
          </a:r>
        </a:p>
      </dsp:txBody>
      <dsp:txXfrm>
        <a:off x="164015" y="3014939"/>
        <a:ext cx="501578" cy="514801"/>
      </dsp:txXfrm>
    </dsp:sp>
    <dsp:sp modelId="{9D2B4FF6-13FB-EF49-977A-31DF5EE58099}">
      <dsp:nvSpPr>
        <dsp:cNvPr id="0" name=""/>
        <dsp:cNvSpPr/>
      </dsp:nvSpPr>
      <dsp:spPr>
        <a:xfrm rot="5400000">
          <a:off x="1202530" y="313243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Give space</a:t>
          </a:r>
        </a:p>
      </dsp:txBody>
      <dsp:txXfrm rot="-5400000">
        <a:off x="692728" y="3664458"/>
        <a:ext cx="1452636" cy="410807"/>
      </dsp:txXfrm>
    </dsp:sp>
    <dsp:sp modelId="{B67BA8B7-08DC-C244-8300-FCD547033DBD}">
      <dsp:nvSpPr>
        <dsp:cNvPr id="0" name=""/>
        <dsp:cNvSpPr/>
      </dsp:nvSpPr>
      <dsp:spPr>
        <a:xfrm>
          <a:off x="136881" y="358532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7</a:t>
          </a:r>
        </a:p>
      </dsp:txBody>
      <dsp:txXfrm>
        <a:off x="164015" y="3612462"/>
        <a:ext cx="501578" cy="514801"/>
      </dsp:txXfrm>
    </dsp:sp>
    <dsp:sp modelId="{8CF3EAF4-8574-9841-9B3E-4FBF8CB57172}">
      <dsp:nvSpPr>
        <dsp:cNvPr id="0" name=""/>
        <dsp:cNvSpPr/>
      </dsp:nvSpPr>
      <dsp:spPr>
        <a:xfrm rot="5400000">
          <a:off x="1202530" y="372995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ek support</a:t>
          </a:r>
        </a:p>
      </dsp:txBody>
      <dsp:txXfrm rot="-5400000">
        <a:off x="692728" y="4261982"/>
        <a:ext cx="1452636" cy="410807"/>
      </dsp:txXfrm>
    </dsp:sp>
    <dsp:sp modelId="{D5D04DA4-D0C2-DE47-8C8C-0B8EFFA304FE}">
      <dsp:nvSpPr>
        <dsp:cNvPr id="0" name=""/>
        <dsp:cNvSpPr/>
      </dsp:nvSpPr>
      <dsp:spPr>
        <a:xfrm>
          <a:off x="136881" y="418285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8</a:t>
          </a:r>
        </a:p>
      </dsp:txBody>
      <dsp:txXfrm>
        <a:off x="164015" y="4209985"/>
        <a:ext cx="501578" cy="514801"/>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1D64796-42C1-6A47-B16B-F23C35A117FF}">
      <dsp:nvSpPr>
        <dsp:cNvPr id="0" name=""/>
        <dsp:cNvSpPr/>
      </dsp:nvSpPr>
      <dsp:spPr>
        <a:xfrm rot="5400000">
          <a:off x="1202530" y="-45270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a:t>Patient stability</a:t>
          </a:r>
          <a:endParaRPr lang="en-US" sz="1300" kern="1200" dirty="0"/>
        </a:p>
      </dsp:txBody>
      <dsp:txXfrm rot="-5400000">
        <a:off x="692728" y="79320"/>
        <a:ext cx="1452636" cy="410807"/>
      </dsp:txXfrm>
    </dsp:sp>
    <dsp:sp modelId="{2F0271A3-745A-A943-B67B-E4069A93AE61}">
      <dsp:nvSpPr>
        <dsp:cNvPr id="0" name=""/>
        <dsp:cNvSpPr/>
      </dsp:nvSpPr>
      <dsp:spPr>
        <a:xfrm>
          <a:off x="136881" y="18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1</a:t>
          </a:r>
        </a:p>
      </dsp:txBody>
      <dsp:txXfrm>
        <a:off x="164015" y="27322"/>
        <a:ext cx="501578" cy="514801"/>
      </dsp:txXfrm>
    </dsp:sp>
    <dsp:sp modelId="{2EB4DD27-0645-2048-89E9-55CE50FE52DA}">
      <dsp:nvSpPr>
        <dsp:cNvPr id="0" name=""/>
        <dsp:cNvSpPr/>
      </dsp:nvSpPr>
      <dsp:spPr>
        <a:xfrm rot="5400000">
          <a:off x="1202530" y="14481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Emotional check</a:t>
          </a:r>
        </a:p>
      </dsp:txBody>
      <dsp:txXfrm rot="-5400000">
        <a:off x="692728" y="676842"/>
        <a:ext cx="1452636" cy="410807"/>
      </dsp:txXfrm>
    </dsp:sp>
    <dsp:sp modelId="{6CEBA26E-9501-3E41-ACBB-39C96B19A924}">
      <dsp:nvSpPr>
        <dsp:cNvPr id="0" name=""/>
        <dsp:cNvSpPr/>
      </dsp:nvSpPr>
      <dsp:spPr>
        <a:xfrm>
          <a:off x="136881" y="59771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2</a:t>
          </a:r>
        </a:p>
      </dsp:txBody>
      <dsp:txXfrm>
        <a:off x="164015" y="624845"/>
        <a:ext cx="501578" cy="514801"/>
      </dsp:txXfrm>
    </dsp:sp>
    <dsp:sp modelId="{5432570E-A980-7C49-B78B-FBD7E95247D6}">
      <dsp:nvSpPr>
        <dsp:cNvPr id="0" name=""/>
        <dsp:cNvSpPr/>
      </dsp:nvSpPr>
      <dsp:spPr>
        <a:xfrm rot="5400000">
          <a:off x="1202530" y="74233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ddress bias</a:t>
          </a:r>
        </a:p>
      </dsp:txBody>
      <dsp:txXfrm rot="-5400000">
        <a:off x="692728" y="1274365"/>
        <a:ext cx="1452636" cy="410807"/>
      </dsp:txXfrm>
    </dsp:sp>
    <dsp:sp modelId="{A3A63788-1227-B240-AFF4-87DA3887717D}">
      <dsp:nvSpPr>
        <dsp:cNvPr id="0" name=""/>
        <dsp:cNvSpPr/>
      </dsp:nvSpPr>
      <dsp:spPr>
        <a:xfrm>
          <a:off x="136881" y="119523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3</a:t>
          </a:r>
        </a:p>
      </dsp:txBody>
      <dsp:txXfrm>
        <a:off x="164015" y="1222369"/>
        <a:ext cx="501578" cy="514801"/>
      </dsp:txXfrm>
    </dsp:sp>
    <dsp:sp modelId="{B11406A9-5BCB-7247-9C38-2B1D2505F2B8}">
      <dsp:nvSpPr>
        <dsp:cNvPr id="0" name=""/>
        <dsp:cNvSpPr/>
      </dsp:nvSpPr>
      <dsp:spPr>
        <a:xfrm rot="5400000">
          <a:off x="1202530" y="133986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team</a:t>
          </a:r>
        </a:p>
      </dsp:txBody>
      <dsp:txXfrm rot="-5400000">
        <a:off x="692728" y="1871888"/>
        <a:ext cx="1452636" cy="410807"/>
      </dsp:txXfrm>
    </dsp:sp>
    <dsp:sp modelId="{F459C834-8503-9C47-9E88-19B5B264D39A}">
      <dsp:nvSpPr>
        <dsp:cNvPr id="0" name=""/>
        <dsp:cNvSpPr/>
      </dsp:nvSpPr>
      <dsp:spPr>
        <a:xfrm>
          <a:off x="136881" y="179275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4</a:t>
          </a:r>
        </a:p>
      </dsp:txBody>
      <dsp:txXfrm>
        <a:off x="164015" y="1819892"/>
        <a:ext cx="501578" cy="514801"/>
      </dsp:txXfrm>
    </dsp:sp>
    <dsp:sp modelId="{DF481026-182D-AB4B-A938-B9E12915351D}">
      <dsp:nvSpPr>
        <dsp:cNvPr id="0" name=""/>
        <dsp:cNvSpPr/>
      </dsp:nvSpPr>
      <dsp:spPr>
        <a:xfrm rot="5400000">
          <a:off x="1202530" y="193738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t boundaries</a:t>
          </a:r>
        </a:p>
      </dsp:txBody>
      <dsp:txXfrm rot="-5400000">
        <a:off x="692728" y="2469412"/>
        <a:ext cx="1452636" cy="410807"/>
      </dsp:txXfrm>
    </dsp:sp>
    <dsp:sp modelId="{4D3677DD-203E-6A46-986E-4A5C658C9303}">
      <dsp:nvSpPr>
        <dsp:cNvPr id="0" name=""/>
        <dsp:cNvSpPr/>
      </dsp:nvSpPr>
      <dsp:spPr>
        <a:xfrm>
          <a:off x="136881" y="239028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5</a:t>
          </a:r>
        </a:p>
      </dsp:txBody>
      <dsp:txXfrm>
        <a:off x="164015" y="2417415"/>
        <a:ext cx="501578" cy="514801"/>
      </dsp:txXfrm>
    </dsp:sp>
    <dsp:sp modelId="{95DA0D8B-BC89-0948-909A-C298332DBD75}">
      <dsp:nvSpPr>
        <dsp:cNvPr id="0" name=""/>
        <dsp:cNvSpPr/>
      </dsp:nvSpPr>
      <dsp:spPr>
        <a:xfrm rot="5400000">
          <a:off x="1202530" y="253490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Recenter on care</a:t>
          </a:r>
        </a:p>
      </dsp:txBody>
      <dsp:txXfrm rot="-5400000">
        <a:off x="692728" y="3066935"/>
        <a:ext cx="1452636" cy="410807"/>
      </dsp:txXfrm>
    </dsp:sp>
    <dsp:sp modelId="{B6C279C8-1B63-3845-ADAB-B82AEFA3D8E4}">
      <dsp:nvSpPr>
        <dsp:cNvPr id="0" name=""/>
        <dsp:cNvSpPr/>
      </dsp:nvSpPr>
      <dsp:spPr>
        <a:xfrm>
          <a:off x="136881" y="298780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6</a:t>
          </a:r>
        </a:p>
      </dsp:txBody>
      <dsp:txXfrm>
        <a:off x="164015" y="3014939"/>
        <a:ext cx="501578" cy="514801"/>
      </dsp:txXfrm>
    </dsp:sp>
    <dsp:sp modelId="{9D2B4FF6-13FB-EF49-977A-31DF5EE58099}">
      <dsp:nvSpPr>
        <dsp:cNvPr id="0" name=""/>
        <dsp:cNvSpPr/>
      </dsp:nvSpPr>
      <dsp:spPr>
        <a:xfrm rot="5400000">
          <a:off x="1202530" y="313243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Give space</a:t>
          </a:r>
        </a:p>
      </dsp:txBody>
      <dsp:txXfrm rot="-5400000">
        <a:off x="692728" y="3664458"/>
        <a:ext cx="1452636" cy="410807"/>
      </dsp:txXfrm>
    </dsp:sp>
    <dsp:sp modelId="{B67BA8B7-08DC-C244-8300-FCD547033DBD}">
      <dsp:nvSpPr>
        <dsp:cNvPr id="0" name=""/>
        <dsp:cNvSpPr/>
      </dsp:nvSpPr>
      <dsp:spPr>
        <a:xfrm>
          <a:off x="136881" y="358532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7</a:t>
          </a:r>
        </a:p>
      </dsp:txBody>
      <dsp:txXfrm>
        <a:off x="164015" y="3612462"/>
        <a:ext cx="501578" cy="514801"/>
      </dsp:txXfrm>
    </dsp:sp>
    <dsp:sp modelId="{8CF3EAF4-8574-9841-9B3E-4FBF8CB57172}">
      <dsp:nvSpPr>
        <dsp:cNvPr id="0" name=""/>
        <dsp:cNvSpPr/>
      </dsp:nvSpPr>
      <dsp:spPr>
        <a:xfrm rot="5400000">
          <a:off x="1202530" y="372995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ek support</a:t>
          </a:r>
        </a:p>
      </dsp:txBody>
      <dsp:txXfrm rot="-5400000">
        <a:off x="692728" y="4261982"/>
        <a:ext cx="1452636" cy="410807"/>
      </dsp:txXfrm>
    </dsp:sp>
    <dsp:sp modelId="{D5D04DA4-D0C2-DE47-8C8C-0B8EFFA304FE}">
      <dsp:nvSpPr>
        <dsp:cNvPr id="0" name=""/>
        <dsp:cNvSpPr/>
      </dsp:nvSpPr>
      <dsp:spPr>
        <a:xfrm>
          <a:off x="136881" y="418285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8</a:t>
          </a:r>
        </a:p>
      </dsp:txBody>
      <dsp:txXfrm>
        <a:off x="164015" y="4209985"/>
        <a:ext cx="501578" cy="514801"/>
      </dsp:txXfrm>
    </dsp:sp>
  </dsp:spTree>
</dsp:drawing>
</file>

<file path=ppt/diagrams/drawing1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1D64796-42C1-6A47-B16B-F23C35A117FF}">
      <dsp:nvSpPr>
        <dsp:cNvPr id="0" name=""/>
        <dsp:cNvSpPr/>
      </dsp:nvSpPr>
      <dsp:spPr>
        <a:xfrm rot="5400000">
          <a:off x="1202530" y="-45270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a:t>Patient stability</a:t>
          </a:r>
          <a:endParaRPr lang="en-US" sz="1300" kern="1200" dirty="0"/>
        </a:p>
      </dsp:txBody>
      <dsp:txXfrm rot="-5400000">
        <a:off x="692728" y="79320"/>
        <a:ext cx="1452636" cy="410807"/>
      </dsp:txXfrm>
    </dsp:sp>
    <dsp:sp modelId="{2F0271A3-745A-A943-B67B-E4069A93AE61}">
      <dsp:nvSpPr>
        <dsp:cNvPr id="0" name=""/>
        <dsp:cNvSpPr/>
      </dsp:nvSpPr>
      <dsp:spPr>
        <a:xfrm>
          <a:off x="136881" y="18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1</a:t>
          </a:r>
        </a:p>
      </dsp:txBody>
      <dsp:txXfrm>
        <a:off x="164015" y="27322"/>
        <a:ext cx="501578" cy="514801"/>
      </dsp:txXfrm>
    </dsp:sp>
    <dsp:sp modelId="{2EB4DD27-0645-2048-89E9-55CE50FE52DA}">
      <dsp:nvSpPr>
        <dsp:cNvPr id="0" name=""/>
        <dsp:cNvSpPr/>
      </dsp:nvSpPr>
      <dsp:spPr>
        <a:xfrm rot="5400000">
          <a:off x="1202530" y="14481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Emotional check</a:t>
          </a:r>
        </a:p>
      </dsp:txBody>
      <dsp:txXfrm rot="-5400000">
        <a:off x="692728" y="676842"/>
        <a:ext cx="1452636" cy="410807"/>
      </dsp:txXfrm>
    </dsp:sp>
    <dsp:sp modelId="{6CEBA26E-9501-3E41-ACBB-39C96B19A924}">
      <dsp:nvSpPr>
        <dsp:cNvPr id="0" name=""/>
        <dsp:cNvSpPr/>
      </dsp:nvSpPr>
      <dsp:spPr>
        <a:xfrm>
          <a:off x="136881" y="59771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2</a:t>
          </a:r>
        </a:p>
      </dsp:txBody>
      <dsp:txXfrm>
        <a:off x="164015" y="624845"/>
        <a:ext cx="501578" cy="514801"/>
      </dsp:txXfrm>
    </dsp:sp>
    <dsp:sp modelId="{5432570E-A980-7C49-B78B-FBD7E95247D6}">
      <dsp:nvSpPr>
        <dsp:cNvPr id="0" name=""/>
        <dsp:cNvSpPr/>
      </dsp:nvSpPr>
      <dsp:spPr>
        <a:xfrm rot="5400000">
          <a:off x="1202530" y="74233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ddress bias</a:t>
          </a:r>
        </a:p>
      </dsp:txBody>
      <dsp:txXfrm rot="-5400000">
        <a:off x="692728" y="1274365"/>
        <a:ext cx="1452636" cy="410807"/>
      </dsp:txXfrm>
    </dsp:sp>
    <dsp:sp modelId="{A3A63788-1227-B240-AFF4-87DA3887717D}">
      <dsp:nvSpPr>
        <dsp:cNvPr id="0" name=""/>
        <dsp:cNvSpPr/>
      </dsp:nvSpPr>
      <dsp:spPr>
        <a:xfrm>
          <a:off x="136881" y="119523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3</a:t>
          </a:r>
        </a:p>
      </dsp:txBody>
      <dsp:txXfrm>
        <a:off x="164015" y="1222369"/>
        <a:ext cx="501578" cy="514801"/>
      </dsp:txXfrm>
    </dsp:sp>
    <dsp:sp modelId="{B11406A9-5BCB-7247-9C38-2B1D2505F2B8}">
      <dsp:nvSpPr>
        <dsp:cNvPr id="0" name=""/>
        <dsp:cNvSpPr/>
      </dsp:nvSpPr>
      <dsp:spPr>
        <a:xfrm rot="5400000">
          <a:off x="1202530" y="133986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team</a:t>
          </a:r>
        </a:p>
      </dsp:txBody>
      <dsp:txXfrm rot="-5400000">
        <a:off x="692728" y="1871888"/>
        <a:ext cx="1452636" cy="410807"/>
      </dsp:txXfrm>
    </dsp:sp>
    <dsp:sp modelId="{F459C834-8503-9C47-9E88-19B5B264D39A}">
      <dsp:nvSpPr>
        <dsp:cNvPr id="0" name=""/>
        <dsp:cNvSpPr/>
      </dsp:nvSpPr>
      <dsp:spPr>
        <a:xfrm>
          <a:off x="136881" y="179275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4</a:t>
          </a:r>
        </a:p>
      </dsp:txBody>
      <dsp:txXfrm>
        <a:off x="164015" y="1819892"/>
        <a:ext cx="501578" cy="514801"/>
      </dsp:txXfrm>
    </dsp:sp>
    <dsp:sp modelId="{DF481026-182D-AB4B-A938-B9E12915351D}">
      <dsp:nvSpPr>
        <dsp:cNvPr id="0" name=""/>
        <dsp:cNvSpPr/>
      </dsp:nvSpPr>
      <dsp:spPr>
        <a:xfrm rot="5400000">
          <a:off x="1202530" y="193738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t boundaries</a:t>
          </a:r>
        </a:p>
      </dsp:txBody>
      <dsp:txXfrm rot="-5400000">
        <a:off x="692728" y="2469412"/>
        <a:ext cx="1452636" cy="410807"/>
      </dsp:txXfrm>
    </dsp:sp>
    <dsp:sp modelId="{4D3677DD-203E-6A46-986E-4A5C658C9303}">
      <dsp:nvSpPr>
        <dsp:cNvPr id="0" name=""/>
        <dsp:cNvSpPr/>
      </dsp:nvSpPr>
      <dsp:spPr>
        <a:xfrm>
          <a:off x="136881" y="239028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5</a:t>
          </a:r>
        </a:p>
      </dsp:txBody>
      <dsp:txXfrm>
        <a:off x="164015" y="2417415"/>
        <a:ext cx="501578" cy="514801"/>
      </dsp:txXfrm>
    </dsp:sp>
    <dsp:sp modelId="{95DA0D8B-BC89-0948-909A-C298332DBD75}">
      <dsp:nvSpPr>
        <dsp:cNvPr id="0" name=""/>
        <dsp:cNvSpPr/>
      </dsp:nvSpPr>
      <dsp:spPr>
        <a:xfrm rot="5400000">
          <a:off x="1202530" y="253490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Recenter on care</a:t>
          </a:r>
        </a:p>
      </dsp:txBody>
      <dsp:txXfrm rot="-5400000">
        <a:off x="692728" y="3066935"/>
        <a:ext cx="1452636" cy="410807"/>
      </dsp:txXfrm>
    </dsp:sp>
    <dsp:sp modelId="{B6C279C8-1B63-3845-ADAB-B82AEFA3D8E4}">
      <dsp:nvSpPr>
        <dsp:cNvPr id="0" name=""/>
        <dsp:cNvSpPr/>
      </dsp:nvSpPr>
      <dsp:spPr>
        <a:xfrm>
          <a:off x="136881" y="298780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6</a:t>
          </a:r>
        </a:p>
      </dsp:txBody>
      <dsp:txXfrm>
        <a:off x="164015" y="3014939"/>
        <a:ext cx="501578" cy="514801"/>
      </dsp:txXfrm>
    </dsp:sp>
    <dsp:sp modelId="{9D2B4FF6-13FB-EF49-977A-31DF5EE58099}">
      <dsp:nvSpPr>
        <dsp:cNvPr id="0" name=""/>
        <dsp:cNvSpPr/>
      </dsp:nvSpPr>
      <dsp:spPr>
        <a:xfrm rot="5400000">
          <a:off x="1202530" y="313243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Give space</a:t>
          </a:r>
        </a:p>
      </dsp:txBody>
      <dsp:txXfrm rot="-5400000">
        <a:off x="692728" y="3664458"/>
        <a:ext cx="1452636" cy="410807"/>
      </dsp:txXfrm>
    </dsp:sp>
    <dsp:sp modelId="{B67BA8B7-08DC-C244-8300-FCD547033DBD}">
      <dsp:nvSpPr>
        <dsp:cNvPr id="0" name=""/>
        <dsp:cNvSpPr/>
      </dsp:nvSpPr>
      <dsp:spPr>
        <a:xfrm>
          <a:off x="136881" y="358532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7</a:t>
          </a:r>
        </a:p>
      </dsp:txBody>
      <dsp:txXfrm>
        <a:off x="164015" y="3612462"/>
        <a:ext cx="501578" cy="514801"/>
      </dsp:txXfrm>
    </dsp:sp>
    <dsp:sp modelId="{8CF3EAF4-8574-9841-9B3E-4FBF8CB57172}">
      <dsp:nvSpPr>
        <dsp:cNvPr id="0" name=""/>
        <dsp:cNvSpPr/>
      </dsp:nvSpPr>
      <dsp:spPr>
        <a:xfrm rot="5400000">
          <a:off x="1202530" y="372995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ek support</a:t>
          </a:r>
        </a:p>
      </dsp:txBody>
      <dsp:txXfrm rot="-5400000">
        <a:off x="692728" y="4261982"/>
        <a:ext cx="1452636" cy="410807"/>
      </dsp:txXfrm>
    </dsp:sp>
    <dsp:sp modelId="{D5D04DA4-D0C2-DE47-8C8C-0B8EFFA304FE}">
      <dsp:nvSpPr>
        <dsp:cNvPr id="0" name=""/>
        <dsp:cNvSpPr/>
      </dsp:nvSpPr>
      <dsp:spPr>
        <a:xfrm>
          <a:off x="136881" y="418285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8</a:t>
          </a:r>
        </a:p>
      </dsp:txBody>
      <dsp:txXfrm>
        <a:off x="164015" y="4209985"/>
        <a:ext cx="501578" cy="514801"/>
      </dsp:txXfrm>
    </dsp:sp>
  </dsp:spTree>
</dsp:drawing>
</file>

<file path=ppt/diagrams/drawing1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1D64796-42C1-6A47-B16B-F23C35A117FF}">
      <dsp:nvSpPr>
        <dsp:cNvPr id="0" name=""/>
        <dsp:cNvSpPr/>
      </dsp:nvSpPr>
      <dsp:spPr>
        <a:xfrm rot="5400000">
          <a:off x="1202530" y="-45270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a:t>Patient stability</a:t>
          </a:r>
          <a:endParaRPr lang="en-US" sz="1300" kern="1200" dirty="0"/>
        </a:p>
      </dsp:txBody>
      <dsp:txXfrm rot="-5400000">
        <a:off x="692728" y="79320"/>
        <a:ext cx="1452636" cy="410807"/>
      </dsp:txXfrm>
    </dsp:sp>
    <dsp:sp modelId="{2F0271A3-745A-A943-B67B-E4069A93AE61}">
      <dsp:nvSpPr>
        <dsp:cNvPr id="0" name=""/>
        <dsp:cNvSpPr/>
      </dsp:nvSpPr>
      <dsp:spPr>
        <a:xfrm>
          <a:off x="136881" y="18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1</a:t>
          </a:r>
        </a:p>
      </dsp:txBody>
      <dsp:txXfrm>
        <a:off x="164015" y="27322"/>
        <a:ext cx="501578" cy="514801"/>
      </dsp:txXfrm>
    </dsp:sp>
    <dsp:sp modelId="{2EB4DD27-0645-2048-89E9-55CE50FE52DA}">
      <dsp:nvSpPr>
        <dsp:cNvPr id="0" name=""/>
        <dsp:cNvSpPr/>
      </dsp:nvSpPr>
      <dsp:spPr>
        <a:xfrm rot="5400000">
          <a:off x="1202530" y="14481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Emotional check</a:t>
          </a:r>
        </a:p>
      </dsp:txBody>
      <dsp:txXfrm rot="-5400000">
        <a:off x="692728" y="676842"/>
        <a:ext cx="1452636" cy="410807"/>
      </dsp:txXfrm>
    </dsp:sp>
    <dsp:sp modelId="{6CEBA26E-9501-3E41-ACBB-39C96B19A924}">
      <dsp:nvSpPr>
        <dsp:cNvPr id="0" name=""/>
        <dsp:cNvSpPr/>
      </dsp:nvSpPr>
      <dsp:spPr>
        <a:xfrm>
          <a:off x="136881" y="59771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2</a:t>
          </a:r>
        </a:p>
      </dsp:txBody>
      <dsp:txXfrm>
        <a:off x="164015" y="624845"/>
        <a:ext cx="501578" cy="514801"/>
      </dsp:txXfrm>
    </dsp:sp>
    <dsp:sp modelId="{5432570E-A980-7C49-B78B-FBD7E95247D6}">
      <dsp:nvSpPr>
        <dsp:cNvPr id="0" name=""/>
        <dsp:cNvSpPr/>
      </dsp:nvSpPr>
      <dsp:spPr>
        <a:xfrm rot="5400000">
          <a:off x="1202530" y="74233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ddress bias</a:t>
          </a:r>
        </a:p>
      </dsp:txBody>
      <dsp:txXfrm rot="-5400000">
        <a:off x="692728" y="1274365"/>
        <a:ext cx="1452636" cy="410807"/>
      </dsp:txXfrm>
    </dsp:sp>
    <dsp:sp modelId="{A3A63788-1227-B240-AFF4-87DA3887717D}">
      <dsp:nvSpPr>
        <dsp:cNvPr id="0" name=""/>
        <dsp:cNvSpPr/>
      </dsp:nvSpPr>
      <dsp:spPr>
        <a:xfrm>
          <a:off x="136881" y="119523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3</a:t>
          </a:r>
        </a:p>
      </dsp:txBody>
      <dsp:txXfrm>
        <a:off x="164015" y="1222369"/>
        <a:ext cx="501578" cy="514801"/>
      </dsp:txXfrm>
    </dsp:sp>
    <dsp:sp modelId="{B11406A9-5BCB-7247-9C38-2B1D2505F2B8}">
      <dsp:nvSpPr>
        <dsp:cNvPr id="0" name=""/>
        <dsp:cNvSpPr/>
      </dsp:nvSpPr>
      <dsp:spPr>
        <a:xfrm rot="5400000">
          <a:off x="1202530" y="133986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team</a:t>
          </a:r>
        </a:p>
      </dsp:txBody>
      <dsp:txXfrm rot="-5400000">
        <a:off x="692728" y="1871888"/>
        <a:ext cx="1452636" cy="410807"/>
      </dsp:txXfrm>
    </dsp:sp>
    <dsp:sp modelId="{F459C834-8503-9C47-9E88-19B5B264D39A}">
      <dsp:nvSpPr>
        <dsp:cNvPr id="0" name=""/>
        <dsp:cNvSpPr/>
      </dsp:nvSpPr>
      <dsp:spPr>
        <a:xfrm>
          <a:off x="136881" y="179275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4</a:t>
          </a:r>
        </a:p>
      </dsp:txBody>
      <dsp:txXfrm>
        <a:off x="164015" y="1819892"/>
        <a:ext cx="501578" cy="514801"/>
      </dsp:txXfrm>
    </dsp:sp>
    <dsp:sp modelId="{DF481026-182D-AB4B-A938-B9E12915351D}">
      <dsp:nvSpPr>
        <dsp:cNvPr id="0" name=""/>
        <dsp:cNvSpPr/>
      </dsp:nvSpPr>
      <dsp:spPr>
        <a:xfrm rot="5400000">
          <a:off x="1202530" y="193738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t boundaries</a:t>
          </a:r>
        </a:p>
      </dsp:txBody>
      <dsp:txXfrm rot="-5400000">
        <a:off x="692728" y="2469412"/>
        <a:ext cx="1452636" cy="410807"/>
      </dsp:txXfrm>
    </dsp:sp>
    <dsp:sp modelId="{4D3677DD-203E-6A46-986E-4A5C658C9303}">
      <dsp:nvSpPr>
        <dsp:cNvPr id="0" name=""/>
        <dsp:cNvSpPr/>
      </dsp:nvSpPr>
      <dsp:spPr>
        <a:xfrm>
          <a:off x="136881" y="239028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5</a:t>
          </a:r>
        </a:p>
      </dsp:txBody>
      <dsp:txXfrm>
        <a:off x="164015" y="2417415"/>
        <a:ext cx="501578" cy="514801"/>
      </dsp:txXfrm>
    </dsp:sp>
    <dsp:sp modelId="{95DA0D8B-BC89-0948-909A-C298332DBD75}">
      <dsp:nvSpPr>
        <dsp:cNvPr id="0" name=""/>
        <dsp:cNvSpPr/>
      </dsp:nvSpPr>
      <dsp:spPr>
        <a:xfrm rot="5400000">
          <a:off x="1202530" y="253490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Recenter on care</a:t>
          </a:r>
        </a:p>
      </dsp:txBody>
      <dsp:txXfrm rot="-5400000">
        <a:off x="692728" y="3066935"/>
        <a:ext cx="1452636" cy="410807"/>
      </dsp:txXfrm>
    </dsp:sp>
    <dsp:sp modelId="{B6C279C8-1B63-3845-ADAB-B82AEFA3D8E4}">
      <dsp:nvSpPr>
        <dsp:cNvPr id="0" name=""/>
        <dsp:cNvSpPr/>
      </dsp:nvSpPr>
      <dsp:spPr>
        <a:xfrm>
          <a:off x="136881" y="298780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6</a:t>
          </a:r>
        </a:p>
      </dsp:txBody>
      <dsp:txXfrm>
        <a:off x="164015" y="3014939"/>
        <a:ext cx="501578" cy="514801"/>
      </dsp:txXfrm>
    </dsp:sp>
    <dsp:sp modelId="{9D2B4FF6-13FB-EF49-977A-31DF5EE58099}">
      <dsp:nvSpPr>
        <dsp:cNvPr id="0" name=""/>
        <dsp:cNvSpPr/>
      </dsp:nvSpPr>
      <dsp:spPr>
        <a:xfrm rot="5400000">
          <a:off x="1202530" y="313243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Give space</a:t>
          </a:r>
        </a:p>
      </dsp:txBody>
      <dsp:txXfrm rot="-5400000">
        <a:off x="692728" y="3664458"/>
        <a:ext cx="1452636" cy="410807"/>
      </dsp:txXfrm>
    </dsp:sp>
    <dsp:sp modelId="{B67BA8B7-08DC-C244-8300-FCD547033DBD}">
      <dsp:nvSpPr>
        <dsp:cNvPr id="0" name=""/>
        <dsp:cNvSpPr/>
      </dsp:nvSpPr>
      <dsp:spPr>
        <a:xfrm>
          <a:off x="136881" y="358532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7</a:t>
          </a:r>
        </a:p>
      </dsp:txBody>
      <dsp:txXfrm>
        <a:off x="164015" y="3612462"/>
        <a:ext cx="501578" cy="514801"/>
      </dsp:txXfrm>
    </dsp:sp>
    <dsp:sp modelId="{8CF3EAF4-8574-9841-9B3E-4FBF8CB57172}">
      <dsp:nvSpPr>
        <dsp:cNvPr id="0" name=""/>
        <dsp:cNvSpPr/>
      </dsp:nvSpPr>
      <dsp:spPr>
        <a:xfrm rot="5400000">
          <a:off x="1202530" y="372995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ek support</a:t>
          </a:r>
        </a:p>
      </dsp:txBody>
      <dsp:txXfrm rot="-5400000">
        <a:off x="692728" y="4261982"/>
        <a:ext cx="1452636" cy="410807"/>
      </dsp:txXfrm>
    </dsp:sp>
    <dsp:sp modelId="{D5D04DA4-D0C2-DE47-8C8C-0B8EFFA304FE}">
      <dsp:nvSpPr>
        <dsp:cNvPr id="0" name=""/>
        <dsp:cNvSpPr/>
      </dsp:nvSpPr>
      <dsp:spPr>
        <a:xfrm>
          <a:off x="136881" y="418285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8</a:t>
          </a:r>
        </a:p>
      </dsp:txBody>
      <dsp:txXfrm>
        <a:off x="164015" y="4209985"/>
        <a:ext cx="501578" cy="514801"/>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1D64796-42C1-6A47-B16B-F23C35A117FF}">
      <dsp:nvSpPr>
        <dsp:cNvPr id="0" name=""/>
        <dsp:cNvSpPr/>
      </dsp:nvSpPr>
      <dsp:spPr>
        <a:xfrm rot="5400000">
          <a:off x="1202530" y="-45270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a:t>Patient stability</a:t>
          </a:r>
          <a:endParaRPr lang="en-US" sz="1300" kern="1200" dirty="0"/>
        </a:p>
      </dsp:txBody>
      <dsp:txXfrm rot="-5400000">
        <a:off x="692728" y="79320"/>
        <a:ext cx="1452636" cy="410807"/>
      </dsp:txXfrm>
    </dsp:sp>
    <dsp:sp modelId="{2F0271A3-745A-A943-B67B-E4069A93AE61}">
      <dsp:nvSpPr>
        <dsp:cNvPr id="0" name=""/>
        <dsp:cNvSpPr/>
      </dsp:nvSpPr>
      <dsp:spPr>
        <a:xfrm>
          <a:off x="136881" y="18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1</a:t>
          </a:r>
        </a:p>
      </dsp:txBody>
      <dsp:txXfrm>
        <a:off x="164015" y="27322"/>
        <a:ext cx="501578" cy="514801"/>
      </dsp:txXfrm>
    </dsp:sp>
    <dsp:sp modelId="{2EB4DD27-0645-2048-89E9-55CE50FE52DA}">
      <dsp:nvSpPr>
        <dsp:cNvPr id="0" name=""/>
        <dsp:cNvSpPr/>
      </dsp:nvSpPr>
      <dsp:spPr>
        <a:xfrm rot="5400000">
          <a:off x="1202530" y="14481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Emotional check</a:t>
          </a:r>
        </a:p>
      </dsp:txBody>
      <dsp:txXfrm rot="-5400000">
        <a:off x="692728" y="676842"/>
        <a:ext cx="1452636" cy="410807"/>
      </dsp:txXfrm>
    </dsp:sp>
    <dsp:sp modelId="{6CEBA26E-9501-3E41-ACBB-39C96B19A924}">
      <dsp:nvSpPr>
        <dsp:cNvPr id="0" name=""/>
        <dsp:cNvSpPr/>
      </dsp:nvSpPr>
      <dsp:spPr>
        <a:xfrm>
          <a:off x="136881" y="59771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2</a:t>
          </a:r>
        </a:p>
      </dsp:txBody>
      <dsp:txXfrm>
        <a:off x="164015" y="624845"/>
        <a:ext cx="501578" cy="514801"/>
      </dsp:txXfrm>
    </dsp:sp>
    <dsp:sp modelId="{5432570E-A980-7C49-B78B-FBD7E95247D6}">
      <dsp:nvSpPr>
        <dsp:cNvPr id="0" name=""/>
        <dsp:cNvSpPr/>
      </dsp:nvSpPr>
      <dsp:spPr>
        <a:xfrm rot="5400000">
          <a:off x="1202530" y="74233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ddress bias</a:t>
          </a:r>
        </a:p>
      </dsp:txBody>
      <dsp:txXfrm rot="-5400000">
        <a:off x="692728" y="1274365"/>
        <a:ext cx="1452636" cy="410807"/>
      </dsp:txXfrm>
    </dsp:sp>
    <dsp:sp modelId="{A3A63788-1227-B240-AFF4-87DA3887717D}">
      <dsp:nvSpPr>
        <dsp:cNvPr id="0" name=""/>
        <dsp:cNvSpPr/>
      </dsp:nvSpPr>
      <dsp:spPr>
        <a:xfrm>
          <a:off x="136881" y="119523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3</a:t>
          </a:r>
        </a:p>
      </dsp:txBody>
      <dsp:txXfrm>
        <a:off x="164015" y="1222369"/>
        <a:ext cx="501578" cy="514801"/>
      </dsp:txXfrm>
    </dsp:sp>
    <dsp:sp modelId="{B11406A9-5BCB-7247-9C38-2B1D2505F2B8}">
      <dsp:nvSpPr>
        <dsp:cNvPr id="0" name=""/>
        <dsp:cNvSpPr/>
      </dsp:nvSpPr>
      <dsp:spPr>
        <a:xfrm rot="5400000">
          <a:off x="1202530" y="133986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patient</a:t>
          </a:r>
        </a:p>
      </dsp:txBody>
      <dsp:txXfrm rot="-5400000">
        <a:off x="692728" y="1871888"/>
        <a:ext cx="1452636" cy="410807"/>
      </dsp:txXfrm>
    </dsp:sp>
    <dsp:sp modelId="{F459C834-8503-9C47-9E88-19B5B264D39A}">
      <dsp:nvSpPr>
        <dsp:cNvPr id="0" name=""/>
        <dsp:cNvSpPr/>
      </dsp:nvSpPr>
      <dsp:spPr>
        <a:xfrm>
          <a:off x="136881" y="179275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4</a:t>
          </a:r>
        </a:p>
      </dsp:txBody>
      <dsp:txXfrm>
        <a:off x="164015" y="1819892"/>
        <a:ext cx="501578" cy="514801"/>
      </dsp:txXfrm>
    </dsp:sp>
    <dsp:sp modelId="{DF481026-182D-AB4B-A938-B9E12915351D}">
      <dsp:nvSpPr>
        <dsp:cNvPr id="0" name=""/>
        <dsp:cNvSpPr/>
      </dsp:nvSpPr>
      <dsp:spPr>
        <a:xfrm rot="5400000">
          <a:off x="1202530" y="193738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team</a:t>
          </a:r>
        </a:p>
      </dsp:txBody>
      <dsp:txXfrm rot="-5400000">
        <a:off x="692728" y="2469412"/>
        <a:ext cx="1452636" cy="410807"/>
      </dsp:txXfrm>
    </dsp:sp>
    <dsp:sp modelId="{4D3677DD-203E-6A46-986E-4A5C658C9303}">
      <dsp:nvSpPr>
        <dsp:cNvPr id="0" name=""/>
        <dsp:cNvSpPr/>
      </dsp:nvSpPr>
      <dsp:spPr>
        <a:xfrm>
          <a:off x="136881" y="239028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5</a:t>
          </a:r>
        </a:p>
      </dsp:txBody>
      <dsp:txXfrm>
        <a:off x="164015" y="2417415"/>
        <a:ext cx="501578" cy="514801"/>
      </dsp:txXfrm>
    </dsp:sp>
    <dsp:sp modelId="{95DA0D8B-BC89-0948-909A-C298332DBD75}">
      <dsp:nvSpPr>
        <dsp:cNvPr id="0" name=""/>
        <dsp:cNvSpPr/>
      </dsp:nvSpPr>
      <dsp:spPr>
        <a:xfrm rot="5400000">
          <a:off x="1202530" y="253490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t boundaries</a:t>
          </a:r>
        </a:p>
      </dsp:txBody>
      <dsp:txXfrm rot="-5400000">
        <a:off x="692728" y="3066935"/>
        <a:ext cx="1452636" cy="410807"/>
      </dsp:txXfrm>
    </dsp:sp>
    <dsp:sp modelId="{B6C279C8-1B63-3845-ADAB-B82AEFA3D8E4}">
      <dsp:nvSpPr>
        <dsp:cNvPr id="0" name=""/>
        <dsp:cNvSpPr/>
      </dsp:nvSpPr>
      <dsp:spPr>
        <a:xfrm>
          <a:off x="136881" y="298780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6</a:t>
          </a:r>
        </a:p>
      </dsp:txBody>
      <dsp:txXfrm>
        <a:off x="164015" y="3014939"/>
        <a:ext cx="501578" cy="514801"/>
      </dsp:txXfrm>
    </dsp:sp>
    <dsp:sp modelId="{9D2B4FF6-13FB-EF49-977A-31DF5EE58099}">
      <dsp:nvSpPr>
        <dsp:cNvPr id="0" name=""/>
        <dsp:cNvSpPr/>
      </dsp:nvSpPr>
      <dsp:spPr>
        <a:xfrm rot="5400000">
          <a:off x="1202530" y="313243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Give space</a:t>
          </a:r>
        </a:p>
      </dsp:txBody>
      <dsp:txXfrm rot="-5400000">
        <a:off x="692728" y="3664458"/>
        <a:ext cx="1452636" cy="410807"/>
      </dsp:txXfrm>
    </dsp:sp>
    <dsp:sp modelId="{B67BA8B7-08DC-C244-8300-FCD547033DBD}">
      <dsp:nvSpPr>
        <dsp:cNvPr id="0" name=""/>
        <dsp:cNvSpPr/>
      </dsp:nvSpPr>
      <dsp:spPr>
        <a:xfrm>
          <a:off x="136881" y="358532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7</a:t>
          </a:r>
        </a:p>
      </dsp:txBody>
      <dsp:txXfrm>
        <a:off x="164015" y="3612462"/>
        <a:ext cx="501578" cy="514801"/>
      </dsp:txXfrm>
    </dsp:sp>
    <dsp:sp modelId="{8CF3EAF4-8574-9841-9B3E-4FBF8CB57172}">
      <dsp:nvSpPr>
        <dsp:cNvPr id="0" name=""/>
        <dsp:cNvSpPr/>
      </dsp:nvSpPr>
      <dsp:spPr>
        <a:xfrm rot="5400000">
          <a:off x="1202530" y="372995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ek support</a:t>
          </a:r>
        </a:p>
      </dsp:txBody>
      <dsp:txXfrm rot="-5400000">
        <a:off x="692728" y="4261982"/>
        <a:ext cx="1452636" cy="410807"/>
      </dsp:txXfrm>
    </dsp:sp>
    <dsp:sp modelId="{D5D04DA4-D0C2-DE47-8C8C-0B8EFFA304FE}">
      <dsp:nvSpPr>
        <dsp:cNvPr id="0" name=""/>
        <dsp:cNvSpPr/>
      </dsp:nvSpPr>
      <dsp:spPr>
        <a:xfrm>
          <a:off x="136881" y="418285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8</a:t>
          </a:r>
        </a:p>
      </dsp:txBody>
      <dsp:txXfrm>
        <a:off x="164015" y="4209985"/>
        <a:ext cx="501578" cy="514801"/>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9CDD79B-5F7C-524F-AFDA-B8B9EDF45DDA}">
      <dsp:nvSpPr>
        <dsp:cNvPr id="0" name=""/>
        <dsp:cNvSpPr/>
      </dsp:nvSpPr>
      <dsp:spPr>
        <a:xfrm>
          <a:off x="5192346" y="796984"/>
          <a:ext cx="1660449" cy="790222"/>
        </a:xfrm>
        <a:custGeom>
          <a:avLst/>
          <a:gdLst/>
          <a:ahLst/>
          <a:cxnLst/>
          <a:rect l="0" t="0" r="0" b="0"/>
          <a:pathLst>
            <a:path>
              <a:moveTo>
                <a:pt x="0" y="0"/>
              </a:moveTo>
              <a:lnTo>
                <a:pt x="0" y="538513"/>
              </a:lnTo>
              <a:lnTo>
                <a:pt x="1660449" y="538513"/>
              </a:lnTo>
              <a:lnTo>
                <a:pt x="1660449" y="790222"/>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3033233B-3142-7141-A450-F85AAA8AC8F2}">
      <dsp:nvSpPr>
        <dsp:cNvPr id="0" name=""/>
        <dsp:cNvSpPr/>
      </dsp:nvSpPr>
      <dsp:spPr>
        <a:xfrm>
          <a:off x="3531897" y="2381354"/>
          <a:ext cx="1660449" cy="790222"/>
        </a:xfrm>
        <a:custGeom>
          <a:avLst/>
          <a:gdLst/>
          <a:ahLst/>
          <a:cxnLst/>
          <a:rect l="0" t="0" r="0" b="0"/>
          <a:pathLst>
            <a:path>
              <a:moveTo>
                <a:pt x="0" y="0"/>
              </a:moveTo>
              <a:lnTo>
                <a:pt x="0" y="538513"/>
              </a:lnTo>
              <a:lnTo>
                <a:pt x="1660449" y="538513"/>
              </a:lnTo>
              <a:lnTo>
                <a:pt x="1660449" y="790222"/>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9D58F763-DC5B-4449-9D55-E52EFAB978AC}">
      <dsp:nvSpPr>
        <dsp:cNvPr id="0" name=""/>
        <dsp:cNvSpPr/>
      </dsp:nvSpPr>
      <dsp:spPr>
        <a:xfrm>
          <a:off x="1871448" y="2381354"/>
          <a:ext cx="1660449" cy="790222"/>
        </a:xfrm>
        <a:custGeom>
          <a:avLst/>
          <a:gdLst/>
          <a:ahLst/>
          <a:cxnLst/>
          <a:rect l="0" t="0" r="0" b="0"/>
          <a:pathLst>
            <a:path>
              <a:moveTo>
                <a:pt x="1660449" y="0"/>
              </a:moveTo>
              <a:lnTo>
                <a:pt x="1660449" y="538513"/>
              </a:lnTo>
              <a:lnTo>
                <a:pt x="0" y="538513"/>
              </a:lnTo>
              <a:lnTo>
                <a:pt x="0" y="790222"/>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D39A8AD1-7CE3-C34F-B134-0CE95B3FFC60}">
      <dsp:nvSpPr>
        <dsp:cNvPr id="0" name=""/>
        <dsp:cNvSpPr/>
      </dsp:nvSpPr>
      <dsp:spPr>
        <a:xfrm>
          <a:off x="3531897" y="796984"/>
          <a:ext cx="1660449" cy="790222"/>
        </a:xfrm>
        <a:custGeom>
          <a:avLst/>
          <a:gdLst/>
          <a:ahLst/>
          <a:cxnLst/>
          <a:rect l="0" t="0" r="0" b="0"/>
          <a:pathLst>
            <a:path>
              <a:moveTo>
                <a:pt x="1660449" y="0"/>
              </a:moveTo>
              <a:lnTo>
                <a:pt x="1660449" y="538513"/>
              </a:lnTo>
              <a:lnTo>
                <a:pt x="0" y="538513"/>
              </a:lnTo>
              <a:lnTo>
                <a:pt x="0" y="790222"/>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8052D55D-B261-7642-8B61-F8E9E779D0FA}">
      <dsp:nvSpPr>
        <dsp:cNvPr id="0" name=""/>
        <dsp:cNvSpPr/>
      </dsp:nvSpPr>
      <dsp:spPr>
        <a:xfrm>
          <a:off x="3833797" y="2836"/>
          <a:ext cx="2717098" cy="794147"/>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D2B5DB64-631D-B24D-9ED7-813FE7B29263}">
      <dsp:nvSpPr>
        <dsp:cNvPr id="0" name=""/>
        <dsp:cNvSpPr/>
      </dsp:nvSpPr>
      <dsp:spPr>
        <a:xfrm>
          <a:off x="4135697" y="289641"/>
          <a:ext cx="2717098" cy="794147"/>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Is your patient stable?</a:t>
          </a:r>
        </a:p>
      </dsp:txBody>
      <dsp:txXfrm>
        <a:off x="4158957" y="312901"/>
        <a:ext cx="2670578" cy="747627"/>
      </dsp:txXfrm>
    </dsp:sp>
    <dsp:sp modelId="{2537D348-0A60-F64D-A40A-7A3C9A6F3688}">
      <dsp:nvSpPr>
        <dsp:cNvPr id="0" name=""/>
        <dsp:cNvSpPr/>
      </dsp:nvSpPr>
      <dsp:spPr>
        <a:xfrm>
          <a:off x="2173348" y="1587207"/>
          <a:ext cx="2717098" cy="794147"/>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EF3C079A-5D7F-5246-A7DB-73AB70CC18BF}">
      <dsp:nvSpPr>
        <dsp:cNvPr id="0" name=""/>
        <dsp:cNvSpPr/>
      </dsp:nvSpPr>
      <dsp:spPr>
        <a:xfrm>
          <a:off x="2475248" y="1874012"/>
          <a:ext cx="2717098" cy="794147"/>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Is your patient altered?</a:t>
          </a:r>
        </a:p>
      </dsp:txBody>
      <dsp:txXfrm>
        <a:off x="2498508" y="1897272"/>
        <a:ext cx="2670578" cy="747627"/>
      </dsp:txXfrm>
    </dsp:sp>
    <dsp:sp modelId="{C79C7631-E591-5C40-ADA0-BFFED70AD127}">
      <dsp:nvSpPr>
        <dsp:cNvPr id="0" name=""/>
        <dsp:cNvSpPr/>
      </dsp:nvSpPr>
      <dsp:spPr>
        <a:xfrm>
          <a:off x="512899" y="3171577"/>
          <a:ext cx="2717098" cy="794147"/>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AD4EBA35-6F4A-E041-B6B1-E9A60439915E}">
      <dsp:nvSpPr>
        <dsp:cNvPr id="0" name=""/>
        <dsp:cNvSpPr/>
      </dsp:nvSpPr>
      <dsp:spPr>
        <a:xfrm>
          <a:off x="814799" y="3458382"/>
          <a:ext cx="2717098" cy="794147"/>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Proceed with the toolkit</a:t>
          </a:r>
        </a:p>
      </dsp:txBody>
      <dsp:txXfrm>
        <a:off x="838059" y="3481642"/>
        <a:ext cx="2670578" cy="747627"/>
      </dsp:txXfrm>
    </dsp:sp>
    <dsp:sp modelId="{5D8B4A0C-9602-5440-B473-8EE1143E33EF}">
      <dsp:nvSpPr>
        <dsp:cNvPr id="0" name=""/>
        <dsp:cNvSpPr/>
      </dsp:nvSpPr>
      <dsp:spPr>
        <a:xfrm>
          <a:off x="3833797" y="3171577"/>
          <a:ext cx="2717098" cy="794147"/>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04D342C-A759-3745-AA61-7E9DFE12CA7B}">
      <dsp:nvSpPr>
        <dsp:cNvPr id="0" name=""/>
        <dsp:cNvSpPr/>
      </dsp:nvSpPr>
      <dsp:spPr>
        <a:xfrm>
          <a:off x="4135697" y="3458382"/>
          <a:ext cx="2717098" cy="794147"/>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Consider redirection &amp; lean on debriefs</a:t>
          </a:r>
        </a:p>
      </dsp:txBody>
      <dsp:txXfrm>
        <a:off x="4158957" y="3481642"/>
        <a:ext cx="2670578" cy="747627"/>
      </dsp:txXfrm>
    </dsp:sp>
    <dsp:sp modelId="{93F31CF9-F237-5443-8BAB-D74798F1326D}">
      <dsp:nvSpPr>
        <dsp:cNvPr id="0" name=""/>
        <dsp:cNvSpPr/>
      </dsp:nvSpPr>
      <dsp:spPr>
        <a:xfrm>
          <a:off x="5494246" y="1587207"/>
          <a:ext cx="2717098" cy="794147"/>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252EE175-1C23-734D-90A4-182E0CC8C50C}">
      <dsp:nvSpPr>
        <dsp:cNvPr id="0" name=""/>
        <dsp:cNvSpPr/>
      </dsp:nvSpPr>
      <dsp:spPr>
        <a:xfrm>
          <a:off x="5796146" y="1874012"/>
          <a:ext cx="2717098" cy="794147"/>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Call for help</a:t>
          </a:r>
        </a:p>
      </dsp:txBody>
      <dsp:txXfrm>
        <a:off x="5819406" y="1897272"/>
        <a:ext cx="2670578" cy="747627"/>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1D64796-42C1-6A47-B16B-F23C35A117FF}">
      <dsp:nvSpPr>
        <dsp:cNvPr id="0" name=""/>
        <dsp:cNvSpPr/>
      </dsp:nvSpPr>
      <dsp:spPr>
        <a:xfrm rot="5400000">
          <a:off x="1202530" y="-45270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a:t>Patient stability</a:t>
          </a:r>
          <a:endParaRPr lang="en-US" sz="1300" kern="1200" dirty="0"/>
        </a:p>
      </dsp:txBody>
      <dsp:txXfrm rot="-5400000">
        <a:off x="692728" y="79320"/>
        <a:ext cx="1452636" cy="410807"/>
      </dsp:txXfrm>
    </dsp:sp>
    <dsp:sp modelId="{2F0271A3-745A-A943-B67B-E4069A93AE61}">
      <dsp:nvSpPr>
        <dsp:cNvPr id="0" name=""/>
        <dsp:cNvSpPr/>
      </dsp:nvSpPr>
      <dsp:spPr>
        <a:xfrm>
          <a:off x="136881" y="18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1</a:t>
          </a:r>
        </a:p>
      </dsp:txBody>
      <dsp:txXfrm>
        <a:off x="164015" y="27322"/>
        <a:ext cx="501578" cy="514801"/>
      </dsp:txXfrm>
    </dsp:sp>
    <dsp:sp modelId="{2EB4DD27-0645-2048-89E9-55CE50FE52DA}">
      <dsp:nvSpPr>
        <dsp:cNvPr id="0" name=""/>
        <dsp:cNvSpPr/>
      </dsp:nvSpPr>
      <dsp:spPr>
        <a:xfrm rot="5400000">
          <a:off x="1202530" y="14481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Emotional check</a:t>
          </a:r>
        </a:p>
      </dsp:txBody>
      <dsp:txXfrm rot="-5400000">
        <a:off x="692728" y="676842"/>
        <a:ext cx="1452636" cy="410807"/>
      </dsp:txXfrm>
    </dsp:sp>
    <dsp:sp modelId="{6CEBA26E-9501-3E41-ACBB-39C96B19A924}">
      <dsp:nvSpPr>
        <dsp:cNvPr id="0" name=""/>
        <dsp:cNvSpPr/>
      </dsp:nvSpPr>
      <dsp:spPr>
        <a:xfrm>
          <a:off x="136881" y="59771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2</a:t>
          </a:r>
        </a:p>
      </dsp:txBody>
      <dsp:txXfrm>
        <a:off x="164015" y="624845"/>
        <a:ext cx="501578" cy="514801"/>
      </dsp:txXfrm>
    </dsp:sp>
    <dsp:sp modelId="{5432570E-A980-7C49-B78B-FBD7E95247D6}">
      <dsp:nvSpPr>
        <dsp:cNvPr id="0" name=""/>
        <dsp:cNvSpPr/>
      </dsp:nvSpPr>
      <dsp:spPr>
        <a:xfrm rot="5400000">
          <a:off x="1202530" y="74233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ddress bias</a:t>
          </a:r>
        </a:p>
      </dsp:txBody>
      <dsp:txXfrm rot="-5400000">
        <a:off x="692728" y="1274365"/>
        <a:ext cx="1452636" cy="410807"/>
      </dsp:txXfrm>
    </dsp:sp>
    <dsp:sp modelId="{A3A63788-1227-B240-AFF4-87DA3887717D}">
      <dsp:nvSpPr>
        <dsp:cNvPr id="0" name=""/>
        <dsp:cNvSpPr/>
      </dsp:nvSpPr>
      <dsp:spPr>
        <a:xfrm>
          <a:off x="136881" y="119523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3</a:t>
          </a:r>
        </a:p>
      </dsp:txBody>
      <dsp:txXfrm>
        <a:off x="164015" y="1222369"/>
        <a:ext cx="501578" cy="514801"/>
      </dsp:txXfrm>
    </dsp:sp>
    <dsp:sp modelId="{B11406A9-5BCB-7247-9C38-2B1D2505F2B8}">
      <dsp:nvSpPr>
        <dsp:cNvPr id="0" name=""/>
        <dsp:cNvSpPr/>
      </dsp:nvSpPr>
      <dsp:spPr>
        <a:xfrm rot="5400000">
          <a:off x="1202530" y="133986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patient</a:t>
          </a:r>
        </a:p>
      </dsp:txBody>
      <dsp:txXfrm rot="-5400000">
        <a:off x="692728" y="1871888"/>
        <a:ext cx="1452636" cy="410807"/>
      </dsp:txXfrm>
    </dsp:sp>
    <dsp:sp modelId="{F459C834-8503-9C47-9E88-19B5B264D39A}">
      <dsp:nvSpPr>
        <dsp:cNvPr id="0" name=""/>
        <dsp:cNvSpPr/>
      </dsp:nvSpPr>
      <dsp:spPr>
        <a:xfrm>
          <a:off x="136881" y="179275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4</a:t>
          </a:r>
        </a:p>
      </dsp:txBody>
      <dsp:txXfrm>
        <a:off x="164015" y="1819892"/>
        <a:ext cx="501578" cy="514801"/>
      </dsp:txXfrm>
    </dsp:sp>
    <dsp:sp modelId="{DF481026-182D-AB4B-A938-B9E12915351D}">
      <dsp:nvSpPr>
        <dsp:cNvPr id="0" name=""/>
        <dsp:cNvSpPr/>
      </dsp:nvSpPr>
      <dsp:spPr>
        <a:xfrm rot="5400000">
          <a:off x="1202530" y="193738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team</a:t>
          </a:r>
        </a:p>
      </dsp:txBody>
      <dsp:txXfrm rot="-5400000">
        <a:off x="692728" y="2469412"/>
        <a:ext cx="1452636" cy="410807"/>
      </dsp:txXfrm>
    </dsp:sp>
    <dsp:sp modelId="{4D3677DD-203E-6A46-986E-4A5C658C9303}">
      <dsp:nvSpPr>
        <dsp:cNvPr id="0" name=""/>
        <dsp:cNvSpPr/>
      </dsp:nvSpPr>
      <dsp:spPr>
        <a:xfrm>
          <a:off x="136881" y="239028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5</a:t>
          </a:r>
        </a:p>
      </dsp:txBody>
      <dsp:txXfrm>
        <a:off x="164015" y="2417415"/>
        <a:ext cx="501578" cy="514801"/>
      </dsp:txXfrm>
    </dsp:sp>
    <dsp:sp modelId="{95DA0D8B-BC89-0948-909A-C298332DBD75}">
      <dsp:nvSpPr>
        <dsp:cNvPr id="0" name=""/>
        <dsp:cNvSpPr/>
      </dsp:nvSpPr>
      <dsp:spPr>
        <a:xfrm rot="5400000">
          <a:off x="1202530" y="253490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t boundaries</a:t>
          </a:r>
        </a:p>
      </dsp:txBody>
      <dsp:txXfrm rot="-5400000">
        <a:off x="692728" y="3066935"/>
        <a:ext cx="1452636" cy="410807"/>
      </dsp:txXfrm>
    </dsp:sp>
    <dsp:sp modelId="{B6C279C8-1B63-3845-ADAB-B82AEFA3D8E4}">
      <dsp:nvSpPr>
        <dsp:cNvPr id="0" name=""/>
        <dsp:cNvSpPr/>
      </dsp:nvSpPr>
      <dsp:spPr>
        <a:xfrm>
          <a:off x="136881" y="298780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6</a:t>
          </a:r>
        </a:p>
      </dsp:txBody>
      <dsp:txXfrm>
        <a:off x="164015" y="3014939"/>
        <a:ext cx="501578" cy="514801"/>
      </dsp:txXfrm>
    </dsp:sp>
    <dsp:sp modelId="{9D2B4FF6-13FB-EF49-977A-31DF5EE58099}">
      <dsp:nvSpPr>
        <dsp:cNvPr id="0" name=""/>
        <dsp:cNvSpPr/>
      </dsp:nvSpPr>
      <dsp:spPr>
        <a:xfrm rot="5400000">
          <a:off x="1202530" y="313243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Give space</a:t>
          </a:r>
        </a:p>
      </dsp:txBody>
      <dsp:txXfrm rot="-5400000">
        <a:off x="692728" y="3664458"/>
        <a:ext cx="1452636" cy="410807"/>
      </dsp:txXfrm>
    </dsp:sp>
    <dsp:sp modelId="{B67BA8B7-08DC-C244-8300-FCD547033DBD}">
      <dsp:nvSpPr>
        <dsp:cNvPr id="0" name=""/>
        <dsp:cNvSpPr/>
      </dsp:nvSpPr>
      <dsp:spPr>
        <a:xfrm>
          <a:off x="136881" y="358532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7</a:t>
          </a:r>
        </a:p>
      </dsp:txBody>
      <dsp:txXfrm>
        <a:off x="164015" y="3612462"/>
        <a:ext cx="501578" cy="514801"/>
      </dsp:txXfrm>
    </dsp:sp>
    <dsp:sp modelId="{8CF3EAF4-8574-9841-9B3E-4FBF8CB57172}">
      <dsp:nvSpPr>
        <dsp:cNvPr id="0" name=""/>
        <dsp:cNvSpPr/>
      </dsp:nvSpPr>
      <dsp:spPr>
        <a:xfrm rot="5400000">
          <a:off x="1202530" y="372995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ek support</a:t>
          </a:r>
        </a:p>
      </dsp:txBody>
      <dsp:txXfrm rot="-5400000">
        <a:off x="692728" y="4261982"/>
        <a:ext cx="1452636" cy="410807"/>
      </dsp:txXfrm>
    </dsp:sp>
    <dsp:sp modelId="{D5D04DA4-D0C2-DE47-8C8C-0B8EFFA304FE}">
      <dsp:nvSpPr>
        <dsp:cNvPr id="0" name=""/>
        <dsp:cNvSpPr/>
      </dsp:nvSpPr>
      <dsp:spPr>
        <a:xfrm>
          <a:off x="136881" y="418285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8</a:t>
          </a:r>
        </a:p>
      </dsp:txBody>
      <dsp:txXfrm>
        <a:off x="164015" y="4209985"/>
        <a:ext cx="501578" cy="514801"/>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1D64796-42C1-6A47-B16B-F23C35A117FF}">
      <dsp:nvSpPr>
        <dsp:cNvPr id="0" name=""/>
        <dsp:cNvSpPr/>
      </dsp:nvSpPr>
      <dsp:spPr>
        <a:xfrm rot="5400000">
          <a:off x="1202530" y="-45270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a:t>Patient stability</a:t>
          </a:r>
          <a:endParaRPr lang="en-US" sz="1300" kern="1200" dirty="0"/>
        </a:p>
      </dsp:txBody>
      <dsp:txXfrm rot="-5400000">
        <a:off x="692728" y="79320"/>
        <a:ext cx="1452636" cy="410807"/>
      </dsp:txXfrm>
    </dsp:sp>
    <dsp:sp modelId="{2F0271A3-745A-A943-B67B-E4069A93AE61}">
      <dsp:nvSpPr>
        <dsp:cNvPr id="0" name=""/>
        <dsp:cNvSpPr/>
      </dsp:nvSpPr>
      <dsp:spPr>
        <a:xfrm>
          <a:off x="136881" y="18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1</a:t>
          </a:r>
        </a:p>
      </dsp:txBody>
      <dsp:txXfrm>
        <a:off x="164015" y="27322"/>
        <a:ext cx="501578" cy="514801"/>
      </dsp:txXfrm>
    </dsp:sp>
    <dsp:sp modelId="{2EB4DD27-0645-2048-89E9-55CE50FE52DA}">
      <dsp:nvSpPr>
        <dsp:cNvPr id="0" name=""/>
        <dsp:cNvSpPr/>
      </dsp:nvSpPr>
      <dsp:spPr>
        <a:xfrm rot="5400000">
          <a:off x="1202530" y="14481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Emotional check</a:t>
          </a:r>
        </a:p>
      </dsp:txBody>
      <dsp:txXfrm rot="-5400000">
        <a:off x="692728" y="676842"/>
        <a:ext cx="1452636" cy="410807"/>
      </dsp:txXfrm>
    </dsp:sp>
    <dsp:sp modelId="{6CEBA26E-9501-3E41-ACBB-39C96B19A924}">
      <dsp:nvSpPr>
        <dsp:cNvPr id="0" name=""/>
        <dsp:cNvSpPr/>
      </dsp:nvSpPr>
      <dsp:spPr>
        <a:xfrm>
          <a:off x="136881" y="59771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2</a:t>
          </a:r>
        </a:p>
      </dsp:txBody>
      <dsp:txXfrm>
        <a:off x="164015" y="624845"/>
        <a:ext cx="501578" cy="514801"/>
      </dsp:txXfrm>
    </dsp:sp>
    <dsp:sp modelId="{5432570E-A980-7C49-B78B-FBD7E95247D6}">
      <dsp:nvSpPr>
        <dsp:cNvPr id="0" name=""/>
        <dsp:cNvSpPr/>
      </dsp:nvSpPr>
      <dsp:spPr>
        <a:xfrm rot="5400000">
          <a:off x="1202530" y="74233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ddress bias</a:t>
          </a:r>
        </a:p>
      </dsp:txBody>
      <dsp:txXfrm rot="-5400000">
        <a:off x="692728" y="1274365"/>
        <a:ext cx="1452636" cy="410807"/>
      </dsp:txXfrm>
    </dsp:sp>
    <dsp:sp modelId="{A3A63788-1227-B240-AFF4-87DA3887717D}">
      <dsp:nvSpPr>
        <dsp:cNvPr id="0" name=""/>
        <dsp:cNvSpPr/>
      </dsp:nvSpPr>
      <dsp:spPr>
        <a:xfrm>
          <a:off x="136881" y="119523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3</a:t>
          </a:r>
        </a:p>
      </dsp:txBody>
      <dsp:txXfrm>
        <a:off x="164015" y="1222369"/>
        <a:ext cx="501578" cy="514801"/>
      </dsp:txXfrm>
    </dsp:sp>
    <dsp:sp modelId="{B11406A9-5BCB-7247-9C38-2B1D2505F2B8}">
      <dsp:nvSpPr>
        <dsp:cNvPr id="0" name=""/>
        <dsp:cNvSpPr/>
      </dsp:nvSpPr>
      <dsp:spPr>
        <a:xfrm rot="5400000">
          <a:off x="1202530" y="133986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patient</a:t>
          </a:r>
        </a:p>
      </dsp:txBody>
      <dsp:txXfrm rot="-5400000">
        <a:off x="692728" y="1871888"/>
        <a:ext cx="1452636" cy="410807"/>
      </dsp:txXfrm>
    </dsp:sp>
    <dsp:sp modelId="{F459C834-8503-9C47-9E88-19B5B264D39A}">
      <dsp:nvSpPr>
        <dsp:cNvPr id="0" name=""/>
        <dsp:cNvSpPr/>
      </dsp:nvSpPr>
      <dsp:spPr>
        <a:xfrm>
          <a:off x="136881" y="179275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4</a:t>
          </a:r>
        </a:p>
      </dsp:txBody>
      <dsp:txXfrm>
        <a:off x="164015" y="1819892"/>
        <a:ext cx="501578" cy="514801"/>
      </dsp:txXfrm>
    </dsp:sp>
    <dsp:sp modelId="{DF481026-182D-AB4B-A938-B9E12915351D}">
      <dsp:nvSpPr>
        <dsp:cNvPr id="0" name=""/>
        <dsp:cNvSpPr/>
      </dsp:nvSpPr>
      <dsp:spPr>
        <a:xfrm rot="5400000">
          <a:off x="1202530" y="193738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team</a:t>
          </a:r>
        </a:p>
      </dsp:txBody>
      <dsp:txXfrm rot="-5400000">
        <a:off x="692728" y="2469412"/>
        <a:ext cx="1452636" cy="410807"/>
      </dsp:txXfrm>
    </dsp:sp>
    <dsp:sp modelId="{4D3677DD-203E-6A46-986E-4A5C658C9303}">
      <dsp:nvSpPr>
        <dsp:cNvPr id="0" name=""/>
        <dsp:cNvSpPr/>
      </dsp:nvSpPr>
      <dsp:spPr>
        <a:xfrm>
          <a:off x="136881" y="239028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5</a:t>
          </a:r>
        </a:p>
      </dsp:txBody>
      <dsp:txXfrm>
        <a:off x="164015" y="2417415"/>
        <a:ext cx="501578" cy="514801"/>
      </dsp:txXfrm>
    </dsp:sp>
    <dsp:sp modelId="{95DA0D8B-BC89-0948-909A-C298332DBD75}">
      <dsp:nvSpPr>
        <dsp:cNvPr id="0" name=""/>
        <dsp:cNvSpPr/>
      </dsp:nvSpPr>
      <dsp:spPr>
        <a:xfrm rot="5400000">
          <a:off x="1202530" y="253490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t boundaries</a:t>
          </a:r>
        </a:p>
      </dsp:txBody>
      <dsp:txXfrm rot="-5400000">
        <a:off x="692728" y="3066935"/>
        <a:ext cx="1452636" cy="410807"/>
      </dsp:txXfrm>
    </dsp:sp>
    <dsp:sp modelId="{B6C279C8-1B63-3845-ADAB-B82AEFA3D8E4}">
      <dsp:nvSpPr>
        <dsp:cNvPr id="0" name=""/>
        <dsp:cNvSpPr/>
      </dsp:nvSpPr>
      <dsp:spPr>
        <a:xfrm>
          <a:off x="136881" y="298780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6</a:t>
          </a:r>
        </a:p>
      </dsp:txBody>
      <dsp:txXfrm>
        <a:off x="164015" y="3014939"/>
        <a:ext cx="501578" cy="514801"/>
      </dsp:txXfrm>
    </dsp:sp>
    <dsp:sp modelId="{9D2B4FF6-13FB-EF49-977A-31DF5EE58099}">
      <dsp:nvSpPr>
        <dsp:cNvPr id="0" name=""/>
        <dsp:cNvSpPr/>
      </dsp:nvSpPr>
      <dsp:spPr>
        <a:xfrm rot="5400000">
          <a:off x="1202530" y="313243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Give space</a:t>
          </a:r>
        </a:p>
      </dsp:txBody>
      <dsp:txXfrm rot="-5400000">
        <a:off x="692728" y="3664458"/>
        <a:ext cx="1452636" cy="410807"/>
      </dsp:txXfrm>
    </dsp:sp>
    <dsp:sp modelId="{B67BA8B7-08DC-C244-8300-FCD547033DBD}">
      <dsp:nvSpPr>
        <dsp:cNvPr id="0" name=""/>
        <dsp:cNvSpPr/>
      </dsp:nvSpPr>
      <dsp:spPr>
        <a:xfrm>
          <a:off x="136881" y="358532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7</a:t>
          </a:r>
        </a:p>
      </dsp:txBody>
      <dsp:txXfrm>
        <a:off x="164015" y="3612462"/>
        <a:ext cx="501578" cy="514801"/>
      </dsp:txXfrm>
    </dsp:sp>
    <dsp:sp modelId="{8CF3EAF4-8574-9841-9B3E-4FBF8CB57172}">
      <dsp:nvSpPr>
        <dsp:cNvPr id="0" name=""/>
        <dsp:cNvSpPr/>
      </dsp:nvSpPr>
      <dsp:spPr>
        <a:xfrm rot="5400000">
          <a:off x="1202530" y="372995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ek support</a:t>
          </a:r>
        </a:p>
      </dsp:txBody>
      <dsp:txXfrm rot="-5400000">
        <a:off x="692728" y="4261982"/>
        <a:ext cx="1452636" cy="410807"/>
      </dsp:txXfrm>
    </dsp:sp>
    <dsp:sp modelId="{D5D04DA4-D0C2-DE47-8C8C-0B8EFFA304FE}">
      <dsp:nvSpPr>
        <dsp:cNvPr id="0" name=""/>
        <dsp:cNvSpPr/>
      </dsp:nvSpPr>
      <dsp:spPr>
        <a:xfrm>
          <a:off x="136881" y="418285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8</a:t>
          </a:r>
        </a:p>
      </dsp:txBody>
      <dsp:txXfrm>
        <a:off x="164015" y="4209985"/>
        <a:ext cx="501578" cy="514801"/>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1D64796-42C1-6A47-B16B-F23C35A117FF}">
      <dsp:nvSpPr>
        <dsp:cNvPr id="0" name=""/>
        <dsp:cNvSpPr/>
      </dsp:nvSpPr>
      <dsp:spPr>
        <a:xfrm rot="5400000">
          <a:off x="1202530" y="-45270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a:t>Patient stability</a:t>
          </a:r>
          <a:endParaRPr lang="en-US" sz="1300" kern="1200" dirty="0"/>
        </a:p>
      </dsp:txBody>
      <dsp:txXfrm rot="-5400000">
        <a:off x="692728" y="79320"/>
        <a:ext cx="1452636" cy="410807"/>
      </dsp:txXfrm>
    </dsp:sp>
    <dsp:sp modelId="{2F0271A3-745A-A943-B67B-E4069A93AE61}">
      <dsp:nvSpPr>
        <dsp:cNvPr id="0" name=""/>
        <dsp:cNvSpPr/>
      </dsp:nvSpPr>
      <dsp:spPr>
        <a:xfrm>
          <a:off x="136881" y="18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1</a:t>
          </a:r>
        </a:p>
      </dsp:txBody>
      <dsp:txXfrm>
        <a:off x="164015" y="27322"/>
        <a:ext cx="501578" cy="514801"/>
      </dsp:txXfrm>
    </dsp:sp>
    <dsp:sp modelId="{2EB4DD27-0645-2048-89E9-55CE50FE52DA}">
      <dsp:nvSpPr>
        <dsp:cNvPr id="0" name=""/>
        <dsp:cNvSpPr/>
      </dsp:nvSpPr>
      <dsp:spPr>
        <a:xfrm rot="5400000">
          <a:off x="1202530" y="14481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Emotional check</a:t>
          </a:r>
        </a:p>
      </dsp:txBody>
      <dsp:txXfrm rot="-5400000">
        <a:off x="692728" y="676842"/>
        <a:ext cx="1452636" cy="410807"/>
      </dsp:txXfrm>
    </dsp:sp>
    <dsp:sp modelId="{6CEBA26E-9501-3E41-ACBB-39C96B19A924}">
      <dsp:nvSpPr>
        <dsp:cNvPr id="0" name=""/>
        <dsp:cNvSpPr/>
      </dsp:nvSpPr>
      <dsp:spPr>
        <a:xfrm>
          <a:off x="136881" y="59771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2</a:t>
          </a:r>
        </a:p>
      </dsp:txBody>
      <dsp:txXfrm>
        <a:off x="164015" y="624845"/>
        <a:ext cx="501578" cy="514801"/>
      </dsp:txXfrm>
    </dsp:sp>
    <dsp:sp modelId="{5432570E-A980-7C49-B78B-FBD7E95247D6}">
      <dsp:nvSpPr>
        <dsp:cNvPr id="0" name=""/>
        <dsp:cNvSpPr/>
      </dsp:nvSpPr>
      <dsp:spPr>
        <a:xfrm rot="5400000">
          <a:off x="1202530" y="74233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ddress bias</a:t>
          </a:r>
        </a:p>
      </dsp:txBody>
      <dsp:txXfrm rot="-5400000">
        <a:off x="692728" y="1274365"/>
        <a:ext cx="1452636" cy="410807"/>
      </dsp:txXfrm>
    </dsp:sp>
    <dsp:sp modelId="{A3A63788-1227-B240-AFF4-87DA3887717D}">
      <dsp:nvSpPr>
        <dsp:cNvPr id="0" name=""/>
        <dsp:cNvSpPr/>
      </dsp:nvSpPr>
      <dsp:spPr>
        <a:xfrm>
          <a:off x="136881" y="119523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3</a:t>
          </a:r>
        </a:p>
      </dsp:txBody>
      <dsp:txXfrm>
        <a:off x="164015" y="1222369"/>
        <a:ext cx="501578" cy="514801"/>
      </dsp:txXfrm>
    </dsp:sp>
    <dsp:sp modelId="{B11406A9-5BCB-7247-9C38-2B1D2505F2B8}">
      <dsp:nvSpPr>
        <dsp:cNvPr id="0" name=""/>
        <dsp:cNvSpPr/>
      </dsp:nvSpPr>
      <dsp:spPr>
        <a:xfrm rot="5400000">
          <a:off x="1202530" y="133986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patient</a:t>
          </a:r>
        </a:p>
      </dsp:txBody>
      <dsp:txXfrm rot="-5400000">
        <a:off x="692728" y="1871888"/>
        <a:ext cx="1452636" cy="410807"/>
      </dsp:txXfrm>
    </dsp:sp>
    <dsp:sp modelId="{F459C834-8503-9C47-9E88-19B5B264D39A}">
      <dsp:nvSpPr>
        <dsp:cNvPr id="0" name=""/>
        <dsp:cNvSpPr/>
      </dsp:nvSpPr>
      <dsp:spPr>
        <a:xfrm>
          <a:off x="136881" y="179275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4</a:t>
          </a:r>
        </a:p>
      </dsp:txBody>
      <dsp:txXfrm>
        <a:off x="164015" y="1819892"/>
        <a:ext cx="501578" cy="514801"/>
      </dsp:txXfrm>
    </dsp:sp>
    <dsp:sp modelId="{DF481026-182D-AB4B-A938-B9E12915351D}">
      <dsp:nvSpPr>
        <dsp:cNvPr id="0" name=""/>
        <dsp:cNvSpPr/>
      </dsp:nvSpPr>
      <dsp:spPr>
        <a:xfrm rot="5400000">
          <a:off x="1202530" y="193738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team</a:t>
          </a:r>
        </a:p>
      </dsp:txBody>
      <dsp:txXfrm rot="-5400000">
        <a:off x="692728" y="2469412"/>
        <a:ext cx="1452636" cy="410807"/>
      </dsp:txXfrm>
    </dsp:sp>
    <dsp:sp modelId="{4D3677DD-203E-6A46-986E-4A5C658C9303}">
      <dsp:nvSpPr>
        <dsp:cNvPr id="0" name=""/>
        <dsp:cNvSpPr/>
      </dsp:nvSpPr>
      <dsp:spPr>
        <a:xfrm>
          <a:off x="136881" y="239028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5</a:t>
          </a:r>
        </a:p>
      </dsp:txBody>
      <dsp:txXfrm>
        <a:off x="164015" y="2417415"/>
        <a:ext cx="501578" cy="514801"/>
      </dsp:txXfrm>
    </dsp:sp>
    <dsp:sp modelId="{95DA0D8B-BC89-0948-909A-C298332DBD75}">
      <dsp:nvSpPr>
        <dsp:cNvPr id="0" name=""/>
        <dsp:cNvSpPr/>
      </dsp:nvSpPr>
      <dsp:spPr>
        <a:xfrm rot="5400000">
          <a:off x="1202530" y="253490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t boundaries</a:t>
          </a:r>
        </a:p>
      </dsp:txBody>
      <dsp:txXfrm rot="-5400000">
        <a:off x="692728" y="3066935"/>
        <a:ext cx="1452636" cy="410807"/>
      </dsp:txXfrm>
    </dsp:sp>
    <dsp:sp modelId="{B6C279C8-1B63-3845-ADAB-B82AEFA3D8E4}">
      <dsp:nvSpPr>
        <dsp:cNvPr id="0" name=""/>
        <dsp:cNvSpPr/>
      </dsp:nvSpPr>
      <dsp:spPr>
        <a:xfrm>
          <a:off x="136881" y="298780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6</a:t>
          </a:r>
        </a:p>
      </dsp:txBody>
      <dsp:txXfrm>
        <a:off x="164015" y="3014939"/>
        <a:ext cx="501578" cy="514801"/>
      </dsp:txXfrm>
    </dsp:sp>
    <dsp:sp modelId="{9D2B4FF6-13FB-EF49-977A-31DF5EE58099}">
      <dsp:nvSpPr>
        <dsp:cNvPr id="0" name=""/>
        <dsp:cNvSpPr/>
      </dsp:nvSpPr>
      <dsp:spPr>
        <a:xfrm rot="5400000">
          <a:off x="1202530" y="313243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Give space</a:t>
          </a:r>
        </a:p>
      </dsp:txBody>
      <dsp:txXfrm rot="-5400000">
        <a:off x="692728" y="3664458"/>
        <a:ext cx="1452636" cy="410807"/>
      </dsp:txXfrm>
    </dsp:sp>
    <dsp:sp modelId="{B67BA8B7-08DC-C244-8300-FCD547033DBD}">
      <dsp:nvSpPr>
        <dsp:cNvPr id="0" name=""/>
        <dsp:cNvSpPr/>
      </dsp:nvSpPr>
      <dsp:spPr>
        <a:xfrm>
          <a:off x="136881" y="358532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7</a:t>
          </a:r>
        </a:p>
      </dsp:txBody>
      <dsp:txXfrm>
        <a:off x="164015" y="3612462"/>
        <a:ext cx="501578" cy="514801"/>
      </dsp:txXfrm>
    </dsp:sp>
    <dsp:sp modelId="{8CF3EAF4-8574-9841-9B3E-4FBF8CB57172}">
      <dsp:nvSpPr>
        <dsp:cNvPr id="0" name=""/>
        <dsp:cNvSpPr/>
      </dsp:nvSpPr>
      <dsp:spPr>
        <a:xfrm rot="5400000">
          <a:off x="1202530" y="372995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ek support</a:t>
          </a:r>
        </a:p>
      </dsp:txBody>
      <dsp:txXfrm rot="-5400000">
        <a:off x="692728" y="4261982"/>
        <a:ext cx="1452636" cy="410807"/>
      </dsp:txXfrm>
    </dsp:sp>
    <dsp:sp modelId="{D5D04DA4-D0C2-DE47-8C8C-0B8EFFA304FE}">
      <dsp:nvSpPr>
        <dsp:cNvPr id="0" name=""/>
        <dsp:cNvSpPr/>
      </dsp:nvSpPr>
      <dsp:spPr>
        <a:xfrm>
          <a:off x="136881" y="418285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8</a:t>
          </a:r>
        </a:p>
      </dsp:txBody>
      <dsp:txXfrm>
        <a:off x="164015" y="4209985"/>
        <a:ext cx="501578" cy="514801"/>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1D64796-42C1-6A47-B16B-F23C35A117FF}">
      <dsp:nvSpPr>
        <dsp:cNvPr id="0" name=""/>
        <dsp:cNvSpPr/>
      </dsp:nvSpPr>
      <dsp:spPr>
        <a:xfrm rot="5400000">
          <a:off x="1202530" y="-45270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a:t>Patient stability</a:t>
          </a:r>
          <a:endParaRPr lang="en-US" sz="1300" kern="1200" dirty="0"/>
        </a:p>
      </dsp:txBody>
      <dsp:txXfrm rot="-5400000">
        <a:off x="692728" y="79320"/>
        <a:ext cx="1452636" cy="410807"/>
      </dsp:txXfrm>
    </dsp:sp>
    <dsp:sp modelId="{2F0271A3-745A-A943-B67B-E4069A93AE61}">
      <dsp:nvSpPr>
        <dsp:cNvPr id="0" name=""/>
        <dsp:cNvSpPr/>
      </dsp:nvSpPr>
      <dsp:spPr>
        <a:xfrm>
          <a:off x="136881" y="18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1</a:t>
          </a:r>
        </a:p>
      </dsp:txBody>
      <dsp:txXfrm>
        <a:off x="164015" y="27322"/>
        <a:ext cx="501578" cy="514801"/>
      </dsp:txXfrm>
    </dsp:sp>
    <dsp:sp modelId="{2EB4DD27-0645-2048-89E9-55CE50FE52DA}">
      <dsp:nvSpPr>
        <dsp:cNvPr id="0" name=""/>
        <dsp:cNvSpPr/>
      </dsp:nvSpPr>
      <dsp:spPr>
        <a:xfrm rot="5400000">
          <a:off x="1202530" y="14481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Emotional check</a:t>
          </a:r>
        </a:p>
      </dsp:txBody>
      <dsp:txXfrm rot="-5400000">
        <a:off x="692728" y="676842"/>
        <a:ext cx="1452636" cy="410807"/>
      </dsp:txXfrm>
    </dsp:sp>
    <dsp:sp modelId="{6CEBA26E-9501-3E41-ACBB-39C96B19A924}">
      <dsp:nvSpPr>
        <dsp:cNvPr id="0" name=""/>
        <dsp:cNvSpPr/>
      </dsp:nvSpPr>
      <dsp:spPr>
        <a:xfrm>
          <a:off x="136881" y="59771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2</a:t>
          </a:r>
        </a:p>
      </dsp:txBody>
      <dsp:txXfrm>
        <a:off x="164015" y="624845"/>
        <a:ext cx="501578" cy="514801"/>
      </dsp:txXfrm>
    </dsp:sp>
    <dsp:sp modelId="{5432570E-A980-7C49-B78B-FBD7E95247D6}">
      <dsp:nvSpPr>
        <dsp:cNvPr id="0" name=""/>
        <dsp:cNvSpPr/>
      </dsp:nvSpPr>
      <dsp:spPr>
        <a:xfrm rot="5400000">
          <a:off x="1202530" y="74233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ddress bias</a:t>
          </a:r>
        </a:p>
      </dsp:txBody>
      <dsp:txXfrm rot="-5400000">
        <a:off x="692728" y="1274365"/>
        <a:ext cx="1452636" cy="410807"/>
      </dsp:txXfrm>
    </dsp:sp>
    <dsp:sp modelId="{A3A63788-1227-B240-AFF4-87DA3887717D}">
      <dsp:nvSpPr>
        <dsp:cNvPr id="0" name=""/>
        <dsp:cNvSpPr/>
      </dsp:nvSpPr>
      <dsp:spPr>
        <a:xfrm>
          <a:off x="136881" y="119523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3</a:t>
          </a:r>
        </a:p>
      </dsp:txBody>
      <dsp:txXfrm>
        <a:off x="164015" y="1222369"/>
        <a:ext cx="501578" cy="514801"/>
      </dsp:txXfrm>
    </dsp:sp>
    <dsp:sp modelId="{B11406A9-5BCB-7247-9C38-2B1D2505F2B8}">
      <dsp:nvSpPr>
        <dsp:cNvPr id="0" name=""/>
        <dsp:cNvSpPr/>
      </dsp:nvSpPr>
      <dsp:spPr>
        <a:xfrm rot="5400000">
          <a:off x="1202530" y="133986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patient</a:t>
          </a:r>
        </a:p>
      </dsp:txBody>
      <dsp:txXfrm rot="-5400000">
        <a:off x="692728" y="1871888"/>
        <a:ext cx="1452636" cy="410807"/>
      </dsp:txXfrm>
    </dsp:sp>
    <dsp:sp modelId="{F459C834-8503-9C47-9E88-19B5B264D39A}">
      <dsp:nvSpPr>
        <dsp:cNvPr id="0" name=""/>
        <dsp:cNvSpPr/>
      </dsp:nvSpPr>
      <dsp:spPr>
        <a:xfrm>
          <a:off x="136881" y="179275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4</a:t>
          </a:r>
        </a:p>
      </dsp:txBody>
      <dsp:txXfrm>
        <a:off x="164015" y="1819892"/>
        <a:ext cx="501578" cy="514801"/>
      </dsp:txXfrm>
    </dsp:sp>
    <dsp:sp modelId="{DF481026-182D-AB4B-A938-B9E12915351D}">
      <dsp:nvSpPr>
        <dsp:cNvPr id="0" name=""/>
        <dsp:cNvSpPr/>
      </dsp:nvSpPr>
      <dsp:spPr>
        <a:xfrm rot="5400000">
          <a:off x="1202530" y="193738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team</a:t>
          </a:r>
        </a:p>
      </dsp:txBody>
      <dsp:txXfrm rot="-5400000">
        <a:off x="692728" y="2469412"/>
        <a:ext cx="1452636" cy="410807"/>
      </dsp:txXfrm>
    </dsp:sp>
    <dsp:sp modelId="{4D3677DD-203E-6A46-986E-4A5C658C9303}">
      <dsp:nvSpPr>
        <dsp:cNvPr id="0" name=""/>
        <dsp:cNvSpPr/>
      </dsp:nvSpPr>
      <dsp:spPr>
        <a:xfrm>
          <a:off x="136881" y="239028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5</a:t>
          </a:r>
        </a:p>
      </dsp:txBody>
      <dsp:txXfrm>
        <a:off x="164015" y="2417415"/>
        <a:ext cx="501578" cy="514801"/>
      </dsp:txXfrm>
    </dsp:sp>
    <dsp:sp modelId="{95DA0D8B-BC89-0948-909A-C298332DBD75}">
      <dsp:nvSpPr>
        <dsp:cNvPr id="0" name=""/>
        <dsp:cNvSpPr/>
      </dsp:nvSpPr>
      <dsp:spPr>
        <a:xfrm rot="5400000">
          <a:off x="1202530" y="253490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t boundaries</a:t>
          </a:r>
        </a:p>
      </dsp:txBody>
      <dsp:txXfrm rot="-5400000">
        <a:off x="692728" y="3066935"/>
        <a:ext cx="1452636" cy="410807"/>
      </dsp:txXfrm>
    </dsp:sp>
    <dsp:sp modelId="{B6C279C8-1B63-3845-ADAB-B82AEFA3D8E4}">
      <dsp:nvSpPr>
        <dsp:cNvPr id="0" name=""/>
        <dsp:cNvSpPr/>
      </dsp:nvSpPr>
      <dsp:spPr>
        <a:xfrm>
          <a:off x="136881" y="298780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6</a:t>
          </a:r>
        </a:p>
      </dsp:txBody>
      <dsp:txXfrm>
        <a:off x="164015" y="3014939"/>
        <a:ext cx="501578" cy="514801"/>
      </dsp:txXfrm>
    </dsp:sp>
    <dsp:sp modelId="{9D2B4FF6-13FB-EF49-977A-31DF5EE58099}">
      <dsp:nvSpPr>
        <dsp:cNvPr id="0" name=""/>
        <dsp:cNvSpPr/>
      </dsp:nvSpPr>
      <dsp:spPr>
        <a:xfrm rot="5400000">
          <a:off x="1202530" y="313243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Give space</a:t>
          </a:r>
        </a:p>
      </dsp:txBody>
      <dsp:txXfrm rot="-5400000">
        <a:off x="692728" y="3664458"/>
        <a:ext cx="1452636" cy="410807"/>
      </dsp:txXfrm>
    </dsp:sp>
    <dsp:sp modelId="{B67BA8B7-08DC-C244-8300-FCD547033DBD}">
      <dsp:nvSpPr>
        <dsp:cNvPr id="0" name=""/>
        <dsp:cNvSpPr/>
      </dsp:nvSpPr>
      <dsp:spPr>
        <a:xfrm>
          <a:off x="136881" y="358532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7</a:t>
          </a:r>
        </a:p>
      </dsp:txBody>
      <dsp:txXfrm>
        <a:off x="164015" y="3612462"/>
        <a:ext cx="501578" cy="514801"/>
      </dsp:txXfrm>
    </dsp:sp>
    <dsp:sp modelId="{8CF3EAF4-8574-9841-9B3E-4FBF8CB57172}">
      <dsp:nvSpPr>
        <dsp:cNvPr id="0" name=""/>
        <dsp:cNvSpPr/>
      </dsp:nvSpPr>
      <dsp:spPr>
        <a:xfrm rot="5400000">
          <a:off x="1202530" y="372995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ek support</a:t>
          </a:r>
        </a:p>
      </dsp:txBody>
      <dsp:txXfrm rot="-5400000">
        <a:off x="692728" y="4261982"/>
        <a:ext cx="1452636" cy="410807"/>
      </dsp:txXfrm>
    </dsp:sp>
    <dsp:sp modelId="{D5D04DA4-D0C2-DE47-8C8C-0B8EFFA304FE}">
      <dsp:nvSpPr>
        <dsp:cNvPr id="0" name=""/>
        <dsp:cNvSpPr/>
      </dsp:nvSpPr>
      <dsp:spPr>
        <a:xfrm>
          <a:off x="136881" y="418285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8</a:t>
          </a:r>
        </a:p>
      </dsp:txBody>
      <dsp:txXfrm>
        <a:off x="164015" y="4209985"/>
        <a:ext cx="501578" cy="514801"/>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1D64796-42C1-6A47-B16B-F23C35A117FF}">
      <dsp:nvSpPr>
        <dsp:cNvPr id="0" name=""/>
        <dsp:cNvSpPr/>
      </dsp:nvSpPr>
      <dsp:spPr>
        <a:xfrm rot="5400000">
          <a:off x="1202530" y="-45270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a:t>Patient stability</a:t>
          </a:r>
          <a:endParaRPr lang="en-US" sz="1300" kern="1200" dirty="0"/>
        </a:p>
      </dsp:txBody>
      <dsp:txXfrm rot="-5400000">
        <a:off x="692728" y="79320"/>
        <a:ext cx="1452636" cy="410807"/>
      </dsp:txXfrm>
    </dsp:sp>
    <dsp:sp modelId="{2F0271A3-745A-A943-B67B-E4069A93AE61}">
      <dsp:nvSpPr>
        <dsp:cNvPr id="0" name=""/>
        <dsp:cNvSpPr/>
      </dsp:nvSpPr>
      <dsp:spPr>
        <a:xfrm>
          <a:off x="136881" y="18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1</a:t>
          </a:r>
        </a:p>
      </dsp:txBody>
      <dsp:txXfrm>
        <a:off x="164015" y="27322"/>
        <a:ext cx="501578" cy="514801"/>
      </dsp:txXfrm>
    </dsp:sp>
    <dsp:sp modelId="{2EB4DD27-0645-2048-89E9-55CE50FE52DA}">
      <dsp:nvSpPr>
        <dsp:cNvPr id="0" name=""/>
        <dsp:cNvSpPr/>
      </dsp:nvSpPr>
      <dsp:spPr>
        <a:xfrm rot="5400000">
          <a:off x="1202530" y="14481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Emotional check</a:t>
          </a:r>
        </a:p>
      </dsp:txBody>
      <dsp:txXfrm rot="-5400000">
        <a:off x="692728" y="676842"/>
        <a:ext cx="1452636" cy="410807"/>
      </dsp:txXfrm>
    </dsp:sp>
    <dsp:sp modelId="{6CEBA26E-9501-3E41-ACBB-39C96B19A924}">
      <dsp:nvSpPr>
        <dsp:cNvPr id="0" name=""/>
        <dsp:cNvSpPr/>
      </dsp:nvSpPr>
      <dsp:spPr>
        <a:xfrm>
          <a:off x="136881" y="59771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2</a:t>
          </a:r>
        </a:p>
      </dsp:txBody>
      <dsp:txXfrm>
        <a:off x="164015" y="624845"/>
        <a:ext cx="501578" cy="514801"/>
      </dsp:txXfrm>
    </dsp:sp>
    <dsp:sp modelId="{5432570E-A980-7C49-B78B-FBD7E95247D6}">
      <dsp:nvSpPr>
        <dsp:cNvPr id="0" name=""/>
        <dsp:cNvSpPr/>
      </dsp:nvSpPr>
      <dsp:spPr>
        <a:xfrm rot="5400000">
          <a:off x="1202530" y="74233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ddress bias</a:t>
          </a:r>
        </a:p>
      </dsp:txBody>
      <dsp:txXfrm rot="-5400000">
        <a:off x="692728" y="1274365"/>
        <a:ext cx="1452636" cy="410807"/>
      </dsp:txXfrm>
    </dsp:sp>
    <dsp:sp modelId="{A3A63788-1227-B240-AFF4-87DA3887717D}">
      <dsp:nvSpPr>
        <dsp:cNvPr id="0" name=""/>
        <dsp:cNvSpPr/>
      </dsp:nvSpPr>
      <dsp:spPr>
        <a:xfrm>
          <a:off x="136881" y="119523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3</a:t>
          </a:r>
        </a:p>
      </dsp:txBody>
      <dsp:txXfrm>
        <a:off x="164015" y="1222369"/>
        <a:ext cx="501578" cy="514801"/>
      </dsp:txXfrm>
    </dsp:sp>
    <dsp:sp modelId="{B11406A9-5BCB-7247-9C38-2B1D2505F2B8}">
      <dsp:nvSpPr>
        <dsp:cNvPr id="0" name=""/>
        <dsp:cNvSpPr/>
      </dsp:nvSpPr>
      <dsp:spPr>
        <a:xfrm rot="5400000">
          <a:off x="1202530" y="133986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team</a:t>
          </a:r>
        </a:p>
      </dsp:txBody>
      <dsp:txXfrm rot="-5400000">
        <a:off x="692728" y="1871888"/>
        <a:ext cx="1452636" cy="410807"/>
      </dsp:txXfrm>
    </dsp:sp>
    <dsp:sp modelId="{F459C834-8503-9C47-9E88-19B5B264D39A}">
      <dsp:nvSpPr>
        <dsp:cNvPr id="0" name=""/>
        <dsp:cNvSpPr/>
      </dsp:nvSpPr>
      <dsp:spPr>
        <a:xfrm>
          <a:off x="136881" y="179275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4</a:t>
          </a:r>
        </a:p>
      </dsp:txBody>
      <dsp:txXfrm>
        <a:off x="164015" y="1819892"/>
        <a:ext cx="501578" cy="514801"/>
      </dsp:txXfrm>
    </dsp:sp>
    <dsp:sp modelId="{DF481026-182D-AB4B-A938-B9E12915351D}">
      <dsp:nvSpPr>
        <dsp:cNvPr id="0" name=""/>
        <dsp:cNvSpPr/>
      </dsp:nvSpPr>
      <dsp:spPr>
        <a:xfrm rot="5400000">
          <a:off x="1202530" y="193738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t boundaries</a:t>
          </a:r>
        </a:p>
      </dsp:txBody>
      <dsp:txXfrm rot="-5400000">
        <a:off x="692728" y="2469412"/>
        <a:ext cx="1452636" cy="410807"/>
      </dsp:txXfrm>
    </dsp:sp>
    <dsp:sp modelId="{4D3677DD-203E-6A46-986E-4A5C658C9303}">
      <dsp:nvSpPr>
        <dsp:cNvPr id="0" name=""/>
        <dsp:cNvSpPr/>
      </dsp:nvSpPr>
      <dsp:spPr>
        <a:xfrm>
          <a:off x="136881" y="239028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5</a:t>
          </a:r>
        </a:p>
      </dsp:txBody>
      <dsp:txXfrm>
        <a:off x="164015" y="2417415"/>
        <a:ext cx="501578" cy="514801"/>
      </dsp:txXfrm>
    </dsp:sp>
    <dsp:sp modelId="{95DA0D8B-BC89-0948-909A-C298332DBD75}">
      <dsp:nvSpPr>
        <dsp:cNvPr id="0" name=""/>
        <dsp:cNvSpPr/>
      </dsp:nvSpPr>
      <dsp:spPr>
        <a:xfrm rot="5400000">
          <a:off x="1202530" y="253490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Recenter on care</a:t>
          </a:r>
        </a:p>
      </dsp:txBody>
      <dsp:txXfrm rot="-5400000">
        <a:off x="692728" y="3066935"/>
        <a:ext cx="1452636" cy="410807"/>
      </dsp:txXfrm>
    </dsp:sp>
    <dsp:sp modelId="{B6C279C8-1B63-3845-ADAB-B82AEFA3D8E4}">
      <dsp:nvSpPr>
        <dsp:cNvPr id="0" name=""/>
        <dsp:cNvSpPr/>
      </dsp:nvSpPr>
      <dsp:spPr>
        <a:xfrm>
          <a:off x="136881" y="298780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6</a:t>
          </a:r>
        </a:p>
      </dsp:txBody>
      <dsp:txXfrm>
        <a:off x="164015" y="3014939"/>
        <a:ext cx="501578" cy="514801"/>
      </dsp:txXfrm>
    </dsp:sp>
    <dsp:sp modelId="{9D2B4FF6-13FB-EF49-977A-31DF5EE58099}">
      <dsp:nvSpPr>
        <dsp:cNvPr id="0" name=""/>
        <dsp:cNvSpPr/>
      </dsp:nvSpPr>
      <dsp:spPr>
        <a:xfrm rot="5400000">
          <a:off x="1202530" y="313243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Give space</a:t>
          </a:r>
        </a:p>
      </dsp:txBody>
      <dsp:txXfrm rot="-5400000">
        <a:off x="692728" y="3664458"/>
        <a:ext cx="1452636" cy="410807"/>
      </dsp:txXfrm>
    </dsp:sp>
    <dsp:sp modelId="{B67BA8B7-08DC-C244-8300-FCD547033DBD}">
      <dsp:nvSpPr>
        <dsp:cNvPr id="0" name=""/>
        <dsp:cNvSpPr/>
      </dsp:nvSpPr>
      <dsp:spPr>
        <a:xfrm>
          <a:off x="136881" y="358532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7</a:t>
          </a:r>
        </a:p>
      </dsp:txBody>
      <dsp:txXfrm>
        <a:off x="164015" y="3612462"/>
        <a:ext cx="501578" cy="514801"/>
      </dsp:txXfrm>
    </dsp:sp>
    <dsp:sp modelId="{8CF3EAF4-8574-9841-9B3E-4FBF8CB57172}">
      <dsp:nvSpPr>
        <dsp:cNvPr id="0" name=""/>
        <dsp:cNvSpPr/>
      </dsp:nvSpPr>
      <dsp:spPr>
        <a:xfrm rot="5400000">
          <a:off x="1202530" y="372995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ek support</a:t>
          </a:r>
        </a:p>
      </dsp:txBody>
      <dsp:txXfrm rot="-5400000">
        <a:off x="692728" y="4261982"/>
        <a:ext cx="1452636" cy="410807"/>
      </dsp:txXfrm>
    </dsp:sp>
    <dsp:sp modelId="{D5D04DA4-D0C2-DE47-8C8C-0B8EFFA304FE}">
      <dsp:nvSpPr>
        <dsp:cNvPr id="0" name=""/>
        <dsp:cNvSpPr/>
      </dsp:nvSpPr>
      <dsp:spPr>
        <a:xfrm>
          <a:off x="136881" y="418285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8</a:t>
          </a:r>
        </a:p>
      </dsp:txBody>
      <dsp:txXfrm>
        <a:off x="164015" y="4209985"/>
        <a:ext cx="501578" cy="514801"/>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1D64796-42C1-6A47-B16B-F23C35A117FF}">
      <dsp:nvSpPr>
        <dsp:cNvPr id="0" name=""/>
        <dsp:cNvSpPr/>
      </dsp:nvSpPr>
      <dsp:spPr>
        <a:xfrm rot="5400000">
          <a:off x="1202530" y="-45270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a:t>Patient stability</a:t>
          </a:r>
          <a:endParaRPr lang="en-US" sz="1300" kern="1200" dirty="0"/>
        </a:p>
      </dsp:txBody>
      <dsp:txXfrm rot="-5400000">
        <a:off x="692728" y="79320"/>
        <a:ext cx="1452636" cy="410807"/>
      </dsp:txXfrm>
    </dsp:sp>
    <dsp:sp modelId="{2F0271A3-745A-A943-B67B-E4069A93AE61}">
      <dsp:nvSpPr>
        <dsp:cNvPr id="0" name=""/>
        <dsp:cNvSpPr/>
      </dsp:nvSpPr>
      <dsp:spPr>
        <a:xfrm>
          <a:off x="136881" y="18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1</a:t>
          </a:r>
        </a:p>
      </dsp:txBody>
      <dsp:txXfrm>
        <a:off x="164015" y="27322"/>
        <a:ext cx="501578" cy="514801"/>
      </dsp:txXfrm>
    </dsp:sp>
    <dsp:sp modelId="{2EB4DD27-0645-2048-89E9-55CE50FE52DA}">
      <dsp:nvSpPr>
        <dsp:cNvPr id="0" name=""/>
        <dsp:cNvSpPr/>
      </dsp:nvSpPr>
      <dsp:spPr>
        <a:xfrm rot="5400000">
          <a:off x="1202530" y="14481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Emotional check</a:t>
          </a:r>
        </a:p>
      </dsp:txBody>
      <dsp:txXfrm rot="-5400000">
        <a:off x="692728" y="676842"/>
        <a:ext cx="1452636" cy="410807"/>
      </dsp:txXfrm>
    </dsp:sp>
    <dsp:sp modelId="{6CEBA26E-9501-3E41-ACBB-39C96B19A924}">
      <dsp:nvSpPr>
        <dsp:cNvPr id="0" name=""/>
        <dsp:cNvSpPr/>
      </dsp:nvSpPr>
      <dsp:spPr>
        <a:xfrm>
          <a:off x="136881" y="59771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2</a:t>
          </a:r>
        </a:p>
      </dsp:txBody>
      <dsp:txXfrm>
        <a:off x="164015" y="624845"/>
        <a:ext cx="501578" cy="514801"/>
      </dsp:txXfrm>
    </dsp:sp>
    <dsp:sp modelId="{5432570E-A980-7C49-B78B-FBD7E95247D6}">
      <dsp:nvSpPr>
        <dsp:cNvPr id="0" name=""/>
        <dsp:cNvSpPr/>
      </dsp:nvSpPr>
      <dsp:spPr>
        <a:xfrm rot="5400000">
          <a:off x="1202530" y="74233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ddress bias</a:t>
          </a:r>
        </a:p>
      </dsp:txBody>
      <dsp:txXfrm rot="-5400000">
        <a:off x="692728" y="1274365"/>
        <a:ext cx="1452636" cy="410807"/>
      </dsp:txXfrm>
    </dsp:sp>
    <dsp:sp modelId="{A3A63788-1227-B240-AFF4-87DA3887717D}">
      <dsp:nvSpPr>
        <dsp:cNvPr id="0" name=""/>
        <dsp:cNvSpPr/>
      </dsp:nvSpPr>
      <dsp:spPr>
        <a:xfrm>
          <a:off x="136881" y="119523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3</a:t>
          </a:r>
        </a:p>
      </dsp:txBody>
      <dsp:txXfrm>
        <a:off x="164015" y="1222369"/>
        <a:ext cx="501578" cy="514801"/>
      </dsp:txXfrm>
    </dsp:sp>
    <dsp:sp modelId="{B11406A9-5BCB-7247-9C38-2B1D2505F2B8}">
      <dsp:nvSpPr>
        <dsp:cNvPr id="0" name=""/>
        <dsp:cNvSpPr/>
      </dsp:nvSpPr>
      <dsp:spPr>
        <a:xfrm rot="5400000">
          <a:off x="1202530" y="133986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Align with team</a:t>
          </a:r>
        </a:p>
      </dsp:txBody>
      <dsp:txXfrm rot="-5400000">
        <a:off x="692728" y="1871888"/>
        <a:ext cx="1452636" cy="410807"/>
      </dsp:txXfrm>
    </dsp:sp>
    <dsp:sp modelId="{F459C834-8503-9C47-9E88-19B5B264D39A}">
      <dsp:nvSpPr>
        <dsp:cNvPr id="0" name=""/>
        <dsp:cNvSpPr/>
      </dsp:nvSpPr>
      <dsp:spPr>
        <a:xfrm>
          <a:off x="136881" y="179275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4</a:t>
          </a:r>
        </a:p>
      </dsp:txBody>
      <dsp:txXfrm>
        <a:off x="164015" y="1819892"/>
        <a:ext cx="501578" cy="514801"/>
      </dsp:txXfrm>
    </dsp:sp>
    <dsp:sp modelId="{DF481026-182D-AB4B-A938-B9E12915351D}">
      <dsp:nvSpPr>
        <dsp:cNvPr id="0" name=""/>
        <dsp:cNvSpPr/>
      </dsp:nvSpPr>
      <dsp:spPr>
        <a:xfrm rot="5400000">
          <a:off x="1202530" y="193738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t boundaries</a:t>
          </a:r>
        </a:p>
      </dsp:txBody>
      <dsp:txXfrm rot="-5400000">
        <a:off x="692728" y="2469412"/>
        <a:ext cx="1452636" cy="410807"/>
      </dsp:txXfrm>
    </dsp:sp>
    <dsp:sp modelId="{4D3677DD-203E-6A46-986E-4A5C658C9303}">
      <dsp:nvSpPr>
        <dsp:cNvPr id="0" name=""/>
        <dsp:cNvSpPr/>
      </dsp:nvSpPr>
      <dsp:spPr>
        <a:xfrm>
          <a:off x="136881" y="239028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5</a:t>
          </a:r>
        </a:p>
      </dsp:txBody>
      <dsp:txXfrm>
        <a:off x="164015" y="2417415"/>
        <a:ext cx="501578" cy="514801"/>
      </dsp:txXfrm>
    </dsp:sp>
    <dsp:sp modelId="{95DA0D8B-BC89-0948-909A-C298332DBD75}">
      <dsp:nvSpPr>
        <dsp:cNvPr id="0" name=""/>
        <dsp:cNvSpPr/>
      </dsp:nvSpPr>
      <dsp:spPr>
        <a:xfrm rot="5400000">
          <a:off x="1202530" y="2534909"/>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Recenter on care</a:t>
          </a:r>
        </a:p>
      </dsp:txBody>
      <dsp:txXfrm rot="-5400000">
        <a:off x="692728" y="3066935"/>
        <a:ext cx="1452636" cy="410807"/>
      </dsp:txXfrm>
    </dsp:sp>
    <dsp:sp modelId="{B6C279C8-1B63-3845-ADAB-B82AEFA3D8E4}">
      <dsp:nvSpPr>
        <dsp:cNvPr id="0" name=""/>
        <dsp:cNvSpPr/>
      </dsp:nvSpPr>
      <dsp:spPr>
        <a:xfrm>
          <a:off x="136881" y="2987805"/>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6</a:t>
          </a:r>
        </a:p>
      </dsp:txBody>
      <dsp:txXfrm>
        <a:off x="164015" y="3014939"/>
        <a:ext cx="501578" cy="514801"/>
      </dsp:txXfrm>
    </dsp:sp>
    <dsp:sp modelId="{9D2B4FF6-13FB-EF49-977A-31DF5EE58099}">
      <dsp:nvSpPr>
        <dsp:cNvPr id="0" name=""/>
        <dsp:cNvSpPr/>
      </dsp:nvSpPr>
      <dsp:spPr>
        <a:xfrm rot="5400000">
          <a:off x="1202530" y="3132432"/>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Give space</a:t>
          </a:r>
        </a:p>
      </dsp:txBody>
      <dsp:txXfrm rot="-5400000">
        <a:off x="692728" y="3664458"/>
        <a:ext cx="1452636" cy="410807"/>
      </dsp:txXfrm>
    </dsp:sp>
    <dsp:sp modelId="{B67BA8B7-08DC-C244-8300-FCD547033DBD}">
      <dsp:nvSpPr>
        <dsp:cNvPr id="0" name=""/>
        <dsp:cNvSpPr/>
      </dsp:nvSpPr>
      <dsp:spPr>
        <a:xfrm>
          <a:off x="136881" y="3585328"/>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7</a:t>
          </a:r>
        </a:p>
      </dsp:txBody>
      <dsp:txXfrm>
        <a:off x="164015" y="3612462"/>
        <a:ext cx="501578" cy="514801"/>
      </dsp:txXfrm>
    </dsp:sp>
    <dsp:sp modelId="{8CF3EAF4-8574-9841-9B3E-4FBF8CB57172}">
      <dsp:nvSpPr>
        <dsp:cNvPr id="0" name=""/>
        <dsp:cNvSpPr/>
      </dsp:nvSpPr>
      <dsp:spPr>
        <a:xfrm rot="5400000">
          <a:off x="1202530" y="3729956"/>
          <a:ext cx="455255" cy="1474860"/>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9530" tIns="24765" rIns="49530" bIns="24765"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eek support</a:t>
          </a:r>
        </a:p>
      </dsp:txBody>
      <dsp:txXfrm rot="-5400000">
        <a:off x="692728" y="4261982"/>
        <a:ext cx="1452636" cy="410807"/>
      </dsp:txXfrm>
    </dsp:sp>
    <dsp:sp modelId="{D5D04DA4-D0C2-DE47-8C8C-0B8EFFA304FE}">
      <dsp:nvSpPr>
        <dsp:cNvPr id="0" name=""/>
        <dsp:cNvSpPr/>
      </dsp:nvSpPr>
      <dsp:spPr>
        <a:xfrm>
          <a:off x="136881" y="4182851"/>
          <a:ext cx="555846" cy="56906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57150" rIns="114300" bIns="57150" numCol="1" spcCol="1270" anchor="ctr" anchorCtr="0">
          <a:noAutofit/>
        </a:bodyPr>
        <a:lstStyle/>
        <a:p>
          <a:pPr marL="0" lvl="0" indent="0" algn="ctr" defTabSz="1333500">
            <a:lnSpc>
              <a:spcPct val="90000"/>
            </a:lnSpc>
            <a:spcBef>
              <a:spcPct val="0"/>
            </a:spcBef>
            <a:spcAft>
              <a:spcPct val="35000"/>
            </a:spcAft>
            <a:buNone/>
          </a:pPr>
          <a:r>
            <a:rPr lang="en-US" sz="3000" kern="1200" dirty="0"/>
            <a:t>8</a:t>
          </a:r>
        </a:p>
      </dsp:txBody>
      <dsp:txXfrm>
        <a:off x="164015" y="4209985"/>
        <a:ext cx="501578" cy="514801"/>
      </dsp:txXfrm>
    </dsp:sp>
  </dsp:spTree>
</dsp:drawing>
</file>

<file path=ppt/diagrams/layout1.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10.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11.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12.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9"/>
        <p:cNvGrpSpPr/>
        <p:nvPr/>
      </p:nvGrpSpPr>
      <p:grpSpPr>
        <a:xfrm>
          <a:off x="0" y="0"/>
          <a:ext cx="0" cy="0"/>
          <a:chOff x="0" y="0"/>
          <a:chExt cx="0" cy="0"/>
        </a:xfrm>
      </p:grpSpPr>
      <p:sp>
        <p:nvSpPr>
          <p:cNvPr id="90" name="Google Shape;90;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1" name="Google Shape;91;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800" dirty="0">
                <a:effectLst/>
                <a:latin typeface="Calibri" panose="020F0502020204030204" pitchFamily="34" charset="0"/>
                <a:ea typeface="Calibri" panose="020F0502020204030204" pitchFamily="34" charset="0"/>
              </a:rPr>
              <a:t>These are the slides that accompany the </a:t>
            </a:r>
            <a:r>
              <a:rPr lang="en-US" sz="1800" dirty="0" err="1">
                <a:effectLst/>
                <a:latin typeface="Calibri" panose="020F0502020204030204" pitchFamily="34" charset="0"/>
                <a:ea typeface="Calibri" panose="020F0502020204030204" pitchFamily="34" charset="0"/>
              </a:rPr>
              <a:t>MedEdPORTAL</a:t>
            </a:r>
            <a:r>
              <a:rPr lang="en-US" sz="1800" dirty="0">
                <a:effectLst/>
                <a:latin typeface="Calibri" panose="020F0502020204030204" pitchFamily="34" charset="0"/>
                <a:ea typeface="Calibri" panose="020F0502020204030204" pitchFamily="34" charset="0"/>
              </a:rPr>
              <a:t> workshop: </a:t>
            </a:r>
            <a:r>
              <a:rPr lang="en-US" sz="1800" u="none" dirty="0">
                <a:solidFill>
                  <a:srgbClr val="008080"/>
                </a:solidFill>
                <a:effectLst/>
                <a:latin typeface="Calibri" panose="020F0502020204030204" pitchFamily="34" charset="0"/>
                <a:ea typeface="Calibri" panose="020F0502020204030204" pitchFamily="34" charset="0"/>
              </a:rPr>
              <a:t>Responding to Bias: Equipping Residents with Tools to Address Microaggressions</a:t>
            </a:r>
            <a:r>
              <a:rPr lang="en-US" sz="1800" u="none" dirty="0">
                <a:effectLst/>
                <a:latin typeface="Calibri" panose="020F0502020204030204" pitchFamily="34" charset="0"/>
                <a:ea typeface="Calibri" panose="020F0502020204030204" pitchFamily="34" charset="0"/>
              </a:rPr>
              <a:t>.</a:t>
            </a:r>
            <a:r>
              <a:rPr lang="en-US" sz="2400" u="none" dirty="0">
                <a:effectLst/>
              </a:rPr>
              <a:t> </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sz="2400" u="none" dirty="0">
              <a:effectLst/>
            </a:endParaRP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altLang="x-none" sz="1600" kern="1200" baseline="0" dirty="0">
              <a:solidFill>
                <a:srgbClr val="FF0000"/>
              </a:solidFill>
              <a:latin typeface="Verdana" pitchFamily="1" charset="0"/>
              <a:ea typeface="+mn-ea"/>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altLang="x-none" sz="1600" kern="1200" baseline="0" dirty="0">
                <a:solidFill>
                  <a:srgbClr val="FF0000"/>
                </a:solidFill>
                <a:latin typeface="Verdana" pitchFamily="1" charset="0"/>
                <a:ea typeface="+mn-ea"/>
                <a:cs typeface="+mn-cs"/>
              </a:rPr>
              <a:t>Presenters can introduce themselves, acknowledge their identities, the privilege those identities confer, and their role as facilitator and co-learner in this discussion. Read the workshop title and express that if participants lean in and are vulnerable and open, growth will follow over the 45-minute session. </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altLang="x-none" sz="1600" kern="1200" baseline="0" dirty="0">
              <a:solidFill>
                <a:srgbClr val="FF0000"/>
              </a:solidFill>
              <a:latin typeface="Verdana" pitchFamily="1" charset="0"/>
              <a:ea typeface="+mn-ea"/>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altLang="x-none" sz="1600" kern="1200" baseline="0" dirty="0">
                <a:solidFill>
                  <a:srgbClr val="FF0000"/>
                </a:solidFill>
                <a:latin typeface="Verdana" pitchFamily="1" charset="0"/>
                <a:ea typeface="+mn-ea"/>
                <a:cs typeface="+mn-cs"/>
              </a:rPr>
              <a:t>If using a polling software to collect pre/post workshop data, a QR code and/or link to polling software can be placed on the upper right corner of the slide so attendees can start their pre-intervention survey. Presenters should introduce this survey– to assess the workshop’s ability to build attendee confidence in responding to patient bias-towards-self and bias-towards-others. Encourage true responses so the workshop can be improved. They should request that attendees leave this polling application open to allow for both intra-presentation engagement as well as post-intervention survey.</a:t>
            </a:r>
            <a:endParaRPr lang="x-none" altLang="x-none" sz="1600" kern="1200" dirty="0">
              <a:solidFill>
                <a:schemeClr val="tx1"/>
              </a:solidFill>
              <a:latin typeface="Verdana" pitchFamily="1" charset="0"/>
              <a:ea typeface="+mn-ea"/>
              <a:cs typeface="+mn-cs"/>
            </a:endParaRPr>
          </a:p>
        </p:txBody>
      </p:sp>
      <p:sp>
        <p:nvSpPr>
          <p:cNvPr id="92" name="Google Shape;92;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c473988d5b_0_8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gc473988d5b_0_81: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Here presenters show the full toolkit. In the following slides the presenter will walk through step by step and offer suggested language for each step. Remind learners that this toolkit is designed to be applied when responding to both </a:t>
            </a:r>
            <a:r>
              <a:rPr lang="en-US" altLang="x-none" sz="1200" kern="1200" baseline="0" dirty="0">
                <a:solidFill>
                  <a:srgbClr val="FF0000"/>
                </a:solidFill>
                <a:latin typeface="Verdana" pitchFamily="1" charset="0"/>
                <a:ea typeface="+mn-ea"/>
                <a:cs typeface="+mn-cs"/>
              </a:rPr>
              <a:t>patient bias-towards-self and bias-towards-others.</a:t>
            </a:r>
            <a:endParaRPr lang="en-US" dirty="0"/>
          </a:p>
          <a:p>
            <a:pPr marL="228600" lvl="0" indent="-241300" algn="l" rtl="0">
              <a:spcBef>
                <a:spcPts val="0"/>
              </a:spcBef>
              <a:spcAft>
                <a:spcPts val="0"/>
              </a:spcAft>
              <a:buSzPts val="1400"/>
              <a:buAutoNum type="arabicPeriod"/>
            </a:pPr>
            <a:endParaRPr dirty="0"/>
          </a:p>
        </p:txBody>
      </p:sp>
      <p:sp>
        <p:nvSpPr>
          <p:cNvPr id="165" name="Google Shape;165;gc473988d5b_0_81: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extLst>
      <p:ext uri="{BB962C8B-B14F-4D97-AF65-F5344CB8AC3E}">
        <p14:creationId xmlns:p14="http://schemas.microsoft.com/office/powerpoint/2010/main" val="257974836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c473988d5b_0_8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gc473988d5b_0_81: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is the first step in the toolkit. Presenters can change the slide formatting so each option appears as they speak if so desired. The presenter can read the following:</a:t>
            </a:r>
          </a:p>
          <a:p>
            <a:pPr marL="0" lvl="0" indent="0" algn="l" rtl="0">
              <a:spcBef>
                <a:spcPts val="0"/>
              </a:spcBef>
              <a:spcAft>
                <a:spcPts val="0"/>
              </a:spcAft>
              <a:buNone/>
            </a:pPr>
            <a:endParaRPr lang="en-US" dirty="0"/>
          </a:p>
          <a:p>
            <a:pPr marL="0" lvl="0" indent="0" algn="l" rtl="0">
              <a:lnSpc>
                <a:spcPct val="115000"/>
              </a:lnSpc>
              <a:spcBef>
                <a:spcPts val="1200"/>
              </a:spcBef>
              <a:spcAft>
                <a:spcPts val="0"/>
              </a:spcAft>
              <a:buClr>
                <a:schemeClr val="dk1"/>
              </a:buClr>
              <a:buSzPts val="1200"/>
              <a:buFont typeface="Calibri"/>
              <a:buNone/>
            </a:pPr>
            <a:r>
              <a:rPr lang="en-US" dirty="0"/>
              <a:t>“Step 1: Ask yourself, is the patient stable? If the patient is saying inappropriate things because they are unstable and </a:t>
            </a:r>
            <a:r>
              <a:rPr lang="en-US" dirty="0" err="1"/>
              <a:t>hypoperfusing</a:t>
            </a:r>
            <a:r>
              <a:rPr lang="en-US" dirty="0"/>
              <a:t> their brain, call for help. Maybe they are crossing a boundary and acutely ill. In this case do no harm first and advance their care. Once help arrives, if you need to step out, communicate that to your team and excuse yourself. If you can continue to care for the patient, do so.</a:t>
            </a:r>
          </a:p>
          <a:p>
            <a:pPr marL="0" lvl="0" indent="0" algn="l" rtl="0">
              <a:lnSpc>
                <a:spcPct val="115000"/>
              </a:lnSpc>
              <a:spcBef>
                <a:spcPts val="1200"/>
              </a:spcBef>
              <a:spcAft>
                <a:spcPts val="0"/>
              </a:spcAft>
              <a:buClr>
                <a:schemeClr val="dk1"/>
              </a:buClr>
              <a:buSzPts val="1200"/>
              <a:buFont typeface="Calibri"/>
              <a:buNone/>
            </a:pPr>
            <a:r>
              <a:rPr lang="en-US" dirty="0"/>
              <a:t>If the patient is stable, ask yourself if the patient is altered. If the patient is altered, they likely cannot engage in conversation about bias or be held to a behavioral contract. In these challenging scenarios, consider redirection away from topic of the bias and lean on team debriefs for support. Consider adjusting the staffing model for the patient to protect the target of bias as resources allow. If the patient is stable and is not altered, procced with the toolkit.”</a:t>
            </a:r>
          </a:p>
          <a:p>
            <a:pPr marL="228600" lvl="0" indent="-241300" algn="l" rtl="0">
              <a:spcBef>
                <a:spcPts val="0"/>
              </a:spcBef>
              <a:spcAft>
                <a:spcPts val="0"/>
              </a:spcAft>
              <a:buSzPts val="1400"/>
              <a:buAutoNum type="arabicPeriod"/>
            </a:pPr>
            <a:endParaRPr dirty="0"/>
          </a:p>
        </p:txBody>
      </p:sp>
      <p:sp>
        <p:nvSpPr>
          <p:cNvPr id="165" name="Google Shape;165;gc473988d5b_0_81: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extLst>
      <p:ext uri="{BB962C8B-B14F-4D97-AF65-F5344CB8AC3E}">
        <p14:creationId xmlns:p14="http://schemas.microsoft.com/office/powerpoint/2010/main" val="239780934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a:extLst>
            <a:ext uri="{FF2B5EF4-FFF2-40B4-BE49-F238E27FC236}">
              <a16:creationId xmlns:a16="http://schemas.microsoft.com/office/drawing/2014/main" id="{4610ADF6-FEF1-76BC-5141-01CAE486D4D4}"/>
            </a:ext>
          </a:extLst>
        </p:cNvPr>
        <p:cNvGrpSpPr/>
        <p:nvPr/>
      </p:nvGrpSpPr>
      <p:grpSpPr>
        <a:xfrm>
          <a:off x="0" y="0"/>
          <a:ext cx="0" cy="0"/>
          <a:chOff x="0" y="0"/>
          <a:chExt cx="0" cy="0"/>
        </a:xfrm>
      </p:grpSpPr>
      <p:sp>
        <p:nvSpPr>
          <p:cNvPr id="163" name="Google Shape;163;gc473988d5b_0_81:notes">
            <a:extLst>
              <a:ext uri="{FF2B5EF4-FFF2-40B4-BE49-F238E27FC236}">
                <a16:creationId xmlns:a16="http://schemas.microsoft.com/office/drawing/2014/main" id="{4BC22472-A56A-8073-9B94-2336EF662867}"/>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gc473988d5b_0_81:notes">
            <a:extLst>
              <a:ext uri="{FF2B5EF4-FFF2-40B4-BE49-F238E27FC236}">
                <a16:creationId xmlns:a16="http://schemas.microsoft.com/office/drawing/2014/main" id="{2604D8F1-AAB6-F68B-0C0A-9F120E002D3B}"/>
              </a:ext>
            </a:extLst>
          </p:cNvPr>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expands on the first step in the toolkit. Presenters spend a minute reviewing some techniques to redirect in the room and debrief if the patient is altered from an underlying medical condition and is unlikely to change their behavior or respond to the toolkit:</a:t>
            </a:r>
          </a:p>
          <a:p>
            <a:pPr marL="0" lvl="0" indent="0" algn="l" rtl="0">
              <a:spcBef>
                <a:spcPts val="0"/>
              </a:spcBef>
              <a:spcAft>
                <a:spcPts val="0"/>
              </a:spcAft>
              <a:buNone/>
            </a:pPr>
            <a:endParaRPr lang="en-US" dirty="0"/>
          </a:p>
          <a:p>
            <a:pPr marL="0" lvl="0" indent="0" algn="l" rtl="0">
              <a:lnSpc>
                <a:spcPct val="115000"/>
              </a:lnSpc>
              <a:spcBef>
                <a:spcPts val="1200"/>
              </a:spcBef>
              <a:spcAft>
                <a:spcPts val="0"/>
              </a:spcAft>
              <a:buClr>
                <a:schemeClr val="dk1"/>
              </a:buClr>
              <a:buSzPts val="1200"/>
              <a:buFont typeface="Calibri"/>
              <a:buNone/>
            </a:pPr>
            <a:r>
              <a:rPr lang="en-US" dirty="0"/>
              <a:t>“What do you do if the patient is altered and saying inappropriate things? In these challenging scenarios, consider redirection away from topic of the bias. Though it may not modify behavior,</a:t>
            </a:r>
            <a:r>
              <a:rPr lang="en-US" sz="1200" dirty="0"/>
              <a:t> if it helps you can always tell the patient that their language is inappropriate, unless you are worried that establishing a boundary will escalate their behavior/language. </a:t>
            </a:r>
            <a:r>
              <a:rPr lang="en-US" dirty="0"/>
              <a:t> ”</a:t>
            </a:r>
            <a:endParaRPr dirty="0"/>
          </a:p>
        </p:txBody>
      </p:sp>
      <p:sp>
        <p:nvSpPr>
          <p:cNvPr id="165" name="Google Shape;165;gc473988d5b_0_81:notes">
            <a:extLst>
              <a:ext uri="{FF2B5EF4-FFF2-40B4-BE49-F238E27FC236}">
                <a16:creationId xmlns:a16="http://schemas.microsoft.com/office/drawing/2014/main" id="{260A929D-2C25-B2D4-6A8F-94EE1B5943E4}"/>
              </a:ext>
            </a:extLst>
          </p:cNvPr>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extLst>
      <p:ext uri="{BB962C8B-B14F-4D97-AF65-F5344CB8AC3E}">
        <p14:creationId xmlns:p14="http://schemas.microsoft.com/office/powerpoint/2010/main" val="170245261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a:extLst>
            <a:ext uri="{FF2B5EF4-FFF2-40B4-BE49-F238E27FC236}">
              <a16:creationId xmlns:a16="http://schemas.microsoft.com/office/drawing/2014/main" id="{B0181517-1E91-582C-D9F7-3C561D526E1B}"/>
            </a:ext>
          </a:extLst>
        </p:cNvPr>
        <p:cNvGrpSpPr/>
        <p:nvPr/>
      </p:nvGrpSpPr>
      <p:grpSpPr>
        <a:xfrm>
          <a:off x="0" y="0"/>
          <a:ext cx="0" cy="0"/>
          <a:chOff x="0" y="0"/>
          <a:chExt cx="0" cy="0"/>
        </a:xfrm>
      </p:grpSpPr>
      <p:sp>
        <p:nvSpPr>
          <p:cNvPr id="163" name="Google Shape;163;gc473988d5b_0_81:notes">
            <a:extLst>
              <a:ext uri="{FF2B5EF4-FFF2-40B4-BE49-F238E27FC236}">
                <a16:creationId xmlns:a16="http://schemas.microsoft.com/office/drawing/2014/main" id="{2E907DA7-6D0E-B9D0-DA2C-360CCEECEBB4}"/>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gc473988d5b_0_81:notes">
            <a:extLst>
              <a:ext uri="{FF2B5EF4-FFF2-40B4-BE49-F238E27FC236}">
                <a16:creationId xmlns:a16="http://schemas.microsoft.com/office/drawing/2014/main" id="{0BD20A27-22A2-F131-CB41-8191E4468A92}"/>
              </a:ext>
            </a:extLst>
          </p:cNvPr>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expands on the first step in the toolkit. Presenters spend a minute reviewing some techniques to redirect in the room and debrief if the patient is altered from an underlying medical condition and is unlikely to change their behavior or respond to the toolkit:</a:t>
            </a:r>
          </a:p>
          <a:p>
            <a:pPr marL="0" lvl="0" indent="0" algn="l" rtl="0">
              <a:spcBef>
                <a:spcPts val="0"/>
              </a:spcBef>
              <a:spcAft>
                <a:spcPts val="0"/>
              </a:spcAft>
              <a:buNone/>
            </a:pPr>
            <a:endParaRPr lang="en-US" dirty="0"/>
          </a:p>
          <a:p>
            <a:pPr marL="0" lvl="0" indent="0" algn="l" rtl="0">
              <a:lnSpc>
                <a:spcPct val="115000"/>
              </a:lnSpc>
              <a:spcBef>
                <a:spcPts val="1200"/>
              </a:spcBef>
              <a:spcAft>
                <a:spcPts val="0"/>
              </a:spcAft>
              <a:buClr>
                <a:schemeClr val="dk1"/>
              </a:buClr>
              <a:buSzPts val="1200"/>
              <a:buFont typeface="Calibri"/>
              <a:buNone/>
            </a:pPr>
            <a:r>
              <a:rPr lang="en-US" dirty="0"/>
              <a:t>“What do you do if the patient is altered and saying inappropriate things? In these challenging scenarios, consider redirection away from topic of the bias and lean on team debriefs for support. Consider adjusting the staffing model for the patient to protect the target of bias as resources allow.</a:t>
            </a:r>
          </a:p>
          <a:p>
            <a:pPr marL="0" lvl="0" indent="0" algn="l" rtl="0">
              <a:lnSpc>
                <a:spcPct val="115000"/>
              </a:lnSpc>
              <a:spcBef>
                <a:spcPts val="1200"/>
              </a:spcBef>
              <a:spcAft>
                <a:spcPts val="0"/>
              </a:spcAft>
              <a:buClr>
                <a:schemeClr val="dk1"/>
              </a:buClr>
              <a:buSzPts val="1200"/>
              <a:buFont typeface="Calibri"/>
              <a:buNone/>
            </a:pPr>
            <a:r>
              <a:rPr lang="en-US" dirty="0"/>
              <a:t>If the patient is stable and is not altered, procced with the toolkit.”</a:t>
            </a:r>
          </a:p>
          <a:p>
            <a:pPr marL="228600" lvl="0" indent="-241300" algn="l" rtl="0">
              <a:spcBef>
                <a:spcPts val="0"/>
              </a:spcBef>
              <a:spcAft>
                <a:spcPts val="0"/>
              </a:spcAft>
              <a:buSzPts val="1400"/>
              <a:buAutoNum type="arabicPeriod"/>
            </a:pPr>
            <a:endParaRPr lang="en-US" dirty="0"/>
          </a:p>
        </p:txBody>
      </p:sp>
      <p:sp>
        <p:nvSpPr>
          <p:cNvPr id="165" name="Google Shape;165;gc473988d5b_0_81:notes">
            <a:extLst>
              <a:ext uri="{FF2B5EF4-FFF2-40B4-BE49-F238E27FC236}">
                <a16:creationId xmlns:a16="http://schemas.microsoft.com/office/drawing/2014/main" id="{F66E8557-E979-AA5B-E656-F0C2E40435AA}"/>
              </a:ext>
            </a:extLst>
          </p:cNvPr>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extLst>
      <p:ext uri="{BB962C8B-B14F-4D97-AF65-F5344CB8AC3E}">
        <p14:creationId xmlns:p14="http://schemas.microsoft.com/office/powerpoint/2010/main" val="7770714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c473988d5b_0_8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gc473988d5b_0_81: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is the 2</a:t>
            </a:r>
            <a:r>
              <a:rPr lang="en-US" baseline="30000" dirty="0"/>
              <a:t>nd</a:t>
            </a:r>
            <a:r>
              <a:rPr lang="en-US" dirty="0"/>
              <a:t> step in the toolkit. The presenter can read the following:</a:t>
            </a:r>
          </a:p>
          <a:p>
            <a:pPr marL="0" lvl="0" indent="0" algn="l" rtl="0">
              <a:spcBef>
                <a:spcPts val="0"/>
              </a:spcBef>
              <a:spcAft>
                <a:spcPts val="0"/>
              </a:spcAft>
              <a:buNone/>
            </a:pPr>
            <a:endParaRPr lang="en-US" dirty="0"/>
          </a:p>
          <a:p>
            <a:pPr marL="0" lvl="0" indent="0" algn="l" rtl="0">
              <a:lnSpc>
                <a:spcPct val="115000"/>
              </a:lnSpc>
              <a:spcBef>
                <a:spcPts val="0"/>
              </a:spcBef>
              <a:spcAft>
                <a:spcPts val="0"/>
              </a:spcAft>
              <a:buClr>
                <a:schemeClr val="dk1"/>
              </a:buClr>
              <a:buSzPts val="1200"/>
              <a:buFont typeface="Calibri"/>
              <a:buNone/>
            </a:pPr>
            <a:r>
              <a:rPr lang="en-US" dirty="0"/>
              <a:t>“Step 2: Check your emotions and psychological safety. If you are not in a good headspace to respond, it is okay to step out of the situation to process it and to ask for support in responding. We will go over resources for support at the end of the workshop”</a:t>
            </a:r>
          </a:p>
        </p:txBody>
      </p:sp>
      <p:sp>
        <p:nvSpPr>
          <p:cNvPr id="165" name="Google Shape;165;gc473988d5b_0_81: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4</a:t>
            </a:fld>
            <a:endParaRPr/>
          </a:p>
        </p:txBody>
      </p:sp>
    </p:spTree>
    <p:extLst>
      <p:ext uri="{BB962C8B-B14F-4D97-AF65-F5344CB8AC3E}">
        <p14:creationId xmlns:p14="http://schemas.microsoft.com/office/powerpoint/2010/main" val="139876671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c473988d5b_0_8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gc473988d5b_0_81: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is the 3rd step in the toolkit. The presenter can read the following:</a:t>
            </a:r>
          </a:p>
          <a:p>
            <a:pPr marL="0" lvl="0" indent="0" algn="l" rtl="0">
              <a:spcBef>
                <a:spcPts val="0"/>
              </a:spcBef>
              <a:spcAft>
                <a:spcPts val="0"/>
              </a:spcAft>
              <a:buNone/>
            </a:pPr>
            <a:endParaRPr lang="en-US" dirty="0"/>
          </a:p>
          <a:p>
            <a:pPr marL="0" lvl="0" indent="0" algn="l" rtl="0">
              <a:lnSpc>
                <a:spcPct val="115000"/>
              </a:lnSpc>
              <a:spcBef>
                <a:spcPts val="0"/>
              </a:spcBef>
              <a:spcAft>
                <a:spcPts val="0"/>
              </a:spcAft>
              <a:buClr>
                <a:schemeClr val="dk1"/>
              </a:buClr>
              <a:buSzPts val="1200"/>
              <a:buFont typeface="Calibri"/>
              <a:buNone/>
            </a:pPr>
            <a:r>
              <a:rPr lang="en-US" dirty="0"/>
              <a:t>“Step 3: If you do choose to respond, address how the microaggression/behavior/language impacted you. For example, “That’s frustrating to hear from a patient.” “It’s hard to hear you say that.” “I’m disappointed you’d say that.” </a:t>
            </a:r>
          </a:p>
          <a:p>
            <a:pPr marL="0" lvl="0" indent="0" algn="l" rtl="0">
              <a:lnSpc>
                <a:spcPct val="115000"/>
              </a:lnSpc>
              <a:spcBef>
                <a:spcPts val="0"/>
              </a:spcBef>
              <a:spcAft>
                <a:spcPts val="0"/>
              </a:spcAft>
              <a:buClr>
                <a:schemeClr val="dk1"/>
              </a:buClr>
              <a:buSzPts val="1200"/>
              <a:buFont typeface="Calibri"/>
              <a:buNone/>
            </a:pPr>
            <a:endParaRPr lang="en-US" dirty="0"/>
          </a:p>
          <a:p>
            <a:pPr marL="0" lvl="0" indent="0" algn="l" rtl="0">
              <a:lnSpc>
                <a:spcPct val="115000"/>
              </a:lnSpc>
              <a:spcBef>
                <a:spcPts val="0"/>
              </a:spcBef>
              <a:spcAft>
                <a:spcPts val="0"/>
              </a:spcAft>
              <a:buClr>
                <a:schemeClr val="dk1"/>
              </a:buClr>
              <a:buSzPts val="1200"/>
              <a:buFont typeface="Calibri"/>
              <a:buNone/>
            </a:pPr>
            <a:r>
              <a:rPr lang="en-US" dirty="0"/>
              <a:t>In responding to bias-towards-self, you can be curious and ask, “What do you mean by that?”</a:t>
            </a:r>
          </a:p>
          <a:p>
            <a:pPr marL="0" lvl="0" indent="0" algn="l" rtl="0">
              <a:spcBef>
                <a:spcPts val="0"/>
              </a:spcBef>
              <a:spcAft>
                <a:spcPts val="0"/>
              </a:spcAft>
              <a:buSzPts val="1400"/>
              <a:buNone/>
            </a:pPr>
            <a:endParaRPr lang="en-US" dirty="0"/>
          </a:p>
          <a:p>
            <a:pPr marL="0" lvl="0" indent="0" algn="l" rtl="0">
              <a:spcBef>
                <a:spcPts val="0"/>
              </a:spcBef>
              <a:spcAft>
                <a:spcPts val="0"/>
              </a:spcAft>
              <a:buSzPts val="1400"/>
              <a:buNone/>
            </a:pPr>
            <a:r>
              <a:rPr lang="en-US" dirty="0"/>
              <a:t>Please note that here we will usually comment that there are certain types of bias, particularly overt bias, where curiosity is may not be an appropriate response when responding to bias-towards-others as you can cause further injury to the target of the bias by exploring why someone is using language that is not appropriate—it may beget more bias.</a:t>
            </a:r>
          </a:p>
          <a:p>
            <a:pPr marL="228600" lvl="0" indent="-241300" algn="l" rtl="0">
              <a:spcBef>
                <a:spcPts val="0"/>
              </a:spcBef>
              <a:spcAft>
                <a:spcPts val="0"/>
              </a:spcAft>
              <a:buSzPts val="1400"/>
              <a:buAutoNum type="arabicPeriod"/>
            </a:pPr>
            <a:endParaRPr dirty="0"/>
          </a:p>
        </p:txBody>
      </p:sp>
      <p:sp>
        <p:nvSpPr>
          <p:cNvPr id="165" name="Google Shape;165;gc473988d5b_0_81: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5</a:t>
            </a:fld>
            <a:endParaRPr/>
          </a:p>
        </p:txBody>
      </p:sp>
    </p:spTree>
    <p:extLst>
      <p:ext uri="{BB962C8B-B14F-4D97-AF65-F5344CB8AC3E}">
        <p14:creationId xmlns:p14="http://schemas.microsoft.com/office/powerpoint/2010/main" val="129212243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c473988d5b_0_8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gc473988d5b_0_81: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is the 4th step in the toolkit. The presenter can read the following:</a:t>
            </a:r>
          </a:p>
          <a:p>
            <a:pPr marL="0" lvl="0" indent="0" algn="l" rtl="0">
              <a:lnSpc>
                <a:spcPct val="115000"/>
              </a:lnSpc>
              <a:spcBef>
                <a:spcPts val="0"/>
              </a:spcBef>
              <a:spcAft>
                <a:spcPts val="0"/>
              </a:spcAft>
              <a:buClr>
                <a:schemeClr val="dk1"/>
              </a:buClr>
              <a:buSzPts val="1200"/>
              <a:buFont typeface="Calibri"/>
              <a:buNone/>
            </a:pPr>
            <a:br>
              <a:rPr lang="en-US" dirty="0"/>
            </a:br>
            <a:r>
              <a:rPr lang="en-US" dirty="0"/>
              <a:t>“Step 4: Align with your team. </a:t>
            </a:r>
            <a:r>
              <a:rPr lang="en-US" sz="1800" dirty="0">
                <a:effectLst/>
                <a:latin typeface="Calibri" panose="020F0502020204030204" pitchFamily="34" charset="0"/>
                <a:ea typeface="Calibri" panose="020F0502020204030204" pitchFamily="34" charset="0"/>
              </a:rPr>
              <a:t>It is especially important to present a united front when responding to bias-towards-others</a:t>
            </a:r>
            <a:r>
              <a:rPr lang="en-US" dirty="0"/>
              <a:t>. Examples could be, “Our team is doing our best to respect you. We ask that you respect Dr. ___/me as well.”</a:t>
            </a:r>
          </a:p>
          <a:p>
            <a:pPr marL="0" lvl="0" indent="0" algn="l" rtl="0">
              <a:lnSpc>
                <a:spcPct val="115000"/>
              </a:lnSpc>
              <a:spcBef>
                <a:spcPts val="0"/>
              </a:spcBef>
              <a:spcAft>
                <a:spcPts val="0"/>
              </a:spcAft>
              <a:buClr>
                <a:schemeClr val="dk1"/>
              </a:buClr>
              <a:buSzPts val="1200"/>
              <a:buFont typeface="Calibri"/>
              <a:buNone/>
            </a:pPr>
            <a:endParaRPr lang="en-US" dirty="0"/>
          </a:p>
          <a:p>
            <a:pPr marL="0" lvl="0" indent="0" algn="l" rtl="0">
              <a:lnSpc>
                <a:spcPct val="115000"/>
              </a:lnSpc>
              <a:spcBef>
                <a:spcPts val="0"/>
              </a:spcBef>
              <a:spcAft>
                <a:spcPts val="0"/>
              </a:spcAft>
              <a:buClr>
                <a:schemeClr val="dk1"/>
              </a:buClr>
              <a:buSzPts val="1200"/>
              <a:buFont typeface="Calibri"/>
              <a:buNone/>
            </a:pPr>
            <a:r>
              <a:rPr lang="en-US" dirty="0"/>
              <a:t>When responding to bias-towards-others, consider going a step further and adding in a microaffirmation. If your colleague has been verbally put down, you can lift them up.”</a:t>
            </a:r>
          </a:p>
          <a:p>
            <a:pPr marL="228600" lvl="0" indent="-241300" algn="l" rtl="0">
              <a:spcBef>
                <a:spcPts val="0"/>
              </a:spcBef>
              <a:spcAft>
                <a:spcPts val="0"/>
              </a:spcAft>
              <a:buSzPts val="1400"/>
              <a:buAutoNum type="arabicPeriod"/>
            </a:pPr>
            <a:endParaRPr dirty="0"/>
          </a:p>
        </p:txBody>
      </p:sp>
      <p:sp>
        <p:nvSpPr>
          <p:cNvPr id="165" name="Google Shape;165;gc473988d5b_0_81: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a:p>
        </p:txBody>
      </p:sp>
    </p:spTree>
    <p:extLst>
      <p:ext uri="{BB962C8B-B14F-4D97-AF65-F5344CB8AC3E}">
        <p14:creationId xmlns:p14="http://schemas.microsoft.com/office/powerpoint/2010/main" val="413853308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c473988d5b_0_8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gc473988d5b_0_81: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is the 5</a:t>
            </a:r>
            <a:r>
              <a:rPr lang="en-US" baseline="30000" dirty="0"/>
              <a:t>th</a:t>
            </a:r>
            <a:r>
              <a:rPr lang="en-US" dirty="0"/>
              <a:t> step in the toolkit. The presenter can read the following:</a:t>
            </a:r>
          </a:p>
          <a:p>
            <a:pPr marL="0" lvl="0" indent="0" algn="l" rtl="0">
              <a:spcBef>
                <a:spcPts val="0"/>
              </a:spcBef>
              <a:spcAft>
                <a:spcPts val="0"/>
              </a:spcAft>
              <a:buNone/>
            </a:pPr>
            <a:endParaRPr lang="en-US" dirty="0"/>
          </a:p>
          <a:p>
            <a:pPr marL="0" lvl="0" indent="0" algn="l" rtl="0">
              <a:lnSpc>
                <a:spcPct val="115000"/>
              </a:lnSpc>
              <a:spcBef>
                <a:spcPts val="0"/>
              </a:spcBef>
              <a:spcAft>
                <a:spcPts val="0"/>
              </a:spcAft>
              <a:buClr>
                <a:schemeClr val="dk1"/>
              </a:buClr>
              <a:buSzPts val="1200"/>
              <a:buFont typeface="Calibri"/>
              <a:buNone/>
            </a:pPr>
            <a:r>
              <a:rPr lang="en-US" dirty="0"/>
              <a:t>“Step 5 is to set boundaries and expectations. This will vary by context, but common examples include a clear request “I’d ask that you refrain from commenting on ___.” or “Please call them/me Dr.___.” You can redirect with “Let’s keep the focus on you.” </a:t>
            </a:r>
          </a:p>
          <a:p>
            <a:pPr marL="0" lvl="0" indent="0" algn="l" rtl="0">
              <a:lnSpc>
                <a:spcPct val="115000"/>
              </a:lnSpc>
              <a:spcBef>
                <a:spcPts val="0"/>
              </a:spcBef>
              <a:spcAft>
                <a:spcPts val="0"/>
              </a:spcAft>
              <a:buClr>
                <a:schemeClr val="dk1"/>
              </a:buClr>
              <a:buSzPts val="1200"/>
              <a:buFont typeface="Calibri"/>
              <a:buNone/>
            </a:pPr>
            <a:endParaRPr lang="en-US" dirty="0"/>
          </a:p>
          <a:p>
            <a:pPr marL="0" lvl="0" indent="0" algn="l" rtl="0">
              <a:lnSpc>
                <a:spcPct val="115000"/>
              </a:lnSpc>
              <a:spcBef>
                <a:spcPts val="0"/>
              </a:spcBef>
              <a:spcAft>
                <a:spcPts val="0"/>
              </a:spcAft>
              <a:buClr>
                <a:schemeClr val="dk1"/>
              </a:buClr>
              <a:buSzPts val="1200"/>
              <a:buFont typeface="Calibri"/>
              <a:buNone/>
            </a:pPr>
            <a:r>
              <a:rPr lang="en-US" dirty="0"/>
              <a:t>You can establish institutional practice such as “Our institution doesn’t tolerate that behavior/language/etc.” Or “we do not accommodate staff changes based on [race/ethnicity/religion/</a:t>
            </a:r>
            <a:r>
              <a:rPr lang="en-US" dirty="0" err="1"/>
              <a:t>etc</a:t>
            </a:r>
            <a:r>
              <a:rPr lang="en-US" dirty="0"/>
              <a:t>], Dr. __/I will be in charge of your care today.” Whatever boundaries you establish need to be communicated to all providers involved in the patients care.”</a:t>
            </a:r>
          </a:p>
          <a:p>
            <a:pPr marL="228600" lvl="0" indent="-241300" algn="l" rtl="0">
              <a:spcBef>
                <a:spcPts val="0"/>
              </a:spcBef>
              <a:spcAft>
                <a:spcPts val="0"/>
              </a:spcAft>
              <a:buSzPts val="1400"/>
              <a:buAutoNum type="arabicPeriod"/>
            </a:pPr>
            <a:endParaRPr dirty="0"/>
          </a:p>
        </p:txBody>
      </p:sp>
      <p:sp>
        <p:nvSpPr>
          <p:cNvPr id="165" name="Google Shape;165;gc473988d5b_0_81: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extLst>
      <p:ext uri="{BB962C8B-B14F-4D97-AF65-F5344CB8AC3E}">
        <p14:creationId xmlns:p14="http://schemas.microsoft.com/office/powerpoint/2010/main" val="287311484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c473988d5b_0_8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gc473988d5b_0_81: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is the 6th step in the toolkit. The presenter can read the following:</a:t>
            </a:r>
          </a:p>
          <a:p>
            <a:pPr marL="0" lvl="0" indent="0" algn="l" rtl="0">
              <a:spcBef>
                <a:spcPts val="0"/>
              </a:spcBef>
              <a:spcAft>
                <a:spcPts val="0"/>
              </a:spcAft>
              <a:buNone/>
            </a:pPr>
            <a:endParaRPr lang="en-US" dirty="0"/>
          </a:p>
          <a:p>
            <a:pPr marL="0" marR="0" lvl="0" indent="0" algn="l" defTabSz="914400" rtl="0" eaLnBrk="1" fontAlgn="auto" latinLnBrk="0" hangingPunct="1">
              <a:lnSpc>
                <a:spcPct val="115000"/>
              </a:lnSpc>
              <a:spcBef>
                <a:spcPts val="0"/>
              </a:spcBef>
              <a:spcAft>
                <a:spcPts val="0"/>
              </a:spcAft>
              <a:buClr>
                <a:schemeClr val="dk1"/>
              </a:buClr>
              <a:buSzPts val="1200"/>
              <a:buFont typeface="Calibri"/>
              <a:buNone/>
              <a:tabLst/>
              <a:defRPr/>
            </a:pPr>
            <a:r>
              <a:rPr lang="en-US" dirty="0"/>
              <a:t>“Step 6 is to recenter on patient care. E</a:t>
            </a:r>
            <a:r>
              <a:rPr lang="en-US" sz="1800" dirty="0">
                <a:effectLst/>
                <a:latin typeface="Calibri" panose="020F0502020204030204" pitchFamily="34" charset="0"/>
                <a:ea typeface="Calibri" panose="020F0502020204030204" pitchFamily="34" charset="0"/>
              </a:rPr>
              <a:t>stablish a mutual goal with the patient</a:t>
            </a:r>
            <a:r>
              <a:rPr lang="en-US" dirty="0"/>
              <a:t>. Do not worry; by setting boundaries or calling out behaviors, transitioning back to patient care can be a simple pivot. “Our team is here to focus on your health.” Or </a:t>
            </a:r>
            <a:r>
              <a:rPr lang="en-US" sz="1200" dirty="0"/>
              <a:t>“Our goal, like yours, is to ______.”</a:t>
            </a:r>
            <a:endParaRPr lang="en-US" dirty="0"/>
          </a:p>
          <a:p>
            <a:pPr marL="228600" lvl="0" indent="-241300" algn="l" rtl="0">
              <a:spcBef>
                <a:spcPts val="0"/>
              </a:spcBef>
              <a:spcAft>
                <a:spcPts val="0"/>
              </a:spcAft>
              <a:buSzPts val="1400"/>
              <a:buAutoNum type="arabicPeriod"/>
            </a:pPr>
            <a:endParaRPr dirty="0"/>
          </a:p>
        </p:txBody>
      </p:sp>
      <p:sp>
        <p:nvSpPr>
          <p:cNvPr id="165" name="Google Shape;165;gc473988d5b_0_81: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8</a:t>
            </a:fld>
            <a:endParaRPr/>
          </a:p>
        </p:txBody>
      </p:sp>
    </p:spTree>
    <p:extLst>
      <p:ext uri="{BB962C8B-B14F-4D97-AF65-F5344CB8AC3E}">
        <p14:creationId xmlns:p14="http://schemas.microsoft.com/office/powerpoint/2010/main" val="142382327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c473988d5b_0_8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gc473988d5b_0_81: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is the 7</a:t>
            </a:r>
            <a:r>
              <a:rPr lang="en-US" baseline="30000" dirty="0"/>
              <a:t>th</a:t>
            </a:r>
            <a:r>
              <a:rPr lang="en-US" dirty="0"/>
              <a:t> step in the toolkit. The presenter can read the following:</a:t>
            </a:r>
          </a:p>
          <a:p>
            <a:pPr marL="0" lvl="0" indent="0" algn="l" rtl="0">
              <a:spcBef>
                <a:spcPts val="0"/>
              </a:spcBef>
              <a:spcAft>
                <a:spcPts val="0"/>
              </a:spcAft>
              <a:buNone/>
            </a:pPr>
            <a:endParaRPr lang="en-US" dirty="0"/>
          </a:p>
          <a:p>
            <a:pPr marL="0" marR="0" lvl="0" indent="0" algn="l" defTabSz="914400" rtl="0" eaLnBrk="1" fontAlgn="auto" latinLnBrk="0" hangingPunct="1">
              <a:lnSpc>
                <a:spcPct val="115000"/>
              </a:lnSpc>
              <a:spcBef>
                <a:spcPts val="0"/>
              </a:spcBef>
              <a:spcAft>
                <a:spcPts val="0"/>
              </a:spcAft>
              <a:buClr>
                <a:schemeClr val="dk1"/>
              </a:buClr>
              <a:buSzPts val="1200"/>
              <a:buFont typeface="Calibri"/>
              <a:buNone/>
              <a:tabLst/>
              <a:defRPr/>
            </a:pPr>
            <a:r>
              <a:rPr lang="en-US" dirty="0"/>
              <a:t>“Step 7 is to give space. </a:t>
            </a:r>
            <a:r>
              <a:rPr lang="en-US" sz="1800" dirty="0">
                <a:effectLst/>
                <a:latin typeface="Calibri" panose="020F0502020204030204" pitchFamily="34" charset="0"/>
                <a:ea typeface="Calibri" panose="020F0502020204030204" pitchFamily="34" charset="0"/>
                <a:cs typeface="Calibri" panose="020F0502020204030204" pitchFamily="34" charset="0"/>
              </a:rPr>
              <a:t>If tensions need diffusing between the patient and care team, step out &amp; say when to expect your return. This is also an opportunity to acknowledge patient frustration if present.</a:t>
            </a: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r>
              <a:rPr lang="en-US" dirty="0"/>
              <a:t>We are going to give you space for 15 minutes and when we come back, we can focus on your health.”</a:t>
            </a:r>
          </a:p>
          <a:p>
            <a:pPr marL="0" marR="0" lvl="0" indent="0" algn="l" defTabSz="914400" rtl="0" eaLnBrk="1" fontAlgn="auto" latinLnBrk="0" hangingPunct="1">
              <a:lnSpc>
                <a:spcPct val="115000"/>
              </a:lnSpc>
              <a:spcBef>
                <a:spcPts val="0"/>
              </a:spcBef>
              <a:spcAft>
                <a:spcPts val="0"/>
              </a:spcAft>
              <a:buClr>
                <a:schemeClr val="dk1"/>
              </a:buClr>
              <a:buSzPts val="1200"/>
              <a:buFont typeface="Calibri"/>
              <a:buNone/>
              <a:tabLst/>
              <a:defRPr/>
            </a:pPr>
            <a:endParaRPr lang="en-US" dirty="0"/>
          </a:p>
          <a:p>
            <a:pPr marL="0" marR="0" lvl="0" indent="0" algn="l" defTabSz="914400" rtl="0" eaLnBrk="1" fontAlgn="auto" latinLnBrk="0" hangingPunct="1">
              <a:lnSpc>
                <a:spcPct val="115000"/>
              </a:lnSpc>
              <a:spcBef>
                <a:spcPts val="0"/>
              </a:spcBef>
              <a:spcAft>
                <a:spcPts val="0"/>
              </a:spcAft>
              <a:buClr>
                <a:schemeClr val="dk1"/>
              </a:buClr>
              <a:buSzPts val="1200"/>
              <a:buFont typeface="Calibri"/>
              <a:buNone/>
              <a:tabLst/>
              <a:defRPr/>
            </a:pPr>
            <a:r>
              <a:rPr lang="en-US" dirty="0"/>
              <a:t>You also can utilize this if you need time to process or get help. </a:t>
            </a:r>
          </a:p>
        </p:txBody>
      </p:sp>
      <p:sp>
        <p:nvSpPr>
          <p:cNvPr id="165" name="Google Shape;165;gc473988d5b_0_81: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extLst>
      <p:ext uri="{BB962C8B-B14F-4D97-AF65-F5344CB8AC3E}">
        <p14:creationId xmlns:p14="http://schemas.microsoft.com/office/powerpoint/2010/main" val="16128209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p:cNvGrpSpPr/>
        <p:nvPr/>
      </p:nvGrpSpPr>
      <p:grpSpPr>
        <a:xfrm>
          <a:off x="0" y="0"/>
          <a:ext cx="0" cy="0"/>
          <a:chOff x="0" y="0"/>
          <a:chExt cx="0" cy="0"/>
        </a:xfrm>
      </p:grpSpPr>
      <p:sp>
        <p:nvSpPr>
          <p:cNvPr id="106" name="Google Shape;106;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This slide sets the agenda for the talk. Inform participants that you will review the background on patient bias; that there will be a warmup exercise to engage the audience in their personal experiences with bias; that a toolkit with sample language for responding to </a:t>
            </a:r>
            <a:r>
              <a:rPr lang="en-US" altLang="x-none" sz="1200" kern="1200" baseline="0" dirty="0">
                <a:solidFill>
                  <a:srgbClr val="FF0000"/>
                </a:solidFill>
                <a:latin typeface="Verdana" pitchFamily="1" charset="0"/>
                <a:ea typeface="+mn-ea"/>
                <a:cs typeface="+mn-cs"/>
              </a:rPr>
              <a:t>patient bias-towards-self and bias-towards-others </a:t>
            </a:r>
            <a:r>
              <a:rPr lang="en-US" dirty="0"/>
              <a:t>will be reviewed; and that case-based practice in small groups as well as large group discussion will follow. </a:t>
            </a:r>
            <a:endParaRPr dirty="0"/>
          </a:p>
        </p:txBody>
      </p:sp>
      <p:sp>
        <p:nvSpPr>
          <p:cNvPr id="107" name="Google Shape;107;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c473988d5b_0_8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gc473988d5b_0_81: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SzPts val="1400"/>
              <a:buNone/>
            </a:pPr>
            <a:r>
              <a:rPr lang="en-US" dirty="0"/>
              <a:t>This is the 8</a:t>
            </a:r>
            <a:r>
              <a:rPr lang="en-US" baseline="30000" dirty="0"/>
              <a:t>th</a:t>
            </a:r>
            <a:r>
              <a:rPr lang="en-US" dirty="0"/>
              <a:t> and final step in the toolkit. The presenter can read the following:</a:t>
            </a:r>
          </a:p>
          <a:p>
            <a:pPr marL="0" lvl="0" indent="0" algn="l" rtl="0">
              <a:spcBef>
                <a:spcPts val="0"/>
              </a:spcBef>
              <a:spcAft>
                <a:spcPts val="0"/>
              </a:spcAft>
              <a:buSzPts val="1400"/>
              <a:buNone/>
            </a:pPr>
            <a:endParaRPr lang="en-US" dirty="0"/>
          </a:p>
          <a:p>
            <a:pPr marL="0" lvl="0" indent="0" algn="l" rtl="0">
              <a:spcBef>
                <a:spcPts val="0"/>
              </a:spcBef>
              <a:spcAft>
                <a:spcPts val="0"/>
              </a:spcAft>
              <a:buSzPts val="1400"/>
              <a:buNone/>
            </a:pPr>
            <a:r>
              <a:rPr lang="en-US" dirty="0"/>
              <a:t>“The final step in the toolkit is to attend to yourself and other members of the team that were present for the encounter and debrief. Acknowledge the difficulty of the encounter. Reiterate the steps reviewed in debriefing encounters with altered patients when debriefing after all instances of bias: </a:t>
            </a:r>
          </a:p>
          <a:p>
            <a:pPr marL="171450" lvl="0" indent="-171450" algn="l" rtl="0">
              <a:spcBef>
                <a:spcPts val="0"/>
              </a:spcBef>
              <a:spcAft>
                <a:spcPts val="0"/>
              </a:spcAft>
              <a:buSzPts val="1400"/>
              <a:buFont typeface="Arial" panose="020B0604020202020204" pitchFamily="34" charset="0"/>
              <a:buChar char="•"/>
            </a:pPr>
            <a:r>
              <a:rPr lang="en-US" dirty="0">
                <a:ea typeface="Calibri" panose="020F0502020204030204" pitchFamily="34" charset="0"/>
                <a:cs typeface="Times New Roman" panose="02020603050405020304" pitchFamily="18" charset="0"/>
              </a:rPr>
              <a:t>State what you found problematic/painful.</a:t>
            </a:r>
          </a:p>
          <a:p>
            <a:pPr marL="171450" lvl="0" indent="-171450" algn="l" rtl="0">
              <a:spcBef>
                <a:spcPts val="0"/>
              </a:spcBef>
              <a:spcAft>
                <a:spcPts val="0"/>
              </a:spcAft>
              <a:buSzPts val="1400"/>
              <a:buFont typeface="Arial" panose="020B0604020202020204" pitchFamily="34" charset="0"/>
              <a:buChar char="•"/>
            </a:pPr>
            <a:r>
              <a:rPr lang="en-US" dirty="0">
                <a:ea typeface="Calibri" panose="020F0502020204030204" pitchFamily="34" charset="0"/>
                <a:cs typeface="Times New Roman" panose="02020603050405020304" pitchFamily="18" charset="0"/>
              </a:rPr>
              <a:t>Focus on this, not the target.</a:t>
            </a:r>
          </a:p>
          <a:p>
            <a:pPr marL="171450" lvl="0" indent="-171450" algn="l" rtl="0">
              <a:spcBef>
                <a:spcPts val="0"/>
              </a:spcBef>
              <a:spcAft>
                <a:spcPts val="0"/>
              </a:spcAft>
              <a:buSzPts val="1400"/>
              <a:buFont typeface="Arial" panose="020B0604020202020204" pitchFamily="34" charset="0"/>
              <a:buChar char="•"/>
            </a:pPr>
            <a:r>
              <a:rPr lang="en-US" dirty="0">
                <a:cs typeface="Times New Roman" panose="02020603050405020304" pitchFamily="18" charset="0"/>
              </a:rPr>
              <a:t>Ask permission to debrief further. The impacted person may want space or may prefer a 1:1 discussion. </a:t>
            </a:r>
          </a:p>
          <a:p>
            <a:pPr marL="171450" lvl="0" indent="-171450" algn="l" rtl="0">
              <a:spcBef>
                <a:spcPts val="0"/>
              </a:spcBef>
              <a:spcAft>
                <a:spcPts val="0"/>
              </a:spcAft>
              <a:buSzPts val="1400"/>
              <a:buFont typeface="Arial" panose="020B0604020202020204" pitchFamily="34" charset="0"/>
              <a:buChar char="•"/>
            </a:pPr>
            <a:r>
              <a:rPr lang="en-US" dirty="0">
                <a:cs typeface="Times New Roman" panose="02020603050405020304" pitchFamily="18" charset="0"/>
              </a:rPr>
              <a:t>Ask how you can better support the target the next time.</a:t>
            </a:r>
          </a:p>
          <a:p>
            <a:pPr marL="171450" lvl="0" indent="-171450" algn="l" rtl="0">
              <a:spcBef>
                <a:spcPts val="0"/>
              </a:spcBef>
              <a:spcAft>
                <a:spcPts val="0"/>
              </a:spcAft>
              <a:buSzPts val="1400"/>
              <a:buFont typeface="Arial" panose="020B0604020202020204" pitchFamily="34" charset="0"/>
              <a:buChar char="•"/>
            </a:pPr>
            <a:r>
              <a:rPr lang="en-US" dirty="0">
                <a:cs typeface="Times New Roman" panose="02020603050405020304" pitchFamily="18" charset="0"/>
              </a:rPr>
              <a:t>If the target requests, and the team can manage, remove them from further direct patient care.</a:t>
            </a:r>
            <a:endParaRPr lang="en-US" dirty="0"/>
          </a:p>
          <a:p>
            <a:pPr marL="0" lvl="0" indent="0" algn="l" rtl="0">
              <a:spcBef>
                <a:spcPts val="0"/>
              </a:spcBef>
              <a:spcAft>
                <a:spcPts val="0"/>
              </a:spcAft>
              <a:buSzPts val="1400"/>
              <a:buNone/>
            </a:pPr>
            <a:endParaRPr lang="en-US" dirty="0"/>
          </a:p>
          <a:p>
            <a:pPr marL="0" lvl="0" indent="0" algn="l" rtl="0">
              <a:spcBef>
                <a:spcPts val="0"/>
              </a:spcBef>
              <a:spcAft>
                <a:spcPts val="0"/>
              </a:spcAft>
              <a:buSzPts val="1400"/>
              <a:buNone/>
            </a:pPr>
            <a:r>
              <a:rPr lang="en-US" dirty="0"/>
              <a:t>The team can reflect on what went well, and what didn’t. Remember, the target may not want to process with you and that’s ok as long as they’re processing. Reiterate that the more we talk about these scenarios, the easier they are to discuss.”</a:t>
            </a:r>
          </a:p>
          <a:p>
            <a:pPr marL="228600" lvl="0" indent="-241300" algn="l" rtl="0">
              <a:spcBef>
                <a:spcPts val="0"/>
              </a:spcBef>
              <a:spcAft>
                <a:spcPts val="0"/>
              </a:spcAft>
              <a:buSzPts val="1400"/>
              <a:buAutoNum type="arabicPeriod"/>
            </a:pPr>
            <a:endParaRPr dirty="0"/>
          </a:p>
        </p:txBody>
      </p:sp>
      <p:sp>
        <p:nvSpPr>
          <p:cNvPr id="165" name="Google Shape;165;gc473988d5b_0_81: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0</a:t>
            </a:fld>
            <a:endParaRPr/>
          </a:p>
        </p:txBody>
      </p:sp>
    </p:spTree>
    <p:extLst>
      <p:ext uri="{BB962C8B-B14F-4D97-AF65-F5344CB8AC3E}">
        <p14:creationId xmlns:p14="http://schemas.microsoft.com/office/powerpoint/2010/main" val="61060592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gc473988d5b_0_9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1" name="Google Shape;171;gc473988d5b_0_93: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We use this slide to suggest that teams should begin rotations together expecting that one or more members of the team will experience bias from a patient and that taking time to debrief and process these events as a team is as important as clinical work. The presenter can offer that, for example, at the beginning of a rotation a team can decide how and when to debrief challenging conversations and how best to support each other. Some team members might know themselves well enough to know that they often freeze and want others to jump in on their behalf, or that they always want to try to respond first but will let you know with a look when they want your help.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Presenters should emphasize that other members of the interdisciplinary team involved in patient care may be impacted by a patients bias as well and are valuable to bring into the conversation. Unit base leadership can help establish boundary setting and enforce consequences if a behavioral contract is required. Finally, the presenter can offer that providing a patients with a support outlet is helpful as well. At our institution, the involves patient advocacy, spiritual care, and security if the safety of either party is threatened.</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Change these resources listed in #4 if they do not exist at your institution or if they have different team names.</a:t>
            </a:r>
            <a:endParaRPr dirty="0"/>
          </a:p>
        </p:txBody>
      </p:sp>
      <p:sp>
        <p:nvSpPr>
          <p:cNvPr id="172" name="Google Shape;172;gc473988d5b_0_93: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
        <p:cNvGrpSpPr/>
        <p:nvPr/>
      </p:nvGrpSpPr>
      <p:grpSpPr>
        <a:xfrm>
          <a:off x="0" y="0"/>
          <a:ext cx="0" cy="0"/>
          <a:chOff x="0" y="0"/>
          <a:chExt cx="0" cy="0"/>
        </a:xfrm>
      </p:grpSpPr>
      <p:sp>
        <p:nvSpPr>
          <p:cNvPr id="177" name="Google Shape;177;gc473988d5b_0_9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8" name="Google Shape;178;gc473988d5b_0_99: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Here presenters can refer participants to the handouts that can either be printed or distributed electronically and remind them that they include all the helpful examples of language to use in instances of bias that were just reviewed. Participants are encouraged to read these suggested phrases and find one or more that resonates. It is worth rehearsing at least one phrase so it can easily be drawn on during a moment of higher emotional intensity, such as an encounter with a patient expressing bias. The handout is provided in Appendix A.</a:t>
            </a:r>
            <a:endParaRPr dirty="0"/>
          </a:p>
          <a:p>
            <a:pPr marL="0" marR="0" lvl="0" indent="0" algn="l" rtl="0">
              <a:lnSpc>
                <a:spcPct val="100000"/>
              </a:lnSpc>
              <a:spcBef>
                <a:spcPts val="0"/>
              </a:spcBef>
              <a:spcAft>
                <a:spcPts val="0"/>
              </a:spcAft>
              <a:buClr>
                <a:schemeClr val="dk1"/>
              </a:buClr>
              <a:buSzPts val="1200"/>
              <a:buFont typeface="Calibri"/>
              <a:buNone/>
            </a:pPr>
            <a:endParaRPr dirty="0"/>
          </a:p>
        </p:txBody>
      </p:sp>
      <p:sp>
        <p:nvSpPr>
          <p:cNvPr id="179" name="Google Shape;179;gc473988d5b_0_99: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transition slide to get everyone ready for the case-based application segment of the workshop. </a:t>
            </a:r>
          </a:p>
        </p:txBody>
      </p:sp>
      <p:sp>
        <p:nvSpPr>
          <p:cNvPr id="4" name="Slide Number Placeholder 3"/>
          <p:cNvSpPr>
            <a:spLocks noGrp="1"/>
          </p:cNvSpPr>
          <p:nvPr>
            <p:ph type="sldNum" sz="quarter" idx="5"/>
          </p:nvPr>
        </p:nvSpPr>
        <p:spPr/>
        <p:txBody>
          <a:bodyPr/>
          <a:lstStyle/>
          <a:p>
            <a:fld id="{8DE8086E-D83D-7C4A-BCA9-FA45804C261E}" type="slidenum">
              <a:rPr lang="en-US" smtClean="0"/>
              <a:t>23</a:t>
            </a:fld>
            <a:endParaRPr lang="en-US"/>
          </a:p>
        </p:txBody>
      </p:sp>
    </p:spTree>
    <p:extLst>
      <p:ext uri="{BB962C8B-B14F-4D97-AF65-F5344CB8AC3E}">
        <p14:creationId xmlns:p14="http://schemas.microsoft.com/office/powerpoint/2010/main" val="106692693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3"/>
        <p:cNvGrpSpPr/>
        <p:nvPr/>
      </p:nvGrpSpPr>
      <p:grpSpPr>
        <a:xfrm>
          <a:off x="0" y="0"/>
          <a:ext cx="0" cy="0"/>
          <a:chOff x="0" y="0"/>
          <a:chExt cx="0" cy="0"/>
        </a:xfrm>
      </p:grpSpPr>
      <p:sp>
        <p:nvSpPr>
          <p:cNvPr id="184" name="Google Shape;184;p29: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slide begins the transition to the case-based small and large group discussions to apply the toolkit. The facilitator asks attendees present in person to create small groups of 2-3. The virtual participants are asked whether they prefer to be in a breakout room or communicating via the chat function. Ideally an additional moderator would be available to monitor the web conference chat and share virtual participant responses with the group. The attendees are reminded that the forthcoming cases are examples from current residents and that not all forms of bias will be covered in this session. Presenters can tailor these cases to the needs of the audience, so they feel relevant. </a:t>
            </a:r>
          </a:p>
          <a:p>
            <a:pPr marL="0" lvl="0" indent="0" algn="l" rtl="0">
              <a:spcBef>
                <a:spcPts val="0"/>
              </a:spcBef>
              <a:spcAft>
                <a:spcPts val="0"/>
              </a:spcAft>
              <a:buNone/>
            </a:pPr>
            <a:endParaRPr lang="en-US" dirty="0"/>
          </a:p>
          <a:p>
            <a:pPr marL="342900" marR="0" lvl="0" indent="-342900">
              <a:spcBef>
                <a:spcPts val="0"/>
              </a:spcBef>
              <a:spcAft>
                <a:spcPts val="0"/>
              </a:spcAft>
              <a:buFont typeface="Symbol" pitchFamily="2" charset="2"/>
              <a:buChar cha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Explain that each small group will have a few minutes to discuss how they would respond to each case using the toolkit (they should have the toolkit either as a hard copy in front of them or in their email). </a:t>
            </a:r>
            <a:endParaRPr lang="en-US" sz="1800" dirty="0">
              <a:effectLst/>
              <a:latin typeface="Calibri" panose="020F0502020204030204" pitchFamily="34" charset="0"/>
              <a:ea typeface="Times New Roman" panose="02020603050405020304" pitchFamily="18" charset="0"/>
              <a:cs typeface="Times New Roman" panose="02020603050405020304" pitchFamily="18" charset="0"/>
            </a:endParaRPr>
          </a:p>
          <a:p>
            <a:pPr marL="342900" marR="0" lvl="0" indent="-342900">
              <a:spcBef>
                <a:spcPts val="0"/>
              </a:spcBef>
              <a:spcAft>
                <a:spcPts val="0"/>
              </a:spcAft>
              <a:buFont typeface="Symbol" pitchFamily="2" charset="2"/>
              <a:buChar cha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sk all members who feel comfortable chiming in to participate in their groups’ discussions of the three cases. </a:t>
            </a:r>
            <a:endParaRPr lang="en-US" sz="1800" dirty="0">
              <a:effectLst/>
              <a:latin typeface="Calibri" panose="020F0502020204030204" pitchFamily="34" charset="0"/>
              <a:ea typeface="Times New Roman" panose="02020603050405020304" pitchFamily="18" charset="0"/>
              <a:cs typeface="Times New Roman" panose="02020603050405020304" pitchFamily="18" charset="0"/>
            </a:endParaRPr>
          </a:p>
          <a:p>
            <a:pPr marL="342900" marR="0" lvl="0" indent="-342900">
              <a:spcBef>
                <a:spcPts val="0"/>
              </a:spcBef>
              <a:spcAft>
                <a:spcPts val="0"/>
              </a:spcAft>
              <a:buFont typeface="Symbol" pitchFamily="2" charset="2"/>
              <a:buChar cha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sk each group to identify a spokesperson to share the group’s discussion with the broader workshop later.  </a:t>
            </a:r>
          </a:p>
          <a:p>
            <a:pPr marL="342900" marR="0" lvl="0" indent="-342900" algn="l" defTabSz="914400" rtl="0" eaLnBrk="1" fontAlgn="auto" latinLnBrk="0" hangingPunct="1">
              <a:lnSpc>
                <a:spcPct val="100000"/>
              </a:lnSpc>
              <a:spcBef>
                <a:spcPts val="0"/>
              </a:spcBef>
              <a:spcAft>
                <a:spcPts val="0"/>
              </a:spcAft>
              <a:buClr>
                <a:srgbClr val="000000"/>
              </a:buClr>
              <a:buSzPts val="1400"/>
              <a:buFont typeface="Symbol" pitchFamily="2" charset="2"/>
              <a:buChar char=""/>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f there are at least 2 virtual participants and you have a second facilitator or collaborator who can place those participants into a breakout room of 2-3, you can offer this. If virtual participants are not able to join a breakout room and verbally participate, offer them the chat function to share their proposed solutions with each other either in dyads via direct message, or with the broader group. The hope is to make the virtual space as psychologically safe as possible. </a:t>
            </a:r>
            <a:endParaRPr lang="en-US" sz="1800" dirty="0">
              <a:effectLst/>
              <a:latin typeface="Calibri" panose="020F0502020204030204" pitchFamily="34" charset="0"/>
              <a:ea typeface="Times New Roman" panose="02020603050405020304" pitchFamily="18" charset="0"/>
              <a:cs typeface="Times New Roman" panose="02020603050405020304" pitchFamily="18" charset="0"/>
            </a:endParaRPr>
          </a:p>
          <a:p>
            <a:pPr marL="342900" marR="0" lvl="0" indent="-342900">
              <a:spcBef>
                <a:spcPts val="0"/>
              </a:spcBef>
              <a:spcAft>
                <a:spcPts val="0"/>
              </a:spcAft>
              <a:buFont typeface="Symbol" pitchFamily="2" charset="2"/>
              <a:buChar cha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emind participants they can step out to collect themselves in these encounters.</a:t>
            </a:r>
            <a:endParaRPr lang="en-US" sz="1800" dirty="0">
              <a:effectLst/>
              <a:latin typeface="Calibri" panose="020F0502020204030204" pitchFamily="34" charset="0"/>
              <a:ea typeface="Times New Roman" panose="02020603050405020304" pitchFamily="18" charset="0"/>
              <a:cs typeface="Times New Roman" panose="02020603050405020304" pitchFamily="18" charset="0"/>
            </a:endParaRPr>
          </a:p>
          <a:p>
            <a:pPr marL="0" lvl="0" indent="0" algn="l" rtl="0">
              <a:spcBef>
                <a:spcPts val="0"/>
              </a:spcBef>
              <a:spcAft>
                <a:spcPts val="0"/>
              </a:spcAft>
              <a:buNone/>
            </a:pPr>
            <a:endParaRPr dirty="0"/>
          </a:p>
        </p:txBody>
      </p:sp>
      <p:sp>
        <p:nvSpPr>
          <p:cNvPr id="185" name="Google Shape;185;p2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gc8450bc072_1_15: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solidFill>
                  <a:srgbClr val="FFFFFF"/>
                </a:solidFill>
              </a:rPr>
              <a:t>Read the case aloud and then encourage participants to discuss a response with their small group. Facilitators can circulate during this discussion to assess if small group discourse is petering off. If groups are wrapping up or have moved on to discussing other topics, pivot back to the large group discussion before 3 minutes have elapsed. After ~3 minutes, bring the small groups together into one large group discussion and ask groups to share what they discussed and how they would respond. Solicit responses from various small groups. Acknowledge the tools used from the toolkit in each group’s response (naming the bias, setting a boundary, etc.). Share potential responses that have been pre-crafted (examples on the next slide) if participation is minimal.</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dirty="0">
              <a:solidFill>
                <a:srgbClr val="FFFFFF"/>
              </a:solidFill>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solidFill>
                  <a:srgbClr val="FFFFFF"/>
                </a:solidFill>
              </a:rPr>
              <a:t>This case highlights bias against Asian residents. Note that misidentification happens to providers of other races/ethnicities as well. Remind participants they can step out to collect themselves in these encounters. Consider pushing learners to specifically discuss how they would set the record straight in naming their role on the patient’s care team and in correcting inappropriate language.</a:t>
            </a:r>
            <a:endParaRPr b="0" dirty="0"/>
          </a:p>
        </p:txBody>
      </p:sp>
      <p:sp>
        <p:nvSpPr>
          <p:cNvPr id="215" name="Google Shape;215;gc8450bc072_1_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a:extLst>
            <a:ext uri="{FF2B5EF4-FFF2-40B4-BE49-F238E27FC236}">
              <a16:creationId xmlns:a16="http://schemas.microsoft.com/office/drawing/2014/main" id="{9660889D-06C8-0970-C255-86702480695D}"/>
            </a:ext>
          </a:extLst>
        </p:cNvPr>
        <p:cNvGrpSpPr/>
        <p:nvPr/>
      </p:nvGrpSpPr>
      <p:grpSpPr>
        <a:xfrm>
          <a:off x="0" y="0"/>
          <a:ext cx="0" cy="0"/>
          <a:chOff x="0" y="0"/>
          <a:chExt cx="0" cy="0"/>
        </a:xfrm>
      </p:grpSpPr>
      <p:sp>
        <p:nvSpPr>
          <p:cNvPr id="214" name="Google Shape;214;gc8450bc072_1_15:notes">
            <a:extLst>
              <a:ext uri="{FF2B5EF4-FFF2-40B4-BE49-F238E27FC236}">
                <a16:creationId xmlns:a16="http://schemas.microsoft.com/office/drawing/2014/main" id="{85ACD171-8303-A740-C2EF-A6424BDBE7E0}"/>
              </a:ext>
            </a:extLst>
          </p:cNvPr>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solidFill>
                  <a:srgbClr val="FFFFFF"/>
                </a:solidFill>
              </a:rPr>
              <a:t>Share potential responses that have been pre-crafted (on the bottom half of the slide) if participation is minimal.</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dirty="0">
              <a:solidFill>
                <a:srgbClr val="FFFFFF"/>
              </a:solidFill>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solidFill>
                  <a:srgbClr val="FFFFFF"/>
                </a:solidFill>
              </a:rPr>
              <a:t>This case highlights bias against Asian residents. Note that misidentification happens to providers of other races/ethnicities as well. Remind participants they can step out to collect themselves in these encounters. Consider pushing learners to specifically discuss how they would set the record straight in naming their role on the patient’s care team and in correcting inappropriate languag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dirty="0">
              <a:solidFill>
                <a:srgbClr val="FFFFFF"/>
              </a:solidFill>
            </a:endParaRPr>
          </a:p>
          <a:p>
            <a:pPr marL="342900" marR="0" lvl="0" indent="-342900">
              <a:spcBef>
                <a:spcPts val="0"/>
              </a:spcBef>
              <a:spcAft>
                <a:spcPts val="0"/>
              </a:spcAft>
              <a:buFont typeface="Symbol" pitchFamily="2" charset="2"/>
              <a:buChar cha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ow to name your role: </a:t>
            </a:r>
          </a:p>
          <a:p>
            <a:pPr marL="800100" marR="0" lvl="1" indent="-342900">
              <a:spcBef>
                <a:spcPts val="0"/>
              </a:spcBef>
              <a:spcAft>
                <a:spcPts val="0"/>
              </a:spcAft>
              <a:buFont typeface="Symbol" pitchFamily="2" charset="2"/>
              <a:buChar cha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No, I am your primary care doctor. You are mistaking me for another staff member.” </a:t>
            </a:r>
          </a:p>
          <a:p>
            <a:pPr marL="800100" marR="0" lvl="1" indent="-342900">
              <a:spcBef>
                <a:spcPts val="0"/>
              </a:spcBef>
              <a:spcAft>
                <a:spcPts val="0"/>
              </a:spcAft>
              <a:buFont typeface="Symbol" pitchFamily="2" charset="2"/>
              <a:buChar cha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t is disappointing to be confused with another staff member. I was not in radiology today, but I am your doctor and am here to help you feel better. For the future, I’m from ___ and I prefer ______.”</a:t>
            </a:r>
            <a:endParaRPr lang="en-US" sz="1800" dirty="0">
              <a:effectLst/>
              <a:latin typeface="Calibri" panose="020F0502020204030204" pitchFamily="34" charset="0"/>
              <a:ea typeface="Times New Roman" panose="02020603050405020304" pitchFamily="18" charset="0"/>
              <a:cs typeface="Times New Roman" panose="02020603050405020304" pitchFamily="18" charset="0"/>
            </a:endParaRPr>
          </a:p>
          <a:p>
            <a:pPr marL="342900" marR="0" lvl="0" indent="-342900">
              <a:spcBef>
                <a:spcPts val="0"/>
              </a:spcBef>
              <a:spcAft>
                <a:spcPts val="0"/>
              </a:spcAft>
              <a:buFont typeface="Symbol" pitchFamily="2" charset="2"/>
              <a:buChar cha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ow to correct inappropriate language: </a:t>
            </a:r>
          </a:p>
          <a:p>
            <a:pPr marL="800100" marR="0" lvl="1" indent="-342900">
              <a:spcBef>
                <a:spcPts val="0"/>
              </a:spcBef>
              <a:spcAft>
                <a:spcPts val="0"/>
              </a:spcAft>
              <a:buFont typeface="Symbol" pitchFamily="2" charset="2"/>
              <a:buChar cha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Oriental is a disrespectful term. Please refrain from using it moving forward.” </a:t>
            </a:r>
          </a:p>
          <a:p>
            <a:pPr marL="1257300" marR="0" lvl="2" indent="-342900">
              <a:spcBef>
                <a:spcPts val="0"/>
              </a:spcBef>
              <a:spcAft>
                <a:spcPts val="0"/>
              </a:spcAft>
              <a:buFont typeface="Symbol" pitchFamily="2" charset="2"/>
              <a:buChar cha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f seeking a softer approach, consider adding, “In case you are not aware…” to the beginning of the prior comment. </a:t>
            </a:r>
            <a:endParaRPr lang="en-US" sz="1800" dirty="0">
              <a:effectLst/>
              <a:latin typeface="Calibri" panose="020F0502020204030204" pitchFamily="34" charset="0"/>
              <a:ea typeface="Times New Roman" panose="02020603050405020304" pitchFamily="18"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b="0" dirty="0"/>
          </a:p>
        </p:txBody>
      </p:sp>
      <p:sp>
        <p:nvSpPr>
          <p:cNvPr id="215" name="Google Shape;215;gc8450bc072_1_15:notes">
            <a:extLst>
              <a:ext uri="{FF2B5EF4-FFF2-40B4-BE49-F238E27FC236}">
                <a16:creationId xmlns:a16="http://schemas.microsoft.com/office/drawing/2014/main" id="{DF773977-9A2F-7629-CF53-DBD2463BA79F}"/>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77279225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CBA6B36-2906-AF92-DE94-EC1B55527469}"/>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ECF24CA-700D-9791-94EF-F7270F11C89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343EB18E-BF03-DCC2-3554-50F453984A4E}"/>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solidFill>
                  <a:srgbClr val="FFFFFF"/>
                </a:solidFill>
              </a:rPr>
              <a:t>Read the case aloud and then encourage participants to discuss a response with their small group. Facilitators can circulate during this discussion to assess if small group discourse is petering off. If groups are wrapping up or have moved on to discussing other topics, pivot back to the large group discussion before 3 minutes have elapsed. After ~3 minutes, bring the small groups together into one large group discussion and ask groups to share what they discussed and how they would respond. Solicit responses from various small groups. Acknowledge the tools used from the toolkit in each group’s response (naming the bias, setting a boundary, etc.). Share potential responses that have been pre-crafted (examples on the next slide) if participation is minimal.</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dirty="0">
              <a:solidFill>
                <a:srgbClr val="FFFFFF"/>
              </a:solidFill>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solidFill>
                  <a:srgbClr val="FFFFFF"/>
                </a:solidFill>
              </a:rPr>
              <a:t>This case highlights racial bias</a:t>
            </a:r>
            <a:r>
              <a:rPr lang="en-US" dirty="0">
                <a:solidFill>
                  <a:srgbClr val="FFFFFF"/>
                </a:solidFill>
              </a:rPr>
              <a:t>. </a:t>
            </a:r>
            <a:r>
              <a:rPr lang="en-US" b="0" dirty="0">
                <a:solidFill>
                  <a:srgbClr val="FFFFFF"/>
                </a:solidFill>
              </a:rPr>
              <a:t>This case is an opportunity to respond to bias-towards-others and to support your peers. </a:t>
            </a:r>
            <a:r>
              <a:rPr lang="en-US" sz="1800" dirty="0">
                <a:solidFill>
                  <a:srgbClr val="000000"/>
                </a:solidFill>
                <a:effectLst/>
                <a:latin typeface="Calibri" panose="020F0502020204030204" pitchFamily="34" charset="0"/>
                <a:ea typeface="Times New Roman" panose="02020603050405020304" pitchFamily="18" charset="0"/>
              </a:rPr>
              <a:t>Cases of responding to bias-towards-others can be fruitful opportunities to discuss how to debrief an interaction, if time allows. </a:t>
            </a:r>
            <a:r>
              <a:rPr lang="en-US" b="0" dirty="0"/>
              <a:t>Consider asking the group how a responding team member might do an emotional check in with the senior resident after the event. Consider asking the group what the colleague might say to the senior after the event if they froze and didn’t respond to the bias on their behalf. Alternatively, what might the senior say to the colleague if the opportunity to respond to bias-towards-others was missed?</a:t>
            </a:r>
          </a:p>
        </p:txBody>
      </p:sp>
      <p:sp>
        <p:nvSpPr>
          <p:cNvPr id="4" name="Slide Number Placeholder 3">
            <a:extLst>
              <a:ext uri="{FF2B5EF4-FFF2-40B4-BE49-F238E27FC236}">
                <a16:creationId xmlns:a16="http://schemas.microsoft.com/office/drawing/2014/main" id="{7443A9C4-FB0D-3374-0C4E-31C7DE572AFD}"/>
              </a:ext>
            </a:extLst>
          </p:cNvPr>
          <p:cNvSpPr>
            <a:spLocks noGrp="1"/>
          </p:cNvSpPr>
          <p:nvPr>
            <p:ph type="sldNum" sz="quarter" idx="10"/>
          </p:nvPr>
        </p:nvSpPr>
        <p:spPr/>
        <p:txBody>
          <a:bodyPr/>
          <a:lstStyle/>
          <a:p>
            <a:fld id="{E856A05D-4872-4DE3-8153-C3BCB67F6F19}" type="slidenum">
              <a:rPr lang="en-US" smtClean="0"/>
              <a:t>27</a:t>
            </a:fld>
            <a:endParaRPr lang="en-US"/>
          </a:p>
        </p:txBody>
      </p:sp>
    </p:spTree>
    <p:extLst>
      <p:ext uri="{BB962C8B-B14F-4D97-AF65-F5344CB8AC3E}">
        <p14:creationId xmlns:p14="http://schemas.microsoft.com/office/powerpoint/2010/main" val="3502264290"/>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solidFill>
                  <a:srgbClr val="FFFFFF"/>
                </a:solidFill>
              </a:rPr>
              <a:t>Share potential responses that have been pre-crafted (on the bottom half of the slide) if participation is minimal.</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dirty="0">
              <a:solidFill>
                <a:srgbClr val="FFFFFF"/>
              </a:solidFill>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solidFill>
                  <a:srgbClr val="FFFFFF"/>
                </a:solidFill>
              </a:rPr>
              <a:t>This case highlights racial bias</a:t>
            </a:r>
            <a:r>
              <a:rPr lang="en-US" dirty="0">
                <a:solidFill>
                  <a:srgbClr val="FFFFFF"/>
                </a:solidFill>
              </a:rPr>
              <a:t>. </a:t>
            </a:r>
            <a:r>
              <a:rPr lang="en-US" b="0" dirty="0">
                <a:solidFill>
                  <a:srgbClr val="FFFFFF"/>
                </a:solidFill>
              </a:rPr>
              <a:t>This case is an opportunity to respond to bias-towards-others and to support your peers. </a:t>
            </a:r>
            <a:r>
              <a:rPr lang="en-US" sz="1800" dirty="0">
                <a:solidFill>
                  <a:srgbClr val="000000"/>
                </a:solidFill>
                <a:effectLst/>
                <a:latin typeface="Calibri" panose="020F0502020204030204" pitchFamily="34" charset="0"/>
                <a:ea typeface="Times New Roman" panose="02020603050405020304" pitchFamily="18" charset="0"/>
              </a:rPr>
              <a:t>Cases of responding to bias-towards-others can be fruitful opportunities to discuss how to debrief an interaction, if time allows. </a:t>
            </a:r>
            <a:r>
              <a:rPr lang="en-US" b="0" dirty="0"/>
              <a:t>Consider asking the group how a responding team member might do an emotional check in with the senior resident after the event. Consider asking the group what the colleague might say to the senior after the event if they froze and didn’t respond to the bias on their behalf. Alternatively, what might the senior say to the colleague if the opportunity to respond to bias-towards-others was missed?</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dirty="0"/>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b="0" dirty="0"/>
              <a:t>How to respond to bias-towards-self: </a:t>
            </a:r>
          </a:p>
          <a:p>
            <a:pPr marL="628650" marR="0" lvl="1"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solidFill>
                  <a:schemeClr val="bg1"/>
                </a:solidFill>
                <a:latin typeface="Calibri" panose="020F0502020204030204" pitchFamily="34" charset="0"/>
                <a:cs typeface="Calibri" panose="020F0502020204030204" pitchFamily="34" charset="0"/>
              </a:rPr>
              <a:t>“I think you’ve mistaken my role. I’m Dr. ___ and the leader of the resident team.”</a:t>
            </a:r>
            <a:endParaRPr lang="en-US" b="0" dirty="0"/>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b="0" dirty="0"/>
              <a:t>How to respond to bias-towards-others:</a:t>
            </a:r>
          </a:p>
          <a:p>
            <a:pPr marL="628650" marR="0" lvl="1"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solidFill>
                  <a:schemeClr val="bg1"/>
                </a:solidFill>
                <a:latin typeface="Calibri" panose="020F0502020204030204" pitchFamily="34" charset="0"/>
                <a:cs typeface="Calibri" panose="020F0502020204030204" pitchFamily="34" charset="0"/>
              </a:rPr>
              <a:t>“Dr. ___ is actually our team leader. In the future, everyone’s badge has a colorful tag on it to help identify who they are and how they fit into your care. Someone from the transport team will bring you to CT.”</a:t>
            </a:r>
          </a:p>
          <a:p>
            <a:pPr marL="628650" marR="0" lvl="1"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endParaRPr lang="en-US" sz="1200" b="0" dirty="0">
              <a:solidFill>
                <a:schemeClr val="dk1"/>
              </a:solidFill>
              <a:effectLst/>
              <a:latin typeface="Calibri"/>
              <a:cs typeface="Calibri"/>
            </a:endParaRP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nguage to check in with the senior resident: </a:t>
            </a:r>
          </a:p>
          <a:p>
            <a:pPr marL="628650" marR="0" lvl="1"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 found it frustrating that the patient misidentified you as transport. How are you feeling? Do you want to discuss it further?”</a:t>
            </a: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nguage to check in with the senior resident if no one jumped in to respond to the bias: </a:t>
            </a:r>
          </a:p>
          <a:p>
            <a:pPr marL="628650" marR="0" lvl="1"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 found it frustrating that the patient misidentified you as transport and I am sorry I did not jump in to support you. How can I better support you in the future?”</a:t>
            </a:r>
            <a:endParaRPr lang="en-US" sz="1800" dirty="0">
              <a:solidFill>
                <a:schemeClr val="dk1"/>
              </a:solidFill>
              <a:effectLst/>
              <a:latin typeface="Calibri" panose="020F0502020204030204" pitchFamily="34" charset="0"/>
              <a:ea typeface="Times New Roman" panose="02020603050405020304" pitchFamily="18" charset="0"/>
              <a:cs typeface="Times New Roman" panose="02020603050405020304" pitchFamily="18" charset="0"/>
            </a:endParaRP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nguage the senior could use if no one jumped in on their behalf to respond to the bias:</a:t>
            </a:r>
          </a:p>
          <a:p>
            <a:pPr marL="628650" marR="0" lvl="1"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 found it frustrating to be misidentified as transport by our patient. I hope in the future you feel comfortable verbally supporting me. I find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xyz</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supportive.”</a:t>
            </a:r>
            <a:endParaRPr lang="en-US" sz="1800" dirty="0">
              <a:effectLst/>
              <a:latin typeface="Calibri" panose="020F0502020204030204" pitchFamily="34" charset="0"/>
              <a:ea typeface="Times New Roman" panose="02020603050405020304" pitchFamily="18" charset="0"/>
              <a:cs typeface="Times New Roman" panose="02020603050405020304" pitchFamily="18" charset="0"/>
            </a:endParaRPr>
          </a:p>
          <a:p>
            <a:pPr marL="628650" marR="0" lvl="1"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endParaRPr lang="en-US" b="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dirty="0"/>
          </a:p>
        </p:txBody>
      </p:sp>
      <p:sp>
        <p:nvSpPr>
          <p:cNvPr id="4" name="Slide Number Placeholder 3"/>
          <p:cNvSpPr>
            <a:spLocks noGrp="1"/>
          </p:cNvSpPr>
          <p:nvPr>
            <p:ph type="sldNum" sz="quarter" idx="10"/>
          </p:nvPr>
        </p:nvSpPr>
        <p:spPr/>
        <p:txBody>
          <a:bodyPr/>
          <a:lstStyle/>
          <a:p>
            <a:fld id="{E856A05D-4872-4DE3-8153-C3BCB67F6F19}" type="slidenum">
              <a:rPr lang="en-US" smtClean="0"/>
              <a:t>28</a:t>
            </a:fld>
            <a:endParaRPr lang="en-US"/>
          </a:p>
        </p:txBody>
      </p:sp>
    </p:spTree>
    <p:extLst>
      <p:ext uri="{BB962C8B-B14F-4D97-AF65-F5344CB8AC3E}">
        <p14:creationId xmlns:p14="http://schemas.microsoft.com/office/powerpoint/2010/main" val="44821024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a:extLst>
            <a:ext uri="{FF2B5EF4-FFF2-40B4-BE49-F238E27FC236}">
              <a16:creationId xmlns:a16="http://schemas.microsoft.com/office/drawing/2014/main" id="{B1A90A5C-442C-9A69-1299-04F02759DEBC}"/>
            </a:ext>
          </a:extLst>
        </p:cNvPr>
        <p:cNvGrpSpPr/>
        <p:nvPr/>
      </p:nvGrpSpPr>
      <p:grpSpPr>
        <a:xfrm>
          <a:off x="0" y="0"/>
          <a:ext cx="0" cy="0"/>
          <a:chOff x="0" y="0"/>
          <a:chExt cx="0" cy="0"/>
        </a:xfrm>
      </p:grpSpPr>
      <p:sp>
        <p:nvSpPr>
          <p:cNvPr id="238" name="Google Shape;238;gc8450bc072_1_35:notes">
            <a:extLst>
              <a:ext uri="{FF2B5EF4-FFF2-40B4-BE49-F238E27FC236}">
                <a16:creationId xmlns:a16="http://schemas.microsoft.com/office/drawing/2014/main" id="{13B58D26-C456-CDC2-9C0B-AF7FD0B4FC2F}"/>
              </a:ext>
            </a:extLst>
          </p:cNvPr>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solidFill>
                  <a:srgbClr val="FFFFFF"/>
                </a:solidFill>
              </a:rPr>
              <a:t>Read the case aloud and then encourage participants to discuss a response with their small group. Facilitators can circulate during this discussion to assess if small group discourse is petering off. If groups are wrapping up or have moved on to discussing other topics, pivot back to the large group discussion before 3 minutes have elapsed. After ~3 minutes, bring the small groups together into one large group discussion and ask groups to share what they discussed and how they would respond. Solicit responses from various small groups. Acknowledge the tools used from the toolkit in each group’s response (naming the bias, setting a boundary, etc.). Share potential responses that have been pre-crafted (examples on the next slide) if participation is minimal.</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dirty="0">
              <a:solidFill>
                <a:srgbClr val="FFFFFF"/>
              </a:solidFill>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solidFill>
                  <a:srgbClr val="FFFFFF"/>
                </a:solidFill>
              </a:rPr>
              <a:t>This case highlights gender bias or potentially </a:t>
            </a:r>
            <a:r>
              <a:rPr lang="en-US" dirty="0">
                <a:solidFill>
                  <a:srgbClr val="FFFFFF"/>
                </a:solidFill>
              </a:rPr>
              <a:t>another bias (race, ethnicity, age, etc.) depending on the target. </a:t>
            </a:r>
            <a:r>
              <a:rPr lang="en-US" b="0" dirty="0"/>
              <a:t>The presenter can suggest that women experience this type of role confusion and inappropriate terms of endearment more than men.</a:t>
            </a:r>
            <a:r>
              <a:rPr lang="en-US" dirty="0">
                <a:solidFill>
                  <a:srgbClr val="FFFFFF"/>
                </a:solidFill>
              </a:rPr>
              <a:t> </a:t>
            </a:r>
            <a:r>
              <a:rPr lang="en-US" b="0" dirty="0">
                <a:solidFill>
                  <a:srgbClr val="FFFFFF"/>
                </a:solidFill>
              </a:rPr>
              <a:t>This case is an opportunity to both respond as the target to bias-towards-self, or for a peer if bias-towards-others.</a:t>
            </a:r>
            <a:endParaRPr lang="en-US" dirty="0">
              <a:solidFill>
                <a:srgbClr val="FFFFFF"/>
              </a:solidFill>
            </a:endParaRPr>
          </a:p>
        </p:txBody>
      </p:sp>
      <p:sp>
        <p:nvSpPr>
          <p:cNvPr id="239" name="Google Shape;239;gc8450bc072_1_35:notes">
            <a:extLst>
              <a:ext uri="{FF2B5EF4-FFF2-40B4-BE49-F238E27FC236}">
                <a16:creationId xmlns:a16="http://schemas.microsoft.com/office/drawing/2014/main" id="{C6A5DAEB-2FBF-6C91-F65E-8EEFBE62D59D}"/>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26849268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1"/>
        <p:cNvGrpSpPr/>
        <p:nvPr/>
      </p:nvGrpSpPr>
      <p:grpSpPr>
        <a:xfrm>
          <a:off x="0" y="0"/>
          <a:ext cx="0" cy="0"/>
          <a:chOff x="0" y="0"/>
          <a:chExt cx="0" cy="0"/>
        </a:xfrm>
      </p:grpSpPr>
      <p:sp>
        <p:nvSpPr>
          <p:cNvPr id="112" name="Google Shape;112;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3" name="Google Shape;113;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dirty="0"/>
              <a:t>Reviewing the learning objectives is an opportunity to share the learning environment you hope to create in the session—a safe, open one to share experiences and approaches to responding to patient bias. Facilitators can state that you expect confidentiality and respect from participants. Use this slide as a moment to acknowledge the work done by residents most burdened with bias, specifically underrepresented physicians, and to name that this topic may be difficult for some. Welcome residents to excuse themselves as needed. Tell the audience that the goal is to both recognize examples of bias in clinical encounters, to become increasingly resilient in the face of these all-too-common experiences and to support our peers with allyship behavior. State that you hope participants each leave with a personalized toolkit to achieve these goals. Acknowledge systemic change is required to support residents in responding to bias as well and share the plan to review institutional supports at the end of the presentation.</a:t>
            </a:r>
            <a:endParaRPr dirty="0"/>
          </a:p>
        </p:txBody>
      </p:sp>
      <p:sp>
        <p:nvSpPr>
          <p:cNvPr id="114" name="Google Shape;114;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gc8450bc072_1_35: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solidFill>
                  <a:srgbClr val="FFFFFF"/>
                </a:solidFill>
              </a:rPr>
              <a:t>Share potential responses that have been pre-crafted (on the bottom half of the slide) if participation is minimal.</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dirty="0">
              <a:solidFill>
                <a:srgbClr val="FFFFFF"/>
              </a:solidFill>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solidFill>
                  <a:srgbClr val="FFFFFF"/>
                </a:solidFill>
              </a:rPr>
              <a:t>This case highlights gender bias or potentially </a:t>
            </a:r>
            <a:r>
              <a:rPr lang="en-US" dirty="0">
                <a:solidFill>
                  <a:srgbClr val="FFFFFF"/>
                </a:solidFill>
              </a:rPr>
              <a:t>another bias (race, ethnicity, age, etc.) depending on the target. </a:t>
            </a:r>
            <a:r>
              <a:rPr lang="en-US" b="0" dirty="0"/>
              <a:t>The presenter can suggest that women experience this type of role confusion and inappropriate terms of endearment more than men.</a:t>
            </a:r>
            <a:r>
              <a:rPr lang="en-US" dirty="0">
                <a:solidFill>
                  <a:srgbClr val="FFFFFF"/>
                </a:solidFill>
              </a:rPr>
              <a:t> </a:t>
            </a:r>
            <a:r>
              <a:rPr lang="en-US" b="0" dirty="0">
                <a:solidFill>
                  <a:srgbClr val="FFFFFF"/>
                </a:solidFill>
              </a:rPr>
              <a:t>This case is an opportunity to both respond as the target to bias-towards-self, or for a peer if bias-towards-others.</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800" b="0" dirty="0">
              <a:solidFill>
                <a:srgbClr val="FFFFFF"/>
              </a:solidFill>
              <a:effectLst/>
              <a:latin typeface="Calibri" panose="020F0502020204030204" pitchFamily="34" charset="0"/>
              <a:ea typeface="Times New Roman" panose="02020603050405020304" pitchFamily="18" charset="0"/>
              <a:cs typeface="Calibri" panose="020F0502020204030204" pitchFamily="34" charset="0"/>
            </a:endParaRPr>
          </a:p>
          <a:p>
            <a:pPr marL="285750" marR="0" lvl="0" indent="-2857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ow to respond to bias-towards-self:</a:t>
            </a:r>
          </a:p>
          <a:p>
            <a:pPr marL="742950" marR="0" lvl="1" indent="-2857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m one of your physicians and we are still seeing patients. Can you hit your call light to ask another member of the team for help?”</a:t>
            </a:r>
          </a:p>
          <a:p>
            <a:pPr marL="742950" marR="0" lvl="1" indent="-2857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 can grab you a ginger ale. In the future, I’d prefer if you called me Dr._____ or _____ instead of sweetheart.”</a:t>
            </a:r>
            <a:endParaRPr lang="en-US" sz="1800" dirty="0">
              <a:solidFill>
                <a:schemeClr val="dk1"/>
              </a:solidFill>
              <a:effectLst/>
              <a:latin typeface="Calibri" panose="020F0502020204030204" pitchFamily="34" charset="0"/>
              <a:ea typeface="Times New Roman" panose="02020603050405020304" pitchFamily="18" charset="0"/>
              <a:cs typeface="Times New Roman" panose="02020603050405020304" pitchFamily="18" charset="0"/>
            </a:endParaRPr>
          </a:p>
          <a:p>
            <a:pPr marL="285750" marR="0" lvl="0" indent="-2857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rPr>
              <a:t>How to respond to bias-towards-others:</a:t>
            </a:r>
          </a:p>
          <a:p>
            <a:pPr marL="742950" marR="0" lvl="1" indent="-2857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rPr>
              <a:t>“Oh, Dr. ___ needs to see our next patient. I’ll step out and grab you a ginger ale.”</a:t>
            </a:r>
          </a:p>
          <a:p>
            <a:pPr marL="742950" marR="0" lvl="1" indent="-2857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rPr>
              <a:t>“Dr. ___ needs to continue leading the team. We’ll grab a nurse/PCA/other provider on our way to see the next patient.”</a:t>
            </a:r>
            <a:r>
              <a:rPr lang="en-US" dirty="0">
                <a:effectLst/>
              </a:rPr>
              <a:t> </a:t>
            </a:r>
            <a:endParaRPr lang="en-US" dirty="0">
              <a:solidFill>
                <a:srgbClr val="FFFFFF"/>
              </a:solidFill>
            </a:endParaRPr>
          </a:p>
        </p:txBody>
      </p:sp>
      <p:sp>
        <p:nvSpPr>
          <p:cNvPr id="239" name="Google Shape;239;gc8450bc072_1_3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9"/>
        <p:cNvGrpSpPr/>
        <p:nvPr/>
      </p:nvGrpSpPr>
      <p:grpSpPr>
        <a:xfrm>
          <a:off x="0" y="0"/>
          <a:ext cx="0" cy="0"/>
          <a:chOff x="0" y="0"/>
          <a:chExt cx="0" cy="0"/>
        </a:xfrm>
      </p:grpSpPr>
      <p:sp>
        <p:nvSpPr>
          <p:cNvPr id="250" name="Google Shape;250;p3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1" name="Google Shape;251;p3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solidFill>
                  <a:schemeClr val="dk1"/>
                </a:solidFill>
                <a:latin typeface="Calibri"/>
                <a:ea typeface="Calibri"/>
                <a:cs typeface="Calibri"/>
                <a:sym typeface="Calibri"/>
              </a:rPr>
              <a:t>This slide transitions out of the case-based practice and to the closing portion of the workshop. Presenters should highlight that these experiences can sometimes feel very isolating, but residents should never feel that they need to process alone. This is an opportunity to explicitly state the resources and policies around responding to patient-expressed bias.</a:t>
            </a:r>
          </a:p>
          <a:p>
            <a:pPr marL="0" lvl="0" indent="0" algn="l" rtl="0">
              <a:spcBef>
                <a:spcPts val="0"/>
              </a:spcBef>
              <a:spcAft>
                <a:spcPts val="0"/>
              </a:spcAft>
              <a:buNone/>
            </a:pPr>
            <a:endParaRPr lang="en-US" sz="1200" dirty="0">
              <a:solidFill>
                <a:schemeClr val="dk1"/>
              </a:solidFill>
              <a:latin typeface="Calibri"/>
              <a:cs typeface="Calibri"/>
              <a:sym typeface="Calibri"/>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solidFill>
                  <a:schemeClr val="dk1"/>
                </a:solidFill>
                <a:latin typeface="Calibri"/>
                <a:cs typeface="Calibri"/>
                <a:sym typeface="Calibri"/>
              </a:rPr>
              <a:t>Add </a:t>
            </a:r>
            <a:r>
              <a:rPr lang="en-US" dirty="0"/>
              <a:t>your hospital escalation policy or a list of supportive community members to this slide</a:t>
            </a:r>
          </a:p>
        </p:txBody>
      </p:sp>
      <p:sp>
        <p:nvSpPr>
          <p:cNvPr id="252" name="Google Shape;252;p3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1</a:t>
            </a:fld>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9"/>
        <p:cNvGrpSpPr/>
        <p:nvPr/>
      </p:nvGrpSpPr>
      <p:grpSpPr>
        <a:xfrm>
          <a:off x="0" y="0"/>
          <a:ext cx="0" cy="0"/>
          <a:chOff x="0" y="0"/>
          <a:chExt cx="0" cy="0"/>
        </a:xfrm>
      </p:grpSpPr>
      <p:sp>
        <p:nvSpPr>
          <p:cNvPr id="250" name="Google Shape;250;p3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1" name="Google Shape;251;p3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This is an opportunity to explicitly state the resources and policies around responding to patient-expressed bias in the outpatient setting and to define outpatient leadership.</a:t>
            </a:r>
          </a:p>
          <a:p>
            <a:pPr marL="0" lvl="0" indent="0" algn="l" rtl="0">
              <a:spcBef>
                <a:spcPts val="0"/>
              </a:spcBef>
              <a:spcAft>
                <a:spcPts val="0"/>
              </a:spcAft>
              <a:buNone/>
            </a:pPr>
            <a:endParaRPr dirty="0"/>
          </a:p>
        </p:txBody>
      </p:sp>
      <p:sp>
        <p:nvSpPr>
          <p:cNvPr id="252" name="Google Shape;252;p3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2</a:t>
            </a:fld>
            <a:endParaRPr/>
          </a:p>
        </p:txBody>
      </p:sp>
    </p:spTree>
    <p:extLst>
      <p:ext uri="{BB962C8B-B14F-4D97-AF65-F5344CB8AC3E}">
        <p14:creationId xmlns:p14="http://schemas.microsoft.com/office/powerpoint/2010/main" val="1256524838"/>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9"/>
        <p:cNvGrpSpPr/>
        <p:nvPr/>
      </p:nvGrpSpPr>
      <p:grpSpPr>
        <a:xfrm>
          <a:off x="0" y="0"/>
          <a:ext cx="0" cy="0"/>
          <a:chOff x="0" y="0"/>
          <a:chExt cx="0" cy="0"/>
        </a:xfrm>
      </p:grpSpPr>
      <p:sp>
        <p:nvSpPr>
          <p:cNvPr id="250" name="Google Shape;250;p3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1" name="Google Shape;251;p3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This is an opportunity to explicitly state the resources and policies around responding to patient-expressed bias in the inpatient setting and to define inpatient leadership.</a:t>
            </a:r>
          </a:p>
          <a:p>
            <a:pPr marL="0" lvl="0" indent="0" algn="l" rtl="0">
              <a:spcBef>
                <a:spcPts val="0"/>
              </a:spcBef>
              <a:spcAft>
                <a:spcPts val="0"/>
              </a:spcAft>
              <a:buNone/>
            </a:pPr>
            <a:endParaRPr dirty="0"/>
          </a:p>
        </p:txBody>
      </p:sp>
      <p:sp>
        <p:nvSpPr>
          <p:cNvPr id="252" name="Google Shape;252;p3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3</a:t>
            </a:fld>
            <a:endParaRPr/>
          </a:p>
        </p:txBody>
      </p:sp>
    </p:spTree>
    <p:extLst>
      <p:ext uri="{BB962C8B-B14F-4D97-AF65-F5344CB8AC3E}">
        <p14:creationId xmlns:p14="http://schemas.microsoft.com/office/powerpoint/2010/main" val="3141445106"/>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7"/>
        <p:cNvGrpSpPr/>
        <p:nvPr/>
      </p:nvGrpSpPr>
      <p:grpSpPr>
        <a:xfrm>
          <a:off x="0" y="0"/>
          <a:ext cx="0" cy="0"/>
          <a:chOff x="0" y="0"/>
          <a:chExt cx="0" cy="0"/>
        </a:xfrm>
      </p:grpSpPr>
      <p:sp>
        <p:nvSpPr>
          <p:cNvPr id="298" name="Google Shape;298;gc99f4350b8_0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This slide reminds attendees who have closed the polling software to reopen it. Presenters should encourage attendees to fill out the post-intervention survey and to leave comments to improve the workshop for the future.</a:t>
            </a:r>
          </a:p>
          <a:p>
            <a:pPr marL="0" lvl="0" indent="0" algn="l" rtl="0">
              <a:spcBef>
                <a:spcPts val="0"/>
              </a:spcBef>
              <a:spcAft>
                <a:spcPts val="0"/>
              </a:spcAft>
              <a:buNone/>
            </a:pPr>
            <a:endParaRPr dirty="0"/>
          </a:p>
        </p:txBody>
      </p:sp>
      <p:sp>
        <p:nvSpPr>
          <p:cNvPr id="299" name="Google Shape;299;gc99f4350b8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6"/>
        <p:cNvGrpSpPr/>
        <p:nvPr/>
      </p:nvGrpSpPr>
      <p:grpSpPr>
        <a:xfrm>
          <a:off x="0" y="0"/>
          <a:ext cx="0" cy="0"/>
          <a:chOff x="0" y="0"/>
          <a:chExt cx="0" cy="0"/>
        </a:xfrm>
      </p:grpSpPr>
      <p:sp>
        <p:nvSpPr>
          <p:cNvPr id="307" name="Google Shape;307;p3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8" name="Google Shape;308;p3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This is the closing slide. Presenters should thank attendees for their participation and offer contact information for concerns or questions.</a:t>
            </a:r>
          </a:p>
          <a:p>
            <a:pPr marL="0" lvl="0" indent="0" algn="l" rtl="0">
              <a:spcBef>
                <a:spcPts val="0"/>
              </a:spcBef>
              <a:spcAft>
                <a:spcPts val="0"/>
              </a:spcAft>
              <a:buNone/>
            </a:pPr>
            <a:endParaRPr dirty="0"/>
          </a:p>
        </p:txBody>
      </p:sp>
      <p:sp>
        <p:nvSpPr>
          <p:cNvPr id="309" name="Google Shape;309;p3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5</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
        <p:cNvGrpSpPr/>
        <p:nvPr/>
      </p:nvGrpSpPr>
      <p:grpSpPr>
        <a:xfrm>
          <a:off x="0" y="0"/>
          <a:ext cx="0" cy="0"/>
          <a:chOff x="0" y="0"/>
          <a:chExt cx="0" cy="0"/>
        </a:xfrm>
      </p:grpSpPr>
      <p:sp>
        <p:nvSpPr>
          <p:cNvPr id="119" name="Google Shape;119;p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slide allows attendees who have joined late to access the poll application if they missed the QR code earlier in the slides. If using a site such as </a:t>
            </a:r>
            <a:r>
              <a:rPr lang="en-US" dirty="0" err="1"/>
              <a:t>Mentimeter</a:t>
            </a:r>
            <a:r>
              <a:rPr lang="en-US" dirty="0"/>
              <a:t>, remind attendees to keep the application open so pre and post workshop responses can be linked.</a:t>
            </a:r>
            <a:endParaRPr dirty="0"/>
          </a:p>
        </p:txBody>
      </p:sp>
      <p:sp>
        <p:nvSpPr>
          <p:cNvPr id="120" name="Google Shape;120;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8" name="Google Shape;128;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slide offers definitions of common language used when discussing patient bias. Review this content with attendees to create a shared language for the remainder of the session. Acknowledge that the “micro” in microaggressions speaks to the indignities often being in small aliquots, but does not reflect the impact or cumulative effect. </a:t>
            </a:r>
            <a:endParaRPr dirty="0"/>
          </a:p>
        </p:txBody>
      </p:sp>
      <p:sp>
        <p:nvSpPr>
          <p:cNvPr id="129" name="Google Shape;129;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
        <p:cNvGrpSpPr/>
        <p:nvPr/>
      </p:nvGrpSpPr>
      <p:grpSpPr>
        <a:xfrm>
          <a:off x="0" y="0"/>
          <a:ext cx="0" cy="0"/>
          <a:chOff x="0" y="0"/>
          <a:chExt cx="0" cy="0"/>
        </a:xfrm>
      </p:grpSpPr>
      <p:sp>
        <p:nvSpPr>
          <p:cNvPr id="135" name="Google Shape;135;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6" name="Google Shape;136;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0" dirty="0"/>
              <a:t>The presenter can share this is data from a national online survey done by Medscape/STAT in 2017. The results showed that 59% of all physicians had heard an offensive remark about their personal characteristics or background in the last 5 years. These comments revolved around age, ethnicity/national origin, gender, and race primarily, though religion, weight, political views and accent also each accounted for more than 10% of responses. Offer that this demonstrates how common patient bias is. This table makes obvious that non-White physicians experienced significantly more of these offensive remarks than did white physicians. </a:t>
            </a:r>
            <a:endParaRPr dirty="0"/>
          </a:p>
        </p:txBody>
      </p:sp>
      <p:sp>
        <p:nvSpPr>
          <p:cNvPr id="137" name="Google Shape;137;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dirty="0"/>
              <a:t>If local data on prevalence of bias is available, insert it here. If not, and you are teaching to a resident audience, consider leaving this slide to paint a picture of prevalence data in a similar population. If not presenting your own institution's data, change the title of this slide. </a:t>
            </a:r>
          </a:p>
          <a:p>
            <a:pPr marL="0" lvl="0" indent="0" algn="l" rtl="0">
              <a:spcBef>
                <a:spcPts val="0"/>
              </a:spcBef>
              <a:spcAft>
                <a:spcPts val="0"/>
              </a:spcAft>
              <a:buNone/>
            </a:pPr>
            <a:endParaRPr lang="en-US" b="0" dirty="0"/>
          </a:p>
          <a:p>
            <a:pPr marL="0" lvl="0" indent="0" algn="l" rtl="0">
              <a:spcBef>
                <a:spcPts val="0"/>
              </a:spcBef>
              <a:spcAft>
                <a:spcPts val="0"/>
              </a:spcAft>
              <a:buNone/>
            </a:pPr>
            <a:r>
              <a:rPr lang="en-US" b="0" dirty="0"/>
              <a:t>This slide speaks to the prevalence of the problem of patient bias at our institution. Of interns surveyed at our large, urban, academic medical center, most residents had observed or personally experienced gender bias. Most residents had observed racial bias. 30% of residents personally experienced racial bias. The source of this bias was patients and their families almost 80% of the time. When surveyed, other types of bias were identified that were not quantified.</a:t>
            </a:r>
          </a:p>
          <a:p>
            <a:pPr marL="0" lvl="0" indent="0" algn="l" rtl="0">
              <a:spcBef>
                <a:spcPts val="0"/>
              </a:spcBef>
              <a:spcAft>
                <a:spcPts val="0"/>
              </a:spcAft>
              <a:buNone/>
            </a:pPr>
            <a:endParaRPr lang="en-US" b="0" dirty="0"/>
          </a:p>
          <a:p>
            <a:pPr marL="0" lvl="0" indent="0" algn="l" rtl="0">
              <a:spcBef>
                <a:spcPts val="0"/>
              </a:spcBef>
              <a:spcAft>
                <a:spcPts val="0"/>
              </a:spcAft>
              <a:buNone/>
            </a:pPr>
            <a:endParaRPr lang="en-US" b="0" dirty="0"/>
          </a:p>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7</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00373406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This slide is for a word cloud that either integrates with ppt or that serves as a stand in for facilitators to display the polling software warm up question: </a:t>
            </a:r>
            <a:r>
              <a:rPr lang="en-US" sz="1200" dirty="0">
                <a:solidFill>
                  <a:srgbClr val="000000"/>
                </a:solidFill>
                <a:effectLst/>
                <a:latin typeface="Arial" panose="020B0604020202020204" pitchFamily="34" charset="0"/>
                <a:ea typeface="Times New Roman" panose="02020603050405020304" pitchFamily="18" charset="0"/>
              </a:rPr>
              <a:t>“What names other than 'doctor' have patients called you?” The presenter switches to the polling application so respondents can see the word cloud grow in real time. After ~30 seconds of increasing responses, the presenter offers that this cloud represents just a fraction of the patient bias that attendees have likely experienced. The presenter can read off a few of the words in the word cloud as examples. </a:t>
            </a:r>
            <a:r>
              <a:rPr lang="en-US" sz="1200" dirty="0">
                <a:solidFill>
                  <a:srgbClr val="000000"/>
                </a:solidFill>
                <a:effectLst/>
                <a:latin typeface="Arial" panose="020B0604020202020204" pitchFamily="34" charset="0"/>
              </a:rPr>
              <a:t>If time allows, consider facilitating a discussion with attendees about the experience of reading the names the word cloud is generating. </a:t>
            </a:r>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8</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408897286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gc473988d5b_0_7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7" name="Google Shape;157;gc473988d5b_0_75: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b="0" dirty="0">
                <a:solidFill>
                  <a:schemeClr val="dk1"/>
                </a:solidFill>
                <a:latin typeface="Calibri"/>
                <a:ea typeface="Calibri"/>
                <a:cs typeface="Calibri"/>
                <a:sym typeface="Calibri"/>
              </a:rPr>
              <a:t>This slide marks the transition to discussing the toolkit. Presenters will </a:t>
            </a:r>
            <a:r>
              <a:rPr lang="en-US" sz="1200" dirty="0">
                <a:solidFill>
                  <a:schemeClr val="dk1"/>
                </a:solidFill>
                <a:latin typeface="Calibri"/>
                <a:ea typeface="Calibri"/>
                <a:cs typeface="Calibri"/>
                <a:sym typeface="Calibri"/>
              </a:rPr>
              <a:t>introduce this part of the workshop as intervention training, where participants will learn tools that can be used when faced with patient bias. Participants may also be provided with handouts which include all the information from the slide deck. </a:t>
            </a:r>
            <a:endParaRPr dirty="0"/>
          </a:p>
        </p:txBody>
      </p:sp>
      <p:sp>
        <p:nvSpPr>
          <p:cNvPr id="158" name="Google Shape;158;gc473988d5b_0_75: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37"/>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lt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37"/>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lt1"/>
              </a:buClr>
              <a:buSzPts val="2400"/>
              <a:buNone/>
              <a:defRPr sz="2400"/>
            </a:lvl1pPr>
            <a:lvl2pPr lvl="1" algn="ctr">
              <a:lnSpc>
                <a:spcPct val="90000"/>
              </a:lnSpc>
              <a:spcBef>
                <a:spcPts val="500"/>
              </a:spcBef>
              <a:spcAft>
                <a:spcPts val="0"/>
              </a:spcAft>
              <a:buClr>
                <a:schemeClr val="lt1"/>
              </a:buClr>
              <a:buSzPts val="2000"/>
              <a:buNone/>
              <a:defRPr sz="2000"/>
            </a:lvl2pPr>
            <a:lvl3pPr lvl="2" algn="ctr">
              <a:lnSpc>
                <a:spcPct val="90000"/>
              </a:lnSpc>
              <a:spcBef>
                <a:spcPts val="500"/>
              </a:spcBef>
              <a:spcAft>
                <a:spcPts val="0"/>
              </a:spcAft>
              <a:buClr>
                <a:schemeClr val="lt1"/>
              </a:buClr>
              <a:buSzPts val="1800"/>
              <a:buNone/>
              <a:defRPr sz="1800"/>
            </a:lvl3pPr>
            <a:lvl4pPr lvl="3" algn="ctr">
              <a:lnSpc>
                <a:spcPct val="90000"/>
              </a:lnSpc>
              <a:spcBef>
                <a:spcPts val="500"/>
              </a:spcBef>
              <a:spcAft>
                <a:spcPts val="0"/>
              </a:spcAft>
              <a:buClr>
                <a:schemeClr val="lt1"/>
              </a:buClr>
              <a:buSzPts val="1600"/>
              <a:buNone/>
              <a:defRPr sz="1600"/>
            </a:lvl4pPr>
            <a:lvl5pPr lvl="4" algn="ctr">
              <a:lnSpc>
                <a:spcPct val="90000"/>
              </a:lnSpc>
              <a:spcBef>
                <a:spcPts val="500"/>
              </a:spcBef>
              <a:spcAft>
                <a:spcPts val="0"/>
              </a:spcAft>
              <a:buClr>
                <a:schemeClr val="lt1"/>
              </a:buClr>
              <a:buSzPts val="1600"/>
              <a:buNone/>
              <a:defRPr sz="1600"/>
            </a:lvl5pPr>
            <a:lvl6pPr lvl="5" algn="ctr">
              <a:lnSpc>
                <a:spcPct val="90000"/>
              </a:lnSpc>
              <a:spcBef>
                <a:spcPts val="500"/>
              </a:spcBef>
              <a:spcAft>
                <a:spcPts val="0"/>
              </a:spcAft>
              <a:buClr>
                <a:schemeClr val="lt1"/>
              </a:buClr>
              <a:buSzPts val="1600"/>
              <a:buNone/>
              <a:defRPr sz="1600"/>
            </a:lvl6pPr>
            <a:lvl7pPr lvl="6" algn="ctr">
              <a:lnSpc>
                <a:spcPct val="90000"/>
              </a:lnSpc>
              <a:spcBef>
                <a:spcPts val="500"/>
              </a:spcBef>
              <a:spcAft>
                <a:spcPts val="0"/>
              </a:spcAft>
              <a:buClr>
                <a:schemeClr val="lt1"/>
              </a:buClr>
              <a:buSzPts val="1600"/>
              <a:buNone/>
              <a:defRPr sz="1600"/>
            </a:lvl7pPr>
            <a:lvl8pPr lvl="7" algn="ctr">
              <a:lnSpc>
                <a:spcPct val="90000"/>
              </a:lnSpc>
              <a:spcBef>
                <a:spcPts val="500"/>
              </a:spcBef>
              <a:spcAft>
                <a:spcPts val="0"/>
              </a:spcAft>
              <a:buClr>
                <a:schemeClr val="lt1"/>
              </a:buClr>
              <a:buSzPts val="1600"/>
              <a:buNone/>
              <a:defRPr sz="1600"/>
            </a:lvl8pPr>
            <a:lvl9pPr lvl="8" algn="ctr">
              <a:lnSpc>
                <a:spcPct val="90000"/>
              </a:lnSpc>
              <a:spcBef>
                <a:spcPts val="500"/>
              </a:spcBef>
              <a:spcAft>
                <a:spcPts val="0"/>
              </a:spcAft>
              <a:buClr>
                <a:schemeClr val="lt1"/>
              </a:buClr>
              <a:buSzPts val="1600"/>
              <a:buNone/>
              <a:defRPr sz="1600"/>
            </a:lvl9pPr>
          </a:lstStyle>
          <a:p>
            <a:endParaRPr/>
          </a:p>
        </p:txBody>
      </p:sp>
      <p:sp>
        <p:nvSpPr>
          <p:cNvPr id="18" name="Google Shape;18;p3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3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3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47"/>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l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47"/>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lt1"/>
              </a:buClr>
              <a:buSzPts val="1800"/>
              <a:buChar char="•"/>
              <a:defRPr/>
            </a:lvl1pPr>
            <a:lvl2pPr marL="914400" lvl="1" indent="-342900" algn="l">
              <a:lnSpc>
                <a:spcPct val="90000"/>
              </a:lnSpc>
              <a:spcBef>
                <a:spcPts val="500"/>
              </a:spcBef>
              <a:spcAft>
                <a:spcPts val="0"/>
              </a:spcAft>
              <a:buClr>
                <a:schemeClr val="lt1"/>
              </a:buClr>
              <a:buSzPts val="1800"/>
              <a:buChar char="•"/>
              <a:defRPr/>
            </a:lvl2pPr>
            <a:lvl3pPr marL="1371600" lvl="2" indent="-342900" algn="l">
              <a:lnSpc>
                <a:spcPct val="90000"/>
              </a:lnSpc>
              <a:spcBef>
                <a:spcPts val="500"/>
              </a:spcBef>
              <a:spcAft>
                <a:spcPts val="0"/>
              </a:spcAft>
              <a:buClr>
                <a:schemeClr val="lt1"/>
              </a:buClr>
              <a:buSzPts val="1800"/>
              <a:buChar char="•"/>
              <a:defRPr/>
            </a:lvl3pPr>
            <a:lvl4pPr marL="1828800" lvl="3" indent="-342900" algn="l">
              <a:lnSpc>
                <a:spcPct val="90000"/>
              </a:lnSpc>
              <a:spcBef>
                <a:spcPts val="500"/>
              </a:spcBef>
              <a:spcAft>
                <a:spcPts val="0"/>
              </a:spcAft>
              <a:buClr>
                <a:schemeClr val="lt1"/>
              </a:buClr>
              <a:buSzPts val="1800"/>
              <a:buChar char="•"/>
              <a:defRPr/>
            </a:lvl4pPr>
            <a:lvl5pPr marL="2286000" lvl="4" indent="-342900" algn="l">
              <a:lnSpc>
                <a:spcPct val="90000"/>
              </a:lnSpc>
              <a:spcBef>
                <a:spcPts val="500"/>
              </a:spcBef>
              <a:spcAft>
                <a:spcPts val="0"/>
              </a:spcAft>
              <a:buClr>
                <a:schemeClr val="lt1"/>
              </a:buClr>
              <a:buSzPts val="1800"/>
              <a:buChar char="•"/>
              <a:defRPr/>
            </a:lvl5pPr>
            <a:lvl6pPr marL="2743200" lvl="5" indent="-342900" algn="l">
              <a:lnSpc>
                <a:spcPct val="90000"/>
              </a:lnSpc>
              <a:spcBef>
                <a:spcPts val="500"/>
              </a:spcBef>
              <a:spcAft>
                <a:spcPts val="0"/>
              </a:spcAft>
              <a:buClr>
                <a:schemeClr val="lt1"/>
              </a:buClr>
              <a:buSzPts val="1800"/>
              <a:buChar char="•"/>
              <a:defRPr/>
            </a:lvl6pPr>
            <a:lvl7pPr marL="3200400" lvl="6" indent="-342900" algn="l">
              <a:lnSpc>
                <a:spcPct val="90000"/>
              </a:lnSpc>
              <a:spcBef>
                <a:spcPts val="500"/>
              </a:spcBef>
              <a:spcAft>
                <a:spcPts val="0"/>
              </a:spcAft>
              <a:buClr>
                <a:schemeClr val="lt1"/>
              </a:buClr>
              <a:buSzPts val="1800"/>
              <a:buChar char="•"/>
              <a:defRPr/>
            </a:lvl7pPr>
            <a:lvl8pPr marL="3657600" lvl="7" indent="-342900" algn="l">
              <a:lnSpc>
                <a:spcPct val="90000"/>
              </a:lnSpc>
              <a:spcBef>
                <a:spcPts val="500"/>
              </a:spcBef>
              <a:spcAft>
                <a:spcPts val="0"/>
              </a:spcAft>
              <a:buClr>
                <a:schemeClr val="lt1"/>
              </a:buClr>
              <a:buSzPts val="1800"/>
              <a:buChar char="•"/>
              <a:defRPr/>
            </a:lvl8pPr>
            <a:lvl9pPr marL="4114800" lvl="8" indent="-342900" algn="l">
              <a:lnSpc>
                <a:spcPct val="90000"/>
              </a:lnSpc>
              <a:spcBef>
                <a:spcPts val="500"/>
              </a:spcBef>
              <a:spcAft>
                <a:spcPts val="0"/>
              </a:spcAft>
              <a:buClr>
                <a:schemeClr val="lt1"/>
              </a:buClr>
              <a:buSzPts val="1800"/>
              <a:buChar char="•"/>
              <a:defRPr/>
            </a:lvl9pPr>
          </a:lstStyle>
          <a:p>
            <a:endParaRPr/>
          </a:p>
        </p:txBody>
      </p:sp>
      <p:sp>
        <p:nvSpPr>
          <p:cNvPr id="81" name="Google Shape;81;p4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4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4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3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l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38"/>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lt1"/>
              </a:buClr>
              <a:buSzPts val="1800"/>
              <a:buChar char="•"/>
              <a:defRPr/>
            </a:lvl1pPr>
            <a:lvl2pPr marL="914400" lvl="1" indent="-342900" algn="l">
              <a:lnSpc>
                <a:spcPct val="90000"/>
              </a:lnSpc>
              <a:spcBef>
                <a:spcPts val="500"/>
              </a:spcBef>
              <a:spcAft>
                <a:spcPts val="0"/>
              </a:spcAft>
              <a:buClr>
                <a:schemeClr val="lt1"/>
              </a:buClr>
              <a:buSzPts val="1800"/>
              <a:buChar char="•"/>
              <a:defRPr/>
            </a:lvl2pPr>
            <a:lvl3pPr marL="1371600" lvl="2" indent="-342900" algn="l">
              <a:lnSpc>
                <a:spcPct val="90000"/>
              </a:lnSpc>
              <a:spcBef>
                <a:spcPts val="500"/>
              </a:spcBef>
              <a:spcAft>
                <a:spcPts val="0"/>
              </a:spcAft>
              <a:buClr>
                <a:schemeClr val="lt1"/>
              </a:buClr>
              <a:buSzPts val="1800"/>
              <a:buChar char="•"/>
              <a:defRPr/>
            </a:lvl3pPr>
            <a:lvl4pPr marL="1828800" lvl="3" indent="-342900" algn="l">
              <a:lnSpc>
                <a:spcPct val="90000"/>
              </a:lnSpc>
              <a:spcBef>
                <a:spcPts val="500"/>
              </a:spcBef>
              <a:spcAft>
                <a:spcPts val="0"/>
              </a:spcAft>
              <a:buClr>
                <a:schemeClr val="lt1"/>
              </a:buClr>
              <a:buSzPts val="1800"/>
              <a:buChar char="•"/>
              <a:defRPr/>
            </a:lvl4pPr>
            <a:lvl5pPr marL="2286000" lvl="4" indent="-342900" algn="l">
              <a:lnSpc>
                <a:spcPct val="90000"/>
              </a:lnSpc>
              <a:spcBef>
                <a:spcPts val="500"/>
              </a:spcBef>
              <a:spcAft>
                <a:spcPts val="0"/>
              </a:spcAft>
              <a:buClr>
                <a:schemeClr val="lt1"/>
              </a:buClr>
              <a:buSzPts val="1800"/>
              <a:buChar char="•"/>
              <a:defRPr/>
            </a:lvl5pPr>
            <a:lvl6pPr marL="2743200" lvl="5" indent="-342900" algn="l">
              <a:lnSpc>
                <a:spcPct val="90000"/>
              </a:lnSpc>
              <a:spcBef>
                <a:spcPts val="500"/>
              </a:spcBef>
              <a:spcAft>
                <a:spcPts val="0"/>
              </a:spcAft>
              <a:buClr>
                <a:schemeClr val="lt1"/>
              </a:buClr>
              <a:buSzPts val="1800"/>
              <a:buChar char="•"/>
              <a:defRPr/>
            </a:lvl6pPr>
            <a:lvl7pPr marL="3200400" lvl="6" indent="-342900" algn="l">
              <a:lnSpc>
                <a:spcPct val="90000"/>
              </a:lnSpc>
              <a:spcBef>
                <a:spcPts val="500"/>
              </a:spcBef>
              <a:spcAft>
                <a:spcPts val="0"/>
              </a:spcAft>
              <a:buClr>
                <a:schemeClr val="lt1"/>
              </a:buClr>
              <a:buSzPts val="1800"/>
              <a:buChar char="•"/>
              <a:defRPr/>
            </a:lvl7pPr>
            <a:lvl8pPr marL="3657600" lvl="7" indent="-342900" algn="l">
              <a:lnSpc>
                <a:spcPct val="90000"/>
              </a:lnSpc>
              <a:spcBef>
                <a:spcPts val="500"/>
              </a:spcBef>
              <a:spcAft>
                <a:spcPts val="0"/>
              </a:spcAft>
              <a:buClr>
                <a:schemeClr val="lt1"/>
              </a:buClr>
              <a:buSzPts val="1800"/>
              <a:buChar char="•"/>
              <a:defRPr/>
            </a:lvl8pPr>
            <a:lvl9pPr marL="4114800" lvl="8" indent="-342900" algn="l">
              <a:lnSpc>
                <a:spcPct val="90000"/>
              </a:lnSpc>
              <a:spcBef>
                <a:spcPts val="500"/>
              </a:spcBef>
              <a:spcAft>
                <a:spcPts val="0"/>
              </a:spcAft>
              <a:buClr>
                <a:schemeClr val="lt1"/>
              </a:buClr>
              <a:buSzPts val="1800"/>
              <a:buChar char="•"/>
              <a:defRPr/>
            </a:lvl9pPr>
          </a:lstStyle>
          <a:p>
            <a:endParaRPr/>
          </a:p>
        </p:txBody>
      </p:sp>
      <p:sp>
        <p:nvSpPr>
          <p:cNvPr id="24" name="Google Shape;24;p3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3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3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6"/>
        <p:cNvGrpSpPr/>
        <p:nvPr/>
      </p:nvGrpSpPr>
      <p:grpSpPr>
        <a:xfrm>
          <a:off x="0" y="0"/>
          <a:ext cx="0" cy="0"/>
          <a:chOff x="0" y="0"/>
          <a:chExt cx="0" cy="0"/>
        </a:xfrm>
      </p:grpSpPr>
      <p:sp>
        <p:nvSpPr>
          <p:cNvPr id="37" name="Google Shape;37;p40"/>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lt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8" name="Google Shape;38;p40"/>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lt1"/>
              </a:buClr>
              <a:buSzPts val="2400"/>
              <a:buNone/>
              <a:defRPr sz="2400">
                <a:solidFill>
                  <a:schemeClr val="lt1"/>
                </a:solidFill>
              </a:defRPr>
            </a:lvl1pPr>
            <a:lvl2pPr marL="914400" lvl="1" indent="-228600" algn="l">
              <a:lnSpc>
                <a:spcPct val="90000"/>
              </a:lnSpc>
              <a:spcBef>
                <a:spcPts val="500"/>
              </a:spcBef>
              <a:spcAft>
                <a:spcPts val="0"/>
              </a:spcAft>
              <a:buClr>
                <a:schemeClr val="lt1"/>
              </a:buClr>
              <a:buSzPts val="2000"/>
              <a:buNone/>
              <a:defRPr sz="2000">
                <a:solidFill>
                  <a:schemeClr val="lt1"/>
                </a:solidFill>
              </a:defRPr>
            </a:lvl2pPr>
            <a:lvl3pPr marL="1371600" lvl="2" indent="-228600" algn="l">
              <a:lnSpc>
                <a:spcPct val="90000"/>
              </a:lnSpc>
              <a:spcBef>
                <a:spcPts val="500"/>
              </a:spcBef>
              <a:spcAft>
                <a:spcPts val="0"/>
              </a:spcAft>
              <a:buClr>
                <a:schemeClr val="lt1"/>
              </a:buClr>
              <a:buSzPts val="1800"/>
              <a:buNone/>
              <a:defRPr sz="1800">
                <a:solidFill>
                  <a:schemeClr val="lt1"/>
                </a:solidFill>
              </a:defRPr>
            </a:lvl3pPr>
            <a:lvl4pPr marL="1828800" lvl="3" indent="-228600" algn="l">
              <a:lnSpc>
                <a:spcPct val="90000"/>
              </a:lnSpc>
              <a:spcBef>
                <a:spcPts val="500"/>
              </a:spcBef>
              <a:spcAft>
                <a:spcPts val="0"/>
              </a:spcAft>
              <a:buClr>
                <a:schemeClr val="lt1"/>
              </a:buClr>
              <a:buSzPts val="1600"/>
              <a:buNone/>
              <a:defRPr sz="1600">
                <a:solidFill>
                  <a:schemeClr val="lt1"/>
                </a:solidFill>
              </a:defRPr>
            </a:lvl4pPr>
            <a:lvl5pPr marL="2286000" lvl="4" indent="-228600" algn="l">
              <a:lnSpc>
                <a:spcPct val="90000"/>
              </a:lnSpc>
              <a:spcBef>
                <a:spcPts val="500"/>
              </a:spcBef>
              <a:spcAft>
                <a:spcPts val="0"/>
              </a:spcAft>
              <a:buClr>
                <a:schemeClr val="lt1"/>
              </a:buClr>
              <a:buSzPts val="1600"/>
              <a:buNone/>
              <a:defRPr sz="1600">
                <a:solidFill>
                  <a:schemeClr val="lt1"/>
                </a:solidFill>
              </a:defRPr>
            </a:lvl5pPr>
            <a:lvl6pPr marL="2743200" lvl="5" indent="-228600" algn="l">
              <a:lnSpc>
                <a:spcPct val="90000"/>
              </a:lnSpc>
              <a:spcBef>
                <a:spcPts val="500"/>
              </a:spcBef>
              <a:spcAft>
                <a:spcPts val="0"/>
              </a:spcAft>
              <a:buClr>
                <a:schemeClr val="lt1"/>
              </a:buClr>
              <a:buSzPts val="1600"/>
              <a:buNone/>
              <a:defRPr sz="1600">
                <a:solidFill>
                  <a:schemeClr val="lt1"/>
                </a:solidFill>
              </a:defRPr>
            </a:lvl6pPr>
            <a:lvl7pPr marL="3200400" lvl="6" indent="-228600" algn="l">
              <a:lnSpc>
                <a:spcPct val="90000"/>
              </a:lnSpc>
              <a:spcBef>
                <a:spcPts val="500"/>
              </a:spcBef>
              <a:spcAft>
                <a:spcPts val="0"/>
              </a:spcAft>
              <a:buClr>
                <a:schemeClr val="lt1"/>
              </a:buClr>
              <a:buSzPts val="1600"/>
              <a:buNone/>
              <a:defRPr sz="1600">
                <a:solidFill>
                  <a:schemeClr val="lt1"/>
                </a:solidFill>
              </a:defRPr>
            </a:lvl7pPr>
            <a:lvl8pPr marL="3657600" lvl="7" indent="-228600" algn="l">
              <a:lnSpc>
                <a:spcPct val="90000"/>
              </a:lnSpc>
              <a:spcBef>
                <a:spcPts val="500"/>
              </a:spcBef>
              <a:spcAft>
                <a:spcPts val="0"/>
              </a:spcAft>
              <a:buClr>
                <a:schemeClr val="lt1"/>
              </a:buClr>
              <a:buSzPts val="1600"/>
              <a:buNone/>
              <a:defRPr sz="1600">
                <a:solidFill>
                  <a:schemeClr val="lt1"/>
                </a:solidFill>
              </a:defRPr>
            </a:lvl8pPr>
            <a:lvl9pPr marL="4114800" lvl="8" indent="-228600" algn="l">
              <a:lnSpc>
                <a:spcPct val="90000"/>
              </a:lnSpc>
              <a:spcBef>
                <a:spcPts val="500"/>
              </a:spcBef>
              <a:spcAft>
                <a:spcPts val="0"/>
              </a:spcAft>
              <a:buClr>
                <a:schemeClr val="lt1"/>
              </a:buClr>
              <a:buSzPts val="1600"/>
              <a:buNone/>
              <a:defRPr sz="1600">
                <a:solidFill>
                  <a:schemeClr val="lt1"/>
                </a:solidFill>
              </a:defRPr>
            </a:lvl9pPr>
          </a:lstStyle>
          <a:p>
            <a:endParaRPr/>
          </a:p>
        </p:txBody>
      </p:sp>
      <p:sp>
        <p:nvSpPr>
          <p:cNvPr id="39" name="Google Shape;39;p4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0" name="Google Shape;40;p4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1" name="Google Shape;41;p4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42"/>
        <p:cNvGrpSpPr/>
        <p:nvPr/>
      </p:nvGrpSpPr>
      <p:grpSpPr>
        <a:xfrm>
          <a:off x="0" y="0"/>
          <a:ext cx="0" cy="0"/>
          <a:chOff x="0" y="0"/>
          <a:chExt cx="0" cy="0"/>
        </a:xfrm>
      </p:grpSpPr>
      <p:sp>
        <p:nvSpPr>
          <p:cNvPr id="43" name="Google Shape;43;p4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l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4" name="Google Shape;44;p41"/>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lt1"/>
              </a:buClr>
              <a:buSzPts val="1800"/>
              <a:buChar char="•"/>
              <a:defRPr/>
            </a:lvl1pPr>
            <a:lvl2pPr marL="914400" lvl="1" indent="-342900" algn="l">
              <a:lnSpc>
                <a:spcPct val="90000"/>
              </a:lnSpc>
              <a:spcBef>
                <a:spcPts val="500"/>
              </a:spcBef>
              <a:spcAft>
                <a:spcPts val="0"/>
              </a:spcAft>
              <a:buClr>
                <a:schemeClr val="lt1"/>
              </a:buClr>
              <a:buSzPts val="1800"/>
              <a:buChar char="•"/>
              <a:defRPr/>
            </a:lvl2pPr>
            <a:lvl3pPr marL="1371600" lvl="2" indent="-342900" algn="l">
              <a:lnSpc>
                <a:spcPct val="90000"/>
              </a:lnSpc>
              <a:spcBef>
                <a:spcPts val="500"/>
              </a:spcBef>
              <a:spcAft>
                <a:spcPts val="0"/>
              </a:spcAft>
              <a:buClr>
                <a:schemeClr val="lt1"/>
              </a:buClr>
              <a:buSzPts val="1800"/>
              <a:buChar char="•"/>
              <a:defRPr/>
            </a:lvl3pPr>
            <a:lvl4pPr marL="1828800" lvl="3" indent="-342900" algn="l">
              <a:lnSpc>
                <a:spcPct val="90000"/>
              </a:lnSpc>
              <a:spcBef>
                <a:spcPts val="500"/>
              </a:spcBef>
              <a:spcAft>
                <a:spcPts val="0"/>
              </a:spcAft>
              <a:buClr>
                <a:schemeClr val="lt1"/>
              </a:buClr>
              <a:buSzPts val="1800"/>
              <a:buChar char="•"/>
              <a:defRPr/>
            </a:lvl4pPr>
            <a:lvl5pPr marL="2286000" lvl="4" indent="-342900" algn="l">
              <a:lnSpc>
                <a:spcPct val="90000"/>
              </a:lnSpc>
              <a:spcBef>
                <a:spcPts val="500"/>
              </a:spcBef>
              <a:spcAft>
                <a:spcPts val="0"/>
              </a:spcAft>
              <a:buClr>
                <a:schemeClr val="lt1"/>
              </a:buClr>
              <a:buSzPts val="1800"/>
              <a:buChar char="•"/>
              <a:defRPr/>
            </a:lvl5pPr>
            <a:lvl6pPr marL="2743200" lvl="5" indent="-342900" algn="l">
              <a:lnSpc>
                <a:spcPct val="90000"/>
              </a:lnSpc>
              <a:spcBef>
                <a:spcPts val="500"/>
              </a:spcBef>
              <a:spcAft>
                <a:spcPts val="0"/>
              </a:spcAft>
              <a:buClr>
                <a:schemeClr val="lt1"/>
              </a:buClr>
              <a:buSzPts val="1800"/>
              <a:buChar char="•"/>
              <a:defRPr/>
            </a:lvl6pPr>
            <a:lvl7pPr marL="3200400" lvl="6" indent="-342900" algn="l">
              <a:lnSpc>
                <a:spcPct val="90000"/>
              </a:lnSpc>
              <a:spcBef>
                <a:spcPts val="500"/>
              </a:spcBef>
              <a:spcAft>
                <a:spcPts val="0"/>
              </a:spcAft>
              <a:buClr>
                <a:schemeClr val="lt1"/>
              </a:buClr>
              <a:buSzPts val="1800"/>
              <a:buChar char="•"/>
              <a:defRPr/>
            </a:lvl7pPr>
            <a:lvl8pPr marL="3657600" lvl="7" indent="-342900" algn="l">
              <a:lnSpc>
                <a:spcPct val="90000"/>
              </a:lnSpc>
              <a:spcBef>
                <a:spcPts val="500"/>
              </a:spcBef>
              <a:spcAft>
                <a:spcPts val="0"/>
              </a:spcAft>
              <a:buClr>
                <a:schemeClr val="lt1"/>
              </a:buClr>
              <a:buSzPts val="1800"/>
              <a:buChar char="•"/>
              <a:defRPr/>
            </a:lvl8pPr>
            <a:lvl9pPr marL="4114800" lvl="8" indent="-342900" algn="l">
              <a:lnSpc>
                <a:spcPct val="90000"/>
              </a:lnSpc>
              <a:spcBef>
                <a:spcPts val="500"/>
              </a:spcBef>
              <a:spcAft>
                <a:spcPts val="0"/>
              </a:spcAft>
              <a:buClr>
                <a:schemeClr val="lt1"/>
              </a:buClr>
              <a:buSzPts val="1800"/>
              <a:buChar char="•"/>
              <a:defRPr/>
            </a:lvl9pPr>
          </a:lstStyle>
          <a:p>
            <a:endParaRPr/>
          </a:p>
        </p:txBody>
      </p:sp>
      <p:sp>
        <p:nvSpPr>
          <p:cNvPr id="45" name="Google Shape;45;p41"/>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lt1"/>
              </a:buClr>
              <a:buSzPts val="1800"/>
              <a:buChar char="•"/>
              <a:defRPr/>
            </a:lvl1pPr>
            <a:lvl2pPr marL="914400" lvl="1" indent="-342900" algn="l">
              <a:lnSpc>
                <a:spcPct val="90000"/>
              </a:lnSpc>
              <a:spcBef>
                <a:spcPts val="500"/>
              </a:spcBef>
              <a:spcAft>
                <a:spcPts val="0"/>
              </a:spcAft>
              <a:buClr>
                <a:schemeClr val="lt1"/>
              </a:buClr>
              <a:buSzPts val="1800"/>
              <a:buChar char="•"/>
              <a:defRPr/>
            </a:lvl2pPr>
            <a:lvl3pPr marL="1371600" lvl="2" indent="-342900" algn="l">
              <a:lnSpc>
                <a:spcPct val="90000"/>
              </a:lnSpc>
              <a:spcBef>
                <a:spcPts val="500"/>
              </a:spcBef>
              <a:spcAft>
                <a:spcPts val="0"/>
              </a:spcAft>
              <a:buClr>
                <a:schemeClr val="lt1"/>
              </a:buClr>
              <a:buSzPts val="1800"/>
              <a:buChar char="•"/>
              <a:defRPr/>
            </a:lvl3pPr>
            <a:lvl4pPr marL="1828800" lvl="3" indent="-342900" algn="l">
              <a:lnSpc>
                <a:spcPct val="90000"/>
              </a:lnSpc>
              <a:spcBef>
                <a:spcPts val="500"/>
              </a:spcBef>
              <a:spcAft>
                <a:spcPts val="0"/>
              </a:spcAft>
              <a:buClr>
                <a:schemeClr val="lt1"/>
              </a:buClr>
              <a:buSzPts val="1800"/>
              <a:buChar char="•"/>
              <a:defRPr/>
            </a:lvl4pPr>
            <a:lvl5pPr marL="2286000" lvl="4" indent="-342900" algn="l">
              <a:lnSpc>
                <a:spcPct val="90000"/>
              </a:lnSpc>
              <a:spcBef>
                <a:spcPts val="500"/>
              </a:spcBef>
              <a:spcAft>
                <a:spcPts val="0"/>
              </a:spcAft>
              <a:buClr>
                <a:schemeClr val="lt1"/>
              </a:buClr>
              <a:buSzPts val="1800"/>
              <a:buChar char="•"/>
              <a:defRPr/>
            </a:lvl5pPr>
            <a:lvl6pPr marL="2743200" lvl="5" indent="-342900" algn="l">
              <a:lnSpc>
                <a:spcPct val="90000"/>
              </a:lnSpc>
              <a:spcBef>
                <a:spcPts val="500"/>
              </a:spcBef>
              <a:spcAft>
                <a:spcPts val="0"/>
              </a:spcAft>
              <a:buClr>
                <a:schemeClr val="lt1"/>
              </a:buClr>
              <a:buSzPts val="1800"/>
              <a:buChar char="•"/>
              <a:defRPr/>
            </a:lvl6pPr>
            <a:lvl7pPr marL="3200400" lvl="6" indent="-342900" algn="l">
              <a:lnSpc>
                <a:spcPct val="90000"/>
              </a:lnSpc>
              <a:spcBef>
                <a:spcPts val="500"/>
              </a:spcBef>
              <a:spcAft>
                <a:spcPts val="0"/>
              </a:spcAft>
              <a:buClr>
                <a:schemeClr val="lt1"/>
              </a:buClr>
              <a:buSzPts val="1800"/>
              <a:buChar char="•"/>
              <a:defRPr/>
            </a:lvl7pPr>
            <a:lvl8pPr marL="3657600" lvl="7" indent="-342900" algn="l">
              <a:lnSpc>
                <a:spcPct val="90000"/>
              </a:lnSpc>
              <a:spcBef>
                <a:spcPts val="500"/>
              </a:spcBef>
              <a:spcAft>
                <a:spcPts val="0"/>
              </a:spcAft>
              <a:buClr>
                <a:schemeClr val="lt1"/>
              </a:buClr>
              <a:buSzPts val="1800"/>
              <a:buChar char="•"/>
              <a:defRPr/>
            </a:lvl8pPr>
            <a:lvl9pPr marL="4114800" lvl="8" indent="-342900" algn="l">
              <a:lnSpc>
                <a:spcPct val="90000"/>
              </a:lnSpc>
              <a:spcBef>
                <a:spcPts val="500"/>
              </a:spcBef>
              <a:spcAft>
                <a:spcPts val="0"/>
              </a:spcAft>
              <a:buClr>
                <a:schemeClr val="lt1"/>
              </a:buClr>
              <a:buSzPts val="1800"/>
              <a:buChar char="•"/>
              <a:defRPr/>
            </a:lvl9pPr>
          </a:lstStyle>
          <a:p>
            <a:endParaRPr/>
          </a:p>
        </p:txBody>
      </p:sp>
      <p:sp>
        <p:nvSpPr>
          <p:cNvPr id="46" name="Google Shape;46;p4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4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4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4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l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4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4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4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4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4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4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44"/>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lt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44"/>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lt1"/>
              </a:buClr>
              <a:buSzPts val="3200"/>
              <a:buChar char="•"/>
              <a:defRPr sz="3200"/>
            </a:lvl1pPr>
            <a:lvl2pPr marL="914400" lvl="1" indent="-406400" algn="l">
              <a:lnSpc>
                <a:spcPct val="90000"/>
              </a:lnSpc>
              <a:spcBef>
                <a:spcPts val="500"/>
              </a:spcBef>
              <a:spcAft>
                <a:spcPts val="0"/>
              </a:spcAft>
              <a:buClr>
                <a:schemeClr val="lt1"/>
              </a:buClr>
              <a:buSzPts val="2800"/>
              <a:buChar char="•"/>
              <a:defRPr sz="2800"/>
            </a:lvl2pPr>
            <a:lvl3pPr marL="1371600" lvl="2" indent="-381000" algn="l">
              <a:lnSpc>
                <a:spcPct val="90000"/>
              </a:lnSpc>
              <a:spcBef>
                <a:spcPts val="500"/>
              </a:spcBef>
              <a:spcAft>
                <a:spcPts val="0"/>
              </a:spcAft>
              <a:buClr>
                <a:schemeClr val="lt1"/>
              </a:buClr>
              <a:buSzPts val="2400"/>
              <a:buChar char="•"/>
              <a:defRPr sz="2400"/>
            </a:lvl3pPr>
            <a:lvl4pPr marL="1828800" lvl="3" indent="-355600" algn="l">
              <a:lnSpc>
                <a:spcPct val="90000"/>
              </a:lnSpc>
              <a:spcBef>
                <a:spcPts val="500"/>
              </a:spcBef>
              <a:spcAft>
                <a:spcPts val="0"/>
              </a:spcAft>
              <a:buClr>
                <a:schemeClr val="lt1"/>
              </a:buClr>
              <a:buSzPts val="2000"/>
              <a:buChar char="•"/>
              <a:defRPr sz="2000"/>
            </a:lvl4pPr>
            <a:lvl5pPr marL="2286000" lvl="4" indent="-355600" algn="l">
              <a:lnSpc>
                <a:spcPct val="90000"/>
              </a:lnSpc>
              <a:spcBef>
                <a:spcPts val="500"/>
              </a:spcBef>
              <a:spcAft>
                <a:spcPts val="0"/>
              </a:spcAft>
              <a:buClr>
                <a:schemeClr val="lt1"/>
              </a:buClr>
              <a:buSzPts val="2000"/>
              <a:buChar char="•"/>
              <a:defRPr sz="2000"/>
            </a:lvl5pPr>
            <a:lvl6pPr marL="2743200" lvl="5" indent="-355600" algn="l">
              <a:lnSpc>
                <a:spcPct val="90000"/>
              </a:lnSpc>
              <a:spcBef>
                <a:spcPts val="500"/>
              </a:spcBef>
              <a:spcAft>
                <a:spcPts val="0"/>
              </a:spcAft>
              <a:buClr>
                <a:schemeClr val="lt1"/>
              </a:buClr>
              <a:buSzPts val="2000"/>
              <a:buChar char="•"/>
              <a:defRPr sz="2000"/>
            </a:lvl6pPr>
            <a:lvl7pPr marL="3200400" lvl="6" indent="-355600" algn="l">
              <a:lnSpc>
                <a:spcPct val="90000"/>
              </a:lnSpc>
              <a:spcBef>
                <a:spcPts val="500"/>
              </a:spcBef>
              <a:spcAft>
                <a:spcPts val="0"/>
              </a:spcAft>
              <a:buClr>
                <a:schemeClr val="lt1"/>
              </a:buClr>
              <a:buSzPts val="2000"/>
              <a:buChar char="•"/>
              <a:defRPr sz="2000"/>
            </a:lvl7pPr>
            <a:lvl8pPr marL="3657600" lvl="7" indent="-355600" algn="l">
              <a:lnSpc>
                <a:spcPct val="90000"/>
              </a:lnSpc>
              <a:spcBef>
                <a:spcPts val="500"/>
              </a:spcBef>
              <a:spcAft>
                <a:spcPts val="0"/>
              </a:spcAft>
              <a:buClr>
                <a:schemeClr val="lt1"/>
              </a:buClr>
              <a:buSzPts val="2000"/>
              <a:buChar char="•"/>
              <a:defRPr sz="2000"/>
            </a:lvl8pPr>
            <a:lvl9pPr marL="4114800" lvl="8" indent="-355600" algn="l">
              <a:lnSpc>
                <a:spcPct val="90000"/>
              </a:lnSpc>
              <a:spcBef>
                <a:spcPts val="500"/>
              </a:spcBef>
              <a:spcAft>
                <a:spcPts val="0"/>
              </a:spcAft>
              <a:buClr>
                <a:schemeClr val="lt1"/>
              </a:buClr>
              <a:buSzPts val="2000"/>
              <a:buChar char="•"/>
              <a:defRPr sz="2000"/>
            </a:lvl9pPr>
          </a:lstStyle>
          <a:p>
            <a:endParaRPr/>
          </a:p>
        </p:txBody>
      </p:sp>
      <p:sp>
        <p:nvSpPr>
          <p:cNvPr id="61" name="Google Shape;61;p44"/>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lt1"/>
              </a:buClr>
              <a:buSzPts val="1600"/>
              <a:buNone/>
              <a:defRPr sz="1600"/>
            </a:lvl1pPr>
            <a:lvl2pPr marL="914400" lvl="1" indent="-228600" algn="l">
              <a:lnSpc>
                <a:spcPct val="90000"/>
              </a:lnSpc>
              <a:spcBef>
                <a:spcPts val="500"/>
              </a:spcBef>
              <a:spcAft>
                <a:spcPts val="0"/>
              </a:spcAft>
              <a:buClr>
                <a:schemeClr val="lt1"/>
              </a:buClr>
              <a:buSzPts val="1400"/>
              <a:buNone/>
              <a:defRPr sz="1400"/>
            </a:lvl2pPr>
            <a:lvl3pPr marL="1371600" lvl="2" indent="-228600" algn="l">
              <a:lnSpc>
                <a:spcPct val="90000"/>
              </a:lnSpc>
              <a:spcBef>
                <a:spcPts val="500"/>
              </a:spcBef>
              <a:spcAft>
                <a:spcPts val="0"/>
              </a:spcAft>
              <a:buClr>
                <a:schemeClr val="lt1"/>
              </a:buClr>
              <a:buSzPts val="1200"/>
              <a:buNone/>
              <a:defRPr sz="1200"/>
            </a:lvl3pPr>
            <a:lvl4pPr marL="1828800" lvl="3" indent="-228600" algn="l">
              <a:lnSpc>
                <a:spcPct val="90000"/>
              </a:lnSpc>
              <a:spcBef>
                <a:spcPts val="500"/>
              </a:spcBef>
              <a:spcAft>
                <a:spcPts val="0"/>
              </a:spcAft>
              <a:buClr>
                <a:schemeClr val="lt1"/>
              </a:buClr>
              <a:buSzPts val="1000"/>
              <a:buNone/>
              <a:defRPr sz="1000"/>
            </a:lvl4pPr>
            <a:lvl5pPr marL="2286000" lvl="4" indent="-228600" algn="l">
              <a:lnSpc>
                <a:spcPct val="90000"/>
              </a:lnSpc>
              <a:spcBef>
                <a:spcPts val="500"/>
              </a:spcBef>
              <a:spcAft>
                <a:spcPts val="0"/>
              </a:spcAft>
              <a:buClr>
                <a:schemeClr val="lt1"/>
              </a:buClr>
              <a:buSzPts val="1000"/>
              <a:buNone/>
              <a:defRPr sz="1000"/>
            </a:lvl5pPr>
            <a:lvl6pPr marL="2743200" lvl="5" indent="-228600" algn="l">
              <a:lnSpc>
                <a:spcPct val="90000"/>
              </a:lnSpc>
              <a:spcBef>
                <a:spcPts val="500"/>
              </a:spcBef>
              <a:spcAft>
                <a:spcPts val="0"/>
              </a:spcAft>
              <a:buClr>
                <a:schemeClr val="lt1"/>
              </a:buClr>
              <a:buSzPts val="1000"/>
              <a:buNone/>
              <a:defRPr sz="1000"/>
            </a:lvl6pPr>
            <a:lvl7pPr marL="3200400" lvl="6" indent="-228600" algn="l">
              <a:lnSpc>
                <a:spcPct val="90000"/>
              </a:lnSpc>
              <a:spcBef>
                <a:spcPts val="500"/>
              </a:spcBef>
              <a:spcAft>
                <a:spcPts val="0"/>
              </a:spcAft>
              <a:buClr>
                <a:schemeClr val="lt1"/>
              </a:buClr>
              <a:buSzPts val="1000"/>
              <a:buNone/>
              <a:defRPr sz="1000"/>
            </a:lvl7pPr>
            <a:lvl8pPr marL="3657600" lvl="7" indent="-228600" algn="l">
              <a:lnSpc>
                <a:spcPct val="90000"/>
              </a:lnSpc>
              <a:spcBef>
                <a:spcPts val="500"/>
              </a:spcBef>
              <a:spcAft>
                <a:spcPts val="0"/>
              </a:spcAft>
              <a:buClr>
                <a:schemeClr val="lt1"/>
              </a:buClr>
              <a:buSzPts val="1000"/>
              <a:buNone/>
              <a:defRPr sz="1000"/>
            </a:lvl8pPr>
            <a:lvl9pPr marL="4114800" lvl="8" indent="-228600" algn="l">
              <a:lnSpc>
                <a:spcPct val="90000"/>
              </a:lnSpc>
              <a:spcBef>
                <a:spcPts val="500"/>
              </a:spcBef>
              <a:spcAft>
                <a:spcPts val="0"/>
              </a:spcAft>
              <a:buClr>
                <a:schemeClr val="lt1"/>
              </a:buClr>
              <a:buSzPts val="1000"/>
              <a:buNone/>
              <a:defRPr sz="1000"/>
            </a:lvl9pPr>
          </a:lstStyle>
          <a:p>
            <a:endParaRPr/>
          </a:p>
        </p:txBody>
      </p:sp>
      <p:sp>
        <p:nvSpPr>
          <p:cNvPr id="62" name="Google Shape;62;p4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4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4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45"/>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lt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45"/>
          <p:cNvSpPr>
            <a:spLocks noGrp="1"/>
          </p:cNvSpPr>
          <p:nvPr>
            <p:ph type="pic" idx="2"/>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1000"/>
              </a:spcBef>
              <a:spcAft>
                <a:spcPts val="0"/>
              </a:spcAft>
              <a:buClr>
                <a:schemeClr val="lt1"/>
              </a:buClr>
              <a:buSzPts val="3200"/>
              <a:buFont typeface="Arial"/>
              <a:buNone/>
              <a:defRPr sz="3200" b="0" i="0" u="none" strike="noStrike" cap="none">
                <a:solidFill>
                  <a:schemeClr val="lt1"/>
                </a:solidFill>
                <a:latin typeface="Calibri"/>
                <a:ea typeface="Calibri"/>
                <a:cs typeface="Calibri"/>
                <a:sym typeface="Calibri"/>
              </a:defRPr>
            </a:lvl1pPr>
            <a:lvl2pPr marR="0" lvl="1" algn="l" rtl="0">
              <a:lnSpc>
                <a:spcPct val="90000"/>
              </a:lnSpc>
              <a:spcBef>
                <a:spcPts val="500"/>
              </a:spcBef>
              <a:spcAft>
                <a:spcPts val="0"/>
              </a:spcAft>
              <a:buClr>
                <a:schemeClr val="lt1"/>
              </a:buClr>
              <a:buSzPts val="2800"/>
              <a:buFont typeface="Arial"/>
              <a:buNone/>
              <a:defRPr sz="2800" b="0" i="0" u="none" strike="noStrike" cap="none">
                <a:solidFill>
                  <a:schemeClr val="lt1"/>
                </a:solidFill>
                <a:latin typeface="Calibri"/>
                <a:ea typeface="Calibri"/>
                <a:cs typeface="Calibri"/>
                <a:sym typeface="Calibri"/>
              </a:defRPr>
            </a:lvl2pPr>
            <a:lvl3pPr marR="0" lvl="2" algn="l" rtl="0">
              <a:lnSpc>
                <a:spcPct val="90000"/>
              </a:lnSpc>
              <a:spcBef>
                <a:spcPts val="500"/>
              </a:spcBef>
              <a:spcAft>
                <a:spcPts val="0"/>
              </a:spcAft>
              <a:buClr>
                <a:schemeClr val="lt1"/>
              </a:buClr>
              <a:buSzPts val="2400"/>
              <a:buFont typeface="Arial"/>
              <a:buNone/>
              <a:defRPr sz="2400" b="0" i="0" u="none" strike="noStrike" cap="none">
                <a:solidFill>
                  <a:schemeClr val="lt1"/>
                </a:solidFill>
                <a:latin typeface="Calibri"/>
                <a:ea typeface="Calibri"/>
                <a:cs typeface="Calibri"/>
                <a:sym typeface="Calibri"/>
              </a:defRPr>
            </a:lvl3pPr>
            <a:lvl4pPr marR="0" lvl="3" algn="l" rtl="0">
              <a:lnSpc>
                <a:spcPct val="90000"/>
              </a:lnSpc>
              <a:spcBef>
                <a:spcPts val="500"/>
              </a:spcBef>
              <a:spcAft>
                <a:spcPts val="0"/>
              </a:spcAft>
              <a:buClr>
                <a:schemeClr val="lt1"/>
              </a:buClr>
              <a:buSzPts val="2000"/>
              <a:buFont typeface="Arial"/>
              <a:buNone/>
              <a:defRPr sz="2000" b="0" i="0" u="none" strike="noStrike" cap="none">
                <a:solidFill>
                  <a:schemeClr val="lt1"/>
                </a:solidFill>
                <a:latin typeface="Calibri"/>
                <a:ea typeface="Calibri"/>
                <a:cs typeface="Calibri"/>
                <a:sym typeface="Calibri"/>
              </a:defRPr>
            </a:lvl4pPr>
            <a:lvl5pPr marR="0" lvl="4" algn="l" rtl="0">
              <a:lnSpc>
                <a:spcPct val="90000"/>
              </a:lnSpc>
              <a:spcBef>
                <a:spcPts val="500"/>
              </a:spcBef>
              <a:spcAft>
                <a:spcPts val="0"/>
              </a:spcAft>
              <a:buClr>
                <a:schemeClr val="lt1"/>
              </a:buClr>
              <a:buSzPts val="2000"/>
              <a:buFont typeface="Arial"/>
              <a:buNone/>
              <a:defRPr sz="2000" b="0" i="0" u="none" strike="noStrike" cap="none">
                <a:solidFill>
                  <a:schemeClr val="lt1"/>
                </a:solidFill>
                <a:latin typeface="Calibri"/>
                <a:ea typeface="Calibri"/>
                <a:cs typeface="Calibri"/>
                <a:sym typeface="Calibri"/>
              </a:defRPr>
            </a:lvl5pPr>
            <a:lvl6pPr marR="0" lvl="5" algn="l" rtl="0">
              <a:lnSpc>
                <a:spcPct val="90000"/>
              </a:lnSpc>
              <a:spcBef>
                <a:spcPts val="500"/>
              </a:spcBef>
              <a:spcAft>
                <a:spcPts val="0"/>
              </a:spcAft>
              <a:buClr>
                <a:schemeClr val="lt1"/>
              </a:buClr>
              <a:buSzPts val="2000"/>
              <a:buFont typeface="Arial"/>
              <a:buNone/>
              <a:defRPr sz="2000" b="0" i="0" u="none" strike="noStrike" cap="none">
                <a:solidFill>
                  <a:schemeClr val="lt1"/>
                </a:solidFill>
                <a:latin typeface="Calibri"/>
                <a:ea typeface="Calibri"/>
                <a:cs typeface="Calibri"/>
                <a:sym typeface="Calibri"/>
              </a:defRPr>
            </a:lvl6pPr>
            <a:lvl7pPr marR="0" lvl="6" algn="l" rtl="0">
              <a:lnSpc>
                <a:spcPct val="90000"/>
              </a:lnSpc>
              <a:spcBef>
                <a:spcPts val="500"/>
              </a:spcBef>
              <a:spcAft>
                <a:spcPts val="0"/>
              </a:spcAft>
              <a:buClr>
                <a:schemeClr val="lt1"/>
              </a:buClr>
              <a:buSzPts val="2000"/>
              <a:buFont typeface="Arial"/>
              <a:buNone/>
              <a:defRPr sz="2000" b="0" i="0" u="none" strike="noStrike" cap="none">
                <a:solidFill>
                  <a:schemeClr val="lt1"/>
                </a:solidFill>
                <a:latin typeface="Calibri"/>
                <a:ea typeface="Calibri"/>
                <a:cs typeface="Calibri"/>
                <a:sym typeface="Calibri"/>
              </a:defRPr>
            </a:lvl7pPr>
            <a:lvl8pPr marR="0" lvl="7" algn="l" rtl="0">
              <a:lnSpc>
                <a:spcPct val="90000"/>
              </a:lnSpc>
              <a:spcBef>
                <a:spcPts val="500"/>
              </a:spcBef>
              <a:spcAft>
                <a:spcPts val="0"/>
              </a:spcAft>
              <a:buClr>
                <a:schemeClr val="lt1"/>
              </a:buClr>
              <a:buSzPts val="2000"/>
              <a:buFont typeface="Arial"/>
              <a:buNone/>
              <a:defRPr sz="2000" b="0" i="0" u="none" strike="noStrike" cap="none">
                <a:solidFill>
                  <a:schemeClr val="lt1"/>
                </a:solidFill>
                <a:latin typeface="Calibri"/>
                <a:ea typeface="Calibri"/>
                <a:cs typeface="Calibri"/>
                <a:sym typeface="Calibri"/>
              </a:defRPr>
            </a:lvl8pPr>
            <a:lvl9pPr marR="0" lvl="8" algn="l" rtl="0">
              <a:lnSpc>
                <a:spcPct val="90000"/>
              </a:lnSpc>
              <a:spcBef>
                <a:spcPts val="500"/>
              </a:spcBef>
              <a:spcAft>
                <a:spcPts val="0"/>
              </a:spcAft>
              <a:buClr>
                <a:schemeClr val="lt1"/>
              </a:buClr>
              <a:buSzPts val="2000"/>
              <a:buFont typeface="Arial"/>
              <a:buNone/>
              <a:defRPr sz="2000" b="0" i="0" u="none" strike="noStrike" cap="none">
                <a:solidFill>
                  <a:schemeClr val="lt1"/>
                </a:solidFill>
                <a:latin typeface="Calibri"/>
                <a:ea typeface="Calibri"/>
                <a:cs typeface="Calibri"/>
                <a:sym typeface="Calibri"/>
              </a:defRPr>
            </a:lvl9pPr>
          </a:lstStyle>
          <a:p>
            <a:endParaRPr/>
          </a:p>
        </p:txBody>
      </p:sp>
      <p:sp>
        <p:nvSpPr>
          <p:cNvPr id="68" name="Google Shape;68;p45"/>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lt1"/>
              </a:buClr>
              <a:buSzPts val="1600"/>
              <a:buNone/>
              <a:defRPr sz="1600"/>
            </a:lvl1pPr>
            <a:lvl2pPr marL="914400" lvl="1" indent="-228600" algn="l">
              <a:lnSpc>
                <a:spcPct val="90000"/>
              </a:lnSpc>
              <a:spcBef>
                <a:spcPts val="500"/>
              </a:spcBef>
              <a:spcAft>
                <a:spcPts val="0"/>
              </a:spcAft>
              <a:buClr>
                <a:schemeClr val="lt1"/>
              </a:buClr>
              <a:buSzPts val="1400"/>
              <a:buNone/>
              <a:defRPr sz="1400"/>
            </a:lvl2pPr>
            <a:lvl3pPr marL="1371600" lvl="2" indent="-228600" algn="l">
              <a:lnSpc>
                <a:spcPct val="90000"/>
              </a:lnSpc>
              <a:spcBef>
                <a:spcPts val="500"/>
              </a:spcBef>
              <a:spcAft>
                <a:spcPts val="0"/>
              </a:spcAft>
              <a:buClr>
                <a:schemeClr val="lt1"/>
              </a:buClr>
              <a:buSzPts val="1200"/>
              <a:buNone/>
              <a:defRPr sz="1200"/>
            </a:lvl3pPr>
            <a:lvl4pPr marL="1828800" lvl="3" indent="-228600" algn="l">
              <a:lnSpc>
                <a:spcPct val="90000"/>
              </a:lnSpc>
              <a:spcBef>
                <a:spcPts val="500"/>
              </a:spcBef>
              <a:spcAft>
                <a:spcPts val="0"/>
              </a:spcAft>
              <a:buClr>
                <a:schemeClr val="lt1"/>
              </a:buClr>
              <a:buSzPts val="1000"/>
              <a:buNone/>
              <a:defRPr sz="1000"/>
            </a:lvl4pPr>
            <a:lvl5pPr marL="2286000" lvl="4" indent="-228600" algn="l">
              <a:lnSpc>
                <a:spcPct val="90000"/>
              </a:lnSpc>
              <a:spcBef>
                <a:spcPts val="500"/>
              </a:spcBef>
              <a:spcAft>
                <a:spcPts val="0"/>
              </a:spcAft>
              <a:buClr>
                <a:schemeClr val="lt1"/>
              </a:buClr>
              <a:buSzPts val="1000"/>
              <a:buNone/>
              <a:defRPr sz="1000"/>
            </a:lvl5pPr>
            <a:lvl6pPr marL="2743200" lvl="5" indent="-228600" algn="l">
              <a:lnSpc>
                <a:spcPct val="90000"/>
              </a:lnSpc>
              <a:spcBef>
                <a:spcPts val="500"/>
              </a:spcBef>
              <a:spcAft>
                <a:spcPts val="0"/>
              </a:spcAft>
              <a:buClr>
                <a:schemeClr val="lt1"/>
              </a:buClr>
              <a:buSzPts val="1000"/>
              <a:buNone/>
              <a:defRPr sz="1000"/>
            </a:lvl6pPr>
            <a:lvl7pPr marL="3200400" lvl="6" indent="-228600" algn="l">
              <a:lnSpc>
                <a:spcPct val="90000"/>
              </a:lnSpc>
              <a:spcBef>
                <a:spcPts val="500"/>
              </a:spcBef>
              <a:spcAft>
                <a:spcPts val="0"/>
              </a:spcAft>
              <a:buClr>
                <a:schemeClr val="lt1"/>
              </a:buClr>
              <a:buSzPts val="1000"/>
              <a:buNone/>
              <a:defRPr sz="1000"/>
            </a:lvl7pPr>
            <a:lvl8pPr marL="3657600" lvl="7" indent="-228600" algn="l">
              <a:lnSpc>
                <a:spcPct val="90000"/>
              </a:lnSpc>
              <a:spcBef>
                <a:spcPts val="500"/>
              </a:spcBef>
              <a:spcAft>
                <a:spcPts val="0"/>
              </a:spcAft>
              <a:buClr>
                <a:schemeClr val="lt1"/>
              </a:buClr>
              <a:buSzPts val="1000"/>
              <a:buNone/>
              <a:defRPr sz="1000"/>
            </a:lvl8pPr>
            <a:lvl9pPr marL="4114800" lvl="8" indent="-228600" algn="l">
              <a:lnSpc>
                <a:spcPct val="90000"/>
              </a:lnSpc>
              <a:spcBef>
                <a:spcPts val="500"/>
              </a:spcBef>
              <a:spcAft>
                <a:spcPts val="0"/>
              </a:spcAft>
              <a:buClr>
                <a:schemeClr val="lt1"/>
              </a:buClr>
              <a:buSzPts val="1000"/>
              <a:buNone/>
              <a:defRPr sz="1000"/>
            </a:lvl9pPr>
          </a:lstStyle>
          <a:p>
            <a:endParaRPr/>
          </a:p>
        </p:txBody>
      </p:sp>
      <p:sp>
        <p:nvSpPr>
          <p:cNvPr id="69" name="Google Shape;69;p4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4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4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4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l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46"/>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lt1"/>
              </a:buClr>
              <a:buSzPts val="1800"/>
              <a:buChar char="•"/>
              <a:defRPr/>
            </a:lvl1pPr>
            <a:lvl2pPr marL="914400" lvl="1" indent="-342900" algn="l">
              <a:lnSpc>
                <a:spcPct val="90000"/>
              </a:lnSpc>
              <a:spcBef>
                <a:spcPts val="500"/>
              </a:spcBef>
              <a:spcAft>
                <a:spcPts val="0"/>
              </a:spcAft>
              <a:buClr>
                <a:schemeClr val="lt1"/>
              </a:buClr>
              <a:buSzPts val="1800"/>
              <a:buChar char="•"/>
              <a:defRPr/>
            </a:lvl2pPr>
            <a:lvl3pPr marL="1371600" lvl="2" indent="-342900" algn="l">
              <a:lnSpc>
                <a:spcPct val="90000"/>
              </a:lnSpc>
              <a:spcBef>
                <a:spcPts val="500"/>
              </a:spcBef>
              <a:spcAft>
                <a:spcPts val="0"/>
              </a:spcAft>
              <a:buClr>
                <a:schemeClr val="lt1"/>
              </a:buClr>
              <a:buSzPts val="1800"/>
              <a:buChar char="•"/>
              <a:defRPr/>
            </a:lvl3pPr>
            <a:lvl4pPr marL="1828800" lvl="3" indent="-342900" algn="l">
              <a:lnSpc>
                <a:spcPct val="90000"/>
              </a:lnSpc>
              <a:spcBef>
                <a:spcPts val="500"/>
              </a:spcBef>
              <a:spcAft>
                <a:spcPts val="0"/>
              </a:spcAft>
              <a:buClr>
                <a:schemeClr val="lt1"/>
              </a:buClr>
              <a:buSzPts val="1800"/>
              <a:buChar char="•"/>
              <a:defRPr/>
            </a:lvl4pPr>
            <a:lvl5pPr marL="2286000" lvl="4" indent="-342900" algn="l">
              <a:lnSpc>
                <a:spcPct val="90000"/>
              </a:lnSpc>
              <a:spcBef>
                <a:spcPts val="500"/>
              </a:spcBef>
              <a:spcAft>
                <a:spcPts val="0"/>
              </a:spcAft>
              <a:buClr>
                <a:schemeClr val="lt1"/>
              </a:buClr>
              <a:buSzPts val="1800"/>
              <a:buChar char="•"/>
              <a:defRPr/>
            </a:lvl5pPr>
            <a:lvl6pPr marL="2743200" lvl="5" indent="-342900" algn="l">
              <a:lnSpc>
                <a:spcPct val="90000"/>
              </a:lnSpc>
              <a:spcBef>
                <a:spcPts val="500"/>
              </a:spcBef>
              <a:spcAft>
                <a:spcPts val="0"/>
              </a:spcAft>
              <a:buClr>
                <a:schemeClr val="lt1"/>
              </a:buClr>
              <a:buSzPts val="1800"/>
              <a:buChar char="•"/>
              <a:defRPr/>
            </a:lvl6pPr>
            <a:lvl7pPr marL="3200400" lvl="6" indent="-342900" algn="l">
              <a:lnSpc>
                <a:spcPct val="90000"/>
              </a:lnSpc>
              <a:spcBef>
                <a:spcPts val="500"/>
              </a:spcBef>
              <a:spcAft>
                <a:spcPts val="0"/>
              </a:spcAft>
              <a:buClr>
                <a:schemeClr val="lt1"/>
              </a:buClr>
              <a:buSzPts val="1800"/>
              <a:buChar char="•"/>
              <a:defRPr/>
            </a:lvl7pPr>
            <a:lvl8pPr marL="3657600" lvl="7" indent="-342900" algn="l">
              <a:lnSpc>
                <a:spcPct val="90000"/>
              </a:lnSpc>
              <a:spcBef>
                <a:spcPts val="500"/>
              </a:spcBef>
              <a:spcAft>
                <a:spcPts val="0"/>
              </a:spcAft>
              <a:buClr>
                <a:schemeClr val="lt1"/>
              </a:buClr>
              <a:buSzPts val="1800"/>
              <a:buChar char="•"/>
              <a:defRPr/>
            </a:lvl8pPr>
            <a:lvl9pPr marL="4114800" lvl="8" indent="-342900" algn="l">
              <a:lnSpc>
                <a:spcPct val="90000"/>
              </a:lnSpc>
              <a:spcBef>
                <a:spcPts val="500"/>
              </a:spcBef>
              <a:spcAft>
                <a:spcPts val="0"/>
              </a:spcAft>
              <a:buClr>
                <a:schemeClr val="lt1"/>
              </a:buClr>
              <a:buSzPts val="1800"/>
              <a:buChar char="•"/>
              <a:defRPr/>
            </a:lvl9pPr>
          </a:lstStyle>
          <a:p>
            <a:endParaRPr/>
          </a:p>
        </p:txBody>
      </p:sp>
      <p:sp>
        <p:nvSpPr>
          <p:cNvPr id="75" name="Google Shape;75;p4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4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4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9"/>
        <p:cNvGrpSpPr/>
        <p:nvPr/>
      </p:nvGrpSpPr>
      <p:grpSpPr>
        <a:xfrm>
          <a:off x="0" y="0"/>
          <a:ext cx="0" cy="0"/>
          <a:chOff x="0" y="0"/>
          <a:chExt cx="0" cy="0"/>
        </a:xfrm>
      </p:grpSpPr>
      <p:sp>
        <p:nvSpPr>
          <p:cNvPr id="10" name="Google Shape;10;p3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lt1"/>
              </a:buClr>
              <a:buSzPts val="4400"/>
              <a:buFont typeface="Calibri"/>
              <a:buNone/>
              <a:defRPr sz="4400" b="0" i="0" u="none" strike="noStrike" cap="none">
                <a:solidFill>
                  <a:schemeClr val="lt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3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lt1"/>
              </a:buClr>
              <a:buSzPts val="2800"/>
              <a:buFont typeface="Arial"/>
              <a:buChar char="•"/>
              <a:defRPr sz="2800" b="0" i="0" u="none" strike="noStrike" cap="none">
                <a:solidFill>
                  <a:schemeClr val="lt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lt1"/>
              </a:buClr>
              <a:buSzPts val="2400"/>
              <a:buFont typeface="Arial"/>
              <a:buChar char="•"/>
              <a:defRPr sz="2400" b="0" i="0" u="none" strike="noStrike" cap="none">
                <a:solidFill>
                  <a:schemeClr val="lt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lt1"/>
              </a:buClr>
              <a:buSzPts val="2000"/>
              <a:buFont typeface="Arial"/>
              <a:buChar char="•"/>
              <a:defRPr sz="2000" b="0" i="0" u="none" strike="noStrike" cap="none">
                <a:solidFill>
                  <a:schemeClr val="lt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9pPr>
          </a:lstStyle>
          <a:p>
            <a:endParaRPr/>
          </a:p>
        </p:txBody>
      </p:sp>
      <p:sp>
        <p:nvSpPr>
          <p:cNvPr id="12" name="Google Shape;12;p3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13" name="Google Shape;13;p3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chemeClr val="lt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lt1"/>
                </a:solidFill>
                <a:latin typeface="Calibri"/>
                <a:ea typeface="Calibri"/>
                <a:cs typeface="Calibri"/>
                <a:sym typeface="Calibri"/>
              </a:defRPr>
            </a:lvl9pPr>
          </a:lstStyle>
          <a:p>
            <a:endParaRPr/>
          </a:p>
        </p:txBody>
      </p:sp>
      <p:sp>
        <p:nvSpPr>
          <p:cNvPr id="14" name="Google Shape;14;p3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chemeClr val="lt1"/>
                </a:solidFill>
                <a:latin typeface="Calibri"/>
                <a:ea typeface="Calibri"/>
                <a:cs typeface="Calibri"/>
                <a:sym typeface="Calibri"/>
              </a:defRPr>
            </a:lvl1pPr>
            <a:lvl2pPr marL="0" marR="0" lvl="1" indent="0" algn="r" rtl="0">
              <a:spcBef>
                <a:spcPts val="0"/>
              </a:spcBef>
              <a:buNone/>
              <a:defRPr sz="1200" b="0" i="0" u="none" strike="noStrike" cap="none">
                <a:solidFill>
                  <a:schemeClr val="lt1"/>
                </a:solidFill>
                <a:latin typeface="Calibri"/>
                <a:ea typeface="Calibri"/>
                <a:cs typeface="Calibri"/>
                <a:sym typeface="Calibri"/>
              </a:defRPr>
            </a:lvl2pPr>
            <a:lvl3pPr marL="0" marR="0" lvl="2" indent="0" algn="r" rtl="0">
              <a:spcBef>
                <a:spcPts val="0"/>
              </a:spcBef>
              <a:buNone/>
              <a:defRPr sz="1200" b="0" i="0" u="none" strike="noStrike" cap="none">
                <a:solidFill>
                  <a:schemeClr val="lt1"/>
                </a:solidFill>
                <a:latin typeface="Calibri"/>
                <a:ea typeface="Calibri"/>
                <a:cs typeface="Calibri"/>
                <a:sym typeface="Calibri"/>
              </a:defRPr>
            </a:lvl3pPr>
            <a:lvl4pPr marL="0" marR="0" lvl="3" indent="0" algn="r" rtl="0">
              <a:spcBef>
                <a:spcPts val="0"/>
              </a:spcBef>
              <a:buNone/>
              <a:defRPr sz="1200" b="0" i="0" u="none" strike="noStrike" cap="none">
                <a:solidFill>
                  <a:schemeClr val="lt1"/>
                </a:solidFill>
                <a:latin typeface="Calibri"/>
                <a:ea typeface="Calibri"/>
                <a:cs typeface="Calibri"/>
                <a:sym typeface="Calibri"/>
              </a:defRPr>
            </a:lvl4pPr>
            <a:lvl5pPr marL="0" marR="0" lvl="4" indent="0" algn="r" rtl="0">
              <a:spcBef>
                <a:spcPts val="0"/>
              </a:spcBef>
              <a:buNone/>
              <a:defRPr sz="1200" b="0" i="0" u="none" strike="noStrike" cap="none">
                <a:solidFill>
                  <a:schemeClr val="lt1"/>
                </a:solidFill>
                <a:latin typeface="Calibri"/>
                <a:ea typeface="Calibri"/>
                <a:cs typeface="Calibri"/>
                <a:sym typeface="Calibri"/>
              </a:defRPr>
            </a:lvl5pPr>
            <a:lvl6pPr marL="0" marR="0" lvl="5" indent="0" algn="r" rtl="0">
              <a:spcBef>
                <a:spcPts val="0"/>
              </a:spcBef>
              <a:buNone/>
              <a:defRPr sz="1200" b="0" i="0" u="none" strike="noStrike" cap="none">
                <a:solidFill>
                  <a:schemeClr val="lt1"/>
                </a:solidFill>
                <a:latin typeface="Calibri"/>
                <a:ea typeface="Calibri"/>
                <a:cs typeface="Calibri"/>
                <a:sym typeface="Calibri"/>
              </a:defRPr>
            </a:lvl6pPr>
            <a:lvl7pPr marL="0" marR="0" lvl="6" indent="0" algn="r" rtl="0">
              <a:spcBef>
                <a:spcPts val="0"/>
              </a:spcBef>
              <a:buNone/>
              <a:defRPr sz="1200" b="0" i="0" u="none" strike="noStrike" cap="none">
                <a:solidFill>
                  <a:schemeClr val="lt1"/>
                </a:solidFill>
                <a:latin typeface="Calibri"/>
                <a:ea typeface="Calibri"/>
                <a:cs typeface="Calibri"/>
                <a:sym typeface="Calibri"/>
              </a:defRPr>
            </a:lvl7pPr>
            <a:lvl8pPr marL="0" marR="0" lvl="7" indent="0" algn="r" rtl="0">
              <a:spcBef>
                <a:spcPts val="0"/>
              </a:spcBef>
              <a:buNone/>
              <a:defRPr sz="1200" b="0" i="0" u="none" strike="noStrike" cap="none">
                <a:solidFill>
                  <a:schemeClr val="lt1"/>
                </a:solidFill>
                <a:latin typeface="Calibri"/>
                <a:ea typeface="Calibri"/>
                <a:cs typeface="Calibri"/>
                <a:sym typeface="Calibri"/>
              </a:defRPr>
            </a:lvl8pPr>
            <a:lvl9pPr marL="0" marR="0" lvl="8" indent="0" algn="r" rtl="0">
              <a:spcBef>
                <a:spcPts val="0"/>
              </a:spcBef>
              <a:buNone/>
              <a:defRPr sz="1200" b="0" i="0" u="none" strike="noStrike" cap="none">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1.xml.rels><?xml version="1.0" encoding="UTF-8" standalone="yes"?>
<Relationships xmlns="http://schemas.openxmlformats.org/package/2006/relationships"><Relationship Id="rId8" Type="http://schemas.openxmlformats.org/officeDocument/2006/relationships/diagramData" Target="../diagrams/data3.xml"/><Relationship Id="rId3" Type="http://schemas.openxmlformats.org/officeDocument/2006/relationships/diagramData" Target="../diagrams/data2.xml"/><Relationship Id="rId7" Type="http://schemas.microsoft.com/office/2007/relationships/diagramDrawing" Target="../diagrams/drawing2.xml"/><Relationship Id="rId12" Type="http://schemas.microsoft.com/office/2007/relationships/diagramDrawing" Target="../diagrams/drawing3.xm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diagramColors" Target="../diagrams/colors2.xml"/><Relationship Id="rId11" Type="http://schemas.openxmlformats.org/officeDocument/2006/relationships/diagramColors" Target="../diagrams/colors3.xml"/><Relationship Id="rId5" Type="http://schemas.openxmlformats.org/officeDocument/2006/relationships/diagramQuickStyle" Target="../diagrams/quickStyle2.xml"/><Relationship Id="rId10" Type="http://schemas.openxmlformats.org/officeDocument/2006/relationships/diagramQuickStyle" Target="../diagrams/quickStyle3.xml"/><Relationship Id="rId4" Type="http://schemas.openxmlformats.org/officeDocument/2006/relationships/diagramLayout" Target="../diagrams/layout2.xml"/><Relationship Id="rId9" Type="http://schemas.openxmlformats.org/officeDocument/2006/relationships/diagramLayout" Target="../diagrams/layout3.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17.xml.rels><?xml version="1.0" encoding="UTF-8" standalone="yes"?>
<Relationships xmlns="http://schemas.openxmlformats.org/package/2006/relationships"><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18.xml.rels><?xml version="1.0" encoding="UTF-8" standalone="yes"?>
<Relationships xmlns="http://schemas.openxmlformats.org/package/2006/relationships"><Relationship Id="rId3" Type="http://schemas.openxmlformats.org/officeDocument/2006/relationships/diagramData" Target="../diagrams/data10.xml"/><Relationship Id="rId7" Type="http://schemas.microsoft.com/office/2007/relationships/diagramDrawing" Target="../diagrams/drawing10.xml"/><Relationship Id="rId2" Type="http://schemas.openxmlformats.org/officeDocument/2006/relationships/notesSlide" Target="../notesSlides/notesSlide18.xml"/><Relationship Id="rId1" Type="http://schemas.openxmlformats.org/officeDocument/2006/relationships/slideLayout" Target="../slideLayouts/slideLayout2.xml"/><Relationship Id="rId6" Type="http://schemas.openxmlformats.org/officeDocument/2006/relationships/diagramColors" Target="../diagrams/colors10.xml"/><Relationship Id="rId5" Type="http://schemas.openxmlformats.org/officeDocument/2006/relationships/diagramQuickStyle" Target="../diagrams/quickStyle10.xml"/><Relationship Id="rId4" Type="http://schemas.openxmlformats.org/officeDocument/2006/relationships/diagramLayout" Target="../diagrams/layout10.xml"/></Relationships>
</file>

<file path=ppt/slides/_rels/slide19.xml.rels><?xml version="1.0" encoding="UTF-8" standalone="yes"?>
<Relationships xmlns="http://schemas.openxmlformats.org/package/2006/relationships"><Relationship Id="rId3" Type="http://schemas.openxmlformats.org/officeDocument/2006/relationships/diagramData" Target="../diagrams/data11.xml"/><Relationship Id="rId7" Type="http://schemas.microsoft.com/office/2007/relationships/diagramDrawing" Target="../diagrams/drawing11.xml"/><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diagramColors" Target="../diagrams/colors11.xml"/><Relationship Id="rId5" Type="http://schemas.openxmlformats.org/officeDocument/2006/relationships/diagramQuickStyle" Target="../diagrams/quickStyle11.xml"/><Relationship Id="rId4" Type="http://schemas.openxmlformats.org/officeDocument/2006/relationships/diagramLayout" Target="../diagrams/layout11.xm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20.xml.rels><?xml version="1.0" encoding="UTF-8" standalone="yes"?>
<Relationships xmlns="http://schemas.openxmlformats.org/package/2006/relationships"><Relationship Id="rId3" Type="http://schemas.openxmlformats.org/officeDocument/2006/relationships/diagramData" Target="../diagrams/data12.xml"/><Relationship Id="rId7" Type="http://schemas.microsoft.com/office/2007/relationships/diagramDrawing" Target="../diagrams/drawing12.xml"/><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diagramColors" Target="../diagrams/colors12.xml"/><Relationship Id="rId5" Type="http://schemas.openxmlformats.org/officeDocument/2006/relationships/diagramQuickStyle" Target="../diagrams/quickStyle12.xml"/><Relationship Id="rId4" Type="http://schemas.openxmlformats.org/officeDocument/2006/relationships/diagramLayout" Target="../diagrams/layout12.xml"/></Relationships>
</file>

<file path=ppt/slides/_rels/slide21.xml.rels><?xml version="1.0" encoding="UTF-8" standalone="yes"?>
<Relationships xmlns="http://schemas.openxmlformats.org/package/2006/relationships"><Relationship Id="rId3" Type="http://schemas.openxmlformats.org/officeDocument/2006/relationships/notesSlide" Target="../notesSlides/notesSlide21.xml"/><Relationship Id="rId2" Type="http://schemas.openxmlformats.org/officeDocument/2006/relationships/slideLayout" Target="../slideLayouts/slideLayout2.xml"/><Relationship Id="rId1" Type="http://schemas.openxmlformats.org/officeDocument/2006/relationships/tags" Target="../tags/tag8.xml"/></Relationships>
</file>

<file path=ppt/slides/_rels/slide22.xml.rels><?xml version="1.0" encoding="UTF-8" standalone="yes"?>
<Relationships xmlns="http://schemas.openxmlformats.org/package/2006/relationships"><Relationship Id="rId3" Type="http://schemas.openxmlformats.org/officeDocument/2006/relationships/notesSlide" Target="../notesSlides/notesSlide22.xml"/><Relationship Id="rId2" Type="http://schemas.openxmlformats.org/officeDocument/2006/relationships/slideLayout" Target="../slideLayouts/slideLayout2.xml"/><Relationship Id="rId1" Type="http://schemas.openxmlformats.org/officeDocument/2006/relationships/tags" Target="../tags/tag9.xml"/><Relationship Id="rId4" Type="http://schemas.openxmlformats.org/officeDocument/2006/relationships/image" Target="../media/image3.png"/></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3" Type="http://schemas.openxmlformats.org/officeDocument/2006/relationships/notesSlide" Target="../notesSlides/notesSlide24.xml"/><Relationship Id="rId2" Type="http://schemas.openxmlformats.org/officeDocument/2006/relationships/slideLayout" Target="../slideLayouts/slideLayout2.xml"/><Relationship Id="rId1" Type="http://schemas.openxmlformats.org/officeDocument/2006/relationships/tags" Target="../tags/tag10.xml"/></Relationships>
</file>

<file path=ppt/slides/_rels/slide25.xml.rels><?xml version="1.0" encoding="UTF-8" standalone="yes"?>
<Relationships xmlns="http://schemas.openxmlformats.org/package/2006/relationships"><Relationship Id="rId3" Type="http://schemas.openxmlformats.org/officeDocument/2006/relationships/notesSlide" Target="../notesSlides/notesSlide25.xml"/><Relationship Id="rId2" Type="http://schemas.openxmlformats.org/officeDocument/2006/relationships/slideLayout" Target="../slideLayouts/slideLayout2.xml"/><Relationship Id="rId1" Type="http://schemas.openxmlformats.org/officeDocument/2006/relationships/tags" Target="../tags/tag11.xml"/></Relationships>
</file>

<file path=ppt/slides/_rels/slide26.xml.rels><?xml version="1.0" encoding="UTF-8" standalone="yes"?>
<Relationships xmlns="http://schemas.openxmlformats.org/package/2006/relationships"><Relationship Id="rId3" Type="http://schemas.openxmlformats.org/officeDocument/2006/relationships/notesSlide" Target="../notesSlides/notesSlide26.xml"/><Relationship Id="rId2" Type="http://schemas.openxmlformats.org/officeDocument/2006/relationships/slideLayout" Target="../slideLayouts/slideLayout2.xml"/><Relationship Id="rId1" Type="http://schemas.openxmlformats.org/officeDocument/2006/relationships/tags" Target="../tags/tag1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notesSlide" Target="../notesSlides/notesSlide29.xml"/><Relationship Id="rId2" Type="http://schemas.openxmlformats.org/officeDocument/2006/relationships/slideLayout" Target="../slideLayouts/slideLayout2.xml"/><Relationship Id="rId1" Type="http://schemas.openxmlformats.org/officeDocument/2006/relationships/tags" Target="../tags/tag13.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30.xml.rels><?xml version="1.0" encoding="UTF-8" standalone="yes"?>
<Relationships xmlns="http://schemas.openxmlformats.org/package/2006/relationships"><Relationship Id="rId3" Type="http://schemas.openxmlformats.org/officeDocument/2006/relationships/notesSlide" Target="../notesSlides/notesSlide30.xml"/><Relationship Id="rId2" Type="http://schemas.openxmlformats.org/officeDocument/2006/relationships/slideLayout" Target="../slideLayouts/slideLayout2.xml"/><Relationship Id="rId1" Type="http://schemas.openxmlformats.org/officeDocument/2006/relationships/tags" Target="../tags/tag14.xml"/></Relationships>
</file>

<file path=ppt/slides/_rels/slide31.xml.rels><?xml version="1.0" encoding="UTF-8" standalone="yes"?>
<Relationships xmlns="http://schemas.openxmlformats.org/package/2006/relationships"><Relationship Id="rId3" Type="http://schemas.openxmlformats.org/officeDocument/2006/relationships/notesSlide" Target="../notesSlides/notesSlide31.xml"/><Relationship Id="rId2" Type="http://schemas.openxmlformats.org/officeDocument/2006/relationships/slideLayout" Target="../slideLayouts/slideLayout2.xml"/><Relationship Id="rId1" Type="http://schemas.openxmlformats.org/officeDocument/2006/relationships/tags" Target="../tags/tag15.xml"/></Relationships>
</file>

<file path=ppt/slides/_rels/slide32.xml.rels><?xml version="1.0" encoding="UTF-8" standalone="yes"?>
<Relationships xmlns="http://schemas.openxmlformats.org/package/2006/relationships"><Relationship Id="rId3" Type="http://schemas.openxmlformats.org/officeDocument/2006/relationships/notesSlide" Target="../notesSlides/notesSlide32.xml"/><Relationship Id="rId2" Type="http://schemas.openxmlformats.org/officeDocument/2006/relationships/slideLayout" Target="../slideLayouts/slideLayout2.xml"/><Relationship Id="rId1" Type="http://schemas.openxmlformats.org/officeDocument/2006/relationships/tags" Target="../tags/tag16.xml"/></Relationships>
</file>

<file path=ppt/slides/_rels/slide33.xml.rels><?xml version="1.0" encoding="UTF-8" standalone="yes"?>
<Relationships xmlns="http://schemas.openxmlformats.org/package/2006/relationships"><Relationship Id="rId3" Type="http://schemas.openxmlformats.org/officeDocument/2006/relationships/notesSlide" Target="../notesSlides/notesSlide33.xml"/><Relationship Id="rId2" Type="http://schemas.openxmlformats.org/officeDocument/2006/relationships/slideLayout" Target="../slideLayouts/slideLayout2.xml"/><Relationship Id="rId1" Type="http://schemas.openxmlformats.org/officeDocument/2006/relationships/tags" Target="../tags/tag17.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notesSlide" Target="../notesSlides/notesSlide35.xml"/><Relationship Id="rId2" Type="http://schemas.openxmlformats.org/officeDocument/2006/relationships/slideLayout" Target="../slideLayouts/slideLayout1.xml"/><Relationship Id="rId1" Type="http://schemas.openxmlformats.org/officeDocument/2006/relationships/tags" Target="../tags/tag18.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2.xml"/><Relationship Id="rId1" Type="http://schemas.openxmlformats.org/officeDocument/2006/relationships/tags" Target="../tags/tag4.xml"/></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2.xml"/><Relationship Id="rId1" Type="http://schemas.openxmlformats.org/officeDocument/2006/relationships/tags" Target="../tags/tag5.xml"/></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xml"/><Relationship Id="rId1" Type="http://schemas.openxmlformats.org/officeDocument/2006/relationships/tags" Target="../tags/tag6.xml"/><Relationship Id="rId4" Type="http://schemas.openxmlformats.org/officeDocument/2006/relationships/image" Target="../media/image1.png"/></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9.xml"/><Relationship Id="rId2" Type="http://schemas.openxmlformats.org/officeDocument/2006/relationships/slideLayout" Target="../slideLayouts/slideLayout3.xml"/><Relationship Id="rId1" Type="http://schemas.openxmlformats.org/officeDocument/2006/relationships/tags" Target="../tags/tag7.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93"/>
        <p:cNvGrpSpPr/>
        <p:nvPr/>
      </p:nvGrpSpPr>
      <p:grpSpPr>
        <a:xfrm>
          <a:off x="0" y="0"/>
          <a:ext cx="0" cy="0"/>
          <a:chOff x="0" y="0"/>
          <a:chExt cx="0" cy="0"/>
        </a:xfrm>
      </p:grpSpPr>
      <p:sp>
        <p:nvSpPr>
          <p:cNvPr id="95" name="Google Shape;95;p1"/>
          <p:cNvSpPr txBox="1"/>
          <p:nvPr/>
        </p:nvSpPr>
        <p:spPr>
          <a:xfrm>
            <a:off x="2241505" y="1843447"/>
            <a:ext cx="7708690" cy="2031000"/>
          </a:xfrm>
          <a:prstGeom prst="rect">
            <a:avLst/>
          </a:prstGeom>
          <a:noFill/>
          <a:ln>
            <a:noFill/>
          </a:ln>
        </p:spPr>
        <p:txBody>
          <a:bodyPr spcFirstLastPara="1" wrap="square" lIns="91425" tIns="45700" rIns="91425" bIns="45700" anchor="b" anchorCtr="0">
            <a:normAutofit fontScale="92500"/>
          </a:bodyPr>
          <a:lstStyle/>
          <a:p>
            <a:pPr marL="0" marR="0" lvl="0" indent="0" algn="ctr" rtl="0">
              <a:lnSpc>
                <a:spcPct val="90000"/>
              </a:lnSpc>
              <a:spcBef>
                <a:spcPts val="0"/>
              </a:spcBef>
              <a:spcAft>
                <a:spcPts val="0"/>
              </a:spcAft>
              <a:buClr>
                <a:schemeClr val="lt2"/>
              </a:buClr>
              <a:buSzPts val="5200"/>
              <a:buFont typeface="Calibri"/>
              <a:buNone/>
            </a:pPr>
            <a:r>
              <a:rPr lang="en-US" sz="6500" b="0" i="0" u="none" strike="noStrike" cap="none" dirty="0">
                <a:solidFill>
                  <a:schemeClr val="lt2"/>
                </a:solidFill>
                <a:latin typeface="Calibri"/>
                <a:ea typeface="Calibri"/>
                <a:cs typeface="Calibri"/>
                <a:sym typeface="Calibri"/>
              </a:rPr>
              <a:t>Addressing Patient Bias</a:t>
            </a:r>
            <a:br>
              <a:rPr lang="en-US" sz="5200" b="0" i="0" u="none" strike="noStrike" cap="none" dirty="0">
                <a:solidFill>
                  <a:schemeClr val="lt2"/>
                </a:solidFill>
                <a:latin typeface="Calibri"/>
                <a:ea typeface="Calibri"/>
                <a:cs typeface="Calibri"/>
                <a:sym typeface="Calibri"/>
              </a:rPr>
            </a:br>
            <a:r>
              <a:rPr lang="en-US" sz="3100" b="0" i="0" u="none" strike="noStrike" cap="none" dirty="0">
                <a:solidFill>
                  <a:schemeClr val="lt2"/>
                </a:solidFill>
                <a:latin typeface="Calibri"/>
                <a:ea typeface="Calibri"/>
                <a:cs typeface="Calibri"/>
                <a:sym typeface="Calibri"/>
              </a:rPr>
              <a:t>A Toolkit for Bias Response</a:t>
            </a:r>
            <a:endParaRPr sz="5200" b="0" i="0" u="none" strike="noStrike" cap="none" dirty="0">
              <a:solidFill>
                <a:schemeClr val="lt2"/>
              </a:solidFill>
              <a:latin typeface="Calibri"/>
              <a:ea typeface="Calibri"/>
              <a:cs typeface="Calibri"/>
              <a:sym typeface="Calibri"/>
            </a:endParaRPr>
          </a:p>
        </p:txBody>
      </p:sp>
      <p:sp>
        <p:nvSpPr>
          <p:cNvPr id="96" name="Google Shape;96;p1"/>
          <p:cNvSpPr txBox="1"/>
          <p:nvPr/>
        </p:nvSpPr>
        <p:spPr>
          <a:xfrm>
            <a:off x="2902801" y="4333624"/>
            <a:ext cx="6105300" cy="1252200"/>
          </a:xfrm>
          <a:prstGeom prst="rect">
            <a:avLst/>
          </a:prstGeom>
          <a:noFill/>
          <a:ln>
            <a:noFill/>
          </a:ln>
        </p:spPr>
        <p:txBody>
          <a:bodyPr spcFirstLastPara="1" wrap="square" lIns="91425" tIns="45700" rIns="91425" bIns="45700" anchor="t" anchorCtr="0">
            <a:noAutofit/>
          </a:bodyPr>
          <a:lstStyle/>
          <a:p>
            <a:pPr marL="0" marR="0" lvl="0" indent="0" algn="ctr" rtl="0">
              <a:lnSpc>
                <a:spcPct val="70000"/>
              </a:lnSpc>
              <a:spcBef>
                <a:spcPts val="1000"/>
              </a:spcBef>
              <a:spcAft>
                <a:spcPts val="0"/>
              </a:spcAft>
              <a:buClr>
                <a:schemeClr val="lt2"/>
              </a:buClr>
              <a:buSzPts val="1140"/>
              <a:buFont typeface="Arial"/>
              <a:buNone/>
            </a:pPr>
            <a:r>
              <a:rPr lang="en-US" sz="1850" b="0" i="0" u="none" strike="noStrike" cap="none" dirty="0">
                <a:solidFill>
                  <a:schemeClr val="lt2"/>
                </a:solidFill>
                <a:latin typeface="Calibri" panose="020F0502020204030204" pitchFamily="34" charset="0"/>
                <a:ea typeface="Calibri"/>
                <a:cs typeface="Calibri" panose="020F0502020204030204" pitchFamily="34" charset="0"/>
                <a:sym typeface="Calibri"/>
              </a:rPr>
              <a:t>Enter Presenter Name and Title Here</a:t>
            </a:r>
          </a:p>
          <a:p>
            <a:pPr marL="0" marR="0" lvl="0" indent="0" algn="ctr" rtl="0">
              <a:lnSpc>
                <a:spcPct val="70000"/>
              </a:lnSpc>
              <a:spcBef>
                <a:spcPts val="1000"/>
              </a:spcBef>
              <a:spcAft>
                <a:spcPts val="0"/>
              </a:spcAft>
              <a:buClr>
                <a:schemeClr val="lt2"/>
              </a:buClr>
              <a:buSzPts val="1140"/>
              <a:buFont typeface="Arial"/>
              <a:buNone/>
            </a:pPr>
            <a:r>
              <a:rPr lang="en-US" sz="1850" dirty="0">
                <a:solidFill>
                  <a:schemeClr val="lt2"/>
                </a:solidFill>
                <a:latin typeface="Calibri" panose="020F0502020204030204" pitchFamily="34" charset="0"/>
                <a:ea typeface="Calibri"/>
                <a:cs typeface="Calibri" panose="020F0502020204030204" pitchFamily="34" charset="0"/>
                <a:sym typeface="Calibri"/>
              </a:rPr>
              <a:t>Enter Date Here</a:t>
            </a:r>
            <a:endParaRPr sz="1850" dirty="0">
              <a:latin typeface="Calibri" panose="020F0502020204030204" pitchFamily="34" charset="0"/>
              <a:cs typeface="Calibri" panose="020F0502020204030204" pitchFamily="34" charset="0"/>
            </a:endParaRPr>
          </a:p>
        </p:txBody>
      </p:sp>
      <p:sp>
        <p:nvSpPr>
          <p:cNvPr id="3" name="Rectangle 2">
            <a:extLst>
              <a:ext uri="{FF2B5EF4-FFF2-40B4-BE49-F238E27FC236}">
                <a16:creationId xmlns:a16="http://schemas.microsoft.com/office/drawing/2014/main" id="{73A24173-AFD7-9981-DA88-4FAFEA907592}"/>
              </a:ext>
            </a:extLst>
          </p:cNvPr>
          <p:cNvSpPr/>
          <p:nvPr/>
        </p:nvSpPr>
        <p:spPr>
          <a:xfrm>
            <a:off x="9817768" y="208344"/>
            <a:ext cx="2133608" cy="2406519"/>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latin typeface="Calibri" panose="020F0502020204030204" pitchFamily="34" charset="0"/>
                <a:cs typeface="Calibri" panose="020F0502020204030204" pitchFamily="34" charset="0"/>
              </a:rPr>
              <a:t>QR Code for Polling Software Included Here</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sp>
        <p:nvSpPr>
          <p:cNvPr id="6" name="Google Shape;147;gc473988d5b_0_9">
            <a:extLst>
              <a:ext uri="{FF2B5EF4-FFF2-40B4-BE49-F238E27FC236}">
                <a16:creationId xmlns:a16="http://schemas.microsoft.com/office/drawing/2014/main" id="{1B2F972C-A741-414B-A9BE-AC3A1C6D624A}"/>
              </a:ext>
            </a:extLst>
          </p:cNvPr>
          <p:cNvSpPr txBox="1">
            <a:spLocks noGrp="1"/>
          </p:cNvSpPr>
          <p:nvPr>
            <p:ph type="title"/>
          </p:nvPr>
        </p:nvSpPr>
        <p:spPr>
          <a:prstGeom prst="rect">
            <a:avLst/>
          </a:prstGeom>
        </p:spPr>
        <p:txBody>
          <a:bodyPr spcFirstLastPara="1" vert="horz" wrap="square" lIns="91425" tIns="45700" rIns="91425" bIns="45700" rtlCol="0" anchor="ctr" anchorCtr="0">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spcBef>
                <a:spcPts val="0"/>
              </a:spcBef>
            </a:pPr>
            <a:r>
              <a:rPr lang="en-US" dirty="0">
                <a:solidFill>
                  <a:schemeClr val="bg1"/>
                </a:solidFill>
                <a:latin typeface="Calibri" panose="020F0502020204030204" pitchFamily="34" charset="0"/>
                <a:cs typeface="Calibri" panose="020F0502020204030204" pitchFamily="34" charset="0"/>
              </a:rPr>
              <a:t>Bias response</a:t>
            </a:r>
          </a:p>
        </p:txBody>
      </p:sp>
      <p:sp>
        <p:nvSpPr>
          <p:cNvPr id="168" name="Google Shape;168;gc473988d5b_0_81"/>
          <p:cNvSpPr txBox="1">
            <a:spLocks noGrp="1"/>
          </p:cNvSpPr>
          <p:nvPr>
            <p:ph type="body" idx="1"/>
          </p:nvPr>
        </p:nvSpPr>
        <p:spPr>
          <a:xfrm>
            <a:off x="838200" y="1584875"/>
            <a:ext cx="10515600" cy="4591800"/>
          </a:xfrm>
          <a:prstGeom prst="rect">
            <a:avLst/>
          </a:prstGeom>
          <a:noFill/>
          <a:ln>
            <a:noFill/>
          </a:ln>
        </p:spPr>
        <p:txBody>
          <a:bodyPr spcFirstLastPara="1" wrap="square" lIns="91425" tIns="45700" rIns="91425" bIns="45700" anchor="t" anchorCtr="0">
            <a:normAutofit/>
          </a:bodyPr>
          <a:lstStyle/>
          <a:p>
            <a:pPr marL="514350" lvl="0" indent="-514350" algn="l" rtl="0">
              <a:lnSpc>
                <a:spcPct val="90000"/>
              </a:lnSpc>
              <a:spcBef>
                <a:spcPts val="0"/>
              </a:spcBef>
              <a:spcAft>
                <a:spcPts val="0"/>
              </a:spcAft>
              <a:buClr>
                <a:schemeClr val="lt1"/>
              </a:buClr>
              <a:buSzPts val="2800"/>
              <a:buFont typeface="Calibri"/>
              <a:buAutoNum type="arabicPeriod"/>
            </a:pPr>
            <a:r>
              <a:rPr lang="en-US" dirty="0"/>
              <a:t>Ensure stability, assess if altered</a:t>
            </a:r>
            <a:endParaRPr dirty="0"/>
          </a:p>
          <a:p>
            <a:pPr marL="514350" lvl="0" indent="-514350" algn="l" rtl="0">
              <a:lnSpc>
                <a:spcPct val="90000"/>
              </a:lnSpc>
              <a:spcBef>
                <a:spcPts val="1000"/>
              </a:spcBef>
              <a:spcAft>
                <a:spcPts val="0"/>
              </a:spcAft>
              <a:buClr>
                <a:schemeClr val="lt1"/>
              </a:buClr>
              <a:buSzPts val="2800"/>
              <a:buFont typeface="Calibri"/>
              <a:buAutoNum type="arabicPeriod"/>
            </a:pPr>
            <a:r>
              <a:rPr lang="en-US" dirty="0"/>
              <a:t>Check your emotions</a:t>
            </a:r>
            <a:endParaRPr dirty="0"/>
          </a:p>
          <a:p>
            <a:pPr marL="514350" lvl="0" indent="-514350" algn="l" rtl="0">
              <a:lnSpc>
                <a:spcPct val="90000"/>
              </a:lnSpc>
              <a:spcBef>
                <a:spcPts val="1000"/>
              </a:spcBef>
              <a:spcAft>
                <a:spcPts val="0"/>
              </a:spcAft>
              <a:buClr>
                <a:schemeClr val="lt1"/>
              </a:buClr>
              <a:buSzPts val="2800"/>
              <a:buFont typeface="Calibri"/>
              <a:buAutoNum type="arabicPeriod"/>
            </a:pPr>
            <a:r>
              <a:rPr lang="en-US" dirty="0"/>
              <a:t>Address the bias/microaggression explicitly</a:t>
            </a:r>
            <a:endParaRPr dirty="0"/>
          </a:p>
          <a:p>
            <a:pPr marL="514350" lvl="0" indent="-514350" algn="l" rtl="0">
              <a:lnSpc>
                <a:spcPct val="90000"/>
              </a:lnSpc>
              <a:spcBef>
                <a:spcPts val="1000"/>
              </a:spcBef>
              <a:spcAft>
                <a:spcPts val="0"/>
              </a:spcAft>
              <a:buClr>
                <a:schemeClr val="lt1"/>
              </a:buClr>
              <a:buSzPts val="2800"/>
              <a:buFont typeface="Calibri"/>
              <a:buAutoNum type="arabicPeriod"/>
            </a:pPr>
            <a:r>
              <a:rPr lang="en-US" dirty="0"/>
              <a:t>Align with your team</a:t>
            </a:r>
          </a:p>
          <a:p>
            <a:pPr marL="514350" indent="-514350">
              <a:buClr>
                <a:schemeClr val="lt1"/>
              </a:buClr>
              <a:buSzPts val="2800"/>
              <a:buFont typeface="Calibri"/>
              <a:buAutoNum type="arabicPeriod"/>
            </a:pPr>
            <a:r>
              <a:rPr lang="en-US" dirty="0"/>
              <a:t>Set boundaries</a:t>
            </a:r>
          </a:p>
          <a:p>
            <a:pPr marL="514350" indent="-514350">
              <a:buClr>
                <a:schemeClr val="lt1"/>
              </a:buClr>
              <a:buSzPts val="2800"/>
              <a:buFont typeface="Calibri"/>
              <a:buAutoNum type="arabicPeriod"/>
            </a:pPr>
            <a:r>
              <a:rPr lang="en-US" dirty="0"/>
              <a:t>Recenter on patient care</a:t>
            </a:r>
            <a:endParaRPr dirty="0"/>
          </a:p>
          <a:p>
            <a:pPr marL="514350" lvl="0" indent="-514350" algn="l" rtl="0">
              <a:lnSpc>
                <a:spcPct val="90000"/>
              </a:lnSpc>
              <a:spcBef>
                <a:spcPts val="1000"/>
              </a:spcBef>
              <a:spcAft>
                <a:spcPts val="0"/>
              </a:spcAft>
              <a:buClr>
                <a:schemeClr val="lt1"/>
              </a:buClr>
              <a:buSzPts val="2800"/>
              <a:buFont typeface="Calibri"/>
              <a:buAutoNum type="arabicPeriod"/>
            </a:pPr>
            <a:r>
              <a:rPr lang="en-US" dirty="0"/>
              <a:t>Give space</a:t>
            </a:r>
            <a:endParaRPr dirty="0"/>
          </a:p>
          <a:p>
            <a:pPr marL="514350" lvl="0" indent="-514350" algn="l" rtl="0">
              <a:lnSpc>
                <a:spcPct val="90000"/>
              </a:lnSpc>
              <a:spcBef>
                <a:spcPts val="1000"/>
              </a:spcBef>
              <a:spcAft>
                <a:spcPts val="0"/>
              </a:spcAft>
              <a:buClr>
                <a:schemeClr val="lt1"/>
              </a:buClr>
              <a:buSzPts val="2800"/>
              <a:buFont typeface="Calibri"/>
              <a:buAutoNum type="arabicPeriod"/>
            </a:pPr>
            <a:r>
              <a:rPr lang="en-US" dirty="0"/>
              <a:t>Attend to emotion, seek support</a:t>
            </a:r>
            <a:endParaRPr dirty="0"/>
          </a:p>
        </p:txBody>
      </p:sp>
      <p:graphicFrame>
        <p:nvGraphicFramePr>
          <p:cNvPr id="4" name="Diagram 3">
            <a:extLst>
              <a:ext uri="{FF2B5EF4-FFF2-40B4-BE49-F238E27FC236}">
                <a16:creationId xmlns:a16="http://schemas.microsoft.com/office/drawing/2014/main" id="{095675FB-48A9-4F4B-85A3-7E9EC37C0E16}"/>
              </a:ext>
            </a:extLst>
          </p:cNvPr>
          <p:cNvGraphicFramePr/>
          <p:nvPr/>
        </p:nvGraphicFramePr>
        <p:xfrm>
          <a:off x="9961418" y="-1"/>
          <a:ext cx="2304470" cy="475211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89969413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6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68">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68">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68">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68">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68">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168">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168">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4" grpId="0">
        <p:bldAsOne/>
      </p:bldGraphic>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sp>
        <p:nvSpPr>
          <p:cNvPr id="6" name="Google Shape;147;gc473988d5b_0_9">
            <a:extLst>
              <a:ext uri="{FF2B5EF4-FFF2-40B4-BE49-F238E27FC236}">
                <a16:creationId xmlns:a16="http://schemas.microsoft.com/office/drawing/2014/main" id="{1B2F972C-A741-414B-A9BE-AC3A1C6D624A}"/>
              </a:ext>
            </a:extLst>
          </p:cNvPr>
          <p:cNvSpPr txBox="1">
            <a:spLocks noGrp="1"/>
          </p:cNvSpPr>
          <p:nvPr>
            <p:ph type="title"/>
          </p:nvPr>
        </p:nvSpPr>
        <p:spPr>
          <a:xfrm>
            <a:off x="838200" y="365125"/>
            <a:ext cx="9123218" cy="1325563"/>
          </a:xfrm>
          <a:prstGeom prst="rect">
            <a:avLst/>
          </a:prstGeom>
        </p:spPr>
        <p:txBody>
          <a:bodyPr spcFirstLastPara="1" vert="horz" wrap="square" lIns="91425" tIns="45700" rIns="91425" bIns="45700" rtlCol="0" anchor="ctr" anchorCtr="0">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spcBef>
                <a:spcPts val="0"/>
              </a:spcBef>
            </a:pPr>
            <a:r>
              <a:rPr lang="en-US" dirty="0">
                <a:solidFill>
                  <a:schemeClr val="bg1"/>
                </a:solidFill>
                <a:latin typeface="Calibri" panose="020F0502020204030204" pitchFamily="34" charset="0"/>
                <a:cs typeface="Calibri" panose="020F0502020204030204" pitchFamily="34" charset="0"/>
              </a:rPr>
              <a:t>Ensure stability &amp; assess if altered</a:t>
            </a:r>
          </a:p>
        </p:txBody>
      </p:sp>
      <p:graphicFrame>
        <p:nvGraphicFramePr>
          <p:cNvPr id="5" name="Diagram 4">
            <a:extLst>
              <a:ext uri="{FF2B5EF4-FFF2-40B4-BE49-F238E27FC236}">
                <a16:creationId xmlns:a16="http://schemas.microsoft.com/office/drawing/2014/main" id="{DEB56DDD-C74F-4543-ACF8-F8330B010CF1}"/>
              </a:ext>
            </a:extLst>
          </p:cNvPr>
          <p:cNvGraphicFramePr/>
          <p:nvPr/>
        </p:nvGraphicFramePr>
        <p:xfrm>
          <a:off x="9961418" y="-1"/>
          <a:ext cx="2304470" cy="475211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Rectangle 2">
            <a:extLst>
              <a:ext uri="{FF2B5EF4-FFF2-40B4-BE49-F238E27FC236}">
                <a16:creationId xmlns:a16="http://schemas.microsoft.com/office/drawing/2014/main" id="{86AD0E9E-B66C-B64F-93CC-C40BFDC299E0}"/>
              </a:ext>
            </a:extLst>
          </p:cNvPr>
          <p:cNvSpPr/>
          <p:nvPr/>
        </p:nvSpPr>
        <p:spPr>
          <a:xfrm>
            <a:off x="9781309" y="583552"/>
            <a:ext cx="2410691" cy="425536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bg1"/>
              </a:solidFill>
              <a:latin typeface="Calibri" panose="020F0502020204030204" pitchFamily="34" charset="0"/>
              <a:cs typeface="Calibri" panose="020F0502020204030204" pitchFamily="34" charset="0"/>
            </a:endParaRPr>
          </a:p>
        </p:txBody>
      </p:sp>
      <p:graphicFrame>
        <p:nvGraphicFramePr>
          <p:cNvPr id="4" name="Diagram 3">
            <a:extLst>
              <a:ext uri="{FF2B5EF4-FFF2-40B4-BE49-F238E27FC236}">
                <a16:creationId xmlns:a16="http://schemas.microsoft.com/office/drawing/2014/main" id="{C784C6DB-5463-1E4F-92DD-1252BDB4D0EE}"/>
              </a:ext>
            </a:extLst>
          </p:cNvPr>
          <p:cNvGraphicFramePr/>
          <p:nvPr/>
        </p:nvGraphicFramePr>
        <p:xfrm>
          <a:off x="796683" y="2006888"/>
          <a:ext cx="9026144" cy="4255367"/>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sp>
        <p:nvSpPr>
          <p:cNvPr id="9" name="TextBox 8">
            <a:extLst>
              <a:ext uri="{FF2B5EF4-FFF2-40B4-BE49-F238E27FC236}">
                <a16:creationId xmlns:a16="http://schemas.microsoft.com/office/drawing/2014/main" id="{E5E89262-9326-784F-B012-F3FECA561FB1}"/>
              </a:ext>
            </a:extLst>
          </p:cNvPr>
          <p:cNvSpPr txBox="1"/>
          <p:nvPr/>
        </p:nvSpPr>
        <p:spPr>
          <a:xfrm>
            <a:off x="4303776" y="3032098"/>
            <a:ext cx="433132" cy="307777"/>
          </a:xfrm>
          <a:prstGeom prst="rect">
            <a:avLst/>
          </a:prstGeom>
          <a:noFill/>
        </p:spPr>
        <p:txBody>
          <a:bodyPr wrap="none" rtlCol="0">
            <a:spAutoFit/>
          </a:bodyPr>
          <a:lstStyle/>
          <a:p>
            <a:r>
              <a:rPr lang="en-US" dirty="0">
                <a:solidFill>
                  <a:schemeClr val="bg1"/>
                </a:solidFill>
                <a:latin typeface="Calibri" panose="020F0502020204030204" pitchFamily="34" charset="0"/>
                <a:cs typeface="Calibri" panose="020F0502020204030204" pitchFamily="34" charset="0"/>
              </a:rPr>
              <a:t>Yes</a:t>
            </a:r>
          </a:p>
        </p:txBody>
      </p:sp>
      <p:sp>
        <p:nvSpPr>
          <p:cNvPr id="11" name="TextBox 10">
            <a:extLst>
              <a:ext uri="{FF2B5EF4-FFF2-40B4-BE49-F238E27FC236}">
                <a16:creationId xmlns:a16="http://schemas.microsoft.com/office/drawing/2014/main" id="{BACC3D70-E5CE-784A-8553-F34D63DBF3F1}"/>
              </a:ext>
            </a:extLst>
          </p:cNvPr>
          <p:cNvSpPr txBox="1"/>
          <p:nvPr/>
        </p:nvSpPr>
        <p:spPr>
          <a:xfrm>
            <a:off x="2651760" y="4604019"/>
            <a:ext cx="394660" cy="307777"/>
          </a:xfrm>
          <a:prstGeom prst="rect">
            <a:avLst/>
          </a:prstGeom>
          <a:noFill/>
        </p:spPr>
        <p:txBody>
          <a:bodyPr wrap="none" rtlCol="0">
            <a:spAutoFit/>
          </a:bodyPr>
          <a:lstStyle/>
          <a:p>
            <a:r>
              <a:rPr lang="en-US" dirty="0">
                <a:solidFill>
                  <a:schemeClr val="bg1"/>
                </a:solidFill>
                <a:latin typeface="Calibri" panose="020F0502020204030204" pitchFamily="34" charset="0"/>
                <a:cs typeface="Calibri" panose="020F0502020204030204" pitchFamily="34" charset="0"/>
              </a:rPr>
              <a:t>No</a:t>
            </a:r>
          </a:p>
        </p:txBody>
      </p:sp>
      <p:sp>
        <p:nvSpPr>
          <p:cNvPr id="12" name="TextBox 11">
            <a:extLst>
              <a:ext uri="{FF2B5EF4-FFF2-40B4-BE49-F238E27FC236}">
                <a16:creationId xmlns:a16="http://schemas.microsoft.com/office/drawing/2014/main" id="{BC3DD85B-7AA2-8C4F-AE61-B1DA49E0A74F}"/>
              </a:ext>
            </a:extLst>
          </p:cNvPr>
          <p:cNvSpPr txBox="1"/>
          <p:nvPr/>
        </p:nvSpPr>
        <p:spPr>
          <a:xfrm>
            <a:off x="7269693" y="3028388"/>
            <a:ext cx="394660" cy="307777"/>
          </a:xfrm>
          <a:prstGeom prst="rect">
            <a:avLst/>
          </a:prstGeom>
          <a:noFill/>
        </p:spPr>
        <p:txBody>
          <a:bodyPr wrap="none" rtlCol="0">
            <a:spAutoFit/>
          </a:bodyPr>
          <a:lstStyle/>
          <a:p>
            <a:r>
              <a:rPr lang="en-US" dirty="0">
                <a:solidFill>
                  <a:schemeClr val="bg1"/>
                </a:solidFill>
                <a:latin typeface="Calibri" panose="020F0502020204030204" pitchFamily="34" charset="0"/>
                <a:cs typeface="Calibri" panose="020F0502020204030204" pitchFamily="34" charset="0"/>
              </a:rPr>
              <a:t>No</a:t>
            </a:r>
          </a:p>
        </p:txBody>
      </p:sp>
      <p:sp>
        <p:nvSpPr>
          <p:cNvPr id="14" name="TextBox 13">
            <a:extLst>
              <a:ext uri="{FF2B5EF4-FFF2-40B4-BE49-F238E27FC236}">
                <a16:creationId xmlns:a16="http://schemas.microsoft.com/office/drawing/2014/main" id="{5D0760B6-1106-1F46-A3B4-0E8261C118A8}"/>
              </a:ext>
            </a:extLst>
          </p:cNvPr>
          <p:cNvSpPr txBox="1"/>
          <p:nvPr/>
        </p:nvSpPr>
        <p:spPr>
          <a:xfrm>
            <a:off x="5662868" y="4604019"/>
            <a:ext cx="433132" cy="307777"/>
          </a:xfrm>
          <a:prstGeom prst="rect">
            <a:avLst/>
          </a:prstGeom>
          <a:noFill/>
        </p:spPr>
        <p:txBody>
          <a:bodyPr wrap="none" rtlCol="0">
            <a:spAutoFit/>
          </a:bodyPr>
          <a:lstStyle/>
          <a:p>
            <a:r>
              <a:rPr lang="en-US" dirty="0">
                <a:solidFill>
                  <a:schemeClr val="bg1"/>
                </a:solidFill>
                <a:latin typeface="Calibri" panose="020F0502020204030204" pitchFamily="34" charset="0"/>
                <a:cs typeface="Calibri" panose="020F0502020204030204" pitchFamily="34" charset="0"/>
              </a:rPr>
              <a:t>Yes</a:t>
            </a:r>
          </a:p>
        </p:txBody>
      </p:sp>
    </p:spTree>
    <p:extLst>
      <p:ext uri="{BB962C8B-B14F-4D97-AF65-F5344CB8AC3E}">
        <p14:creationId xmlns:p14="http://schemas.microsoft.com/office/powerpoint/2010/main" val="233946824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66">
          <a:extLst>
            <a:ext uri="{FF2B5EF4-FFF2-40B4-BE49-F238E27FC236}">
              <a16:creationId xmlns:a16="http://schemas.microsoft.com/office/drawing/2014/main" id="{6DCA2631-496A-2DAA-C621-1D3AC7F9D652}"/>
            </a:ext>
          </a:extLst>
        </p:cNvPr>
        <p:cNvGrpSpPr/>
        <p:nvPr/>
      </p:nvGrpSpPr>
      <p:grpSpPr>
        <a:xfrm>
          <a:off x="0" y="0"/>
          <a:ext cx="0" cy="0"/>
          <a:chOff x="0" y="0"/>
          <a:chExt cx="0" cy="0"/>
        </a:xfrm>
      </p:grpSpPr>
      <p:sp>
        <p:nvSpPr>
          <p:cNvPr id="6" name="Google Shape;147;gc473988d5b_0_9">
            <a:extLst>
              <a:ext uri="{FF2B5EF4-FFF2-40B4-BE49-F238E27FC236}">
                <a16:creationId xmlns:a16="http://schemas.microsoft.com/office/drawing/2014/main" id="{0EFAD943-0A82-FC2B-36CD-A41DA25D93D2}"/>
              </a:ext>
            </a:extLst>
          </p:cNvPr>
          <p:cNvSpPr txBox="1">
            <a:spLocks noGrp="1"/>
          </p:cNvSpPr>
          <p:nvPr>
            <p:ph type="title"/>
          </p:nvPr>
        </p:nvSpPr>
        <p:spPr>
          <a:xfrm>
            <a:off x="838200" y="365125"/>
            <a:ext cx="9123218" cy="1325563"/>
          </a:xfrm>
          <a:prstGeom prst="rect">
            <a:avLst/>
          </a:prstGeom>
        </p:spPr>
        <p:txBody>
          <a:bodyPr spcFirstLastPara="1" vert="horz" wrap="square" lIns="91425" tIns="45700" rIns="91425" bIns="45700" rtlCol="0" anchor="ctr" anchorCtr="0">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spcBef>
                <a:spcPts val="0"/>
              </a:spcBef>
            </a:pPr>
            <a:r>
              <a:rPr lang="en-US" dirty="0">
                <a:solidFill>
                  <a:schemeClr val="bg1"/>
                </a:solidFill>
                <a:latin typeface="Calibri" panose="020F0502020204030204" pitchFamily="34" charset="0"/>
                <a:cs typeface="Calibri" panose="020F0502020204030204" pitchFamily="34" charset="0"/>
              </a:rPr>
              <a:t>Strategies for the altered patient</a:t>
            </a:r>
          </a:p>
        </p:txBody>
      </p:sp>
      <p:graphicFrame>
        <p:nvGraphicFramePr>
          <p:cNvPr id="5" name="Diagram 4">
            <a:extLst>
              <a:ext uri="{FF2B5EF4-FFF2-40B4-BE49-F238E27FC236}">
                <a16:creationId xmlns:a16="http://schemas.microsoft.com/office/drawing/2014/main" id="{75FE9DEC-6BB5-FD91-0A54-929DCA77CFED}"/>
              </a:ext>
            </a:extLst>
          </p:cNvPr>
          <p:cNvGraphicFramePr/>
          <p:nvPr/>
        </p:nvGraphicFramePr>
        <p:xfrm>
          <a:off x="9961418" y="-1"/>
          <a:ext cx="2304470" cy="475211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Rectangle 2">
            <a:extLst>
              <a:ext uri="{FF2B5EF4-FFF2-40B4-BE49-F238E27FC236}">
                <a16:creationId xmlns:a16="http://schemas.microsoft.com/office/drawing/2014/main" id="{5828C2B0-B637-7818-014B-953B7DA49634}"/>
              </a:ext>
            </a:extLst>
          </p:cNvPr>
          <p:cNvSpPr/>
          <p:nvPr/>
        </p:nvSpPr>
        <p:spPr>
          <a:xfrm>
            <a:off x="9781309" y="583552"/>
            <a:ext cx="2410691" cy="425536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bg1"/>
              </a:solidFill>
              <a:latin typeface="Calibri" panose="020F0502020204030204" pitchFamily="34" charset="0"/>
              <a:cs typeface="Calibri" panose="020F0502020204030204" pitchFamily="34" charset="0"/>
            </a:endParaRPr>
          </a:p>
        </p:txBody>
      </p:sp>
      <p:sp>
        <p:nvSpPr>
          <p:cNvPr id="7" name="Google Shape;168;gc473988d5b_0_81">
            <a:extLst>
              <a:ext uri="{FF2B5EF4-FFF2-40B4-BE49-F238E27FC236}">
                <a16:creationId xmlns:a16="http://schemas.microsoft.com/office/drawing/2014/main" id="{5894348A-AF04-3460-2935-95A53103D02D}"/>
              </a:ext>
            </a:extLst>
          </p:cNvPr>
          <p:cNvSpPr txBox="1">
            <a:spLocks noGrp="1"/>
          </p:cNvSpPr>
          <p:nvPr>
            <p:ph type="body" idx="1"/>
          </p:nvPr>
        </p:nvSpPr>
        <p:spPr>
          <a:xfrm>
            <a:off x="838200" y="1584875"/>
            <a:ext cx="9123218" cy="45918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Clr>
                <a:schemeClr val="lt1"/>
              </a:buClr>
              <a:buSzPts val="2800"/>
              <a:buNone/>
            </a:pPr>
            <a:r>
              <a:rPr lang="en-US" sz="3200" dirty="0"/>
              <a:t>In the room: </a:t>
            </a:r>
          </a:p>
          <a:p>
            <a:pPr indent="-457200">
              <a:buSzPts val="2800"/>
            </a:pPr>
            <a:r>
              <a:rPr lang="en-US" sz="3200" dirty="0"/>
              <a:t>Ignore the bias or change the topic.</a:t>
            </a:r>
          </a:p>
          <a:p>
            <a:pPr indent="-457200">
              <a:buSzPts val="2800"/>
            </a:pPr>
            <a:r>
              <a:rPr lang="en-US" sz="3200" dirty="0"/>
              <a:t>Consider demonstrating support by telling the target of bias it’s ok if they want to step out. </a:t>
            </a:r>
          </a:p>
          <a:p>
            <a:pPr lvl="1" indent="-457200">
              <a:buSzPts val="2800"/>
            </a:pPr>
            <a:r>
              <a:rPr lang="en-US" sz="2800" dirty="0"/>
              <a:t>As the target of bias, assess your emotions and consider stepping out if space or a strategy is needed. </a:t>
            </a:r>
          </a:p>
        </p:txBody>
      </p:sp>
    </p:spTree>
    <p:extLst>
      <p:ext uri="{BB962C8B-B14F-4D97-AF65-F5344CB8AC3E}">
        <p14:creationId xmlns:p14="http://schemas.microsoft.com/office/powerpoint/2010/main" val="272527385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7">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build="p"/>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66">
          <a:extLst>
            <a:ext uri="{FF2B5EF4-FFF2-40B4-BE49-F238E27FC236}">
              <a16:creationId xmlns:a16="http://schemas.microsoft.com/office/drawing/2014/main" id="{C00BD126-7CFC-0313-FA39-9CD300E77D5D}"/>
            </a:ext>
          </a:extLst>
        </p:cNvPr>
        <p:cNvGrpSpPr/>
        <p:nvPr/>
      </p:nvGrpSpPr>
      <p:grpSpPr>
        <a:xfrm>
          <a:off x="0" y="0"/>
          <a:ext cx="0" cy="0"/>
          <a:chOff x="0" y="0"/>
          <a:chExt cx="0" cy="0"/>
        </a:xfrm>
      </p:grpSpPr>
      <p:sp>
        <p:nvSpPr>
          <p:cNvPr id="6" name="Google Shape;147;gc473988d5b_0_9">
            <a:extLst>
              <a:ext uri="{FF2B5EF4-FFF2-40B4-BE49-F238E27FC236}">
                <a16:creationId xmlns:a16="http://schemas.microsoft.com/office/drawing/2014/main" id="{C8A4E5DE-FEDE-57E1-A033-F758DDF865A7}"/>
              </a:ext>
            </a:extLst>
          </p:cNvPr>
          <p:cNvSpPr txBox="1">
            <a:spLocks noGrp="1"/>
          </p:cNvSpPr>
          <p:nvPr>
            <p:ph type="title"/>
          </p:nvPr>
        </p:nvSpPr>
        <p:spPr>
          <a:xfrm>
            <a:off x="838200" y="365125"/>
            <a:ext cx="9123218" cy="1325563"/>
          </a:xfrm>
          <a:prstGeom prst="rect">
            <a:avLst/>
          </a:prstGeom>
        </p:spPr>
        <p:txBody>
          <a:bodyPr spcFirstLastPara="1" vert="horz" wrap="square" lIns="91425" tIns="45700" rIns="91425" bIns="45700" rtlCol="0" anchor="ctr" anchorCtr="0">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spcBef>
                <a:spcPts val="0"/>
              </a:spcBef>
            </a:pPr>
            <a:r>
              <a:rPr lang="en-US" dirty="0">
                <a:solidFill>
                  <a:schemeClr val="bg1"/>
                </a:solidFill>
                <a:latin typeface="Calibri" panose="020F0502020204030204" pitchFamily="34" charset="0"/>
                <a:cs typeface="Calibri" panose="020F0502020204030204" pitchFamily="34" charset="0"/>
              </a:rPr>
              <a:t>Strategies for the altered patient</a:t>
            </a:r>
          </a:p>
        </p:txBody>
      </p:sp>
      <p:graphicFrame>
        <p:nvGraphicFramePr>
          <p:cNvPr id="5" name="Diagram 4">
            <a:extLst>
              <a:ext uri="{FF2B5EF4-FFF2-40B4-BE49-F238E27FC236}">
                <a16:creationId xmlns:a16="http://schemas.microsoft.com/office/drawing/2014/main" id="{EBD91EA0-553E-B1A4-FDD7-1F5F0C704361}"/>
              </a:ext>
            </a:extLst>
          </p:cNvPr>
          <p:cNvGraphicFramePr/>
          <p:nvPr/>
        </p:nvGraphicFramePr>
        <p:xfrm>
          <a:off x="9961418" y="-1"/>
          <a:ext cx="2304470" cy="475211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Rectangle 2">
            <a:extLst>
              <a:ext uri="{FF2B5EF4-FFF2-40B4-BE49-F238E27FC236}">
                <a16:creationId xmlns:a16="http://schemas.microsoft.com/office/drawing/2014/main" id="{CC79447C-8E45-30D6-3278-D0106634D6FB}"/>
              </a:ext>
            </a:extLst>
          </p:cNvPr>
          <p:cNvSpPr/>
          <p:nvPr/>
        </p:nvSpPr>
        <p:spPr>
          <a:xfrm>
            <a:off x="9781309" y="583552"/>
            <a:ext cx="2410691" cy="425536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bg1"/>
              </a:solidFill>
              <a:latin typeface="Calibri" panose="020F0502020204030204" pitchFamily="34" charset="0"/>
              <a:cs typeface="Calibri" panose="020F0502020204030204" pitchFamily="34" charset="0"/>
            </a:endParaRPr>
          </a:p>
        </p:txBody>
      </p:sp>
      <p:sp>
        <p:nvSpPr>
          <p:cNvPr id="7" name="Google Shape;168;gc473988d5b_0_81">
            <a:extLst>
              <a:ext uri="{FF2B5EF4-FFF2-40B4-BE49-F238E27FC236}">
                <a16:creationId xmlns:a16="http://schemas.microsoft.com/office/drawing/2014/main" id="{10DAF00E-26A2-8339-4077-493F9FD58238}"/>
              </a:ext>
            </a:extLst>
          </p:cNvPr>
          <p:cNvSpPr txBox="1">
            <a:spLocks noGrp="1"/>
          </p:cNvSpPr>
          <p:nvPr>
            <p:ph type="body" idx="1"/>
          </p:nvPr>
        </p:nvSpPr>
        <p:spPr>
          <a:xfrm>
            <a:off x="838200" y="1584875"/>
            <a:ext cx="9123218" cy="45918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Clr>
                <a:schemeClr val="lt1"/>
              </a:buClr>
              <a:buSzPts val="2800"/>
              <a:buNone/>
            </a:pPr>
            <a:r>
              <a:rPr lang="en-US" sz="3200" dirty="0"/>
              <a:t>Debriefing bias-towards-others:</a:t>
            </a:r>
          </a:p>
          <a:p>
            <a:r>
              <a:rPr lang="en-US" dirty="0">
                <a:ea typeface="Calibri" panose="020F0502020204030204" pitchFamily="34" charset="0"/>
                <a:cs typeface="Times New Roman" panose="02020603050405020304" pitchFamily="18" charset="0"/>
              </a:rPr>
              <a:t>State what you found problematic/painful.</a:t>
            </a:r>
          </a:p>
          <a:p>
            <a:r>
              <a:rPr lang="en-US" dirty="0">
                <a:ea typeface="Calibri" panose="020F0502020204030204" pitchFamily="34" charset="0"/>
                <a:cs typeface="Times New Roman" panose="02020603050405020304" pitchFamily="18" charset="0"/>
              </a:rPr>
              <a:t>Focus on this, not the target of the bias.</a:t>
            </a:r>
          </a:p>
          <a:p>
            <a:r>
              <a:rPr lang="en-US" dirty="0">
                <a:cs typeface="Times New Roman" panose="02020603050405020304" pitchFamily="18" charset="0"/>
              </a:rPr>
              <a:t>Ask permission to debrief further. The impacted person may want space or may prefer a 1:1 discussion. </a:t>
            </a:r>
          </a:p>
          <a:p>
            <a:r>
              <a:rPr lang="en-US" dirty="0">
                <a:cs typeface="Times New Roman" panose="02020603050405020304" pitchFamily="18" charset="0"/>
              </a:rPr>
              <a:t>Ask how you can better support the target the next time.</a:t>
            </a:r>
          </a:p>
          <a:p>
            <a:r>
              <a:rPr lang="en-US" dirty="0">
                <a:cs typeface="Times New Roman" panose="02020603050405020304" pitchFamily="18" charset="0"/>
              </a:rPr>
              <a:t>If the target requests, and the team can do so, remove the target from further direct care of that patient.</a:t>
            </a:r>
            <a:endParaRPr lang="en-US" dirty="0"/>
          </a:p>
          <a:p>
            <a:pPr indent="-457200">
              <a:buSzPts val="2800"/>
            </a:pPr>
            <a:endParaRPr sz="3200" dirty="0"/>
          </a:p>
        </p:txBody>
      </p:sp>
    </p:spTree>
    <p:extLst>
      <p:ext uri="{BB962C8B-B14F-4D97-AF65-F5344CB8AC3E}">
        <p14:creationId xmlns:p14="http://schemas.microsoft.com/office/powerpoint/2010/main" val="204727541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7">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7">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7">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7">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build="p"/>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sp>
        <p:nvSpPr>
          <p:cNvPr id="6" name="Google Shape;147;gc473988d5b_0_9">
            <a:extLst>
              <a:ext uri="{FF2B5EF4-FFF2-40B4-BE49-F238E27FC236}">
                <a16:creationId xmlns:a16="http://schemas.microsoft.com/office/drawing/2014/main" id="{1B2F972C-A741-414B-A9BE-AC3A1C6D624A}"/>
              </a:ext>
            </a:extLst>
          </p:cNvPr>
          <p:cNvSpPr txBox="1">
            <a:spLocks noGrp="1"/>
          </p:cNvSpPr>
          <p:nvPr>
            <p:ph type="title"/>
          </p:nvPr>
        </p:nvSpPr>
        <p:spPr>
          <a:prstGeom prst="rect">
            <a:avLst/>
          </a:prstGeom>
        </p:spPr>
        <p:txBody>
          <a:bodyPr spcFirstLastPara="1" vert="horz" wrap="square" lIns="91425" tIns="45700" rIns="91425" bIns="45700" rtlCol="0" anchor="ctr" anchorCtr="0">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spcBef>
                <a:spcPts val="0"/>
              </a:spcBef>
            </a:pPr>
            <a:r>
              <a:rPr lang="en-US" dirty="0">
                <a:solidFill>
                  <a:schemeClr val="bg1"/>
                </a:solidFill>
                <a:latin typeface="Calibri" panose="020F0502020204030204" pitchFamily="34" charset="0"/>
                <a:cs typeface="Calibri" panose="020F0502020204030204" pitchFamily="34" charset="0"/>
              </a:rPr>
              <a:t>Check your emotions</a:t>
            </a:r>
          </a:p>
        </p:txBody>
      </p:sp>
      <p:sp>
        <p:nvSpPr>
          <p:cNvPr id="168" name="Google Shape;168;gc473988d5b_0_81"/>
          <p:cNvSpPr txBox="1">
            <a:spLocks noGrp="1"/>
          </p:cNvSpPr>
          <p:nvPr>
            <p:ph type="body" idx="1"/>
          </p:nvPr>
        </p:nvSpPr>
        <p:spPr>
          <a:xfrm>
            <a:off x="838200" y="1584875"/>
            <a:ext cx="9123218" cy="45918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Clr>
                <a:schemeClr val="lt1"/>
              </a:buClr>
              <a:buSzPts val="2800"/>
              <a:buNone/>
            </a:pPr>
            <a:r>
              <a:rPr lang="en-US" sz="3200" dirty="0"/>
              <a:t>If you’re not in a headspace to respond, it is okay to step out, process, and ask for support</a:t>
            </a:r>
          </a:p>
          <a:p>
            <a:pPr marL="0" lvl="0" indent="0" algn="l" rtl="0">
              <a:lnSpc>
                <a:spcPct val="90000"/>
              </a:lnSpc>
              <a:spcBef>
                <a:spcPts val="1000"/>
              </a:spcBef>
              <a:spcAft>
                <a:spcPts val="0"/>
              </a:spcAft>
              <a:buClr>
                <a:schemeClr val="lt1"/>
              </a:buClr>
              <a:buSzPts val="2800"/>
              <a:buNone/>
            </a:pPr>
            <a:endParaRPr sz="3200" dirty="0"/>
          </a:p>
        </p:txBody>
      </p:sp>
      <p:graphicFrame>
        <p:nvGraphicFramePr>
          <p:cNvPr id="5" name="Diagram 4">
            <a:extLst>
              <a:ext uri="{FF2B5EF4-FFF2-40B4-BE49-F238E27FC236}">
                <a16:creationId xmlns:a16="http://schemas.microsoft.com/office/drawing/2014/main" id="{B882EBB4-7A2F-8A4B-816B-7C739C60E9DC}"/>
              </a:ext>
            </a:extLst>
          </p:cNvPr>
          <p:cNvGraphicFramePr/>
          <p:nvPr/>
        </p:nvGraphicFramePr>
        <p:xfrm>
          <a:off x="9961418" y="-1"/>
          <a:ext cx="2304470" cy="475211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Rectangle 6">
            <a:extLst>
              <a:ext uri="{FF2B5EF4-FFF2-40B4-BE49-F238E27FC236}">
                <a16:creationId xmlns:a16="http://schemas.microsoft.com/office/drawing/2014/main" id="{9E685735-A901-E241-A121-CB1D9836CD09}"/>
              </a:ext>
            </a:extLst>
          </p:cNvPr>
          <p:cNvSpPr/>
          <p:nvPr/>
        </p:nvSpPr>
        <p:spPr>
          <a:xfrm>
            <a:off x="9781309" y="1191493"/>
            <a:ext cx="2410691" cy="3629891"/>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6802563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68">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8" grpId="0" build="p"/>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sp>
        <p:nvSpPr>
          <p:cNvPr id="6" name="Google Shape;147;gc473988d5b_0_9">
            <a:extLst>
              <a:ext uri="{FF2B5EF4-FFF2-40B4-BE49-F238E27FC236}">
                <a16:creationId xmlns:a16="http://schemas.microsoft.com/office/drawing/2014/main" id="{1B2F972C-A741-414B-A9BE-AC3A1C6D624A}"/>
              </a:ext>
            </a:extLst>
          </p:cNvPr>
          <p:cNvSpPr txBox="1">
            <a:spLocks noGrp="1"/>
          </p:cNvSpPr>
          <p:nvPr>
            <p:ph type="title"/>
          </p:nvPr>
        </p:nvSpPr>
        <p:spPr>
          <a:xfrm>
            <a:off x="838200" y="365125"/>
            <a:ext cx="9123218" cy="1325563"/>
          </a:xfrm>
          <a:prstGeom prst="rect">
            <a:avLst/>
          </a:prstGeom>
        </p:spPr>
        <p:txBody>
          <a:bodyPr spcFirstLastPara="1" vert="horz" wrap="square" lIns="91425" tIns="45700" rIns="91425" bIns="45700" rtlCol="0" anchor="ctr" anchorCtr="0">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spcBef>
                <a:spcPts val="0"/>
              </a:spcBef>
            </a:pPr>
            <a:r>
              <a:rPr lang="en-US" dirty="0">
                <a:solidFill>
                  <a:schemeClr val="bg1"/>
                </a:solidFill>
                <a:latin typeface="Calibri" panose="020F0502020204030204" pitchFamily="34" charset="0"/>
                <a:cs typeface="Calibri" panose="020F0502020204030204" pitchFamily="34" charset="0"/>
              </a:rPr>
              <a:t>Address the bias/microaggression explicitly</a:t>
            </a:r>
          </a:p>
        </p:txBody>
      </p:sp>
      <p:sp>
        <p:nvSpPr>
          <p:cNvPr id="168" name="Google Shape;168;gc473988d5b_0_81"/>
          <p:cNvSpPr txBox="1">
            <a:spLocks noGrp="1"/>
          </p:cNvSpPr>
          <p:nvPr>
            <p:ph type="body" idx="1"/>
          </p:nvPr>
        </p:nvSpPr>
        <p:spPr>
          <a:xfrm>
            <a:off x="838200" y="1584875"/>
            <a:ext cx="8943109" cy="4591800"/>
          </a:xfrm>
          <a:prstGeom prst="rect">
            <a:avLst/>
          </a:prstGeom>
          <a:noFill/>
          <a:ln>
            <a:noFill/>
          </a:ln>
        </p:spPr>
        <p:txBody>
          <a:bodyPr spcFirstLastPara="1" wrap="square" lIns="91425" tIns="45700" rIns="91425" bIns="45700" anchor="t" anchorCtr="0">
            <a:normAutofit/>
          </a:bodyPr>
          <a:lstStyle/>
          <a:p>
            <a:pPr marL="342900"/>
            <a:r>
              <a:rPr lang="en-US" sz="3200" dirty="0">
                <a:solidFill>
                  <a:schemeClr val="bg1"/>
                </a:solidFill>
                <a:latin typeface="Calibri" panose="020F0502020204030204" pitchFamily="34" charset="0"/>
                <a:cs typeface="Calibri" panose="020F0502020204030204" pitchFamily="34" charset="0"/>
              </a:rPr>
              <a:t>“That’s frustrating to hear.”</a:t>
            </a:r>
            <a:endParaRPr lang="en-US" sz="3200" dirty="0"/>
          </a:p>
          <a:p>
            <a:pPr marL="342900" indent="-342900"/>
            <a:r>
              <a:rPr lang="en-US" sz="3200" dirty="0"/>
              <a:t>“It’s hard to hear you say that.”</a:t>
            </a:r>
          </a:p>
          <a:p>
            <a:pPr marL="342900"/>
            <a:r>
              <a:rPr lang="en-US" sz="3200" dirty="0">
                <a:solidFill>
                  <a:schemeClr val="bg1"/>
                </a:solidFill>
                <a:latin typeface="Calibri" panose="020F0502020204030204" pitchFamily="34" charset="0"/>
                <a:cs typeface="Calibri" panose="020F0502020204030204" pitchFamily="34" charset="0"/>
              </a:rPr>
              <a:t>“I’m disappointed you’d say that.” </a:t>
            </a:r>
          </a:p>
          <a:p>
            <a:pPr marL="342900"/>
            <a:endParaRPr lang="en-US" sz="3200" i="1" dirty="0">
              <a:solidFill>
                <a:schemeClr val="bg1"/>
              </a:solidFill>
              <a:latin typeface="Calibri" panose="020F0502020204030204" pitchFamily="34" charset="0"/>
              <a:cs typeface="Calibri" panose="020F0502020204030204" pitchFamily="34" charset="0"/>
            </a:endParaRPr>
          </a:p>
          <a:p>
            <a:pPr marL="0" indent="0">
              <a:buNone/>
            </a:pPr>
            <a:r>
              <a:rPr lang="en-US" sz="3200" dirty="0">
                <a:solidFill>
                  <a:schemeClr val="bg1"/>
                </a:solidFill>
                <a:latin typeface="Calibri" panose="020F0502020204030204" pitchFamily="34" charset="0"/>
                <a:cs typeface="Calibri" panose="020F0502020204030204" pitchFamily="34" charset="0"/>
              </a:rPr>
              <a:t>Only for bias-towards-self:</a:t>
            </a:r>
          </a:p>
          <a:p>
            <a:pPr marL="342900"/>
            <a:r>
              <a:rPr lang="en-US" sz="3200" i="1" dirty="0">
                <a:solidFill>
                  <a:schemeClr val="bg1"/>
                </a:solidFill>
                <a:latin typeface="Calibri" panose="020F0502020204030204" pitchFamily="34" charset="0"/>
                <a:cs typeface="Calibri" panose="020F0502020204030204" pitchFamily="34" charset="0"/>
              </a:rPr>
              <a:t>“What do you mean by that?”</a:t>
            </a:r>
            <a:endParaRPr lang="en-US" sz="2800" i="1" dirty="0"/>
          </a:p>
          <a:p>
            <a:pPr marL="342900" indent="-342900"/>
            <a:endParaRPr lang="en-US" sz="3200" dirty="0"/>
          </a:p>
        </p:txBody>
      </p:sp>
      <p:graphicFrame>
        <p:nvGraphicFramePr>
          <p:cNvPr id="5" name="Diagram 4">
            <a:extLst>
              <a:ext uri="{FF2B5EF4-FFF2-40B4-BE49-F238E27FC236}">
                <a16:creationId xmlns:a16="http://schemas.microsoft.com/office/drawing/2014/main" id="{14B74346-9C2E-2049-A0A1-8DB2E05E774F}"/>
              </a:ext>
            </a:extLst>
          </p:cNvPr>
          <p:cNvGraphicFramePr/>
          <p:nvPr/>
        </p:nvGraphicFramePr>
        <p:xfrm>
          <a:off x="9961418" y="-1"/>
          <a:ext cx="2304470" cy="475211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Rectangle 6">
            <a:extLst>
              <a:ext uri="{FF2B5EF4-FFF2-40B4-BE49-F238E27FC236}">
                <a16:creationId xmlns:a16="http://schemas.microsoft.com/office/drawing/2014/main" id="{E284F3FD-03FB-1E4B-8E12-C1A9520818E2}"/>
              </a:ext>
            </a:extLst>
          </p:cNvPr>
          <p:cNvSpPr/>
          <p:nvPr/>
        </p:nvSpPr>
        <p:spPr>
          <a:xfrm>
            <a:off x="9781309" y="1787236"/>
            <a:ext cx="2410691" cy="302029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05783173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6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8">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68">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68">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68">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8" grpId="0" build="p"/>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graphicFrame>
        <p:nvGraphicFramePr>
          <p:cNvPr id="3" name="Diagram 2">
            <a:extLst>
              <a:ext uri="{FF2B5EF4-FFF2-40B4-BE49-F238E27FC236}">
                <a16:creationId xmlns:a16="http://schemas.microsoft.com/office/drawing/2014/main" id="{01DB98C4-F32F-D142-4AAE-84F3184B49EA}"/>
              </a:ext>
            </a:extLst>
          </p:cNvPr>
          <p:cNvGraphicFramePr/>
          <p:nvPr/>
        </p:nvGraphicFramePr>
        <p:xfrm>
          <a:off x="9961418" y="-1"/>
          <a:ext cx="2304470" cy="475211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Google Shape;147;gc473988d5b_0_9">
            <a:extLst>
              <a:ext uri="{FF2B5EF4-FFF2-40B4-BE49-F238E27FC236}">
                <a16:creationId xmlns:a16="http://schemas.microsoft.com/office/drawing/2014/main" id="{1B2F972C-A741-414B-A9BE-AC3A1C6D624A}"/>
              </a:ext>
            </a:extLst>
          </p:cNvPr>
          <p:cNvSpPr txBox="1">
            <a:spLocks noGrp="1"/>
          </p:cNvSpPr>
          <p:nvPr>
            <p:ph type="title"/>
          </p:nvPr>
        </p:nvSpPr>
        <p:spPr>
          <a:prstGeom prst="rect">
            <a:avLst/>
          </a:prstGeom>
        </p:spPr>
        <p:txBody>
          <a:bodyPr spcFirstLastPara="1" vert="horz" wrap="square" lIns="91425" tIns="45700" rIns="91425" bIns="45700" rtlCol="0" anchor="ctr" anchorCtr="0">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spcBef>
                <a:spcPts val="0"/>
              </a:spcBef>
            </a:pPr>
            <a:r>
              <a:rPr lang="en-US" dirty="0">
                <a:solidFill>
                  <a:schemeClr val="bg1"/>
                </a:solidFill>
                <a:latin typeface="Calibri" panose="020F0502020204030204" pitchFamily="34" charset="0"/>
                <a:cs typeface="Calibri" panose="020F0502020204030204" pitchFamily="34" charset="0"/>
              </a:rPr>
              <a:t>Align with your team</a:t>
            </a:r>
          </a:p>
        </p:txBody>
      </p:sp>
      <p:sp>
        <p:nvSpPr>
          <p:cNvPr id="168" name="Google Shape;168;gc473988d5b_0_81"/>
          <p:cNvSpPr txBox="1">
            <a:spLocks noGrp="1"/>
          </p:cNvSpPr>
          <p:nvPr>
            <p:ph type="body" idx="1"/>
          </p:nvPr>
        </p:nvSpPr>
        <p:spPr>
          <a:xfrm>
            <a:off x="838200" y="1584875"/>
            <a:ext cx="9123218" cy="4591800"/>
          </a:xfrm>
          <a:prstGeom prst="rect">
            <a:avLst/>
          </a:prstGeom>
          <a:noFill/>
          <a:ln>
            <a:noFill/>
          </a:ln>
        </p:spPr>
        <p:txBody>
          <a:bodyPr spcFirstLastPara="1" wrap="square" lIns="91425" tIns="45700" rIns="91425" bIns="45700" anchor="t" anchorCtr="0">
            <a:normAutofit/>
          </a:bodyPr>
          <a:lstStyle/>
          <a:p>
            <a:pPr marL="342900" indent="-342900"/>
            <a:r>
              <a:rPr lang="en-US" sz="3200" dirty="0"/>
              <a:t>“Our team is doing our best to respect you. We ask that you respect Dr. ___/me as well.”</a:t>
            </a:r>
          </a:p>
          <a:p>
            <a:pPr marL="342900" indent="-342900"/>
            <a:endParaRPr lang="en-US" sz="3200" dirty="0"/>
          </a:p>
          <a:p>
            <a:pPr marL="0" indent="0">
              <a:buNone/>
            </a:pPr>
            <a:r>
              <a:rPr lang="en-US" sz="3200" i="1" dirty="0"/>
              <a:t>**Microaffirmation**</a:t>
            </a:r>
          </a:p>
          <a:p>
            <a:pPr marL="342900" indent="-342900"/>
            <a:r>
              <a:rPr lang="en-US" sz="3200" dirty="0"/>
              <a:t>“Dr. ____ is an excellent physician and a strong member of our team.”</a:t>
            </a:r>
          </a:p>
          <a:p>
            <a:pPr marL="342900" indent="-342900"/>
            <a:endParaRPr lang="en-US" sz="3200" dirty="0"/>
          </a:p>
        </p:txBody>
      </p:sp>
      <p:sp>
        <p:nvSpPr>
          <p:cNvPr id="7" name="Rectangle 6">
            <a:extLst>
              <a:ext uri="{FF2B5EF4-FFF2-40B4-BE49-F238E27FC236}">
                <a16:creationId xmlns:a16="http://schemas.microsoft.com/office/drawing/2014/main" id="{57543838-9DD3-614D-A8A7-98022F64C67D}"/>
              </a:ext>
            </a:extLst>
          </p:cNvPr>
          <p:cNvSpPr/>
          <p:nvPr/>
        </p:nvSpPr>
        <p:spPr>
          <a:xfrm>
            <a:off x="9781309" y="2383971"/>
            <a:ext cx="2410691" cy="250668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65047718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6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8">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68">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8" grpId="0" build="p"/>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graphicFrame>
        <p:nvGraphicFramePr>
          <p:cNvPr id="3" name="Diagram 2">
            <a:extLst>
              <a:ext uri="{FF2B5EF4-FFF2-40B4-BE49-F238E27FC236}">
                <a16:creationId xmlns:a16="http://schemas.microsoft.com/office/drawing/2014/main" id="{834A395B-1E86-3D29-A2BB-1B7F9D7BD25E}"/>
              </a:ext>
            </a:extLst>
          </p:cNvPr>
          <p:cNvGraphicFramePr/>
          <p:nvPr/>
        </p:nvGraphicFramePr>
        <p:xfrm>
          <a:off x="9961418" y="-1"/>
          <a:ext cx="2304470" cy="475211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Google Shape;147;gc473988d5b_0_9">
            <a:extLst>
              <a:ext uri="{FF2B5EF4-FFF2-40B4-BE49-F238E27FC236}">
                <a16:creationId xmlns:a16="http://schemas.microsoft.com/office/drawing/2014/main" id="{1B2F972C-A741-414B-A9BE-AC3A1C6D624A}"/>
              </a:ext>
            </a:extLst>
          </p:cNvPr>
          <p:cNvSpPr txBox="1">
            <a:spLocks noGrp="1"/>
          </p:cNvSpPr>
          <p:nvPr>
            <p:ph type="title"/>
          </p:nvPr>
        </p:nvSpPr>
        <p:spPr>
          <a:prstGeom prst="rect">
            <a:avLst/>
          </a:prstGeom>
        </p:spPr>
        <p:txBody>
          <a:bodyPr spcFirstLastPara="1" vert="horz" wrap="square" lIns="91425" tIns="45700" rIns="91425" bIns="45700" rtlCol="0" anchor="ctr" anchorCtr="0">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spcBef>
                <a:spcPts val="0"/>
              </a:spcBef>
            </a:pPr>
            <a:r>
              <a:rPr lang="en-US" dirty="0">
                <a:solidFill>
                  <a:schemeClr val="bg1"/>
                </a:solidFill>
                <a:latin typeface="Calibri" panose="020F0502020204030204" pitchFamily="34" charset="0"/>
                <a:cs typeface="Calibri" panose="020F0502020204030204" pitchFamily="34" charset="0"/>
              </a:rPr>
              <a:t>Set boundaries</a:t>
            </a:r>
          </a:p>
        </p:txBody>
      </p:sp>
      <p:sp>
        <p:nvSpPr>
          <p:cNvPr id="168" name="Google Shape;168;gc473988d5b_0_81"/>
          <p:cNvSpPr txBox="1">
            <a:spLocks noGrp="1"/>
          </p:cNvSpPr>
          <p:nvPr>
            <p:ph type="body" idx="1"/>
          </p:nvPr>
        </p:nvSpPr>
        <p:spPr>
          <a:xfrm>
            <a:off x="838200" y="1584875"/>
            <a:ext cx="9123218" cy="4591800"/>
          </a:xfrm>
          <a:prstGeom prst="rect">
            <a:avLst/>
          </a:prstGeom>
          <a:noFill/>
          <a:ln>
            <a:noFill/>
          </a:ln>
        </p:spPr>
        <p:txBody>
          <a:bodyPr spcFirstLastPara="1" wrap="square" lIns="91425" tIns="45700" rIns="91425" bIns="45700" anchor="t" anchorCtr="0">
            <a:normAutofit/>
          </a:bodyPr>
          <a:lstStyle/>
          <a:p>
            <a:pPr marL="342900" indent="-342900"/>
            <a:r>
              <a:rPr lang="en-US" sz="3200" dirty="0"/>
              <a:t>“I’d ask that you refrain from commenting on ___.” </a:t>
            </a:r>
          </a:p>
          <a:p>
            <a:pPr marL="342900" indent="-342900"/>
            <a:r>
              <a:rPr lang="en-US" sz="3200" dirty="0"/>
              <a:t>“Please call them/me Dr.___.”</a:t>
            </a:r>
          </a:p>
          <a:p>
            <a:pPr marL="342900"/>
            <a:r>
              <a:rPr lang="en-US" sz="3200" dirty="0"/>
              <a:t>“We do not accommodate staff changes based on [race/ethnicity/religion/</a:t>
            </a:r>
            <a:r>
              <a:rPr lang="en-US" sz="3200" dirty="0" err="1"/>
              <a:t>etc</a:t>
            </a:r>
            <a:r>
              <a:rPr lang="en-US" sz="3200" dirty="0"/>
              <a:t>], Dr. __/I will be in charge of your care today.”</a:t>
            </a:r>
          </a:p>
          <a:p>
            <a:pPr marL="342900"/>
            <a:r>
              <a:rPr lang="en-US" sz="3200" dirty="0"/>
              <a:t>“The [code of conduct/our institution] does not permit that behavior/language/etc.</a:t>
            </a:r>
          </a:p>
        </p:txBody>
      </p:sp>
      <p:sp>
        <p:nvSpPr>
          <p:cNvPr id="7" name="Rectangle 6">
            <a:extLst>
              <a:ext uri="{FF2B5EF4-FFF2-40B4-BE49-F238E27FC236}">
                <a16:creationId xmlns:a16="http://schemas.microsoft.com/office/drawing/2014/main" id="{DAEEE025-CBCC-9F48-B325-53C4FFA94395}"/>
              </a:ext>
            </a:extLst>
          </p:cNvPr>
          <p:cNvSpPr/>
          <p:nvPr/>
        </p:nvSpPr>
        <p:spPr>
          <a:xfrm>
            <a:off x="9887530" y="2988126"/>
            <a:ext cx="2304470" cy="192677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63732773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6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8">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68">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68">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8" grpId="0" build="p"/>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graphicFrame>
        <p:nvGraphicFramePr>
          <p:cNvPr id="3" name="Diagram 2">
            <a:extLst>
              <a:ext uri="{FF2B5EF4-FFF2-40B4-BE49-F238E27FC236}">
                <a16:creationId xmlns:a16="http://schemas.microsoft.com/office/drawing/2014/main" id="{158CBD90-3271-62D6-C0BF-21284CCC637D}"/>
              </a:ext>
            </a:extLst>
          </p:cNvPr>
          <p:cNvGraphicFramePr/>
          <p:nvPr/>
        </p:nvGraphicFramePr>
        <p:xfrm>
          <a:off x="9961418" y="-1"/>
          <a:ext cx="2304470" cy="475211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Google Shape;147;gc473988d5b_0_9">
            <a:extLst>
              <a:ext uri="{FF2B5EF4-FFF2-40B4-BE49-F238E27FC236}">
                <a16:creationId xmlns:a16="http://schemas.microsoft.com/office/drawing/2014/main" id="{1B2F972C-A741-414B-A9BE-AC3A1C6D624A}"/>
              </a:ext>
            </a:extLst>
          </p:cNvPr>
          <p:cNvSpPr txBox="1">
            <a:spLocks noGrp="1"/>
          </p:cNvSpPr>
          <p:nvPr>
            <p:ph type="title"/>
          </p:nvPr>
        </p:nvSpPr>
        <p:spPr>
          <a:prstGeom prst="rect">
            <a:avLst/>
          </a:prstGeom>
        </p:spPr>
        <p:txBody>
          <a:bodyPr spcFirstLastPara="1" vert="horz" wrap="square" lIns="91425" tIns="45700" rIns="91425" bIns="45700" rtlCol="0" anchor="ctr" anchorCtr="0">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spcBef>
                <a:spcPts val="0"/>
              </a:spcBef>
            </a:pPr>
            <a:r>
              <a:rPr lang="en-US" dirty="0">
                <a:solidFill>
                  <a:schemeClr val="bg1"/>
                </a:solidFill>
                <a:latin typeface="Calibri" panose="020F0502020204030204" pitchFamily="34" charset="0"/>
                <a:cs typeface="Calibri" panose="020F0502020204030204" pitchFamily="34" charset="0"/>
              </a:rPr>
              <a:t>Recenter on patient care</a:t>
            </a:r>
          </a:p>
        </p:txBody>
      </p:sp>
      <p:sp>
        <p:nvSpPr>
          <p:cNvPr id="168" name="Google Shape;168;gc473988d5b_0_81"/>
          <p:cNvSpPr txBox="1">
            <a:spLocks noGrp="1"/>
          </p:cNvSpPr>
          <p:nvPr>
            <p:ph type="body" idx="1"/>
          </p:nvPr>
        </p:nvSpPr>
        <p:spPr>
          <a:xfrm>
            <a:off x="838200" y="1584875"/>
            <a:ext cx="10515600" cy="4591800"/>
          </a:xfrm>
          <a:prstGeom prst="rect">
            <a:avLst/>
          </a:prstGeom>
          <a:noFill/>
          <a:ln>
            <a:noFill/>
          </a:ln>
        </p:spPr>
        <p:txBody>
          <a:bodyPr spcFirstLastPara="1" wrap="square" lIns="91425" tIns="45700" rIns="91425" bIns="45700" anchor="t" anchorCtr="0">
            <a:normAutofit/>
          </a:bodyPr>
          <a:lstStyle/>
          <a:p>
            <a:pPr marL="342900" indent="-342900"/>
            <a:r>
              <a:rPr lang="en-US" sz="3200" dirty="0"/>
              <a:t>“Our team is here to focus on your health.”</a:t>
            </a:r>
          </a:p>
          <a:p>
            <a:pPr marL="342900"/>
            <a:r>
              <a:rPr lang="en-US" sz="3200" dirty="0"/>
              <a:t>“Our goal, like yours, is to ______.”  </a:t>
            </a:r>
          </a:p>
        </p:txBody>
      </p:sp>
      <p:sp>
        <p:nvSpPr>
          <p:cNvPr id="7" name="Rectangle 6">
            <a:extLst>
              <a:ext uri="{FF2B5EF4-FFF2-40B4-BE49-F238E27FC236}">
                <a16:creationId xmlns:a16="http://schemas.microsoft.com/office/drawing/2014/main" id="{AD12A4EC-8F59-F444-9694-53FB8B12C8C3}"/>
              </a:ext>
            </a:extLst>
          </p:cNvPr>
          <p:cNvSpPr/>
          <p:nvPr/>
        </p:nvSpPr>
        <p:spPr>
          <a:xfrm>
            <a:off x="9781309" y="3577466"/>
            <a:ext cx="2410691" cy="13255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4770644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6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8">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8" grpId="0" build="p"/>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graphicFrame>
        <p:nvGraphicFramePr>
          <p:cNvPr id="3" name="Diagram 2">
            <a:extLst>
              <a:ext uri="{FF2B5EF4-FFF2-40B4-BE49-F238E27FC236}">
                <a16:creationId xmlns:a16="http://schemas.microsoft.com/office/drawing/2014/main" id="{C4357EF7-97B2-2BEB-4B43-0CF402811E5D}"/>
              </a:ext>
            </a:extLst>
          </p:cNvPr>
          <p:cNvGraphicFramePr/>
          <p:nvPr/>
        </p:nvGraphicFramePr>
        <p:xfrm>
          <a:off x="9961418" y="32656"/>
          <a:ext cx="2304470" cy="475211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Google Shape;147;gc473988d5b_0_9">
            <a:extLst>
              <a:ext uri="{FF2B5EF4-FFF2-40B4-BE49-F238E27FC236}">
                <a16:creationId xmlns:a16="http://schemas.microsoft.com/office/drawing/2014/main" id="{1B2F972C-A741-414B-A9BE-AC3A1C6D624A}"/>
              </a:ext>
            </a:extLst>
          </p:cNvPr>
          <p:cNvSpPr txBox="1">
            <a:spLocks noGrp="1"/>
          </p:cNvSpPr>
          <p:nvPr>
            <p:ph type="title"/>
          </p:nvPr>
        </p:nvSpPr>
        <p:spPr>
          <a:prstGeom prst="rect">
            <a:avLst/>
          </a:prstGeom>
        </p:spPr>
        <p:txBody>
          <a:bodyPr spcFirstLastPara="1" vert="horz" wrap="square" lIns="91425" tIns="45700" rIns="91425" bIns="45700" rtlCol="0" anchor="ctr" anchorCtr="0">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spcBef>
                <a:spcPts val="0"/>
              </a:spcBef>
            </a:pPr>
            <a:r>
              <a:rPr lang="en-US" dirty="0">
                <a:solidFill>
                  <a:schemeClr val="bg1"/>
                </a:solidFill>
                <a:latin typeface="Calibri" panose="020F0502020204030204" pitchFamily="34" charset="0"/>
                <a:cs typeface="Calibri" panose="020F0502020204030204" pitchFamily="34" charset="0"/>
              </a:rPr>
              <a:t>Give space</a:t>
            </a:r>
          </a:p>
        </p:txBody>
      </p:sp>
      <p:sp>
        <p:nvSpPr>
          <p:cNvPr id="168" name="Google Shape;168;gc473988d5b_0_81"/>
          <p:cNvSpPr txBox="1">
            <a:spLocks noGrp="1"/>
          </p:cNvSpPr>
          <p:nvPr>
            <p:ph type="body" idx="1"/>
          </p:nvPr>
        </p:nvSpPr>
        <p:spPr>
          <a:xfrm>
            <a:off x="838200" y="1584875"/>
            <a:ext cx="9123218" cy="4591800"/>
          </a:xfrm>
          <a:prstGeom prst="rect">
            <a:avLst/>
          </a:prstGeom>
          <a:noFill/>
          <a:ln>
            <a:noFill/>
          </a:ln>
        </p:spPr>
        <p:txBody>
          <a:bodyPr spcFirstLastPara="1" wrap="square" lIns="91425" tIns="45700" rIns="91425" bIns="45700" anchor="t" anchorCtr="0">
            <a:normAutofit/>
          </a:bodyPr>
          <a:lstStyle/>
          <a:p>
            <a:pPr marL="342900" indent="-342900"/>
            <a:r>
              <a:rPr lang="en-US" sz="3200" dirty="0"/>
              <a:t>“We are going to give you space for 15 minutes and when we come back, we can focus on your health.”</a:t>
            </a:r>
          </a:p>
        </p:txBody>
      </p:sp>
      <p:sp>
        <p:nvSpPr>
          <p:cNvPr id="7" name="Rectangle 6">
            <a:extLst>
              <a:ext uri="{FF2B5EF4-FFF2-40B4-BE49-F238E27FC236}">
                <a16:creationId xmlns:a16="http://schemas.microsoft.com/office/drawing/2014/main" id="{D6163ADC-3397-F94F-9959-05EFA484C1F3}"/>
              </a:ext>
            </a:extLst>
          </p:cNvPr>
          <p:cNvSpPr/>
          <p:nvPr/>
        </p:nvSpPr>
        <p:spPr>
          <a:xfrm>
            <a:off x="9781309" y="4170218"/>
            <a:ext cx="2410691" cy="637311"/>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7360812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68">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8" grpId="0" build="p"/>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08"/>
        <p:cNvGrpSpPr/>
        <p:nvPr/>
      </p:nvGrpSpPr>
      <p:grpSpPr>
        <a:xfrm>
          <a:off x="0" y="0"/>
          <a:ext cx="0" cy="0"/>
          <a:chOff x="0" y="0"/>
          <a:chExt cx="0" cy="0"/>
        </a:xfrm>
      </p:grpSpPr>
      <p:sp>
        <p:nvSpPr>
          <p:cNvPr id="109" name="Google Shape;109;p2"/>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dirty="0"/>
              <a:t>Roadmap</a:t>
            </a:r>
            <a:endParaRPr dirty="0"/>
          </a:p>
        </p:txBody>
      </p:sp>
      <p:sp>
        <p:nvSpPr>
          <p:cNvPr id="110" name="Google Shape;110;p2"/>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lt1"/>
              </a:buClr>
              <a:buSzPts val="2800"/>
              <a:buChar char="•"/>
            </a:pPr>
            <a:r>
              <a:rPr lang="en-US" dirty="0"/>
              <a:t>Background</a:t>
            </a:r>
            <a:endParaRPr dirty="0"/>
          </a:p>
          <a:p>
            <a:pPr marL="228600" lvl="0" indent="-228600" algn="l" rtl="0">
              <a:lnSpc>
                <a:spcPct val="90000"/>
              </a:lnSpc>
              <a:spcBef>
                <a:spcPts val="1000"/>
              </a:spcBef>
              <a:spcAft>
                <a:spcPts val="0"/>
              </a:spcAft>
              <a:buClr>
                <a:schemeClr val="lt1"/>
              </a:buClr>
              <a:buSzPts val="2800"/>
              <a:buChar char="•"/>
            </a:pPr>
            <a:r>
              <a:rPr lang="en-US" dirty="0"/>
              <a:t>Warm-up</a:t>
            </a:r>
            <a:endParaRPr dirty="0"/>
          </a:p>
          <a:p>
            <a:pPr marL="228600" lvl="0" indent="-165100" algn="l" rtl="0">
              <a:lnSpc>
                <a:spcPct val="90000"/>
              </a:lnSpc>
              <a:spcBef>
                <a:spcPts val="1000"/>
              </a:spcBef>
              <a:spcAft>
                <a:spcPts val="0"/>
              </a:spcAft>
              <a:buSzPts val="1800"/>
              <a:buChar char="•"/>
            </a:pPr>
            <a:r>
              <a:rPr lang="en-US" dirty="0"/>
              <a:t>Toolkit</a:t>
            </a:r>
            <a:endParaRPr dirty="0"/>
          </a:p>
          <a:p>
            <a:pPr marL="228600" lvl="0" indent="-228600" algn="l" rtl="0">
              <a:lnSpc>
                <a:spcPct val="90000"/>
              </a:lnSpc>
              <a:spcBef>
                <a:spcPts val="1000"/>
              </a:spcBef>
              <a:spcAft>
                <a:spcPts val="0"/>
              </a:spcAft>
              <a:buClr>
                <a:schemeClr val="lt1"/>
              </a:buClr>
              <a:buSzPts val="2800"/>
              <a:buChar char="•"/>
            </a:pPr>
            <a:r>
              <a:rPr lang="en-US" dirty="0"/>
              <a:t>Rapid fire practice</a:t>
            </a:r>
            <a:endParaRPr dirty="0"/>
          </a:p>
        </p:txBody>
      </p:sp>
    </p:spTree>
    <p:custDataLst>
      <p:tags r:id="rId1"/>
    </p:custData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sp>
        <p:nvSpPr>
          <p:cNvPr id="6" name="Google Shape;147;gc473988d5b_0_9">
            <a:extLst>
              <a:ext uri="{FF2B5EF4-FFF2-40B4-BE49-F238E27FC236}">
                <a16:creationId xmlns:a16="http://schemas.microsoft.com/office/drawing/2014/main" id="{1B2F972C-A741-414B-A9BE-AC3A1C6D624A}"/>
              </a:ext>
            </a:extLst>
          </p:cNvPr>
          <p:cNvSpPr txBox="1">
            <a:spLocks noGrp="1"/>
          </p:cNvSpPr>
          <p:nvPr>
            <p:ph type="title"/>
          </p:nvPr>
        </p:nvSpPr>
        <p:spPr>
          <a:prstGeom prst="rect">
            <a:avLst/>
          </a:prstGeom>
        </p:spPr>
        <p:txBody>
          <a:bodyPr spcFirstLastPara="1" vert="horz" wrap="square" lIns="91425" tIns="45700" rIns="91425" bIns="45700" rtlCol="0" anchor="ctr" anchorCtr="0">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spcBef>
                <a:spcPts val="0"/>
              </a:spcBef>
            </a:pPr>
            <a:r>
              <a:rPr lang="en-US" dirty="0">
                <a:solidFill>
                  <a:schemeClr val="bg1"/>
                </a:solidFill>
                <a:latin typeface="Calibri" panose="020F0502020204030204" pitchFamily="34" charset="0"/>
                <a:cs typeface="Calibri" panose="020F0502020204030204" pitchFamily="34" charset="0"/>
              </a:rPr>
              <a:t>Attend to emotion, seek support</a:t>
            </a:r>
          </a:p>
        </p:txBody>
      </p:sp>
      <p:sp>
        <p:nvSpPr>
          <p:cNvPr id="168" name="Google Shape;168;gc473988d5b_0_81"/>
          <p:cNvSpPr txBox="1">
            <a:spLocks noGrp="1"/>
          </p:cNvSpPr>
          <p:nvPr>
            <p:ph type="body" idx="1"/>
          </p:nvPr>
        </p:nvSpPr>
        <p:spPr>
          <a:xfrm>
            <a:off x="838200" y="1584875"/>
            <a:ext cx="9123218" cy="4591800"/>
          </a:xfrm>
          <a:prstGeom prst="rect">
            <a:avLst/>
          </a:prstGeom>
          <a:noFill/>
          <a:ln>
            <a:noFill/>
          </a:ln>
        </p:spPr>
        <p:txBody>
          <a:bodyPr spcFirstLastPara="1" wrap="square" lIns="91425" tIns="45700" rIns="91425" bIns="45700" anchor="t" anchorCtr="0">
            <a:normAutofit/>
          </a:bodyPr>
          <a:lstStyle/>
          <a:p>
            <a:pPr marL="342900" indent="-342900"/>
            <a:r>
              <a:rPr lang="en-US" sz="3200" dirty="0"/>
              <a:t>Debrief these encounters so they do not fester</a:t>
            </a:r>
          </a:p>
          <a:p>
            <a:pPr marL="800100" lvl="1"/>
            <a:r>
              <a:rPr lang="en-US" sz="2800" dirty="0"/>
              <a:t>Revisit the debriefing strategies reviewed when responding to an altered patient. </a:t>
            </a:r>
          </a:p>
          <a:p>
            <a:pPr marL="800100" lvl="1"/>
            <a:r>
              <a:rPr lang="en-US" sz="2800" dirty="0"/>
              <a:t>Consider discussing what went well and what you would do differently next time if the target is open to debriefing further. </a:t>
            </a:r>
          </a:p>
          <a:p>
            <a:pPr marL="342900" indent="-342900"/>
            <a:r>
              <a:rPr lang="en-US" sz="3200" dirty="0"/>
              <a:t>Normalize and model talking about your experiences and checking in on each other when you know others have had a tough patient encounter</a:t>
            </a:r>
          </a:p>
        </p:txBody>
      </p:sp>
      <p:graphicFrame>
        <p:nvGraphicFramePr>
          <p:cNvPr id="3" name="Diagram 2">
            <a:extLst>
              <a:ext uri="{FF2B5EF4-FFF2-40B4-BE49-F238E27FC236}">
                <a16:creationId xmlns:a16="http://schemas.microsoft.com/office/drawing/2014/main" id="{9E830603-74F1-1520-994E-752D7B533F7E}"/>
              </a:ext>
            </a:extLst>
          </p:cNvPr>
          <p:cNvGraphicFramePr/>
          <p:nvPr/>
        </p:nvGraphicFramePr>
        <p:xfrm>
          <a:off x="9961418" y="-1"/>
          <a:ext cx="2304470" cy="475211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9362444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68">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68">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68">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68">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8" grpId="0" build="p"/>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174" name="Google Shape;174;gc473988d5b_0_93"/>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a:t>Best practices for the team</a:t>
            </a:r>
            <a:endParaRPr/>
          </a:p>
        </p:txBody>
      </p:sp>
      <p:sp>
        <p:nvSpPr>
          <p:cNvPr id="175" name="Google Shape;175;gc473988d5b_0_93"/>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514350" lvl="0" indent="-514350" algn="l" rtl="0">
              <a:lnSpc>
                <a:spcPct val="90000"/>
              </a:lnSpc>
              <a:spcBef>
                <a:spcPts val="0"/>
              </a:spcBef>
              <a:spcAft>
                <a:spcPts val="0"/>
              </a:spcAft>
              <a:buClr>
                <a:schemeClr val="lt1"/>
              </a:buClr>
              <a:buSzPts val="2800"/>
              <a:buFont typeface="Calibri"/>
              <a:buAutoNum type="arabicPeriod"/>
            </a:pPr>
            <a:r>
              <a:rPr lang="en-US"/>
              <a:t>On day one, establish with your team that addressing bias is as important as debriefing a clinical outcome or difficult conversation</a:t>
            </a:r>
            <a:endParaRPr/>
          </a:p>
          <a:p>
            <a:pPr marL="514350" lvl="0" indent="-514350" algn="l" rtl="0">
              <a:lnSpc>
                <a:spcPct val="90000"/>
              </a:lnSpc>
              <a:spcBef>
                <a:spcPts val="1000"/>
              </a:spcBef>
              <a:spcAft>
                <a:spcPts val="0"/>
              </a:spcAft>
              <a:buClr>
                <a:schemeClr val="lt1"/>
              </a:buClr>
              <a:buSzPts val="2800"/>
              <a:buFont typeface="Calibri"/>
              <a:buAutoNum type="arabicPeriod"/>
            </a:pPr>
            <a:r>
              <a:rPr lang="en-US"/>
              <a:t>Huddle after an event and include attending and others involved in the patient’s care</a:t>
            </a:r>
            <a:endParaRPr/>
          </a:p>
          <a:p>
            <a:pPr marL="514350" lvl="0" indent="-514350" algn="l" rtl="0">
              <a:lnSpc>
                <a:spcPct val="90000"/>
              </a:lnSpc>
              <a:spcBef>
                <a:spcPts val="1000"/>
              </a:spcBef>
              <a:spcAft>
                <a:spcPts val="0"/>
              </a:spcAft>
              <a:buClr>
                <a:schemeClr val="lt1"/>
              </a:buClr>
              <a:buSzPts val="2800"/>
              <a:buFont typeface="Calibri"/>
              <a:buAutoNum type="arabicPeriod"/>
            </a:pPr>
            <a:r>
              <a:rPr lang="en-US"/>
              <a:t>Involve unit-based leadership (Nursing Director, Resource RN, additional faculty etc.)</a:t>
            </a:r>
            <a:endParaRPr/>
          </a:p>
          <a:p>
            <a:pPr marL="514350" lvl="0" indent="-514350" algn="l" rtl="0">
              <a:lnSpc>
                <a:spcPct val="90000"/>
              </a:lnSpc>
              <a:spcBef>
                <a:spcPts val="1000"/>
              </a:spcBef>
              <a:spcAft>
                <a:spcPts val="0"/>
              </a:spcAft>
              <a:buClr>
                <a:schemeClr val="lt1"/>
              </a:buClr>
              <a:buSzPts val="2800"/>
              <a:buFont typeface="Calibri"/>
              <a:buAutoNum type="arabicPeriod"/>
            </a:pPr>
            <a:r>
              <a:rPr lang="en-US"/>
              <a:t>Consider other hospital-based resources (Patient Advocacy, Spiritual Care, Security if safety concerns)</a:t>
            </a:r>
            <a:endParaRPr/>
          </a:p>
          <a:p>
            <a:pPr marL="228600" lvl="0" indent="-50800" algn="l" rtl="0">
              <a:lnSpc>
                <a:spcPct val="90000"/>
              </a:lnSpc>
              <a:spcBef>
                <a:spcPts val="1000"/>
              </a:spcBef>
              <a:spcAft>
                <a:spcPts val="0"/>
              </a:spcAft>
              <a:buClr>
                <a:schemeClr val="lt1"/>
              </a:buClr>
              <a:buSzPts val="2800"/>
              <a:buNone/>
            </a:pPr>
            <a:endParaRPr/>
          </a:p>
        </p:txBody>
      </p:sp>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7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7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7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75">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80"/>
        <p:cNvGrpSpPr/>
        <p:nvPr/>
      </p:nvGrpSpPr>
      <p:grpSpPr>
        <a:xfrm>
          <a:off x="0" y="0"/>
          <a:ext cx="0" cy="0"/>
          <a:chOff x="0" y="0"/>
          <a:chExt cx="0" cy="0"/>
        </a:xfrm>
      </p:grpSpPr>
      <p:sp>
        <p:nvSpPr>
          <p:cNvPr id="181" name="Google Shape;181;gc473988d5b_0_99"/>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dirty="0"/>
              <a:t>Toolkit</a:t>
            </a:r>
            <a:endParaRPr dirty="0"/>
          </a:p>
        </p:txBody>
      </p:sp>
      <p:pic>
        <p:nvPicPr>
          <p:cNvPr id="2" name="Picture 1">
            <a:extLst>
              <a:ext uri="{FF2B5EF4-FFF2-40B4-BE49-F238E27FC236}">
                <a16:creationId xmlns:a16="http://schemas.microsoft.com/office/drawing/2014/main" id="{9216E81E-BE34-87BD-BC5C-92453BFEC15F}"/>
              </a:ext>
            </a:extLst>
          </p:cNvPr>
          <p:cNvPicPr>
            <a:picLocks noChangeAspect="1"/>
          </p:cNvPicPr>
          <p:nvPr/>
        </p:nvPicPr>
        <p:blipFill>
          <a:blip r:embed="rId4"/>
          <a:stretch>
            <a:fillRect/>
          </a:stretch>
        </p:blipFill>
        <p:spPr>
          <a:xfrm>
            <a:off x="3446099" y="0"/>
            <a:ext cx="5299801" cy="6858000"/>
          </a:xfrm>
          <a:prstGeom prst="rect">
            <a:avLst/>
          </a:prstGeom>
        </p:spPr>
      </p:pic>
    </p:spTree>
    <p:custDataLst>
      <p:tags r:id="rId1"/>
    </p:custData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75C1AA-BA1E-624F-902B-EC9048831C60}"/>
              </a:ext>
            </a:extLst>
          </p:cNvPr>
          <p:cNvSpPr>
            <a:spLocks noGrp="1"/>
          </p:cNvSpPr>
          <p:nvPr>
            <p:ph type="ctrTitle"/>
          </p:nvPr>
        </p:nvSpPr>
        <p:spPr>
          <a:xfrm>
            <a:off x="3043403" y="2794905"/>
            <a:ext cx="6105194" cy="1268190"/>
          </a:xfrm>
        </p:spPr>
        <p:txBody>
          <a:bodyPr>
            <a:normAutofit/>
          </a:bodyPr>
          <a:lstStyle/>
          <a:p>
            <a:r>
              <a:rPr lang="en-US" dirty="0">
                <a:solidFill>
                  <a:schemeClr val="tx2"/>
                </a:solidFill>
              </a:rPr>
              <a:t>Case Discussion</a:t>
            </a:r>
          </a:p>
        </p:txBody>
      </p:sp>
    </p:spTree>
    <p:extLst>
      <p:ext uri="{BB962C8B-B14F-4D97-AF65-F5344CB8AC3E}">
        <p14:creationId xmlns:p14="http://schemas.microsoft.com/office/powerpoint/2010/main" val="276949169"/>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186"/>
        <p:cNvGrpSpPr/>
        <p:nvPr/>
      </p:nvGrpSpPr>
      <p:grpSpPr>
        <a:xfrm>
          <a:off x="0" y="0"/>
          <a:ext cx="0" cy="0"/>
          <a:chOff x="0" y="0"/>
          <a:chExt cx="0" cy="0"/>
        </a:xfrm>
      </p:grpSpPr>
      <p:sp>
        <p:nvSpPr>
          <p:cNvPr id="187" name="Google Shape;187;p29"/>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a:t>Applying the toolkit</a:t>
            </a:r>
            <a:endParaRPr/>
          </a:p>
        </p:txBody>
      </p:sp>
      <p:sp>
        <p:nvSpPr>
          <p:cNvPr id="188" name="Google Shape;188;p29"/>
          <p:cNvSpPr txBox="1">
            <a:spLocks noGrp="1"/>
          </p:cNvSpPr>
          <p:nvPr>
            <p:ph type="body" idx="1"/>
          </p:nvPr>
        </p:nvSpPr>
        <p:spPr>
          <a:prstGeom prst="rect">
            <a:avLst/>
          </a:prstGeom>
          <a:noFill/>
          <a:ln>
            <a:noFill/>
          </a:ln>
        </p:spPr>
        <p:txBody>
          <a:bodyPr spcFirstLastPara="1" wrap="square" lIns="91425" tIns="45700" rIns="91425" bIns="45700" anchor="t" anchorCtr="0">
            <a:normAutofit lnSpcReduction="10000"/>
          </a:bodyPr>
          <a:lstStyle/>
          <a:p>
            <a:pPr marL="228600" lvl="0" indent="-228600" algn="l" rtl="0">
              <a:lnSpc>
                <a:spcPct val="90000"/>
              </a:lnSpc>
              <a:spcBef>
                <a:spcPts val="0"/>
              </a:spcBef>
              <a:spcAft>
                <a:spcPts val="0"/>
              </a:spcAft>
              <a:buClr>
                <a:schemeClr val="lt1"/>
              </a:buClr>
              <a:buSzPts val="2800"/>
              <a:buChar char="•"/>
            </a:pPr>
            <a:r>
              <a:rPr lang="en-US" dirty="0"/>
              <a:t>Let’s use your new skills:</a:t>
            </a:r>
            <a:endParaRPr dirty="0"/>
          </a:p>
          <a:p>
            <a:pPr marL="685800" lvl="1" indent="-292100" algn="l" rtl="0">
              <a:lnSpc>
                <a:spcPct val="90000"/>
              </a:lnSpc>
              <a:spcBef>
                <a:spcPts val="1000"/>
              </a:spcBef>
              <a:spcAft>
                <a:spcPts val="0"/>
              </a:spcAft>
              <a:buClr>
                <a:schemeClr val="lt1"/>
              </a:buClr>
              <a:buSzPts val="2800"/>
              <a:buChar char="•"/>
            </a:pPr>
            <a:r>
              <a:rPr lang="en-US" b="1" dirty="0"/>
              <a:t>In-Person Participants:</a:t>
            </a:r>
            <a:r>
              <a:rPr lang="en-US" dirty="0"/>
              <a:t> Please move to sit near a colleague or two</a:t>
            </a:r>
          </a:p>
          <a:p>
            <a:pPr marL="1143000" lvl="2" indent="-292100">
              <a:spcBef>
                <a:spcPts val="1000"/>
              </a:spcBef>
              <a:buSzPts val="2800"/>
            </a:pPr>
            <a:r>
              <a:rPr lang="en-US" dirty="0"/>
              <a:t>We will ask you to share your thoughts on how you’d respond to each case</a:t>
            </a:r>
          </a:p>
          <a:p>
            <a:pPr marL="685800" lvl="1" indent="-292100">
              <a:spcBef>
                <a:spcPts val="1000"/>
              </a:spcBef>
              <a:buSzPts val="2800"/>
            </a:pPr>
            <a:r>
              <a:rPr lang="en-US" b="1" dirty="0"/>
              <a:t>Virtual participants</a:t>
            </a:r>
            <a:r>
              <a:rPr lang="en-US" dirty="0"/>
              <a:t>: We can pair you up in breakout rooms or have you share thoughts via the chat</a:t>
            </a:r>
          </a:p>
          <a:p>
            <a:pPr marL="457200" lvl="1" indent="0" algn="l" rtl="0">
              <a:lnSpc>
                <a:spcPct val="90000"/>
              </a:lnSpc>
              <a:spcBef>
                <a:spcPts val="1000"/>
              </a:spcBef>
              <a:spcAft>
                <a:spcPts val="0"/>
              </a:spcAft>
              <a:buSzPts val="1800"/>
              <a:buNone/>
            </a:pPr>
            <a:endParaRPr lang="en-US" dirty="0"/>
          </a:p>
          <a:p>
            <a:pPr marL="228600" indent="-228600"/>
            <a:r>
              <a:rPr lang="en-US" dirty="0"/>
              <a:t>A note, these cases are real examples submitted by medicine residents. </a:t>
            </a:r>
          </a:p>
          <a:p>
            <a:pPr marL="228600" indent="-228600"/>
            <a:r>
              <a:rPr lang="en-US" dirty="0"/>
              <a:t>Because we will not be able to address all areas of patient in our time together, we will use common examples experienced in healthcare. </a:t>
            </a:r>
            <a:endParaRPr dirty="0"/>
          </a:p>
        </p:txBody>
      </p:sp>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88">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88">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88">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88">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88">
                                            <p:txEl>
                                              <p:pRg st="5" end="5"/>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188">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8" grpId="0" build="p"/>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gc8450bc072_1_15"/>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dirty="0"/>
              <a:t>Rapid-fire practice – case 1</a:t>
            </a:r>
            <a:endParaRPr dirty="0"/>
          </a:p>
        </p:txBody>
      </p:sp>
      <p:sp>
        <p:nvSpPr>
          <p:cNvPr id="218" name="Google Shape;218;gc8450bc072_1_15"/>
          <p:cNvSpPr txBox="1">
            <a:spLocks noGrp="1"/>
          </p:cNvSpPr>
          <p:nvPr>
            <p:ph type="body" idx="1"/>
          </p:nvPr>
        </p:nvSpPr>
        <p:spPr>
          <a:xfrm>
            <a:off x="838200" y="1825624"/>
            <a:ext cx="10515600" cy="4545195"/>
          </a:xfrm>
          <a:prstGeom prst="rect">
            <a:avLst/>
          </a:prstGeom>
          <a:noFill/>
          <a:ln>
            <a:noFill/>
          </a:ln>
        </p:spPr>
        <p:txBody>
          <a:bodyPr spcFirstLastPara="1" wrap="square" lIns="91425" tIns="45700" rIns="91425" bIns="45700" anchor="t" anchorCtr="0">
            <a:normAutofit/>
          </a:bodyPr>
          <a:lstStyle/>
          <a:p>
            <a:pPr marL="0" lvl="0" indent="0" algn="l" rtl="0">
              <a:lnSpc>
                <a:spcPct val="115000"/>
              </a:lnSpc>
              <a:spcBef>
                <a:spcPts val="0"/>
              </a:spcBef>
              <a:spcAft>
                <a:spcPts val="0"/>
              </a:spcAft>
              <a:buNone/>
            </a:pPr>
            <a:r>
              <a:rPr lang="en-US" dirty="0">
                <a:solidFill>
                  <a:srgbClr val="FFFFFF"/>
                </a:solidFill>
              </a:rPr>
              <a:t>In clinic this morning, you introduce yourself as Dr. Han. Your patient says, "How do you spell that last name? I was at radiology earlier today and had an oriental lady scan me there. Was it you?”</a:t>
            </a:r>
            <a:endParaRPr lang="en-US" sz="2800" dirty="0">
              <a:solidFill>
                <a:schemeClr val="bg1"/>
              </a:solidFill>
              <a:latin typeface="Calibri" panose="020F0502020204030204" pitchFamily="34" charset="0"/>
              <a:cs typeface="Calibri" panose="020F0502020204030204" pitchFamily="34" charset="0"/>
            </a:endParaRPr>
          </a:p>
          <a:p>
            <a:endParaRPr lang="en-US" sz="2800" dirty="0">
              <a:solidFill>
                <a:schemeClr val="bg1"/>
              </a:solidFill>
              <a:latin typeface="Calibri" panose="020F0502020204030204" pitchFamily="34" charset="0"/>
              <a:cs typeface="Calibri" panose="020F0502020204030204" pitchFamily="34" charset="0"/>
            </a:endParaRPr>
          </a:p>
          <a:p>
            <a:pPr marL="342900" indent="-342900">
              <a:buFontTx/>
              <a:buChar char="-"/>
            </a:pPr>
            <a:endParaRPr lang="en-US" sz="2800" dirty="0">
              <a:solidFill>
                <a:schemeClr val="bg1"/>
              </a:solidFill>
              <a:latin typeface="Calibri" panose="020F0502020204030204" pitchFamily="34" charset="0"/>
              <a:cs typeface="Calibri" panose="020F0502020204030204" pitchFamily="34" charset="0"/>
            </a:endParaRPr>
          </a:p>
          <a:p>
            <a:pPr marL="0" lvl="0" indent="0" algn="l" rtl="0">
              <a:lnSpc>
                <a:spcPct val="115000"/>
              </a:lnSpc>
              <a:spcBef>
                <a:spcPts val="0"/>
              </a:spcBef>
              <a:spcAft>
                <a:spcPts val="0"/>
              </a:spcAft>
              <a:buNone/>
            </a:pPr>
            <a:endParaRPr lang="en-US" dirty="0">
              <a:solidFill>
                <a:srgbClr val="FFFFFF"/>
              </a:solidFill>
            </a:endParaRPr>
          </a:p>
          <a:p>
            <a:pPr marL="0" lvl="0" indent="0" algn="l" rtl="0">
              <a:lnSpc>
                <a:spcPct val="115000"/>
              </a:lnSpc>
              <a:spcBef>
                <a:spcPts val="0"/>
              </a:spcBef>
              <a:spcAft>
                <a:spcPts val="0"/>
              </a:spcAft>
              <a:buNone/>
            </a:pPr>
            <a:endParaRPr lang="en-US" dirty="0">
              <a:solidFill>
                <a:srgbClr val="FFFFFF"/>
              </a:solidFill>
            </a:endParaRPr>
          </a:p>
        </p:txBody>
      </p:sp>
    </p:spTree>
    <p:custDataLst>
      <p:tags r:id="rId1"/>
    </p:custData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16">
          <a:extLst>
            <a:ext uri="{FF2B5EF4-FFF2-40B4-BE49-F238E27FC236}">
              <a16:creationId xmlns:a16="http://schemas.microsoft.com/office/drawing/2014/main" id="{57C64264-6F78-F720-42F9-EE579601519E}"/>
            </a:ext>
          </a:extLst>
        </p:cNvPr>
        <p:cNvGrpSpPr/>
        <p:nvPr/>
      </p:nvGrpSpPr>
      <p:grpSpPr>
        <a:xfrm>
          <a:off x="0" y="0"/>
          <a:ext cx="0" cy="0"/>
          <a:chOff x="0" y="0"/>
          <a:chExt cx="0" cy="0"/>
        </a:xfrm>
      </p:grpSpPr>
      <p:sp>
        <p:nvSpPr>
          <p:cNvPr id="217" name="Google Shape;217;gc8450bc072_1_15">
            <a:extLst>
              <a:ext uri="{FF2B5EF4-FFF2-40B4-BE49-F238E27FC236}">
                <a16:creationId xmlns:a16="http://schemas.microsoft.com/office/drawing/2014/main" id="{4ACF0631-A102-3F75-AE42-B21D310CD592}"/>
              </a:ext>
            </a:extLst>
          </p:cNvPr>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dirty="0"/>
              <a:t>Rapid-fire practice – case 1</a:t>
            </a:r>
            <a:endParaRPr dirty="0"/>
          </a:p>
        </p:txBody>
      </p:sp>
      <p:sp>
        <p:nvSpPr>
          <p:cNvPr id="218" name="Google Shape;218;gc8450bc072_1_15">
            <a:extLst>
              <a:ext uri="{FF2B5EF4-FFF2-40B4-BE49-F238E27FC236}">
                <a16:creationId xmlns:a16="http://schemas.microsoft.com/office/drawing/2014/main" id="{28A04DB1-3B0D-9DD3-CD05-F9AA3607A4E9}"/>
              </a:ext>
            </a:extLst>
          </p:cNvPr>
          <p:cNvSpPr txBox="1">
            <a:spLocks noGrp="1"/>
          </p:cNvSpPr>
          <p:nvPr>
            <p:ph type="body" idx="1"/>
          </p:nvPr>
        </p:nvSpPr>
        <p:spPr>
          <a:xfrm>
            <a:off x="838200" y="1825624"/>
            <a:ext cx="10515600" cy="4545195"/>
          </a:xfrm>
          <a:prstGeom prst="rect">
            <a:avLst/>
          </a:prstGeom>
          <a:noFill/>
          <a:ln>
            <a:noFill/>
          </a:ln>
        </p:spPr>
        <p:txBody>
          <a:bodyPr spcFirstLastPara="1" wrap="square" lIns="91425" tIns="45700" rIns="91425" bIns="45700" anchor="t" anchorCtr="0">
            <a:normAutofit fontScale="77500" lnSpcReduction="20000"/>
          </a:bodyPr>
          <a:lstStyle/>
          <a:p>
            <a:pPr marL="0" lvl="0" indent="0" algn="l" rtl="0">
              <a:lnSpc>
                <a:spcPct val="115000"/>
              </a:lnSpc>
              <a:spcBef>
                <a:spcPts val="0"/>
              </a:spcBef>
              <a:spcAft>
                <a:spcPts val="0"/>
              </a:spcAft>
              <a:buNone/>
            </a:pPr>
            <a:r>
              <a:rPr lang="en-US" dirty="0">
                <a:solidFill>
                  <a:srgbClr val="FFFFFF"/>
                </a:solidFill>
              </a:rPr>
              <a:t>In clinic this morning, you introduce yourself as Dr. Han. Your patient says, "How do you spell that last name? I was at radiology earlier today and had an oriental lady scan me there. Was it you?”</a:t>
            </a:r>
          </a:p>
          <a:p>
            <a:pPr marL="0" lvl="0" indent="0" algn="l" rtl="0">
              <a:lnSpc>
                <a:spcPct val="115000"/>
              </a:lnSpc>
              <a:spcBef>
                <a:spcPts val="0"/>
              </a:spcBef>
              <a:spcAft>
                <a:spcPts val="0"/>
              </a:spcAft>
              <a:buNone/>
            </a:pPr>
            <a:endParaRPr lang="en-US" sz="2800" dirty="0">
              <a:solidFill>
                <a:srgbClr val="FFFFFF"/>
              </a:solidFill>
              <a:latin typeface="Calibri" panose="020F0502020204030204" pitchFamily="34" charset="0"/>
              <a:cs typeface="Calibri" panose="020F0502020204030204" pitchFamily="34" charset="0"/>
            </a:endParaRPr>
          </a:p>
          <a:p>
            <a:pPr marL="0" lvl="0" indent="0" algn="l" rtl="0">
              <a:lnSpc>
                <a:spcPct val="115000"/>
              </a:lnSpc>
              <a:spcBef>
                <a:spcPts val="0"/>
              </a:spcBef>
              <a:spcAft>
                <a:spcPts val="0"/>
              </a:spcAft>
              <a:buNone/>
            </a:pPr>
            <a:r>
              <a:rPr lang="en-US" sz="2800" dirty="0">
                <a:solidFill>
                  <a:schemeClr val="bg1"/>
                </a:solidFill>
                <a:latin typeface="Calibri" panose="020F0502020204030204" pitchFamily="34" charset="0"/>
                <a:cs typeface="Calibri" panose="020F0502020204030204" pitchFamily="34" charset="0"/>
              </a:rPr>
              <a:t>Potential Responses:</a:t>
            </a:r>
          </a:p>
          <a:p>
            <a:r>
              <a:rPr lang="en-US" sz="2800" dirty="0">
                <a:solidFill>
                  <a:schemeClr val="bg1"/>
                </a:solidFill>
                <a:latin typeface="Calibri" panose="020F0502020204030204" pitchFamily="34" charset="0"/>
                <a:cs typeface="Calibri" panose="020F0502020204030204" pitchFamily="34" charset="0"/>
              </a:rPr>
              <a:t>“I need to excuse myself and step out for a moment.”</a:t>
            </a:r>
          </a:p>
          <a:p>
            <a:r>
              <a:rPr lang="en-US" sz="2800" dirty="0">
                <a:solidFill>
                  <a:schemeClr val="bg1"/>
                </a:solidFill>
                <a:latin typeface="Calibri" panose="020F0502020204030204" pitchFamily="34" charset="0"/>
                <a:cs typeface="Calibri" panose="020F0502020204030204" pitchFamily="34" charset="0"/>
              </a:rPr>
              <a:t>“No, I am your primary care doctor. You are mistaking me for another staff member.”</a:t>
            </a:r>
          </a:p>
          <a:p>
            <a:r>
              <a:rPr lang="en-US" sz="2800" dirty="0">
                <a:solidFill>
                  <a:schemeClr val="bg1"/>
                </a:solidFill>
                <a:latin typeface="Calibri" panose="020F0502020204030204" pitchFamily="34" charset="0"/>
                <a:cs typeface="Calibri" panose="020F0502020204030204" pitchFamily="34" charset="0"/>
              </a:rPr>
              <a:t>“It is disappointing to be confused with another staff member. I was not in radiology today, but I am your doctor and am here to help you feel better. For the future, I’m from ___ and I prefer ______.”</a:t>
            </a:r>
          </a:p>
          <a:p>
            <a:r>
              <a:rPr lang="en-US" sz="2800" dirty="0">
                <a:solidFill>
                  <a:schemeClr val="bg1"/>
                </a:solidFill>
                <a:latin typeface="Calibri" panose="020F0502020204030204" pitchFamily="34" charset="0"/>
                <a:cs typeface="Calibri" panose="020F0502020204030204" pitchFamily="34" charset="0"/>
              </a:rPr>
              <a:t>“Oriental is a disrespectful term. Please refrain from using it moving forward.” </a:t>
            </a:r>
          </a:p>
          <a:p>
            <a:pPr lvl="1"/>
            <a:r>
              <a:rPr lang="en-US" dirty="0">
                <a:solidFill>
                  <a:schemeClr val="bg1"/>
                </a:solidFill>
                <a:latin typeface="Calibri" panose="020F0502020204030204" pitchFamily="34" charset="0"/>
                <a:cs typeface="Calibri" panose="020F0502020204030204" pitchFamily="34" charset="0"/>
              </a:rPr>
              <a:t>If seeking softened language, consider adding to the beginning of the prior comment, “In case you are not aware…” </a:t>
            </a:r>
            <a:endParaRPr lang="en-US" dirty="0">
              <a:solidFill>
                <a:srgbClr val="FFFFFF"/>
              </a:solidFill>
            </a:endParaRPr>
          </a:p>
        </p:txBody>
      </p:sp>
    </p:spTree>
    <p:custDataLst>
      <p:tags r:id="rId1"/>
    </p:custDataLst>
    <p:extLst>
      <p:ext uri="{BB962C8B-B14F-4D97-AF65-F5344CB8AC3E}">
        <p14:creationId xmlns:p14="http://schemas.microsoft.com/office/powerpoint/2010/main" val="363010948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E4846E8-37BE-28B4-5E71-8AE9B0A23B2E}"/>
            </a:ext>
          </a:extLst>
        </p:cNvPr>
        <p:cNvGrpSpPr/>
        <p:nvPr/>
      </p:nvGrpSpPr>
      <p:grpSpPr>
        <a:xfrm>
          <a:off x="0" y="0"/>
          <a:ext cx="0" cy="0"/>
          <a:chOff x="0" y="0"/>
          <a:chExt cx="0" cy="0"/>
        </a:xfrm>
      </p:grpSpPr>
      <p:sp>
        <p:nvSpPr>
          <p:cNvPr id="4" name="Title 3">
            <a:extLst>
              <a:ext uri="{FF2B5EF4-FFF2-40B4-BE49-F238E27FC236}">
                <a16:creationId xmlns:a16="http://schemas.microsoft.com/office/drawing/2014/main" id="{18BA786E-6EF9-24B3-578F-7A317164CD12}"/>
              </a:ext>
            </a:extLst>
          </p:cNvPr>
          <p:cNvSpPr>
            <a:spLocks noGrp="1"/>
          </p:cNvSpPr>
          <p:nvPr>
            <p:ph type="title"/>
          </p:nvPr>
        </p:nvSpPr>
        <p:spPr/>
        <p:txBody>
          <a:bodyPr/>
          <a:lstStyle/>
          <a:p>
            <a:r>
              <a:rPr lang="en-US" dirty="0"/>
              <a:t>Rapid-fire practice – case 2</a:t>
            </a:r>
          </a:p>
        </p:txBody>
      </p:sp>
      <p:sp>
        <p:nvSpPr>
          <p:cNvPr id="5" name="Text Placeholder 4">
            <a:extLst>
              <a:ext uri="{FF2B5EF4-FFF2-40B4-BE49-F238E27FC236}">
                <a16:creationId xmlns:a16="http://schemas.microsoft.com/office/drawing/2014/main" id="{F6E05398-C94A-EF33-D545-8A4E62E934B9}"/>
              </a:ext>
            </a:extLst>
          </p:cNvPr>
          <p:cNvSpPr>
            <a:spLocks noGrp="1"/>
          </p:cNvSpPr>
          <p:nvPr>
            <p:ph type="body" idx="1"/>
          </p:nvPr>
        </p:nvSpPr>
        <p:spPr>
          <a:xfrm>
            <a:off x="838200" y="1825625"/>
            <a:ext cx="10515600" cy="4667250"/>
          </a:xfrm>
        </p:spPr>
        <p:txBody>
          <a:bodyPr>
            <a:normAutofit/>
          </a:bodyPr>
          <a:lstStyle/>
          <a:p>
            <a:pPr marL="0" indent="0">
              <a:buNone/>
            </a:pPr>
            <a:r>
              <a:rPr lang="en-US" i="1" dirty="0"/>
              <a:t>In this case, the senior resident is Black. </a:t>
            </a:r>
          </a:p>
          <a:p>
            <a:pPr marL="0" indent="0">
              <a:buNone/>
            </a:pPr>
            <a:r>
              <a:rPr lang="en-US" dirty="0"/>
              <a:t>You go with your senior resident and attending to present your new patient at bedside. After you lead the interview and exam, you explain the next step is a CT scan. You get ready to leave the room when the patient turns to the senior resident and asks, “Oh, are you here to take me to CT scan?”</a:t>
            </a:r>
          </a:p>
          <a:p>
            <a:endParaRPr lang="en-US" dirty="0">
              <a:solidFill>
                <a:schemeClr val="bg1"/>
              </a:solidFill>
              <a:latin typeface="Calibri" panose="020F0502020204030204" pitchFamily="34" charset="0"/>
              <a:cs typeface="Calibri" panose="020F0502020204030204" pitchFamily="34" charset="0"/>
            </a:endParaRPr>
          </a:p>
          <a:p>
            <a:pPr marL="0" indent="0">
              <a:buNone/>
            </a:pPr>
            <a:endParaRPr lang="en-US" dirty="0"/>
          </a:p>
        </p:txBody>
      </p:sp>
    </p:spTree>
    <p:extLst>
      <p:ext uri="{BB962C8B-B14F-4D97-AF65-F5344CB8AC3E}">
        <p14:creationId xmlns:p14="http://schemas.microsoft.com/office/powerpoint/2010/main" val="251381965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Rapid-fire practice – case 2</a:t>
            </a:r>
          </a:p>
        </p:txBody>
      </p:sp>
      <p:sp>
        <p:nvSpPr>
          <p:cNvPr id="5" name="Text Placeholder 4"/>
          <p:cNvSpPr>
            <a:spLocks noGrp="1"/>
          </p:cNvSpPr>
          <p:nvPr>
            <p:ph type="body" idx="1"/>
          </p:nvPr>
        </p:nvSpPr>
        <p:spPr>
          <a:xfrm>
            <a:off x="838200" y="1825625"/>
            <a:ext cx="10515600" cy="4667250"/>
          </a:xfrm>
        </p:spPr>
        <p:txBody>
          <a:bodyPr>
            <a:normAutofit fontScale="92500" lnSpcReduction="10000"/>
          </a:bodyPr>
          <a:lstStyle/>
          <a:p>
            <a:pPr marL="0" indent="0">
              <a:buNone/>
            </a:pPr>
            <a:r>
              <a:rPr lang="en-US" i="1" dirty="0"/>
              <a:t>In this case, the senior resident is Black. </a:t>
            </a:r>
          </a:p>
          <a:p>
            <a:pPr marL="0" indent="0">
              <a:buNone/>
            </a:pPr>
            <a:r>
              <a:rPr lang="en-US" dirty="0"/>
              <a:t>You go with your senior resident and attending to present your new patient at bedside. After you lead the interview and exam, you explain the next step is a CT scan. You get ready to leave the room when the patient turns to the senior resident and asks, “Oh, are you here to take me to CT scan?”</a:t>
            </a:r>
          </a:p>
          <a:p>
            <a:pPr marL="0" indent="0">
              <a:buNone/>
            </a:pPr>
            <a:endParaRPr lang="en-US" dirty="0">
              <a:solidFill>
                <a:schemeClr val="bg1"/>
              </a:solidFill>
              <a:latin typeface="Calibri" panose="020F0502020204030204" pitchFamily="34" charset="0"/>
              <a:cs typeface="Calibri" panose="020F0502020204030204" pitchFamily="34" charset="0"/>
            </a:endParaRPr>
          </a:p>
          <a:p>
            <a:pPr marL="0" indent="0">
              <a:buNone/>
            </a:pPr>
            <a:r>
              <a:rPr lang="en-US" dirty="0">
                <a:solidFill>
                  <a:schemeClr val="bg1"/>
                </a:solidFill>
                <a:latin typeface="Calibri" panose="020F0502020204030204" pitchFamily="34" charset="0"/>
                <a:cs typeface="Calibri" panose="020F0502020204030204" pitchFamily="34" charset="0"/>
              </a:rPr>
              <a:t>Potential Responses:</a:t>
            </a:r>
          </a:p>
          <a:p>
            <a:r>
              <a:rPr lang="en-US" dirty="0">
                <a:solidFill>
                  <a:schemeClr val="bg1"/>
                </a:solidFill>
                <a:latin typeface="Calibri" panose="020F0502020204030204" pitchFamily="34" charset="0"/>
                <a:cs typeface="Calibri" panose="020F0502020204030204" pitchFamily="34" charset="0"/>
              </a:rPr>
              <a:t>“I think you’ve mistaken my role. I’m Dr. ___ and the leader of the resident team.”</a:t>
            </a:r>
          </a:p>
          <a:p>
            <a:r>
              <a:rPr lang="en-US" dirty="0">
                <a:solidFill>
                  <a:schemeClr val="bg1"/>
                </a:solidFill>
                <a:latin typeface="Calibri" panose="020F0502020204030204" pitchFamily="34" charset="0"/>
                <a:cs typeface="Calibri" panose="020F0502020204030204" pitchFamily="34" charset="0"/>
              </a:rPr>
              <a:t>“Dr. ___ is actually our team leader. In the future, everyone’s badge has a colorful tag on it to help identify who they are and how they fit into your care. Someone from the transport team will bring you to CT.”</a:t>
            </a:r>
          </a:p>
          <a:p>
            <a:endParaRPr lang="en-US" dirty="0">
              <a:solidFill>
                <a:schemeClr val="bg1"/>
              </a:solidFill>
              <a:latin typeface="Calibri" panose="020F0502020204030204" pitchFamily="34" charset="0"/>
              <a:cs typeface="Calibri" panose="020F0502020204030204" pitchFamily="34" charset="0"/>
            </a:endParaRPr>
          </a:p>
          <a:p>
            <a:pPr marL="0" indent="0">
              <a:buNone/>
            </a:pPr>
            <a:endParaRPr lang="en-US" dirty="0"/>
          </a:p>
        </p:txBody>
      </p:sp>
    </p:spTree>
    <p:extLst>
      <p:ext uri="{BB962C8B-B14F-4D97-AF65-F5344CB8AC3E}">
        <p14:creationId xmlns:p14="http://schemas.microsoft.com/office/powerpoint/2010/main" val="3120351385"/>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240">
          <a:extLst>
            <a:ext uri="{FF2B5EF4-FFF2-40B4-BE49-F238E27FC236}">
              <a16:creationId xmlns:a16="http://schemas.microsoft.com/office/drawing/2014/main" id="{2064C2B0-BA7C-6797-9430-AD8CAE68DF4F}"/>
            </a:ext>
          </a:extLst>
        </p:cNvPr>
        <p:cNvGrpSpPr/>
        <p:nvPr/>
      </p:nvGrpSpPr>
      <p:grpSpPr>
        <a:xfrm>
          <a:off x="0" y="0"/>
          <a:ext cx="0" cy="0"/>
          <a:chOff x="0" y="0"/>
          <a:chExt cx="0" cy="0"/>
        </a:xfrm>
      </p:grpSpPr>
      <p:sp>
        <p:nvSpPr>
          <p:cNvPr id="241" name="Google Shape;241;gc8450bc072_1_35">
            <a:extLst>
              <a:ext uri="{FF2B5EF4-FFF2-40B4-BE49-F238E27FC236}">
                <a16:creationId xmlns:a16="http://schemas.microsoft.com/office/drawing/2014/main" id="{94300E6A-F545-EBB2-4CD6-084CE962B9ED}"/>
              </a:ext>
            </a:extLst>
          </p:cNvPr>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dirty="0"/>
              <a:t>Rapid-fire practice – case 3</a:t>
            </a:r>
            <a:endParaRPr dirty="0"/>
          </a:p>
        </p:txBody>
      </p:sp>
      <p:sp>
        <p:nvSpPr>
          <p:cNvPr id="242" name="Google Shape;242;gc8450bc072_1_35">
            <a:extLst>
              <a:ext uri="{FF2B5EF4-FFF2-40B4-BE49-F238E27FC236}">
                <a16:creationId xmlns:a16="http://schemas.microsoft.com/office/drawing/2014/main" id="{D5111365-E962-B889-D48F-8ADE010AF7BB}"/>
              </a:ext>
            </a:extLst>
          </p:cNvPr>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0" lvl="0" indent="0" algn="l" rtl="0">
              <a:lnSpc>
                <a:spcPct val="115000"/>
              </a:lnSpc>
              <a:spcBef>
                <a:spcPts val="0"/>
              </a:spcBef>
              <a:spcAft>
                <a:spcPts val="0"/>
              </a:spcAft>
              <a:buNone/>
            </a:pPr>
            <a:r>
              <a:rPr lang="en-US" dirty="0">
                <a:solidFill>
                  <a:srgbClr val="FFFFFF"/>
                </a:solidFill>
              </a:rPr>
              <a:t>You are the senior resident and only female on the team during CCU morning rounds. As the team is leaving the room after examining the patient, the patient says, “Oh sweetheart? Could you get me another Ginger Ale?”</a:t>
            </a:r>
          </a:p>
        </p:txBody>
      </p:sp>
    </p:spTree>
    <p:custDataLst>
      <p:tags r:id="rId1"/>
    </p:custDataLst>
    <p:extLst>
      <p:ext uri="{BB962C8B-B14F-4D97-AF65-F5344CB8AC3E}">
        <p14:creationId xmlns:p14="http://schemas.microsoft.com/office/powerpoint/2010/main" val="1623538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15"/>
        <p:cNvGrpSpPr/>
        <p:nvPr/>
      </p:nvGrpSpPr>
      <p:grpSpPr>
        <a:xfrm>
          <a:off x="0" y="0"/>
          <a:ext cx="0" cy="0"/>
          <a:chOff x="0" y="0"/>
          <a:chExt cx="0" cy="0"/>
        </a:xfrm>
      </p:grpSpPr>
      <p:sp>
        <p:nvSpPr>
          <p:cNvPr id="116" name="Google Shape;116;p3"/>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a:t>Objectives</a:t>
            </a:r>
            <a:endParaRPr/>
          </a:p>
        </p:txBody>
      </p:sp>
      <p:sp>
        <p:nvSpPr>
          <p:cNvPr id="117" name="Google Shape;117;p3"/>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lt1"/>
              </a:buClr>
              <a:buSzPts val="2800"/>
              <a:buChar char="•"/>
            </a:pPr>
            <a:r>
              <a:rPr lang="en-US" dirty="0"/>
              <a:t>Create a safe space to discuss a critical topic</a:t>
            </a:r>
            <a:endParaRPr dirty="0"/>
          </a:p>
          <a:p>
            <a:pPr marL="228600" lvl="0" indent="-228600" algn="l" rtl="0">
              <a:lnSpc>
                <a:spcPct val="90000"/>
              </a:lnSpc>
              <a:spcBef>
                <a:spcPts val="1000"/>
              </a:spcBef>
              <a:spcAft>
                <a:spcPts val="0"/>
              </a:spcAft>
              <a:buClr>
                <a:schemeClr val="lt1"/>
              </a:buClr>
              <a:buSzPts val="2800"/>
              <a:buChar char="•"/>
            </a:pPr>
            <a:r>
              <a:rPr lang="en-US" dirty="0"/>
              <a:t>Recognize examples of bias in clinical encounters</a:t>
            </a:r>
            <a:endParaRPr dirty="0"/>
          </a:p>
          <a:p>
            <a:pPr marL="228600" lvl="0" indent="-228600" algn="l" rtl="0">
              <a:lnSpc>
                <a:spcPct val="90000"/>
              </a:lnSpc>
              <a:spcBef>
                <a:spcPts val="1000"/>
              </a:spcBef>
              <a:spcAft>
                <a:spcPts val="0"/>
              </a:spcAft>
              <a:buClr>
                <a:schemeClr val="lt1"/>
              </a:buClr>
              <a:buSzPts val="2800"/>
              <a:buChar char="•"/>
            </a:pPr>
            <a:r>
              <a:rPr lang="en-US" dirty="0"/>
              <a:t>Develop a personal toolkit to </a:t>
            </a:r>
            <a:r>
              <a:rPr lang="en-US" dirty="0">
                <a:latin typeface="Calibri" panose="020F0502020204030204" pitchFamily="34" charset="0"/>
                <a:cs typeface="Calibri" panose="020F0502020204030204" pitchFamily="34" charset="0"/>
              </a:rPr>
              <a:t>respond to </a:t>
            </a:r>
            <a:r>
              <a:rPr lang="en-US" altLang="x-none" kern="1200" baseline="0" dirty="0">
                <a:solidFill>
                  <a:schemeClr val="bg1"/>
                </a:solidFill>
                <a:latin typeface="Calibri" panose="020F0502020204030204" pitchFamily="34" charset="0"/>
                <a:ea typeface="+mn-ea"/>
                <a:cs typeface="Calibri" panose="020F0502020204030204" pitchFamily="34" charset="0"/>
              </a:rPr>
              <a:t>patient-expressed bias-towards-self and bias-towards-others</a:t>
            </a:r>
          </a:p>
          <a:p>
            <a:pPr marL="0" lvl="0" indent="0" algn="l" rtl="0">
              <a:lnSpc>
                <a:spcPct val="90000"/>
              </a:lnSpc>
              <a:spcBef>
                <a:spcPts val="1000"/>
              </a:spcBef>
              <a:spcAft>
                <a:spcPts val="0"/>
              </a:spcAft>
              <a:buClr>
                <a:schemeClr val="lt1"/>
              </a:buClr>
              <a:buSzPts val="2800"/>
              <a:buNone/>
            </a:pPr>
            <a:endParaRPr lang="en-US" dirty="0">
              <a:solidFill>
                <a:schemeClr val="bg1"/>
              </a:solidFill>
              <a:latin typeface="Calibri" panose="020F0502020204030204" pitchFamily="34" charset="0"/>
              <a:cs typeface="Calibri" panose="020F0502020204030204" pitchFamily="34" charset="0"/>
            </a:endParaRPr>
          </a:p>
          <a:p>
            <a:pPr marL="0" lvl="0" indent="0" algn="l" rtl="0">
              <a:lnSpc>
                <a:spcPct val="90000"/>
              </a:lnSpc>
              <a:spcBef>
                <a:spcPts val="1000"/>
              </a:spcBef>
              <a:spcAft>
                <a:spcPts val="0"/>
              </a:spcAft>
              <a:buClr>
                <a:schemeClr val="lt1"/>
              </a:buClr>
              <a:buSzPts val="2800"/>
              <a:buNone/>
            </a:pPr>
            <a:r>
              <a:rPr lang="en-US" i="1" dirty="0"/>
              <a:t>Virtual participant etiquette:</a:t>
            </a:r>
          </a:p>
          <a:p>
            <a:pPr marL="228600" lvl="0" indent="-228600" algn="l" rtl="0">
              <a:lnSpc>
                <a:spcPct val="90000"/>
              </a:lnSpc>
              <a:spcBef>
                <a:spcPts val="1000"/>
              </a:spcBef>
              <a:spcAft>
                <a:spcPts val="0"/>
              </a:spcAft>
              <a:buClr>
                <a:schemeClr val="lt1"/>
              </a:buClr>
              <a:buSzPts val="2800"/>
              <a:buChar char="•"/>
            </a:pPr>
            <a:r>
              <a:rPr lang="en-US" dirty="0"/>
              <a:t>Use the hand raise function</a:t>
            </a:r>
          </a:p>
          <a:p>
            <a:pPr marL="228600" lvl="0" indent="-228600" algn="l" rtl="0">
              <a:lnSpc>
                <a:spcPct val="90000"/>
              </a:lnSpc>
              <a:spcBef>
                <a:spcPts val="1000"/>
              </a:spcBef>
              <a:spcAft>
                <a:spcPts val="0"/>
              </a:spcAft>
              <a:buClr>
                <a:schemeClr val="lt1"/>
              </a:buClr>
              <a:buSzPts val="2800"/>
              <a:buChar char="•"/>
            </a:pPr>
            <a:r>
              <a:rPr lang="en-US" dirty="0"/>
              <a:t>Remain in gallery view</a:t>
            </a:r>
          </a:p>
          <a:p>
            <a:pPr marL="228600" lvl="0" indent="-228600" algn="l" rtl="0">
              <a:lnSpc>
                <a:spcPct val="90000"/>
              </a:lnSpc>
              <a:spcBef>
                <a:spcPts val="1000"/>
              </a:spcBef>
              <a:spcAft>
                <a:spcPts val="0"/>
              </a:spcAft>
              <a:buClr>
                <a:schemeClr val="lt1"/>
              </a:buClr>
              <a:buSzPts val="2800"/>
              <a:buChar char="•"/>
            </a:pPr>
            <a:endParaRPr dirty="0"/>
          </a:p>
          <a:p>
            <a:pPr marL="685800" lvl="1" indent="-76200" algn="l" rtl="0">
              <a:lnSpc>
                <a:spcPct val="90000"/>
              </a:lnSpc>
              <a:spcBef>
                <a:spcPts val="500"/>
              </a:spcBef>
              <a:spcAft>
                <a:spcPts val="0"/>
              </a:spcAft>
              <a:buClr>
                <a:schemeClr val="lt1"/>
              </a:buClr>
              <a:buSzPts val="2400"/>
              <a:buNone/>
            </a:pPr>
            <a:endParaRPr dirty="0"/>
          </a:p>
        </p:txBody>
      </p:sp>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1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17">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17">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17">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17">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117">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7" grpId="0" build="p"/>
    </p:bld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240"/>
        <p:cNvGrpSpPr/>
        <p:nvPr/>
      </p:nvGrpSpPr>
      <p:grpSpPr>
        <a:xfrm>
          <a:off x="0" y="0"/>
          <a:ext cx="0" cy="0"/>
          <a:chOff x="0" y="0"/>
          <a:chExt cx="0" cy="0"/>
        </a:xfrm>
      </p:grpSpPr>
      <p:sp>
        <p:nvSpPr>
          <p:cNvPr id="241" name="Google Shape;241;gc8450bc072_1_35"/>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dirty="0"/>
              <a:t>Rapid-fire practice – case 3</a:t>
            </a:r>
            <a:endParaRPr dirty="0"/>
          </a:p>
        </p:txBody>
      </p:sp>
      <p:sp>
        <p:nvSpPr>
          <p:cNvPr id="242" name="Google Shape;242;gc8450bc072_1_35"/>
          <p:cNvSpPr txBox="1">
            <a:spLocks noGrp="1"/>
          </p:cNvSpPr>
          <p:nvPr>
            <p:ph type="body" idx="1"/>
          </p:nvPr>
        </p:nvSpPr>
        <p:spPr>
          <a:prstGeom prst="rect">
            <a:avLst/>
          </a:prstGeom>
          <a:noFill/>
          <a:ln>
            <a:noFill/>
          </a:ln>
        </p:spPr>
        <p:txBody>
          <a:bodyPr spcFirstLastPara="1" wrap="square" lIns="91425" tIns="45700" rIns="91425" bIns="45700" anchor="t" anchorCtr="0">
            <a:normAutofit fontScale="77500" lnSpcReduction="20000"/>
          </a:bodyPr>
          <a:lstStyle/>
          <a:p>
            <a:pPr marL="0" lvl="0" indent="0" algn="l" rtl="0">
              <a:lnSpc>
                <a:spcPct val="115000"/>
              </a:lnSpc>
              <a:spcBef>
                <a:spcPts val="0"/>
              </a:spcBef>
              <a:spcAft>
                <a:spcPts val="0"/>
              </a:spcAft>
              <a:buNone/>
            </a:pPr>
            <a:r>
              <a:rPr lang="en-US" dirty="0">
                <a:solidFill>
                  <a:srgbClr val="FFFFFF"/>
                </a:solidFill>
              </a:rPr>
              <a:t>You are the senior resident and only female on the team during CCU morning rounds. As the team is leaving the room after examining the patient, the patient says, “Oh sweetheart? Could you get me another Ginger Ale?”</a:t>
            </a:r>
          </a:p>
          <a:p>
            <a:pPr marL="0" lvl="0" indent="0" algn="l" rtl="0">
              <a:lnSpc>
                <a:spcPct val="115000"/>
              </a:lnSpc>
              <a:spcBef>
                <a:spcPts val="0"/>
              </a:spcBef>
              <a:spcAft>
                <a:spcPts val="0"/>
              </a:spcAft>
              <a:buNone/>
            </a:pPr>
            <a:endParaRPr lang="en-US" sz="2800" dirty="0">
              <a:solidFill>
                <a:schemeClr val="bg1"/>
              </a:solidFill>
              <a:latin typeface="Calibri" panose="020F0502020204030204" pitchFamily="34" charset="0"/>
              <a:cs typeface="Calibri" panose="020F0502020204030204" pitchFamily="34" charset="0"/>
            </a:endParaRPr>
          </a:p>
          <a:p>
            <a:pPr marL="0" lvl="0" indent="0" algn="l" rtl="0">
              <a:lnSpc>
                <a:spcPct val="115000"/>
              </a:lnSpc>
              <a:spcBef>
                <a:spcPts val="0"/>
              </a:spcBef>
              <a:spcAft>
                <a:spcPts val="0"/>
              </a:spcAft>
              <a:buNone/>
            </a:pPr>
            <a:r>
              <a:rPr lang="en-US" sz="2800" dirty="0">
                <a:solidFill>
                  <a:schemeClr val="bg1"/>
                </a:solidFill>
                <a:latin typeface="Calibri" panose="020F0502020204030204" pitchFamily="34" charset="0"/>
                <a:cs typeface="Calibri" panose="020F0502020204030204" pitchFamily="34" charset="0"/>
              </a:rPr>
              <a:t>Potential Responses:</a:t>
            </a:r>
          </a:p>
          <a:p>
            <a:r>
              <a:rPr lang="en-US" sz="2800" dirty="0">
                <a:solidFill>
                  <a:schemeClr val="bg1"/>
                </a:solidFill>
                <a:latin typeface="Calibri" panose="020F0502020204030204" pitchFamily="34" charset="0"/>
                <a:cs typeface="Calibri" panose="020F0502020204030204" pitchFamily="34" charset="0"/>
              </a:rPr>
              <a:t>“I’m one of your physicians and we are still seeing patients. Can you hit your call light to ask </a:t>
            </a:r>
            <a:r>
              <a:rPr lang="en-US" dirty="0">
                <a:solidFill>
                  <a:schemeClr val="bg1"/>
                </a:solidFill>
                <a:latin typeface="Calibri" panose="020F0502020204030204" pitchFamily="34" charset="0"/>
                <a:cs typeface="Calibri" panose="020F0502020204030204" pitchFamily="34" charset="0"/>
              </a:rPr>
              <a:t>another member of the team </a:t>
            </a:r>
            <a:r>
              <a:rPr lang="en-US" sz="2800" dirty="0">
                <a:solidFill>
                  <a:schemeClr val="bg1"/>
                </a:solidFill>
                <a:latin typeface="Calibri" panose="020F0502020204030204" pitchFamily="34" charset="0"/>
                <a:cs typeface="Calibri" panose="020F0502020204030204" pitchFamily="34" charset="0"/>
              </a:rPr>
              <a:t>for help?”</a:t>
            </a:r>
          </a:p>
          <a:p>
            <a:r>
              <a:rPr lang="en-US" sz="2800" dirty="0">
                <a:solidFill>
                  <a:schemeClr val="bg1"/>
                </a:solidFill>
                <a:latin typeface="Calibri" panose="020F0502020204030204" pitchFamily="34" charset="0"/>
                <a:cs typeface="Calibri" panose="020F0502020204030204" pitchFamily="34" charset="0"/>
              </a:rPr>
              <a:t>“I can grab you a ginger ale. In the future, I’d prefer if you called me Dr._____ or _____ instead of sweetheart.”</a:t>
            </a:r>
          </a:p>
          <a:p>
            <a:r>
              <a:rPr lang="en-US" sz="2800" dirty="0">
                <a:solidFill>
                  <a:schemeClr val="bg1"/>
                </a:solidFill>
                <a:latin typeface="Calibri" panose="020F0502020204030204" pitchFamily="34" charset="0"/>
                <a:cs typeface="Calibri" panose="020F0502020204030204" pitchFamily="34" charset="0"/>
              </a:rPr>
              <a:t>“Oh, Dr. ___ needs to see our next patient. I’ll step out and grab you a ginger ale.”</a:t>
            </a:r>
          </a:p>
          <a:p>
            <a:r>
              <a:rPr lang="en-US" sz="2800" dirty="0">
                <a:solidFill>
                  <a:schemeClr val="bg1"/>
                </a:solidFill>
                <a:latin typeface="Calibri" panose="020F0502020204030204" pitchFamily="34" charset="0"/>
                <a:cs typeface="Calibri" panose="020F0502020204030204" pitchFamily="34" charset="0"/>
              </a:rPr>
              <a:t>“Dr. ___ needs to continue leading the team. We’ll grab a nurse/PCA/other provider on our way to see the next patient.”</a:t>
            </a:r>
            <a:endParaRPr dirty="0">
              <a:solidFill>
                <a:srgbClr val="FFFFFF"/>
              </a:solidFill>
            </a:endParaRPr>
          </a:p>
        </p:txBody>
      </p:sp>
    </p:spTree>
    <p:custDataLst>
      <p:tags r:id="rId1"/>
    </p:custData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sp>
        <p:nvSpPr>
          <p:cNvPr id="254" name="Google Shape;254;p30"/>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dirty="0"/>
              <a:t>Never Worry Alone</a:t>
            </a:r>
            <a:endParaRPr dirty="0"/>
          </a:p>
        </p:txBody>
      </p:sp>
      <p:sp>
        <p:nvSpPr>
          <p:cNvPr id="255" name="Google Shape;255;p30"/>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lt1"/>
              </a:buClr>
              <a:buSzPts val="2800"/>
              <a:buChar char="•"/>
            </a:pPr>
            <a:r>
              <a:rPr lang="en-US" b="1" dirty="0"/>
              <a:t>Do not internalize or bury your experience</a:t>
            </a:r>
            <a:endParaRPr dirty="0"/>
          </a:p>
          <a:p>
            <a:pPr marL="228600" lvl="0" indent="-228600" algn="l" rtl="0">
              <a:lnSpc>
                <a:spcPct val="90000"/>
              </a:lnSpc>
              <a:spcBef>
                <a:spcPts val="1000"/>
              </a:spcBef>
              <a:spcAft>
                <a:spcPts val="0"/>
              </a:spcAft>
              <a:buClr>
                <a:schemeClr val="lt1"/>
              </a:buClr>
              <a:buSzPts val="2800"/>
              <a:buChar char="•"/>
            </a:pPr>
            <a:r>
              <a:rPr lang="en-US" dirty="0"/>
              <a:t>Find support!</a:t>
            </a:r>
            <a:endParaRPr dirty="0"/>
          </a:p>
        </p:txBody>
      </p:sp>
    </p:spTree>
    <p:custDataLst>
      <p:tags r:id="rId1"/>
    </p:custData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sp>
        <p:nvSpPr>
          <p:cNvPr id="254" name="Google Shape;254;p30"/>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dirty="0"/>
              <a:t>Outpatient resources</a:t>
            </a:r>
            <a:endParaRPr dirty="0"/>
          </a:p>
        </p:txBody>
      </p:sp>
      <p:sp>
        <p:nvSpPr>
          <p:cNvPr id="255" name="Google Shape;255;p30"/>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lt1"/>
              </a:buClr>
              <a:buSzPts val="2800"/>
              <a:buChar char="•"/>
            </a:pPr>
            <a:r>
              <a:rPr lang="en-US" dirty="0"/>
              <a:t>List your hospital escalation policy in the outpatient setting here</a:t>
            </a:r>
          </a:p>
          <a:p>
            <a:pPr marL="228600" lvl="0" indent="-228600" algn="l" rtl="0">
              <a:lnSpc>
                <a:spcPct val="90000"/>
              </a:lnSpc>
              <a:spcBef>
                <a:spcPts val="0"/>
              </a:spcBef>
              <a:spcAft>
                <a:spcPts val="0"/>
              </a:spcAft>
              <a:buClr>
                <a:schemeClr val="lt1"/>
              </a:buClr>
              <a:buSzPts val="2800"/>
              <a:buChar char="•"/>
            </a:pPr>
            <a:r>
              <a:rPr lang="en-US" dirty="0"/>
              <a:t>List your outpatient program leadership and staff leadership</a:t>
            </a:r>
          </a:p>
        </p:txBody>
      </p:sp>
    </p:spTree>
    <p:custDataLst>
      <p:tags r:id="rId1"/>
    </p:custDataLst>
    <p:extLst>
      <p:ext uri="{BB962C8B-B14F-4D97-AF65-F5344CB8AC3E}">
        <p14:creationId xmlns:p14="http://schemas.microsoft.com/office/powerpoint/2010/main" val="442498338"/>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sp>
        <p:nvSpPr>
          <p:cNvPr id="254" name="Google Shape;254;p30"/>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dirty="0"/>
              <a:t>Inpatient resources</a:t>
            </a:r>
            <a:endParaRPr dirty="0"/>
          </a:p>
        </p:txBody>
      </p:sp>
      <p:sp>
        <p:nvSpPr>
          <p:cNvPr id="255" name="Google Shape;255;p30"/>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lt1"/>
              </a:buClr>
              <a:buSzPts val="2800"/>
              <a:buChar char="•"/>
            </a:pPr>
            <a:r>
              <a:rPr lang="en-US" dirty="0"/>
              <a:t>List your hospital escalation policy in the inpatient setting here</a:t>
            </a:r>
          </a:p>
          <a:p>
            <a:pPr marL="228600" lvl="0" indent="-228600" algn="l" rtl="0">
              <a:lnSpc>
                <a:spcPct val="90000"/>
              </a:lnSpc>
              <a:spcBef>
                <a:spcPts val="0"/>
              </a:spcBef>
              <a:spcAft>
                <a:spcPts val="0"/>
              </a:spcAft>
              <a:buClr>
                <a:schemeClr val="lt1"/>
              </a:buClr>
              <a:buSzPts val="2800"/>
              <a:buChar char="•"/>
            </a:pPr>
            <a:r>
              <a:rPr lang="en-US" dirty="0"/>
              <a:t>List your inpatient program leadership and staff leadership</a:t>
            </a:r>
          </a:p>
        </p:txBody>
      </p:sp>
    </p:spTree>
    <p:custDataLst>
      <p:tags r:id="rId1"/>
    </p:custDataLst>
    <p:extLst>
      <p:ext uri="{BB962C8B-B14F-4D97-AF65-F5344CB8AC3E}">
        <p14:creationId xmlns:p14="http://schemas.microsoft.com/office/powerpoint/2010/main" val="1296220311"/>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sp>
        <p:nvSpPr>
          <p:cNvPr id="301" name="Google Shape;301;gc99f4350b8_0_0"/>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a:t>Post-workshop survey</a:t>
            </a:r>
            <a:endParaRPr/>
          </a:p>
        </p:txBody>
      </p:sp>
      <p:sp>
        <p:nvSpPr>
          <p:cNvPr id="303" name="Google Shape;303;gc99f4350b8_0_0"/>
          <p:cNvSpPr txBox="1"/>
          <p:nvPr/>
        </p:nvSpPr>
        <p:spPr>
          <a:xfrm>
            <a:off x="6281530" y="1073426"/>
            <a:ext cx="184800" cy="3693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lt1"/>
              </a:solidFill>
              <a:latin typeface="Calibri"/>
              <a:ea typeface="Calibri"/>
              <a:cs typeface="Calibri"/>
              <a:sym typeface="Calibri"/>
            </a:endParaRPr>
          </a:p>
        </p:txBody>
      </p:sp>
      <p:sp>
        <p:nvSpPr>
          <p:cNvPr id="3" name="Rectangle 2">
            <a:extLst>
              <a:ext uri="{FF2B5EF4-FFF2-40B4-BE49-F238E27FC236}">
                <a16:creationId xmlns:a16="http://schemas.microsoft.com/office/drawing/2014/main" id="{754C13B5-5A18-2E91-B6A8-FEC0A7A27AA2}"/>
              </a:ext>
            </a:extLst>
          </p:cNvPr>
          <p:cNvSpPr/>
          <p:nvPr/>
        </p:nvSpPr>
        <p:spPr>
          <a:xfrm>
            <a:off x="3957575" y="1708712"/>
            <a:ext cx="4276845" cy="3440575"/>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latin typeface="Calibri" panose="020F0502020204030204" pitchFamily="34" charset="0"/>
                <a:cs typeface="Calibri" panose="020F0502020204030204" pitchFamily="34" charset="0"/>
              </a:rPr>
              <a:t>QR Code for Polling Software Included Here</a:t>
            </a:r>
          </a:p>
        </p:txBody>
      </p:sp>
      <p:sp>
        <p:nvSpPr>
          <p:cNvPr id="4" name="Google Shape;123;p4">
            <a:extLst>
              <a:ext uri="{FF2B5EF4-FFF2-40B4-BE49-F238E27FC236}">
                <a16:creationId xmlns:a16="http://schemas.microsoft.com/office/drawing/2014/main" id="{0DFB941A-EBE9-6FED-120E-3FC6DDA18B28}"/>
              </a:ext>
            </a:extLst>
          </p:cNvPr>
          <p:cNvSpPr txBox="1"/>
          <p:nvPr/>
        </p:nvSpPr>
        <p:spPr>
          <a:xfrm>
            <a:off x="4044297" y="5784574"/>
            <a:ext cx="4103400" cy="369300"/>
          </a:xfrm>
          <a:prstGeom prst="rect">
            <a:avLst/>
          </a:prstGeom>
          <a:noFill/>
          <a:ln>
            <a:noFill/>
          </a:ln>
        </p:spPr>
        <p:txBody>
          <a:bodyPr spcFirstLastPara="1" wrap="square" lIns="91425" tIns="45700" rIns="91425" bIns="45700" anchor="t" anchorCtr="0">
            <a:spAutoFit/>
          </a:bodyPr>
          <a:lstStyle/>
          <a:p>
            <a:pPr lvl="0" algn="ctr"/>
            <a:r>
              <a:rPr lang="en-US" sz="1800" dirty="0">
                <a:solidFill>
                  <a:schemeClr val="lt1"/>
                </a:solidFill>
                <a:latin typeface="Calibri"/>
                <a:ea typeface="Calibri"/>
                <a:cs typeface="Calibri"/>
                <a:sym typeface="Calibri"/>
              </a:rPr>
              <a:t>(Link to Polling Software Included Here)</a:t>
            </a:r>
            <a:endParaRPr dirty="0"/>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310"/>
        <p:cNvGrpSpPr/>
        <p:nvPr/>
      </p:nvGrpSpPr>
      <p:grpSpPr>
        <a:xfrm>
          <a:off x="0" y="0"/>
          <a:ext cx="0" cy="0"/>
          <a:chOff x="0" y="0"/>
          <a:chExt cx="0" cy="0"/>
        </a:xfrm>
      </p:grpSpPr>
      <p:sp>
        <p:nvSpPr>
          <p:cNvPr id="311" name="Google Shape;311;p35"/>
          <p:cNvSpPr txBox="1">
            <a:spLocks noGrp="1"/>
          </p:cNvSpPr>
          <p:nvPr>
            <p:ph type="ctrTitle"/>
          </p:nvPr>
        </p:nvSpPr>
        <p:spPr>
          <a:xfrm>
            <a:off x="2312298" y="2788226"/>
            <a:ext cx="7567395" cy="2031055"/>
          </a:xfrm>
          <a:prstGeom prst="rect">
            <a:avLst/>
          </a:prstGeom>
          <a:noFill/>
          <a:ln>
            <a:noFill/>
          </a:ln>
        </p:spPr>
        <p:txBody>
          <a:bodyPr spcFirstLastPara="1" wrap="square" lIns="91425" tIns="45700" rIns="91425" bIns="45700" anchor="b" anchorCtr="0">
            <a:normAutofit fontScale="90000"/>
          </a:bodyPr>
          <a:lstStyle/>
          <a:p>
            <a:pPr marL="0" lvl="0" indent="0" algn="ctr" rtl="0">
              <a:lnSpc>
                <a:spcPct val="90000"/>
              </a:lnSpc>
              <a:spcBef>
                <a:spcPts val="0"/>
              </a:spcBef>
              <a:spcAft>
                <a:spcPts val="0"/>
              </a:spcAft>
              <a:buClr>
                <a:schemeClr val="lt2"/>
              </a:buClr>
              <a:buSzPts val="5200"/>
              <a:buFont typeface="Calibri"/>
              <a:buNone/>
            </a:pPr>
            <a:r>
              <a:rPr lang="en-US" sz="5200" dirty="0">
                <a:solidFill>
                  <a:schemeClr val="lt2"/>
                </a:solidFill>
              </a:rPr>
              <a:t>Addressing Patient Bias</a:t>
            </a:r>
            <a:br>
              <a:rPr lang="en-US" sz="5200" dirty="0">
                <a:solidFill>
                  <a:schemeClr val="lt2"/>
                </a:solidFill>
              </a:rPr>
            </a:br>
            <a:r>
              <a:rPr lang="en-US" sz="3100" b="0" i="0" u="none" strike="noStrike" cap="none" dirty="0">
                <a:solidFill>
                  <a:schemeClr val="lt2"/>
                </a:solidFill>
                <a:latin typeface="Calibri"/>
                <a:ea typeface="Calibri"/>
                <a:cs typeface="Calibri"/>
                <a:sym typeface="Calibri"/>
              </a:rPr>
              <a:t>A Toolkit for Bias Response</a:t>
            </a:r>
            <a:br>
              <a:rPr lang="en-US" sz="3100" dirty="0">
                <a:solidFill>
                  <a:schemeClr val="lt2"/>
                </a:solidFill>
              </a:rPr>
            </a:br>
            <a:br>
              <a:rPr lang="en-US" sz="3100" dirty="0">
                <a:solidFill>
                  <a:schemeClr val="lt2"/>
                </a:solidFill>
              </a:rPr>
            </a:br>
            <a:br>
              <a:rPr lang="en-US" sz="3100" dirty="0">
                <a:solidFill>
                  <a:schemeClr val="lt2"/>
                </a:solidFill>
              </a:rPr>
            </a:br>
            <a:r>
              <a:rPr lang="en-US" sz="3100" dirty="0">
                <a:solidFill>
                  <a:schemeClr val="lt2"/>
                </a:solidFill>
              </a:rPr>
              <a:t>Thank you for your attendance and participation</a:t>
            </a:r>
            <a:endParaRPr sz="5200" dirty="0">
              <a:solidFill>
                <a:schemeClr val="lt2"/>
              </a:solidFill>
            </a:endParaRPr>
          </a:p>
        </p:txBody>
      </p:sp>
      <p:sp>
        <p:nvSpPr>
          <p:cNvPr id="312" name="Google Shape;312;p35"/>
          <p:cNvSpPr txBox="1">
            <a:spLocks noGrp="1"/>
          </p:cNvSpPr>
          <p:nvPr>
            <p:ph type="subTitle" idx="1"/>
          </p:nvPr>
        </p:nvSpPr>
        <p:spPr>
          <a:xfrm>
            <a:off x="2878246" y="5626857"/>
            <a:ext cx="6435497" cy="928068"/>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lt2"/>
              </a:buClr>
              <a:buSzPct val="100000"/>
              <a:buNone/>
            </a:pPr>
            <a:r>
              <a:rPr lang="en-US" dirty="0">
                <a:solidFill>
                  <a:schemeClr val="lt2"/>
                </a:solidFill>
              </a:rPr>
              <a:t>For questions and concerns:</a:t>
            </a:r>
          </a:p>
          <a:p>
            <a:pPr marL="0" lvl="0" indent="0" algn="ctr" rtl="0">
              <a:lnSpc>
                <a:spcPct val="90000"/>
              </a:lnSpc>
              <a:spcBef>
                <a:spcPts val="0"/>
              </a:spcBef>
              <a:spcAft>
                <a:spcPts val="0"/>
              </a:spcAft>
              <a:buClr>
                <a:schemeClr val="lt2"/>
              </a:buClr>
              <a:buSzPct val="100000"/>
              <a:buNone/>
            </a:pPr>
            <a:r>
              <a:rPr lang="en-US" dirty="0">
                <a:solidFill>
                  <a:schemeClr val="lt2"/>
                </a:solidFill>
              </a:rPr>
              <a:t>Put your contact information here</a:t>
            </a:r>
            <a:endParaRPr dirty="0">
              <a:solidFill>
                <a:schemeClr val="lt2"/>
              </a:solidFill>
            </a:endParaRPr>
          </a:p>
        </p:txBody>
      </p:sp>
    </p:spTree>
    <p:custDataLst>
      <p:tags r:id="rId1"/>
    </p:custData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21"/>
        <p:cNvGrpSpPr/>
        <p:nvPr/>
      </p:nvGrpSpPr>
      <p:grpSpPr>
        <a:xfrm>
          <a:off x="0" y="0"/>
          <a:ext cx="0" cy="0"/>
          <a:chOff x="0" y="0"/>
          <a:chExt cx="0" cy="0"/>
        </a:xfrm>
      </p:grpSpPr>
      <p:sp>
        <p:nvSpPr>
          <p:cNvPr id="122" name="Google Shape;122;p4"/>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a:t>Pre-workshop survey</a:t>
            </a:r>
            <a:endParaRPr/>
          </a:p>
        </p:txBody>
      </p:sp>
      <p:sp>
        <p:nvSpPr>
          <p:cNvPr id="123" name="Google Shape;123;p4"/>
          <p:cNvSpPr txBox="1"/>
          <p:nvPr/>
        </p:nvSpPr>
        <p:spPr>
          <a:xfrm>
            <a:off x="4229829" y="5784574"/>
            <a:ext cx="4103400" cy="369300"/>
          </a:xfrm>
          <a:prstGeom prst="rect">
            <a:avLst/>
          </a:prstGeom>
          <a:noFill/>
          <a:ln>
            <a:noFill/>
          </a:ln>
        </p:spPr>
        <p:txBody>
          <a:bodyPr spcFirstLastPara="1" wrap="square" lIns="91425" tIns="45700" rIns="91425" bIns="45700" anchor="t" anchorCtr="0">
            <a:spAutoFit/>
          </a:bodyPr>
          <a:lstStyle/>
          <a:p>
            <a:pPr lvl="0" algn="ctr"/>
            <a:r>
              <a:rPr lang="en-US" sz="1800" dirty="0">
                <a:solidFill>
                  <a:schemeClr val="lt1"/>
                </a:solidFill>
                <a:latin typeface="Calibri"/>
                <a:ea typeface="Calibri"/>
                <a:cs typeface="Calibri"/>
                <a:sym typeface="Calibri"/>
              </a:rPr>
              <a:t>(Link to Polling Software Included Here)</a:t>
            </a:r>
            <a:endParaRPr dirty="0"/>
          </a:p>
        </p:txBody>
      </p:sp>
      <p:sp>
        <p:nvSpPr>
          <p:cNvPr id="124" name="Google Shape;124;p4"/>
          <p:cNvSpPr txBox="1"/>
          <p:nvPr/>
        </p:nvSpPr>
        <p:spPr>
          <a:xfrm>
            <a:off x="6281530" y="1073426"/>
            <a:ext cx="184731"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lt1"/>
              </a:solidFill>
              <a:latin typeface="Calibri"/>
              <a:ea typeface="Calibri"/>
              <a:cs typeface="Calibri"/>
              <a:sym typeface="Calibri"/>
            </a:endParaRPr>
          </a:p>
        </p:txBody>
      </p:sp>
      <p:sp>
        <p:nvSpPr>
          <p:cNvPr id="3" name="Rectangle 2">
            <a:extLst>
              <a:ext uri="{FF2B5EF4-FFF2-40B4-BE49-F238E27FC236}">
                <a16:creationId xmlns:a16="http://schemas.microsoft.com/office/drawing/2014/main" id="{ED299422-B451-1899-B53F-3F00731E57B8}"/>
              </a:ext>
            </a:extLst>
          </p:cNvPr>
          <p:cNvSpPr/>
          <p:nvPr/>
        </p:nvSpPr>
        <p:spPr>
          <a:xfrm>
            <a:off x="4143107" y="1900550"/>
            <a:ext cx="4276845" cy="3440575"/>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latin typeface="Calibri" panose="020F0502020204030204" pitchFamily="34" charset="0"/>
                <a:cs typeface="Calibri" panose="020F0502020204030204" pitchFamily="34" charset="0"/>
              </a:rPr>
              <a:t>QR Code for Polling Software Included Here</a:t>
            </a:r>
          </a:p>
        </p:txBody>
      </p:sp>
    </p:spTree>
    <p:custDataLst>
      <p:tags r:id="rId1"/>
    </p:custData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30"/>
        <p:cNvGrpSpPr/>
        <p:nvPr/>
      </p:nvGrpSpPr>
      <p:grpSpPr>
        <a:xfrm>
          <a:off x="0" y="0"/>
          <a:ext cx="0" cy="0"/>
          <a:chOff x="0" y="0"/>
          <a:chExt cx="0" cy="0"/>
        </a:xfrm>
      </p:grpSpPr>
      <p:sp>
        <p:nvSpPr>
          <p:cNvPr id="131" name="Google Shape;131;p5"/>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a:t>Definitions</a:t>
            </a:r>
            <a:endParaRPr/>
          </a:p>
        </p:txBody>
      </p:sp>
      <p:sp>
        <p:nvSpPr>
          <p:cNvPr id="132" name="Google Shape;132;p5"/>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lt1"/>
              </a:buClr>
              <a:buSzPts val="2800"/>
              <a:buChar char="•"/>
            </a:pPr>
            <a:r>
              <a:rPr lang="en-US" b="1" dirty="0"/>
              <a:t>Bias</a:t>
            </a:r>
            <a:r>
              <a:rPr lang="en-US" dirty="0"/>
              <a:t> – an </a:t>
            </a:r>
            <a:r>
              <a:rPr lang="en-US" u="sng" dirty="0"/>
              <a:t>attitude</a:t>
            </a:r>
            <a:r>
              <a:rPr lang="en-US" dirty="0"/>
              <a:t> that projects favorable or unfavorable dispositions towards people</a:t>
            </a:r>
            <a:endParaRPr dirty="0"/>
          </a:p>
          <a:p>
            <a:pPr marL="228600" lvl="0" indent="-292100" algn="l" rtl="0">
              <a:spcBef>
                <a:spcPts val="1000"/>
              </a:spcBef>
              <a:spcAft>
                <a:spcPts val="0"/>
              </a:spcAft>
              <a:buSzPts val="2800"/>
              <a:buChar char="•"/>
            </a:pPr>
            <a:r>
              <a:rPr lang="en-US" b="1" dirty="0"/>
              <a:t>Microaggression</a:t>
            </a:r>
            <a:r>
              <a:rPr lang="en-US" dirty="0"/>
              <a:t> – brief &amp; common indignities that communicate hostile, derogatory or negative slights to target a person or group</a:t>
            </a:r>
          </a:p>
          <a:p>
            <a:pPr marL="685800" lvl="1" indent="-292100">
              <a:spcBef>
                <a:spcPts val="1000"/>
              </a:spcBef>
              <a:buSzPts val="2800"/>
            </a:pPr>
            <a:r>
              <a:rPr lang="en-US" dirty="0"/>
              <a:t>“</a:t>
            </a:r>
            <a:r>
              <a:rPr lang="en-US" dirty="0" err="1"/>
              <a:t>micro”aggression</a:t>
            </a:r>
            <a:r>
              <a:rPr lang="en-US" dirty="0"/>
              <a:t> ≠ micro impact</a:t>
            </a:r>
            <a:endParaRPr dirty="0"/>
          </a:p>
          <a:p>
            <a:pPr marL="228600" lvl="0" indent="-228600" algn="l" rtl="0">
              <a:lnSpc>
                <a:spcPct val="90000"/>
              </a:lnSpc>
              <a:spcBef>
                <a:spcPts val="1000"/>
              </a:spcBef>
              <a:spcAft>
                <a:spcPts val="0"/>
              </a:spcAft>
              <a:buClr>
                <a:schemeClr val="lt1"/>
              </a:buClr>
              <a:buSzPts val="2800"/>
              <a:buChar char="•"/>
            </a:pPr>
            <a:r>
              <a:rPr lang="en-US" b="1" dirty="0"/>
              <a:t>Stereotype</a:t>
            </a:r>
            <a:r>
              <a:rPr lang="en-US" dirty="0"/>
              <a:t> – a </a:t>
            </a:r>
            <a:r>
              <a:rPr lang="en-US" u="sng" dirty="0"/>
              <a:t>shared</a:t>
            </a:r>
            <a:r>
              <a:rPr lang="en-US" dirty="0"/>
              <a:t> sets of beliefs; </a:t>
            </a:r>
            <a:r>
              <a:rPr lang="en-US" u="sng" dirty="0"/>
              <a:t>fixed</a:t>
            </a:r>
            <a:r>
              <a:rPr lang="en-US" dirty="0"/>
              <a:t> impression of a group</a:t>
            </a:r>
            <a:endParaRPr dirty="0"/>
          </a:p>
          <a:p>
            <a:pPr marL="228600" lvl="0" indent="-228600" algn="l" rtl="0">
              <a:lnSpc>
                <a:spcPct val="90000"/>
              </a:lnSpc>
              <a:spcBef>
                <a:spcPts val="1000"/>
              </a:spcBef>
              <a:spcAft>
                <a:spcPts val="0"/>
              </a:spcAft>
              <a:buClr>
                <a:schemeClr val="lt1"/>
              </a:buClr>
              <a:buSzPts val="2800"/>
              <a:buChar char="•"/>
            </a:pPr>
            <a:r>
              <a:rPr lang="en-US" b="1" dirty="0"/>
              <a:t>Discrimination</a:t>
            </a:r>
            <a:r>
              <a:rPr lang="en-US" dirty="0"/>
              <a:t> – </a:t>
            </a:r>
            <a:r>
              <a:rPr lang="en-US" u="sng" dirty="0"/>
              <a:t>behavioral</a:t>
            </a:r>
            <a:r>
              <a:rPr lang="en-US" dirty="0"/>
              <a:t> manifestations of bias, stereotyping and prejudice</a:t>
            </a:r>
            <a:endParaRPr b="1" dirty="0"/>
          </a:p>
        </p:txBody>
      </p:sp>
      <p:sp>
        <p:nvSpPr>
          <p:cNvPr id="2" name="Google Shape;133;p5">
            <a:extLst>
              <a:ext uri="{FF2B5EF4-FFF2-40B4-BE49-F238E27FC236}">
                <a16:creationId xmlns:a16="http://schemas.microsoft.com/office/drawing/2014/main" id="{6FAC5B3E-7A4C-060B-5E58-BFE1F0016CC5}"/>
              </a:ext>
            </a:extLst>
          </p:cNvPr>
          <p:cNvSpPr/>
          <p:nvPr/>
        </p:nvSpPr>
        <p:spPr>
          <a:xfrm>
            <a:off x="3687580" y="6280788"/>
            <a:ext cx="7666221" cy="461624"/>
          </a:xfrm>
          <a:prstGeom prst="rect">
            <a:avLst/>
          </a:prstGeom>
          <a:noFill/>
          <a:ln>
            <a:noFill/>
          </a:ln>
        </p:spPr>
        <p:txBody>
          <a:bodyPr spcFirstLastPara="1" wrap="square" lIns="91425" tIns="45700" rIns="91425" bIns="45700" anchor="t" anchorCtr="0">
            <a:spAutoFit/>
          </a:bodyPr>
          <a:lstStyle/>
          <a:p>
            <a:pPr marL="228600" marR="0" lvl="0" indent="-228600" algn="r" rtl="0">
              <a:spcBef>
                <a:spcPts val="0"/>
              </a:spcBef>
              <a:spcAft>
                <a:spcPts val="0"/>
              </a:spcAft>
              <a:buClr>
                <a:schemeClr val="lt1"/>
              </a:buClr>
              <a:buSzPts val="1200"/>
              <a:buFont typeface="Source Sans Pro"/>
              <a:buAutoNum type="arabicPeriod"/>
            </a:pPr>
            <a:r>
              <a:rPr lang="en-US" sz="1200" i="1" dirty="0">
                <a:solidFill>
                  <a:schemeClr val="lt1"/>
                </a:solidFill>
                <a:latin typeface="Calibri" panose="020F0502020204030204" pitchFamily="34" charset="0"/>
                <a:ea typeface="Source Sans Pro"/>
                <a:cs typeface="Calibri" panose="020F0502020204030204" pitchFamily="34" charset="0"/>
                <a:sym typeface="Source Sans Pro"/>
              </a:rPr>
              <a:t>Adapted from Dr. Janice Sabin, University of Washington</a:t>
            </a:r>
            <a:endParaRPr dirty="0">
              <a:latin typeface="Calibri" panose="020F0502020204030204" pitchFamily="34" charset="0"/>
              <a:cs typeface="Calibri" panose="020F0502020204030204" pitchFamily="34" charset="0"/>
            </a:endParaRPr>
          </a:p>
          <a:p>
            <a:pPr marL="228600" marR="0" lvl="0" indent="-228600" algn="r" rtl="0">
              <a:spcBef>
                <a:spcPts val="0"/>
              </a:spcBef>
              <a:spcAft>
                <a:spcPts val="0"/>
              </a:spcAft>
              <a:buClr>
                <a:schemeClr val="lt1"/>
              </a:buClr>
              <a:buSzPts val="1200"/>
              <a:buFont typeface="Source Sans Pro"/>
              <a:buAutoNum type="arabicPeriod"/>
            </a:pPr>
            <a:r>
              <a:rPr lang="en-US" sz="1200" i="1" dirty="0">
                <a:solidFill>
                  <a:schemeClr val="lt1"/>
                </a:solidFill>
                <a:latin typeface="Calibri" panose="020F0502020204030204" pitchFamily="34" charset="0"/>
                <a:ea typeface="Source Sans Pro"/>
                <a:cs typeface="Calibri" panose="020F0502020204030204" pitchFamily="34" charset="0"/>
                <a:sym typeface="Source Sans Pro"/>
              </a:rPr>
              <a:t>Adapted from </a:t>
            </a:r>
            <a:r>
              <a:rPr lang="en-US" sz="1200" i="1" dirty="0" err="1">
                <a:solidFill>
                  <a:schemeClr val="lt1"/>
                </a:solidFill>
                <a:latin typeface="Calibri" panose="020F0502020204030204" pitchFamily="34" charset="0"/>
                <a:ea typeface="Calibri"/>
                <a:cs typeface="Calibri" panose="020F0502020204030204" pitchFamily="34" charset="0"/>
                <a:sym typeface="Calibri"/>
              </a:rPr>
              <a:t>Derald</a:t>
            </a:r>
            <a:r>
              <a:rPr lang="en-US" sz="1200" i="1" dirty="0">
                <a:solidFill>
                  <a:schemeClr val="lt1"/>
                </a:solidFill>
                <a:latin typeface="Calibri" panose="020F0502020204030204" pitchFamily="34" charset="0"/>
                <a:ea typeface="Calibri"/>
                <a:cs typeface="Calibri" panose="020F0502020204030204" pitchFamily="34" charset="0"/>
                <a:sym typeface="Calibri"/>
              </a:rPr>
              <a:t> Wing Sue, 2010, Microaggressions in Everyday Life: Race, Gender, and Sexual Orientation</a:t>
            </a:r>
            <a:endParaRPr sz="1200" i="1" dirty="0">
              <a:solidFill>
                <a:schemeClr val="lt1"/>
              </a:solidFill>
              <a:latin typeface="Calibri" panose="020F0502020204030204" pitchFamily="34" charset="0"/>
              <a:ea typeface="Source Sans Pro"/>
              <a:cs typeface="Calibri" panose="020F0502020204030204" pitchFamily="34" charset="0"/>
              <a:sym typeface="Source Sans Pro"/>
            </a:endParaRPr>
          </a:p>
        </p:txBody>
      </p:sp>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3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3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3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3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32">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38"/>
        <p:cNvGrpSpPr/>
        <p:nvPr/>
      </p:nvGrpSpPr>
      <p:grpSpPr>
        <a:xfrm>
          <a:off x="0" y="0"/>
          <a:ext cx="0" cy="0"/>
          <a:chOff x="0" y="0"/>
          <a:chExt cx="0" cy="0"/>
        </a:xfrm>
      </p:grpSpPr>
      <p:sp>
        <p:nvSpPr>
          <p:cNvPr id="139" name="Google Shape;139;p6"/>
          <p:cNvSpPr/>
          <p:nvPr/>
        </p:nvSpPr>
        <p:spPr>
          <a:xfrm>
            <a:off x="1952786" y="6262063"/>
            <a:ext cx="9401014" cy="461624"/>
          </a:xfrm>
          <a:prstGeom prst="rect">
            <a:avLst/>
          </a:prstGeom>
          <a:noFill/>
          <a:ln>
            <a:noFill/>
          </a:ln>
        </p:spPr>
        <p:txBody>
          <a:bodyPr spcFirstLastPara="1" wrap="square" lIns="91425" tIns="45700" rIns="91425" bIns="45700" anchor="t" anchorCtr="0">
            <a:spAutoFit/>
          </a:bodyPr>
          <a:lstStyle/>
          <a:p>
            <a:pPr marL="0" marR="0" lvl="0" indent="0" algn="r" rtl="0">
              <a:spcBef>
                <a:spcPts val="0"/>
              </a:spcBef>
              <a:spcAft>
                <a:spcPts val="0"/>
              </a:spcAft>
              <a:buNone/>
            </a:pPr>
            <a:r>
              <a:rPr lang="en-US" sz="1200" dirty="0">
                <a:solidFill>
                  <a:schemeClr val="lt1"/>
                </a:solidFill>
                <a:latin typeface="Calibri" panose="020F0502020204030204" pitchFamily="34" charset="0"/>
                <a:ea typeface="Source Sans Pro"/>
                <a:cs typeface="Calibri" panose="020F0502020204030204" pitchFamily="34" charset="0"/>
                <a:sym typeface="Source Sans Pro"/>
              </a:rPr>
              <a:t>Author adapted graph from: </a:t>
            </a:r>
            <a:r>
              <a:rPr lang="en-US" sz="1200" dirty="0" err="1">
                <a:solidFill>
                  <a:schemeClr val="lt1"/>
                </a:solidFill>
                <a:latin typeface="Calibri" panose="020F0502020204030204" pitchFamily="34" charset="0"/>
                <a:ea typeface="Source Sans Pro"/>
                <a:cs typeface="Calibri" panose="020F0502020204030204" pitchFamily="34" charset="0"/>
                <a:sym typeface="Source Sans Pro"/>
              </a:rPr>
              <a:t>Cajigal</a:t>
            </a:r>
            <a:r>
              <a:rPr lang="en-US" sz="1200" dirty="0">
                <a:solidFill>
                  <a:schemeClr val="lt1"/>
                </a:solidFill>
                <a:latin typeface="Calibri" panose="020F0502020204030204" pitchFamily="34" charset="0"/>
                <a:ea typeface="Source Sans Pro"/>
                <a:cs typeface="Calibri" panose="020F0502020204030204" pitchFamily="34" charset="0"/>
                <a:sym typeface="Source Sans Pro"/>
              </a:rPr>
              <a:t> S, Scudder L.</a:t>
            </a:r>
            <a:r>
              <a:rPr lang="en-US" sz="1200" b="0" u="none" strike="noStrike" dirty="0">
                <a:solidFill>
                  <a:schemeClr val="bg1"/>
                </a:solidFill>
                <a:effectLst/>
                <a:latin typeface="Calibri" panose="020F0502020204030204" pitchFamily="34" charset="0"/>
                <a:cs typeface="Calibri" panose="020F0502020204030204" pitchFamily="34" charset="0"/>
              </a:rPr>
              <a:t> </a:t>
            </a:r>
            <a:r>
              <a:rPr lang="en-US" sz="1200" dirty="0">
                <a:solidFill>
                  <a:schemeClr val="lt1"/>
                </a:solidFill>
                <a:latin typeface="Calibri" panose="020F0502020204030204" pitchFamily="34" charset="0"/>
                <a:ea typeface="Source Sans Pro"/>
                <a:cs typeface="Calibri" panose="020F0502020204030204" pitchFamily="34" charset="0"/>
                <a:sym typeface="Source Sans Pro"/>
              </a:rPr>
              <a:t>Patient Prejudice: When Credentials Aren’t Enough. WebMD/Medscape in collaboration with STAT. </a:t>
            </a:r>
            <a:r>
              <a:rPr lang="en-US" sz="1200" b="0" u="none" strike="noStrike" dirty="0">
                <a:solidFill>
                  <a:schemeClr val="bg1"/>
                </a:solidFill>
                <a:effectLst/>
                <a:latin typeface="Calibri" panose="020F0502020204030204" pitchFamily="34" charset="0"/>
                <a:cs typeface="Calibri" panose="020F0502020204030204" pitchFamily="34" charset="0"/>
              </a:rPr>
              <a:t>Published October 18, 2017. Accessed August 3, 2023. </a:t>
            </a:r>
            <a:r>
              <a:rPr lang="en-US" sz="1200" b="1" dirty="0">
                <a:solidFill>
                  <a:schemeClr val="lt1"/>
                </a:solidFill>
                <a:latin typeface="Calibri" panose="020F0502020204030204" pitchFamily="34" charset="0"/>
                <a:ea typeface="Calibri"/>
                <a:cs typeface="Calibri" panose="020F0502020204030204" pitchFamily="34" charset="0"/>
                <a:sym typeface="Calibri"/>
              </a:rPr>
              <a:t>https://www.medscape.com/slideshow/2017-patient-prejudice-report-6009134#11</a:t>
            </a:r>
            <a:endParaRPr sz="1200" dirty="0">
              <a:solidFill>
                <a:schemeClr val="lt1"/>
              </a:solidFill>
              <a:latin typeface="Calibri" panose="020F0502020204030204" pitchFamily="34" charset="0"/>
              <a:ea typeface="Calibri"/>
              <a:cs typeface="Calibri" panose="020F0502020204030204" pitchFamily="34" charset="0"/>
              <a:sym typeface="Calibri"/>
            </a:endParaRPr>
          </a:p>
        </p:txBody>
      </p:sp>
      <p:sp>
        <p:nvSpPr>
          <p:cNvPr id="2" name="Google Shape;109;p2">
            <a:extLst>
              <a:ext uri="{FF2B5EF4-FFF2-40B4-BE49-F238E27FC236}">
                <a16:creationId xmlns:a16="http://schemas.microsoft.com/office/drawing/2014/main" id="{3C92AE59-6ED7-94DC-82B3-DAF46A342C89}"/>
              </a:ext>
            </a:extLst>
          </p:cNvPr>
          <p:cNvSpPr txBox="1">
            <a:spLocks/>
          </p:cNvSpPr>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lt1"/>
              </a:buClr>
              <a:buSzPts val="1800"/>
              <a:buFont typeface="Calibri"/>
              <a:buNone/>
              <a:defRPr sz="4400" b="0" i="0" u="none" strike="noStrike" cap="none">
                <a:solidFill>
                  <a:schemeClr val="lt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a:buSzPts val="4400"/>
            </a:pPr>
            <a:r>
              <a:rPr lang="en-US" dirty="0"/>
              <a:t>Patient bias is a national problem</a:t>
            </a:r>
          </a:p>
        </p:txBody>
      </p:sp>
      <p:pic>
        <p:nvPicPr>
          <p:cNvPr id="4" name="Picture 3">
            <a:extLst>
              <a:ext uri="{FF2B5EF4-FFF2-40B4-BE49-F238E27FC236}">
                <a16:creationId xmlns:a16="http://schemas.microsoft.com/office/drawing/2014/main" id="{3109622B-1B6F-C95A-950C-8D693062EFA0}"/>
              </a:ext>
            </a:extLst>
          </p:cNvPr>
          <p:cNvPicPr>
            <a:picLocks noChangeAspect="1"/>
          </p:cNvPicPr>
          <p:nvPr/>
        </p:nvPicPr>
        <p:blipFill>
          <a:blip r:embed="rId4"/>
          <a:stretch>
            <a:fillRect/>
          </a:stretch>
        </p:blipFill>
        <p:spPr>
          <a:xfrm>
            <a:off x="3294256" y="1690825"/>
            <a:ext cx="5603488" cy="4153384"/>
          </a:xfrm>
          <a:prstGeom prst="rect">
            <a:avLst/>
          </a:prstGeom>
        </p:spPr>
      </p:pic>
    </p:spTree>
    <p:custDataLst>
      <p:tags r:id="rId1"/>
    </p:custData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93B785-6DA8-D177-0041-672E3457DC64}"/>
              </a:ext>
            </a:extLst>
          </p:cNvPr>
          <p:cNvSpPr>
            <a:spLocks noGrp="1"/>
          </p:cNvSpPr>
          <p:nvPr>
            <p:ph type="title"/>
          </p:nvPr>
        </p:nvSpPr>
        <p:spPr/>
        <p:txBody>
          <a:bodyPr/>
          <a:lstStyle/>
          <a:p>
            <a:r>
              <a:rPr lang="en-US" dirty="0"/>
              <a:t>And a local one…</a:t>
            </a:r>
          </a:p>
        </p:txBody>
      </p:sp>
      <p:sp>
        <p:nvSpPr>
          <p:cNvPr id="3" name="Text Placeholder 2">
            <a:extLst>
              <a:ext uri="{FF2B5EF4-FFF2-40B4-BE49-F238E27FC236}">
                <a16:creationId xmlns:a16="http://schemas.microsoft.com/office/drawing/2014/main" id="{16E429AC-458F-6D24-EE27-A9C3B1F3E6CD}"/>
              </a:ext>
            </a:extLst>
          </p:cNvPr>
          <p:cNvSpPr>
            <a:spLocks noGrp="1"/>
          </p:cNvSpPr>
          <p:nvPr>
            <p:ph type="body" idx="1"/>
          </p:nvPr>
        </p:nvSpPr>
        <p:spPr/>
        <p:txBody>
          <a:bodyPr/>
          <a:lstStyle/>
          <a:p>
            <a:pPr marL="0" lvl="0" indent="0" algn="l" rtl="0">
              <a:spcBef>
                <a:spcPts val="1000"/>
              </a:spcBef>
              <a:spcAft>
                <a:spcPts val="0"/>
              </a:spcAft>
              <a:buNone/>
            </a:pPr>
            <a:r>
              <a:rPr lang="en-US" dirty="0"/>
              <a:t>89 interns surveyed at an AMC in 2021:</a:t>
            </a:r>
          </a:p>
        </p:txBody>
      </p:sp>
      <p:sp>
        <p:nvSpPr>
          <p:cNvPr id="6" name="Google Shape;148;gc473988d5b_0_9">
            <a:extLst>
              <a:ext uri="{FF2B5EF4-FFF2-40B4-BE49-F238E27FC236}">
                <a16:creationId xmlns:a16="http://schemas.microsoft.com/office/drawing/2014/main" id="{AFE46828-1CE0-FAF8-02DD-D5415011B391}"/>
              </a:ext>
            </a:extLst>
          </p:cNvPr>
          <p:cNvSpPr txBox="1">
            <a:spLocks/>
          </p:cNvSpPr>
          <p:nvPr/>
        </p:nvSpPr>
        <p:spPr>
          <a:xfrm>
            <a:off x="6613525" y="1825625"/>
            <a:ext cx="4740275" cy="4327525"/>
          </a:xfrm>
          <a:prstGeom prst="rect">
            <a:avLst/>
          </a:prstGeom>
          <a:noFill/>
          <a:ln>
            <a:noFill/>
          </a:ln>
        </p:spPr>
        <p:txBody>
          <a:bodyPr spcFirstLastPara="1" wrap="square" lIns="91425" tIns="45700" rIns="91425" bIns="45700" anchor="t" anchorCtr="0">
            <a:normAutofit fontScale="92500" lnSpcReduction="20000"/>
          </a:bodyPr>
          <a:lstStyle>
            <a:defPPr marR="0" lvl="0" algn="l" rtl="0">
              <a:lnSpc>
                <a:spcPct val="100000"/>
              </a:lnSpc>
              <a:spcBef>
                <a:spcPts val="0"/>
              </a:spcBef>
              <a:spcAft>
                <a:spcPts val="0"/>
              </a:spcAft>
            </a:defPPr>
            <a:lvl1pPr marL="457200" marR="0" lvl="0" indent="-406400" algn="l" rtl="0">
              <a:lnSpc>
                <a:spcPct val="90000"/>
              </a:lnSpc>
              <a:spcBef>
                <a:spcPts val="1000"/>
              </a:spcBef>
              <a:spcAft>
                <a:spcPts val="0"/>
              </a:spcAft>
              <a:buClr>
                <a:schemeClr val="lt1"/>
              </a:buClr>
              <a:buSzPts val="2800"/>
              <a:buFont typeface="Arial"/>
              <a:buChar char="•"/>
              <a:defRPr sz="2800" b="0" i="0" u="none" strike="noStrike" cap="none">
                <a:solidFill>
                  <a:schemeClr val="lt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lt1"/>
              </a:buClr>
              <a:buSzPts val="2400"/>
              <a:buFont typeface="Arial"/>
              <a:buChar char="•"/>
              <a:defRPr sz="2400" b="0" i="0" u="none" strike="noStrike" cap="none">
                <a:solidFill>
                  <a:schemeClr val="lt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lt1"/>
              </a:buClr>
              <a:buSzPts val="2000"/>
              <a:buFont typeface="Arial"/>
              <a:buChar char="•"/>
              <a:defRPr sz="2000" b="0" i="0" u="none" strike="noStrike" cap="none">
                <a:solidFill>
                  <a:schemeClr val="lt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9pPr>
          </a:lstStyle>
          <a:p>
            <a:pPr marL="609600" indent="-482600">
              <a:buFont typeface="Calibri"/>
              <a:buChar char="-"/>
            </a:pPr>
            <a:r>
              <a:rPr lang="en-US" dirty="0"/>
              <a:t>79% patients/their families </a:t>
            </a:r>
          </a:p>
          <a:p>
            <a:pPr marL="609600" indent="-482600">
              <a:buFont typeface="Calibri"/>
              <a:buChar char="-"/>
            </a:pPr>
            <a:r>
              <a:rPr lang="en-US" dirty="0"/>
              <a:t>10% non-physician colleagues</a:t>
            </a:r>
          </a:p>
          <a:p>
            <a:pPr marL="609600" indent="-482600">
              <a:buFont typeface="Calibri"/>
              <a:buChar char="-"/>
            </a:pPr>
            <a:r>
              <a:rPr lang="en-US" dirty="0"/>
              <a:t>10% attendings or peers</a:t>
            </a:r>
          </a:p>
          <a:p>
            <a:pPr marL="609600" indent="-482600">
              <a:buFont typeface="Calibri"/>
              <a:buChar char="-"/>
            </a:pPr>
            <a:r>
              <a:rPr lang="en-US" dirty="0"/>
              <a:t>Other forms of bias identified: </a:t>
            </a:r>
          </a:p>
          <a:p>
            <a:pPr marL="1219200" lvl="1" indent="-457200">
              <a:buFont typeface="Calibri"/>
              <a:buChar char="-"/>
            </a:pPr>
            <a:r>
              <a:rPr lang="en-US" dirty="0"/>
              <a:t>Age, class, sexual orientation, LGBTQ+, hometown/medical school attended, nationality, speaking with an accent, religion, weight/physical characteristics</a:t>
            </a:r>
          </a:p>
        </p:txBody>
      </p:sp>
      <p:pic>
        <p:nvPicPr>
          <p:cNvPr id="7" name="Google Shape;149;gc473988d5b_0_9">
            <a:extLst>
              <a:ext uri="{FF2B5EF4-FFF2-40B4-BE49-F238E27FC236}">
                <a16:creationId xmlns:a16="http://schemas.microsoft.com/office/drawing/2014/main" id="{9E9C1461-423E-BFCA-33AF-02229683D31A}"/>
              </a:ext>
            </a:extLst>
          </p:cNvPr>
          <p:cNvPicPr preferRelativeResize="0"/>
          <p:nvPr/>
        </p:nvPicPr>
        <p:blipFill>
          <a:blip r:embed="rId3">
            <a:alphaModFix/>
          </a:blip>
          <a:stretch>
            <a:fillRect/>
          </a:stretch>
        </p:blipFill>
        <p:spPr>
          <a:xfrm>
            <a:off x="838200" y="2603233"/>
            <a:ext cx="5578800" cy="3353462"/>
          </a:xfrm>
          <a:prstGeom prst="rect">
            <a:avLst/>
          </a:prstGeom>
          <a:noFill/>
          <a:ln>
            <a:noFill/>
          </a:ln>
        </p:spPr>
      </p:pic>
      <p:sp>
        <p:nvSpPr>
          <p:cNvPr id="8" name="TextBox 7">
            <a:extLst>
              <a:ext uri="{FF2B5EF4-FFF2-40B4-BE49-F238E27FC236}">
                <a16:creationId xmlns:a16="http://schemas.microsoft.com/office/drawing/2014/main" id="{801C2E40-2CCB-E3FA-B330-A997E7F8B585}"/>
              </a:ext>
            </a:extLst>
          </p:cNvPr>
          <p:cNvSpPr txBox="1"/>
          <p:nvPr/>
        </p:nvSpPr>
        <p:spPr>
          <a:xfrm>
            <a:off x="1630017" y="6272638"/>
            <a:ext cx="9723783" cy="461665"/>
          </a:xfrm>
          <a:prstGeom prst="rect">
            <a:avLst/>
          </a:prstGeom>
          <a:noFill/>
        </p:spPr>
        <p:txBody>
          <a:bodyPr wrap="square">
            <a:spAutoFit/>
          </a:bodyPr>
          <a:lstStyle/>
          <a:p>
            <a:pPr algn="r"/>
            <a:r>
              <a:rPr lang="en-US" sz="1200" b="0" i="0" u="none" strike="noStrike" dirty="0">
                <a:solidFill>
                  <a:schemeClr val="bg1"/>
                </a:solidFill>
                <a:effectLst/>
                <a:latin typeface="Calibri" panose="020F0502020204030204" pitchFamily="34" charset="0"/>
                <a:cs typeface="Calibri" panose="020F0502020204030204" pitchFamily="34" charset="0"/>
              </a:rPr>
              <a:t>Author adapted graph from: Bromberg GK, Gay EA, Hills-Dunlap K, Burnett-Bowie SM. Using a Virtual Platform to Teach Residents How to Respond to Bias. J Gen Intern Med. 2022 Aug;37(11):2871-2872. </a:t>
            </a:r>
            <a:r>
              <a:rPr lang="en-US" sz="1200" b="0" i="0" u="none" strike="noStrike" dirty="0" err="1">
                <a:solidFill>
                  <a:schemeClr val="bg1"/>
                </a:solidFill>
                <a:effectLst/>
                <a:latin typeface="Calibri" panose="020F0502020204030204" pitchFamily="34" charset="0"/>
                <a:cs typeface="Calibri" panose="020F0502020204030204" pitchFamily="34" charset="0"/>
              </a:rPr>
              <a:t>doi</a:t>
            </a:r>
            <a:r>
              <a:rPr lang="en-US" sz="1200" b="0" i="0" u="none" strike="noStrike" dirty="0">
                <a:solidFill>
                  <a:schemeClr val="bg1"/>
                </a:solidFill>
                <a:effectLst/>
                <a:latin typeface="Calibri" panose="020F0502020204030204" pitchFamily="34" charset="0"/>
                <a:cs typeface="Calibri" panose="020F0502020204030204" pitchFamily="34" charset="0"/>
              </a:rPr>
              <a:t>: 10.1007/s11606-021-07156-y. </a:t>
            </a:r>
            <a:r>
              <a:rPr lang="en-US" sz="1200" b="0" i="0" u="none" strike="noStrike" dirty="0" err="1">
                <a:solidFill>
                  <a:schemeClr val="bg1"/>
                </a:solidFill>
                <a:effectLst/>
                <a:latin typeface="Calibri" panose="020F0502020204030204" pitchFamily="34" charset="0"/>
                <a:cs typeface="Calibri" panose="020F0502020204030204" pitchFamily="34" charset="0"/>
              </a:rPr>
              <a:t>Epub</a:t>
            </a:r>
            <a:r>
              <a:rPr lang="en-US" sz="1200" b="0" i="0" u="none" strike="noStrike" dirty="0">
                <a:solidFill>
                  <a:schemeClr val="bg1"/>
                </a:solidFill>
                <a:effectLst/>
                <a:latin typeface="Calibri" panose="020F0502020204030204" pitchFamily="34" charset="0"/>
                <a:cs typeface="Calibri" panose="020F0502020204030204" pitchFamily="34" charset="0"/>
              </a:rPr>
              <a:t> 2021 Oct 12. PMID: 34642859; PMCID: PMC8510575.</a:t>
            </a:r>
            <a:endParaRPr lang="en-US" sz="1200" dirty="0">
              <a:solidFill>
                <a:schemeClr val="bg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4706381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animEffect transition="in" filter="fade">
                                      <p:cBhvr>
                                        <p:cTn id="7" dur="1000"/>
                                        <p:tgtEl>
                                          <p:spTgt spid="7"/>
                                        </p:tgtEl>
                                      </p:cBhvr>
                                    </p:animEffect>
                                  </p:childTnLst>
                                </p:cTn>
                              </p:par>
                            </p:childTnLst>
                          </p:cTn>
                        </p:par>
                      </p:childTnLst>
                    </p:cTn>
                  </p:par>
                  <p:par>
                    <p:cTn id="8" fill="hold">
                      <p:stCondLst>
                        <p:cond delay="indefinite"/>
                      </p:stCondLst>
                      <p:childTnLst>
                        <p:par>
                          <p:cTn id="9" fill="hold">
                            <p:stCondLst>
                              <p:cond delay="0"/>
                            </p:stCondLst>
                            <p:childTnLst>
                              <p:par>
                                <p:cTn id="10" presetID="1" presetClass="entr" presetSubtype="0" fill="hold" grpId="0" nodeType="clickEffect">
                                  <p:stCondLst>
                                    <p:cond delay="0"/>
                                  </p:stCondLst>
                                  <p:childTnLst>
                                    <p:set>
                                      <p:cBhvr>
                                        <p:cTn id="11"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grpId="0" nodeType="clickEffect">
                                  <p:stCondLst>
                                    <p:cond delay="0"/>
                                  </p:stCondLst>
                                  <p:childTnLst>
                                    <p:set>
                                      <p:cBhvr>
                                        <p:cTn id="15"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par>
                    <p:cTn id="16" fill="hold">
                      <p:stCondLst>
                        <p:cond delay="indefinite"/>
                      </p:stCondLst>
                      <p:childTnLst>
                        <p:par>
                          <p:cTn id="17" fill="hold">
                            <p:stCondLst>
                              <p:cond delay="0"/>
                            </p:stCondLst>
                            <p:childTnLst>
                              <p:par>
                                <p:cTn id="18" presetID="1" presetClass="entr" presetSubtype="0" fill="hold" grpId="0" nodeType="clickEffect">
                                  <p:stCondLst>
                                    <p:cond delay="0"/>
                                  </p:stCondLst>
                                  <p:childTnLst>
                                    <p:set>
                                      <p:cBhvr>
                                        <p:cTn id="19"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par>
                    <p:cTn id="20" fill="hold">
                      <p:stCondLst>
                        <p:cond delay="indefinite"/>
                      </p:stCondLst>
                      <p:childTnLst>
                        <p:par>
                          <p:cTn id="21" fill="hold">
                            <p:stCondLst>
                              <p:cond delay="0"/>
                            </p:stCondLst>
                            <p:childTnLst>
                              <p:par>
                                <p:cTn id="22" presetID="1" presetClass="entr" presetSubtype="0" fill="hold" grpId="0" nodeType="clickEffect">
                                  <p:stCondLst>
                                    <p:cond delay="0"/>
                                  </p:stCondLst>
                                  <p:childTnLst>
                                    <p:set>
                                      <p:cBhvr>
                                        <p:cTn id="23" dur="1" fill="hold">
                                          <p:stCondLst>
                                            <p:cond delay="0"/>
                                          </p:stCondLst>
                                        </p:cTn>
                                        <p:tgtEl>
                                          <p:spTgt spid="6">
                                            <p:txEl>
                                              <p:pRg st="3" end="3"/>
                                            </p:txEl>
                                          </p:spTgt>
                                        </p:tgtEl>
                                        <p:attrNameLst>
                                          <p:attrName>style.visibility</p:attrName>
                                        </p:attrNameLst>
                                      </p:cBhvr>
                                      <p:to>
                                        <p:strVal val="visible"/>
                                      </p:to>
                                    </p:set>
                                  </p:childTnLst>
                                </p:cTn>
                              </p:par>
                              <p:par>
                                <p:cTn id="24" presetID="1" presetClass="entr" presetSubtype="0" fill="hold" grpId="0" nodeType="withEffect">
                                  <p:stCondLst>
                                    <p:cond delay="0"/>
                                  </p:stCondLst>
                                  <p:childTnLst>
                                    <p:set>
                                      <p:cBhvr>
                                        <p:cTn id="25" dur="1" fill="hold">
                                          <p:stCondLst>
                                            <p:cond delay="0"/>
                                          </p:stCondLst>
                                        </p:cTn>
                                        <p:tgtEl>
                                          <p:spTgt spid="6">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build="p"/>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E8D0EE-C112-4BE3-CB29-4BC4824F1DB1}"/>
              </a:ext>
            </a:extLst>
          </p:cNvPr>
          <p:cNvSpPr>
            <a:spLocks noGrp="1"/>
          </p:cNvSpPr>
          <p:nvPr>
            <p:ph type="title"/>
          </p:nvPr>
        </p:nvSpPr>
        <p:spPr/>
        <p:txBody>
          <a:bodyPr/>
          <a:lstStyle/>
          <a:p>
            <a:r>
              <a:rPr lang="en-US" dirty="0"/>
              <a:t>Word cloud</a:t>
            </a:r>
          </a:p>
        </p:txBody>
      </p:sp>
      <p:sp>
        <p:nvSpPr>
          <p:cNvPr id="3" name="Text Placeholder 2">
            <a:extLst>
              <a:ext uri="{FF2B5EF4-FFF2-40B4-BE49-F238E27FC236}">
                <a16:creationId xmlns:a16="http://schemas.microsoft.com/office/drawing/2014/main" id="{739ABFEE-749B-7BAC-27CB-12183730A8BE}"/>
              </a:ext>
            </a:extLst>
          </p:cNvPr>
          <p:cNvSpPr>
            <a:spLocks noGrp="1"/>
          </p:cNvSpPr>
          <p:nvPr>
            <p:ph type="body" idx="1"/>
          </p:nvPr>
        </p:nvSpPr>
        <p:spPr/>
        <p:txBody>
          <a:bodyPr/>
          <a:lstStyle/>
          <a:p>
            <a:r>
              <a:rPr lang="en-US" sz="2800" dirty="0"/>
              <a:t>What names other than doctor have patients called you?</a:t>
            </a:r>
            <a:endParaRPr lang="en-US" dirty="0"/>
          </a:p>
        </p:txBody>
      </p:sp>
      <p:sp>
        <p:nvSpPr>
          <p:cNvPr id="4" name="Rectangle 3">
            <a:extLst>
              <a:ext uri="{FF2B5EF4-FFF2-40B4-BE49-F238E27FC236}">
                <a16:creationId xmlns:a16="http://schemas.microsoft.com/office/drawing/2014/main" id="{E5572D96-3BB2-F1C8-7D51-7B8583E872DC}"/>
              </a:ext>
            </a:extLst>
          </p:cNvPr>
          <p:cNvSpPr/>
          <p:nvPr/>
        </p:nvSpPr>
        <p:spPr>
          <a:xfrm>
            <a:off x="3957576" y="2736388"/>
            <a:ext cx="4276845" cy="3440575"/>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latin typeface="Calibri" panose="020F0502020204030204" pitchFamily="34" charset="0"/>
                <a:cs typeface="Calibri" panose="020F0502020204030204" pitchFamily="34" charset="0"/>
              </a:rPr>
              <a:t>QR Code for Polling Software Included Here</a:t>
            </a:r>
          </a:p>
        </p:txBody>
      </p:sp>
      <p:sp>
        <p:nvSpPr>
          <p:cNvPr id="5" name="Google Shape;123;p4">
            <a:extLst>
              <a:ext uri="{FF2B5EF4-FFF2-40B4-BE49-F238E27FC236}">
                <a16:creationId xmlns:a16="http://schemas.microsoft.com/office/drawing/2014/main" id="{EFAE20F0-48B7-5853-4CBB-16FFA912E9A5}"/>
              </a:ext>
            </a:extLst>
          </p:cNvPr>
          <p:cNvSpPr txBox="1"/>
          <p:nvPr/>
        </p:nvSpPr>
        <p:spPr>
          <a:xfrm>
            <a:off x="4044299" y="6344014"/>
            <a:ext cx="4103400" cy="369300"/>
          </a:xfrm>
          <a:prstGeom prst="rect">
            <a:avLst/>
          </a:prstGeom>
          <a:noFill/>
          <a:ln>
            <a:noFill/>
          </a:ln>
        </p:spPr>
        <p:txBody>
          <a:bodyPr spcFirstLastPara="1" wrap="square" lIns="91425" tIns="45700" rIns="91425" bIns="45700" anchor="t" anchorCtr="0">
            <a:spAutoFit/>
          </a:bodyPr>
          <a:lstStyle/>
          <a:p>
            <a:pPr lvl="0" algn="ctr"/>
            <a:r>
              <a:rPr lang="en-US" sz="1800" dirty="0">
                <a:solidFill>
                  <a:schemeClr val="lt1"/>
                </a:solidFill>
                <a:latin typeface="Calibri"/>
                <a:ea typeface="Calibri"/>
                <a:cs typeface="Calibri"/>
                <a:sym typeface="Calibri"/>
              </a:rPr>
              <a:t>(Link to Polling Software Included Here)</a:t>
            </a:r>
            <a:endParaRPr dirty="0"/>
          </a:p>
        </p:txBody>
      </p:sp>
    </p:spTree>
    <p:extLst>
      <p:ext uri="{BB962C8B-B14F-4D97-AF65-F5344CB8AC3E}">
        <p14:creationId xmlns:p14="http://schemas.microsoft.com/office/powerpoint/2010/main" val="394311690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sp>
        <p:nvSpPr>
          <p:cNvPr id="160" name="Google Shape;160;gc473988d5b_0_75"/>
          <p:cNvSpPr txBox="1">
            <a:spLocks noGrp="1"/>
          </p:cNvSpPr>
          <p:nvPr>
            <p:ph type="title"/>
          </p:nvPr>
        </p:nvSpPr>
        <p:spPr>
          <a:xfrm>
            <a:off x="2209800" y="2748000"/>
            <a:ext cx="7772400" cy="1362000"/>
          </a:xfrm>
          <a:prstGeom prst="rect">
            <a:avLst/>
          </a:prstGeom>
          <a:noFill/>
          <a:ln>
            <a:noFill/>
          </a:ln>
        </p:spPr>
        <p:txBody>
          <a:bodyPr spcFirstLastPara="1" wrap="square" lIns="91425" tIns="45700" rIns="91425" bIns="45700" anchor="b" anchorCtr="0">
            <a:noAutofit/>
          </a:bodyPr>
          <a:lstStyle/>
          <a:p>
            <a:pPr marL="0" lvl="0" indent="0" algn="ctr" rtl="0">
              <a:lnSpc>
                <a:spcPct val="90000"/>
              </a:lnSpc>
              <a:spcBef>
                <a:spcPts val="0"/>
              </a:spcBef>
              <a:spcAft>
                <a:spcPts val="0"/>
              </a:spcAft>
              <a:buClr>
                <a:schemeClr val="lt1"/>
              </a:buClr>
              <a:buSzPts val="6000"/>
              <a:buFont typeface="Calibri"/>
              <a:buNone/>
            </a:pPr>
            <a:r>
              <a:rPr lang="en-US" dirty="0"/>
              <a:t>Addressing Patient Bias</a:t>
            </a:r>
            <a:br>
              <a:rPr lang="en-US" dirty="0"/>
            </a:br>
            <a:r>
              <a:rPr lang="en-US" dirty="0"/>
              <a:t>Intervention Training</a:t>
            </a:r>
            <a:endParaRPr dirty="0"/>
          </a:p>
        </p:txBody>
      </p:sp>
    </p:spTree>
    <p:custDataLst>
      <p:tags r:id="rId1"/>
    </p:custData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RTICULATE_PROJECT_OPEN" val="0"/>
  <p:tag name="ARTICULATE_SLIDE_COUNT" val="37"/>
</p:tagLst>
</file>

<file path=ppt/tags/tag1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heme/theme1.xml><?xml version="1.0" encoding="utf-8"?>
<a:theme xmlns:a="http://schemas.openxmlformats.org/drawingml/2006/main" name="Office Theme">
  <a:themeElements>
    <a:clrScheme name="Office Theme">
      <a:dk1>
        <a:srgbClr val="000000"/>
      </a:dk1>
      <a:lt1>
        <a:srgbClr val="FFFFFF"/>
      </a:lt1>
      <a:dk2>
        <a:srgbClr val="44546A"/>
      </a:dk2>
      <a:lt2>
        <a:srgbClr val="E7E6E6"/>
      </a:lt2>
      <a:accent1>
        <a:srgbClr val="29AF8C"/>
      </a:accent1>
      <a:accent2>
        <a:srgbClr val="97BE49"/>
      </a:accent2>
      <a:accent3>
        <a:srgbClr val="3D9CCC"/>
      </a:accent3>
      <a:accent4>
        <a:srgbClr val="7C60C6"/>
      </a:accent4>
      <a:accent5>
        <a:srgbClr val="C9492C"/>
      </a:accent5>
      <a:accent6>
        <a:srgbClr val="D58C2E"/>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24201</TotalTime>
  <Words>6653</Words>
  <Application>Microsoft Macintosh PowerPoint</Application>
  <PresentationFormat>Widescreen</PresentationFormat>
  <Paragraphs>500</Paragraphs>
  <Slides>35</Slides>
  <Notes>35</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5</vt:i4>
      </vt:variant>
    </vt:vector>
  </HeadingPairs>
  <TitlesOfParts>
    <vt:vector size="42" baseType="lpstr">
      <vt:lpstr>Calibri</vt:lpstr>
      <vt:lpstr>Source Sans Pro</vt:lpstr>
      <vt:lpstr>Verdana</vt:lpstr>
      <vt:lpstr>Symbol</vt:lpstr>
      <vt:lpstr>Arial</vt:lpstr>
      <vt:lpstr>Times New Roman</vt:lpstr>
      <vt:lpstr>Office Theme</vt:lpstr>
      <vt:lpstr>PowerPoint Presentation</vt:lpstr>
      <vt:lpstr>Roadmap</vt:lpstr>
      <vt:lpstr>Objectives</vt:lpstr>
      <vt:lpstr>Pre-workshop survey</vt:lpstr>
      <vt:lpstr>Definitions</vt:lpstr>
      <vt:lpstr>PowerPoint Presentation</vt:lpstr>
      <vt:lpstr>And a local one…</vt:lpstr>
      <vt:lpstr>Word cloud</vt:lpstr>
      <vt:lpstr>Addressing Patient Bias Intervention Training</vt:lpstr>
      <vt:lpstr>Bias response</vt:lpstr>
      <vt:lpstr>Ensure stability &amp; assess if altered</vt:lpstr>
      <vt:lpstr>Strategies for the altered patient</vt:lpstr>
      <vt:lpstr>Strategies for the altered patient</vt:lpstr>
      <vt:lpstr>Check your emotions</vt:lpstr>
      <vt:lpstr>Address the bias/microaggression explicitly</vt:lpstr>
      <vt:lpstr>Align with your team</vt:lpstr>
      <vt:lpstr>Set boundaries</vt:lpstr>
      <vt:lpstr>Recenter on patient care</vt:lpstr>
      <vt:lpstr>Give space</vt:lpstr>
      <vt:lpstr>Attend to emotion, seek support</vt:lpstr>
      <vt:lpstr>Best practices for the team</vt:lpstr>
      <vt:lpstr>Toolkit</vt:lpstr>
      <vt:lpstr>Case Discussion</vt:lpstr>
      <vt:lpstr>Applying the toolkit</vt:lpstr>
      <vt:lpstr>Rapid-fire practice – case 1</vt:lpstr>
      <vt:lpstr>Rapid-fire practice – case 1</vt:lpstr>
      <vt:lpstr>Rapid-fire practice – case 2</vt:lpstr>
      <vt:lpstr>Rapid-fire practice – case 2</vt:lpstr>
      <vt:lpstr>Rapid-fire practice – case 3</vt:lpstr>
      <vt:lpstr>Rapid-fire practice – case 3</vt:lpstr>
      <vt:lpstr>Never Worry Alone</vt:lpstr>
      <vt:lpstr>Outpatient resources</vt:lpstr>
      <vt:lpstr>Inpatient resources</vt:lpstr>
      <vt:lpstr>Post-workshop survey</vt:lpstr>
      <vt:lpstr>Addressing Patient Bias A Toolkit for Bias Response   Thank you for your attendance and particip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romberg, Gabrielle</dc:creator>
  <cp:lastModifiedBy>Bromberg, Gabrielle K.,MD</cp:lastModifiedBy>
  <cp:revision>344</cp:revision>
  <dcterms:created xsi:type="dcterms:W3CDTF">2021-01-23T12:21:42Z</dcterms:created>
  <dcterms:modified xsi:type="dcterms:W3CDTF">2024-02-16T02:52:0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rticulateGUID">
    <vt:lpwstr>DEC7B7AB-1264-4918-971A-D69B77F4573C</vt:lpwstr>
  </property>
  <property fmtid="{D5CDD505-2E9C-101B-9397-08002B2CF9AE}" pid="3" name="ArticulatePath">
    <vt:lpwstr>MABCII_NoonConf_2_2_22-Final</vt:lpwstr>
  </property>
</Properties>
</file>